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customXml/itemProps5.xml" ContentType="application/vnd.openxmlformats-officedocument.customXmlProperties+xml"/>
  <Override PartName="/customXml/itemProps6.xml" ContentType="application/vnd.openxmlformats-officedocument.customXmlProperties+xml"/>
  <Override PartName="/customXml/itemProps7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8"/>
  </p:sldMasterIdLst>
  <p:notesMasterIdLst>
    <p:notesMasterId r:id="rId10"/>
  </p:notesMasterIdLst>
  <p:sldIdLst>
    <p:sldId id="256" r:id="rId9"/>
  </p:sldIdLst>
  <p:sldSz cx="9906000" cy="6858000" type="A4"/>
  <p:notesSz cx="6858000" cy="9144000"/>
  <p:defaultTextStyle>
    <a:defPPr>
      <a:defRPr lang="nl-NL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. Pol" initials="NP" lastIdx="5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1144E"/>
    <a:srgbClr val="FFFFFF"/>
    <a:srgbClr val="0C207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3440508-977A-4C13-833D-1DFEA36A392E}" v="498" dt="2021-11-17T10:05:45.546"/>
    <p1510:client id="{73CAAEAD-3389-4BE5-8B8C-272D2702D5F5}" v="77" dt="2021-11-16T13:34:15.513"/>
    <p1510:client id="{DF810FFF-E37A-46DD-B778-CDB764D04AF9}" v="65" dt="2021-11-16T14:15:23.437"/>
    <p1510:client id="{FE28E140-0BC7-4AC6-8AC2-5983C3D2CD03}" v="431" dt="2021-11-17T10:36:11.7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7" d="100"/>
          <a:sy n="97" d="100"/>
        </p:scale>
        <p:origin x="90" y="3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Master" Target="slideMasters/slideMaster1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customXml" Target="../customXml/item7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customXml" Target="../customXml/item6.xml"/><Relationship Id="rId11" Type="http://schemas.openxmlformats.org/officeDocument/2006/relationships/commentAuthors" Target="commentAuthors.xml"/><Relationship Id="rId5" Type="http://schemas.openxmlformats.org/officeDocument/2006/relationships/customXml" Target="../customXml/item5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customXml" Target="../customXml/item4.xml"/><Relationship Id="rId9" Type="http://schemas.openxmlformats.org/officeDocument/2006/relationships/slide" Target="slides/slide1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>
            <a:extLst>
              <a:ext uri="{FF2B5EF4-FFF2-40B4-BE49-F238E27FC236}">
                <a16:creationId xmlns:a16="http://schemas.microsoft.com/office/drawing/2014/main" id="{F36DB63A-7909-5A4B-A3D9-19581C21E06E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A215842A-5020-0D4A-9EB1-C988770FE19C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91A17014-CD54-0642-BF63-EC3CE5B3257B}" type="datetimeFigureOut">
              <a:rPr lang="nl-NL"/>
              <a:pPr>
                <a:defRPr/>
              </a:pPr>
              <a:t>26-01-2023</a:t>
            </a:fld>
            <a:endParaRPr lang="nl-NL"/>
          </a:p>
        </p:txBody>
      </p:sp>
      <p:sp>
        <p:nvSpPr>
          <p:cNvPr id="4" name="Tijdelijke aanduiding voor dia-afbeelding 3">
            <a:extLst>
              <a:ext uri="{FF2B5EF4-FFF2-40B4-BE49-F238E27FC236}">
                <a16:creationId xmlns:a16="http://schemas.microsoft.com/office/drawing/2014/main" id="{9D50A4FE-8DDA-1C42-9C8A-064BC82B7CA8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nl-NL" noProof="0"/>
          </a:p>
        </p:txBody>
      </p:sp>
      <p:sp>
        <p:nvSpPr>
          <p:cNvPr id="5" name="Tijdelijke aanduiding voor notities 4">
            <a:extLst>
              <a:ext uri="{FF2B5EF4-FFF2-40B4-BE49-F238E27FC236}">
                <a16:creationId xmlns:a16="http://schemas.microsoft.com/office/drawing/2014/main" id="{8D0F4B64-BD31-EE43-9066-64D4F35921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 noProof="0"/>
              <a:t>Klikken om de tekststijl van het model te bewerken</a:t>
            </a:r>
          </a:p>
          <a:p>
            <a:pPr lvl="1"/>
            <a:r>
              <a:rPr lang="nl-NL" noProof="0"/>
              <a:t>Tweede niveau</a:t>
            </a:r>
          </a:p>
          <a:p>
            <a:pPr lvl="2"/>
            <a:r>
              <a:rPr lang="nl-NL" noProof="0"/>
              <a:t>Derde niveau</a:t>
            </a:r>
          </a:p>
          <a:p>
            <a:pPr lvl="3"/>
            <a:r>
              <a:rPr lang="nl-NL" noProof="0"/>
              <a:t>Vierde niveau</a:t>
            </a:r>
          </a:p>
          <a:p>
            <a:pPr lvl="4"/>
            <a:r>
              <a:rPr lang="nl-NL" noProof="0"/>
              <a:t>Vijfde niveau</a:t>
            </a:r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45116776-121C-1A4E-B2F6-DD38D1D7FBFC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1D1FB5E8-CD34-6E41-B4F8-8E88ECA8D4C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fld id="{0A622139-329B-174F-9882-7DFF5ECAF1D8}" type="slidenum">
              <a:rPr lang="nl-NL" altLang="nl-NL"/>
              <a:pPr/>
              <a:t>‹#›</a:t>
            </a:fld>
            <a:endParaRPr lang="nl-NL" alt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E5C8C94-6483-5F44-A214-6BBE58E30B33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513358" y="313067"/>
            <a:ext cx="7744488" cy="2387600"/>
          </a:xfrm>
        </p:spPr>
        <p:txBody>
          <a:bodyPr anchor="b">
            <a:noAutofit/>
          </a:bodyPr>
          <a:lstStyle>
            <a:lvl1pPr algn="l">
              <a:defRPr sz="4875">
                <a:solidFill>
                  <a:schemeClr val="accent1"/>
                </a:solidFill>
              </a:defRPr>
            </a:lvl1pPr>
          </a:lstStyle>
          <a:p>
            <a:r>
              <a:rPr lang="nl-NL"/>
              <a:t>Voeg titel toe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D28D2045-79CC-614D-BA13-696E7AAAEE4A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513358" y="2876824"/>
            <a:ext cx="7744488" cy="1655762"/>
          </a:xfrm>
        </p:spPr>
        <p:txBody>
          <a:bodyPr/>
          <a:lstStyle>
            <a:lvl1pPr marL="0" indent="0" algn="l">
              <a:buNone/>
              <a:defRPr sz="195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75" indent="0" algn="ctr">
              <a:buNone/>
              <a:defRPr sz="1625"/>
            </a:lvl2pPr>
            <a:lvl3pPr marL="742950" indent="0" algn="ctr">
              <a:buNone/>
              <a:defRPr sz="1463"/>
            </a:lvl3pPr>
            <a:lvl4pPr marL="1114425" indent="0" algn="ctr">
              <a:buNone/>
              <a:defRPr sz="1300"/>
            </a:lvl4pPr>
            <a:lvl5pPr marL="1485900" indent="0" algn="ctr">
              <a:buNone/>
              <a:defRPr sz="1300"/>
            </a:lvl5pPr>
            <a:lvl6pPr marL="1857375" indent="0" algn="ctr">
              <a:buNone/>
              <a:defRPr sz="1300"/>
            </a:lvl6pPr>
            <a:lvl7pPr marL="2228850" indent="0" algn="ctr">
              <a:buNone/>
              <a:defRPr sz="1300"/>
            </a:lvl7pPr>
            <a:lvl8pPr marL="2600325" indent="0" algn="ctr">
              <a:buNone/>
              <a:defRPr sz="1300"/>
            </a:lvl8pPr>
            <a:lvl9pPr marL="2971800" indent="0" algn="ctr">
              <a:buNone/>
              <a:defRPr sz="1300"/>
            </a:lvl9pPr>
          </a:lstStyle>
          <a:p>
            <a:r>
              <a:rPr lang="nl-NL"/>
              <a:t>Voeg ondertitel to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36DB54-88F1-4358-B17D-E35D994C4489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513358" y="7165953"/>
            <a:ext cx="676085" cy="179921"/>
          </a:xfrm>
        </p:spPr>
        <p:txBody>
          <a:bodyPr/>
          <a:lstStyle/>
          <a:p>
            <a:fld id="{0FBDD9FE-454E-427B-A3A1-00EEA30AE87E}" type="datetime1">
              <a:rPr lang="en-GB" smtClean="0"/>
              <a:t>26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2EDB1A-A8E9-4E2A-8325-F6C815820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1269414" y="7165952"/>
            <a:ext cx="7064081" cy="179921"/>
          </a:xfrm>
        </p:spPr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8D8322-31E3-481B-ABDE-EA810DE824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413467" y="7165954"/>
            <a:ext cx="394875" cy="179921"/>
          </a:xfrm>
        </p:spPr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1863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D765F5E8-6299-BB40-AA7E-D87AA34359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14705" y="1818172"/>
            <a:ext cx="4084261" cy="823912"/>
          </a:xfrm>
        </p:spPr>
        <p:txBody>
          <a:bodyPr anchor="b"/>
          <a:lstStyle>
            <a:lvl1pPr marL="0" indent="0">
              <a:buNone/>
              <a:defRPr sz="1950" b="1"/>
            </a:lvl1pPr>
            <a:lvl2pPr marL="371475" indent="0">
              <a:buNone/>
              <a:defRPr sz="1625" b="1"/>
            </a:lvl2pPr>
            <a:lvl3pPr marL="742950" indent="0">
              <a:buNone/>
              <a:defRPr sz="1463" b="1"/>
            </a:lvl3pPr>
            <a:lvl4pPr marL="1114425" indent="0">
              <a:buNone/>
              <a:defRPr sz="1300" b="1"/>
            </a:lvl4pPr>
            <a:lvl5pPr marL="1485900" indent="0">
              <a:buNone/>
              <a:defRPr sz="1300" b="1"/>
            </a:lvl5pPr>
            <a:lvl6pPr marL="1857375" indent="0">
              <a:buNone/>
              <a:defRPr sz="1300" b="1"/>
            </a:lvl6pPr>
            <a:lvl7pPr marL="2228850" indent="0">
              <a:buNone/>
              <a:defRPr sz="1300" b="1"/>
            </a:lvl7pPr>
            <a:lvl8pPr marL="2600325" indent="0">
              <a:buNone/>
              <a:defRPr sz="1300" b="1"/>
            </a:lvl8pPr>
            <a:lvl9pPr marL="2971800" indent="0">
              <a:buNone/>
              <a:defRPr sz="1300" b="1"/>
            </a:lvl9pPr>
          </a:lstStyle>
          <a:p>
            <a:pPr lvl="0"/>
            <a:endParaRPr lang="nl-NL"/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6EEDA3F4-ED99-D54F-B0AE-3E3ADFDC09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722762" y="1818172"/>
            <a:ext cx="4085580" cy="823912"/>
          </a:xfrm>
        </p:spPr>
        <p:txBody>
          <a:bodyPr anchor="b"/>
          <a:lstStyle>
            <a:lvl1pPr marL="0" indent="0">
              <a:buNone/>
              <a:defRPr sz="1950" b="1"/>
            </a:lvl1pPr>
            <a:lvl2pPr marL="371475" indent="0">
              <a:buNone/>
              <a:defRPr sz="1625" b="1"/>
            </a:lvl2pPr>
            <a:lvl3pPr marL="742950" indent="0">
              <a:buNone/>
              <a:defRPr sz="1463" b="1"/>
            </a:lvl3pPr>
            <a:lvl4pPr marL="1114425" indent="0">
              <a:buNone/>
              <a:defRPr sz="1300" b="1"/>
            </a:lvl4pPr>
            <a:lvl5pPr marL="1485900" indent="0">
              <a:buNone/>
              <a:defRPr sz="1300" b="1"/>
            </a:lvl5pPr>
            <a:lvl6pPr marL="1857375" indent="0">
              <a:buNone/>
              <a:defRPr sz="1300" b="1"/>
            </a:lvl6pPr>
            <a:lvl7pPr marL="2228850" indent="0">
              <a:buNone/>
              <a:defRPr sz="1300" b="1"/>
            </a:lvl7pPr>
            <a:lvl8pPr marL="2600325" indent="0">
              <a:buNone/>
              <a:defRPr sz="1300" b="1"/>
            </a:lvl8pPr>
            <a:lvl9pPr marL="2971800" indent="0">
              <a:buNone/>
              <a:defRPr sz="1300" b="1"/>
            </a:lvl9pPr>
          </a:lstStyle>
          <a:p>
            <a:pPr lvl="0"/>
            <a:endParaRPr lang="nl-NL"/>
          </a:p>
        </p:txBody>
      </p:sp>
      <p:sp>
        <p:nvSpPr>
          <p:cNvPr id="14" name="Tijdelijke aanduiding voor inhoud 2">
            <a:extLst>
              <a:ext uri="{FF2B5EF4-FFF2-40B4-BE49-F238E27FC236}">
                <a16:creationId xmlns:a16="http://schemas.microsoft.com/office/drawing/2014/main" id="{F28CC1D8-B688-4145-9196-20A3827814D3}"/>
              </a:ext>
            </a:extLst>
          </p:cNvPr>
          <p:cNvSpPr>
            <a:spLocks noGrp="1"/>
          </p:cNvSpPr>
          <p:nvPr>
            <p:ph sz="half" idx="14"/>
          </p:nvPr>
        </p:nvSpPr>
        <p:spPr>
          <a:xfrm>
            <a:off x="513359" y="2642084"/>
            <a:ext cx="4085579" cy="3215790"/>
          </a:xfrm>
        </p:spPr>
        <p:txBody>
          <a:bodyPr/>
          <a:lstStyle>
            <a:lvl1pPr>
              <a:defRPr sz="1950"/>
            </a:lvl1pPr>
          </a:lstStyle>
          <a:p>
            <a:pPr lvl="0"/>
            <a:endParaRPr lang="nl-NL"/>
          </a:p>
        </p:txBody>
      </p:sp>
      <p:sp>
        <p:nvSpPr>
          <p:cNvPr id="15" name="Tijdelijke aanduiding voor inhoud 3">
            <a:extLst>
              <a:ext uri="{FF2B5EF4-FFF2-40B4-BE49-F238E27FC236}">
                <a16:creationId xmlns:a16="http://schemas.microsoft.com/office/drawing/2014/main" id="{5E7B9D8C-5520-4CA3-8B03-D336D53E0E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2762" y="2642084"/>
            <a:ext cx="4085580" cy="3215790"/>
          </a:xfrm>
        </p:spPr>
        <p:txBody>
          <a:bodyPr/>
          <a:lstStyle>
            <a:lvl1pPr>
              <a:defRPr sz="1950"/>
            </a:lvl1pPr>
          </a:lstStyle>
          <a:p>
            <a:pPr lvl="0"/>
            <a:endParaRPr lang="nl-NL"/>
          </a:p>
        </p:txBody>
      </p:sp>
      <p:sp>
        <p:nvSpPr>
          <p:cNvPr id="18" name="Ondertitel 2">
            <a:extLst>
              <a:ext uri="{FF2B5EF4-FFF2-40B4-BE49-F238E27FC236}">
                <a16:creationId xmlns:a16="http://schemas.microsoft.com/office/drawing/2014/main" id="{A226B935-B8CA-45B5-9B1A-6DD312D7A97F}"/>
              </a:ext>
            </a:extLst>
          </p:cNvPr>
          <p:cNvSpPr>
            <a:spLocks noGrp="1"/>
          </p:cNvSpPr>
          <p:nvPr>
            <p:ph type="subTitle" idx="13" hasCustomPrompt="1"/>
          </p:nvPr>
        </p:nvSpPr>
        <p:spPr>
          <a:xfrm>
            <a:off x="513359" y="926508"/>
            <a:ext cx="8294985" cy="571042"/>
          </a:xfrm>
        </p:spPr>
        <p:txBody>
          <a:bodyPr/>
          <a:lstStyle>
            <a:lvl1pPr marL="0" indent="0" algn="l">
              <a:buNone/>
              <a:defRPr sz="195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75" indent="0" algn="ctr">
              <a:buNone/>
              <a:defRPr sz="1625"/>
            </a:lvl2pPr>
            <a:lvl3pPr marL="742950" indent="0" algn="ctr">
              <a:buNone/>
              <a:defRPr sz="1463"/>
            </a:lvl3pPr>
            <a:lvl4pPr marL="1114425" indent="0" algn="ctr">
              <a:buNone/>
              <a:defRPr sz="1300"/>
            </a:lvl4pPr>
            <a:lvl5pPr marL="1485900" indent="0" algn="ctr">
              <a:buNone/>
              <a:defRPr sz="1300"/>
            </a:lvl5pPr>
            <a:lvl6pPr marL="1857375" indent="0" algn="ctr">
              <a:buNone/>
              <a:defRPr sz="1300"/>
            </a:lvl6pPr>
            <a:lvl7pPr marL="2228850" indent="0" algn="ctr">
              <a:buNone/>
              <a:defRPr sz="1300"/>
            </a:lvl7pPr>
            <a:lvl8pPr marL="2600325" indent="0" algn="ctr">
              <a:buNone/>
              <a:defRPr sz="1300"/>
            </a:lvl8pPr>
            <a:lvl9pPr marL="2971800" indent="0" algn="ctr">
              <a:buNone/>
              <a:defRPr sz="1300"/>
            </a:lvl9pPr>
          </a:lstStyle>
          <a:p>
            <a:r>
              <a:rPr lang="nl-NL"/>
              <a:t>Voeg ondertitel toe</a:t>
            </a:r>
          </a:p>
        </p:txBody>
      </p:sp>
      <p:sp>
        <p:nvSpPr>
          <p:cNvPr id="21" name="Title 20">
            <a:extLst>
              <a:ext uri="{FF2B5EF4-FFF2-40B4-BE49-F238E27FC236}">
                <a16:creationId xmlns:a16="http://schemas.microsoft.com/office/drawing/2014/main" id="{749B6409-B371-4B9F-B3ED-16C2E291560A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err="1"/>
              <a:t>Voeg</a:t>
            </a:r>
            <a:r>
              <a:rPr lang="en-US"/>
              <a:t> </a:t>
            </a:r>
            <a:r>
              <a:rPr lang="en-US" err="1"/>
              <a:t>titel</a:t>
            </a:r>
            <a:r>
              <a:rPr lang="en-US"/>
              <a:t> toe</a:t>
            </a:r>
          </a:p>
        </p:txBody>
      </p:sp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1D5B612-A5DC-429C-BEED-F567BC46DA16}"/>
              </a:ext>
            </a:extLst>
          </p:cNvPr>
          <p:cNvSpPr>
            <a:spLocks noGrp="1"/>
          </p:cNvSpPr>
          <p:nvPr>
            <p:ph type="dt" sz="half" idx="15"/>
          </p:nvPr>
        </p:nvSpPr>
        <p:spPr/>
        <p:txBody>
          <a:bodyPr/>
          <a:lstStyle/>
          <a:p>
            <a:fld id="{4A16BB2A-F23F-4E0F-829E-86051D38B0EA}" type="datetime1">
              <a:rPr lang="en-GB" smtClean="0"/>
              <a:t>26/0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3805DAB-FAA5-42E4-AA95-5CB304C269C4}"/>
              </a:ext>
            </a:extLst>
          </p:cNvPr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B5E665-0587-47B7-AAB9-E02D385674B3}"/>
              </a:ext>
            </a:extLst>
          </p:cNvPr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8167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Afbeeld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icture Placeholder 8">
            <a:extLst>
              <a:ext uri="{FF2B5EF4-FFF2-40B4-BE49-F238E27FC236}">
                <a16:creationId xmlns:a16="http://schemas.microsoft.com/office/drawing/2014/main" id="{CC1BF7E4-62DA-49C2-9061-4B75E6E294E7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0" y="0"/>
            <a:ext cx="9906000" cy="6858000"/>
          </a:xfrm>
          <a:custGeom>
            <a:avLst/>
            <a:gdLst>
              <a:gd name="connsiteX0" fmla="*/ 0 w 12192000"/>
              <a:gd name="connsiteY0" fmla="*/ 0 h 6858000"/>
              <a:gd name="connsiteX1" fmla="*/ 12192000 w 12192000"/>
              <a:gd name="connsiteY1" fmla="*/ 0 h 6858000"/>
              <a:gd name="connsiteX2" fmla="*/ 12192000 w 12192000"/>
              <a:gd name="connsiteY2" fmla="*/ 5928360 h 6858000"/>
              <a:gd name="connsiteX3" fmla="*/ 12192000 w 12192000"/>
              <a:gd name="connsiteY3" fmla="*/ 6858000 h 6858000"/>
              <a:gd name="connsiteX4" fmla="*/ 10546080 w 12192000"/>
              <a:gd name="connsiteY4" fmla="*/ 6858000 h 6858000"/>
              <a:gd name="connsiteX5" fmla="*/ 0 w 12192000"/>
              <a:gd name="connsiteY5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2192000" h="6858000">
                <a:moveTo>
                  <a:pt x="0" y="0"/>
                </a:moveTo>
                <a:lnTo>
                  <a:pt x="12192000" y="0"/>
                </a:lnTo>
                <a:lnTo>
                  <a:pt x="12192000" y="5928360"/>
                </a:lnTo>
                <a:lnTo>
                  <a:pt x="12192000" y="6858000"/>
                </a:lnTo>
                <a:lnTo>
                  <a:pt x="10546080" y="6858000"/>
                </a:lnTo>
                <a:lnTo>
                  <a:pt x="0" y="6858000"/>
                </a:ln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marL="0" indent="0" algn="ctr">
              <a:buNone/>
              <a:defRPr sz="1950"/>
            </a:lvl1pPr>
          </a:lstStyle>
          <a:p>
            <a:pPr lvl="0"/>
            <a:endParaRPr lang="nl-NL" noProof="0"/>
          </a:p>
        </p:txBody>
      </p:sp>
      <p:sp>
        <p:nvSpPr>
          <p:cNvPr id="15" name="Date Placeholder 3">
            <a:extLst>
              <a:ext uri="{FF2B5EF4-FFF2-40B4-BE49-F238E27FC236}">
                <a16:creationId xmlns:a16="http://schemas.microsoft.com/office/drawing/2014/main" id="{B8B169DA-F6EB-44C4-8C39-89055F4E21BB}"/>
              </a:ext>
            </a:extLst>
          </p:cNvPr>
          <p:cNvSpPr>
            <a:spLocks noGrp="1"/>
          </p:cNvSpPr>
          <p:nvPr>
            <p:ph type="dt" sz="half" idx="11"/>
          </p:nvPr>
        </p:nvSpPr>
        <p:spPr>
          <a:xfrm>
            <a:off x="513358" y="7165953"/>
            <a:ext cx="676085" cy="179921"/>
          </a:xfrm>
        </p:spPr>
        <p:txBody>
          <a:bodyPr/>
          <a:lstStyle/>
          <a:p>
            <a:fld id="{5DA6945E-81CA-4BD3-A6D1-5E443B4DE943}" type="datetime1">
              <a:rPr lang="en-GB" smtClean="0"/>
              <a:t>26/01/2023</a:t>
            </a:fld>
            <a:endParaRPr lang="en-GB"/>
          </a:p>
        </p:txBody>
      </p:sp>
      <p:sp>
        <p:nvSpPr>
          <p:cNvPr id="16" name="Footer Placeholder 4">
            <a:extLst>
              <a:ext uri="{FF2B5EF4-FFF2-40B4-BE49-F238E27FC236}">
                <a16:creationId xmlns:a16="http://schemas.microsoft.com/office/drawing/2014/main" id="{D5721CA1-4C99-4AE1-A09F-C01D6D60F419}"/>
              </a:ext>
            </a:extLst>
          </p:cNvPr>
          <p:cNvSpPr>
            <a:spLocks noGrp="1"/>
          </p:cNvSpPr>
          <p:nvPr>
            <p:ph type="ftr" sz="quarter" idx="12"/>
          </p:nvPr>
        </p:nvSpPr>
        <p:spPr>
          <a:xfrm>
            <a:off x="1269414" y="7165952"/>
            <a:ext cx="7064081" cy="179921"/>
          </a:xfrm>
        </p:spPr>
        <p:txBody>
          <a:bodyPr/>
          <a:lstStyle/>
          <a:p>
            <a:endParaRPr lang="en-GB"/>
          </a:p>
        </p:txBody>
      </p:sp>
      <p:sp>
        <p:nvSpPr>
          <p:cNvPr id="17" name="Slide Number Placeholder 5">
            <a:extLst>
              <a:ext uri="{FF2B5EF4-FFF2-40B4-BE49-F238E27FC236}">
                <a16:creationId xmlns:a16="http://schemas.microsoft.com/office/drawing/2014/main" id="{B77AFA47-3EE4-4DA3-A423-AE9B8CB63208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8413467" y="7165954"/>
            <a:ext cx="394875" cy="179921"/>
          </a:xfrm>
        </p:spPr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2" name="Text Placeholder 2059">
            <a:extLst>
              <a:ext uri="{FF2B5EF4-FFF2-40B4-BE49-F238E27FC236}">
                <a16:creationId xmlns:a16="http://schemas.microsoft.com/office/drawing/2014/main" id="{70D4D95F-9082-4390-8238-9D84FFCB5E8A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8983503" y="6322695"/>
            <a:ext cx="741620" cy="359794"/>
          </a:xfrm>
          <a:blipFill dpi="0"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r>
              <a:rPr lang="en-US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546806594"/>
      </p:ext>
    </p:extLst>
  </p:cSld>
  <p:clrMapOvr>
    <a:masterClrMapping/>
  </p:clrMapOvr>
  <p:transition spd="slow">
    <p:wipe/>
  </p:transition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Ondertitel 2">
            <a:extLst>
              <a:ext uri="{FF2B5EF4-FFF2-40B4-BE49-F238E27FC236}">
                <a16:creationId xmlns:a16="http://schemas.microsoft.com/office/drawing/2014/main" id="{1740F6E3-BB69-4FDB-B455-05A3929CE3E8}"/>
              </a:ext>
            </a:extLst>
          </p:cNvPr>
          <p:cNvSpPr>
            <a:spLocks noGrp="1"/>
          </p:cNvSpPr>
          <p:nvPr>
            <p:ph type="subTitle" idx="13" hasCustomPrompt="1"/>
          </p:nvPr>
        </p:nvSpPr>
        <p:spPr>
          <a:xfrm>
            <a:off x="513359" y="926508"/>
            <a:ext cx="8294985" cy="571042"/>
          </a:xfrm>
        </p:spPr>
        <p:txBody>
          <a:bodyPr/>
          <a:lstStyle>
            <a:lvl1pPr marL="0" indent="0" algn="l">
              <a:buNone/>
              <a:defRPr sz="195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75" indent="0" algn="ctr">
              <a:buNone/>
              <a:defRPr sz="1625"/>
            </a:lvl2pPr>
            <a:lvl3pPr marL="742950" indent="0" algn="ctr">
              <a:buNone/>
              <a:defRPr sz="1463"/>
            </a:lvl3pPr>
            <a:lvl4pPr marL="1114425" indent="0" algn="ctr">
              <a:buNone/>
              <a:defRPr sz="1300"/>
            </a:lvl4pPr>
            <a:lvl5pPr marL="1485900" indent="0" algn="ctr">
              <a:buNone/>
              <a:defRPr sz="1300"/>
            </a:lvl5pPr>
            <a:lvl6pPr marL="1857375" indent="0" algn="ctr">
              <a:buNone/>
              <a:defRPr sz="1300"/>
            </a:lvl6pPr>
            <a:lvl7pPr marL="2228850" indent="0" algn="ctr">
              <a:buNone/>
              <a:defRPr sz="1300"/>
            </a:lvl7pPr>
            <a:lvl8pPr marL="2600325" indent="0" algn="ctr">
              <a:buNone/>
              <a:defRPr sz="1300"/>
            </a:lvl8pPr>
            <a:lvl9pPr marL="2971800" indent="0" algn="ctr">
              <a:buNone/>
              <a:defRPr sz="1300"/>
            </a:lvl9pPr>
          </a:lstStyle>
          <a:p>
            <a:r>
              <a:rPr lang="nl-NL"/>
              <a:t>Voeg ondertitel toe</a:t>
            </a:r>
          </a:p>
        </p:txBody>
      </p:sp>
      <p:sp>
        <p:nvSpPr>
          <p:cNvPr id="12" name="Title 11">
            <a:extLst>
              <a:ext uri="{FF2B5EF4-FFF2-40B4-BE49-F238E27FC236}">
                <a16:creationId xmlns:a16="http://schemas.microsoft.com/office/drawing/2014/main" id="{5B2E0F06-95BB-4E0F-B6D2-44A1325E008F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err="1"/>
              <a:t>Voeg</a:t>
            </a:r>
            <a:r>
              <a:rPr lang="en-US"/>
              <a:t> </a:t>
            </a:r>
            <a:r>
              <a:rPr lang="en-US" err="1"/>
              <a:t>titel</a:t>
            </a:r>
            <a:r>
              <a:rPr lang="en-US"/>
              <a:t> toe</a:t>
            </a:r>
          </a:p>
        </p:txBody>
      </p:sp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90DE726-9C54-4569-9477-C17382798F10}"/>
              </a:ext>
            </a:extLst>
          </p:cNvPr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fld id="{65E688D0-DE6F-477F-B90C-D66EB6B4C12B}" type="datetime1">
              <a:rPr lang="en-GB" smtClean="0"/>
              <a:t>26/0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8E679D3-9656-4BF5-BF31-B4F76FB4DF74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F84C3F-81CA-4916-B522-934D603E63BC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750220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90DE726-9C54-4569-9477-C17382798F10}"/>
              </a:ext>
            </a:extLst>
          </p:cNvPr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fld id="{65E688D0-DE6F-477F-B90C-D66EB6B4C12B}" type="datetime1">
              <a:rPr lang="en-GB" smtClean="0"/>
              <a:t>26/0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8E679D3-9656-4BF5-BF31-B4F76FB4DF74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F84C3F-81CA-4916-B522-934D603E63BC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1643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eldia (alternatief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Freeform: Shape 24">
            <a:extLst>
              <a:ext uri="{FF2B5EF4-FFF2-40B4-BE49-F238E27FC236}">
                <a16:creationId xmlns:a16="http://schemas.microsoft.com/office/drawing/2014/main" id="{57E780CB-CF25-46D6-AC5C-CFB15D854970}"/>
              </a:ext>
            </a:extLst>
          </p:cNvPr>
          <p:cNvSpPr>
            <a:spLocks/>
          </p:cNvSpPr>
          <p:nvPr userDrawn="1"/>
        </p:nvSpPr>
        <p:spPr bwMode="auto">
          <a:xfrm rot="5400000">
            <a:off x="994921" y="-1010588"/>
            <a:ext cx="5709971" cy="7723032"/>
          </a:xfrm>
          <a:custGeom>
            <a:avLst/>
            <a:gdLst>
              <a:gd name="connsiteX0" fmla="*/ 0 w 5705912"/>
              <a:gd name="connsiteY0" fmla="*/ 9505270 h 9505270"/>
              <a:gd name="connsiteX1" fmla="*/ 0 w 5705912"/>
              <a:gd name="connsiteY1" fmla="*/ 0 h 9505270"/>
              <a:gd name="connsiteX2" fmla="*/ 5705912 w 5705912"/>
              <a:gd name="connsiteY2" fmla="*/ 5674948 h 9505270"/>
              <a:gd name="connsiteX3" fmla="*/ 5705912 w 5705912"/>
              <a:gd name="connsiteY3" fmla="*/ 9505270 h 95052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705912" h="9505270">
                <a:moveTo>
                  <a:pt x="0" y="9505270"/>
                </a:moveTo>
                <a:lnTo>
                  <a:pt x="0" y="0"/>
                </a:lnTo>
                <a:lnTo>
                  <a:pt x="5705912" y="5674948"/>
                </a:lnTo>
                <a:lnTo>
                  <a:pt x="5705912" y="9505270"/>
                </a:lnTo>
                <a:close/>
              </a:path>
            </a:pathLst>
          </a:custGeom>
          <a:solidFill>
            <a:schemeClr val="accent4"/>
          </a:solidFill>
          <a:ln>
            <a:noFill/>
          </a:ln>
        </p:spPr>
        <p:txBody>
          <a:bodyPr wrap="square">
            <a:noAutofit/>
          </a:bodyPr>
          <a:lstStyle/>
          <a:p>
            <a:endParaRPr lang="nl-NL"/>
          </a:p>
        </p:txBody>
      </p:sp>
      <p:sp>
        <p:nvSpPr>
          <p:cNvPr id="2" name="Titel 1">
            <a:extLst>
              <a:ext uri="{FF2B5EF4-FFF2-40B4-BE49-F238E27FC236}">
                <a16:creationId xmlns:a16="http://schemas.microsoft.com/office/drawing/2014/main" id="{4E5C8C94-6483-5F44-A214-6BBE58E30B33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513358" y="313067"/>
            <a:ext cx="7744488" cy="2387600"/>
          </a:xfrm>
        </p:spPr>
        <p:txBody>
          <a:bodyPr anchor="b">
            <a:noAutofit/>
          </a:bodyPr>
          <a:lstStyle>
            <a:lvl1pPr algn="l">
              <a:defRPr sz="4875">
                <a:solidFill>
                  <a:schemeClr val="accent1"/>
                </a:solidFill>
              </a:defRPr>
            </a:lvl1pPr>
          </a:lstStyle>
          <a:p>
            <a:r>
              <a:rPr lang="nl-NL"/>
              <a:t>Voeg titel toe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D28D2045-79CC-614D-BA13-696E7AAAEE4A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513358" y="2876824"/>
            <a:ext cx="7744488" cy="1655762"/>
          </a:xfrm>
        </p:spPr>
        <p:txBody>
          <a:bodyPr/>
          <a:lstStyle>
            <a:lvl1pPr marL="0" indent="0" algn="l">
              <a:buNone/>
              <a:defRPr sz="195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75" indent="0" algn="ctr">
              <a:buNone/>
              <a:defRPr sz="1625"/>
            </a:lvl2pPr>
            <a:lvl3pPr marL="742950" indent="0" algn="ctr">
              <a:buNone/>
              <a:defRPr sz="1463"/>
            </a:lvl3pPr>
            <a:lvl4pPr marL="1114425" indent="0" algn="ctr">
              <a:buNone/>
              <a:defRPr sz="1300"/>
            </a:lvl4pPr>
            <a:lvl5pPr marL="1485900" indent="0" algn="ctr">
              <a:buNone/>
              <a:defRPr sz="1300"/>
            </a:lvl5pPr>
            <a:lvl6pPr marL="1857375" indent="0" algn="ctr">
              <a:buNone/>
              <a:defRPr sz="1300"/>
            </a:lvl6pPr>
            <a:lvl7pPr marL="2228850" indent="0" algn="ctr">
              <a:buNone/>
              <a:defRPr sz="1300"/>
            </a:lvl7pPr>
            <a:lvl8pPr marL="2600325" indent="0" algn="ctr">
              <a:buNone/>
              <a:defRPr sz="1300"/>
            </a:lvl8pPr>
            <a:lvl9pPr marL="2971800" indent="0" algn="ctr">
              <a:buNone/>
              <a:defRPr sz="1300"/>
            </a:lvl9pPr>
          </a:lstStyle>
          <a:p>
            <a:r>
              <a:rPr lang="nl-NL"/>
              <a:t>Voeg ondertitel toe</a:t>
            </a:r>
          </a:p>
        </p:txBody>
      </p:sp>
      <p:pic>
        <p:nvPicPr>
          <p:cNvPr id="20" name="Picture 9">
            <a:extLst>
              <a:ext uri="{FF2B5EF4-FFF2-40B4-BE49-F238E27FC236}">
                <a16:creationId xmlns:a16="http://schemas.microsoft.com/office/drawing/2014/main" id="{42E0AF8F-2773-4A1E-A448-0EA7CC0EEB73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21981" y="5813208"/>
            <a:ext cx="1607145" cy="10257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" name="Freeform: Shape 28">
            <a:extLst>
              <a:ext uri="{FF2B5EF4-FFF2-40B4-BE49-F238E27FC236}">
                <a16:creationId xmlns:a16="http://schemas.microsoft.com/office/drawing/2014/main" id="{7CFB27A8-9C4A-461D-9970-77857B17D290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0" name="Freeform: Shape 29">
            <a:extLst>
              <a:ext uri="{FF2B5EF4-FFF2-40B4-BE49-F238E27FC236}">
                <a16:creationId xmlns:a16="http://schemas.microsoft.com/office/drawing/2014/main" id="{DB080469-7312-4D9A-97F8-76CC0D697DCA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1" name="Freeform: Shape 30">
            <a:extLst>
              <a:ext uri="{FF2B5EF4-FFF2-40B4-BE49-F238E27FC236}">
                <a16:creationId xmlns:a16="http://schemas.microsoft.com/office/drawing/2014/main" id="{1917E6CC-D4C4-4A9E-961D-0B948335C1D5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2" name="Freeform: Shape 31">
            <a:extLst>
              <a:ext uri="{FF2B5EF4-FFF2-40B4-BE49-F238E27FC236}">
                <a16:creationId xmlns:a16="http://schemas.microsoft.com/office/drawing/2014/main" id="{E0CC0964-109E-4724-9CBD-9C5E8E1259E3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3" name="Freeform: Shape 32">
            <a:extLst>
              <a:ext uri="{FF2B5EF4-FFF2-40B4-BE49-F238E27FC236}">
                <a16:creationId xmlns:a16="http://schemas.microsoft.com/office/drawing/2014/main" id="{BAA75C3C-7293-4F05-A284-5A879C55898D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4" name="Freeform: Shape 33">
            <a:extLst>
              <a:ext uri="{FF2B5EF4-FFF2-40B4-BE49-F238E27FC236}">
                <a16:creationId xmlns:a16="http://schemas.microsoft.com/office/drawing/2014/main" id="{32BC5C39-F12F-4182-BF69-2195D6B83D83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5" name="Freeform: Shape 34">
            <a:extLst>
              <a:ext uri="{FF2B5EF4-FFF2-40B4-BE49-F238E27FC236}">
                <a16:creationId xmlns:a16="http://schemas.microsoft.com/office/drawing/2014/main" id="{E586304D-0D32-4355-AFB8-EE1B95429126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6" name="Freeform: Shape 35">
            <a:extLst>
              <a:ext uri="{FF2B5EF4-FFF2-40B4-BE49-F238E27FC236}">
                <a16:creationId xmlns:a16="http://schemas.microsoft.com/office/drawing/2014/main" id="{E46081E0-F5F3-471B-BD58-FAE737F9B87D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7" name="Freeform: Shape 36">
            <a:extLst>
              <a:ext uri="{FF2B5EF4-FFF2-40B4-BE49-F238E27FC236}">
                <a16:creationId xmlns:a16="http://schemas.microsoft.com/office/drawing/2014/main" id="{4977F8C8-F8D3-467D-ADC4-D72F1CD86B0D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8" name="Freeform: Shape 37">
            <a:extLst>
              <a:ext uri="{FF2B5EF4-FFF2-40B4-BE49-F238E27FC236}">
                <a16:creationId xmlns:a16="http://schemas.microsoft.com/office/drawing/2014/main" id="{ADF03386-67A2-4DA1-933B-68ACD7DB7263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grpSp>
        <p:nvGrpSpPr>
          <p:cNvPr id="412" name="Group 411">
            <a:extLst>
              <a:ext uri="{FF2B5EF4-FFF2-40B4-BE49-F238E27FC236}">
                <a16:creationId xmlns:a16="http://schemas.microsoft.com/office/drawing/2014/main" id="{3D9CA86E-0332-4452-B729-E54474C27F2F}"/>
              </a:ext>
            </a:extLst>
          </p:cNvPr>
          <p:cNvGrpSpPr/>
          <p:nvPr userDrawn="1"/>
        </p:nvGrpSpPr>
        <p:grpSpPr>
          <a:xfrm>
            <a:off x="47096" y="6040468"/>
            <a:ext cx="8168924" cy="505212"/>
            <a:chOff x="57964" y="6040468"/>
            <a:chExt cx="10054060" cy="505212"/>
          </a:xfrm>
        </p:grpSpPr>
        <p:sp>
          <p:nvSpPr>
            <p:cNvPr id="119" name="Freeform: Shape 118">
              <a:extLst>
                <a:ext uri="{FF2B5EF4-FFF2-40B4-BE49-F238E27FC236}">
                  <a16:creationId xmlns:a16="http://schemas.microsoft.com/office/drawing/2014/main" id="{FBB5A79E-A673-4083-B350-775A277F3F18}"/>
                </a:ext>
              </a:extLst>
            </p:cNvPr>
            <p:cNvSpPr/>
            <p:nvPr/>
          </p:nvSpPr>
          <p:spPr>
            <a:xfrm>
              <a:off x="918490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3" name="Freeform: Shape 122">
              <a:extLst>
                <a:ext uri="{FF2B5EF4-FFF2-40B4-BE49-F238E27FC236}">
                  <a16:creationId xmlns:a16="http://schemas.microsoft.com/office/drawing/2014/main" id="{7314F4B8-9563-47B9-BA13-E917B36F7A1D}"/>
                </a:ext>
              </a:extLst>
            </p:cNvPr>
            <p:cNvSpPr/>
            <p:nvPr/>
          </p:nvSpPr>
          <p:spPr>
            <a:xfrm>
              <a:off x="918490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4" name="Freeform: Shape 123">
              <a:extLst>
                <a:ext uri="{FF2B5EF4-FFF2-40B4-BE49-F238E27FC236}">
                  <a16:creationId xmlns:a16="http://schemas.microsoft.com/office/drawing/2014/main" id="{E303E408-62FC-4C15-B556-62611CA3E64F}"/>
                </a:ext>
              </a:extLst>
            </p:cNvPr>
            <p:cNvSpPr/>
            <p:nvPr/>
          </p:nvSpPr>
          <p:spPr>
            <a:xfrm>
              <a:off x="918490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6" name="Freeform: Shape 125">
              <a:extLst>
                <a:ext uri="{FF2B5EF4-FFF2-40B4-BE49-F238E27FC236}">
                  <a16:creationId xmlns:a16="http://schemas.microsoft.com/office/drawing/2014/main" id="{F3879587-7221-44C7-9379-58125B709819}"/>
                </a:ext>
              </a:extLst>
            </p:cNvPr>
            <p:cNvSpPr/>
            <p:nvPr/>
          </p:nvSpPr>
          <p:spPr>
            <a:xfrm>
              <a:off x="932750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0" name="Freeform: Shape 129">
              <a:extLst>
                <a:ext uri="{FF2B5EF4-FFF2-40B4-BE49-F238E27FC236}">
                  <a16:creationId xmlns:a16="http://schemas.microsoft.com/office/drawing/2014/main" id="{F7D54071-55C5-4718-8A4A-D4A6A7EA3948}"/>
                </a:ext>
              </a:extLst>
            </p:cNvPr>
            <p:cNvSpPr/>
            <p:nvPr/>
          </p:nvSpPr>
          <p:spPr>
            <a:xfrm>
              <a:off x="932750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1" name="Freeform: Shape 130">
              <a:extLst>
                <a:ext uri="{FF2B5EF4-FFF2-40B4-BE49-F238E27FC236}">
                  <a16:creationId xmlns:a16="http://schemas.microsoft.com/office/drawing/2014/main" id="{6A601018-DD2A-4B51-B908-A7626B4D1FD9}"/>
                </a:ext>
              </a:extLst>
            </p:cNvPr>
            <p:cNvSpPr/>
            <p:nvPr/>
          </p:nvSpPr>
          <p:spPr>
            <a:xfrm>
              <a:off x="932750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3" name="Freeform: Shape 132">
              <a:extLst>
                <a:ext uri="{FF2B5EF4-FFF2-40B4-BE49-F238E27FC236}">
                  <a16:creationId xmlns:a16="http://schemas.microsoft.com/office/drawing/2014/main" id="{5F36B160-117D-4E4E-BF02-6D207613022B}"/>
                </a:ext>
              </a:extLst>
            </p:cNvPr>
            <p:cNvSpPr/>
            <p:nvPr/>
          </p:nvSpPr>
          <p:spPr>
            <a:xfrm>
              <a:off x="947017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7" name="Freeform: Shape 136">
              <a:extLst>
                <a:ext uri="{FF2B5EF4-FFF2-40B4-BE49-F238E27FC236}">
                  <a16:creationId xmlns:a16="http://schemas.microsoft.com/office/drawing/2014/main" id="{C299758A-84AF-48E4-A6B3-8BDA303CFC4C}"/>
                </a:ext>
              </a:extLst>
            </p:cNvPr>
            <p:cNvSpPr/>
            <p:nvPr/>
          </p:nvSpPr>
          <p:spPr>
            <a:xfrm>
              <a:off x="947017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8" name="Freeform: Shape 137">
              <a:extLst>
                <a:ext uri="{FF2B5EF4-FFF2-40B4-BE49-F238E27FC236}">
                  <a16:creationId xmlns:a16="http://schemas.microsoft.com/office/drawing/2014/main" id="{D877352E-FCC3-43A9-854D-49E30B67A212}"/>
                </a:ext>
              </a:extLst>
            </p:cNvPr>
            <p:cNvSpPr/>
            <p:nvPr/>
          </p:nvSpPr>
          <p:spPr>
            <a:xfrm>
              <a:off x="947017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0" name="Freeform: Shape 139">
              <a:extLst>
                <a:ext uri="{FF2B5EF4-FFF2-40B4-BE49-F238E27FC236}">
                  <a16:creationId xmlns:a16="http://schemas.microsoft.com/office/drawing/2014/main" id="{E2ECC865-A0A2-475A-AFD1-E02D5FC45FB1}"/>
                </a:ext>
              </a:extLst>
            </p:cNvPr>
            <p:cNvSpPr/>
            <p:nvPr/>
          </p:nvSpPr>
          <p:spPr>
            <a:xfrm>
              <a:off x="961277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4" name="Freeform: Shape 143">
              <a:extLst>
                <a:ext uri="{FF2B5EF4-FFF2-40B4-BE49-F238E27FC236}">
                  <a16:creationId xmlns:a16="http://schemas.microsoft.com/office/drawing/2014/main" id="{ACADF418-FAA8-4F33-93E5-FB38F5F04370}"/>
                </a:ext>
              </a:extLst>
            </p:cNvPr>
            <p:cNvSpPr/>
            <p:nvPr/>
          </p:nvSpPr>
          <p:spPr>
            <a:xfrm>
              <a:off x="961277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5" name="Freeform: Shape 144">
              <a:extLst>
                <a:ext uri="{FF2B5EF4-FFF2-40B4-BE49-F238E27FC236}">
                  <a16:creationId xmlns:a16="http://schemas.microsoft.com/office/drawing/2014/main" id="{29E39FFB-F607-45FF-B525-9FBA42B84515}"/>
                </a:ext>
              </a:extLst>
            </p:cNvPr>
            <p:cNvSpPr/>
            <p:nvPr/>
          </p:nvSpPr>
          <p:spPr>
            <a:xfrm>
              <a:off x="961277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7" name="Freeform: Shape 146">
              <a:extLst>
                <a:ext uri="{FF2B5EF4-FFF2-40B4-BE49-F238E27FC236}">
                  <a16:creationId xmlns:a16="http://schemas.microsoft.com/office/drawing/2014/main" id="{FF37CDEA-044B-46DE-A9B3-C1BC4A74AEE5}"/>
                </a:ext>
              </a:extLst>
            </p:cNvPr>
            <p:cNvSpPr/>
            <p:nvPr/>
          </p:nvSpPr>
          <p:spPr>
            <a:xfrm>
              <a:off x="975545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1" name="Freeform: Shape 150">
              <a:extLst>
                <a:ext uri="{FF2B5EF4-FFF2-40B4-BE49-F238E27FC236}">
                  <a16:creationId xmlns:a16="http://schemas.microsoft.com/office/drawing/2014/main" id="{883BEC52-1805-43EB-850F-A4FC16FED475}"/>
                </a:ext>
              </a:extLst>
            </p:cNvPr>
            <p:cNvSpPr/>
            <p:nvPr/>
          </p:nvSpPr>
          <p:spPr>
            <a:xfrm>
              <a:off x="975545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2" name="Freeform: Shape 151">
              <a:extLst>
                <a:ext uri="{FF2B5EF4-FFF2-40B4-BE49-F238E27FC236}">
                  <a16:creationId xmlns:a16="http://schemas.microsoft.com/office/drawing/2014/main" id="{F44B94CB-22BD-4C04-B55A-3D7CD110B22E}"/>
                </a:ext>
              </a:extLst>
            </p:cNvPr>
            <p:cNvSpPr/>
            <p:nvPr/>
          </p:nvSpPr>
          <p:spPr>
            <a:xfrm>
              <a:off x="975545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4" name="Freeform: Shape 153">
              <a:extLst>
                <a:ext uri="{FF2B5EF4-FFF2-40B4-BE49-F238E27FC236}">
                  <a16:creationId xmlns:a16="http://schemas.microsoft.com/office/drawing/2014/main" id="{4F174AC2-9247-499D-ADB9-AA882FB75AF7}"/>
                </a:ext>
              </a:extLst>
            </p:cNvPr>
            <p:cNvSpPr/>
            <p:nvPr/>
          </p:nvSpPr>
          <p:spPr>
            <a:xfrm>
              <a:off x="989812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8" name="Freeform: Shape 157">
              <a:extLst>
                <a:ext uri="{FF2B5EF4-FFF2-40B4-BE49-F238E27FC236}">
                  <a16:creationId xmlns:a16="http://schemas.microsoft.com/office/drawing/2014/main" id="{4CDFCD77-B492-457F-A3E1-BEFA542C038D}"/>
                </a:ext>
              </a:extLst>
            </p:cNvPr>
            <p:cNvSpPr/>
            <p:nvPr/>
          </p:nvSpPr>
          <p:spPr>
            <a:xfrm>
              <a:off x="989812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2" name="Freeform: Shape 161">
              <a:extLst>
                <a:ext uri="{FF2B5EF4-FFF2-40B4-BE49-F238E27FC236}">
                  <a16:creationId xmlns:a16="http://schemas.microsoft.com/office/drawing/2014/main" id="{3E300686-D5D8-482A-8202-AF942FA89E8C}"/>
                </a:ext>
              </a:extLst>
            </p:cNvPr>
            <p:cNvSpPr/>
            <p:nvPr/>
          </p:nvSpPr>
          <p:spPr>
            <a:xfrm>
              <a:off x="1004072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4" name="Freeform: Shape 163">
              <a:extLst>
                <a:ext uri="{FF2B5EF4-FFF2-40B4-BE49-F238E27FC236}">
                  <a16:creationId xmlns:a16="http://schemas.microsoft.com/office/drawing/2014/main" id="{791F1B89-92BD-4C9C-914F-87165F4229BB}"/>
                </a:ext>
              </a:extLst>
            </p:cNvPr>
            <p:cNvSpPr/>
            <p:nvPr/>
          </p:nvSpPr>
          <p:spPr>
            <a:xfrm>
              <a:off x="1004072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9" name="Freeform: Shape 38">
              <a:extLst>
                <a:ext uri="{FF2B5EF4-FFF2-40B4-BE49-F238E27FC236}">
                  <a16:creationId xmlns:a16="http://schemas.microsoft.com/office/drawing/2014/main" id="{5D038036-E487-4CEC-B6CF-FBE40EEC150E}"/>
                </a:ext>
              </a:extLst>
            </p:cNvPr>
            <p:cNvSpPr/>
            <p:nvPr/>
          </p:nvSpPr>
          <p:spPr>
            <a:xfrm>
              <a:off x="504825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0" name="Freeform: Shape 39">
              <a:extLst>
                <a:ext uri="{FF2B5EF4-FFF2-40B4-BE49-F238E27FC236}">
                  <a16:creationId xmlns:a16="http://schemas.microsoft.com/office/drawing/2014/main" id="{61BEA055-6200-4675-94DA-4F96012054A3}"/>
                </a:ext>
              </a:extLst>
            </p:cNvPr>
            <p:cNvSpPr/>
            <p:nvPr/>
          </p:nvSpPr>
          <p:spPr>
            <a:xfrm>
              <a:off x="761578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1" name="Freeform: Shape 40">
              <a:extLst>
                <a:ext uri="{FF2B5EF4-FFF2-40B4-BE49-F238E27FC236}">
                  <a16:creationId xmlns:a16="http://schemas.microsoft.com/office/drawing/2014/main" id="{D879A564-9B06-4425-B6D0-989F39B8CCB4}"/>
                </a:ext>
              </a:extLst>
            </p:cNvPr>
            <p:cNvSpPr/>
            <p:nvPr/>
          </p:nvSpPr>
          <p:spPr>
            <a:xfrm>
              <a:off x="504825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2" name="Freeform: Shape 41">
              <a:extLst>
                <a:ext uri="{FF2B5EF4-FFF2-40B4-BE49-F238E27FC236}">
                  <a16:creationId xmlns:a16="http://schemas.microsoft.com/office/drawing/2014/main" id="{793DB27F-D22A-4598-8FA0-76A9F930DB4F}"/>
                </a:ext>
              </a:extLst>
            </p:cNvPr>
            <p:cNvSpPr/>
            <p:nvPr/>
          </p:nvSpPr>
          <p:spPr>
            <a:xfrm>
              <a:off x="504825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3" name="Freeform: Shape 42">
              <a:extLst>
                <a:ext uri="{FF2B5EF4-FFF2-40B4-BE49-F238E27FC236}">
                  <a16:creationId xmlns:a16="http://schemas.microsoft.com/office/drawing/2014/main" id="{3D639325-E72D-4983-84C4-A9583BCD7840}"/>
                </a:ext>
              </a:extLst>
            </p:cNvPr>
            <p:cNvSpPr/>
            <p:nvPr/>
          </p:nvSpPr>
          <p:spPr>
            <a:xfrm>
              <a:off x="504825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4" name="Freeform: Shape 43">
              <a:extLst>
                <a:ext uri="{FF2B5EF4-FFF2-40B4-BE49-F238E27FC236}">
                  <a16:creationId xmlns:a16="http://schemas.microsoft.com/office/drawing/2014/main" id="{9B602F2D-73AC-4148-805C-4104095B98F0}"/>
                </a:ext>
              </a:extLst>
            </p:cNvPr>
            <p:cNvSpPr/>
            <p:nvPr/>
          </p:nvSpPr>
          <p:spPr>
            <a:xfrm>
              <a:off x="761578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5" name="Freeform: Shape 44">
              <a:extLst>
                <a:ext uri="{FF2B5EF4-FFF2-40B4-BE49-F238E27FC236}">
                  <a16:creationId xmlns:a16="http://schemas.microsoft.com/office/drawing/2014/main" id="{93B0E366-3CAC-4067-AAE8-14089D978935}"/>
                </a:ext>
              </a:extLst>
            </p:cNvPr>
            <p:cNvSpPr/>
            <p:nvPr/>
          </p:nvSpPr>
          <p:spPr>
            <a:xfrm>
              <a:off x="761578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6" name="Freeform: Shape 45">
              <a:extLst>
                <a:ext uri="{FF2B5EF4-FFF2-40B4-BE49-F238E27FC236}">
                  <a16:creationId xmlns:a16="http://schemas.microsoft.com/office/drawing/2014/main" id="{928422A2-39FD-4302-BD2E-C41B8C5B6F43}"/>
                </a:ext>
              </a:extLst>
            </p:cNvPr>
            <p:cNvSpPr/>
            <p:nvPr/>
          </p:nvSpPr>
          <p:spPr>
            <a:xfrm>
              <a:off x="761578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7" name="Freeform: Shape 46">
              <a:extLst>
                <a:ext uri="{FF2B5EF4-FFF2-40B4-BE49-F238E27FC236}">
                  <a16:creationId xmlns:a16="http://schemas.microsoft.com/office/drawing/2014/main" id="{A5178749-DA3F-457C-B11C-3D8A66D558E2}"/>
                </a:ext>
              </a:extLst>
            </p:cNvPr>
            <p:cNvSpPr/>
            <p:nvPr/>
          </p:nvSpPr>
          <p:spPr>
            <a:xfrm>
              <a:off x="533352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8" name="Freeform: Shape 47">
              <a:extLst>
                <a:ext uri="{FF2B5EF4-FFF2-40B4-BE49-F238E27FC236}">
                  <a16:creationId xmlns:a16="http://schemas.microsoft.com/office/drawing/2014/main" id="{8CCF38D3-E377-4642-ACF2-A2941FB6D6C9}"/>
                </a:ext>
              </a:extLst>
            </p:cNvPr>
            <p:cNvSpPr/>
            <p:nvPr/>
          </p:nvSpPr>
          <p:spPr>
            <a:xfrm>
              <a:off x="790106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9" name="Freeform: Shape 48">
              <a:extLst>
                <a:ext uri="{FF2B5EF4-FFF2-40B4-BE49-F238E27FC236}">
                  <a16:creationId xmlns:a16="http://schemas.microsoft.com/office/drawing/2014/main" id="{49E03297-F590-47A8-9224-9DE9CD7BE3B7}"/>
                </a:ext>
              </a:extLst>
            </p:cNvPr>
            <p:cNvSpPr/>
            <p:nvPr/>
          </p:nvSpPr>
          <p:spPr>
            <a:xfrm>
              <a:off x="533352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0" name="Freeform: Shape 49">
              <a:extLst>
                <a:ext uri="{FF2B5EF4-FFF2-40B4-BE49-F238E27FC236}">
                  <a16:creationId xmlns:a16="http://schemas.microsoft.com/office/drawing/2014/main" id="{59765AFA-AA6D-47A9-A557-DF1383D5DFAC}"/>
                </a:ext>
              </a:extLst>
            </p:cNvPr>
            <p:cNvSpPr/>
            <p:nvPr/>
          </p:nvSpPr>
          <p:spPr>
            <a:xfrm>
              <a:off x="533352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1" name="Freeform: Shape 50">
              <a:extLst>
                <a:ext uri="{FF2B5EF4-FFF2-40B4-BE49-F238E27FC236}">
                  <a16:creationId xmlns:a16="http://schemas.microsoft.com/office/drawing/2014/main" id="{E04551E8-FBDA-42A5-B5F1-ACCD3F76AE95}"/>
                </a:ext>
              </a:extLst>
            </p:cNvPr>
            <p:cNvSpPr/>
            <p:nvPr/>
          </p:nvSpPr>
          <p:spPr>
            <a:xfrm>
              <a:off x="533352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2" name="Freeform: Shape 51">
              <a:extLst>
                <a:ext uri="{FF2B5EF4-FFF2-40B4-BE49-F238E27FC236}">
                  <a16:creationId xmlns:a16="http://schemas.microsoft.com/office/drawing/2014/main" id="{C568421F-7044-4A10-A1FE-923CBA6A707E}"/>
                </a:ext>
              </a:extLst>
            </p:cNvPr>
            <p:cNvSpPr/>
            <p:nvPr/>
          </p:nvSpPr>
          <p:spPr>
            <a:xfrm>
              <a:off x="790106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3" name="Freeform: Shape 52">
              <a:extLst>
                <a:ext uri="{FF2B5EF4-FFF2-40B4-BE49-F238E27FC236}">
                  <a16:creationId xmlns:a16="http://schemas.microsoft.com/office/drawing/2014/main" id="{C8BBBC79-DA74-48CA-9B28-0D6327686B9E}"/>
                </a:ext>
              </a:extLst>
            </p:cNvPr>
            <p:cNvSpPr/>
            <p:nvPr/>
          </p:nvSpPr>
          <p:spPr>
            <a:xfrm>
              <a:off x="790106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4" name="Freeform: Shape 53">
              <a:extLst>
                <a:ext uri="{FF2B5EF4-FFF2-40B4-BE49-F238E27FC236}">
                  <a16:creationId xmlns:a16="http://schemas.microsoft.com/office/drawing/2014/main" id="{98E55AC3-5E3D-4EB4-BDA2-EDAC7E18D945}"/>
                </a:ext>
              </a:extLst>
            </p:cNvPr>
            <p:cNvSpPr/>
            <p:nvPr/>
          </p:nvSpPr>
          <p:spPr>
            <a:xfrm>
              <a:off x="790106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5" name="Freeform: Shape 54">
              <a:extLst>
                <a:ext uri="{FF2B5EF4-FFF2-40B4-BE49-F238E27FC236}">
                  <a16:creationId xmlns:a16="http://schemas.microsoft.com/office/drawing/2014/main" id="{3315EEF4-E395-4F39-84F6-C28BAE920118}"/>
                </a:ext>
              </a:extLst>
            </p:cNvPr>
            <p:cNvSpPr/>
            <p:nvPr/>
          </p:nvSpPr>
          <p:spPr>
            <a:xfrm>
              <a:off x="547619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6" name="Freeform: Shape 55">
              <a:extLst>
                <a:ext uri="{FF2B5EF4-FFF2-40B4-BE49-F238E27FC236}">
                  <a16:creationId xmlns:a16="http://schemas.microsoft.com/office/drawing/2014/main" id="{731F4630-1F40-4203-9A22-5F05D897A7B1}"/>
                </a:ext>
              </a:extLst>
            </p:cNvPr>
            <p:cNvSpPr/>
            <p:nvPr/>
          </p:nvSpPr>
          <p:spPr>
            <a:xfrm>
              <a:off x="804373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7" name="Freeform: Shape 56">
              <a:extLst>
                <a:ext uri="{FF2B5EF4-FFF2-40B4-BE49-F238E27FC236}">
                  <a16:creationId xmlns:a16="http://schemas.microsoft.com/office/drawing/2014/main" id="{C0C56C64-7D81-4F10-BACF-1AFCA2F7FBD1}"/>
                </a:ext>
              </a:extLst>
            </p:cNvPr>
            <p:cNvSpPr/>
            <p:nvPr/>
          </p:nvSpPr>
          <p:spPr>
            <a:xfrm>
              <a:off x="547619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8" name="Freeform: Shape 57">
              <a:extLst>
                <a:ext uri="{FF2B5EF4-FFF2-40B4-BE49-F238E27FC236}">
                  <a16:creationId xmlns:a16="http://schemas.microsoft.com/office/drawing/2014/main" id="{FAA06042-8415-4B14-B81F-FD50C8700DAC}"/>
                </a:ext>
              </a:extLst>
            </p:cNvPr>
            <p:cNvSpPr/>
            <p:nvPr/>
          </p:nvSpPr>
          <p:spPr>
            <a:xfrm>
              <a:off x="547619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9" name="Freeform: Shape 58">
              <a:extLst>
                <a:ext uri="{FF2B5EF4-FFF2-40B4-BE49-F238E27FC236}">
                  <a16:creationId xmlns:a16="http://schemas.microsoft.com/office/drawing/2014/main" id="{7E195C8E-6A70-48CB-AA84-2688EFF2A034}"/>
                </a:ext>
              </a:extLst>
            </p:cNvPr>
            <p:cNvSpPr/>
            <p:nvPr/>
          </p:nvSpPr>
          <p:spPr>
            <a:xfrm>
              <a:off x="547619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0" name="Freeform: Shape 59">
              <a:extLst>
                <a:ext uri="{FF2B5EF4-FFF2-40B4-BE49-F238E27FC236}">
                  <a16:creationId xmlns:a16="http://schemas.microsoft.com/office/drawing/2014/main" id="{1BD0DEF4-0837-4D4A-98A6-594F4D6E380D}"/>
                </a:ext>
              </a:extLst>
            </p:cNvPr>
            <p:cNvSpPr/>
            <p:nvPr/>
          </p:nvSpPr>
          <p:spPr>
            <a:xfrm>
              <a:off x="804373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1" name="Freeform: Shape 60">
              <a:extLst>
                <a:ext uri="{FF2B5EF4-FFF2-40B4-BE49-F238E27FC236}">
                  <a16:creationId xmlns:a16="http://schemas.microsoft.com/office/drawing/2014/main" id="{486D3C23-3579-43BB-B707-2E0420EB5940}"/>
                </a:ext>
              </a:extLst>
            </p:cNvPr>
            <p:cNvSpPr/>
            <p:nvPr/>
          </p:nvSpPr>
          <p:spPr>
            <a:xfrm>
              <a:off x="804373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2" name="Freeform: Shape 61">
              <a:extLst>
                <a:ext uri="{FF2B5EF4-FFF2-40B4-BE49-F238E27FC236}">
                  <a16:creationId xmlns:a16="http://schemas.microsoft.com/office/drawing/2014/main" id="{4A299754-769E-4797-AB87-DB343571428B}"/>
                </a:ext>
              </a:extLst>
            </p:cNvPr>
            <p:cNvSpPr/>
            <p:nvPr/>
          </p:nvSpPr>
          <p:spPr>
            <a:xfrm>
              <a:off x="804373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3" name="Freeform: Shape 62">
              <a:extLst>
                <a:ext uri="{FF2B5EF4-FFF2-40B4-BE49-F238E27FC236}">
                  <a16:creationId xmlns:a16="http://schemas.microsoft.com/office/drawing/2014/main" id="{FA71463F-9F61-4C0C-80A6-F5309D183561}"/>
                </a:ext>
              </a:extLst>
            </p:cNvPr>
            <p:cNvSpPr/>
            <p:nvPr/>
          </p:nvSpPr>
          <p:spPr>
            <a:xfrm>
              <a:off x="561879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4" name="Freeform: Shape 63">
              <a:extLst>
                <a:ext uri="{FF2B5EF4-FFF2-40B4-BE49-F238E27FC236}">
                  <a16:creationId xmlns:a16="http://schemas.microsoft.com/office/drawing/2014/main" id="{5253B8DE-C202-46A5-BB84-BE2085B413DE}"/>
                </a:ext>
              </a:extLst>
            </p:cNvPr>
            <p:cNvSpPr/>
            <p:nvPr/>
          </p:nvSpPr>
          <p:spPr>
            <a:xfrm>
              <a:off x="818640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" name="Freeform: Shape 64">
              <a:extLst>
                <a:ext uri="{FF2B5EF4-FFF2-40B4-BE49-F238E27FC236}">
                  <a16:creationId xmlns:a16="http://schemas.microsoft.com/office/drawing/2014/main" id="{2BF04809-F482-4FF4-A92F-4D3F088B9325}"/>
                </a:ext>
              </a:extLst>
            </p:cNvPr>
            <p:cNvSpPr/>
            <p:nvPr/>
          </p:nvSpPr>
          <p:spPr>
            <a:xfrm>
              <a:off x="561879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" name="Freeform: Shape 65">
              <a:extLst>
                <a:ext uri="{FF2B5EF4-FFF2-40B4-BE49-F238E27FC236}">
                  <a16:creationId xmlns:a16="http://schemas.microsoft.com/office/drawing/2014/main" id="{0E2612AA-0DAA-4CE4-A4FC-2CD8E3675650}"/>
                </a:ext>
              </a:extLst>
            </p:cNvPr>
            <p:cNvSpPr/>
            <p:nvPr/>
          </p:nvSpPr>
          <p:spPr>
            <a:xfrm>
              <a:off x="561879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" name="Freeform: Shape 66">
              <a:extLst>
                <a:ext uri="{FF2B5EF4-FFF2-40B4-BE49-F238E27FC236}">
                  <a16:creationId xmlns:a16="http://schemas.microsoft.com/office/drawing/2014/main" id="{14224439-8340-4ED6-81A7-18FFF744DABF}"/>
                </a:ext>
              </a:extLst>
            </p:cNvPr>
            <p:cNvSpPr/>
            <p:nvPr/>
          </p:nvSpPr>
          <p:spPr>
            <a:xfrm>
              <a:off x="561879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" name="Freeform: Shape 67">
              <a:extLst>
                <a:ext uri="{FF2B5EF4-FFF2-40B4-BE49-F238E27FC236}">
                  <a16:creationId xmlns:a16="http://schemas.microsoft.com/office/drawing/2014/main" id="{5E85F2ED-72FE-45ED-AEC5-B32ED10C5DC2}"/>
                </a:ext>
              </a:extLst>
            </p:cNvPr>
            <p:cNvSpPr/>
            <p:nvPr/>
          </p:nvSpPr>
          <p:spPr>
            <a:xfrm>
              <a:off x="818640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" name="Freeform: Shape 68">
              <a:extLst>
                <a:ext uri="{FF2B5EF4-FFF2-40B4-BE49-F238E27FC236}">
                  <a16:creationId xmlns:a16="http://schemas.microsoft.com/office/drawing/2014/main" id="{0C2D1743-32B6-419C-A5EE-D234880371A1}"/>
                </a:ext>
              </a:extLst>
            </p:cNvPr>
            <p:cNvSpPr/>
            <p:nvPr/>
          </p:nvSpPr>
          <p:spPr>
            <a:xfrm>
              <a:off x="818640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" name="Freeform: Shape 69">
              <a:extLst>
                <a:ext uri="{FF2B5EF4-FFF2-40B4-BE49-F238E27FC236}">
                  <a16:creationId xmlns:a16="http://schemas.microsoft.com/office/drawing/2014/main" id="{19C38E51-0804-4A8C-83C4-7615E2F2EC9C}"/>
                </a:ext>
              </a:extLst>
            </p:cNvPr>
            <p:cNvSpPr/>
            <p:nvPr/>
          </p:nvSpPr>
          <p:spPr>
            <a:xfrm>
              <a:off x="818640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" name="Freeform: Shape 70">
              <a:extLst>
                <a:ext uri="{FF2B5EF4-FFF2-40B4-BE49-F238E27FC236}">
                  <a16:creationId xmlns:a16="http://schemas.microsoft.com/office/drawing/2014/main" id="{D12965FA-0901-4D9B-B1B3-E79AC56A3641}"/>
                </a:ext>
              </a:extLst>
            </p:cNvPr>
            <p:cNvSpPr/>
            <p:nvPr/>
          </p:nvSpPr>
          <p:spPr>
            <a:xfrm>
              <a:off x="576147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" name="Freeform: Shape 71">
              <a:extLst>
                <a:ext uri="{FF2B5EF4-FFF2-40B4-BE49-F238E27FC236}">
                  <a16:creationId xmlns:a16="http://schemas.microsoft.com/office/drawing/2014/main" id="{E8458EAA-C378-4BEF-A643-6923127E7B54}"/>
                </a:ext>
              </a:extLst>
            </p:cNvPr>
            <p:cNvSpPr/>
            <p:nvPr/>
          </p:nvSpPr>
          <p:spPr>
            <a:xfrm>
              <a:off x="832900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" name="Freeform: Shape 72">
              <a:extLst>
                <a:ext uri="{FF2B5EF4-FFF2-40B4-BE49-F238E27FC236}">
                  <a16:creationId xmlns:a16="http://schemas.microsoft.com/office/drawing/2014/main" id="{F30BBCC6-DABB-4D52-A6C9-66388994E0A7}"/>
                </a:ext>
              </a:extLst>
            </p:cNvPr>
            <p:cNvSpPr/>
            <p:nvPr/>
          </p:nvSpPr>
          <p:spPr>
            <a:xfrm>
              <a:off x="576147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" name="Freeform: Shape 73">
              <a:extLst>
                <a:ext uri="{FF2B5EF4-FFF2-40B4-BE49-F238E27FC236}">
                  <a16:creationId xmlns:a16="http://schemas.microsoft.com/office/drawing/2014/main" id="{522B12BD-017E-490A-88B8-A5118F05E384}"/>
                </a:ext>
              </a:extLst>
            </p:cNvPr>
            <p:cNvSpPr/>
            <p:nvPr/>
          </p:nvSpPr>
          <p:spPr>
            <a:xfrm>
              <a:off x="576147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" name="Freeform: Shape 74">
              <a:extLst>
                <a:ext uri="{FF2B5EF4-FFF2-40B4-BE49-F238E27FC236}">
                  <a16:creationId xmlns:a16="http://schemas.microsoft.com/office/drawing/2014/main" id="{1B33745F-3DB7-4F47-88A8-21343291EA19}"/>
                </a:ext>
              </a:extLst>
            </p:cNvPr>
            <p:cNvSpPr/>
            <p:nvPr/>
          </p:nvSpPr>
          <p:spPr>
            <a:xfrm>
              <a:off x="576147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" name="Freeform: Shape 75">
              <a:extLst>
                <a:ext uri="{FF2B5EF4-FFF2-40B4-BE49-F238E27FC236}">
                  <a16:creationId xmlns:a16="http://schemas.microsoft.com/office/drawing/2014/main" id="{E218D883-BFD1-4D9C-A0C3-2E85FE22E65F}"/>
                </a:ext>
              </a:extLst>
            </p:cNvPr>
            <p:cNvSpPr/>
            <p:nvPr/>
          </p:nvSpPr>
          <p:spPr>
            <a:xfrm>
              <a:off x="832900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" name="Freeform: Shape 76">
              <a:extLst>
                <a:ext uri="{FF2B5EF4-FFF2-40B4-BE49-F238E27FC236}">
                  <a16:creationId xmlns:a16="http://schemas.microsoft.com/office/drawing/2014/main" id="{A3D2871E-F2F7-431F-B864-00084831F3B6}"/>
                </a:ext>
              </a:extLst>
            </p:cNvPr>
            <p:cNvSpPr/>
            <p:nvPr/>
          </p:nvSpPr>
          <p:spPr>
            <a:xfrm>
              <a:off x="832900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" name="Freeform: Shape 77">
              <a:extLst>
                <a:ext uri="{FF2B5EF4-FFF2-40B4-BE49-F238E27FC236}">
                  <a16:creationId xmlns:a16="http://schemas.microsoft.com/office/drawing/2014/main" id="{09913F84-6815-4D23-9000-820F299CE932}"/>
                </a:ext>
              </a:extLst>
            </p:cNvPr>
            <p:cNvSpPr/>
            <p:nvPr/>
          </p:nvSpPr>
          <p:spPr>
            <a:xfrm>
              <a:off x="832900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" name="Freeform: Shape 78">
              <a:extLst>
                <a:ext uri="{FF2B5EF4-FFF2-40B4-BE49-F238E27FC236}">
                  <a16:creationId xmlns:a16="http://schemas.microsoft.com/office/drawing/2014/main" id="{96C68A4B-2BD2-477F-A5FF-39486FC1A0B5}"/>
                </a:ext>
              </a:extLst>
            </p:cNvPr>
            <p:cNvSpPr/>
            <p:nvPr/>
          </p:nvSpPr>
          <p:spPr>
            <a:xfrm>
              <a:off x="590407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" name="Freeform: Shape 79">
              <a:extLst>
                <a:ext uri="{FF2B5EF4-FFF2-40B4-BE49-F238E27FC236}">
                  <a16:creationId xmlns:a16="http://schemas.microsoft.com/office/drawing/2014/main" id="{E021036E-9FFC-4167-98DD-2E58A9E870A5}"/>
                </a:ext>
              </a:extLst>
            </p:cNvPr>
            <p:cNvSpPr/>
            <p:nvPr/>
          </p:nvSpPr>
          <p:spPr>
            <a:xfrm>
              <a:off x="847168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" name="Freeform: Shape 80">
              <a:extLst>
                <a:ext uri="{FF2B5EF4-FFF2-40B4-BE49-F238E27FC236}">
                  <a16:creationId xmlns:a16="http://schemas.microsoft.com/office/drawing/2014/main" id="{DA72E3A2-A47B-4EA9-A86A-83FBABB8E592}"/>
                </a:ext>
              </a:extLst>
            </p:cNvPr>
            <p:cNvSpPr/>
            <p:nvPr/>
          </p:nvSpPr>
          <p:spPr>
            <a:xfrm>
              <a:off x="590407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" name="Freeform: Shape 81">
              <a:extLst>
                <a:ext uri="{FF2B5EF4-FFF2-40B4-BE49-F238E27FC236}">
                  <a16:creationId xmlns:a16="http://schemas.microsoft.com/office/drawing/2014/main" id="{F91B2307-41FE-4C47-BF22-F074AF9AC3DC}"/>
                </a:ext>
              </a:extLst>
            </p:cNvPr>
            <p:cNvSpPr/>
            <p:nvPr/>
          </p:nvSpPr>
          <p:spPr>
            <a:xfrm>
              <a:off x="590407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" name="Freeform: Shape 82">
              <a:extLst>
                <a:ext uri="{FF2B5EF4-FFF2-40B4-BE49-F238E27FC236}">
                  <a16:creationId xmlns:a16="http://schemas.microsoft.com/office/drawing/2014/main" id="{13378EB6-BA15-4CF1-B935-B2039EFDFFE8}"/>
                </a:ext>
              </a:extLst>
            </p:cNvPr>
            <p:cNvSpPr/>
            <p:nvPr/>
          </p:nvSpPr>
          <p:spPr>
            <a:xfrm>
              <a:off x="590407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" name="Freeform: Shape 83">
              <a:extLst>
                <a:ext uri="{FF2B5EF4-FFF2-40B4-BE49-F238E27FC236}">
                  <a16:creationId xmlns:a16="http://schemas.microsoft.com/office/drawing/2014/main" id="{F0989A68-5462-47EB-88A6-13C68CDC5CEF}"/>
                </a:ext>
              </a:extLst>
            </p:cNvPr>
            <p:cNvSpPr/>
            <p:nvPr/>
          </p:nvSpPr>
          <p:spPr>
            <a:xfrm>
              <a:off x="847168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" name="Freeform: Shape 84">
              <a:extLst>
                <a:ext uri="{FF2B5EF4-FFF2-40B4-BE49-F238E27FC236}">
                  <a16:creationId xmlns:a16="http://schemas.microsoft.com/office/drawing/2014/main" id="{D9648252-04C1-4420-B7F4-07D90BF0A632}"/>
                </a:ext>
              </a:extLst>
            </p:cNvPr>
            <p:cNvSpPr/>
            <p:nvPr/>
          </p:nvSpPr>
          <p:spPr>
            <a:xfrm>
              <a:off x="847168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" name="Freeform: Shape 85">
              <a:extLst>
                <a:ext uri="{FF2B5EF4-FFF2-40B4-BE49-F238E27FC236}">
                  <a16:creationId xmlns:a16="http://schemas.microsoft.com/office/drawing/2014/main" id="{14AC37F7-89BD-4FAF-A5F2-62C1A580C02F}"/>
                </a:ext>
              </a:extLst>
            </p:cNvPr>
            <p:cNvSpPr/>
            <p:nvPr/>
          </p:nvSpPr>
          <p:spPr>
            <a:xfrm>
              <a:off x="604674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" name="Freeform: Shape 86">
              <a:extLst>
                <a:ext uri="{FF2B5EF4-FFF2-40B4-BE49-F238E27FC236}">
                  <a16:creationId xmlns:a16="http://schemas.microsoft.com/office/drawing/2014/main" id="{3D481774-0D5F-4191-B7A3-BD1EFF21CD77}"/>
                </a:ext>
              </a:extLst>
            </p:cNvPr>
            <p:cNvSpPr/>
            <p:nvPr/>
          </p:nvSpPr>
          <p:spPr>
            <a:xfrm>
              <a:off x="861428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" name="Freeform: Shape 87">
              <a:extLst>
                <a:ext uri="{FF2B5EF4-FFF2-40B4-BE49-F238E27FC236}">
                  <a16:creationId xmlns:a16="http://schemas.microsoft.com/office/drawing/2014/main" id="{9A5647BF-3899-449D-9C82-15C6FEE40713}"/>
                </a:ext>
              </a:extLst>
            </p:cNvPr>
            <p:cNvSpPr/>
            <p:nvPr/>
          </p:nvSpPr>
          <p:spPr>
            <a:xfrm>
              <a:off x="604674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" name="Freeform: Shape 88">
              <a:extLst>
                <a:ext uri="{FF2B5EF4-FFF2-40B4-BE49-F238E27FC236}">
                  <a16:creationId xmlns:a16="http://schemas.microsoft.com/office/drawing/2014/main" id="{6EFA414C-5F21-48DB-80BA-47EDA24CC0EB}"/>
                </a:ext>
              </a:extLst>
            </p:cNvPr>
            <p:cNvSpPr/>
            <p:nvPr/>
          </p:nvSpPr>
          <p:spPr>
            <a:xfrm>
              <a:off x="604674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" name="Freeform: Shape 89">
              <a:extLst>
                <a:ext uri="{FF2B5EF4-FFF2-40B4-BE49-F238E27FC236}">
                  <a16:creationId xmlns:a16="http://schemas.microsoft.com/office/drawing/2014/main" id="{13AD91C5-4441-4169-8C1A-5B112E1C0768}"/>
                </a:ext>
              </a:extLst>
            </p:cNvPr>
            <p:cNvSpPr/>
            <p:nvPr/>
          </p:nvSpPr>
          <p:spPr>
            <a:xfrm>
              <a:off x="604674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" name="Freeform: Shape 90">
              <a:extLst>
                <a:ext uri="{FF2B5EF4-FFF2-40B4-BE49-F238E27FC236}">
                  <a16:creationId xmlns:a16="http://schemas.microsoft.com/office/drawing/2014/main" id="{8A66D5BD-D5C6-4B1D-A38C-060603FBBB92}"/>
                </a:ext>
              </a:extLst>
            </p:cNvPr>
            <p:cNvSpPr/>
            <p:nvPr/>
          </p:nvSpPr>
          <p:spPr>
            <a:xfrm>
              <a:off x="861428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2" name="Freeform: Shape 91">
              <a:extLst>
                <a:ext uri="{FF2B5EF4-FFF2-40B4-BE49-F238E27FC236}">
                  <a16:creationId xmlns:a16="http://schemas.microsoft.com/office/drawing/2014/main" id="{2EE92EA5-0729-449E-8DF6-E3FAF8B11FB2}"/>
                </a:ext>
              </a:extLst>
            </p:cNvPr>
            <p:cNvSpPr/>
            <p:nvPr/>
          </p:nvSpPr>
          <p:spPr>
            <a:xfrm>
              <a:off x="861428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3" name="Freeform: Shape 92">
              <a:extLst>
                <a:ext uri="{FF2B5EF4-FFF2-40B4-BE49-F238E27FC236}">
                  <a16:creationId xmlns:a16="http://schemas.microsoft.com/office/drawing/2014/main" id="{67F2A1B1-9913-4F10-AC5B-019D0ED5F9E1}"/>
                </a:ext>
              </a:extLst>
            </p:cNvPr>
            <p:cNvSpPr/>
            <p:nvPr/>
          </p:nvSpPr>
          <p:spPr>
            <a:xfrm>
              <a:off x="861428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4" name="Freeform: Shape 93">
              <a:extLst>
                <a:ext uri="{FF2B5EF4-FFF2-40B4-BE49-F238E27FC236}">
                  <a16:creationId xmlns:a16="http://schemas.microsoft.com/office/drawing/2014/main" id="{01965D0E-EF06-4233-BD91-47DEDE9E68AA}"/>
                </a:ext>
              </a:extLst>
            </p:cNvPr>
            <p:cNvSpPr/>
            <p:nvPr/>
          </p:nvSpPr>
          <p:spPr>
            <a:xfrm>
              <a:off x="618941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5" name="Freeform: Shape 94">
              <a:extLst>
                <a:ext uri="{FF2B5EF4-FFF2-40B4-BE49-F238E27FC236}">
                  <a16:creationId xmlns:a16="http://schemas.microsoft.com/office/drawing/2014/main" id="{204B2D3B-CC51-4BF3-97BD-F5D06E1DD6F2}"/>
                </a:ext>
              </a:extLst>
            </p:cNvPr>
            <p:cNvSpPr/>
            <p:nvPr/>
          </p:nvSpPr>
          <p:spPr>
            <a:xfrm>
              <a:off x="875695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6" name="Freeform: Shape 95">
              <a:extLst>
                <a:ext uri="{FF2B5EF4-FFF2-40B4-BE49-F238E27FC236}">
                  <a16:creationId xmlns:a16="http://schemas.microsoft.com/office/drawing/2014/main" id="{4992508A-829F-45F0-A89F-412A52699F19}"/>
                </a:ext>
              </a:extLst>
            </p:cNvPr>
            <p:cNvSpPr/>
            <p:nvPr/>
          </p:nvSpPr>
          <p:spPr>
            <a:xfrm>
              <a:off x="618941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7" name="Freeform: Shape 96">
              <a:extLst>
                <a:ext uri="{FF2B5EF4-FFF2-40B4-BE49-F238E27FC236}">
                  <a16:creationId xmlns:a16="http://schemas.microsoft.com/office/drawing/2014/main" id="{4C3C7150-757E-4A52-88DB-44D014725CEE}"/>
                </a:ext>
              </a:extLst>
            </p:cNvPr>
            <p:cNvSpPr/>
            <p:nvPr/>
          </p:nvSpPr>
          <p:spPr>
            <a:xfrm>
              <a:off x="618941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8" name="Freeform: Shape 97">
              <a:extLst>
                <a:ext uri="{FF2B5EF4-FFF2-40B4-BE49-F238E27FC236}">
                  <a16:creationId xmlns:a16="http://schemas.microsoft.com/office/drawing/2014/main" id="{17D51A27-830B-4EB4-B363-122134EA2B44}"/>
                </a:ext>
              </a:extLst>
            </p:cNvPr>
            <p:cNvSpPr/>
            <p:nvPr/>
          </p:nvSpPr>
          <p:spPr>
            <a:xfrm>
              <a:off x="618941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9" name="Freeform: Shape 98">
              <a:extLst>
                <a:ext uri="{FF2B5EF4-FFF2-40B4-BE49-F238E27FC236}">
                  <a16:creationId xmlns:a16="http://schemas.microsoft.com/office/drawing/2014/main" id="{F7405B1D-9AB5-46C6-B76A-B8737B0F2F74}"/>
                </a:ext>
              </a:extLst>
            </p:cNvPr>
            <p:cNvSpPr/>
            <p:nvPr/>
          </p:nvSpPr>
          <p:spPr>
            <a:xfrm>
              <a:off x="875695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0" name="Freeform: Shape 99">
              <a:extLst>
                <a:ext uri="{FF2B5EF4-FFF2-40B4-BE49-F238E27FC236}">
                  <a16:creationId xmlns:a16="http://schemas.microsoft.com/office/drawing/2014/main" id="{66ED331E-1980-4E68-952E-EC03CD650AA7}"/>
                </a:ext>
              </a:extLst>
            </p:cNvPr>
            <p:cNvSpPr/>
            <p:nvPr/>
          </p:nvSpPr>
          <p:spPr>
            <a:xfrm>
              <a:off x="875695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1" name="Freeform: Shape 100">
              <a:extLst>
                <a:ext uri="{FF2B5EF4-FFF2-40B4-BE49-F238E27FC236}">
                  <a16:creationId xmlns:a16="http://schemas.microsoft.com/office/drawing/2014/main" id="{D690871E-79D8-48EF-B72E-35C9851C3936}"/>
                </a:ext>
              </a:extLst>
            </p:cNvPr>
            <p:cNvSpPr/>
            <p:nvPr/>
          </p:nvSpPr>
          <p:spPr>
            <a:xfrm>
              <a:off x="875695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2" name="Freeform: Shape 101">
              <a:extLst>
                <a:ext uri="{FF2B5EF4-FFF2-40B4-BE49-F238E27FC236}">
                  <a16:creationId xmlns:a16="http://schemas.microsoft.com/office/drawing/2014/main" id="{409B7C7A-0ADE-47E1-929E-12F8A6B5C097}"/>
                </a:ext>
              </a:extLst>
            </p:cNvPr>
            <p:cNvSpPr/>
            <p:nvPr/>
          </p:nvSpPr>
          <p:spPr>
            <a:xfrm>
              <a:off x="633201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3" name="Freeform: Shape 102">
              <a:extLst>
                <a:ext uri="{FF2B5EF4-FFF2-40B4-BE49-F238E27FC236}">
                  <a16:creationId xmlns:a16="http://schemas.microsoft.com/office/drawing/2014/main" id="{029CDFCF-B8C6-4D9A-BEF6-3B8D94582F29}"/>
                </a:ext>
              </a:extLst>
            </p:cNvPr>
            <p:cNvSpPr/>
            <p:nvPr/>
          </p:nvSpPr>
          <p:spPr>
            <a:xfrm>
              <a:off x="889962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4" name="Freeform: Shape 103">
              <a:extLst>
                <a:ext uri="{FF2B5EF4-FFF2-40B4-BE49-F238E27FC236}">
                  <a16:creationId xmlns:a16="http://schemas.microsoft.com/office/drawing/2014/main" id="{18320B64-F66B-4A92-A2AF-82BC6C42CA53}"/>
                </a:ext>
              </a:extLst>
            </p:cNvPr>
            <p:cNvSpPr/>
            <p:nvPr/>
          </p:nvSpPr>
          <p:spPr>
            <a:xfrm>
              <a:off x="633201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5" name="Freeform: Shape 104">
              <a:extLst>
                <a:ext uri="{FF2B5EF4-FFF2-40B4-BE49-F238E27FC236}">
                  <a16:creationId xmlns:a16="http://schemas.microsoft.com/office/drawing/2014/main" id="{EB44A32B-BE01-464D-9198-575AFC6C2E2E}"/>
                </a:ext>
              </a:extLst>
            </p:cNvPr>
            <p:cNvSpPr/>
            <p:nvPr/>
          </p:nvSpPr>
          <p:spPr>
            <a:xfrm>
              <a:off x="633201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6" name="Freeform: Shape 105">
              <a:extLst>
                <a:ext uri="{FF2B5EF4-FFF2-40B4-BE49-F238E27FC236}">
                  <a16:creationId xmlns:a16="http://schemas.microsoft.com/office/drawing/2014/main" id="{7CA954BA-5A74-4AAD-ABC4-176729FDE046}"/>
                </a:ext>
              </a:extLst>
            </p:cNvPr>
            <p:cNvSpPr/>
            <p:nvPr/>
          </p:nvSpPr>
          <p:spPr>
            <a:xfrm>
              <a:off x="633201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7" name="Freeform: Shape 106">
              <a:extLst>
                <a:ext uri="{FF2B5EF4-FFF2-40B4-BE49-F238E27FC236}">
                  <a16:creationId xmlns:a16="http://schemas.microsoft.com/office/drawing/2014/main" id="{80BC3E72-0EBD-4623-BF24-42969768F22A}"/>
                </a:ext>
              </a:extLst>
            </p:cNvPr>
            <p:cNvSpPr/>
            <p:nvPr/>
          </p:nvSpPr>
          <p:spPr>
            <a:xfrm>
              <a:off x="889962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8" name="Freeform: Shape 107">
              <a:extLst>
                <a:ext uri="{FF2B5EF4-FFF2-40B4-BE49-F238E27FC236}">
                  <a16:creationId xmlns:a16="http://schemas.microsoft.com/office/drawing/2014/main" id="{819BD11E-FDBC-4B33-A524-D0308250361B}"/>
                </a:ext>
              </a:extLst>
            </p:cNvPr>
            <p:cNvSpPr/>
            <p:nvPr/>
          </p:nvSpPr>
          <p:spPr>
            <a:xfrm>
              <a:off x="889962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9" name="Freeform: Shape 108">
              <a:extLst>
                <a:ext uri="{FF2B5EF4-FFF2-40B4-BE49-F238E27FC236}">
                  <a16:creationId xmlns:a16="http://schemas.microsoft.com/office/drawing/2014/main" id="{6FA7C197-146A-4992-A9B5-4BACD232CCA4}"/>
                </a:ext>
              </a:extLst>
            </p:cNvPr>
            <p:cNvSpPr/>
            <p:nvPr/>
          </p:nvSpPr>
          <p:spPr>
            <a:xfrm>
              <a:off x="889962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0" name="Freeform: Shape 109">
              <a:extLst>
                <a:ext uri="{FF2B5EF4-FFF2-40B4-BE49-F238E27FC236}">
                  <a16:creationId xmlns:a16="http://schemas.microsoft.com/office/drawing/2014/main" id="{7568733B-6B2A-49EC-9F8B-6500197716A0}"/>
                </a:ext>
              </a:extLst>
            </p:cNvPr>
            <p:cNvSpPr/>
            <p:nvPr/>
          </p:nvSpPr>
          <p:spPr>
            <a:xfrm>
              <a:off x="647469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1" name="Freeform: Shape 110">
              <a:extLst>
                <a:ext uri="{FF2B5EF4-FFF2-40B4-BE49-F238E27FC236}">
                  <a16:creationId xmlns:a16="http://schemas.microsoft.com/office/drawing/2014/main" id="{50114FD4-DDEB-4322-94E0-363FCE0DD652}"/>
                </a:ext>
              </a:extLst>
            </p:cNvPr>
            <p:cNvSpPr/>
            <p:nvPr/>
          </p:nvSpPr>
          <p:spPr>
            <a:xfrm>
              <a:off x="904222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2" name="Freeform: Shape 111">
              <a:extLst>
                <a:ext uri="{FF2B5EF4-FFF2-40B4-BE49-F238E27FC236}">
                  <a16:creationId xmlns:a16="http://schemas.microsoft.com/office/drawing/2014/main" id="{EC226B35-606E-4D9D-AD59-0A9A80EEDE72}"/>
                </a:ext>
              </a:extLst>
            </p:cNvPr>
            <p:cNvSpPr/>
            <p:nvPr/>
          </p:nvSpPr>
          <p:spPr>
            <a:xfrm>
              <a:off x="647469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3" name="Freeform: Shape 112">
              <a:extLst>
                <a:ext uri="{FF2B5EF4-FFF2-40B4-BE49-F238E27FC236}">
                  <a16:creationId xmlns:a16="http://schemas.microsoft.com/office/drawing/2014/main" id="{168C6E95-C718-4DDD-9461-CF94683EAB81}"/>
                </a:ext>
              </a:extLst>
            </p:cNvPr>
            <p:cNvSpPr/>
            <p:nvPr/>
          </p:nvSpPr>
          <p:spPr>
            <a:xfrm>
              <a:off x="647469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4" name="Freeform: Shape 113">
              <a:extLst>
                <a:ext uri="{FF2B5EF4-FFF2-40B4-BE49-F238E27FC236}">
                  <a16:creationId xmlns:a16="http://schemas.microsoft.com/office/drawing/2014/main" id="{A25FE9C2-BC11-4B5C-9424-F7D614DD9314}"/>
                </a:ext>
              </a:extLst>
            </p:cNvPr>
            <p:cNvSpPr/>
            <p:nvPr/>
          </p:nvSpPr>
          <p:spPr>
            <a:xfrm>
              <a:off x="647469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5" name="Freeform: Shape 114">
              <a:extLst>
                <a:ext uri="{FF2B5EF4-FFF2-40B4-BE49-F238E27FC236}">
                  <a16:creationId xmlns:a16="http://schemas.microsoft.com/office/drawing/2014/main" id="{55A2A430-C4DB-4402-B886-3A3D68C1B0BC}"/>
                </a:ext>
              </a:extLst>
            </p:cNvPr>
            <p:cNvSpPr/>
            <p:nvPr/>
          </p:nvSpPr>
          <p:spPr>
            <a:xfrm>
              <a:off x="904222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6" name="Freeform: Shape 115">
              <a:extLst>
                <a:ext uri="{FF2B5EF4-FFF2-40B4-BE49-F238E27FC236}">
                  <a16:creationId xmlns:a16="http://schemas.microsoft.com/office/drawing/2014/main" id="{1536ED74-0F1B-43BF-A93F-BBD503130938}"/>
                </a:ext>
              </a:extLst>
            </p:cNvPr>
            <p:cNvSpPr/>
            <p:nvPr/>
          </p:nvSpPr>
          <p:spPr>
            <a:xfrm>
              <a:off x="904222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7" name="Freeform: Shape 116">
              <a:extLst>
                <a:ext uri="{FF2B5EF4-FFF2-40B4-BE49-F238E27FC236}">
                  <a16:creationId xmlns:a16="http://schemas.microsoft.com/office/drawing/2014/main" id="{141B1486-0EFC-43DD-973A-25FEC6B90AE5}"/>
                </a:ext>
              </a:extLst>
            </p:cNvPr>
            <p:cNvSpPr/>
            <p:nvPr/>
          </p:nvSpPr>
          <p:spPr>
            <a:xfrm>
              <a:off x="904222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8" name="Freeform: Shape 117">
              <a:extLst>
                <a:ext uri="{FF2B5EF4-FFF2-40B4-BE49-F238E27FC236}">
                  <a16:creationId xmlns:a16="http://schemas.microsoft.com/office/drawing/2014/main" id="{F644D102-3AE2-439C-B964-712E6339B6AF}"/>
                </a:ext>
              </a:extLst>
            </p:cNvPr>
            <p:cNvSpPr/>
            <p:nvPr/>
          </p:nvSpPr>
          <p:spPr>
            <a:xfrm>
              <a:off x="661729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0" name="Freeform: Shape 119">
              <a:extLst>
                <a:ext uri="{FF2B5EF4-FFF2-40B4-BE49-F238E27FC236}">
                  <a16:creationId xmlns:a16="http://schemas.microsoft.com/office/drawing/2014/main" id="{B682A1FB-563B-4068-8C4E-317A6DDCA9FE}"/>
                </a:ext>
              </a:extLst>
            </p:cNvPr>
            <p:cNvSpPr/>
            <p:nvPr/>
          </p:nvSpPr>
          <p:spPr>
            <a:xfrm>
              <a:off x="661729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1" name="Freeform: Shape 120">
              <a:extLst>
                <a:ext uri="{FF2B5EF4-FFF2-40B4-BE49-F238E27FC236}">
                  <a16:creationId xmlns:a16="http://schemas.microsoft.com/office/drawing/2014/main" id="{F789FFE1-C574-4F43-B786-715540751909}"/>
                </a:ext>
              </a:extLst>
            </p:cNvPr>
            <p:cNvSpPr/>
            <p:nvPr/>
          </p:nvSpPr>
          <p:spPr>
            <a:xfrm>
              <a:off x="661729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2" name="Freeform: Shape 121">
              <a:extLst>
                <a:ext uri="{FF2B5EF4-FFF2-40B4-BE49-F238E27FC236}">
                  <a16:creationId xmlns:a16="http://schemas.microsoft.com/office/drawing/2014/main" id="{7F9D7825-0D90-4799-883E-2E379F47A284}"/>
                </a:ext>
              </a:extLst>
            </p:cNvPr>
            <p:cNvSpPr/>
            <p:nvPr/>
          </p:nvSpPr>
          <p:spPr>
            <a:xfrm>
              <a:off x="661729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5" name="Freeform: Shape 124">
              <a:extLst>
                <a:ext uri="{FF2B5EF4-FFF2-40B4-BE49-F238E27FC236}">
                  <a16:creationId xmlns:a16="http://schemas.microsoft.com/office/drawing/2014/main" id="{40CF1F65-92BB-4DC7-8B42-D364E5567E80}"/>
                </a:ext>
              </a:extLst>
            </p:cNvPr>
            <p:cNvSpPr/>
            <p:nvPr/>
          </p:nvSpPr>
          <p:spPr>
            <a:xfrm>
              <a:off x="675996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7" name="Freeform: Shape 126">
              <a:extLst>
                <a:ext uri="{FF2B5EF4-FFF2-40B4-BE49-F238E27FC236}">
                  <a16:creationId xmlns:a16="http://schemas.microsoft.com/office/drawing/2014/main" id="{CA2D31C0-E4F3-4B4C-BE3D-A738094122DB}"/>
                </a:ext>
              </a:extLst>
            </p:cNvPr>
            <p:cNvSpPr/>
            <p:nvPr/>
          </p:nvSpPr>
          <p:spPr>
            <a:xfrm>
              <a:off x="675996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8" name="Freeform: Shape 127">
              <a:extLst>
                <a:ext uri="{FF2B5EF4-FFF2-40B4-BE49-F238E27FC236}">
                  <a16:creationId xmlns:a16="http://schemas.microsoft.com/office/drawing/2014/main" id="{9D7873BF-023B-4D8A-B777-915A520D44CC}"/>
                </a:ext>
              </a:extLst>
            </p:cNvPr>
            <p:cNvSpPr/>
            <p:nvPr/>
          </p:nvSpPr>
          <p:spPr>
            <a:xfrm>
              <a:off x="675996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29" name="Freeform: Shape 128">
              <a:extLst>
                <a:ext uri="{FF2B5EF4-FFF2-40B4-BE49-F238E27FC236}">
                  <a16:creationId xmlns:a16="http://schemas.microsoft.com/office/drawing/2014/main" id="{C6545918-1854-489F-8809-B9C11FD56D42}"/>
                </a:ext>
              </a:extLst>
            </p:cNvPr>
            <p:cNvSpPr/>
            <p:nvPr/>
          </p:nvSpPr>
          <p:spPr>
            <a:xfrm>
              <a:off x="675996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2" name="Freeform: Shape 131">
              <a:extLst>
                <a:ext uri="{FF2B5EF4-FFF2-40B4-BE49-F238E27FC236}">
                  <a16:creationId xmlns:a16="http://schemas.microsoft.com/office/drawing/2014/main" id="{E181D08F-12E8-4057-BB36-592919EA1A42}"/>
                </a:ext>
              </a:extLst>
            </p:cNvPr>
            <p:cNvSpPr/>
            <p:nvPr/>
          </p:nvSpPr>
          <p:spPr>
            <a:xfrm>
              <a:off x="690263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4" name="Freeform: Shape 133">
              <a:extLst>
                <a:ext uri="{FF2B5EF4-FFF2-40B4-BE49-F238E27FC236}">
                  <a16:creationId xmlns:a16="http://schemas.microsoft.com/office/drawing/2014/main" id="{6F8957C0-9CF9-4677-9BC6-1AFEC10BA967}"/>
                </a:ext>
              </a:extLst>
            </p:cNvPr>
            <p:cNvSpPr/>
            <p:nvPr/>
          </p:nvSpPr>
          <p:spPr>
            <a:xfrm>
              <a:off x="690263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5" name="Freeform: Shape 134">
              <a:extLst>
                <a:ext uri="{FF2B5EF4-FFF2-40B4-BE49-F238E27FC236}">
                  <a16:creationId xmlns:a16="http://schemas.microsoft.com/office/drawing/2014/main" id="{D77CCD97-54D5-4CFA-BECA-3B94E3D6C580}"/>
                </a:ext>
              </a:extLst>
            </p:cNvPr>
            <p:cNvSpPr/>
            <p:nvPr/>
          </p:nvSpPr>
          <p:spPr>
            <a:xfrm>
              <a:off x="690263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6" name="Freeform: Shape 135">
              <a:extLst>
                <a:ext uri="{FF2B5EF4-FFF2-40B4-BE49-F238E27FC236}">
                  <a16:creationId xmlns:a16="http://schemas.microsoft.com/office/drawing/2014/main" id="{69892961-F7DA-4A8E-88EC-75EF2D8742DE}"/>
                </a:ext>
              </a:extLst>
            </p:cNvPr>
            <p:cNvSpPr/>
            <p:nvPr/>
          </p:nvSpPr>
          <p:spPr>
            <a:xfrm>
              <a:off x="690263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9" name="Freeform: Shape 138">
              <a:extLst>
                <a:ext uri="{FF2B5EF4-FFF2-40B4-BE49-F238E27FC236}">
                  <a16:creationId xmlns:a16="http://schemas.microsoft.com/office/drawing/2014/main" id="{3DEAC609-9F20-4FB7-9E60-4CC3432DD910}"/>
                </a:ext>
              </a:extLst>
            </p:cNvPr>
            <p:cNvSpPr/>
            <p:nvPr/>
          </p:nvSpPr>
          <p:spPr>
            <a:xfrm>
              <a:off x="704523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1" name="Freeform: Shape 140">
              <a:extLst>
                <a:ext uri="{FF2B5EF4-FFF2-40B4-BE49-F238E27FC236}">
                  <a16:creationId xmlns:a16="http://schemas.microsoft.com/office/drawing/2014/main" id="{56DA692B-07C5-4BD3-A982-43A6D40AC57F}"/>
                </a:ext>
              </a:extLst>
            </p:cNvPr>
            <p:cNvSpPr/>
            <p:nvPr/>
          </p:nvSpPr>
          <p:spPr>
            <a:xfrm>
              <a:off x="704523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2" name="Freeform: Shape 141">
              <a:extLst>
                <a:ext uri="{FF2B5EF4-FFF2-40B4-BE49-F238E27FC236}">
                  <a16:creationId xmlns:a16="http://schemas.microsoft.com/office/drawing/2014/main" id="{03813CE0-38A3-4FA7-8ADC-144C641590EE}"/>
                </a:ext>
              </a:extLst>
            </p:cNvPr>
            <p:cNvSpPr/>
            <p:nvPr/>
          </p:nvSpPr>
          <p:spPr>
            <a:xfrm>
              <a:off x="704523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3" name="Freeform: Shape 142">
              <a:extLst>
                <a:ext uri="{FF2B5EF4-FFF2-40B4-BE49-F238E27FC236}">
                  <a16:creationId xmlns:a16="http://schemas.microsoft.com/office/drawing/2014/main" id="{60850E53-10F6-4DB0-9D09-DC3110F0BC88}"/>
                </a:ext>
              </a:extLst>
            </p:cNvPr>
            <p:cNvSpPr/>
            <p:nvPr/>
          </p:nvSpPr>
          <p:spPr>
            <a:xfrm>
              <a:off x="704523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6" name="Freeform: Shape 145">
              <a:extLst>
                <a:ext uri="{FF2B5EF4-FFF2-40B4-BE49-F238E27FC236}">
                  <a16:creationId xmlns:a16="http://schemas.microsoft.com/office/drawing/2014/main" id="{60448AE2-1B27-42E4-A721-E7CF5DFA4A02}"/>
                </a:ext>
              </a:extLst>
            </p:cNvPr>
            <p:cNvSpPr/>
            <p:nvPr/>
          </p:nvSpPr>
          <p:spPr>
            <a:xfrm>
              <a:off x="718791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8" name="Freeform: Shape 147">
              <a:extLst>
                <a:ext uri="{FF2B5EF4-FFF2-40B4-BE49-F238E27FC236}">
                  <a16:creationId xmlns:a16="http://schemas.microsoft.com/office/drawing/2014/main" id="{AD260E54-03AF-43F7-8654-17E91FFB690A}"/>
                </a:ext>
              </a:extLst>
            </p:cNvPr>
            <p:cNvSpPr/>
            <p:nvPr/>
          </p:nvSpPr>
          <p:spPr>
            <a:xfrm>
              <a:off x="718791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9" name="Freeform: Shape 148">
              <a:extLst>
                <a:ext uri="{FF2B5EF4-FFF2-40B4-BE49-F238E27FC236}">
                  <a16:creationId xmlns:a16="http://schemas.microsoft.com/office/drawing/2014/main" id="{224BDFD1-CF74-4891-8495-3C4EDB231B0F}"/>
                </a:ext>
              </a:extLst>
            </p:cNvPr>
            <p:cNvSpPr/>
            <p:nvPr/>
          </p:nvSpPr>
          <p:spPr>
            <a:xfrm>
              <a:off x="718791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0" name="Freeform: Shape 149">
              <a:extLst>
                <a:ext uri="{FF2B5EF4-FFF2-40B4-BE49-F238E27FC236}">
                  <a16:creationId xmlns:a16="http://schemas.microsoft.com/office/drawing/2014/main" id="{399F4E14-13C7-4ECB-9CD2-B17A39EC5E61}"/>
                </a:ext>
              </a:extLst>
            </p:cNvPr>
            <p:cNvSpPr/>
            <p:nvPr/>
          </p:nvSpPr>
          <p:spPr>
            <a:xfrm>
              <a:off x="718791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3" name="Freeform: Shape 152">
              <a:extLst>
                <a:ext uri="{FF2B5EF4-FFF2-40B4-BE49-F238E27FC236}">
                  <a16:creationId xmlns:a16="http://schemas.microsoft.com/office/drawing/2014/main" id="{564D470B-0D02-4450-93F5-7F3718242359}"/>
                </a:ext>
              </a:extLst>
            </p:cNvPr>
            <p:cNvSpPr/>
            <p:nvPr/>
          </p:nvSpPr>
          <p:spPr>
            <a:xfrm>
              <a:off x="733051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5" name="Freeform: Shape 154">
              <a:extLst>
                <a:ext uri="{FF2B5EF4-FFF2-40B4-BE49-F238E27FC236}">
                  <a16:creationId xmlns:a16="http://schemas.microsoft.com/office/drawing/2014/main" id="{E54C9EA1-4629-4440-9337-62BA6FAEA35F}"/>
                </a:ext>
              </a:extLst>
            </p:cNvPr>
            <p:cNvSpPr/>
            <p:nvPr/>
          </p:nvSpPr>
          <p:spPr>
            <a:xfrm>
              <a:off x="733051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6" name="Freeform: Shape 155">
              <a:extLst>
                <a:ext uri="{FF2B5EF4-FFF2-40B4-BE49-F238E27FC236}">
                  <a16:creationId xmlns:a16="http://schemas.microsoft.com/office/drawing/2014/main" id="{5B3C4547-C7C2-445D-8D05-DFB6B8E731B2}"/>
                </a:ext>
              </a:extLst>
            </p:cNvPr>
            <p:cNvSpPr/>
            <p:nvPr/>
          </p:nvSpPr>
          <p:spPr>
            <a:xfrm>
              <a:off x="733051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7" name="Freeform: Shape 156">
              <a:extLst>
                <a:ext uri="{FF2B5EF4-FFF2-40B4-BE49-F238E27FC236}">
                  <a16:creationId xmlns:a16="http://schemas.microsoft.com/office/drawing/2014/main" id="{2B2048C7-EEC1-4836-A1EE-36AADE0D5E92}"/>
                </a:ext>
              </a:extLst>
            </p:cNvPr>
            <p:cNvSpPr/>
            <p:nvPr/>
          </p:nvSpPr>
          <p:spPr>
            <a:xfrm>
              <a:off x="733051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9" name="Freeform: Shape 158">
              <a:extLst>
                <a:ext uri="{FF2B5EF4-FFF2-40B4-BE49-F238E27FC236}">
                  <a16:creationId xmlns:a16="http://schemas.microsoft.com/office/drawing/2014/main" id="{B4CCC221-E405-4F66-84C7-6766087A8945}"/>
                </a:ext>
              </a:extLst>
            </p:cNvPr>
            <p:cNvSpPr/>
            <p:nvPr/>
          </p:nvSpPr>
          <p:spPr>
            <a:xfrm>
              <a:off x="747318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0" name="Freeform: Shape 159">
              <a:extLst>
                <a:ext uri="{FF2B5EF4-FFF2-40B4-BE49-F238E27FC236}">
                  <a16:creationId xmlns:a16="http://schemas.microsoft.com/office/drawing/2014/main" id="{5E085AFA-C42C-42DE-A97C-DB7EE6280930}"/>
                </a:ext>
              </a:extLst>
            </p:cNvPr>
            <p:cNvSpPr/>
            <p:nvPr/>
          </p:nvSpPr>
          <p:spPr>
            <a:xfrm>
              <a:off x="747318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1" name="Freeform: Shape 160">
              <a:extLst>
                <a:ext uri="{FF2B5EF4-FFF2-40B4-BE49-F238E27FC236}">
                  <a16:creationId xmlns:a16="http://schemas.microsoft.com/office/drawing/2014/main" id="{DFEDEE10-2293-47A4-ACD1-5A55775E22A7}"/>
                </a:ext>
              </a:extLst>
            </p:cNvPr>
            <p:cNvSpPr/>
            <p:nvPr/>
          </p:nvSpPr>
          <p:spPr>
            <a:xfrm>
              <a:off x="747318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3" name="Freeform: Shape 162">
              <a:extLst>
                <a:ext uri="{FF2B5EF4-FFF2-40B4-BE49-F238E27FC236}">
                  <a16:creationId xmlns:a16="http://schemas.microsoft.com/office/drawing/2014/main" id="{281A9412-7308-4554-806A-8516049ED4D0}"/>
                </a:ext>
              </a:extLst>
            </p:cNvPr>
            <p:cNvSpPr/>
            <p:nvPr/>
          </p:nvSpPr>
          <p:spPr>
            <a:xfrm>
              <a:off x="747318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5" name="Freeform: Shape 164">
              <a:extLst>
                <a:ext uri="{FF2B5EF4-FFF2-40B4-BE49-F238E27FC236}">
                  <a16:creationId xmlns:a16="http://schemas.microsoft.com/office/drawing/2014/main" id="{2A46649D-F7DD-4A80-8486-09666B1825E0}"/>
                </a:ext>
              </a:extLst>
            </p:cNvPr>
            <p:cNvSpPr/>
            <p:nvPr/>
          </p:nvSpPr>
          <p:spPr>
            <a:xfrm>
              <a:off x="519092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6" name="Freeform: Shape 165">
              <a:extLst>
                <a:ext uri="{FF2B5EF4-FFF2-40B4-BE49-F238E27FC236}">
                  <a16:creationId xmlns:a16="http://schemas.microsoft.com/office/drawing/2014/main" id="{B74D90BE-A637-4D89-9E81-5B0795B0F988}"/>
                </a:ext>
              </a:extLst>
            </p:cNvPr>
            <p:cNvSpPr/>
            <p:nvPr/>
          </p:nvSpPr>
          <p:spPr>
            <a:xfrm>
              <a:off x="775846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7" name="Freeform: Shape 166">
              <a:extLst>
                <a:ext uri="{FF2B5EF4-FFF2-40B4-BE49-F238E27FC236}">
                  <a16:creationId xmlns:a16="http://schemas.microsoft.com/office/drawing/2014/main" id="{EC27017A-3D86-4720-9A53-BC540AD930E7}"/>
                </a:ext>
              </a:extLst>
            </p:cNvPr>
            <p:cNvSpPr/>
            <p:nvPr/>
          </p:nvSpPr>
          <p:spPr>
            <a:xfrm>
              <a:off x="519092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8" name="Freeform: Shape 167">
              <a:extLst>
                <a:ext uri="{FF2B5EF4-FFF2-40B4-BE49-F238E27FC236}">
                  <a16:creationId xmlns:a16="http://schemas.microsoft.com/office/drawing/2014/main" id="{B6D90DC9-8E6F-4DD4-8D61-36AD37DAFE8E}"/>
                </a:ext>
              </a:extLst>
            </p:cNvPr>
            <p:cNvSpPr/>
            <p:nvPr/>
          </p:nvSpPr>
          <p:spPr>
            <a:xfrm>
              <a:off x="519092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69" name="Freeform: Shape 168">
              <a:extLst>
                <a:ext uri="{FF2B5EF4-FFF2-40B4-BE49-F238E27FC236}">
                  <a16:creationId xmlns:a16="http://schemas.microsoft.com/office/drawing/2014/main" id="{2AC80D00-5483-4C82-91AB-ECDFE7C7303E}"/>
                </a:ext>
              </a:extLst>
            </p:cNvPr>
            <p:cNvSpPr/>
            <p:nvPr/>
          </p:nvSpPr>
          <p:spPr>
            <a:xfrm>
              <a:off x="519092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0" name="Freeform: Shape 169">
              <a:extLst>
                <a:ext uri="{FF2B5EF4-FFF2-40B4-BE49-F238E27FC236}">
                  <a16:creationId xmlns:a16="http://schemas.microsoft.com/office/drawing/2014/main" id="{2E26EE2E-0611-4DBB-818A-3916D387BF07}"/>
                </a:ext>
              </a:extLst>
            </p:cNvPr>
            <p:cNvSpPr/>
            <p:nvPr/>
          </p:nvSpPr>
          <p:spPr>
            <a:xfrm>
              <a:off x="775846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1" name="Freeform: Shape 170">
              <a:extLst>
                <a:ext uri="{FF2B5EF4-FFF2-40B4-BE49-F238E27FC236}">
                  <a16:creationId xmlns:a16="http://schemas.microsoft.com/office/drawing/2014/main" id="{386B813A-D417-4A75-8E18-62FBDA47F967}"/>
                </a:ext>
              </a:extLst>
            </p:cNvPr>
            <p:cNvSpPr/>
            <p:nvPr/>
          </p:nvSpPr>
          <p:spPr>
            <a:xfrm>
              <a:off x="775846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2" name="Freeform: Shape 171">
              <a:extLst>
                <a:ext uri="{FF2B5EF4-FFF2-40B4-BE49-F238E27FC236}">
                  <a16:creationId xmlns:a16="http://schemas.microsoft.com/office/drawing/2014/main" id="{FB84132A-EAFE-4177-BB63-802E0207C2DE}"/>
                </a:ext>
              </a:extLst>
            </p:cNvPr>
            <p:cNvSpPr/>
            <p:nvPr/>
          </p:nvSpPr>
          <p:spPr>
            <a:xfrm>
              <a:off x="775846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3" name="Freeform: Shape 172">
              <a:extLst>
                <a:ext uri="{FF2B5EF4-FFF2-40B4-BE49-F238E27FC236}">
                  <a16:creationId xmlns:a16="http://schemas.microsoft.com/office/drawing/2014/main" id="{79B375A7-BA32-48E1-9F63-D9980AAC6BAB}"/>
                </a:ext>
              </a:extLst>
            </p:cNvPr>
            <p:cNvSpPr/>
            <p:nvPr/>
          </p:nvSpPr>
          <p:spPr>
            <a:xfrm>
              <a:off x="847168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6" name="Freeform: Shape 175">
              <a:extLst>
                <a:ext uri="{FF2B5EF4-FFF2-40B4-BE49-F238E27FC236}">
                  <a16:creationId xmlns:a16="http://schemas.microsoft.com/office/drawing/2014/main" id="{8DDAA581-5F2B-44B0-9C48-B49D93D35330}"/>
                </a:ext>
              </a:extLst>
            </p:cNvPr>
            <p:cNvSpPr/>
            <p:nvPr/>
          </p:nvSpPr>
          <p:spPr>
            <a:xfrm>
              <a:off x="91268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7" name="Freeform: Shape 176">
              <a:extLst>
                <a:ext uri="{FF2B5EF4-FFF2-40B4-BE49-F238E27FC236}">
                  <a16:creationId xmlns:a16="http://schemas.microsoft.com/office/drawing/2014/main" id="{41D85240-4229-42B5-A320-06AA6EAEFC3C}"/>
                </a:ext>
              </a:extLst>
            </p:cNvPr>
            <p:cNvSpPr/>
            <p:nvPr/>
          </p:nvSpPr>
          <p:spPr>
            <a:xfrm>
              <a:off x="348022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8" name="Freeform: Shape 177">
              <a:extLst>
                <a:ext uri="{FF2B5EF4-FFF2-40B4-BE49-F238E27FC236}">
                  <a16:creationId xmlns:a16="http://schemas.microsoft.com/office/drawing/2014/main" id="{8ABCEE14-083F-4545-AC2D-06AF377F1489}"/>
                </a:ext>
              </a:extLst>
            </p:cNvPr>
            <p:cNvSpPr/>
            <p:nvPr/>
          </p:nvSpPr>
          <p:spPr>
            <a:xfrm>
              <a:off x="91268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9" name="Freeform: Shape 178">
              <a:extLst>
                <a:ext uri="{FF2B5EF4-FFF2-40B4-BE49-F238E27FC236}">
                  <a16:creationId xmlns:a16="http://schemas.microsoft.com/office/drawing/2014/main" id="{BEE17395-7B92-4084-8801-AC508607386F}"/>
                </a:ext>
              </a:extLst>
            </p:cNvPr>
            <p:cNvSpPr/>
            <p:nvPr/>
          </p:nvSpPr>
          <p:spPr>
            <a:xfrm>
              <a:off x="91268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0" name="Freeform: Shape 179">
              <a:extLst>
                <a:ext uri="{FF2B5EF4-FFF2-40B4-BE49-F238E27FC236}">
                  <a16:creationId xmlns:a16="http://schemas.microsoft.com/office/drawing/2014/main" id="{7AFC5A98-6D09-401E-B154-F653FD0B4834}"/>
                </a:ext>
              </a:extLst>
            </p:cNvPr>
            <p:cNvSpPr/>
            <p:nvPr/>
          </p:nvSpPr>
          <p:spPr>
            <a:xfrm>
              <a:off x="91268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1" name="Freeform: Shape 180">
              <a:extLst>
                <a:ext uri="{FF2B5EF4-FFF2-40B4-BE49-F238E27FC236}">
                  <a16:creationId xmlns:a16="http://schemas.microsoft.com/office/drawing/2014/main" id="{D9EB2C48-BBC9-4020-A304-6D16E6860CC2}"/>
                </a:ext>
              </a:extLst>
            </p:cNvPr>
            <p:cNvSpPr/>
            <p:nvPr/>
          </p:nvSpPr>
          <p:spPr>
            <a:xfrm>
              <a:off x="348022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2" name="Freeform: Shape 181">
              <a:extLst>
                <a:ext uri="{FF2B5EF4-FFF2-40B4-BE49-F238E27FC236}">
                  <a16:creationId xmlns:a16="http://schemas.microsoft.com/office/drawing/2014/main" id="{12D8DF70-D0D5-4EB9-BCD1-57A7AB76DE91}"/>
                </a:ext>
              </a:extLst>
            </p:cNvPr>
            <p:cNvSpPr/>
            <p:nvPr/>
          </p:nvSpPr>
          <p:spPr>
            <a:xfrm>
              <a:off x="348022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3" name="Freeform: Shape 182">
              <a:extLst>
                <a:ext uri="{FF2B5EF4-FFF2-40B4-BE49-F238E27FC236}">
                  <a16:creationId xmlns:a16="http://schemas.microsoft.com/office/drawing/2014/main" id="{A9A45E78-3606-4A82-8CF2-7E519D791CA5}"/>
                </a:ext>
              </a:extLst>
            </p:cNvPr>
            <p:cNvSpPr/>
            <p:nvPr/>
          </p:nvSpPr>
          <p:spPr>
            <a:xfrm>
              <a:off x="348022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4" name="Freeform: Shape 183">
              <a:extLst>
                <a:ext uri="{FF2B5EF4-FFF2-40B4-BE49-F238E27FC236}">
                  <a16:creationId xmlns:a16="http://schemas.microsoft.com/office/drawing/2014/main" id="{08E33485-B216-4580-A474-732A9B5B8B08}"/>
                </a:ext>
              </a:extLst>
            </p:cNvPr>
            <p:cNvSpPr/>
            <p:nvPr/>
          </p:nvSpPr>
          <p:spPr>
            <a:xfrm>
              <a:off x="119795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5" name="Freeform: Shape 184">
              <a:extLst>
                <a:ext uri="{FF2B5EF4-FFF2-40B4-BE49-F238E27FC236}">
                  <a16:creationId xmlns:a16="http://schemas.microsoft.com/office/drawing/2014/main" id="{E044FEF0-5FE2-472F-90BE-140703CC5A79}"/>
                </a:ext>
              </a:extLst>
            </p:cNvPr>
            <p:cNvSpPr/>
            <p:nvPr/>
          </p:nvSpPr>
          <p:spPr>
            <a:xfrm>
              <a:off x="376549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6" name="Freeform: Shape 185">
              <a:extLst>
                <a:ext uri="{FF2B5EF4-FFF2-40B4-BE49-F238E27FC236}">
                  <a16:creationId xmlns:a16="http://schemas.microsoft.com/office/drawing/2014/main" id="{CB530E1B-95F4-47E2-B456-1C5F993DD6E6}"/>
                </a:ext>
              </a:extLst>
            </p:cNvPr>
            <p:cNvSpPr/>
            <p:nvPr/>
          </p:nvSpPr>
          <p:spPr>
            <a:xfrm>
              <a:off x="119795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7" name="Freeform: Shape 186">
              <a:extLst>
                <a:ext uri="{FF2B5EF4-FFF2-40B4-BE49-F238E27FC236}">
                  <a16:creationId xmlns:a16="http://schemas.microsoft.com/office/drawing/2014/main" id="{332CEB12-25BC-4C0E-B020-F8286DDC86E7}"/>
                </a:ext>
              </a:extLst>
            </p:cNvPr>
            <p:cNvSpPr/>
            <p:nvPr/>
          </p:nvSpPr>
          <p:spPr>
            <a:xfrm>
              <a:off x="119795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8" name="Freeform: Shape 187">
              <a:extLst>
                <a:ext uri="{FF2B5EF4-FFF2-40B4-BE49-F238E27FC236}">
                  <a16:creationId xmlns:a16="http://schemas.microsoft.com/office/drawing/2014/main" id="{D100A337-2788-4468-A4CB-C48B02ECA26B}"/>
                </a:ext>
              </a:extLst>
            </p:cNvPr>
            <p:cNvSpPr/>
            <p:nvPr/>
          </p:nvSpPr>
          <p:spPr>
            <a:xfrm>
              <a:off x="119795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89" name="Freeform: Shape 188">
              <a:extLst>
                <a:ext uri="{FF2B5EF4-FFF2-40B4-BE49-F238E27FC236}">
                  <a16:creationId xmlns:a16="http://schemas.microsoft.com/office/drawing/2014/main" id="{5D359A40-ECB9-42D2-8347-1AE4759A1131}"/>
                </a:ext>
              </a:extLst>
            </p:cNvPr>
            <p:cNvSpPr/>
            <p:nvPr/>
          </p:nvSpPr>
          <p:spPr>
            <a:xfrm>
              <a:off x="376549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0" name="Freeform: Shape 189">
              <a:extLst>
                <a:ext uri="{FF2B5EF4-FFF2-40B4-BE49-F238E27FC236}">
                  <a16:creationId xmlns:a16="http://schemas.microsoft.com/office/drawing/2014/main" id="{C507620F-90A0-45AF-95DA-0AC2C4C36324}"/>
                </a:ext>
              </a:extLst>
            </p:cNvPr>
            <p:cNvSpPr/>
            <p:nvPr/>
          </p:nvSpPr>
          <p:spPr>
            <a:xfrm>
              <a:off x="376549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1" name="Freeform: Shape 190">
              <a:extLst>
                <a:ext uri="{FF2B5EF4-FFF2-40B4-BE49-F238E27FC236}">
                  <a16:creationId xmlns:a16="http://schemas.microsoft.com/office/drawing/2014/main" id="{E045B831-EBF6-4E86-B5A5-CDCED052A98A}"/>
                </a:ext>
              </a:extLst>
            </p:cNvPr>
            <p:cNvSpPr/>
            <p:nvPr/>
          </p:nvSpPr>
          <p:spPr>
            <a:xfrm>
              <a:off x="376549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2" name="Freeform: Shape 191">
              <a:extLst>
                <a:ext uri="{FF2B5EF4-FFF2-40B4-BE49-F238E27FC236}">
                  <a16:creationId xmlns:a16="http://schemas.microsoft.com/office/drawing/2014/main" id="{E1090618-E569-41C4-B7A6-90A295FDAE92}"/>
                </a:ext>
              </a:extLst>
            </p:cNvPr>
            <p:cNvSpPr/>
            <p:nvPr/>
          </p:nvSpPr>
          <p:spPr>
            <a:xfrm>
              <a:off x="134063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3" name="Freeform: Shape 192">
              <a:extLst>
                <a:ext uri="{FF2B5EF4-FFF2-40B4-BE49-F238E27FC236}">
                  <a16:creationId xmlns:a16="http://schemas.microsoft.com/office/drawing/2014/main" id="{0986E01C-F815-494A-9FD5-FFFE230152B2}"/>
                </a:ext>
              </a:extLst>
            </p:cNvPr>
            <p:cNvSpPr/>
            <p:nvPr/>
          </p:nvSpPr>
          <p:spPr>
            <a:xfrm>
              <a:off x="390816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4" name="Freeform: Shape 193">
              <a:extLst>
                <a:ext uri="{FF2B5EF4-FFF2-40B4-BE49-F238E27FC236}">
                  <a16:creationId xmlns:a16="http://schemas.microsoft.com/office/drawing/2014/main" id="{0F7779C9-78FB-41A0-BA97-CD149A951EBA}"/>
                </a:ext>
              </a:extLst>
            </p:cNvPr>
            <p:cNvSpPr/>
            <p:nvPr/>
          </p:nvSpPr>
          <p:spPr>
            <a:xfrm>
              <a:off x="134063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5" name="Freeform: Shape 194">
              <a:extLst>
                <a:ext uri="{FF2B5EF4-FFF2-40B4-BE49-F238E27FC236}">
                  <a16:creationId xmlns:a16="http://schemas.microsoft.com/office/drawing/2014/main" id="{5D525B1E-BB43-434F-8BAF-8FFFEE2002A9}"/>
                </a:ext>
              </a:extLst>
            </p:cNvPr>
            <p:cNvSpPr/>
            <p:nvPr/>
          </p:nvSpPr>
          <p:spPr>
            <a:xfrm>
              <a:off x="134063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6" name="Freeform: Shape 195">
              <a:extLst>
                <a:ext uri="{FF2B5EF4-FFF2-40B4-BE49-F238E27FC236}">
                  <a16:creationId xmlns:a16="http://schemas.microsoft.com/office/drawing/2014/main" id="{4C8D080C-B0EB-4D53-BCF5-5B59756B60E9}"/>
                </a:ext>
              </a:extLst>
            </p:cNvPr>
            <p:cNvSpPr/>
            <p:nvPr/>
          </p:nvSpPr>
          <p:spPr>
            <a:xfrm>
              <a:off x="134063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7" name="Freeform: Shape 196">
              <a:extLst>
                <a:ext uri="{FF2B5EF4-FFF2-40B4-BE49-F238E27FC236}">
                  <a16:creationId xmlns:a16="http://schemas.microsoft.com/office/drawing/2014/main" id="{3E8C703A-C963-4DE5-80D7-2480BE6D9DCF}"/>
                </a:ext>
              </a:extLst>
            </p:cNvPr>
            <p:cNvSpPr/>
            <p:nvPr/>
          </p:nvSpPr>
          <p:spPr>
            <a:xfrm>
              <a:off x="390816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8" name="Freeform: Shape 197">
              <a:extLst>
                <a:ext uri="{FF2B5EF4-FFF2-40B4-BE49-F238E27FC236}">
                  <a16:creationId xmlns:a16="http://schemas.microsoft.com/office/drawing/2014/main" id="{F85374E7-4BFC-497B-BAF3-5FB2C8FB976F}"/>
                </a:ext>
              </a:extLst>
            </p:cNvPr>
            <p:cNvSpPr/>
            <p:nvPr/>
          </p:nvSpPr>
          <p:spPr>
            <a:xfrm>
              <a:off x="390816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9" name="Freeform: Shape 198">
              <a:extLst>
                <a:ext uri="{FF2B5EF4-FFF2-40B4-BE49-F238E27FC236}">
                  <a16:creationId xmlns:a16="http://schemas.microsoft.com/office/drawing/2014/main" id="{85C7409A-DF96-4E83-96D4-E13B4CC62303}"/>
                </a:ext>
              </a:extLst>
            </p:cNvPr>
            <p:cNvSpPr/>
            <p:nvPr/>
          </p:nvSpPr>
          <p:spPr>
            <a:xfrm>
              <a:off x="390816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0" name="Freeform: Shape 199">
              <a:extLst>
                <a:ext uri="{FF2B5EF4-FFF2-40B4-BE49-F238E27FC236}">
                  <a16:creationId xmlns:a16="http://schemas.microsoft.com/office/drawing/2014/main" id="{D94855D2-7980-4F80-BF67-4AF5955B326A}"/>
                </a:ext>
              </a:extLst>
            </p:cNvPr>
            <p:cNvSpPr/>
            <p:nvPr/>
          </p:nvSpPr>
          <p:spPr>
            <a:xfrm>
              <a:off x="148323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1" name="Freeform: Shape 200">
              <a:extLst>
                <a:ext uri="{FF2B5EF4-FFF2-40B4-BE49-F238E27FC236}">
                  <a16:creationId xmlns:a16="http://schemas.microsoft.com/office/drawing/2014/main" id="{77EB28C9-61A9-4F5F-97D0-50814C7FB5A8}"/>
                </a:ext>
              </a:extLst>
            </p:cNvPr>
            <p:cNvSpPr/>
            <p:nvPr/>
          </p:nvSpPr>
          <p:spPr>
            <a:xfrm>
              <a:off x="405084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2" name="Freeform: Shape 201">
              <a:extLst>
                <a:ext uri="{FF2B5EF4-FFF2-40B4-BE49-F238E27FC236}">
                  <a16:creationId xmlns:a16="http://schemas.microsoft.com/office/drawing/2014/main" id="{C19F90A1-2FB3-47BE-92AB-341E2039B275}"/>
                </a:ext>
              </a:extLst>
            </p:cNvPr>
            <p:cNvSpPr/>
            <p:nvPr/>
          </p:nvSpPr>
          <p:spPr>
            <a:xfrm>
              <a:off x="148323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3" name="Freeform: Shape 202">
              <a:extLst>
                <a:ext uri="{FF2B5EF4-FFF2-40B4-BE49-F238E27FC236}">
                  <a16:creationId xmlns:a16="http://schemas.microsoft.com/office/drawing/2014/main" id="{C2F318FE-DA25-41E2-B1A6-098519F1F4B4}"/>
                </a:ext>
              </a:extLst>
            </p:cNvPr>
            <p:cNvSpPr/>
            <p:nvPr/>
          </p:nvSpPr>
          <p:spPr>
            <a:xfrm>
              <a:off x="148323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4" name="Freeform: Shape 203">
              <a:extLst>
                <a:ext uri="{FF2B5EF4-FFF2-40B4-BE49-F238E27FC236}">
                  <a16:creationId xmlns:a16="http://schemas.microsoft.com/office/drawing/2014/main" id="{FF2B064C-CF42-410D-B7CB-DA53F18B9B4D}"/>
                </a:ext>
              </a:extLst>
            </p:cNvPr>
            <p:cNvSpPr/>
            <p:nvPr/>
          </p:nvSpPr>
          <p:spPr>
            <a:xfrm>
              <a:off x="148323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5" name="Freeform: Shape 204">
              <a:extLst>
                <a:ext uri="{FF2B5EF4-FFF2-40B4-BE49-F238E27FC236}">
                  <a16:creationId xmlns:a16="http://schemas.microsoft.com/office/drawing/2014/main" id="{AF37A684-4EC0-4ACE-B7FC-586CB74578E0}"/>
                </a:ext>
              </a:extLst>
            </p:cNvPr>
            <p:cNvSpPr/>
            <p:nvPr/>
          </p:nvSpPr>
          <p:spPr>
            <a:xfrm>
              <a:off x="405084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6" name="Freeform: Shape 205">
              <a:extLst>
                <a:ext uri="{FF2B5EF4-FFF2-40B4-BE49-F238E27FC236}">
                  <a16:creationId xmlns:a16="http://schemas.microsoft.com/office/drawing/2014/main" id="{BB6F0CA8-474E-45E1-8174-38D396A0E007}"/>
                </a:ext>
              </a:extLst>
            </p:cNvPr>
            <p:cNvSpPr/>
            <p:nvPr/>
          </p:nvSpPr>
          <p:spPr>
            <a:xfrm>
              <a:off x="405084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7" name="Freeform: Shape 206">
              <a:extLst>
                <a:ext uri="{FF2B5EF4-FFF2-40B4-BE49-F238E27FC236}">
                  <a16:creationId xmlns:a16="http://schemas.microsoft.com/office/drawing/2014/main" id="{D5D510BC-CDA0-4672-A7BB-8D0FB1CCFCC0}"/>
                </a:ext>
              </a:extLst>
            </p:cNvPr>
            <p:cNvSpPr/>
            <p:nvPr/>
          </p:nvSpPr>
          <p:spPr>
            <a:xfrm>
              <a:off x="405084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8" name="Freeform: Shape 207">
              <a:extLst>
                <a:ext uri="{FF2B5EF4-FFF2-40B4-BE49-F238E27FC236}">
                  <a16:creationId xmlns:a16="http://schemas.microsoft.com/office/drawing/2014/main" id="{48B50B64-752F-4048-B2FF-4896DCDD7489}"/>
                </a:ext>
              </a:extLst>
            </p:cNvPr>
            <p:cNvSpPr/>
            <p:nvPr/>
          </p:nvSpPr>
          <p:spPr>
            <a:xfrm>
              <a:off x="162590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9" name="Freeform: Shape 208">
              <a:extLst>
                <a:ext uri="{FF2B5EF4-FFF2-40B4-BE49-F238E27FC236}">
                  <a16:creationId xmlns:a16="http://schemas.microsoft.com/office/drawing/2014/main" id="{FB1304C6-3833-4A73-B313-608D54120530}"/>
                </a:ext>
              </a:extLst>
            </p:cNvPr>
            <p:cNvSpPr/>
            <p:nvPr/>
          </p:nvSpPr>
          <p:spPr>
            <a:xfrm>
              <a:off x="419344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0" name="Freeform: Shape 209">
              <a:extLst>
                <a:ext uri="{FF2B5EF4-FFF2-40B4-BE49-F238E27FC236}">
                  <a16:creationId xmlns:a16="http://schemas.microsoft.com/office/drawing/2014/main" id="{76C13183-3FDF-4D16-85A1-DCE8B63450EA}"/>
                </a:ext>
              </a:extLst>
            </p:cNvPr>
            <p:cNvSpPr/>
            <p:nvPr/>
          </p:nvSpPr>
          <p:spPr>
            <a:xfrm>
              <a:off x="162590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1" name="Freeform: Shape 210">
              <a:extLst>
                <a:ext uri="{FF2B5EF4-FFF2-40B4-BE49-F238E27FC236}">
                  <a16:creationId xmlns:a16="http://schemas.microsoft.com/office/drawing/2014/main" id="{70028DCF-6DBD-40E9-B717-AD47CE8EB5A2}"/>
                </a:ext>
              </a:extLst>
            </p:cNvPr>
            <p:cNvSpPr/>
            <p:nvPr/>
          </p:nvSpPr>
          <p:spPr>
            <a:xfrm>
              <a:off x="162590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2" name="Freeform: Shape 211">
              <a:extLst>
                <a:ext uri="{FF2B5EF4-FFF2-40B4-BE49-F238E27FC236}">
                  <a16:creationId xmlns:a16="http://schemas.microsoft.com/office/drawing/2014/main" id="{E7B06EC1-8237-4871-B530-22FC5EBB2F14}"/>
                </a:ext>
              </a:extLst>
            </p:cNvPr>
            <p:cNvSpPr/>
            <p:nvPr/>
          </p:nvSpPr>
          <p:spPr>
            <a:xfrm>
              <a:off x="162590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3" name="Freeform: Shape 212">
              <a:extLst>
                <a:ext uri="{FF2B5EF4-FFF2-40B4-BE49-F238E27FC236}">
                  <a16:creationId xmlns:a16="http://schemas.microsoft.com/office/drawing/2014/main" id="{506D6A60-9F53-4A90-9DA5-B8B5EA9BC15F}"/>
                </a:ext>
              </a:extLst>
            </p:cNvPr>
            <p:cNvSpPr/>
            <p:nvPr/>
          </p:nvSpPr>
          <p:spPr>
            <a:xfrm>
              <a:off x="419344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4" name="Freeform: Shape 213">
              <a:extLst>
                <a:ext uri="{FF2B5EF4-FFF2-40B4-BE49-F238E27FC236}">
                  <a16:creationId xmlns:a16="http://schemas.microsoft.com/office/drawing/2014/main" id="{C63A4013-275C-4D0E-8DC0-B97DA90B2263}"/>
                </a:ext>
              </a:extLst>
            </p:cNvPr>
            <p:cNvSpPr/>
            <p:nvPr/>
          </p:nvSpPr>
          <p:spPr>
            <a:xfrm>
              <a:off x="419344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5" name="Freeform: Shape 214">
              <a:extLst>
                <a:ext uri="{FF2B5EF4-FFF2-40B4-BE49-F238E27FC236}">
                  <a16:creationId xmlns:a16="http://schemas.microsoft.com/office/drawing/2014/main" id="{FD4D115C-773C-418D-8AB2-FAD35ADA6CDE}"/>
                </a:ext>
              </a:extLst>
            </p:cNvPr>
            <p:cNvSpPr/>
            <p:nvPr/>
          </p:nvSpPr>
          <p:spPr>
            <a:xfrm>
              <a:off x="419344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6" name="Freeform: Shape 215">
              <a:extLst>
                <a:ext uri="{FF2B5EF4-FFF2-40B4-BE49-F238E27FC236}">
                  <a16:creationId xmlns:a16="http://schemas.microsoft.com/office/drawing/2014/main" id="{B00366CE-D6B7-4CC8-A2F1-2F3D518AB0B0}"/>
                </a:ext>
              </a:extLst>
            </p:cNvPr>
            <p:cNvSpPr/>
            <p:nvPr/>
          </p:nvSpPr>
          <p:spPr>
            <a:xfrm>
              <a:off x="176850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7" name="Freeform: Shape 216">
              <a:extLst>
                <a:ext uri="{FF2B5EF4-FFF2-40B4-BE49-F238E27FC236}">
                  <a16:creationId xmlns:a16="http://schemas.microsoft.com/office/drawing/2014/main" id="{A373578C-D879-4DAA-9A91-8B2C9D54B7F3}"/>
                </a:ext>
              </a:extLst>
            </p:cNvPr>
            <p:cNvSpPr/>
            <p:nvPr/>
          </p:nvSpPr>
          <p:spPr>
            <a:xfrm>
              <a:off x="433611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8" name="Freeform: Shape 217">
              <a:extLst>
                <a:ext uri="{FF2B5EF4-FFF2-40B4-BE49-F238E27FC236}">
                  <a16:creationId xmlns:a16="http://schemas.microsoft.com/office/drawing/2014/main" id="{396F2279-FD1B-4338-B160-D7599D0FCE1B}"/>
                </a:ext>
              </a:extLst>
            </p:cNvPr>
            <p:cNvSpPr/>
            <p:nvPr/>
          </p:nvSpPr>
          <p:spPr>
            <a:xfrm>
              <a:off x="176850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19" name="Freeform: Shape 218">
              <a:extLst>
                <a:ext uri="{FF2B5EF4-FFF2-40B4-BE49-F238E27FC236}">
                  <a16:creationId xmlns:a16="http://schemas.microsoft.com/office/drawing/2014/main" id="{31151DF7-BBDC-44D1-9BBD-243AD157DAAB}"/>
                </a:ext>
              </a:extLst>
            </p:cNvPr>
            <p:cNvSpPr/>
            <p:nvPr/>
          </p:nvSpPr>
          <p:spPr>
            <a:xfrm>
              <a:off x="176850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0" name="Freeform: Shape 219">
              <a:extLst>
                <a:ext uri="{FF2B5EF4-FFF2-40B4-BE49-F238E27FC236}">
                  <a16:creationId xmlns:a16="http://schemas.microsoft.com/office/drawing/2014/main" id="{F3D9C2BD-BDE7-4169-8B26-D7E77E63C3C9}"/>
                </a:ext>
              </a:extLst>
            </p:cNvPr>
            <p:cNvSpPr/>
            <p:nvPr/>
          </p:nvSpPr>
          <p:spPr>
            <a:xfrm>
              <a:off x="176850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1" name="Freeform: Shape 220">
              <a:extLst>
                <a:ext uri="{FF2B5EF4-FFF2-40B4-BE49-F238E27FC236}">
                  <a16:creationId xmlns:a16="http://schemas.microsoft.com/office/drawing/2014/main" id="{66422BC7-3128-427B-8C35-9D9684265CA7}"/>
                </a:ext>
              </a:extLst>
            </p:cNvPr>
            <p:cNvSpPr/>
            <p:nvPr/>
          </p:nvSpPr>
          <p:spPr>
            <a:xfrm>
              <a:off x="433611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2" name="Freeform: Shape 221">
              <a:extLst>
                <a:ext uri="{FF2B5EF4-FFF2-40B4-BE49-F238E27FC236}">
                  <a16:creationId xmlns:a16="http://schemas.microsoft.com/office/drawing/2014/main" id="{B5DE83A4-409C-4BF1-9ACF-AB2F77CC5EE2}"/>
                </a:ext>
              </a:extLst>
            </p:cNvPr>
            <p:cNvSpPr/>
            <p:nvPr/>
          </p:nvSpPr>
          <p:spPr>
            <a:xfrm>
              <a:off x="433611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3" name="Freeform: Shape 222">
              <a:extLst>
                <a:ext uri="{FF2B5EF4-FFF2-40B4-BE49-F238E27FC236}">
                  <a16:creationId xmlns:a16="http://schemas.microsoft.com/office/drawing/2014/main" id="{BC2BE6A5-83D6-4705-8A3C-CAB2AC930816}"/>
                </a:ext>
              </a:extLst>
            </p:cNvPr>
            <p:cNvSpPr/>
            <p:nvPr/>
          </p:nvSpPr>
          <p:spPr>
            <a:xfrm>
              <a:off x="191117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4" name="Freeform: Shape 223">
              <a:extLst>
                <a:ext uri="{FF2B5EF4-FFF2-40B4-BE49-F238E27FC236}">
                  <a16:creationId xmlns:a16="http://schemas.microsoft.com/office/drawing/2014/main" id="{9F6093C0-397C-4894-BCDF-6ADFE679C7F3}"/>
                </a:ext>
              </a:extLst>
            </p:cNvPr>
            <p:cNvSpPr/>
            <p:nvPr/>
          </p:nvSpPr>
          <p:spPr>
            <a:xfrm>
              <a:off x="447871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5" name="Freeform: Shape 224">
              <a:extLst>
                <a:ext uri="{FF2B5EF4-FFF2-40B4-BE49-F238E27FC236}">
                  <a16:creationId xmlns:a16="http://schemas.microsoft.com/office/drawing/2014/main" id="{B20BEBF9-4229-4798-B905-42B977C0BB32}"/>
                </a:ext>
              </a:extLst>
            </p:cNvPr>
            <p:cNvSpPr/>
            <p:nvPr/>
          </p:nvSpPr>
          <p:spPr>
            <a:xfrm>
              <a:off x="191117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6" name="Freeform: Shape 225">
              <a:extLst>
                <a:ext uri="{FF2B5EF4-FFF2-40B4-BE49-F238E27FC236}">
                  <a16:creationId xmlns:a16="http://schemas.microsoft.com/office/drawing/2014/main" id="{F124D6B5-7088-47E0-9593-CB762DA70EA3}"/>
                </a:ext>
              </a:extLst>
            </p:cNvPr>
            <p:cNvSpPr/>
            <p:nvPr/>
          </p:nvSpPr>
          <p:spPr>
            <a:xfrm>
              <a:off x="191117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7" name="Freeform: Shape 226">
              <a:extLst>
                <a:ext uri="{FF2B5EF4-FFF2-40B4-BE49-F238E27FC236}">
                  <a16:creationId xmlns:a16="http://schemas.microsoft.com/office/drawing/2014/main" id="{A9C0289D-0603-458F-B4DA-B00EC6DC386F}"/>
                </a:ext>
              </a:extLst>
            </p:cNvPr>
            <p:cNvSpPr/>
            <p:nvPr/>
          </p:nvSpPr>
          <p:spPr>
            <a:xfrm>
              <a:off x="191117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8" name="Freeform: Shape 227">
              <a:extLst>
                <a:ext uri="{FF2B5EF4-FFF2-40B4-BE49-F238E27FC236}">
                  <a16:creationId xmlns:a16="http://schemas.microsoft.com/office/drawing/2014/main" id="{A0604DAB-694D-4492-91AC-E6ED758EE2B6}"/>
                </a:ext>
              </a:extLst>
            </p:cNvPr>
            <p:cNvSpPr/>
            <p:nvPr/>
          </p:nvSpPr>
          <p:spPr>
            <a:xfrm>
              <a:off x="447871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9" name="Freeform: Shape 228">
              <a:extLst>
                <a:ext uri="{FF2B5EF4-FFF2-40B4-BE49-F238E27FC236}">
                  <a16:creationId xmlns:a16="http://schemas.microsoft.com/office/drawing/2014/main" id="{B16A077F-AAE5-43F4-AA14-063007C3ABE2}"/>
                </a:ext>
              </a:extLst>
            </p:cNvPr>
            <p:cNvSpPr/>
            <p:nvPr/>
          </p:nvSpPr>
          <p:spPr>
            <a:xfrm>
              <a:off x="447871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0" name="Freeform: Shape 229">
              <a:extLst>
                <a:ext uri="{FF2B5EF4-FFF2-40B4-BE49-F238E27FC236}">
                  <a16:creationId xmlns:a16="http://schemas.microsoft.com/office/drawing/2014/main" id="{F2FBF56D-8731-47C3-8315-003A9B487594}"/>
                </a:ext>
              </a:extLst>
            </p:cNvPr>
            <p:cNvSpPr/>
            <p:nvPr/>
          </p:nvSpPr>
          <p:spPr>
            <a:xfrm>
              <a:off x="447871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1" name="Freeform: Shape 230">
              <a:extLst>
                <a:ext uri="{FF2B5EF4-FFF2-40B4-BE49-F238E27FC236}">
                  <a16:creationId xmlns:a16="http://schemas.microsoft.com/office/drawing/2014/main" id="{2BE94DDC-2CE8-49C7-AE79-4D0E6806329B}"/>
                </a:ext>
              </a:extLst>
            </p:cNvPr>
            <p:cNvSpPr/>
            <p:nvPr/>
          </p:nvSpPr>
          <p:spPr>
            <a:xfrm>
              <a:off x="205385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2" name="Freeform: Shape 231">
              <a:extLst>
                <a:ext uri="{FF2B5EF4-FFF2-40B4-BE49-F238E27FC236}">
                  <a16:creationId xmlns:a16="http://schemas.microsoft.com/office/drawing/2014/main" id="{E3B2671E-995F-4B54-8308-845621B27616}"/>
                </a:ext>
              </a:extLst>
            </p:cNvPr>
            <p:cNvSpPr/>
            <p:nvPr/>
          </p:nvSpPr>
          <p:spPr>
            <a:xfrm>
              <a:off x="462138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3" name="Freeform: Shape 232">
              <a:extLst>
                <a:ext uri="{FF2B5EF4-FFF2-40B4-BE49-F238E27FC236}">
                  <a16:creationId xmlns:a16="http://schemas.microsoft.com/office/drawing/2014/main" id="{BBE7FA4D-BF05-4B7D-99EE-DA2DC30AEFE5}"/>
                </a:ext>
              </a:extLst>
            </p:cNvPr>
            <p:cNvSpPr/>
            <p:nvPr/>
          </p:nvSpPr>
          <p:spPr>
            <a:xfrm>
              <a:off x="205385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4" name="Freeform: Shape 233">
              <a:extLst>
                <a:ext uri="{FF2B5EF4-FFF2-40B4-BE49-F238E27FC236}">
                  <a16:creationId xmlns:a16="http://schemas.microsoft.com/office/drawing/2014/main" id="{C1FF0BD1-04FE-40C6-AF1F-3E7FB8347958}"/>
                </a:ext>
              </a:extLst>
            </p:cNvPr>
            <p:cNvSpPr/>
            <p:nvPr/>
          </p:nvSpPr>
          <p:spPr>
            <a:xfrm>
              <a:off x="205385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5" name="Freeform: Shape 234">
              <a:extLst>
                <a:ext uri="{FF2B5EF4-FFF2-40B4-BE49-F238E27FC236}">
                  <a16:creationId xmlns:a16="http://schemas.microsoft.com/office/drawing/2014/main" id="{C1B172B2-EA20-425F-B1F1-A48F06A8316A}"/>
                </a:ext>
              </a:extLst>
            </p:cNvPr>
            <p:cNvSpPr/>
            <p:nvPr/>
          </p:nvSpPr>
          <p:spPr>
            <a:xfrm>
              <a:off x="205385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6" name="Freeform: Shape 235">
              <a:extLst>
                <a:ext uri="{FF2B5EF4-FFF2-40B4-BE49-F238E27FC236}">
                  <a16:creationId xmlns:a16="http://schemas.microsoft.com/office/drawing/2014/main" id="{63E786EA-9A18-420F-A5EC-CE11BACC2A24}"/>
                </a:ext>
              </a:extLst>
            </p:cNvPr>
            <p:cNvSpPr/>
            <p:nvPr/>
          </p:nvSpPr>
          <p:spPr>
            <a:xfrm>
              <a:off x="462138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7" name="Freeform: Shape 236">
              <a:extLst>
                <a:ext uri="{FF2B5EF4-FFF2-40B4-BE49-F238E27FC236}">
                  <a16:creationId xmlns:a16="http://schemas.microsoft.com/office/drawing/2014/main" id="{C5AEADB0-C8CF-4D89-A8F7-8901FBFA387D}"/>
                </a:ext>
              </a:extLst>
            </p:cNvPr>
            <p:cNvSpPr/>
            <p:nvPr/>
          </p:nvSpPr>
          <p:spPr>
            <a:xfrm>
              <a:off x="462138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8" name="Freeform: Shape 237">
              <a:extLst>
                <a:ext uri="{FF2B5EF4-FFF2-40B4-BE49-F238E27FC236}">
                  <a16:creationId xmlns:a16="http://schemas.microsoft.com/office/drawing/2014/main" id="{8F8B91AB-7CA4-4BB1-A0A9-DC410278CBEE}"/>
                </a:ext>
              </a:extLst>
            </p:cNvPr>
            <p:cNvSpPr/>
            <p:nvPr/>
          </p:nvSpPr>
          <p:spPr>
            <a:xfrm>
              <a:off x="462138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9" name="Freeform: Shape 238">
              <a:extLst>
                <a:ext uri="{FF2B5EF4-FFF2-40B4-BE49-F238E27FC236}">
                  <a16:creationId xmlns:a16="http://schemas.microsoft.com/office/drawing/2014/main" id="{563242A6-6155-4DEC-9083-DA74ECFD3CFB}"/>
                </a:ext>
              </a:extLst>
            </p:cNvPr>
            <p:cNvSpPr/>
            <p:nvPr/>
          </p:nvSpPr>
          <p:spPr>
            <a:xfrm>
              <a:off x="219645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0" name="Freeform: Shape 239">
              <a:extLst>
                <a:ext uri="{FF2B5EF4-FFF2-40B4-BE49-F238E27FC236}">
                  <a16:creationId xmlns:a16="http://schemas.microsoft.com/office/drawing/2014/main" id="{D149601D-B476-44F1-B0BA-BC97CCEE7F72}"/>
                </a:ext>
              </a:extLst>
            </p:cNvPr>
            <p:cNvSpPr/>
            <p:nvPr/>
          </p:nvSpPr>
          <p:spPr>
            <a:xfrm>
              <a:off x="476406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1" name="Freeform: Shape 240">
              <a:extLst>
                <a:ext uri="{FF2B5EF4-FFF2-40B4-BE49-F238E27FC236}">
                  <a16:creationId xmlns:a16="http://schemas.microsoft.com/office/drawing/2014/main" id="{901C92FA-FCC6-44F7-8155-855987F3EB7B}"/>
                </a:ext>
              </a:extLst>
            </p:cNvPr>
            <p:cNvSpPr/>
            <p:nvPr/>
          </p:nvSpPr>
          <p:spPr>
            <a:xfrm>
              <a:off x="219645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2" name="Freeform: Shape 241">
              <a:extLst>
                <a:ext uri="{FF2B5EF4-FFF2-40B4-BE49-F238E27FC236}">
                  <a16:creationId xmlns:a16="http://schemas.microsoft.com/office/drawing/2014/main" id="{836CAB45-208E-4C31-B4C1-9485A97EF92F}"/>
                </a:ext>
              </a:extLst>
            </p:cNvPr>
            <p:cNvSpPr/>
            <p:nvPr/>
          </p:nvSpPr>
          <p:spPr>
            <a:xfrm>
              <a:off x="219645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3" name="Freeform: Shape 242">
              <a:extLst>
                <a:ext uri="{FF2B5EF4-FFF2-40B4-BE49-F238E27FC236}">
                  <a16:creationId xmlns:a16="http://schemas.microsoft.com/office/drawing/2014/main" id="{6B0F97A8-3E5B-4A17-8A6E-531C6893A453}"/>
                </a:ext>
              </a:extLst>
            </p:cNvPr>
            <p:cNvSpPr/>
            <p:nvPr/>
          </p:nvSpPr>
          <p:spPr>
            <a:xfrm>
              <a:off x="219645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4" name="Freeform: Shape 243">
              <a:extLst>
                <a:ext uri="{FF2B5EF4-FFF2-40B4-BE49-F238E27FC236}">
                  <a16:creationId xmlns:a16="http://schemas.microsoft.com/office/drawing/2014/main" id="{137E6758-7FF9-4CFA-8F31-997F5E269161}"/>
                </a:ext>
              </a:extLst>
            </p:cNvPr>
            <p:cNvSpPr/>
            <p:nvPr/>
          </p:nvSpPr>
          <p:spPr>
            <a:xfrm>
              <a:off x="476406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5" name="Freeform: Shape 244">
              <a:extLst>
                <a:ext uri="{FF2B5EF4-FFF2-40B4-BE49-F238E27FC236}">
                  <a16:creationId xmlns:a16="http://schemas.microsoft.com/office/drawing/2014/main" id="{CDFE0C78-EE08-4000-A1AE-CB6120D51AB4}"/>
                </a:ext>
              </a:extLst>
            </p:cNvPr>
            <p:cNvSpPr/>
            <p:nvPr/>
          </p:nvSpPr>
          <p:spPr>
            <a:xfrm>
              <a:off x="476406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6" name="Freeform: Shape 245">
              <a:extLst>
                <a:ext uri="{FF2B5EF4-FFF2-40B4-BE49-F238E27FC236}">
                  <a16:creationId xmlns:a16="http://schemas.microsoft.com/office/drawing/2014/main" id="{6C4BA017-8387-4EE1-9605-0E91B7CBB5EB}"/>
                </a:ext>
              </a:extLst>
            </p:cNvPr>
            <p:cNvSpPr/>
            <p:nvPr/>
          </p:nvSpPr>
          <p:spPr>
            <a:xfrm>
              <a:off x="476406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7" name="Freeform: Shape 246">
              <a:extLst>
                <a:ext uri="{FF2B5EF4-FFF2-40B4-BE49-F238E27FC236}">
                  <a16:creationId xmlns:a16="http://schemas.microsoft.com/office/drawing/2014/main" id="{4F5A48D8-C5C7-4D09-A6DD-E5FA0B3D4FEC}"/>
                </a:ext>
              </a:extLst>
            </p:cNvPr>
            <p:cNvSpPr/>
            <p:nvPr/>
          </p:nvSpPr>
          <p:spPr>
            <a:xfrm>
              <a:off x="233912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8" name="Freeform: Shape 247">
              <a:extLst>
                <a:ext uri="{FF2B5EF4-FFF2-40B4-BE49-F238E27FC236}">
                  <a16:creationId xmlns:a16="http://schemas.microsoft.com/office/drawing/2014/main" id="{0FA3B7B4-9AB0-4418-ABDF-00851EE9F228}"/>
                </a:ext>
              </a:extLst>
            </p:cNvPr>
            <p:cNvSpPr/>
            <p:nvPr/>
          </p:nvSpPr>
          <p:spPr>
            <a:xfrm>
              <a:off x="490666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49" name="Freeform: Shape 248">
              <a:extLst>
                <a:ext uri="{FF2B5EF4-FFF2-40B4-BE49-F238E27FC236}">
                  <a16:creationId xmlns:a16="http://schemas.microsoft.com/office/drawing/2014/main" id="{E7A0D928-8FE2-425C-ADBC-D4D07361EC1E}"/>
                </a:ext>
              </a:extLst>
            </p:cNvPr>
            <p:cNvSpPr/>
            <p:nvPr/>
          </p:nvSpPr>
          <p:spPr>
            <a:xfrm>
              <a:off x="233912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0" name="Freeform: Shape 249">
              <a:extLst>
                <a:ext uri="{FF2B5EF4-FFF2-40B4-BE49-F238E27FC236}">
                  <a16:creationId xmlns:a16="http://schemas.microsoft.com/office/drawing/2014/main" id="{4C4250B4-CD4D-4F29-A18F-118B23AD1D79}"/>
                </a:ext>
              </a:extLst>
            </p:cNvPr>
            <p:cNvSpPr/>
            <p:nvPr/>
          </p:nvSpPr>
          <p:spPr>
            <a:xfrm>
              <a:off x="233912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1" name="Freeform: Shape 250">
              <a:extLst>
                <a:ext uri="{FF2B5EF4-FFF2-40B4-BE49-F238E27FC236}">
                  <a16:creationId xmlns:a16="http://schemas.microsoft.com/office/drawing/2014/main" id="{29ECE4F5-E97F-417A-98FC-322C918420A1}"/>
                </a:ext>
              </a:extLst>
            </p:cNvPr>
            <p:cNvSpPr/>
            <p:nvPr/>
          </p:nvSpPr>
          <p:spPr>
            <a:xfrm>
              <a:off x="233912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2" name="Freeform: Shape 251">
              <a:extLst>
                <a:ext uri="{FF2B5EF4-FFF2-40B4-BE49-F238E27FC236}">
                  <a16:creationId xmlns:a16="http://schemas.microsoft.com/office/drawing/2014/main" id="{352285FB-1125-4133-A6E1-17350E35B2C0}"/>
                </a:ext>
              </a:extLst>
            </p:cNvPr>
            <p:cNvSpPr/>
            <p:nvPr/>
          </p:nvSpPr>
          <p:spPr>
            <a:xfrm>
              <a:off x="490666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3" name="Freeform: Shape 252">
              <a:extLst>
                <a:ext uri="{FF2B5EF4-FFF2-40B4-BE49-F238E27FC236}">
                  <a16:creationId xmlns:a16="http://schemas.microsoft.com/office/drawing/2014/main" id="{6D93EC60-6966-411C-AC22-3E6F24BCBA1E}"/>
                </a:ext>
              </a:extLst>
            </p:cNvPr>
            <p:cNvSpPr/>
            <p:nvPr/>
          </p:nvSpPr>
          <p:spPr>
            <a:xfrm>
              <a:off x="490666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4" name="Freeform: Shape 253">
              <a:extLst>
                <a:ext uri="{FF2B5EF4-FFF2-40B4-BE49-F238E27FC236}">
                  <a16:creationId xmlns:a16="http://schemas.microsoft.com/office/drawing/2014/main" id="{BB149CAC-A10A-49BC-BFEB-51A199BE5188}"/>
                </a:ext>
              </a:extLst>
            </p:cNvPr>
            <p:cNvSpPr/>
            <p:nvPr/>
          </p:nvSpPr>
          <p:spPr>
            <a:xfrm>
              <a:off x="490666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5" name="Freeform: Shape 254">
              <a:extLst>
                <a:ext uri="{FF2B5EF4-FFF2-40B4-BE49-F238E27FC236}">
                  <a16:creationId xmlns:a16="http://schemas.microsoft.com/office/drawing/2014/main" id="{FA825405-E475-46C0-BA54-B8D94BD30162}"/>
                </a:ext>
              </a:extLst>
            </p:cNvPr>
            <p:cNvSpPr/>
            <p:nvPr/>
          </p:nvSpPr>
          <p:spPr>
            <a:xfrm>
              <a:off x="248172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6" name="Freeform: Shape 255">
              <a:extLst>
                <a:ext uri="{FF2B5EF4-FFF2-40B4-BE49-F238E27FC236}">
                  <a16:creationId xmlns:a16="http://schemas.microsoft.com/office/drawing/2014/main" id="{69142E7D-5664-4811-8AD6-778EEAD03EE1}"/>
                </a:ext>
              </a:extLst>
            </p:cNvPr>
            <p:cNvSpPr/>
            <p:nvPr/>
          </p:nvSpPr>
          <p:spPr>
            <a:xfrm>
              <a:off x="248172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7" name="Freeform: Shape 256">
              <a:extLst>
                <a:ext uri="{FF2B5EF4-FFF2-40B4-BE49-F238E27FC236}">
                  <a16:creationId xmlns:a16="http://schemas.microsoft.com/office/drawing/2014/main" id="{37672409-4202-45DF-A430-54E171B69841}"/>
                </a:ext>
              </a:extLst>
            </p:cNvPr>
            <p:cNvSpPr/>
            <p:nvPr/>
          </p:nvSpPr>
          <p:spPr>
            <a:xfrm>
              <a:off x="248172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8" name="Freeform: Shape 257">
              <a:extLst>
                <a:ext uri="{FF2B5EF4-FFF2-40B4-BE49-F238E27FC236}">
                  <a16:creationId xmlns:a16="http://schemas.microsoft.com/office/drawing/2014/main" id="{7BA52E99-D265-4B78-821C-91B5EF94A004}"/>
                </a:ext>
              </a:extLst>
            </p:cNvPr>
            <p:cNvSpPr/>
            <p:nvPr/>
          </p:nvSpPr>
          <p:spPr>
            <a:xfrm>
              <a:off x="248172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9" name="Freeform: Shape 258">
              <a:extLst>
                <a:ext uri="{FF2B5EF4-FFF2-40B4-BE49-F238E27FC236}">
                  <a16:creationId xmlns:a16="http://schemas.microsoft.com/office/drawing/2014/main" id="{61C66DC2-D30E-4756-8C4E-A116C561C399}"/>
                </a:ext>
              </a:extLst>
            </p:cNvPr>
            <p:cNvSpPr/>
            <p:nvPr/>
          </p:nvSpPr>
          <p:spPr>
            <a:xfrm>
              <a:off x="262439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0" name="Freeform: Shape 259">
              <a:extLst>
                <a:ext uri="{FF2B5EF4-FFF2-40B4-BE49-F238E27FC236}">
                  <a16:creationId xmlns:a16="http://schemas.microsoft.com/office/drawing/2014/main" id="{67B1DCDA-C2F2-4450-A659-020FD287249B}"/>
                </a:ext>
              </a:extLst>
            </p:cNvPr>
            <p:cNvSpPr/>
            <p:nvPr/>
          </p:nvSpPr>
          <p:spPr>
            <a:xfrm>
              <a:off x="262439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1" name="Freeform: Shape 260">
              <a:extLst>
                <a:ext uri="{FF2B5EF4-FFF2-40B4-BE49-F238E27FC236}">
                  <a16:creationId xmlns:a16="http://schemas.microsoft.com/office/drawing/2014/main" id="{08C78037-A6AF-4564-930B-F7DFC42D78A1}"/>
                </a:ext>
              </a:extLst>
            </p:cNvPr>
            <p:cNvSpPr/>
            <p:nvPr/>
          </p:nvSpPr>
          <p:spPr>
            <a:xfrm>
              <a:off x="262439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2" name="Freeform: Shape 261">
              <a:extLst>
                <a:ext uri="{FF2B5EF4-FFF2-40B4-BE49-F238E27FC236}">
                  <a16:creationId xmlns:a16="http://schemas.microsoft.com/office/drawing/2014/main" id="{F64BCA66-336A-448A-9CBD-2873C6B4A184}"/>
                </a:ext>
              </a:extLst>
            </p:cNvPr>
            <p:cNvSpPr/>
            <p:nvPr/>
          </p:nvSpPr>
          <p:spPr>
            <a:xfrm>
              <a:off x="262439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3" name="Freeform: Shape 262">
              <a:extLst>
                <a:ext uri="{FF2B5EF4-FFF2-40B4-BE49-F238E27FC236}">
                  <a16:creationId xmlns:a16="http://schemas.microsoft.com/office/drawing/2014/main" id="{FF1ADF70-1B20-491A-9A49-369147036E8E}"/>
                </a:ext>
              </a:extLst>
            </p:cNvPr>
            <p:cNvSpPr/>
            <p:nvPr/>
          </p:nvSpPr>
          <p:spPr>
            <a:xfrm>
              <a:off x="276707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4" name="Freeform: Shape 263">
              <a:extLst>
                <a:ext uri="{FF2B5EF4-FFF2-40B4-BE49-F238E27FC236}">
                  <a16:creationId xmlns:a16="http://schemas.microsoft.com/office/drawing/2014/main" id="{EDED8DA9-EEBE-4E3D-BF13-EF7922BCE6BB}"/>
                </a:ext>
              </a:extLst>
            </p:cNvPr>
            <p:cNvSpPr/>
            <p:nvPr/>
          </p:nvSpPr>
          <p:spPr>
            <a:xfrm>
              <a:off x="276707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5" name="Freeform: Shape 264">
              <a:extLst>
                <a:ext uri="{FF2B5EF4-FFF2-40B4-BE49-F238E27FC236}">
                  <a16:creationId xmlns:a16="http://schemas.microsoft.com/office/drawing/2014/main" id="{B5A6A0DB-7373-4869-84A9-642FC216AF9A}"/>
                </a:ext>
              </a:extLst>
            </p:cNvPr>
            <p:cNvSpPr/>
            <p:nvPr/>
          </p:nvSpPr>
          <p:spPr>
            <a:xfrm>
              <a:off x="276707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6" name="Freeform: Shape 265">
              <a:extLst>
                <a:ext uri="{FF2B5EF4-FFF2-40B4-BE49-F238E27FC236}">
                  <a16:creationId xmlns:a16="http://schemas.microsoft.com/office/drawing/2014/main" id="{78D5987E-0F85-4452-98CB-0E6C29BDF7DE}"/>
                </a:ext>
              </a:extLst>
            </p:cNvPr>
            <p:cNvSpPr/>
            <p:nvPr/>
          </p:nvSpPr>
          <p:spPr>
            <a:xfrm>
              <a:off x="276707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7" name="Freeform: Shape 266">
              <a:extLst>
                <a:ext uri="{FF2B5EF4-FFF2-40B4-BE49-F238E27FC236}">
                  <a16:creationId xmlns:a16="http://schemas.microsoft.com/office/drawing/2014/main" id="{E4AD54D6-CDA9-4AD6-B8E0-F133D886604F}"/>
                </a:ext>
              </a:extLst>
            </p:cNvPr>
            <p:cNvSpPr/>
            <p:nvPr/>
          </p:nvSpPr>
          <p:spPr>
            <a:xfrm>
              <a:off x="290967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8" name="Freeform: Shape 267">
              <a:extLst>
                <a:ext uri="{FF2B5EF4-FFF2-40B4-BE49-F238E27FC236}">
                  <a16:creationId xmlns:a16="http://schemas.microsoft.com/office/drawing/2014/main" id="{45511346-D7F2-4203-A1F3-BA32581F7678}"/>
                </a:ext>
              </a:extLst>
            </p:cNvPr>
            <p:cNvSpPr/>
            <p:nvPr/>
          </p:nvSpPr>
          <p:spPr>
            <a:xfrm>
              <a:off x="290967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9" name="Freeform: Shape 268">
              <a:extLst>
                <a:ext uri="{FF2B5EF4-FFF2-40B4-BE49-F238E27FC236}">
                  <a16:creationId xmlns:a16="http://schemas.microsoft.com/office/drawing/2014/main" id="{5D52E8EA-AC09-4971-875E-487276545554}"/>
                </a:ext>
              </a:extLst>
            </p:cNvPr>
            <p:cNvSpPr/>
            <p:nvPr/>
          </p:nvSpPr>
          <p:spPr>
            <a:xfrm>
              <a:off x="290967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0" name="Freeform: Shape 269">
              <a:extLst>
                <a:ext uri="{FF2B5EF4-FFF2-40B4-BE49-F238E27FC236}">
                  <a16:creationId xmlns:a16="http://schemas.microsoft.com/office/drawing/2014/main" id="{2D6BCFFE-413F-40F6-B8E3-F0092B54562F}"/>
                </a:ext>
              </a:extLst>
            </p:cNvPr>
            <p:cNvSpPr/>
            <p:nvPr/>
          </p:nvSpPr>
          <p:spPr>
            <a:xfrm>
              <a:off x="290967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1" name="Freeform: Shape 270">
              <a:extLst>
                <a:ext uri="{FF2B5EF4-FFF2-40B4-BE49-F238E27FC236}">
                  <a16:creationId xmlns:a16="http://schemas.microsoft.com/office/drawing/2014/main" id="{CBD41B8E-3BB8-4CC2-BC69-DEC8965AEF96}"/>
                </a:ext>
              </a:extLst>
            </p:cNvPr>
            <p:cNvSpPr/>
            <p:nvPr/>
          </p:nvSpPr>
          <p:spPr>
            <a:xfrm>
              <a:off x="305234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2" name="Freeform: Shape 271">
              <a:extLst>
                <a:ext uri="{FF2B5EF4-FFF2-40B4-BE49-F238E27FC236}">
                  <a16:creationId xmlns:a16="http://schemas.microsoft.com/office/drawing/2014/main" id="{3F1F0664-677C-49B1-8578-BE71028B30F2}"/>
                </a:ext>
              </a:extLst>
            </p:cNvPr>
            <p:cNvSpPr/>
            <p:nvPr/>
          </p:nvSpPr>
          <p:spPr>
            <a:xfrm>
              <a:off x="305234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3" name="Freeform: Shape 272">
              <a:extLst>
                <a:ext uri="{FF2B5EF4-FFF2-40B4-BE49-F238E27FC236}">
                  <a16:creationId xmlns:a16="http://schemas.microsoft.com/office/drawing/2014/main" id="{8404CF36-D296-45D3-9A4A-D4597F8F1332}"/>
                </a:ext>
              </a:extLst>
            </p:cNvPr>
            <p:cNvSpPr/>
            <p:nvPr/>
          </p:nvSpPr>
          <p:spPr>
            <a:xfrm>
              <a:off x="305234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4" name="Freeform: Shape 273">
              <a:extLst>
                <a:ext uri="{FF2B5EF4-FFF2-40B4-BE49-F238E27FC236}">
                  <a16:creationId xmlns:a16="http://schemas.microsoft.com/office/drawing/2014/main" id="{511C9E56-2906-4FC7-B554-21AF8C0734CC}"/>
                </a:ext>
              </a:extLst>
            </p:cNvPr>
            <p:cNvSpPr/>
            <p:nvPr/>
          </p:nvSpPr>
          <p:spPr>
            <a:xfrm>
              <a:off x="305234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5" name="Freeform: Shape 274">
              <a:extLst>
                <a:ext uri="{FF2B5EF4-FFF2-40B4-BE49-F238E27FC236}">
                  <a16:creationId xmlns:a16="http://schemas.microsoft.com/office/drawing/2014/main" id="{C8DFFF25-4B5C-4403-8C5D-34F0AF82DE9C}"/>
                </a:ext>
              </a:extLst>
            </p:cNvPr>
            <p:cNvSpPr/>
            <p:nvPr/>
          </p:nvSpPr>
          <p:spPr>
            <a:xfrm>
              <a:off x="319494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6" name="Freeform: Shape 275">
              <a:extLst>
                <a:ext uri="{FF2B5EF4-FFF2-40B4-BE49-F238E27FC236}">
                  <a16:creationId xmlns:a16="http://schemas.microsoft.com/office/drawing/2014/main" id="{4B260F95-B905-4C20-83D3-CF9FAC73B9D1}"/>
                </a:ext>
              </a:extLst>
            </p:cNvPr>
            <p:cNvSpPr/>
            <p:nvPr/>
          </p:nvSpPr>
          <p:spPr>
            <a:xfrm>
              <a:off x="319494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7" name="Freeform: Shape 276">
              <a:extLst>
                <a:ext uri="{FF2B5EF4-FFF2-40B4-BE49-F238E27FC236}">
                  <a16:creationId xmlns:a16="http://schemas.microsoft.com/office/drawing/2014/main" id="{E4CC5BF6-0646-475C-819D-BC5105B23663}"/>
                </a:ext>
              </a:extLst>
            </p:cNvPr>
            <p:cNvSpPr/>
            <p:nvPr/>
          </p:nvSpPr>
          <p:spPr>
            <a:xfrm>
              <a:off x="319494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8" name="Freeform: Shape 277">
              <a:extLst>
                <a:ext uri="{FF2B5EF4-FFF2-40B4-BE49-F238E27FC236}">
                  <a16:creationId xmlns:a16="http://schemas.microsoft.com/office/drawing/2014/main" id="{F02CBDE4-AA9D-49F9-AF20-A55A3094217D}"/>
                </a:ext>
              </a:extLst>
            </p:cNvPr>
            <p:cNvSpPr/>
            <p:nvPr/>
          </p:nvSpPr>
          <p:spPr>
            <a:xfrm>
              <a:off x="319494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9" name="Freeform: Shape 278">
              <a:extLst>
                <a:ext uri="{FF2B5EF4-FFF2-40B4-BE49-F238E27FC236}">
                  <a16:creationId xmlns:a16="http://schemas.microsoft.com/office/drawing/2014/main" id="{59A043AC-DAF1-4C86-908F-0D5159E6C962}"/>
                </a:ext>
              </a:extLst>
            </p:cNvPr>
            <p:cNvSpPr/>
            <p:nvPr/>
          </p:nvSpPr>
          <p:spPr>
            <a:xfrm>
              <a:off x="333762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0" name="Freeform: Shape 279">
              <a:extLst>
                <a:ext uri="{FF2B5EF4-FFF2-40B4-BE49-F238E27FC236}">
                  <a16:creationId xmlns:a16="http://schemas.microsoft.com/office/drawing/2014/main" id="{F02000E7-119E-4BDE-90BD-02C3258F95CE}"/>
                </a:ext>
              </a:extLst>
            </p:cNvPr>
            <p:cNvSpPr/>
            <p:nvPr/>
          </p:nvSpPr>
          <p:spPr>
            <a:xfrm>
              <a:off x="333762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1" name="Freeform: Shape 280">
              <a:extLst>
                <a:ext uri="{FF2B5EF4-FFF2-40B4-BE49-F238E27FC236}">
                  <a16:creationId xmlns:a16="http://schemas.microsoft.com/office/drawing/2014/main" id="{007FF71B-51FA-40AB-885A-CA18B4DB9FDC}"/>
                </a:ext>
              </a:extLst>
            </p:cNvPr>
            <p:cNvSpPr/>
            <p:nvPr/>
          </p:nvSpPr>
          <p:spPr>
            <a:xfrm>
              <a:off x="333762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2" name="Freeform: Shape 281">
              <a:extLst>
                <a:ext uri="{FF2B5EF4-FFF2-40B4-BE49-F238E27FC236}">
                  <a16:creationId xmlns:a16="http://schemas.microsoft.com/office/drawing/2014/main" id="{54FCD10B-A51B-498F-8A1F-79B213186880}"/>
                </a:ext>
              </a:extLst>
            </p:cNvPr>
            <p:cNvSpPr/>
            <p:nvPr/>
          </p:nvSpPr>
          <p:spPr>
            <a:xfrm>
              <a:off x="333762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3" name="Freeform: Shape 282">
              <a:extLst>
                <a:ext uri="{FF2B5EF4-FFF2-40B4-BE49-F238E27FC236}">
                  <a16:creationId xmlns:a16="http://schemas.microsoft.com/office/drawing/2014/main" id="{94F8232D-7004-49F0-A86B-F05FCDB208D5}"/>
                </a:ext>
              </a:extLst>
            </p:cNvPr>
            <p:cNvSpPr/>
            <p:nvPr/>
          </p:nvSpPr>
          <p:spPr>
            <a:xfrm>
              <a:off x="105535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4" name="Freeform: Shape 283">
              <a:extLst>
                <a:ext uri="{FF2B5EF4-FFF2-40B4-BE49-F238E27FC236}">
                  <a16:creationId xmlns:a16="http://schemas.microsoft.com/office/drawing/2014/main" id="{9CB82260-A2F2-42F1-8E07-A0E19C8F3DCA}"/>
                </a:ext>
              </a:extLst>
            </p:cNvPr>
            <p:cNvSpPr/>
            <p:nvPr/>
          </p:nvSpPr>
          <p:spPr>
            <a:xfrm>
              <a:off x="362289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5" name="Freeform: Shape 284">
              <a:extLst>
                <a:ext uri="{FF2B5EF4-FFF2-40B4-BE49-F238E27FC236}">
                  <a16:creationId xmlns:a16="http://schemas.microsoft.com/office/drawing/2014/main" id="{1F6AE420-CF9A-4288-94E6-36229C056D4E}"/>
                </a:ext>
              </a:extLst>
            </p:cNvPr>
            <p:cNvSpPr/>
            <p:nvPr/>
          </p:nvSpPr>
          <p:spPr>
            <a:xfrm>
              <a:off x="105535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6" name="Freeform: Shape 285">
              <a:extLst>
                <a:ext uri="{FF2B5EF4-FFF2-40B4-BE49-F238E27FC236}">
                  <a16:creationId xmlns:a16="http://schemas.microsoft.com/office/drawing/2014/main" id="{07D4CEA2-8395-43CE-8F8A-D8D0D6AE0E69}"/>
                </a:ext>
              </a:extLst>
            </p:cNvPr>
            <p:cNvSpPr/>
            <p:nvPr/>
          </p:nvSpPr>
          <p:spPr>
            <a:xfrm>
              <a:off x="105535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7" name="Freeform: Shape 286">
              <a:extLst>
                <a:ext uri="{FF2B5EF4-FFF2-40B4-BE49-F238E27FC236}">
                  <a16:creationId xmlns:a16="http://schemas.microsoft.com/office/drawing/2014/main" id="{C9DD8D14-D681-454B-A37A-130B124AF186}"/>
                </a:ext>
              </a:extLst>
            </p:cNvPr>
            <p:cNvSpPr/>
            <p:nvPr/>
          </p:nvSpPr>
          <p:spPr>
            <a:xfrm>
              <a:off x="105535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8" name="Freeform: Shape 287">
              <a:extLst>
                <a:ext uri="{FF2B5EF4-FFF2-40B4-BE49-F238E27FC236}">
                  <a16:creationId xmlns:a16="http://schemas.microsoft.com/office/drawing/2014/main" id="{B087AB6E-8287-4804-A33B-1E8553C0E673}"/>
                </a:ext>
              </a:extLst>
            </p:cNvPr>
            <p:cNvSpPr/>
            <p:nvPr/>
          </p:nvSpPr>
          <p:spPr>
            <a:xfrm>
              <a:off x="362289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89" name="Freeform: Shape 288">
              <a:extLst>
                <a:ext uri="{FF2B5EF4-FFF2-40B4-BE49-F238E27FC236}">
                  <a16:creationId xmlns:a16="http://schemas.microsoft.com/office/drawing/2014/main" id="{6C757E94-1B00-4135-B402-7044EE9CE4C1}"/>
                </a:ext>
              </a:extLst>
            </p:cNvPr>
            <p:cNvSpPr/>
            <p:nvPr/>
          </p:nvSpPr>
          <p:spPr>
            <a:xfrm>
              <a:off x="362289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90" name="Freeform: Shape 289">
              <a:extLst>
                <a:ext uri="{FF2B5EF4-FFF2-40B4-BE49-F238E27FC236}">
                  <a16:creationId xmlns:a16="http://schemas.microsoft.com/office/drawing/2014/main" id="{B8AA6312-A24C-48EB-8758-4735B5CA4B8D}"/>
                </a:ext>
              </a:extLst>
            </p:cNvPr>
            <p:cNvSpPr/>
            <p:nvPr/>
          </p:nvSpPr>
          <p:spPr>
            <a:xfrm>
              <a:off x="362289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91" name="Freeform: Shape 290">
              <a:extLst>
                <a:ext uri="{FF2B5EF4-FFF2-40B4-BE49-F238E27FC236}">
                  <a16:creationId xmlns:a16="http://schemas.microsoft.com/office/drawing/2014/main" id="{FD09459E-D063-43D4-859A-D6416B11B494}"/>
                </a:ext>
              </a:extLst>
            </p:cNvPr>
            <p:cNvSpPr/>
            <p:nvPr/>
          </p:nvSpPr>
          <p:spPr>
            <a:xfrm>
              <a:off x="433611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27" name="Freeform: Shape 326">
              <a:extLst>
                <a:ext uri="{FF2B5EF4-FFF2-40B4-BE49-F238E27FC236}">
                  <a16:creationId xmlns:a16="http://schemas.microsoft.com/office/drawing/2014/main" id="{B729397C-5660-43A9-A868-84D452318882}"/>
                </a:ext>
              </a:extLst>
            </p:cNvPr>
            <p:cNvSpPr/>
            <p:nvPr/>
          </p:nvSpPr>
          <p:spPr>
            <a:xfrm>
              <a:off x="5796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31" name="Freeform: Shape 330">
              <a:extLst>
                <a:ext uri="{FF2B5EF4-FFF2-40B4-BE49-F238E27FC236}">
                  <a16:creationId xmlns:a16="http://schemas.microsoft.com/office/drawing/2014/main" id="{E233F836-7120-4377-9478-CAA7B8AFD47F}"/>
                </a:ext>
              </a:extLst>
            </p:cNvPr>
            <p:cNvSpPr/>
            <p:nvPr/>
          </p:nvSpPr>
          <p:spPr>
            <a:xfrm>
              <a:off x="5796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32" name="Freeform: Shape 331">
              <a:extLst>
                <a:ext uri="{FF2B5EF4-FFF2-40B4-BE49-F238E27FC236}">
                  <a16:creationId xmlns:a16="http://schemas.microsoft.com/office/drawing/2014/main" id="{900399CE-0161-4AEB-B3D1-9EABC33111DA}"/>
                </a:ext>
              </a:extLst>
            </p:cNvPr>
            <p:cNvSpPr/>
            <p:nvPr/>
          </p:nvSpPr>
          <p:spPr>
            <a:xfrm>
              <a:off x="5796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33" name="Freeform: Shape 332">
              <a:extLst>
                <a:ext uri="{FF2B5EF4-FFF2-40B4-BE49-F238E27FC236}">
                  <a16:creationId xmlns:a16="http://schemas.microsoft.com/office/drawing/2014/main" id="{793F1B21-2A2A-4BF1-839A-0CED429D1DBA}"/>
                </a:ext>
              </a:extLst>
            </p:cNvPr>
            <p:cNvSpPr/>
            <p:nvPr/>
          </p:nvSpPr>
          <p:spPr>
            <a:xfrm>
              <a:off x="5796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35" name="Freeform: Shape 334">
              <a:extLst>
                <a:ext uri="{FF2B5EF4-FFF2-40B4-BE49-F238E27FC236}">
                  <a16:creationId xmlns:a16="http://schemas.microsoft.com/office/drawing/2014/main" id="{E1C112C9-B364-4E4E-82A6-4EAE2A02713D}"/>
                </a:ext>
              </a:extLst>
            </p:cNvPr>
            <p:cNvSpPr/>
            <p:nvPr/>
          </p:nvSpPr>
          <p:spPr>
            <a:xfrm>
              <a:off x="20063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39" name="Freeform: Shape 338">
              <a:extLst>
                <a:ext uri="{FF2B5EF4-FFF2-40B4-BE49-F238E27FC236}">
                  <a16:creationId xmlns:a16="http://schemas.microsoft.com/office/drawing/2014/main" id="{EC7413E4-7EC7-44BF-8632-DAE56E19E9E3}"/>
                </a:ext>
              </a:extLst>
            </p:cNvPr>
            <p:cNvSpPr/>
            <p:nvPr/>
          </p:nvSpPr>
          <p:spPr>
            <a:xfrm>
              <a:off x="20063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40" name="Freeform: Shape 339">
              <a:extLst>
                <a:ext uri="{FF2B5EF4-FFF2-40B4-BE49-F238E27FC236}">
                  <a16:creationId xmlns:a16="http://schemas.microsoft.com/office/drawing/2014/main" id="{EEB08736-0088-47DA-8C05-FF81394FF89A}"/>
                </a:ext>
              </a:extLst>
            </p:cNvPr>
            <p:cNvSpPr/>
            <p:nvPr/>
          </p:nvSpPr>
          <p:spPr>
            <a:xfrm>
              <a:off x="20063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42" name="Freeform: Shape 341">
              <a:extLst>
                <a:ext uri="{FF2B5EF4-FFF2-40B4-BE49-F238E27FC236}">
                  <a16:creationId xmlns:a16="http://schemas.microsoft.com/office/drawing/2014/main" id="{FCB7F045-4899-4D02-9BDD-B2D788983C2A}"/>
                </a:ext>
              </a:extLst>
            </p:cNvPr>
            <p:cNvSpPr/>
            <p:nvPr/>
          </p:nvSpPr>
          <p:spPr>
            <a:xfrm>
              <a:off x="34323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46" name="Freeform: Shape 345">
              <a:extLst>
                <a:ext uri="{FF2B5EF4-FFF2-40B4-BE49-F238E27FC236}">
                  <a16:creationId xmlns:a16="http://schemas.microsoft.com/office/drawing/2014/main" id="{AE62143C-7F01-4699-87B0-4F7E0213B1F1}"/>
                </a:ext>
              </a:extLst>
            </p:cNvPr>
            <p:cNvSpPr/>
            <p:nvPr/>
          </p:nvSpPr>
          <p:spPr>
            <a:xfrm>
              <a:off x="34323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47" name="Freeform: Shape 346">
              <a:extLst>
                <a:ext uri="{FF2B5EF4-FFF2-40B4-BE49-F238E27FC236}">
                  <a16:creationId xmlns:a16="http://schemas.microsoft.com/office/drawing/2014/main" id="{8DD37511-8CBA-4EA7-879A-6D40721E9F41}"/>
                </a:ext>
              </a:extLst>
            </p:cNvPr>
            <p:cNvSpPr/>
            <p:nvPr/>
          </p:nvSpPr>
          <p:spPr>
            <a:xfrm>
              <a:off x="34323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48" name="Freeform: Shape 347">
              <a:extLst>
                <a:ext uri="{FF2B5EF4-FFF2-40B4-BE49-F238E27FC236}">
                  <a16:creationId xmlns:a16="http://schemas.microsoft.com/office/drawing/2014/main" id="{0556BDE0-F157-49A4-B1B7-74399407455E}"/>
                </a:ext>
              </a:extLst>
            </p:cNvPr>
            <p:cNvSpPr/>
            <p:nvPr/>
          </p:nvSpPr>
          <p:spPr>
            <a:xfrm>
              <a:off x="34323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50" name="Freeform: Shape 349">
              <a:extLst>
                <a:ext uri="{FF2B5EF4-FFF2-40B4-BE49-F238E27FC236}">
                  <a16:creationId xmlns:a16="http://schemas.microsoft.com/office/drawing/2014/main" id="{FB5F50F3-ABAA-47E1-89A3-E910AF0BA842}"/>
                </a:ext>
              </a:extLst>
            </p:cNvPr>
            <p:cNvSpPr/>
            <p:nvPr/>
          </p:nvSpPr>
          <p:spPr>
            <a:xfrm>
              <a:off x="48591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54" name="Freeform: Shape 353">
              <a:extLst>
                <a:ext uri="{FF2B5EF4-FFF2-40B4-BE49-F238E27FC236}">
                  <a16:creationId xmlns:a16="http://schemas.microsoft.com/office/drawing/2014/main" id="{69BF788E-F153-42B2-93C1-459F2B0771AE}"/>
                </a:ext>
              </a:extLst>
            </p:cNvPr>
            <p:cNvSpPr/>
            <p:nvPr/>
          </p:nvSpPr>
          <p:spPr>
            <a:xfrm>
              <a:off x="48591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55" name="Freeform: Shape 354">
              <a:extLst>
                <a:ext uri="{FF2B5EF4-FFF2-40B4-BE49-F238E27FC236}">
                  <a16:creationId xmlns:a16="http://schemas.microsoft.com/office/drawing/2014/main" id="{D07A0FB8-07F4-4A2F-B2F3-A843586407CF}"/>
                </a:ext>
              </a:extLst>
            </p:cNvPr>
            <p:cNvSpPr/>
            <p:nvPr/>
          </p:nvSpPr>
          <p:spPr>
            <a:xfrm>
              <a:off x="48591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56" name="Freeform: Shape 355">
              <a:extLst>
                <a:ext uri="{FF2B5EF4-FFF2-40B4-BE49-F238E27FC236}">
                  <a16:creationId xmlns:a16="http://schemas.microsoft.com/office/drawing/2014/main" id="{C0C72748-283B-40D7-A03A-DBF58B58B46A}"/>
                </a:ext>
              </a:extLst>
            </p:cNvPr>
            <p:cNvSpPr/>
            <p:nvPr/>
          </p:nvSpPr>
          <p:spPr>
            <a:xfrm>
              <a:off x="48591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58" name="Freeform: Shape 357">
              <a:extLst>
                <a:ext uri="{FF2B5EF4-FFF2-40B4-BE49-F238E27FC236}">
                  <a16:creationId xmlns:a16="http://schemas.microsoft.com/office/drawing/2014/main" id="{9C1884FB-3490-4058-8240-F3C01BD7DD80}"/>
                </a:ext>
              </a:extLst>
            </p:cNvPr>
            <p:cNvSpPr/>
            <p:nvPr/>
          </p:nvSpPr>
          <p:spPr>
            <a:xfrm>
              <a:off x="62858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62" name="Freeform: Shape 361">
              <a:extLst>
                <a:ext uri="{FF2B5EF4-FFF2-40B4-BE49-F238E27FC236}">
                  <a16:creationId xmlns:a16="http://schemas.microsoft.com/office/drawing/2014/main" id="{DAD260AE-42CF-4390-9176-B4BD22A528DD}"/>
                </a:ext>
              </a:extLst>
            </p:cNvPr>
            <p:cNvSpPr/>
            <p:nvPr/>
          </p:nvSpPr>
          <p:spPr>
            <a:xfrm>
              <a:off x="62858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63" name="Freeform: Shape 362">
              <a:extLst>
                <a:ext uri="{FF2B5EF4-FFF2-40B4-BE49-F238E27FC236}">
                  <a16:creationId xmlns:a16="http://schemas.microsoft.com/office/drawing/2014/main" id="{905CB6DA-C557-4481-82A2-65FB8AEED2E7}"/>
                </a:ext>
              </a:extLst>
            </p:cNvPr>
            <p:cNvSpPr/>
            <p:nvPr/>
          </p:nvSpPr>
          <p:spPr>
            <a:xfrm>
              <a:off x="62858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64" name="Freeform: Shape 363">
              <a:extLst>
                <a:ext uri="{FF2B5EF4-FFF2-40B4-BE49-F238E27FC236}">
                  <a16:creationId xmlns:a16="http://schemas.microsoft.com/office/drawing/2014/main" id="{32E4D79A-E40D-48E2-9294-14FB1A40078E}"/>
                </a:ext>
              </a:extLst>
            </p:cNvPr>
            <p:cNvSpPr/>
            <p:nvPr/>
          </p:nvSpPr>
          <p:spPr>
            <a:xfrm>
              <a:off x="62858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66" name="Freeform: Shape 365">
              <a:extLst>
                <a:ext uri="{FF2B5EF4-FFF2-40B4-BE49-F238E27FC236}">
                  <a16:creationId xmlns:a16="http://schemas.microsoft.com/office/drawing/2014/main" id="{F7A68C10-6696-4047-AE23-BCE93A5B20F6}"/>
                </a:ext>
              </a:extLst>
            </p:cNvPr>
            <p:cNvSpPr/>
            <p:nvPr/>
          </p:nvSpPr>
          <p:spPr>
            <a:xfrm>
              <a:off x="77118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70" name="Freeform: Shape 369">
              <a:extLst>
                <a:ext uri="{FF2B5EF4-FFF2-40B4-BE49-F238E27FC236}">
                  <a16:creationId xmlns:a16="http://schemas.microsoft.com/office/drawing/2014/main" id="{C8C95FF5-312C-408F-881B-B6E20CA3692B}"/>
                </a:ext>
              </a:extLst>
            </p:cNvPr>
            <p:cNvSpPr/>
            <p:nvPr/>
          </p:nvSpPr>
          <p:spPr>
            <a:xfrm>
              <a:off x="77118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71" name="Freeform: Shape 370">
              <a:extLst>
                <a:ext uri="{FF2B5EF4-FFF2-40B4-BE49-F238E27FC236}">
                  <a16:creationId xmlns:a16="http://schemas.microsoft.com/office/drawing/2014/main" id="{3CA81529-5200-48C6-9458-524876AFE459}"/>
                </a:ext>
              </a:extLst>
            </p:cNvPr>
            <p:cNvSpPr/>
            <p:nvPr/>
          </p:nvSpPr>
          <p:spPr>
            <a:xfrm>
              <a:off x="77118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72" name="Freeform: Shape 371">
              <a:extLst>
                <a:ext uri="{FF2B5EF4-FFF2-40B4-BE49-F238E27FC236}">
                  <a16:creationId xmlns:a16="http://schemas.microsoft.com/office/drawing/2014/main" id="{693C9681-43DA-4555-ADB6-DA2F8D2BD211}"/>
                </a:ext>
              </a:extLst>
            </p:cNvPr>
            <p:cNvSpPr/>
            <p:nvPr/>
          </p:nvSpPr>
          <p:spPr>
            <a:xfrm>
              <a:off x="77118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09" name="Freeform: Shape 408">
              <a:extLst>
                <a:ext uri="{FF2B5EF4-FFF2-40B4-BE49-F238E27FC236}">
                  <a16:creationId xmlns:a16="http://schemas.microsoft.com/office/drawing/2014/main" id="{4A15EF01-C679-408F-A73F-A98755821DD0}"/>
                </a:ext>
              </a:extLst>
            </p:cNvPr>
            <p:cNvSpPr/>
            <p:nvPr/>
          </p:nvSpPr>
          <p:spPr>
            <a:xfrm>
              <a:off x="20063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solidFill>
              <a:srgbClr val="85D1EC"/>
            </a:solidFill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</p:grpSp>
      <p:sp>
        <p:nvSpPr>
          <p:cNvPr id="295" name="Date Placeholder 3">
            <a:extLst>
              <a:ext uri="{FF2B5EF4-FFF2-40B4-BE49-F238E27FC236}">
                <a16:creationId xmlns:a16="http://schemas.microsoft.com/office/drawing/2014/main" id="{A28A91CD-1DE9-4D8C-95D1-C1C70CCB4E6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513358" y="7165953"/>
            <a:ext cx="676085" cy="179921"/>
          </a:xfrm>
        </p:spPr>
        <p:txBody>
          <a:bodyPr/>
          <a:lstStyle/>
          <a:p>
            <a:fld id="{2003B1D3-F118-4DC2-9C13-CFA16C6DBB7D}" type="datetime1">
              <a:rPr lang="en-GB" smtClean="0"/>
              <a:t>26/01/2023</a:t>
            </a:fld>
            <a:endParaRPr lang="en-GB"/>
          </a:p>
        </p:txBody>
      </p:sp>
      <p:sp>
        <p:nvSpPr>
          <p:cNvPr id="296" name="Footer Placeholder 4">
            <a:extLst>
              <a:ext uri="{FF2B5EF4-FFF2-40B4-BE49-F238E27FC236}">
                <a16:creationId xmlns:a16="http://schemas.microsoft.com/office/drawing/2014/main" id="{2424FC31-CE78-4C31-BB97-A80E82A56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1269414" y="7165952"/>
            <a:ext cx="7064081" cy="179921"/>
          </a:xfrm>
        </p:spPr>
        <p:txBody>
          <a:bodyPr/>
          <a:lstStyle/>
          <a:p>
            <a:endParaRPr lang="en-GB"/>
          </a:p>
        </p:txBody>
      </p:sp>
      <p:sp>
        <p:nvSpPr>
          <p:cNvPr id="297" name="Slide Number Placeholder 5">
            <a:extLst>
              <a:ext uri="{FF2B5EF4-FFF2-40B4-BE49-F238E27FC236}">
                <a16:creationId xmlns:a16="http://schemas.microsoft.com/office/drawing/2014/main" id="{9E754D4A-8F07-48F1-ADC4-FCC25FA89E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413467" y="7165954"/>
            <a:ext cx="394875" cy="179921"/>
          </a:xfrm>
        </p:spPr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61003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dia met afbeeld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icture Placeholder 250">
            <a:extLst>
              <a:ext uri="{FF2B5EF4-FFF2-40B4-BE49-F238E27FC236}">
                <a16:creationId xmlns:a16="http://schemas.microsoft.com/office/drawing/2014/main" id="{8FC9796D-6AA5-4C11-9361-CFA70946833A}"/>
              </a:ext>
            </a:extLst>
          </p:cNvPr>
          <p:cNvSpPr>
            <a:spLocks noGrp="1"/>
          </p:cNvSpPr>
          <p:nvPr>
            <p:ph type="pic" sz="quarter" idx="13" hasCustomPrompt="1"/>
          </p:nvPr>
        </p:nvSpPr>
        <p:spPr bwMode="auto">
          <a:xfrm>
            <a:off x="49" y="35"/>
            <a:ext cx="9905952" cy="6857967"/>
          </a:xfrm>
          <a:custGeom>
            <a:avLst/>
            <a:gdLst>
              <a:gd name="connsiteX0" fmla="*/ 9042170 w 12191941"/>
              <a:gd name="connsiteY0" fmla="*/ 6474347 h 6857967"/>
              <a:gd name="connsiteX1" fmla="*/ 9042170 w 12191941"/>
              <a:gd name="connsiteY1" fmla="*/ 6545648 h 6857967"/>
              <a:gd name="connsiteX2" fmla="*/ 9113471 w 12191941"/>
              <a:gd name="connsiteY2" fmla="*/ 6545648 h 6857967"/>
              <a:gd name="connsiteX3" fmla="*/ 9113471 w 12191941"/>
              <a:gd name="connsiteY3" fmla="*/ 6474347 h 6857967"/>
              <a:gd name="connsiteX4" fmla="*/ 8899568 w 12191941"/>
              <a:gd name="connsiteY4" fmla="*/ 6474347 h 6857967"/>
              <a:gd name="connsiteX5" fmla="*/ 8899568 w 12191941"/>
              <a:gd name="connsiteY5" fmla="*/ 6545648 h 6857967"/>
              <a:gd name="connsiteX6" fmla="*/ 8970869 w 12191941"/>
              <a:gd name="connsiteY6" fmla="*/ 6545648 h 6857967"/>
              <a:gd name="connsiteX7" fmla="*/ 8970869 w 12191941"/>
              <a:gd name="connsiteY7" fmla="*/ 6474347 h 6857967"/>
              <a:gd name="connsiteX8" fmla="*/ 8756896 w 12191941"/>
              <a:gd name="connsiteY8" fmla="*/ 6474347 h 6857967"/>
              <a:gd name="connsiteX9" fmla="*/ 8756896 w 12191941"/>
              <a:gd name="connsiteY9" fmla="*/ 6545648 h 6857967"/>
              <a:gd name="connsiteX10" fmla="*/ 8828196 w 12191941"/>
              <a:gd name="connsiteY10" fmla="*/ 6545648 h 6857967"/>
              <a:gd name="connsiteX11" fmla="*/ 8828196 w 12191941"/>
              <a:gd name="connsiteY11" fmla="*/ 6474347 h 6857967"/>
              <a:gd name="connsiteX12" fmla="*/ 8614223 w 12191941"/>
              <a:gd name="connsiteY12" fmla="*/ 6474347 h 6857967"/>
              <a:gd name="connsiteX13" fmla="*/ 8614223 w 12191941"/>
              <a:gd name="connsiteY13" fmla="*/ 6545648 h 6857967"/>
              <a:gd name="connsiteX14" fmla="*/ 8685524 w 12191941"/>
              <a:gd name="connsiteY14" fmla="*/ 6545648 h 6857967"/>
              <a:gd name="connsiteX15" fmla="*/ 8685524 w 12191941"/>
              <a:gd name="connsiteY15" fmla="*/ 6474347 h 6857967"/>
              <a:gd name="connsiteX16" fmla="*/ 8471622 w 12191941"/>
              <a:gd name="connsiteY16" fmla="*/ 6474347 h 6857967"/>
              <a:gd name="connsiteX17" fmla="*/ 8471622 w 12191941"/>
              <a:gd name="connsiteY17" fmla="*/ 6545648 h 6857967"/>
              <a:gd name="connsiteX18" fmla="*/ 8542923 w 12191941"/>
              <a:gd name="connsiteY18" fmla="*/ 6545648 h 6857967"/>
              <a:gd name="connsiteX19" fmla="*/ 8542923 w 12191941"/>
              <a:gd name="connsiteY19" fmla="*/ 6474347 h 6857967"/>
              <a:gd name="connsiteX20" fmla="*/ 8328949 w 12191941"/>
              <a:gd name="connsiteY20" fmla="*/ 6474347 h 6857967"/>
              <a:gd name="connsiteX21" fmla="*/ 8328949 w 12191941"/>
              <a:gd name="connsiteY21" fmla="*/ 6545648 h 6857967"/>
              <a:gd name="connsiteX22" fmla="*/ 8400250 w 12191941"/>
              <a:gd name="connsiteY22" fmla="*/ 6545648 h 6857967"/>
              <a:gd name="connsiteX23" fmla="*/ 8400250 w 12191941"/>
              <a:gd name="connsiteY23" fmla="*/ 6474347 h 6857967"/>
              <a:gd name="connsiteX24" fmla="*/ 8186348 w 12191941"/>
              <a:gd name="connsiteY24" fmla="*/ 6474347 h 6857967"/>
              <a:gd name="connsiteX25" fmla="*/ 8186348 w 12191941"/>
              <a:gd name="connsiteY25" fmla="*/ 6545648 h 6857967"/>
              <a:gd name="connsiteX26" fmla="*/ 8257649 w 12191941"/>
              <a:gd name="connsiteY26" fmla="*/ 6545648 h 6857967"/>
              <a:gd name="connsiteX27" fmla="*/ 8257649 w 12191941"/>
              <a:gd name="connsiteY27" fmla="*/ 6474347 h 6857967"/>
              <a:gd name="connsiteX28" fmla="*/ 8043675 w 12191941"/>
              <a:gd name="connsiteY28" fmla="*/ 6474347 h 6857967"/>
              <a:gd name="connsiteX29" fmla="*/ 8043675 w 12191941"/>
              <a:gd name="connsiteY29" fmla="*/ 6545648 h 6857967"/>
              <a:gd name="connsiteX30" fmla="*/ 8114976 w 12191941"/>
              <a:gd name="connsiteY30" fmla="*/ 6545648 h 6857967"/>
              <a:gd name="connsiteX31" fmla="*/ 8114976 w 12191941"/>
              <a:gd name="connsiteY31" fmla="*/ 6474347 h 6857967"/>
              <a:gd name="connsiteX32" fmla="*/ 7901003 w 12191941"/>
              <a:gd name="connsiteY32" fmla="*/ 6474347 h 6857967"/>
              <a:gd name="connsiteX33" fmla="*/ 7901003 w 12191941"/>
              <a:gd name="connsiteY33" fmla="*/ 6545648 h 6857967"/>
              <a:gd name="connsiteX34" fmla="*/ 7972304 w 12191941"/>
              <a:gd name="connsiteY34" fmla="*/ 6545648 h 6857967"/>
              <a:gd name="connsiteX35" fmla="*/ 7972304 w 12191941"/>
              <a:gd name="connsiteY35" fmla="*/ 6474347 h 6857967"/>
              <a:gd name="connsiteX36" fmla="*/ 7758401 w 12191941"/>
              <a:gd name="connsiteY36" fmla="*/ 6474347 h 6857967"/>
              <a:gd name="connsiteX37" fmla="*/ 7758401 w 12191941"/>
              <a:gd name="connsiteY37" fmla="*/ 6545648 h 6857967"/>
              <a:gd name="connsiteX38" fmla="*/ 7829702 w 12191941"/>
              <a:gd name="connsiteY38" fmla="*/ 6545648 h 6857967"/>
              <a:gd name="connsiteX39" fmla="*/ 7829702 w 12191941"/>
              <a:gd name="connsiteY39" fmla="*/ 6474347 h 6857967"/>
              <a:gd name="connsiteX40" fmla="*/ 7615728 w 12191941"/>
              <a:gd name="connsiteY40" fmla="*/ 6474347 h 6857967"/>
              <a:gd name="connsiteX41" fmla="*/ 7615728 w 12191941"/>
              <a:gd name="connsiteY41" fmla="*/ 6545648 h 6857967"/>
              <a:gd name="connsiteX42" fmla="*/ 7687029 w 12191941"/>
              <a:gd name="connsiteY42" fmla="*/ 6545648 h 6857967"/>
              <a:gd name="connsiteX43" fmla="*/ 7687029 w 12191941"/>
              <a:gd name="connsiteY43" fmla="*/ 6474347 h 6857967"/>
              <a:gd name="connsiteX44" fmla="*/ 7473127 w 12191941"/>
              <a:gd name="connsiteY44" fmla="*/ 6474347 h 6857967"/>
              <a:gd name="connsiteX45" fmla="*/ 7473127 w 12191941"/>
              <a:gd name="connsiteY45" fmla="*/ 6545648 h 6857967"/>
              <a:gd name="connsiteX46" fmla="*/ 7544428 w 12191941"/>
              <a:gd name="connsiteY46" fmla="*/ 6545648 h 6857967"/>
              <a:gd name="connsiteX47" fmla="*/ 7544428 w 12191941"/>
              <a:gd name="connsiteY47" fmla="*/ 6474347 h 6857967"/>
              <a:gd name="connsiteX48" fmla="*/ 7330454 w 12191941"/>
              <a:gd name="connsiteY48" fmla="*/ 6474347 h 6857967"/>
              <a:gd name="connsiteX49" fmla="*/ 7330454 w 12191941"/>
              <a:gd name="connsiteY49" fmla="*/ 6545648 h 6857967"/>
              <a:gd name="connsiteX50" fmla="*/ 7401755 w 12191941"/>
              <a:gd name="connsiteY50" fmla="*/ 6545648 h 6857967"/>
              <a:gd name="connsiteX51" fmla="*/ 7401755 w 12191941"/>
              <a:gd name="connsiteY51" fmla="*/ 6474347 h 6857967"/>
              <a:gd name="connsiteX52" fmla="*/ 7187853 w 12191941"/>
              <a:gd name="connsiteY52" fmla="*/ 6474347 h 6857967"/>
              <a:gd name="connsiteX53" fmla="*/ 7187853 w 12191941"/>
              <a:gd name="connsiteY53" fmla="*/ 6545648 h 6857967"/>
              <a:gd name="connsiteX54" fmla="*/ 7259154 w 12191941"/>
              <a:gd name="connsiteY54" fmla="*/ 6545648 h 6857967"/>
              <a:gd name="connsiteX55" fmla="*/ 7259154 w 12191941"/>
              <a:gd name="connsiteY55" fmla="*/ 6474347 h 6857967"/>
              <a:gd name="connsiteX56" fmla="*/ 7045180 w 12191941"/>
              <a:gd name="connsiteY56" fmla="*/ 6474347 h 6857967"/>
              <a:gd name="connsiteX57" fmla="*/ 7045180 w 12191941"/>
              <a:gd name="connsiteY57" fmla="*/ 6545648 h 6857967"/>
              <a:gd name="connsiteX58" fmla="*/ 7116481 w 12191941"/>
              <a:gd name="connsiteY58" fmla="*/ 6545648 h 6857967"/>
              <a:gd name="connsiteX59" fmla="*/ 7116481 w 12191941"/>
              <a:gd name="connsiteY59" fmla="*/ 6474347 h 6857967"/>
              <a:gd name="connsiteX60" fmla="*/ 6902579 w 12191941"/>
              <a:gd name="connsiteY60" fmla="*/ 6474347 h 6857967"/>
              <a:gd name="connsiteX61" fmla="*/ 6902579 w 12191941"/>
              <a:gd name="connsiteY61" fmla="*/ 6545648 h 6857967"/>
              <a:gd name="connsiteX62" fmla="*/ 6973880 w 12191941"/>
              <a:gd name="connsiteY62" fmla="*/ 6545648 h 6857967"/>
              <a:gd name="connsiteX63" fmla="*/ 6973880 w 12191941"/>
              <a:gd name="connsiteY63" fmla="*/ 6474347 h 6857967"/>
              <a:gd name="connsiteX64" fmla="*/ 6759906 w 12191941"/>
              <a:gd name="connsiteY64" fmla="*/ 6474347 h 6857967"/>
              <a:gd name="connsiteX65" fmla="*/ 6759906 w 12191941"/>
              <a:gd name="connsiteY65" fmla="*/ 6545648 h 6857967"/>
              <a:gd name="connsiteX66" fmla="*/ 6831207 w 12191941"/>
              <a:gd name="connsiteY66" fmla="*/ 6545648 h 6857967"/>
              <a:gd name="connsiteX67" fmla="*/ 6831207 w 12191941"/>
              <a:gd name="connsiteY67" fmla="*/ 6474347 h 6857967"/>
              <a:gd name="connsiteX68" fmla="*/ 6617234 w 12191941"/>
              <a:gd name="connsiteY68" fmla="*/ 6474347 h 6857967"/>
              <a:gd name="connsiteX69" fmla="*/ 6617234 w 12191941"/>
              <a:gd name="connsiteY69" fmla="*/ 6545648 h 6857967"/>
              <a:gd name="connsiteX70" fmla="*/ 6688535 w 12191941"/>
              <a:gd name="connsiteY70" fmla="*/ 6545648 h 6857967"/>
              <a:gd name="connsiteX71" fmla="*/ 6688535 w 12191941"/>
              <a:gd name="connsiteY71" fmla="*/ 6474347 h 6857967"/>
              <a:gd name="connsiteX72" fmla="*/ 6474632 w 12191941"/>
              <a:gd name="connsiteY72" fmla="*/ 6474347 h 6857967"/>
              <a:gd name="connsiteX73" fmla="*/ 6474632 w 12191941"/>
              <a:gd name="connsiteY73" fmla="*/ 6545648 h 6857967"/>
              <a:gd name="connsiteX74" fmla="*/ 6545933 w 12191941"/>
              <a:gd name="connsiteY74" fmla="*/ 6545648 h 6857967"/>
              <a:gd name="connsiteX75" fmla="*/ 6545933 w 12191941"/>
              <a:gd name="connsiteY75" fmla="*/ 6474347 h 6857967"/>
              <a:gd name="connsiteX76" fmla="*/ 6331959 w 12191941"/>
              <a:gd name="connsiteY76" fmla="*/ 6474347 h 6857967"/>
              <a:gd name="connsiteX77" fmla="*/ 6331959 w 12191941"/>
              <a:gd name="connsiteY77" fmla="*/ 6545648 h 6857967"/>
              <a:gd name="connsiteX78" fmla="*/ 6403260 w 12191941"/>
              <a:gd name="connsiteY78" fmla="*/ 6545648 h 6857967"/>
              <a:gd name="connsiteX79" fmla="*/ 6403260 w 12191941"/>
              <a:gd name="connsiteY79" fmla="*/ 6474347 h 6857967"/>
              <a:gd name="connsiteX80" fmla="*/ 6189358 w 12191941"/>
              <a:gd name="connsiteY80" fmla="*/ 6474347 h 6857967"/>
              <a:gd name="connsiteX81" fmla="*/ 6189358 w 12191941"/>
              <a:gd name="connsiteY81" fmla="*/ 6545648 h 6857967"/>
              <a:gd name="connsiteX82" fmla="*/ 6260659 w 12191941"/>
              <a:gd name="connsiteY82" fmla="*/ 6545648 h 6857967"/>
              <a:gd name="connsiteX83" fmla="*/ 6260659 w 12191941"/>
              <a:gd name="connsiteY83" fmla="*/ 6474347 h 6857967"/>
              <a:gd name="connsiteX84" fmla="*/ 6046689 w 12191941"/>
              <a:gd name="connsiteY84" fmla="*/ 6474347 h 6857967"/>
              <a:gd name="connsiteX85" fmla="*/ 6046689 w 12191941"/>
              <a:gd name="connsiteY85" fmla="*/ 6545648 h 6857967"/>
              <a:gd name="connsiteX86" fmla="*/ 6117986 w 12191941"/>
              <a:gd name="connsiteY86" fmla="*/ 6545648 h 6857967"/>
              <a:gd name="connsiteX87" fmla="*/ 6117986 w 12191941"/>
              <a:gd name="connsiteY87" fmla="*/ 6474347 h 6857967"/>
              <a:gd name="connsiteX88" fmla="*/ 5904022 w 12191941"/>
              <a:gd name="connsiteY88" fmla="*/ 6474347 h 6857967"/>
              <a:gd name="connsiteX89" fmla="*/ 5904022 w 12191941"/>
              <a:gd name="connsiteY89" fmla="*/ 6545648 h 6857967"/>
              <a:gd name="connsiteX90" fmla="*/ 5975319 w 12191941"/>
              <a:gd name="connsiteY90" fmla="*/ 6545648 h 6857967"/>
              <a:gd name="connsiteX91" fmla="*/ 5975319 w 12191941"/>
              <a:gd name="connsiteY91" fmla="*/ 6474347 h 6857967"/>
              <a:gd name="connsiteX92" fmla="*/ 5761426 w 12191941"/>
              <a:gd name="connsiteY92" fmla="*/ 6474347 h 6857967"/>
              <a:gd name="connsiteX93" fmla="*/ 5761426 w 12191941"/>
              <a:gd name="connsiteY93" fmla="*/ 6545648 h 6857967"/>
              <a:gd name="connsiteX94" fmla="*/ 5832724 w 12191941"/>
              <a:gd name="connsiteY94" fmla="*/ 6545648 h 6857967"/>
              <a:gd name="connsiteX95" fmla="*/ 5832724 w 12191941"/>
              <a:gd name="connsiteY95" fmla="*/ 6474347 h 6857967"/>
              <a:gd name="connsiteX96" fmla="*/ 5618761 w 12191941"/>
              <a:gd name="connsiteY96" fmla="*/ 6474347 h 6857967"/>
              <a:gd name="connsiteX97" fmla="*/ 5618761 w 12191941"/>
              <a:gd name="connsiteY97" fmla="*/ 6545648 h 6857967"/>
              <a:gd name="connsiteX98" fmla="*/ 5690059 w 12191941"/>
              <a:gd name="connsiteY98" fmla="*/ 6545648 h 6857967"/>
              <a:gd name="connsiteX99" fmla="*/ 5690059 w 12191941"/>
              <a:gd name="connsiteY99" fmla="*/ 6474347 h 6857967"/>
              <a:gd name="connsiteX100" fmla="*/ 5476167 w 12191941"/>
              <a:gd name="connsiteY100" fmla="*/ 6474347 h 6857967"/>
              <a:gd name="connsiteX101" fmla="*/ 5476167 w 12191941"/>
              <a:gd name="connsiteY101" fmla="*/ 6545648 h 6857967"/>
              <a:gd name="connsiteX102" fmla="*/ 5547463 w 12191941"/>
              <a:gd name="connsiteY102" fmla="*/ 6545648 h 6857967"/>
              <a:gd name="connsiteX103" fmla="*/ 5547463 w 12191941"/>
              <a:gd name="connsiteY103" fmla="*/ 6474347 h 6857967"/>
              <a:gd name="connsiteX104" fmla="*/ 5333500 w 12191941"/>
              <a:gd name="connsiteY104" fmla="*/ 6474347 h 6857967"/>
              <a:gd name="connsiteX105" fmla="*/ 5333500 w 12191941"/>
              <a:gd name="connsiteY105" fmla="*/ 6545648 h 6857967"/>
              <a:gd name="connsiteX106" fmla="*/ 5404799 w 12191941"/>
              <a:gd name="connsiteY106" fmla="*/ 6545648 h 6857967"/>
              <a:gd name="connsiteX107" fmla="*/ 5404799 w 12191941"/>
              <a:gd name="connsiteY107" fmla="*/ 6474347 h 6857967"/>
              <a:gd name="connsiteX108" fmla="*/ 5190877 w 12191941"/>
              <a:gd name="connsiteY108" fmla="*/ 6474347 h 6857967"/>
              <a:gd name="connsiteX109" fmla="*/ 5190877 w 12191941"/>
              <a:gd name="connsiteY109" fmla="*/ 6545648 h 6857967"/>
              <a:gd name="connsiteX110" fmla="*/ 5262188 w 12191941"/>
              <a:gd name="connsiteY110" fmla="*/ 6545648 h 6857967"/>
              <a:gd name="connsiteX111" fmla="*/ 5262188 w 12191941"/>
              <a:gd name="connsiteY111" fmla="*/ 6474347 h 6857967"/>
              <a:gd name="connsiteX112" fmla="*/ 5048236 w 12191941"/>
              <a:gd name="connsiteY112" fmla="*/ 6474347 h 6857967"/>
              <a:gd name="connsiteX113" fmla="*/ 5048236 w 12191941"/>
              <a:gd name="connsiteY113" fmla="*/ 6545648 h 6857967"/>
              <a:gd name="connsiteX114" fmla="*/ 5119527 w 12191941"/>
              <a:gd name="connsiteY114" fmla="*/ 6545648 h 6857967"/>
              <a:gd name="connsiteX115" fmla="*/ 5119527 w 12191941"/>
              <a:gd name="connsiteY115" fmla="*/ 6474347 h 6857967"/>
              <a:gd name="connsiteX116" fmla="*/ 4906607 w 12191941"/>
              <a:gd name="connsiteY116" fmla="*/ 6474347 h 6857967"/>
              <a:gd name="connsiteX117" fmla="*/ 4906607 w 12191941"/>
              <a:gd name="connsiteY117" fmla="*/ 6545648 h 6857967"/>
              <a:gd name="connsiteX118" fmla="*/ 4977916 w 12191941"/>
              <a:gd name="connsiteY118" fmla="*/ 6545648 h 6857967"/>
              <a:gd name="connsiteX119" fmla="*/ 4977916 w 12191941"/>
              <a:gd name="connsiteY119" fmla="*/ 6474347 h 6857967"/>
              <a:gd name="connsiteX120" fmla="*/ 4764013 w 12191941"/>
              <a:gd name="connsiteY120" fmla="*/ 6474347 h 6857967"/>
              <a:gd name="connsiteX121" fmla="*/ 4764013 w 12191941"/>
              <a:gd name="connsiteY121" fmla="*/ 6545648 h 6857967"/>
              <a:gd name="connsiteX122" fmla="*/ 4835311 w 12191941"/>
              <a:gd name="connsiteY122" fmla="*/ 6545648 h 6857967"/>
              <a:gd name="connsiteX123" fmla="*/ 4835311 w 12191941"/>
              <a:gd name="connsiteY123" fmla="*/ 6474347 h 6857967"/>
              <a:gd name="connsiteX124" fmla="*/ 4621341 w 12191941"/>
              <a:gd name="connsiteY124" fmla="*/ 6474347 h 6857967"/>
              <a:gd name="connsiteX125" fmla="*/ 4621341 w 12191941"/>
              <a:gd name="connsiteY125" fmla="*/ 6545648 h 6857967"/>
              <a:gd name="connsiteX126" fmla="*/ 4692639 w 12191941"/>
              <a:gd name="connsiteY126" fmla="*/ 6545648 h 6857967"/>
              <a:gd name="connsiteX127" fmla="*/ 4692639 w 12191941"/>
              <a:gd name="connsiteY127" fmla="*/ 6474347 h 6857967"/>
              <a:gd name="connsiteX128" fmla="*/ 4478666 w 12191941"/>
              <a:gd name="connsiteY128" fmla="*/ 6474347 h 6857967"/>
              <a:gd name="connsiteX129" fmla="*/ 4478666 w 12191941"/>
              <a:gd name="connsiteY129" fmla="*/ 6545648 h 6857967"/>
              <a:gd name="connsiteX130" fmla="*/ 4549969 w 12191941"/>
              <a:gd name="connsiteY130" fmla="*/ 6545648 h 6857967"/>
              <a:gd name="connsiteX131" fmla="*/ 4549969 w 12191941"/>
              <a:gd name="connsiteY131" fmla="*/ 6474347 h 6857967"/>
              <a:gd name="connsiteX132" fmla="*/ 4336061 w 12191941"/>
              <a:gd name="connsiteY132" fmla="*/ 6474347 h 6857967"/>
              <a:gd name="connsiteX133" fmla="*/ 4336061 w 12191941"/>
              <a:gd name="connsiteY133" fmla="*/ 6545648 h 6857967"/>
              <a:gd name="connsiteX134" fmla="*/ 4407362 w 12191941"/>
              <a:gd name="connsiteY134" fmla="*/ 6545648 h 6857967"/>
              <a:gd name="connsiteX135" fmla="*/ 4407362 w 12191941"/>
              <a:gd name="connsiteY135" fmla="*/ 6474347 h 6857967"/>
              <a:gd name="connsiteX136" fmla="*/ 4193412 w 12191941"/>
              <a:gd name="connsiteY136" fmla="*/ 6474347 h 6857967"/>
              <a:gd name="connsiteX137" fmla="*/ 4193412 w 12191941"/>
              <a:gd name="connsiteY137" fmla="*/ 6545648 h 6857967"/>
              <a:gd name="connsiteX138" fmla="*/ 4264695 w 12191941"/>
              <a:gd name="connsiteY138" fmla="*/ 6545648 h 6857967"/>
              <a:gd name="connsiteX139" fmla="*/ 4264695 w 12191941"/>
              <a:gd name="connsiteY139" fmla="*/ 6474347 h 6857967"/>
              <a:gd name="connsiteX140" fmla="*/ 4050809 w 12191941"/>
              <a:gd name="connsiteY140" fmla="*/ 6474347 h 6857967"/>
              <a:gd name="connsiteX141" fmla="*/ 4050809 w 12191941"/>
              <a:gd name="connsiteY141" fmla="*/ 6545648 h 6857967"/>
              <a:gd name="connsiteX142" fmla="*/ 4122113 w 12191941"/>
              <a:gd name="connsiteY142" fmla="*/ 6545648 h 6857967"/>
              <a:gd name="connsiteX143" fmla="*/ 4122113 w 12191941"/>
              <a:gd name="connsiteY143" fmla="*/ 6474347 h 6857967"/>
              <a:gd name="connsiteX144" fmla="*/ 3908136 w 12191941"/>
              <a:gd name="connsiteY144" fmla="*/ 6474347 h 6857967"/>
              <a:gd name="connsiteX145" fmla="*/ 3908136 w 12191941"/>
              <a:gd name="connsiteY145" fmla="*/ 6545648 h 6857967"/>
              <a:gd name="connsiteX146" fmla="*/ 3979438 w 12191941"/>
              <a:gd name="connsiteY146" fmla="*/ 6545648 h 6857967"/>
              <a:gd name="connsiteX147" fmla="*/ 3979438 w 12191941"/>
              <a:gd name="connsiteY147" fmla="*/ 6474347 h 6857967"/>
              <a:gd name="connsiteX148" fmla="*/ 3765462 w 12191941"/>
              <a:gd name="connsiteY148" fmla="*/ 6474347 h 6857967"/>
              <a:gd name="connsiteX149" fmla="*/ 3765462 w 12191941"/>
              <a:gd name="connsiteY149" fmla="*/ 6545648 h 6857967"/>
              <a:gd name="connsiteX150" fmla="*/ 3836763 w 12191941"/>
              <a:gd name="connsiteY150" fmla="*/ 6545648 h 6857967"/>
              <a:gd name="connsiteX151" fmla="*/ 3836763 w 12191941"/>
              <a:gd name="connsiteY151" fmla="*/ 6474347 h 6857967"/>
              <a:gd name="connsiteX152" fmla="*/ 3622851 w 12191941"/>
              <a:gd name="connsiteY152" fmla="*/ 6474347 h 6857967"/>
              <a:gd name="connsiteX153" fmla="*/ 3622851 w 12191941"/>
              <a:gd name="connsiteY153" fmla="*/ 6545648 h 6857967"/>
              <a:gd name="connsiteX154" fmla="*/ 3694151 w 12191941"/>
              <a:gd name="connsiteY154" fmla="*/ 6545648 h 6857967"/>
              <a:gd name="connsiteX155" fmla="*/ 3694151 w 12191941"/>
              <a:gd name="connsiteY155" fmla="*/ 6474347 h 6857967"/>
              <a:gd name="connsiteX156" fmla="*/ 3480203 w 12191941"/>
              <a:gd name="connsiteY156" fmla="*/ 6474347 h 6857967"/>
              <a:gd name="connsiteX157" fmla="*/ 3480203 w 12191941"/>
              <a:gd name="connsiteY157" fmla="*/ 6545648 h 6857967"/>
              <a:gd name="connsiteX158" fmla="*/ 3551509 w 12191941"/>
              <a:gd name="connsiteY158" fmla="*/ 6545648 h 6857967"/>
              <a:gd name="connsiteX159" fmla="*/ 3551509 w 12191941"/>
              <a:gd name="connsiteY159" fmla="*/ 6474347 h 6857967"/>
              <a:gd name="connsiteX160" fmla="*/ 3337579 w 12191941"/>
              <a:gd name="connsiteY160" fmla="*/ 6474347 h 6857967"/>
              <a:gd name="connsiteX161" fmla="*/ 3337579 w 12191941"/>
              <a:gd name="connsiteY161" fmla="*/ 6545648 h 6857967"/>
              <a:gd name="connsiteX162" fmla="*/ 3408880 w 12191941"/>
              <a:gd name="connsiteY162" fmla="*/ 6545648 h 6857967"/>
              <a:gd name="connsiteX163" fmla="*/ 3408880 w 12191941"/>
              <a:gd name="connsiteY163" fmla="*/ 6474347 h 6857967"/>
              <a:gd name="connsiteX164" fmla="*/ 3194905 w 12191941"/>
              <a:gd name="connsiteY164" fmla="*/ 6474347 h 6857967"/>
              <a:gd name="connsiteX165" fmla="*/ 3194905 w 12191941"/>
              <a:gd name="connsiteY165" fmla="*/ 6545648 h 6857967"/>
              <a:gd name="connsiteX166" fmla="*/ 3266206 w 12191941"/>
              <a:gd name="connsiteY166" fmla="*/ 6545648 h 6857967"/>
              <a:gd name="connsiteX167" fmla="*/ 3266206 w 12191941"/>
              <a:gd name="connsiteY167" fmla="*/ 6474347 h 6857967"/>
              <a:gd name="connsiteX168" fmla="*/ 3052304 w 12191941"/>
              <a:gd name="connsiteY168" fmla="*/ 6474347 h 6857967"/>
              <a:gd name="connsiteX169" fmla="*/ 3052304 w 12191941"/>
              <a:gd name="connsiteY169" fmla="*/ 6545648 h 6857967"/>
              <a:gd name="connsiteX170" fmla="*/ 3123606 w 12191941"/>
              <a:gd name="connsiteY170" fmla="*/ 6545648 h 6857967"/>
              <a:gd name="connsiteX171" fmla="*/ 3123606 w 12191941"/>
              <a:gd name="connsiteY171" fmla="*/ 6474347 h 6857967"/>
              <a:gd name="connsiteX172" fmla="*/ 2909633 w 12191941"/>
              <a:gd name="connsiteY172" fmla="*/ 6474347 h 6857967"/>
              <a:gd name="connsiteX173" fmla="*/ 2909633 w 12191941"/>
              <a:gd name="connsiteY173" fmla="*/ 6545648 h 6857967"/>
              <a:gd name="connsiteX174" fmla="*/ 2980934 w 12191941"/>
              <a:gd name="connsiteY174" fmla="*/ 6545648 h 6857967"/>
              <a:gd name="connsiteX175" fmla="*/ 2980934 w 12191941"/>
              <a:gd name="connsiteY175" fmla="*/ 6474347 h 6857967"/>
              <a:gd name="connsiteX176" fmla="*/ 2767033 w 12191941"/>
              <a:gd name="connsiteY176" fmla="*/ 6474347 h 6857967"/>
              <a:gd name="connsiteX177" fmla="*/ 2767033 w 12191941"/>
              <a:gd name="connsiteY177" fmla="*/ 6545648 h 6857967"/>
              <a:gd name="connsiteX178" fmla="*/ 2838334 w 12191941"/>
              <a:gd name="connsiteY178" fmla="*/ 6545648 h 6857967"/>
              <a:gd name="connsiteX179" fmla="*/ 2838334 w 12191941"/>
              <a:gd name="connsiteY179" fmla="*/ 6474347 h 6857967"/>
              <a:gd name="connsiteX180" fmla="*/ 2624360 w 12191941"/>
              <a:gd name="connsiteY180" fmla="*/ 6474347 h 6857967"/>
              <a:gd name="connsiteX181" fmla="*/ 2624360 w 12191941"/>
              <a:gd name="connsiteY181" fmla="*/ 6545648 h 6857967"/>
              <a:gd name="connsiteX182" fmla="*/ 2695661 w 12191941"/>
              <a:gd name="connsiteY182" fmla="*/ 6545648 h 6857967"/>
              <a:gd name="connsiteX183" fmla="*/ 2695661 w 12191941"/>
              <a:gd name="connsiteY183" fmla="*/ 6474347 h 6857967"/>
              <a:gd name="connsiteX184" fmla="*/ 2481690 w 12191941"/>
              <a:gd name="connsiteY184" fmla="*/ 6474347 h 6857967"/>
              <a:gd name="connsiteX185" fmla="*/ 2481690 w 12191941"/>
              <a:gd name="connsiteY185" fmla="*/ 6545648 h 6857967"/>
              <a:gd name="connsiteX186" fmla="*/ 2552990 w 12191941"/>
              <a:gd name="connsiteY186" fmla="*/ 6545648 h 6857967"/>
              <a:gd name="connsiteX187" fmla="*/ 2552990 w 12191941"/>
              <a:gd name="connsiteY187" fmla="*/ 6474347 h 6857967"/>
              <a:gd name="connsiteX188" fmla="*/ 2339090 w 12191941"/>
              <a:gd name="connsiteY188" fmla="*/ 6474347 h 6857967"/>
              <a:gd name="connsiteX189" fmla="*/ 2339090 w 12191941"/>
              <a:gd name="connsiteY189" fmla="*/ 6545648 h 6857967"/>
              <a:gd name="connsiteX190" fmla="*/ 2410390 w 12191941"/>
              <a:gd name="connsiteY190" fmla="*/ 6545648 h 6857967"/>
              <a:gd name="connsiteX191" fmla="*/ 2410390 w 12191941"/>
              <a:gd name="connsiteY191" fmla="*/ 6474347 h 6857967"/>
              <a:gd name="connsiteX192" fmla="*/ 2196420 w 12191941"/>
              <a:gd name="connsiteY192" fmla="*/ 6474347 h 6857967"/>
              <a:gd name="connsiteX193" fmla="*/ 2196420 w 12191941"/>
              <a:gd name="connsiteY193" fmla="*/ 6545648 h 6857967"/>
              <a:gd name="connsiteX194" fmla="*/ 2267720 w 12191941"/>
              <a:gd name="connsiteY194" fmla="*/ 6545648 h 6857967"/>
              <a:gd name="connsiteX195" fmla="*/ 2267720 w 12191941"/>
              <a:gd name="connsiteY195" fmla="*/ 6474347 h 6857967"/>
              <a:gd name="connsiteX196" fmla="*/ 2053813 w 12191941"/>
              <a:gd name="connsiteY196" fmla="*/ 6474347 h 6857967"/>
              <a:gd name="connsiteX197" fmla="*/ 2053813 w 12191941"/>
              <a:gd name="connsiteY197" fmla="*/ 6545648 h 6857967"/>
              <a:gd name="connsiteX198" fmla="*/ 2125117 w 12191941"/>
              <a:gd name="connsiteY198" fmla="*/ 6545648 h 6857967"/>
              <a:gd name="connsiteX199" fmla="*/ 2125117 w 12191941"/>
              <a:gd name="connsiteY199" fmla="*/ 6474347 h 6857967"/>
              <a:gd name="connsiteX200" fmla="*/ 1911141 w 12191941"/>
              <a:gd name="connsiteY200" fmla="*/ 6474347 h 6857967"/>
              <a:gd name="connsiteX201" fmla="*/ 1911141 w 12191941"/>
              <a:gd name="connsiteY201" fmla="*/ 6545648 h 6857967"/>
              <a:gd name="connsiteX202" fmla="*/ 1982442 w 12191941"/>
              <a:gd name="connsiteY202" fmla="*/ 6545648 h 6857967"/>
              <a:gd name="connsiteX203" fmla="*/ 1982442 w 12191941"/>
              <a:gd name="connsiteY203" fmla="*/ 6474347 h 6857967"/>
              <a:gd name="connsiteX204" fmla="*/ 1768470 w 12191941"/>
              <a:gd name="connsiteY204" fmla="*/ 6474347 h 6857967"/>
              <a:gd name="connsiteX205" fmla="*/ 1768470 w 12191941"/>
              <a:gd name="connsiteY205" fmla="*/ 6545648 h 6857967"/>
              <a:gd name="connsiteX206" fmla="*/ 1839771 w 12191941"/>
              <a:gd name="connsiteY206" fmla="*/ 6545648 h 6857967"/>
              <a:gd name="connsiteX207" fmla="*/ 1839771 w 12191941"/>
              <a:gd name="connsiteY207" fmla="*/ 6474347 h 6857967"/>
              <a:gd name="connsiteX208" fmla="*/ 1625870 w 12191941"/>
              <a:gd name="connsiteY208" fmla="*/ 6474347 h 6857967"/>
              <a:gd name="connsiteX209" fmla="*/ 1625870 w 12191941"/>
              <a:gd name="connsiteY209" fmla="*/ 6545648 h 6857967"/>
              <a:gd name="connsiteX210" fmla="*/ 1697170 w 12191941"/>
              <a:gd name="connsiteY210" fmla="*/ 6545648 h 6857967"/>
              <a:gd name="connsiteX211" fmla="*/ 1697170 w 12191941"/>
              <a:gd name="connsiteY211" fmla="*/ 6474347 h 6857967"/>
              <a:gd name="connsiteX212" fmla="*/ 1483199 w 12191941"/>
              <a:gd name="connsiteY212" fmla="*/ 6474347 h 6857967"/>
              <a:gd name="connsiteX213" fmla="*/ 1483199 w 12191941"/>
              <a:gd name="connsiteY213" fmla="*/ 6545648 h 6857967"/>
              <a:gd name="connsiteX214" fmla="*/ 1554500 w 12191941"/>
              <a:gd name="connsiteY214" fmla="*/ 6545648 h 6857967"/>
              <a:gd name="connsiteX215" fmla="*/ 1554500 w 12191941"/>
              <a:gd name="connsiteY215" fmla="*/ 6474347 h 6857967"/>
              <a:gd name="connsiteX216" fmla="*/ 1340599 w 12191941"/>
              <a:gd name="connsiteY216" fmla="*/ 6474347 h 6857967"/>
              <a:gd name="connsiteX217" fmla="*/ 1340599 w 12191941"/>
              <a:gd name="connsiteY217" fmla="*/ 6545648 h 6857967"/>
              <a:gd name="connsiteX218" fmla="*/ 1411899 w 12191941"/>
              <a:gd name="connsiteY218" fmla="*/ 6545648 h 6857967"/>
              <a:gd name="connsiteX219" fmla="*/ 1411899 w 12191941"/>
              <a:gd name="connsiteY219" fmla="*/ 6474347 h 6857967"/>
              <a:gd name="connsiteX220" fmla="*/ 1197929 w 12191941"/>
              <a:gd name="connsiteY220" fmla="*/ 6474347 h 6857967"/>
              <a:gd name="connsiteX221" fmla="*/ 1197929 w 12191941"/>
              <a:gd name="connsiteY221" fmla="*/ 6545648 h 6857967"/>
              <a:gd name="connsiteX222" fmla="*/ 1269230 w 12191941"/>
              <a:gd name="connsiteY222" fmla="*/ 6545648 h 6857967"/>
              <a:gd name="connsiteX223" fmla="*/ 1269230 w 12191941"/>
              <a:gd name="connsiteY223" fmla="*/ 6474347 h 6857967"/>
              <a:gd name="connsiteX224" fmla="*/ 1055311 w 12191941"/>
              <a:gd name="connsiteY224" fmla="*/ 6474347 h 6857967"/>
              <a:gd name="connsiteX225" fmla="*/ 1055311 w 12191941"/>
              <a:gd name="connsiteY225" fmla="*/ 6545648 h 6857967"/>
              <a:gd name="connsiteX226" fmla="*/ 1126612 w 12191941"/>
              <a:gd name="connsiteY226" fmla="*/ 6545648 h 6857967"/>
              <a:gd name="connsiteX227" fmla="*/ 1126612 w 12191941"/>
              <a:gd name="connsiteY227" fmla="*/ 6474347 h 6857967"/>
              <a:gd name="connsiteX228" fmla="*/ 912657 w 12191941"/>
              <a:gd name="connsiteY228" fmla="*/ 6474347 h 6857967"/>
              <a:gd name="connsiteX229" fmla="*/ 912657 w 12191941"/>
              <a:gd name="connsiteY229" fmla="*/ 6545648 h 6857967"/>
              <a:gd name="connsiteX230" fmla="*/ 983958 w 12191941"/>
              <a:gd name="connsiteY230" fmla="*/ 6545648 h 6857967"/>
              <a:gd name="connsiteX231" fmla="*/ 983958 w 12191941"/>
              <a:gd name="connsiteY231" fmla="*/ 6474347 h 6857967"/>
              <a:gd name="connsiteX232" fmla="*/ 771135 w 12191941"/>
              <a:gd name="connsiteY232" fmla="*/ 6474347 h 6857967"/>
              <a:gd name="connsiteX233" fmla="*/ 771135 w 12191941"/>
              <a:gd name="connsiteY233" fmla="*/ 6545648 h 6857967"/>
              <a:gd name="connsiteX234" fmla="*/ 842436 w 12191941"/>
              <a:gd name="connsiteY234" fmla="*/ 6545648 h 6857967"/>
              <a:gd name="connsiteX235" fmla="*/ 842436 w 12191941"/>
              <a:gd name="connsiteY235" fmla="*/ 6474347 h 6857967"/>
              <a:gd name="connsiteX236" fmla="*/ 628534 w 12191941"/>
              <a:gd name="connsiteY236" fmla="*/ 6474347 h 6857967"/>
              <a:gd name="connsiteX237" fmla="*/ 628534 w 12191941"/>
              <a:gd name="connsiteY237" fmla="*/ 6545648 h 6857967"/>
              <a:gd name="connsiteX238" fmla="*/ 699835 w 12191941"/>
              <a:gd name="connsiteY238" fmla="*/ 6545648 h 6857967"/>
              <a:gd name="connsiteX239" fmla="*/ 699835 w 12191941"/>
              <a:gd name="connsiteY239" fmla="*/ 6474347 h 6857967"/>
              <a:gd name="connsiteX240" fmla="*/ 485863 w 12191941"/>
              <a:gd name="connsiteY240" fmla="*/ 6474347 h 6857967"/>
              <a:gd name="connsiteX241" fmla="*/ 485863 w 12191941"/>
              <a:gd name="connsiteY241" fmla="*/ 6545648 h 6857967"/>
              <a:gd name="connsiteX242" fmla="*/ 557163 w 12191941"/>
              <a:gd name="connsiteY242" fmla="*/ 6545648 h 6857967"/>
              <a:gd name="connsiteX243" fmla="*/ 557163 w 12191941"/>
              <a:gd name="connsiteY243" fmla="*/ 6474347 h 6857967"/>
              <a:gd name="connsiteX244" fmla="*/ 343191 w 12191941"/>
              <a:gd name="connsiteY244" fmla="*/ 6474347 h 6857967"/>
              <a:gd name="connsiteX245" fmla="*/ 343191 w 12191941"/>
              <a:gd name="connsiteY245" fmla="*/ 6545648 h 6857967"/>
              <a:gd name="connsiteX246" fmla="*/ 414492 w 12191941"/>
              <a:gd name="connsiteY246" fmla="*/ 6545648 h 6857967"/>
              <a:gd name="connsiteX247" fmla="*/ 414492 w 12191941"/>
              <a:gd name="connsiteY247" fmla="*/ 6474347 h 6857967"/>
              <a:gd name="connsiteX248" fmla="*/ 200587 w 12191941"/>
              <a:gd name="connsiteY248" fmla="*/ 6474347 h 6857967"/>
              <a:gd name="connsiteX249" fmla="*/ 200587 w 12191941"/>
              <a:gd name="connsiteY249" fmla="*/ 6545648 h 6857967"/>
              <a:gd name="connsiteX250" fmla="*/ 271888 w 12191941"/>
              <a:gd name="connsiteY250" fmla="*/ 6545648 h 6857967"/>
              <a:gd name="connsiteX251" fmla="*/ 271888 w 12191941"/>
              <a:gd name="connsiteY251" fmla="*/ 6474347 h 6857967"/>
              <a:gd name="connsiteX252" fmla="*/ 57918 w 12191941"/>
              <a:gd name="connsiteY252" fmla="*/ 6474347 h 6857967"/>
              <a:gd name="connsiteX253" fmla="*/ 57918 w 12191941"/>
              <a:gd name="connsiteY253" fmla="*/ 6545648 h 6857967"/>
              <a:gd name="connsiteX254" fmla="*/ 129219 w 12191941"/>
              <a:gd name="connsiteY254" fmla="*/ 6545648 h 6857967"/>
              <a:gd name="connsiteX255" fmla="*/ 129219 w 12191941"/>
              <a:gd name="connsiteY255" fmla="*/ 6474347 h 6857967"/>
              <a:gd name="connsiteX256" fmla="*/ 10040665 w 12191941"/>
              <a:gd name="connsiteY256" fmla="*/ 6325709 h 6857967"/>
              <a:gd name="connsiteX257" fmla="*/ 10040665 w 12191941"/>
              <a:gd name="connsiteY257" fmla="*/ 6397010 h 6857967"/>
              <a:gd name="connsiteX258" fmla="*/ 10111966 w 12191941"/>
              <a:gd name="connsiteY258" fmla="*/ 6397010 h 6857967"/>
              <a:gd name="connsiteX259" fmla="*/ 10111966 w 12191941"/>
              <a:gd name="connsiteY259" fmla="*/ 6325709 h 6857967"/>
              <a:gd name="connsiteX260" fmla="*/ 9898063 w 12191941"/>
              <a:gd name="connsiteY260" fmla="*/ 6325709 h 6857967"/>
              <a:gd name="connsiteX261" fmla="*/ 9898063 w 12191941"/>
              <a:gd name="connsiteY261" fmla="*/ 6397010 h 6857967"/>
              <a:gd name="connsiteX262" fmla="*/ 9969363 w 12191941"/>
              <a:gd name="connsiteY262" fmla="*/ 6397010 h 6857967"/>
              <a:gd name="connsiteX263" fmla="*/ 9969363 w 12191941"/>
              <a:gd name="connsiteY263" fmla="*/ 6325709 h 6857967"/>
              <a:gd name="connsiteX264" fmla="*/ 9755391 w 12191941"/>
              <a:gd name="connsiteY264" fmla="*/ 6325709 h 6857967"/>
              <a:gd name="connsiteX265" fmla="*/ 9755391 w 12191941"/>
              <a:gd name="connsiteY265" fmla="*/ 6397010 h 6857967"/>
              <a:gd name="connsiteX266" fmla="*/ 9826692 w 12191941"/>
              <a:gd name="connsiteY266" fmla="*/ 6397010 h 6857967"/>
              <a:gd name="connsiteX267" fmla="*/ 9826692 w 12191941"/>
              <a:gd name="connsiteY267" fmla="*/ 6325709 h 6857967"/>
              <a:gd name="connsiteX268" fmla="*/ 9612718 w 12191941"/>
              <a:gd name="connsiteY268" fmla="*/ 6325709 h 6857967"/>
              <a:gd name="connsiteX269" fmla="*/ 9612718 w 12191941"/>
              <a:gd name="connsiteY269" fmla="*/ 6397010 h 6857967"/>
              <a:gd name="connsiteX270" fmla="*/ 9684019 w 12191941"/>
              <a:gd name="connsiteY270" fmla="*/ 6397010 h 6857967"/>
              <a:gd name="connsiteX271" fmla="*/ 9684019 w 12191941"/>
              <a:gd name="connsiteY271" fmla="*/ 6325709 h 6857967"/>
              <a:gd name="connsiteX272" fmla="*/ 9470117 w 12191941"/>
              <a:gd name="connsiteY272" fmla="*/ 6325709 h 6857967"/>
              <a:gd name="connsiteX273" fmla="*/ 9470117 w 12191941"/>
              <a:gd name="connsiteY273" fmla="*/ 6397010 h 6857967"/>
              <a:gd name="connsiteX274" fmla="*/ 9541417 w 12191941"/>
              <a:gd name="connsiteY274" fmla="*/ 6397010 h 6857967"/>
              <a:gd name="connsiteX275" fmla="*/ 9541417 w 12191941"/>
              <a:gd name="connsiteY275" fmla="*/ 6325709 h 6857967"/>
              <a:gd name="connsiteX276" fmla="*/ 9327444 w 12191941"/>
              <a:gd name="connsiteY276" fmla="*/ 6325709 h 6857967"/>
              <a:gd name="connsiteX277" fmla="*/ 9327444 w 12191941"/>
              <a:gd name="connsiteY277" fmla="*/ 6397010 h 6857967"/>
              <a:gd name="connsiteX278" fmla="*/ 9398745 w 12191941"/>
              <a:gd name="connsiteY278" fmla="*/ 6397010 h 6857967"/>
              <a:gd name="connsiteX279" fmla="*/ 9398745 w 12191941"/>
              <a:gd name="connsiteY279" fmla="*/ 6325709 h 6857967"/>
              <a:gd name="connsiteX280" fmla="*/ 9184842 w 12191941"/>
              <a:gd name="connsiteY280" fmla="*/ 6325709 h 6857967"/>
              <a:gd name="connsiteX281" fmla="*/ 9184842 w 12191941"/>
              <a:gd name="connsiteY281" fmla="*/ 6397010 h 6857967"/>
              <a:gd name="connsiteX282" fmla="*/ 9256143 w 12191941"/>
              <a:gd name="connsiteY282" fmla="*/ 6397010 h 6857967"/>
              <a:gd name="connsiteX283" fmla="*/ 9256143 w 12191941"/>
              <a:gd name="connsiteY283" fmla="*/ 6325709 h 6857967"/>
              <a:gd name="connsiteX284" fmla="*/ 9042170 w 12191941"/>
              <a:gd name="connsiteY284" fmla="*/ 6325709 h 6857967"/>
              <a:gd name="connsiteX285" fmla="*/ 9042170 w 12191941"/>
              <a:gd name="connsiteY285" fmla="*/ 6397010 h 6857967"/>
              <a:gd name="connsiteX286" fmla="*/ 9113471 w 12191941"/>
              <a:gd name="connsiteY286" fmla="*/ 6397010 h 6857967"/>
              <a:gd name="connsiteX287" fmla="*/ 9113471 w 12191941"/>
              <a:gd name="connsiteY287" fmla="*/ 6325709 h 6857967"/>
              <a:gd name="connsiteX288" fmla="*/ 8899568 w 12191941"/>
              <a:gd name="connsiteY288" fmla="*/ 6325709 h 6857967"/>
              <a:gd name="connsiteX289" fmla="*/ 8899568 w 12191941"/>
              <a:gd name="connsiteY289" fmla="*/ 6397010 h 6857967"/>
              <a:gd name="connsiteX290" fmla="*/ 8970869 w 12191941"/>
              <a:gd name="connsiteY290" fmla="*/ 6397010 h 6857967"/>
              <a:gd name="connsiteX291" fmla="*/ 8970869 w 12191941"/>
              <a:gd name="connsiteY291" fmla="*/ 6325709 h 6857967"/>
              <a:gd name="connsiteX292" fmla="*/ 8756896 w 12191941"/>
              <a:gd name="connsiteY292" fmla="*/ 6325709 h 6857967"/>
              <a:gd name="connsiteX293" fmla="*/ 8756896 w 12191941"/>
              <a:gd name="connsiteY293" fmla="*/ 6397010 h 6857967"/>
              <a:gd name="connsiteX294" fmla="*/ 8828196 w 12191941"/>
              <a:gd name="connsiteY294" fmla="*/ 6397010 h 6857967"/>
              <a:gd name="connsiteX295" fmla="*/ 8828196 w 12191941"/>
              <a:gd name="connsiteY295" fmla="*/ 6325709 h 6857967"/>
              <a:gd name="connsiteX296" fmla="*/ 8614223 w 12191941"/>
              <a:gd name="connsiteY296" fmla="*/ 6325709 h 6857967"/>
              <a:gd name="connsiteX297" fmla="*/ 8614223 w 12191941"/>
              <a:gd name="connsiteY297" fmla="*/ 6397010 h 6857967"/>
              <a:gd name="connsiteX298" fmla="*/ 8685524 w 12191941"/>
              <a:gd name="connsiteY298" fmla="*/ 6397010 h 6857967"/>
              <a:gd name="connsiteX299" fmla="*/ 8685524 w 12191941"/>
              <a:gd name="connsiteY299" fmla="*/ 6325709 h 6857967"/>
              <a:gd name="connsiteX300" fmla="*/ 8471622 w 12191941"/>
              <a:gd name="connsiteY300" fmla="*/ 6325709 h 6857967"/>
              <a:gd name="connsiteX301" fmla="*/ 8471622 w 12191941"/>
              <a:gd name="connsiteY301" fmla="*/ 6397010 h 6857967"/>
              <a:gd name="connsiteX302" fmla="*/ 8542923 w 12191941"/>
              <a:gd name="connsiteY302" fmla="*/ 6397010 h 6857967"/>
              <a:gd name="connsiteX303" fmla="*/ 8542923 w 12191941"/>
              <a:gd name="connsiteY303" fmla="*/ 6325709 h 6857967"/>
              <a:gd name="connsiteX304" fmla="*/ 8328949 w 12191941"/>
              <a:gd name="connsiteY304" fmla="*/ 6325709 h 6857967"/>
              <a:gd name="connsiteX305" fmla="*/ 8328949 w 12191941"/>
              <a:gd name="connsiteY305" fmla="*/ 6397010 h 6857967"/>
              <a:gd name="connsiteX306" fmla="*/ 8400250 w 12191941"/>
              <a:gd name="connsiteY306" fmla="*/ 6397010 h 6857967"/>
              <a:gd name="connsiteX307" fmla="*/ 8400250 w 12191941"/>
              <a:gd name="connsiteY307" fmla="*/ 6325709 h 6857967"/>
              <a:gd name="connsiteX308" fmla="*/ 8186348 w 12191941"/>
              <a:gd name="connsiteY308" fmla="*/ 6325709 h 6857967"/>
              <a:gd name="connsiteX309" fmla="*/ 8186348 w 12191941"/>
              <a:gd name="connsiteY309" fmla="*/ 6397010 h 6857967"/>
              <a:gd name="connsiteX310" fmla="*/ 8257649 w 12191941"/>
              <a:gd name="connsiteY310" fmla="*/ 6397010 h 6857967"/>
              <a:gd name="connsiteX311" fmla="*/ 8257649 w 12191941"/>
              <a:gd name="connsiteY311" fmla="*/ 6325709 h 6857967"/>
              <a:gd name="connsiteX312" fmla="*/ 8043675 w 12191941"/>
              <a:gd name="connsiteY312" fmla="*/ 6325709 h 6857967"/>
              <a:gd name="connsiteX313" fmla="*/ 8043675 w 12191941"/>
              <a:gd name="connsiteY313" fmla="*/ 6397010 h 6857967"/>
              <a:gd name="connsiteX314" fmla="*/ 8114976 w 12191941"/>
              <a:gd name="connsiteY314" fmla="*/ 6397010 h 6857967"/>
              <a:gd name="connsiteX315" fmla="*/ 8114976 w 12191941"/>
              <a:gd name="connsiteY315" fmla="*/ 6325709 h 6857967"/>
              <a:gd name="connsiteX316" fmla="*/ 7901003 w 12191941"/>
              <a:gd name="connsiteY316" fmla="*/ 6325709 h 6857967"/>
              <a:gd name="connsiteX317" fmla="*/ 7901003 w 12191941"/>
              <a:gd name="connsiteY317" fmla="*/ 6397010 h 6857967"/>
              <a:gd name="connsiteX318" fmla="*/ 7972304 w 12191941"/>
              <a:gd name="connsiteY318" fmla="*/ 6397010 h 6857967"/>
              <a:gd name="connsiteX319" fmla="*/ 7972304 w 12191941"/>
              <a:gd name="connsiteY319" fmla="*/ 6325709 h 6857967"/>
              <a:gd name="connsiteX320" fmla="*/ 7758401 w 12191941"/>
              <a:gd name="connsiteY320" fmla="*/ 6325709 h 6857967"/>
              <a:gd name="connsiteX321" fmla="*/ 7758401 w 12191941"/>
              <a:gd name="connsiteY321" fmla="*/ 6397010 h 6857967"/>
              <a:gd name="connsiteX322" fmla="*/ 7829702 w 12191941"/>
              <a:gd name="connsiteY322" fmla="*/ 6397010 h 6857967"/>
              <a:gd name="connsiteX323" fmla="*/ 7829702 w 12191941"/>
              <a:gd name="connsiteY323" fmla="*/ 6325709 h 6857967"/>
              <a:gd name="connsiteX324" fmla="*/ 7615728 w 12191941"/>
              <a:gd name="connsiteY324" fmla="*/ 6325709 h 6857967"/>
              <a:gd name="connsiteX325" fmla="*/ 7615728 w 12191941"/>
              <a:gd name="connsiteY325" fmla="*/ 6397010 h 6857967"/>
              <a:gd name="connsiteX326" fmla="*/ 7687029 w 12191941"/>
              <a:gd name="connsiteY326" fmla="*/ 6397010 h 6857967"/>
              <a:gd name="connsiteX327" fmla="*/ 7687029 w 12191941"/>
              <a:gd name="connsiteY327" fmla="*/ 6325709 h 6857967"/>
              <a:gd name="connsiteX328" fmla="*/ 7473127 w 12191941"/>
              <a:gd name="connsiteY328" fmla="*/ 6325709 h 6857967"/>
              <a:gd name="connsiteX329" fmla="*/ 7473127 w 12191941"/>
              <a:gd name="connsiteY329" fmla="*/ 6397010 h 6857967"/>
              <a:gd name="connsiteX330" fmla="*/ 7544428 w 12191941"/>
              <a:gd name="connsiteY330" fmla="*/ 6397010 h 6857967"/>
              <a:gd name="connsiteX331" fmla="*/ 7544428 w 12191941"/>
              <a:gd name="connsiteY331" fmla="*/ 6325709 h 6857967"/>
              <a:gd name="connsiteX332" fmla="*/ 7330454 w 12191941"/>
              <a:gd name="connsiteY332" fmla="*/ 6325709 h 6857967"/>
              <a:gd name="connsiteX333" fmla="*/ 7330454 w 12191941"/>
              <a:gd name="connsiteY333" fmla="*/ 6397010 h 6857967"/>
              <a:gd name="connsiteX334" fmla="*/ 7401755 w 12191941"/>
              <a:gd name="connsiteY334" fmla="*/ 6397010 h 6857967"/>
              <a:gd name="connsiteX335" fmla="*/ 7401755 w 12191941"/>
              <a:gd name="connsiteY335" fmla="*/ 6325709 h 6857967"/>
              <a:gd name="connsiteX336" fmla="*/ 7187853 w 12191941"/>
              <a:gd name="connsiteY336" fmla="*/ 6325709 h 6857967"/>
              <a:gd name="connsiteX337" fmla="*/ 7187853 w 12191941"/>
              <a:gd name="connsiteY337" fmla="*/ 6397010 h 6857967"/>
              <a:gd name="connsiteX338" fmla="*/ 7259154 w 12191941"/>
              <a:gd name="connsiteY338" fmla="*/ 6397010 h 6857967"/>
              <a:gd name="connsiteX339" fmla="*/ 7259154 w 12191941"/>
              <a:gd name="connsiteY339" fmla="*/ 6325709 h 6857967"/>
              <a:gd name="connsiteX340" fmla="*/ 7045180 w 12191941"/>
              <a:gd name="connsiteY340" fmla="*/ 6325709 h 6857967"/>
              <a:gd name="connsiteX341" fmla="*/ 7045180 w 12191941"/>
              <a:gd name="connsiteY341" fmla="*/ 6397010 h 6857967"/>
              <a:gd name="connsiteX342" fmla="*/ 7116481 w 12191941"/>
              <a:gd name="connsiteY342" fmla="*/ 6397010 h 6857967"/>
              <a:gd name="connsiteX343" fmla="*/ 7116481 w 12191941"/>
              <a:gd name="connsiteY343" fmla="*/ 6325709 h 6857967"/>
              <a:gd name="connsiteX344" fmla="*/ 6902579 w 12191941"/>
              <a:gd name="connsiteY344" fmla="*/ 6325709 h 6857967"/>
              <a:gd name="connsiteX345" fmla="*/ 6902579 w 12191941"/>
              <a:gd name="connsiteY345" fmla="*/ 6397010 h 6857967"/>
              <a:gd name="connsiteX346" fmla="*/ 6973880 w 12191941"/>
              <a:gd name="connsiteY346" fmla="*/ 6397010 h 6857967"/>
              <a:gd name="connsiteX347" fmla="*/ 6973880 w 12191941"/>
              <a:gd name="connsiteY347" fmla="*/ 6325709 h 6857967"/>
              <a:gd name="connsiteX348" fmla="*/ 6759906 w 12191941"/>
              <a:gd name="connsiteY348" fmla="*/ 6325709 h 6857967"/>
              <a:gd name="connsiteX349" fmla="*/ 6759906 w 12191941"/>
              <a:gd name="connsiteY349" fmla="*/ 6397010 h 6857967"/>
              <a:gd name="connsiteX350" fmla="*/ 6831207 w 12191941"/>
              <a:gd name="connsiteY350" fmla="*/ 6397010 h 6857967"/>
              <a:gd name="connsiteX351" fmla="*/ 6831207 w 12191941"/>
              <a:gd name="connsiteY351" fmla="*/ 6325709 h 6857967"/>
              <a:gd name="connsiteX352" fmla="*/ 6617234 w 12191941"/>
              <a:gd name="connsiteY352" fmla="*/ 6325709 h 6857967"/>
              <a:gd name="connsiteX353" fmla="*/ 6617234 w 12191941"/>
              <a:gd name="connsiteY353" fmla="*/ 6397010 h 6857967"/>
              <a:gd name="connsiteX354" fmla="*/ 6688535 w 12191941"/>
              <a:gd name="connsiteY354" fmla="*/ 6397010 h 6857967"/>
              <a:gd name="connsiteX355" fmla="*/ 6688535 w 12191941"/>
              <a:gd name="connsiteY355" fmla="*/ 6325709 h 6857967"/>
              <a:gd name="connsiteX356" fmla="*/ 6474632 w 12191941"/>
              <a:gd name="connsiteY356" fmla="*/ 6325709 h 6857967"/>
              <a:gd name="connsiteX357" fmla="*/ 6474632 w 12191941"/>
              <a:gd name="connsiteY357" fmla="*/ 6397010 h 6857967"/>
              <a:gd name="connsiteX358" fmla="*/ 6545933 w 12191941"/>
              <a:gd name="connsiteY358" fmla="*/ 6397010 h 6857967"/>
              <a:gd name="connsiteX359" fmla="*/ 6545933 w 12191941"/>
              <a:gd name="connsiteY359" fmla="*/ 6325709 h 6857967"/>
              <a:gd name="connsiteX360" fmla="*/ 6331959 w 12191941"/>
              <a:gd name="connsiteY360" fmla="*/ 6325709 h 6857967"/>
              <a:gd name="connsiteX361" fmla="*/ 6331959 w 12191941"/>
              <a:gd name="connsiteY361" fmla="*/ 6397010 h 6857967"/>
              <a:gd name="connsiteX362" fmla="*/ 6403260 w 12191941"/>
              <a:gd name="connsiteY362" fmla="*/ 6397010 h 6857967"/>
              <a:gd name="connsiteX363" fmla="*/ 6403260 w 12191941"/>
              <a:gd name="connsiteY363" fmla="*/ 6325709 h 6857967"/>
              <a:gd name="connsiteX364" fmla="*/ 6189358 w 12191941"/>
              <a:gd name="connsiteY364" fmla="*/ 6325709 h 6857967"/>
              <a:gd name="connsiteX365" fmla="*/ 6189358 w 12191941"/>
              <a:gd name="connsiteY365" fmla="*/ 6397010 h 6857967"/>
              <a:gd name="connsiteX366" fmla="*/ 6260659 w 12191941"/>
              <a:gd name="connsiteY366" fmla="*/ 6397010 h 6857967"/>
              <a:gd name="connsiteX367" fmla="*/ 6260659 w 12191941"/>
              <a:gd name="connsiteY367" fmla="*/ 6325709 h 6857967"/>
              <a:gd name="connsiteX368" fmla="*/ 6046689 w 12191941"/>
              <a:gd name="connsiteY368" fmla="*/ 6325709 h 6857967"/>
              <a:gd name="connsiteX369" fmla="*/ 6046689 w 12191941"/>
              <a:gd name="connsiteY369" fmla="*/ 6397010 h 6857967"/>
              <a:gd name="connsiteX370" fmla="*/ 6117986 w 12191941"/>
              <a:gd name="connsiteY370" fmla="*/ 6397010 h 6857967"/>
              <a:gd name="connsiteX371" fmla="*/ 6117986 w 12191941"/>
              <a:gd name="connsiteY371" fmla="*/ 6325709 h 6857967"/>
              <a:gd name="connsiteX372" fmla="*/ 5904022 w 12191941"/>
              <a:gd name="connsiteY372" fmla="*/ 6325709 h 6857967"/>
              <a:gd name="connsiteX373" fmla="*/ 5904022 w 12191941"/>
              <a:gd name="connsiteY373" fmla="*/ 6397010 h 6857967"/>
              <a:gd name="connsiteX374" fmla="*/ 5975319 w 12191941"/>
              <a:gd name="connsiteY374" fmla="*/ 6397010 h 6857967"/>
              <a:gd name="connsiteX375" fmla="*/ 5975319 w 12191941"/>
              <a:gd name="connsiteY375" fmla="*/ 6325709 h 6857967"/>
              <a:gd name="connsiteX376" fmla="*/ 5761426 w 12191941"/>
              <a:gd name="connsiteY376" fmla="*/ 6325709 h 6857967"/>
              <a:gd name="connsiteX377" fmla="*/ 5761426 w 12191941"/>
              <a:gd name="connsiteY377" fmla="*/ 6397010 h 6857967"/>
              <a:gd name="connsiteX378" fmla="*/ 5832724 w 12191941"/>
              <a:gd name="connsiteY378" fmla="*/ 6397010 h 6857967"/>
              <a:gd name="connsiteX379" fmla="*/ 5832724 w 12191941"/>
              <a:gd name="connsiteY379" fmla="*/ 6325709 h 6857967"/>
              <a:gd name="connsiteX380" fmla="*/ 5618761 w 12191941"/>
              <a:gd name="connsiteY380" fmla="*/ 6325709 h 6857967"/>
              <a:gd name="connsiteX381" fmla="*/ 5618761 w 12191941"/>
              <a:gd name="connsiteY381" fmla="*/ 6397010 h 6857967"/>
              <a:gd name="connsiteX382" fmla="*/ 5690059 w 12191941"/>
              <a:gd name="connsiteY382" fmla="*/ 6397010 h 6857967"/>
              <a:gd name="connsiteX383" fmla="*/ 5690059 w 12191941"/>
              <a:gd name="connsiteY383" fmla="*/ 6325709 h 6857967"/>
              <a:gd name="connsiteX384" fmla="*/ 5476167 w 12191941"/>
              <a:gd name="connsiteY384" fmla="*/ 6325709 h 6857967"/>
              <a:gd name="connsiteX385" fmla="*/ 5476167 w 12191941"/>
              <a:gd name="connsiteY385" fmla="*/ 6397010 h 6857967"/>
              <a:gd name="connsiteX386" fmla="*/ 5547465 w 12191941"/>
              <a:gd name="connsiteY386" fmla="*/ 6397010 h 6857967"/>
              <a:gd name="connsiteX387" fmla="*/ 5547465 w 12191941"/>
              <a:gd name="connsiteY387" fmla="*/ 6325709 h 6857967"/>
              <a:gd name="connsiteX388" fmla="*/ 5333500 w 12191941"/>
              <a:gd name="connsiteY388" fmla="*/ 6325709 h 6857967"/>
              <a:gd name="connsiteX389" fmla="*/ 5333500 w 12191941"/>
              <a:gd name="connsiteY389" fmla="*/ 6397010 h 6857967"/>
              <a:gd name="connsiteX390" fmla="*/ 5404799 w 12191941"/>
              <a:gd name="connsiteY390" fmla="*/ 6397010 h 6857967"/>
              <a:gd name="connsiteX391" fmla="*/ 5404799 w 12191941"/>
              <a:gd name="connsiteY391" fmla="*/ 6325709 h 6857967"/>
              <a:gd name="connsiteX392" fmla="*/ 5190877 w 12191941"/>
              <a:gd name="connsiteY392" fmla="*/ 6325709 h 6857967"/>
              <a:gd name="connsiteX393" fmla="*/ 5190877 w 12191941"/>
              <a:gd name="connsiteY393" fmla="*/ 6397010 h 6857967"/>
              <a:gd name="connsiteX394" fmla="*/ 5262188 w 12191941"/>
              <a:gd name="connsiteY394" fmla="*/ 6397010 h 6857967"/>
              <a:gd name="connsiteX395" fmla="*/ 5262188 w 12191941"/>
              <a:gd name="connsiteY395" fmla="*/ 6325709 h 6857967"/>
              <a:gd name="connsiteX396" fmla="*/ 5048236 w 12191941"/>
              <a:gd name="connsiteY396" fmla="*/ 6325709 h 6857967"/>
              <a:gd name="connsiteX397" fmla="*/ 5048236 w 12191941"/>
              <a:gd name="connsiteY397" fmla="*/ 6397010 h 6857967"/>
              <a:gd name="connsiteX398" fmla="*/ 5119527 w 12191941"/>
              <a:gd name="connsiteY398" fmla="*/ 6397010 h 6857967"/>
              <a:gd name="connsiteX399" fmla="*/ 5119527 w 12191941"/>
              <a:gd name="connsiteY399" fmla="*/ 6325709 h 6857967"/>
              <a:gd name="connsiteX400" fmla="*/ 4906607 w 12191941"/>
              <a:gd name="connsiteY400" fmla="*/ 6325709 h 6857967"/>
              <a:gd name="connsiteX401" fmla="*/ 4906607 w 12191941"/>
              <a:gd name="connsiteY401" fmla="*/ 6397010 h 6857967"/>
              <a:gd name="connsiteX402" fmla="*/ 4977916 w 12191941"/>
              <a:gd name="connsiteY402" fmla="*/ 6397010 h 6857967"/>
              <a:gd name="connsiteX403" fmla="*/ 4977916 w 12191941"/>
              <a:gd name="connsiteY403" fmla="*/ 6325709 h 6857967"/>
              <a:gd name="connsiteX404" fmla="*/ 4764013 w 12191941"/>
              <a:gd name="connsiteY404" fmla="*/ 6325709 h 6857967"/>
              <a:gd name="connsiteX405" fmla="*/ 4764013 w 12191941"/>
              <a:gd name="connsiteY405" fmla="*/ 6397010 h 6857967"/>
              <a:gd name="connsiteX406" fmla="*/ 4835311 w 12191941"/>
              <a:gd name="connsiteY406" fmla="*/ 6397010 h 6857967"/>
              <a:gd name="connsiteX407" fmla="*/ 4835311 w 12191941"/>
              <a:gd name="connsiteY407" fmla="*/ 6325709 h 6857967"/>
              <a:gd name="connsiteX408" fmla="*/ 4621341 w 12191941"/>
              <a:gd name="connsiteY408" fmla="*/ 6325709 h 6857967"/>
              <a:gd name="connsiteX409" fmla="*/ 4621341 w 12191941"/>
              <a:gd name="connsiteY409" fmla="*/ 6397010 h 6857967"/>
              <a:gd name="connsiteX410" fmla="*/ 4692639 w 12191941"/>
              <a:gd name="connsiteY410" fmla="*/ 6397010 h 6857967"/>
              <a:gd name="connsiteX411" fmla="*/ 4692639 w 12191941"/>
              <a:gd name="connsiteY411" fmla="*/ 6325709 h 6857967"/>
              <a:gd name="connsiteX412" fmla="*/ 4478666 w 12191941"/>
              <a:gd name="connsiteY412" fmla="*/ 6325709 h 6857967"/>
              <a:gd name="connsiteX413" fmla="*/ 4478666 w 12191941"/>
              <a:gd name="connsiteY413" fmla="*/ 6397010 h 6857967"/>
              <a:gd name="connsiteX414" fmla="*/ 4549969 w 12191941"/>
              <a:gd name="connsiteY414" fmla="*/ 6397010 h 6857967"/>
              <a:gd name="connsiteX415" fmla="*/ 4549969 w 12191941"/>
              <a:gd name="connsiteY415" fmla="*/ 6325709 h 6857967"/>
              <a:gd name="connsiteX416" fmla="*/ 4336067 w 12191941"/>
              <a:gd name="connsiteY416" fmla="*/ 6325709 h 6857967"/>
              <a:gd name="connsiteX417" fmla="*/ 4336067 w 12191941"/>
              <a:gd name="connsiteY417" fmla="*/ 6397010 h 6857967"/>
              <a:gd name="connsiteX418" fmla="*/ 4407366 w 12191941"/>
              <a:gd name="connsiteY418" fmla="*/ 6397010 h 6857967"/>
              <a:gd name="connsiteX419" fmla="*/ 4407366 w 12191941"/>
              <a:gd name="connsiteY419" fmla="*/ 6325709 h 6857967"/>
              <a:gd name="connsiteX420" fmla="*/ 4193413 w 12191941"/>
              <a:gd name="connsiteY420" fmla="*/ 6325709 h 6857967"/>
              <a:gd name="connsiteX421" fmla="*/ 4193413 w 12191941"/>
              <a:gd name="connsiteY421" fmla="*/ 6397010 h 6857967"/>
              <a:gd name="connsiteX422" fmla="*/ 4264695 w 12191941"/>
              <a:gd name="connsiteY422" fmla="*/ 6397010 h 6857967"/>
              <a:gd name="connsiteX423" fmla="*/ 4264695 w 12191941"/>
              <a:gd name="connsiteY423" fmla="*/ 6325709 h 6857967"/>
              <a:gd name="connsiteX424" fmla="*/ 4050810 w 12191941"/>
              <a:gd name="connsiteY424" fmla="*/ 6325709 h 6857967"/>
              <a:gd name="connsiteX425" fmla="*/ 4050810 w 12191941"/>
              <a:gd name="connsiteY425" fmla="*/ 6397010 h 6857967"/>
              <a:gd name="connsiteX426" fmla="*/ 4122113 w 12191941"/>
              <a:gd name="connsiteY426" fmla="*/ 6397010 h 6857967"/>
              <a:gd name="connsiteX427" fmla="*/ 4122113 w 12191941"/>
              <a:gd name="connsiteY427" fmla="*/ 6325709 h 6857967"/>
              <a:gd name="connsiteX428" fmla="*/ 3908136 w 12191941"/>
              <a:gd name="connsiteY428" fmla="*/ 6325709 h 6857967"/>
              <a:gd name="connsiteX429" fmla="*/ 3908136 w 12191941"/>
              <a:gd name="connsiteY429" fmla="*/ 6397010 h 6857967"/>
              <a:gd name="connsiteX430" fmla="*/ 3979438 w 12191941"/>
              <a:gd name="connsiteY430" fmla="*/ 6397010 h 6857967"/>
              <a:gd name="connsiteX431" fmla="*/ 3979438 w 12191941"/>
              <a:gd name="connsiteY431" fmla="*/ 6325709 h 6857967"/>
              <a:gd name="connsiteX432" fmla="*/ 3765462 w 12191941"/>
              <a:gd name="connsiteY432" fmla="*/ 6325709 h 6857967"/>
              <a:gd name="connsiteX433" fmla="*/ 3765462 w 12191941"/>
              <a:gd name="connsiteY433" fmla="*/ 6397010 h 6857967"/>
              <a:gd name="connsiteX434" fmla="*/ 3836763 w 12191941"/>
              <a:gd name="connsiteY434" fmla="*/ 6397010 h 6857967"/>
              <a:gd name="connsiteX435" fmla="*/ 3836763 w 12191941"/>
              <a:gd name="connsiteY435" fmla="*/ 6325709 h 6857967"/>
              <a:gd name="connsiteX436" fmla="*/ 3622851 w 12191941"/>
              <a:gd name="connsiteY436" fmla="*/ 6325709 h 6857967"/>
              <a:gd name="connsiteX437" fmla="*/ 3622851 w 12191941"/>
              <a:gd name="connsiteY437" fmla="*/ 6397010 h 6857967"/>
              <a:gd name="connsiteX438" fmla="*/ 3694151 w 12191941"/>
              <a:gd name="connsiteY438" fmla="*/ 6397010 h 6857967"/>
              <a:gd name="connsiteX439" fmla="*/ 3694151 w 12191941"/>
              <a:gd name="connsiteY439" fmla="*/ 6325709 h 6857967"/>
              <a:gd name="connsiteX440" fmla="*/ 3480203 w 12191941"/>
              <a:gd name="connsiteY440" fmla="*/ 6325709 h 6857967"/>
              <a:gd name="connsiteX441" fmla="*/ 3480203 w 12191941"/>
              <a:gd name="connsiteY441" fmla="*/ 6397010 h 6857967"/>
              <a:gd name="connsiteX442" fmla="*/ 3551509 w 12191941"/>
              <a:gd name="connsiteY442" fmla="*/ 6397010 h 6857967"/>
              <a:gd name="connsiteX443" fmla="*/ 3551509 w 12191941"/>
              <a:gd name="connsiteY443" fmla="*/ 6325709 h 6857967"/>
              <a:gd name="connsiteX444" fmla="*/ 3337580 w 12191941"/>
              <a:gd name="connsiteY444" fmla="*/ 6325709 h 6857967"/>
              <a:gd name="connsiteX445" fmla="*/ 3337580 w 12191941"/>
              <a:gd name="connsiteY445" fmla="*/ 6397010 h 6857967"/>
              <a:gd name="connsiteX446" fmla="*/ 3408881 w 12191941"/>
              <a:gd name="connsiteY446" fmla="*/ 6397010 h 6857967"/>
              <a:gd name="connsiteX447" fmla="*/ 3408881 w 12191941"/>
              <a:gd name="connsiteY447" fmla="*/ 6325709 h 6857967"/>
              <a:gd name="connsiteX448" fmla="*/ 3194905 w 12191941"/>
              <a:gd name="connsiteY448" fmla="*/ 6325709 h 6857967"/>
              <a:gd name="connsiteX449" fmla="*/ 3194905 w 12191941"/>
              <a:gd name="connsiteY449" fmla="*/ 6397010 h 6857967"/>
              <a:gd name="connsiteX450" fmla="*/ 3266208 w 12191941"/>
              <a:gd name="connsiteY450" fmla="*/ 6397010 h 6857967"/>
              <a:gd name="connsiteX451" fmla="*/ 3266208 w 12191941"/>
              <a:gd name="connsiteY451" fmla="*/ 6325709 h 6857967"/>
              <a:gd name="connsiteX452" fmla="*/ 3052305 w 12191941"/>
              <a:gd name="connsiteY452" fmla="*/ 6325709 h 6857967"/>
              <a:gd name="connsiteX453" fmla="*/ 3052305 w 12191941"/>
              <a:gd name="connsiteY453" fmla="*/ 6397010 h 6857967"/>
              <a:gd name="connsiteX454" fmla="*/ 3123607 w 12191941"/>
              <a:gd name="connsiteY454" fmla="*/ 6397010 h 6857967"/>
              <a:gd name="connsiteX455" fmla="*/ 3123607 w 12191941"/>
              <a:gd name="connsiteY455" fmla="*/ 6325709 h 6857967"/>
              <a:gd name="connsiteX456" fmla="*/ 2909633 w 12191941"/>
              <a:gd name="connsiteY456" fmla="*/ 6325709 h 6857967"/>
              <a:gd name="connsiteX457" fmla="*/ 2909633 w 12191941"/>
              <a:gd name="connsiteY457" fmla="*/ 6397010 h 6857967"/>
              <a:gd name="connsiteX458" fmla="*/ 2980934 w 12191941"/>
              <a:gd name="connsiteY458" fmla="*/ 6397010 h 6857967"/>
              <a:gd name="connsiteX459" fmla="*/ 2980934 w 12191941"/>
              <a:gd name="connsiteY459" fmla="*/ 6325709 h 6857967"/>
              <a:gd name="connsiteX460" fmla="*/ 2767033 w 12191941"/>
              <a:gd name="connsiteY460" fmla="*/ 6325709 h 6857967"/>
              <a:gd name="connsiteX461" fmla="*/ 2767033 w 12191941"/>
              <a:gd name="connsiteY461" fmla="*/ 6397010 h 6857967"/>
              <a:gd name="connsiteX462" fmla="*/ 2838334 w 12191941"/>
              <a:gd name="connsiteY462" fmla="*/ 6397010 h 6857967"/>
              <a:gd name="connsiteX463" fmla="*/ 2838334 w 12191941"/>
              <a:gd name="connsiteY463" fmla="*/ 6325709 h 6857967"/>
              <a:gd name="connsiteX464" fmla="*/ 2624361 w 12191941"/>
              <a:gd name="connsiteY464" fmla="*/ 6325709 h 6857967"/>
              <a:gd name="connsiteX465" fmla="*/ 2624361 w 12191941"/>
              <a:gd name="connsiteY465" fmla="*/ 6397010 h 6857967"/>
              <a:gd name="connsiteX466" fmla="*/ 2695661 w 12191941"/>
              <a:gd name="connsiteY466" fmla="*/ 6397010 h 6857967"/>
              <a:gd name="connsiteX467" fmla="*/ 2695661 w 12191941"/>
              <a:gd name="connsiteY467" fmla="*/ 6325709 h 6857967"/>
              <a:gd name="connsiteX468" fmla="*/ 2481690 w 12191941"/>
              <a:gd name="connsiteY468" fmla="*/ 6325709 h 6857967"/>
              <a:gd name="connsiteX469" fmla="*/ 2481690 w 12191941"/>
              <a:gd name="connsiteY469" fmla="*/ 6397010 h 6857967"/>
              <a:gd name="connsiteX470" fmla="*/ 2552991 w 12191941"/>
              <a:gd name="connsiteY470" fmla="*/ 6397010 h 6857967"/>
              <a:gd name="connsiteX471" fmla="*/ 2552991 w 12191941"/>
              <a:gd name="connsiteY471" fmla="*/ 6325709 h 6857967"/>
              <a:gd name="connsiteX472" fmla="*/ 2339091 w 12191941"/>
              <a:gd name="connsiteY472" fmla="*/ 6325709 h 6857967"/>
              <a:gd name="connsiteX473" fmla="*/ 2339091 w 12191941"/>
              <a:gd name="connsiteY473" fmla="*/ 6397010 h 6857967"/>
              <a:gd name="connsiteX474" fmla="*/ 2410390 w 12191941"/>
              <a:gd name="connsiteY474" fmla="*/ 6397010 h 6857967"/>
              <a:gd name="connsiteX475" fmla="*/ 2410390 w 12191941"/>
              <a:gd name="connsiteY475" fmla="*/ 6325709 h 6857967"/>
              <a:gd name="connsiteX476" fmla="*/ 2196420 w 12191941"/>
              <a:gd name="connsiteY476" fmla="*/ 6325709 h 6857967"/>
              <a:gd name="connsiteX477" fmla="*/ 2196420 w 12191941"/>
              <a:gd name="connsiteY477" fmla="*/ 6397010 h 6857967"/>
              <a:gd name="connsiteX478" fmla="*/ 2267720 w 12191941"/>
              <a:gd name="connsiteY478" fmla="*/ 6397010 h 6857967"/>
              <a:gd name="connsiteX479" fmla="*/ 2267720 w 12191941"/>
              <a:gd name="connsiteY479" fmla="*/ 6325709 h 6857967"/>
              <a:gd name="connsiteX480" fmla="*/ 2053813 w 12191941"/>
              <a:gd name="connsiteY480" fmla="*/ 6325709 h 6857967"/>
              <a:gd name="connsiteX481" fmla="*/ 2053813 w 12191941"/>
              <a:gd name="connsiteY481" fmla="*/ 6397010 h 6857967"/>
              <a:gd name="connsiteX482" fmla="*/ 2125117 w 12191941"/>
              <a:gd name="connsiteY482" fmla="*/ 6397010 h 6857967"/>
              <a:gd name="connsiteX483" fmla="*/ 2125117 w 12191941"/>
              <a:gd name="connsiteY483" fmla="*/ 6325709 h 6857967"/>
              <a:gd name="connsiteX484" fmla="*/ 1911141 w 12191941"/>
              <a:gd name="connsiteY484" fmla="*/ 6325709 h 6857967"/>
              <a:gd name="connsiteX485" fmla="*/ 1911141 w 12191941"/>
              <a:gd name="connsiteY485" fmla="*/ 6397010 h 6857967"/>
              <a:gd name="connsiteX486" fmla="*/ 1982442 w 12191941"/>
              <a:gd name="connsiteY486" fmla="*/ 6397010 h 6857967"/>
              <a:gd name="connsiteX487" fmla="*/ 1982442 w 12191941"/>
              <a:gd name="connsiteY487" fmla="*/ 6325709 h 6857967"/>
              <a:gd name="connsiteX488" fmla="*/ 1768470 w 12191941"/>
              <a:gd name="connsiteY488" fmla="*/ 6325709 h 6857967"/>
              <a:gd name="connsiteX489" fmla="*/ 1768470 w 12191941"/>
              <a:gd name="connsiteY489" fmla="*/ 6397010 h 6857967"/>
              <a:gd name="connsiteX490" fmla="*/ 1839771 w 12191941"/>
              <a:gd name="connsiteY490" fmla="*/ 6397010 h 6857967"/>
              <a:gd name="connsiteX491" fmla="*/ 1839771 w 12191941"/>
              <a:gd name="connsiteY491" fmla="*/ 6325709 h 6857967"/>
              <a:gd name="connsiteX492" fmla="*/ 1625870 w 12191941"/>
              <a:gd name="connsiteY492" fmla="*/ 6325709 h 6857967"/>
              <a:gd name="connsiteX493" fmla="*/ 1625870 w 12191941"/>
              <a:gd name="connsiteY493" fmla="*/ 6397010 h 6857967"/>
              <a:gd name="connsiteX494" fmla="*/ 1697170 w 12191941"/>
              <a:gd name="connsiteY494" fmla="*/ 6397010 h 6857967"/>
              <a:gd name="connsiteX495" fmla="*/ 1697170 w 12191941"/>
              <a:gd name="connsiteY495" fmla="*/ 6325709 h 6857967"/>
              <a:gd name="connsiteX496" fmla="*/ 1483199 w 12191941"/>
              <a:gd name="connsiteY496" fmla="*/ 6325709 h 6857967"/>
              <a:gd name="connsiteX497" fmla="*/ 1483199 w 12191941"/>
              <a:gd name="connsiteY497" fmla="*/ 6397010 h 6857967"/>
              <a:gd name="connsiteX498" fmla="*/ 1554500 w 12191941"/>
              <a:gd name="connsiteY498" fmla="*/ 6397010 h 6857967"/>
              <a:gd name="connsiteX499" fmla="*/ 1554500 w 12191941"/>
              <a:gd name="connsiteY499" fmla="*/ 6325709 h 6857967"/>
              <a:gd name="connsiteX500" fmla="*/ 1340599 w 12191941"/>
              <a:gd name="connsiteY500" fmla="*/ 6325709 h 6857967"/>
              <a:gd name="connsiteX501" fmla="*/ 1340599 w 12191941"/>
              <a:gd name="connsiteY501" fmla="*/ 6397010 h 6857967"/>
              <a:gd name="connsiteX502" fmla="*/ 1411899 w 12191941"/>
              <a:gd name="connsiteY502" fmla="*/ 6397010 h 6857967"/>
              <a:gd name="connsiteX503" fmla="*/ 1411899 w 12191941"/>
              <a:gd name="connsiteY503" fmla="*/ 6325709 h 6857967"/>
              <a:gd name="connsiteX504" fmla="*/ 1197929 w 12191941"/>
              <a:gd name="connsiteY504" fmla="*/ 6325709 h 6857967"/>
              <a:gd name="connsiteX505" fmla="*/ 1197929 w 12191941"/>
              <a:gd name="connsiteY505" fmla="*/ 6397010 h 6857967"/>
              <a:gd name="connsiteX506" fmla="*/ 1269230 w 12191941"/>
              <a:gd name="connsiteY506" fmla="*/ 6397010 h 6857967"/>
              <a:gd name="connsiteX507" fmla="*/ 1269230 w 12191941"/>
              <a:gd name="connsiteY507" fmla="*/ 6325709 h 6857967"/>
              <a:gd name="connsiteX508" fmla="*/ 1055311 w 12191941"/>
              <a:gd name="connsiteY508" fmla="*/ 6325709 h 6857967"/>
              <a:gd name="connsiteX509" fmla="*/ 1055311 w 12191941"/>
              <a:gd name="connsiteY509" fmla="*/ 6397010 h 6857967"/>
              <a:gd name="connsiteX510" fmla="*/ 1126612 w 12191941"/>
              <a:gd name="connsiteY510" fmla="*/ 6397010 h 6857967"/>
              <a:gd name="connsiteX511" fmla="*/ 1126612 w 12191941"/>
              <a:gd name="connsiteY511" fmla="*/ 6325709 h 6857967"/>
              <a:gd name="connsiteX512" fmla="*/ 912657 w 12191941"/>
              <a:gd name="connsiteY512" fmla="*/ 6325709 h 6857967"/>
              <a:gd name="connsiteX513" fmla="*/ 912657 w 12191941"/>
              <a:gd name="connsiteY513" fmla="*/ 6397010 h 6857967"/>
              <a:gd name="connsiteX514" fmla="*/ 983958 w 12191941"/>
              <a:gd name="connsiteY514" fmla="*/ 6397010 h 6857967"/>
              <a:gd name="connsiteX515" fmla="*/ 983958 w 12191941"/>
              <a:gd name="connsiteY515" fmla="*/ 6325709 h 6857967"/>
              <a:gd name="connsiteX516" fmla="*/ 771136 w 12191941"/>
              <a:gd name="connsiteY516" fmla="*/ 6325709 h 6857967"/>
              <a:gd name="connsiteX517" fmla="*/ 771136 w 12191941"/>
              <a:gd name="connsiteY517" fmla="*/ 6397010 h 6857967"/>
              <a:gd name="connsiteX518" fmla="*/ 842437 w 12191941"/>
              <a:gd name="connsiteY518" fmla="*/ 6397010 h 6857967"/>
              <a:gd name="connsiteX519" fmla="*/ 842437 w 12191941"/>
              <a:gd name="connsiteY519" fmla="*/ 6325709 h 6857967"/>
              <a:gd name="connsiteX520" fmla="*/ 628534 w 12191941"/>
              <a:gd name="connsiteY520" fmla="*/ 6325709 h 6857967"/>
              <a:gd name="connsiteX521" fmla="*/ 628534 w 12191941"/>
              <a:gd name="connsiteY521" fmla="*/ 6397010 h 6857967"/>
              <a:gd name="connsiteX522" fmla="*/ 699835 w 12191941"/>
              <a:gd name="connsiteY522" fmla="*/ 6397010 h 6857967"/>
              <a:gd name="connsiteX523" fmla="*/ 699835 w 12191941"/>
              <a:gd name="connsiteY523" fmla="*/ 6325709 h 6857967"/>
              <a:gd name="connsiteX524" fmla="*/ 485863 w 12191941"/>
              <a:gd name="connsiteY524" fmla="*/ 6325709 h 6857967"/>
              <a:gd name="connsiteX525" fmla="*/ 485863 w 12191941"/>
              <a:gd name="connsiteY525" fmla="*/ 6397010 h 6857967"/>
              <a:gd name="connsiteX526" fmla="*/ 557163 w 12191941"/>
              <a:gd name="connsiteY526" fmla="*/ 6397010 h 6857967"/>
              <a:gd name="connsiteX527" fmla="*/ 557163 w 12191941"/>
              <a:gd name="connsiteY527" fmla="*/ 6325709 h 6857967"/>
              <a:gd name="connsiteX528" fmla="*/ 343191 w 12191941"/>
              <a:gd name="connsiteY528" fmla="*/ 6325709 h 6857967"/>
              <a:gd name="connsiteX529" fmla="*/ 343191 w 12191941"/>
              <a:gd name="connsiteY529" fmla="*/ 6397010 h 6857967"/>
              <a:gd name="connsiteX530" fmla="*/ 414492 w 12191941"/>
              <a:gd name="connsiteY530" fmla="*/ 6397010 h 6857967"/>
              <a:gd name="connsiteX531" fmla="*/ 414492 w 12191941"/>
              <a:gd name="connsiteY531" fmla="*/ 6325709 h 6857967"/>
              <a:gd name="connsiteX532" fmla="*/ 200590 w 12191941"/>
              <a:gd name="connsiteY532" fmla="*/ 6325709 h 6857967"/>
              <a:gd name="connsiteX533" fmla="*/ 200590 w 12191941"/>
              <a:gd name="connsiteY533" fmla="*/ 6397010 h 6857967"/>
              <a:gd name="connsiteX534" fmla="*/ 271891 w 12191941"/>
              <a:gd name="connsiteY534" fmla="*/ 6397010 h 6857967"/>
              <a:gd name="connsiteX535" fmla="*/ 271891 w 12191941"/>
              <a:gd name="connsiteY535" fmla="*/ 6325709 h 6857967"/>
              <a:gd name="connsiteX536" fmla="*/ 57918 w 12191941"/>
              <a:gd name="connsiteY536" fmla="*/ 6325709 h 6857967"/>
              <a:gd name="connsiteX537" fmla="*/ 57918 w 12191941"/>
              <a:gd name="connsiteY537" fmla="*/ 6397010 h 6857967"/>
              <a:gd name="connsiteX538" fmla="*/ 129219 w 12191941"/>
              <a:gd name="connsiteY538" fmla="*/ 6397010 h 6857967"/>
              <a:gd name="connsiteX539" fmla="*/ 129219 w 12191941"/>
              <a:gd name="connsiteY539" fmla="*/ 6325709 h 6857967"/>
              <a:gd name="connsiteX540" fmla="*/ 9755391 w 12191941"/>
              <a:gd name="connsiteY540" fmla="*/ 6183107 h 6857967"/>
              <a:gd name="connsiteX541" fmla="*/ 9755391 w 12191941"/>
              <a:gd name="connsiteY541" fmla="*/ 6254408 h 6857967"/>
              <a:gd name="connsiteX542" fmla="*/ 9826692 w 12191941"/>
              <a:gd name="connsiteY542" fmla="*/ 6254408 h 6857967"/>
              <a:gd name="connsiteX543" fmla="*/ 9826692 w 12191941"/>
              <a:gd name="connsiteY543" fmla="*/ 6183107 h 6857967"/>
              <a:gd name="connsiteX544" fmla="*/ 9612718 w 12191941"/>
              <a:gd name="connsiteY544" fmla="*/ 6183107 h 6857967"/>
              <a:gd name="connsiteX545" fmla="*/ 9612718 w 12191941"/>
              <a:gd name="connsiteY545" fmla="*/ 6254408 h 6857967"/>
              <a:gd name="connsiteX546" fmla="*/ 9684019 w 12191941"/>
              <a:gd name="connsiteY546" fmla="*/ 6254408 h 6857967"/>
              <a:gd name="connsiteX547" fmla="*/ 9684019 w 12191941"/>
              <a:gd name="connsiteY547" fmla="*/ 6183107 h 6857967"/>
              <a:gd name="connsiteX548" fmla="*/ 9470117 w 12191941"/>
              <a:gd name="connsiteY548" fmla="*/ 6183107 h 6857967"/>
              <a:gd name="connsiteX549" fmla="*/ 9470117 w 12191941"/>
              <a:gd name="connsiteY549" fmla="*/ 6254408 h 6857967"/>
              <a:gd name="connsiteX550" fmla="*/ 9541417 w 12191941"/>
              <a:gd name="connsiteY550" fmla="*/ 6254408 h 6857967"/>
              <a:gd name="connsiteX551" fmla="*/ 9541417 w 12191941"/>
              <a:gd name="connsiteY551" fmla="*/ 6183107 h 6857967"/>
              <a:gd name="connsiteX552" fmla="*/ 9327444 w 12191941"/>
              <a:gd name="connsiteY552" fmla="*/ 6183107 h 6857967"/>
              <a:gd name="connsiteX553" fmla="*/ 9327444 w 12191941"/>
              <a:gd name="connsiteY553" fmla="*/ 6254408 h 6857967"/>
              <a:gd name="connsiteX554" fmla="*/ 9398745 w 12191941"/>
              <a:gd name="connsiteY554" fmla="*/ 6254408 h 6857967"/>
              <a:gd name="connsiteX555" fmla="*/ 9398745 w 12191941"/>
              <a:gd name="connsiteY555" fmla="*/ 6183107 h 6857967"/>
              <a:gd name="connsiteX556" fmla="*/ 9184842 w 12191941"/>
              <a:gd name="connsiteY556" fmla="*/ 6183107 h 6857967"/>
              <a:gd name="connsiteX557" fmla="*/ 9184842 w 12191941"/>
              <a:gd name="connsiteY557" fmla="*/ 6254408 h 6857967"/>
              <a:gd name="connsiteX558" fmla="*/ 9256143 w 12191941"/>
              <a:gd name="connsiteY558" fmla="*/ 6254408 h 6857967"/>
              <a:gd name="connsiteX559" fmla="*/ 9256143 w 12191941"/>
              <a:gd name="connsiteY559" fmla="*/ 6183107 h 6857967"/>
              <a:gd name="connsiteX560" fmla="*/ 9042170 w 12191941"/>
              <a:gd name="connsiteY560" fmla="*/ 6183107 h 6857967"/>
              <a:gd name="connsiteX561" fmla="*/ 9042170 w 12191941"/>
              <a:gd name="connsiteY561" fmla="*/ 6254408 h 6857967"/>
              <a:gd name="connsiteX562" fmla="*/ 9113471 w 12191941"/>
              <a:gd name="connsiteY562" fmla="*/ 6254408 h 6857967"/>
              <a:gd name="connsiteX563" fmla="*/ 9113471 w 12191941"/>
              <a:gd name="connsiteY563" fmla="*/ 6183107 h 6857967"/>
              <a:gd name="connsiteX564" fmla="*/ 8899568 w 12191941"/>
              <a:gd name="connsiteY564" fmla="*/ 6183107 h 6857967"/>
              <a:gd name="connsiteX565" fmla="*/ 8899568 w 12191941"/>
              <a:gd name="connsiteY565" fmla="*/ 6254408 h 6857967"/>
              <a:gd name="connsiteX566" fmla="*/ 8970869 w 12191941"/>
              <a:gd name="connsiteY566" fmla="*/ 6254408 h 6857967"/>
              <a:gd name="connsiteX567" fmla="*/ 8970869 w 12191941"/>
              <a:gd name="connsiteY567" fmla="*/ 6183107 h 6857967"/>
              <a:gd name="connsiteX568" fmla="*/ 8756896 w 12191941"/>
              <a:gd name="connsiteY568" fmla="*/ 6183107 h 6857967"/>
              <a:gd name="connsiteX569" fmla="*/ 8756896 w 12191941"/>
              <a:gd name="connsiteY569" fmla="*/ 6254408 h 6857967"/>
              <a:gd name="connsiteX570" fmla="*/ 8828196 w 12191941"/>
              <a:gd name="connsiteY570" fmla="*/ 6254408 h 6857967"/>
              <a:gd name="connsiteX571" fmla="*/ 8828196 w 12191941"/>
              <a:gd name="connsiteY571" fmla="*/ 6183107 h 6857967"/>
              <a:gd name="connsiteX572" fmla="*/ 8614223 w 12191941"/>
              <a:gd name="connsiteY572" fmla="*/ 6183107 h 6857967"/>
              <a:gd name="connsiteX573" fmla="*/ 8614223 w 12191941"/>
              <a:gd name="connsiteY573" fmla="*/ 6254408 h 6857967"/>
              <a:gd name="connsiteX574" fmla="*/ 8685524 w 12191941"/>
              <a:gd name="connsiteY574" fmla="*/ 6254408 h 6857967"/>
              <a:gd name="connsiteX575" fmla="*/ 8685524 w 12191941"/>
              <a:gd name="connsiteY575" fmla="*/ 6183107 h 6857967"/>
              <a:gd name="connsiteX576" fmla="*/ 8471622 w 12191941"/>
              <a:gd name="connsiteY576" fmla="*/ 6183107 h 6857967"/>
              <a:gd name="connsiteX577" fmla="*/ 8471622 w 12191941"/>
              <a:gd name="connsiteY577" fmla="*/ 6254408 h 6857967"/>
              <a:gd name="connsiteX578" fmla="*/ 8542923 w 12191941"/>
              <a:gd name="connsiteY578" fmla="*/ 6254408 h 6857967"/>
              <a:gd name="connsiteX579" fmla="*/ 8542923 w 12191941"/>
              <a:gd name="connsiteY579" fmla="*/ 6183107 h 6857967"/>
              <a:gd name="connsiteX580" fmla="*/ 8328949 w 12191941"/>
              <a:gd name="connsiteY580" fmla="*/ 6183107 h 6857967"/>
              <a:gd name="connsiteX581" fmla="*/ 8328949 w 12191941"/>
              <a:gd name="connsiteY581" fmla="*/ 6254408 h 6857967"/>
              <a:gd name="connsiteX582" fmla="*/ 8400250 w 12191941"/>
              <a:gd name="connsiteY582" fmla="*/ 6254408 h 6857967"/>
              <a:gd name="connsiteX583" fmla="*/ 8400250 w 12191941"/>
              <a:gd name="connsiteY583" fmla="*/ 6183107 h 6857967"/>
              <a:gd name="connsiteX584" fmla="*/ 8186348 w 12191941"/>
              <a:gd name="connsiteY584" fmla="*/ 6183107 h 6857967"/>
              <a:gd name="connsiteX585" fmla="*/ 8186348 w 12191941"/>
              <a:gd name="connsiteY585" fmla="*/ 6254408 h 6857967"/>
              <a:gd name="connsiteX586" fmla="*/ 8257649 w 12191941"/>
              <a:gd name="connsiteY586" fmla="*/ 6254408 h 6857967"/>
              <a:gd name="connsiteX587" fmla="*/ 8257649 w 12191941"/>
              <a:gd name="connsiteY587" fmla="*/ 6183107 h 6857967"/>
              <a:gd name="connsiteX588" fmla="*/ 8043675 w 12191941"/>
              <a:gd name="connsiteY588" fmla="*/ 6183107 h 6857967"/>
              <a:gd name="connsiteX589" fmla="*/ 8043675 w 12191941"/>
              <a:gd name="connsiteY589" fmla="*/ 6254408 h 6857967"/>
              <a:gd name="connsiteX590" fmla="*/ 8114976 w 12191941"/>
              <a:gd name="connsiteY590" fmla="*/ 6254408 h 6857967"/>
              <a:gd name="connsiteX591" fmla="*/ 8114976 w 12191941"/>
              <a:gd name="connsiteY591" fmla="*/ 6183107 h 6857967"/>
              <a:gd name="connsiteX592" fmla="*/ 7901003 w 12191941"/>
              <a:gd name="connsiteY592" fmla="*/ 6183107 h 6857967"/>
              <a:gd name="connsiteX593" fmla="*/ 7901003 w 12191941"/>
              <a:gd name="connsiteY593" fmla="*/ 6254408 h 6857967"/>
              <a:gd name="connsiteX594" fmla="*/ 7972304 w 12191941"/>
              <a:gd name="connsiteY594" fmla="*/ 6254408 h 6857967"/>
              <a:gd name="connsiteX595" fmla="*/ 7972304 w 12191941"/>
              <a:gd name="connsiteY595" fmla="*/ 6183107 h 6857967"/>
              <a:gd name="connsiteX596" fmla="*/ 7758401 w 12191941"/>
              <a:gd name="connsiteY596" fmla="*/ 6183107 h 6857967"/>
              <a:gd name="connsiteX597" fmla="*/ 7758401 w 12191941"/>
              <a:gd name="connsiteY597" fmla="*/ 6254408 h 6857967"/>
              <a:gd name="connsiteX598" fmla="*/ 7829702 w 12191941"/>
              <a:gd name="connsiteY598" fmla="*/ 6254408 h 6857967"/>
              <a:gd name="connsiteX599" fmla="*/ 7829702 w 12191941"/>
              <a:gd name="connsiteY599" fmla="*/ 6183107 h 6857967"/>
              <a:gd name="connsiteX600" fmla="*/ 7615728 w 12191941"/>
              <a:gd name="connsiteY600" fmla="*/ 6183107 h 6857967"/>
              <a:gd name="connsiteX601" fmla="*/ 7615728 w 12191941"/>
              <a:gd name="connsiteY601" fmla="*/ 6254408 h 6857967"/>
              <a:gd name="connsiteX602" fmla="*/ 7687029 w 12191941"/>
              <a:gd name="connsiteY602" fmla="*/ 6254408 h 6857967"/>
              <a:gd name="connsiteX603" fmla="*/ 7687029 w 12191941"/>
              <a:gd name="connsiteY603" fmla="*/ 6183107 h 6857967"/>
              <a:gd name="connsiteX604" fmla="*/ 7473127 w 12191941"/>
              <a:gd name="connsiteY604" fmla="*/ 6183107 h 6857967"/>
              <a:gd name="connsiteX605" fmla="*/ 7473127 w 12191941"/>
              <a:gd name="connsiteY605" fmla="*/ 6254408 h 6857967"/>
              <a:gd name="connsiteX606" fmla="*/ 7544428 w 12191941"/>
              <a:gd name="connsiteY606" fmla="*/ 6254408 h 6857967"/>
              <a:gd name="connsiteX607" fmla="*/ 7544428 w 12191941"/>
              <a:gd name="connsiteY607" fmla="*/ 6183107 h 6857967"/>
              <a:gd name="connsiteX608" fmla="*/ 7330454 w 12191941"/>
              <a:gd name="connsiteY608" fmla="*/ 6183107 h 6857967"/>
              <a:gd name="connsiteX609" fmla="*/ 7330454 w 12191941"/>
              <a:gd name="connsiteY609" fmla="*/ 6254408 h 6857967"/>
              <a:gd name="connsiteX610" fmla="*/ 7401755 w 12191941"/>
              <a:gd name="connsiteY610" fmla="*/ 6254408 h 6857967"/>
              <a:gd name="connsiteX611" fmla="*/ 7401755 w 12191941"/>
              <a:gd name="connsiteY611" fmla="*/ 6183107 h 6857967"/>
              <a:gd name="connsiteX612" fmla="*/ 7187853 w 12191941"/>
              <a:gd name="connsiteY612" fmla="*/ 6183107 h 6857967"/>
              <a:gd name="connsiteX613" fmla="*/ 7187853 w 12191941"/>
              <a:gd name="connsiteY613" fmla="*/ 6254408 h 6857967"/>
              <a:gd name="connsiteX614" fmla="*/ 7259154 w 12191941"/>
              <a:gd name="connsiteY614" fmla="*/ 6254408 h 6857967"/>
              <a:gd name="connsiteX615" fmla="*/ 7259154 w 12191941"/>
              <a:gd name="connsiteY615" fmla="*/ 6183107 h 6857967"/>
              <a:gd name="connsiteX616" fmla="*/ 7045180 w 12191941"/>
              <a:gd name="connsiteY616" fmla="*/ 6183107 h 6857967"/>
              <a:gd name="connsiteX617" fmla="*/ 7045180 w 12191941"/>
              <a:gd name="connsiteY617" fmla="*/ 6254408 h 6857967"/>
              <a:gd name="connsiteX618" fmla="*/ 7116481 w 12191941"/>
              <a:gd name="connsiteY618" fmla="*/ 6254408 h 6857967"/>
              <a:gd name="connsiteX619" fmla="*/ 7116481 w 12191941"/>
              <a:gd name="connsiteY619" fmla="*/ 6183107 h 6857967"/>
              <a:gd name="connsiteX620" fmla="*/ 6902579 w 12191941"/>
              <a:gd name="connsiteY620" fmla="*/ 6183107 h 6857967"/>
              <a:gd name="connsiteX621" fmla="*/ 6902579 w 12191941"/>
              <a:gd name="connsiteY621" fmla="*/ 6254408 h 6857967"/>
              <a:gd name="connsiteX622" fmla="*/ 6973880 w 12191941"/>
              <a:gd name="connsiteY622" fmla="*/ 6254408 h 6857967"/>
              <a:gd name="connsiteX623" fmla="*/ 6973880 w 12191941"/>
              <a:gd name="connsiteY623" fmla="*/ 6183107 h 6857967"/>
              <a:gd name="connsiteX624" fmla="*/ 6759906 w 12191941"/>
              <a:gd name="connsiteY624" fmla="*/ 6183107 h 6857967"/>
              <a:gd name="connsiteX625" fmla="*/ 6759906 w 12191941"/>
              <a:gd name="connsiteY625" fmla="*/ 6254408 h 6857967"/>
              <a:gd name="connsiteX626" fmla="*/ 6831207 w 12191941"/>
              <a:gd name="connsiteY626" fmla="*/ 6254408 h 6857967"/>
              <a:gd name="connsiteX627" fmla="*/ 6831207 w 12191941"/>
              <a:gd name="connsiteY627" fmla="*/ 6183107 h 6857967"/>
              <a:gd name="connsiteX628" fmla="*/ 6617234 w 12191941"/>
              <a:gd name="connsiteY628" fmla="*/ 6183107 h 6857967"/>
              <a:gd name="connsiteX629" fmla="*/ 6617234 w 12191941"/>
              <a:gd name="connsiteY629" fmla="*/ 6254408 h 6857967"/>
              <a:gd name="connsiteX630" fmla="*/ 6688535 w 12191941"/>
              <a:gd name="connsiteY630" fmla="*/ 6254408 h 6857967"/>
              <a:gd name="connsiteX631" fmla="*/ 6688535 w 12191941"/>
              <a:gd name="connsiteY631" fmla="*/ 6183107 h 6857967"/>
              <a:gd name="connsiteX632" fmla="*/ 6474632 w 12191941"/>
              <a:gd name="connsiteY632" fmla="*/ 6183107 h 6857967"/>
              <a:gd name="connsiteX633" fmla="*/ 6474632 w 12191941"/>
              <a:gd name="connsiteY633" fmla="*/ 6254408 h 6857967"/>
              <a:gd name="connsiteX634" fmla="*/ 6545933 w 12191941"/>
              <a:gd name="connsiteY634" fmla="*/ 6254408 h 6857967"/>
              <a:gd name="connsiteX635" fmla="*/ 6545933 w 12191941"/>
              <a:gd name="connsiteY635" fmla="*/ 6183107 h 6857967"/>
              <a:gd name="connsiteX636" fmla="*/ 6331959 w 12191941"/>
              <a:gd name="connsiteY636" fmla="*/ 6183107 h 6857967"/>
              <a:gd name="connsiteX637" fmla="*/ 6331959 w 12191941"/>
              <a:gd name="connsiteY637" fmla="*/ 6254408 h 6857967"/>
              <a:gd name="connsiteX638" fmla="*/ 6403260 w 12191941"/>
              <a:gd name="connsiteY638" fmla="*/ 6254408 h 6857967"/>
              <a:gd name="connsiteX639" fmla="*/ 6403260 w 12191941"/>
              <a:gd name="connsiteY639" fmla="*/ 6183107 h 6857967"/>
              <a:gd name="connsiteX640" fmla="*/ 6189358 w 12191941"/>
              <a:gd name="connsiteY640" fmla="*/ 6183107 h 6857967"/>
              <a:gd name="connsiteX641" fmla="*/ 6189358 w 12191941"/>
              <a:gd name="connsiteY641" fmla="*/ 6254408 h 6857967"/>
              <a:gd name="connsiteX642" fmla="*/ 6260659 w 12191941"/>
              <a:gd name="connsiteY642" fmla="*/ 6254408 h 6857967"/>
              <a:gd name="connsiteX643" fmla="*/ 6260659 w 12191941"/>
              <a:gd name="connsiteY643" fmla="*/ 6183107 h 6857967"/>
              <a:gd name="connsiteX644" fmla="*/ 6046689 w 12191941"/>
              <a:gd name="connsiteY644" fmla="*/ 6183107 h 6857967"/>
              <a:gd name="connsiteX645" fmla="*/ 6046689 w 12191941"/>
              <a:gd name="connsiteY645" fmla="*/ 6254408 h 6857967"/>
              <a:gd name="connsiteX646" fmla="*/ 6117986 w 12191941"/>
              <a:gd name="connsiteY646" fmla="*/ 6254408 h 6857967"/>
              <a:gd name="connsiteX647" fmla="*/ 6117986 w 12191941"/>
              <a:gd name="connsiteY647" fmla="*/ 6183107 h 6857967"/>
              <a:gd name="connsiteX648" fmla="*/ 5904022 w 12191941"/>
              <a:gd name="connsiteY648" fmla="*/ 6183107 h 6857967"/>
              <a:gd name="connsiteX649" fmla="*/ 5904022 w 12191941"/>
              <a:gd name="connsiteY649" fmla="*/ 6254408 h 6857967"/>
              <a:gd name="connsiteX650" fmla="*/ 5975319 w 12191941"/>
              <a:gd name="connsiteY650" fmla="*/ 6254408 h 6857967"/>
              <a:gd name="connsiteX651" fmla="*/ 5975319 w 12191941"/>
              <a:gd name="connsiteY651" fmla="*/ 6183107 h 6857967"/>
              <a:gd name="connsiteX652" fmla="*/ 5761426 w 12191941"/>
              <a:gd name="connsiteY652" fmla="*/ 6183107 h 6857967"/>
              <a:gd name="connsiteX653" fmla="*/ 5761426 w 12191941"/>
              <a:gd name="connsiteY653" fmla="*/ 6254408 h 6857967"/>
              <a:gd name="connsiteX654" fmla="*/ 5832724 w 12191941"/>
              <a:gd name="connsiteY654" fmla="*/ 6254408 h 6857967"/>
              <a:gd name="connsiteX655" fmla="*/ 5832724 w 12191941"/>
              <a:gd name="connsiteY655" fmla="*/ 6183107 h 6857967"/>
              <a:gd name="connsiteX656" fmla="*/ 5618761 w 12191941"/>
              <a:gd name="connsiteY656" fmla="*/ 6183107 h 6857967"/>
              <a:gd name="connsiteX657" fmla="*/ 5618761 w 12191941"/>
              <a:gd name="connsiteY657" fmla="*/ 6254408 h 6857967"/>
              <a:gd name="connsiteX658" fmla="*/ 5690059 w 12191941"/>
              <a:gd name="connsiteY658" fmla="*/ 6254408 h 6857967"/>
              <a:gd name="connsiteX659" fmla="*/ 5690059 w 12191941"/>
              <a:gd name="connsiteY659" fmla="*/ 6183107 h 6857967"/>
              <a:gd name="connsiteX660" fmla="*/ 5476167 w 12191941"/>
              <a:gd name="connsiteY660" fmla="*/ 6183107 h 6857967"/>
              <a:gd name="connsiteX661" fmla="*/ 5476167 w 12191941"/>
              <a:gd name="connsiteY661" fmla="*/ 6254408 h 6857967"/>
              <a:gd name="connsiteX662" fmla="*/ 5547465 w 12191941"/>
              <a:gd name="connsiteY662" fmla="*/ 6254408 h 6857967"/>
              <a:gd name="connsiteX663" fmla="*/ 5547465 w 12191941"/>
              <a:gd name="connsiteY663" fmla="*/ 6183107 h 6857967"/>
              <a:gd name="connsiteX664" fmla="*/ 5333502 w 12191941"/>
              <a:gd name="connsiteY664" fmla="*/ 6183107 h 6857967"/>
              <a:gd name="connsiteX665" fmla="*/ 5333502 w 12191941"/>
              <a:gd name="connsiteY665" fmla="*/ 6254408 h 6857967"/>
              <a:gd name="connsiteX666" fmla="*/ 5404799 w 12191941"/>
              <a:gd name="connsiteY666" fmla="*/ 6254408 h 6857967"/>
              <a:gd name="connsiteX667" fmla="*/ 5404799 w 12191941"/>
              <a:gd name="connsiteY667" fmla="*/ 6183107 h 6857967"/>
              <a:gd name="connsiteX668" fmla="*/ 5190877 w 12191941"/>
              <a:gd name="connsiteY668" fmla="*/ 6183107 h 6857967"/>
              <a:gd name="connsiteX669" fmla="*/ 5190877 w 12191941"/>
              <a:gd name="connsiteY669" fmla="*/ 6254408 h 6857967"/>
              <a:gd name="connsiteX670" fmla="*/ 5262188 w 12191941"/>
              <a:gd name="connsiteY670" fmla="*/ 6254408 h 6857967"/>
              <a:gd name="connsiteX671" fmla="*/ 5262188 w 12191941"/>
              <a:gd name="connsiteY671" fmla="*/ 6183107 h 6857967"/>
              <a:gd name="connsiteX672" fmla="*/ 5048236 w 12191941"/>
              <a:gd name="connsiteY672" fmla="*/ 6183107 h 6857967"/>
              <a:gd name="connsiteX673" fmla="*/ 5048236 w 12191941"/>
              <a:gd name="connsiteY673" fmla="*/ 6254408 h 6857967"/>
              <a:gd name="connsiteX674" fmla="*/ 5119527 w 12191941"/>
              <a:gd name="connsiteY674" fmla="*/ 6254408 h 6857967"/>
              <a:gd name="connsiteX675" fmla="*/ 5119527 w 12191941"/>
              <a:gd name="connsiteY675" fmla="*/ 6183107 h 6857967"/>
              <a:gd name="connsiteX676" fmla="*/ 4906607 w 12191941"/>
              <a:gd name="connsiteY676" fmla="*/ 6183107 h 6857967"/>
              <a:gd name="connsiteX677" fmla="*/ 4906607 w 12191941"/>
              <a:gd name="connsiteY677" fmla="*/ 6254408 h 6857967"/>
              <a:gd name="connsiteX678" fmla="*/ 4977916 w 12191941"/>
              <a:gd name="connsiteY678" fmla="*/ 6254408 h 6857967"/>
              <a:gd name="connsiteX679" fmla="*/ 4977916 w 12191941"/>
              <a:gd name="connsiteY679" fmla="*/ 6183107 h 6857967"/>
              <a:gd name="connsiteX680" fmla="*/ 4764013 w 12191941"/>
              <a:gd name="connsiteY680" fmla="*/ 6183107 h 6857967"/>
              <a:gd name="connsiteX681" fmla="*/ 4764013 w 12191941"/>
              <a:gd name="connsiteY681" fmla="*/ 6254408 h 6857967"/>
              <a:gd name="connsiteX682" fmla="*/ 4835311 w 12191941"/>
              <a:gd name="connsiteY682" fmla="*/ 6254408 h 6857967"/>
              <a:gd name="connsiteX683" fmla="*/ 4835311 w 12191941"/>
              <a:gd name="connsiteY683" fmla="*/ 6183107 h 6857967"/>
              <a:gd name="connsiteX684" fmla="*/ 4621341 w 12191941"/>
              <a:gd name="connsiteY684" fmla="*/ 6183107 h 6857967"/>
              <a:gd name="connsiteX685" fmla="*/ 4621341 w 12191941"/>
              <a:gd name="connsiteY685" fmla="*/ 6254408 h 6857967"/>
              <a:gd name="connsiteX686" fmla="*/ 4692639 w 12191941"/>
              <a:gd name="connsiteY686" fmla="*/ 6254408 h 6857967"/>
              <a:gd name="connsiteX687" fmla="*/ 4692639 w 12191941"/>
              <a:gd name="connsiteY687" fmla="*/ 6183107 h 6857967"/>
              <a:gd name="connsiteX688" fmla="*/ 4478666 w 12191941"/>
              <a:gd name="connsiteY688" fmla="*/ 6183107 h 6857967"/>
              <a:gd name="connsiteX689" fmla="*/ 4478666 w 12191941"/>
              <a:gd name="connsiteY689" fmla="*/ 6254408 h 6857967"/>
              <a:gd name="connsiteX690" fmla="*/ 4549969 w 12191941"/>
              <a:gd name="connsiteY690" fmla="*/ 6254408 h 6857967"/>
              <a:gd name="connsiteX691" fmla="*/ 4549969 w 12191941"/>
              <a:gd name="connsiteY691" fmla="*/ 6183107 h 6857967"/>
              <a:gd name="connsiteX692" fmla="*/ 4336067 w 12191941"/>
              <a:gd name="connsiteY692" fmla="*/ 6183107 h 6857967"/>
              <a:gd name="connsiteX693" fmla="*/ 4336067 w 12191941"/>
              <a:gd name="connsiteY693" fmla="*/ 6254408 h 6857967"/>
              <a:gd name="connsiteX694" fmla="*/ 4407366 w 12191941"/>
              <a:gd name="connsiteY694" fmla="*/ 6254408 h 6857967"/>
              <a:gd name="connsiteX695" fmla="*/ 4407366 w 12191941"/>
              <a:gd name="connsiteY695" fmla="*/ 6183107 h 6857967"/>
              <a:gd name="connsiteX696" fmla="*/ 4193413 w 12191941"/>
              <a:gd name="connsiteY696" fmla="*/ 6183107 h 6857967"/>
              <a:gd name="connsiteX697" fmla="*/ 4193413 w 12191941"/>
              <a:gd name="connsiteY697" fmla="*/ 6254408 h 6857967"/>
              <a:gd name="connsiteX698" fmla="*/ 4264695 w 12191941"/>
              <a:gd name="connsiteY698" fmla="*/ 6254408 h 6857967"/>
              <a:gd name="connsiteX699" fmla="*/ 4264695 w 12191941"/>
              <a:gd name="connsiteY699" fmla="*/ 6183107 h 6857967"/>
              <a:gd name="connsiteX700" fmla="*/ 4050810 w 12191941"/>
              <a:gd name="connsiteY700" fmla="*/ 6183107 h 6857967"/>
              <a:gd name="connsiteX701" fmla="*/ 4050810 w 12191941"/>
              <a:gd name="connsiteY701" fmla="*/ 6254408 h 6857967"/>
              <a:gd name="connsiteX702" fmla="*/ 4122113 w 12191941"/>
              <a:gd name="connsiteY702" fmla="*/ 6254408 h 6857967"/>
              <a:gd name="connsiteX703" fmla="*/ 4122113 w 12191941"/>
              <a:gd name="connsiteY703" fmla="*/ 6183107 h 6857967"/>
              <a:gd name="connsiteX704" fmla="*/ 3908136 w 12191941"/>
              <a:gd name="connsiteY704" fmla="*/ 6183107 h 6857967"/>
              <a:gd name="connsiteX705" fmla="*/ 3908136 w 12191941"/>
              <a:gd name="connsiteY705" fmla="*/ 6254408 h 6857967"/>
              <a:gd name="connsiteX706" fmla="*/ 3979438 w 12191941"/>
              <a:gd name="connsiteY706" fmla="*/ 6254408 h 6857967"/>
              <a:gd name="connsiteX707" fmla="*/ 3979438 w 12191941"/>
              <a:gd name="connsiteY707" fmla="*/ 6183107 h 6857967"/>
              <a:gd name="connsiteX708" fmla="*/ 3765462 w 12191941"/>
              <a:gd name="connsiteY708" fmla="*/ 6183107 h 6857967"/>
              <a:gd name="connsiteX709" fmla="*/ 3765462 w 12191941"/>
              <a:gd name="connsiteY709" fmla="*/ 6254408 h 6857967"/>
              <a:gd name="connsiteX710" fmla="*/ 3836763 w 12191941"/>
              <a:gd name="connsiteY710" fmla="*/ 6254408 h 6857967"/>
              <a:gd name="connsiteX711" fmla="*/ 3836763 w 12191941"/>
              <a:gd name="connsiteY711" fmla="*/ 6183107 h 6857967"/>
              <a:gd name="connsiteX712" fmla="*/ 3622851 w 12191941"/>
              <a:gd name="connsiteY712" fmla="*/ 6183107 h 6857967"/>
              <a:gd name="connsiteX713" fmla="*/ 3622851 w 12191941"/>
              <a:gd name="connsiteY713" fmla="*/ 6254408 h 6857967"/>
              <a:gd name="connsiteX714" fmla="*/ 3694151 w 12191941"/>
              <a:gd name="connsiteY714" fmla="*/ 6254408 h 6857967"/>
              <a:gd name="connsiteX715" fmla="*/ 3694151 w 12191941"/>
              <a:gd name="connsiteY715" fmla="*/ 6183107 h 6857967"/>
              <a:gd name="connsiteX716" fmla="*/ 3480203 w 12191941"/>
              <a:gd name="connsiteY716" fmla="*/ 6183107 h 6857967"/>
              <a:gd name="connsiteX717" fmla="*/ 3480203 w 12191941"/>
              <a:gd name="connsiteY717" fmla="*/ 6254408 h 6857967"/>
              <a:gd name="connsiteX718" fmla="*/ 3551509 w 12191941"/>
              <a:gd name="connsiteY718" fmla="*/ 6254408 h 6857967"/>
              <a:gd name="connsiteX719" fmla="*/ 3551509 w 12191941"/>
              <a:gd name="connsiteY719" fmla="*/ 6183107 h 6857967"/>
              <a:gd name="connsiteX720" fmla="*/ 3337580 w 12191941"/>
              <a:gd name="connsiteY720" fmla="*/ 6183107 h 6857967"/>
              <a:gd name="connsiteX721" fmla="*/ 3337580 w 12191941"/>
              <a:gd name="connsiteY721" fmla="*/ 6254408 h 6857967"/>
              <a:gd name="connsiteX722" fmla="*/ 3408881 w 12191941"/>
              <a:gd name="connsiteY722" fmla="*/ 6254408 h 6857967"/>
              <a:gd name="connsiteX723" fmla="*/ 3408881 w 12191941"/>
              <a:gd name="connsiteY723" fmla="*/ 6183107 h 6857967"/>
              <a:gd name="connsiteX724" fmla="*/ 3194906 w 12191941"/>
              <a:gd name="connsiteY724" fmla="*/ 6183107 h 6857967"/>
              <a:gd name="connsiteX725" fmla="*/ 3194906 w 12191941"/>
              <a:gd name="connsiteY725" fmla="*/ 6254408 h 6857967"/>
              <a:gd name="connsiteX726" fmla="*/ 3266208 w 12191941"/>
              <a:gd name="connsiteY726" fmla="*/ 6254408 h 6857967"/>
              <a:gd name="connsiteX727" fmla="*/ 3266208 w 12191941"/>
              <a:gd name="connsiteY727" fmla="*/ 6183107 h 6857967"/>
              <a:gd name="connsiteX728" fmla="*/ 3052305 w 12191941"/>
              <a:gd name="connsiteY728" fmla="*/ 6183107 h 6857967"/>
              <a:gd name="connsiteX729" fmla="*/ 3052305 w 12191941"/>
              <a:gd name="connsiteY729" fmla="*/ 6254408 h 6857967"/>
              <a:gd name="connsiteX730" fmla="*/ 3123607 w 12191941"/>
              <a:gd name="connsiteY730" fmla="*/ 6254408 h 6857967"/>
              <a:gd name="connsiteX731" fmla="*/ 3123607 w 12191941"/>
              <a:gd name="connsiteY731" fmla="*/ 6183107 h 6857967"/>
              <a:gd name="connsiteX732" fmla="*/ 2909634 w 12191941"/>
              <a:gd name="connsiteY732" fmla="*/ 6183107 h 6857967"/>
              <a:gd name="connsiteX733" fmla="*/ 2909634 w 12191941"/>
              <a:gd name="connsiteY733" fmla="*/ 6254408 h 6857967"/>
              <a:gd name="connsiteX734" fmla="*/ 2980934 w 12191941"/>
              <a:gd name="connsiteY734" fmla="*/ 6254408 h 6857967"/>
              <a:gd name="connsiteX735" fmla="*/ 2980934 w 12191941"/>
              <a:gd name="connsiteY735" fmla="*/ 6183107 h 6857967"/>
              <a:gd name="connsiteX736" fmla="*/ 2767033 w 12191941"/>
              <a:gd name="connsiteY736" fmla="*/ 6183107 h 6857967"/>
              <a:gd name="connsiteX737" fmla="*/ 2767033 w 12191941"/>
              <a:gd name="connsiteY737" fmla="*/ 6254408 h 6857967"/>
              <a:gd name="connsiteX738" fmla="*/ 2838334 w 12191941"/>
              <a:gd name="connsiteY738" fmla="*/ 6254408 h 6857967"/>
              <a:gd name="connsiteX739" fmla="*/ 2838334 w 12191941"/>
              <a:gd name="connsiteY739" fmla="*/ 6183107 h 6857967"/>
              <a:gd name="connsiteX740" fmla="*/ 2624361 w 12191941"/>
              <a:gd name="connsiteY740" fmla="*/ 6183107 h 6857967"/>
              <a:gd name="connsiteX741" fmla="*/ 2624361 w 12191941"/>
              <a:gd name="connsiteY741" fmla="*/ 6254408 h 6857967"/>
              <a:gd name="connsiteX742" fmla="*/ 2695661 w 12191941"/>
              <a:gd name="connsiteY742" fmla="*/ 6254408 h 6857967"/>
              <a:gd name="connsiteX743" fmla="*/ 2695661 w 12191941"/>
              <a:gd name="connsiteY743" fmla="*/ 6183107 h 6857967"/>
              <a:gd name="connsiteX744" fmla="*/ 2481690 w 12191941"/>
              <a:gd name="connsiteY744" fmla="*/ 6183107 h 6857967"/>
              <a:gd name="connsiteX745" fmla="*/ 2481690 w 12191941"/>
              <a:gd name="connsiteY745" fmla="*/ 6254408 h 6857967"/>
              <a:gd name="connsiteX746" fmla="*/ 2552991 w 12191941"/>
              <a:gd name="connsiteY746" fmla="*/ 6254408 h 6857967"/>
              <a:gd name="connsiteX747" fmla="*/ 2552991 w 12191941"/>
              <a:gd name="connsiteY747" fmla="*/ 6183107 h 6857967"/>
              <a:gd name="connsiteX748" fmla="*/ 2339091 w 12191941"/>
              <a:gd name="connsiteY748" fmla="*/ 6183107 h 6857967"/>
              <a:gd name="connsiteX749" fmla="*/ 2339091 w 12191941"/>
              <a:gd name="connsiteY749" fmla="*/ 6254408 h 6857967"/>
              <a:gd name="connsiteX750" fmla="*/ 2410392 w 12191941"/>
              <a:gd name="connsiteY750" fmla="*/ 6254408 h 6857967"/>
              <a:gd name="connsiteX751" fmla="*/ 2410392 w 12191941"/>
              <a:gd name="connsiteY751" fmla="*/ 6183107 h 6857967"/>
              <a:gd name="connsiteX752" fmla="*/ 2196420 w 12191941"/>
              <a:gd name="connsiteY752" fmla="*/ 6183107 h 6857967"/>
              <a:gd name="connsiteX753" fmla="*/ 2196420 w 12191941"/>
              <a:gd name="connsiteY753" fmla="*/ 6254408 h 6857967"/>
              <a:gd name="connsiteX754" fmla="*/ 2267721 w 12191941"/>
              <a:gd name="connsiteY754" fmla="*/ 6254408 h 6857967"/>
              <a:gd name="connsiteX755" fmla="*/ 2267721 w 12191941"/>
              <a:gd name="connsiteY755" fmla="*/ 6183107 h 6857967"/>
              <a:gd name="connsiteX756" fmla="*/ 2053813 w 12191941"/>
              <a:gd name="connsiteY756" fmla="*/ 6183107 h 6857967"/>
              <a:gd name="connsiteX757" fmla="*/ 2053813 w 12191941"/>
              <a:gd name="connsiteY757" fmla="*/ 6254408 h 6857967"/>
              <a:gd name="connsiteX758" fmla="*/ 2125117 w 12191941"/>
              <a:gd name="connsiteY758" fmla="*/ 6254408 h 6857967"/>
              <a:gd name="connsiteX759" fmla="*/ 2125117 w 12191941"/>
              <a:gd name="connsiteY759" fmla="*/ 6183107 h 6857967"/>
              <a:gd name="connsiteX760" fmla="*/ 1911141 w 12191941"/>
              <a:gd name="connsiteY760" fmla="*/ 6183107 h 6857967"/>
              <a:gd name="connsiteX761" fmla="*/ 1911141 w 12191941"/>
              <a:gd name="connsiteY761" fmla="*/ 6254408 h 6857967"/>
              <a:gd name="connsiteX762" fmla="*/ 1982442 w 12191941"/>
              <a:gd name="connsiteY762" fmla="*/ 6254408 h 6857967"/>
              <a:gd name="connsiteX763" fmla="*/ 1982442 w 12191941"/>
              <a:gd name="connsiteY763" fmla="*/ 6183107 h 6857967"/>
              <a:gd name="connsiteX764" fmla="*/ 1768470 w 12191941"/>
              <a:gd name="connsiteY764" fmla="*/ 6183107 h 6857967"/>
              <a:gd name="connsiteX765" fmla="*/ 1768470 w 12191941"/>
              <a:gd name="connsiteY765" fmla="*/ 6254408 h 6857967"/>
              <a:gd name="connsiteX766" fmla="*/ 1839771 w 12191941"/>
              <a:gd name="connsiteY766" fmla="*/ 6254408 h 6857967"/>
              <a:gd name="connsiteX767" fmla="*/ 1839771 w 12191941"/>
              <a:gd name="connsiteY767" fmla="*/ 6183107 h 6857967"/>
              <a:gd name="connsiteX768" fmla="*/ 1625870 w 12191941"/>
              <a:gd name="connsiteY768" fmla="*/ 6183107 h 6857967"/>
              <a:gd name="connsiteX769" fmla="*/ 1625870 w 12191941"/>
              <a:gd name="connsiteY769" fmla="*/ 6254408 h 6857967"/>
              <a:gd name="connsiteX770" fmla="*/ 1697171 w 12191941"/>
              <a:gd name="connsiteY770" fmla="*/ 6254408 h 6857967"/>
              <a:gd name="connsiteX771" fmla="*/ 1697171 w 12191941"/>
              <a:gd name="connsiteY771" fmla="*/ 6183107 h 6857967"/>
              <a:gd name="connsiteX772" fmla="*/ 1483199 w 12191941"/>
              <a:gd name="connsiteY772" fmla="*/ 6183107 h 6857967"/>
              <a:gd name="connsiteX773" fmla="*/ 1483199 w 12191941"/>
              <a:gd name="connsiteY773" fmla="*/ 6254408 h 6857967"/>
              <a:gd name="connsiteX774" fmla="*/ 1554500 w 12191941"/>
              <a:gd name="connsiteY774" fmla="*/ 6254408 h 6857967"/>
              <a:gd name="connsiteX775" fmla="*/ 1554500 w 12191941"/>
              <a:gd name="connsiteY775" fmla="*/ 6183107 h 6857967"/>
              <a:gd name="connsiteX776" fmla="*/ 1340599 w 12191941"/>
              <a:gd name="connsiteY776" fmla="*/ 6183107 h 6857967"/>
              <a:gd name="connsiteX777" fmla="*/ 1340599 w 12191941"/>
              <a:gd name="connsiteY777" fmla="*/ 6254408 h 6857967"/>
              <a:gd name="connsiteX778" fmla="*/ 1411901 w 12191941"/>
              <a:gd name="connsiteY778" fmla="*/ 6254408 h 6857967"/>
              <a:gd name="connsiteX779" fmla="*/ 1411901 w 12191941"/>
              <a:gd name="connsiteY779" fmla="*/ 6183107 h 6857967"/>
              <a:gd name="connsiteX780" fmla="*/ 1197929 w 12191941"/>
              <a:gd name="connsiteY780" fmla="*/ 6183107 h 6857967"/>
              <a:gd name="connsiteX781" fmla="*/ 1197929 w 12191941"/>
              <a:gd name="connsiteY781" fmla="*/ 6254408 h 6857967"/>
              <a:gd name="connsiteX782" fmla="*/ 1269230 w 12191941"/>
              <a:gd name="connsiteY782" fmla="*/ 6254408 h 6857967"/>
              <a:gd name="connsiteX783" fmla="*/ 1269230 w 12191941"/>
              <a:gd name="connsiteY783" fmla="*/ 6183107 h 6857967"/>
              <a:gd name="connsiteX784" fmla="*/ 1055311 w 12191941"/>
              <a:gd name="connsiteY784" fmla="*/ 6183107 h 6857967"/>
              <a:gd name="connsiteX785" fmla="*/ 1055311 w 12191941"/>
              <a:gd name="connsiteY785" fmla="*/ 6254408 h 6857967"/>
              <a:gd name="connsiteX786" fmla="*/ 1126612 w 12191941"/>
              <a:gd name="connsiteY786" fmla="*/ 6254408 h 6857967"/>
              <a:gd name="connsiteX787" fmla="*/ 1126612 w 12191941"/>
              <a:gd name="connsiteY787" fmla="*/ 6183107 h 6857967"/>
              <a:gd name="connsiteX788" fmla="*/ 912657 w 12191941"/>
              <a:gd name="connsiteY788" fmla="*/ 6183107 h 6857967"/>
              <a:gd name="connsiteX789" fmla="*/ 912657 w 12191941"/>
              <a:gd name="connsiteY789" fmla="*/ 6254408 h 6857967"/>
              <a:gd name="connsiteX790" fmla="*/ 983958 w 12191941"/>
              <a:gd name="connsiteY790" fmla="*/ 6254408 h 6857967"/>
              <a:gd name="connsiteX791" fmla="*/ 983958 w 12191941"/>
              <a:gd name="connsiteY791" fmla="*/ 6183107 h 6857967"/>
              <a:gd name="connsiteX792" fmla="*/ 771136 w 12191941"/>
              <a:gd name="connsiteY792" fmla="*/ 6183107 h 6857967"/>
              <a:gd name="connsiteX793" fmla="*/ 771136 w 12191941"/>
              <a:gd name="connsiteY793" fmla="*/ 6254408 h 6857967"/>
              <a:gd name="connsiteX794" fmla="*/ 842437 w 12191941"/>
              <a:gd name="connsiteY794" fmla="*/ 6254408 h 6857967"/>
              <a:gd name="connsiteX795" fmla="*/ 842437 w 12191941"/>
              <a:gd name="connsiteY795" fmla="*/ 6183107 h 6857967"/>
              <a:gd name="connsiteX796" fmla="*/ 628534 w 12191941"/>
              <a:gd name="connsiteY796" fmla="*/ 6183107 h 6857967"/>
              <a:gd name="connsiteX797" fmla="*/ 628534 w 12191941"/>
              <a:gd name="connsiteY797" fmla="*/ 6254408 h 6857967"/>
              <a:gd name="connsiteX798" fmla="*/ 699835 w 12191941"/>
              <a:gd name="connsiteY798" fmla="*/ 6254408 h 6857967"/>
              <a:gd name="connsiteX799" fmla="*/ 699835 w 12191941"/>
              <a:gd name="connsiteY799" fmla="*/ 6183107 h 6857967"/>
              <a:gd name="connsiteX800" fmla="*/ 485863 w 12191941"/>
              <a:gd name="connsiteY800" fmla="*/ 6183107 h 6857967"/>
              <a:gd name="connsiteX801" fmla="*/ 485863 w 12191941"/>
              <a:gd name="connsiteY801" fmla="*/ 6254408 h 6857967"/>
              <a:gd name="connsiteX802" fmla="*/ 557163 w 12191941"/>
              <a:gd name="connsiteY802" fmla="*/ 6254408 h 6857967"/>
              <a:gd name="connsiteX803" fmla="*/ 557163 w 12191941"/>
              <a:gd name="connsiteY803" fmla="*/ 6183107 h 6857967"/>
              <a:gd name="connsiteX804" fmla="*/ 343191 w 12191941"/>
              <a:gd name="connsiteY804" fmla="*/ 6183107 h 6857967"/>
              <a:gd name="connsiteX805" fmla="*/ 343191 w 12191941"/>
              <a:gd name="connsiteY805" fmla="*/ 6254408 h 6857967"/>
              <a:gd name="connsiteX806" fmla="*/ 414492 w 12191941"/>
              <a:gd name="connsiteY806" fmla="*/ 6254408 h 6857967"/>
              <a:gd name="connsiteX807" fmla="*/ 414492 w 12191941"/>
              <a:gd name="connsiteY807" fmla="*/ 6183107 h 6857967"/>
              <a:gd name="connsiteX808" fmla="*/ 200590 w 12191941"/>
              <a:gd name="connsiteY808" fmla="*/ 6183107 h 6857967"/>
              <a:gd name="connsiteX809" fmla="*/ 200590 w 12191941"/>
              <a:gd name="connsiteY809" fmla="*/ 6254408 h 6857967"/>
              <a:gd name="connsiteX810" fmla="*/ 271891 w 12191941"/>
              <a:gd name="connsiteY810" fmla="*/ 6254408 h 6857967"/>
              <a:gd name="connsiteX811" fmla="*/ 271891 w 12191941"/>
              <a:gd name="connsiteY811" fmla="*/ 6183107 h 6857967"/>
              <a:gd name="connsiteX812" fmla="*/ 57918 w 12191941"/>
              <a:gd name="connsiteY812" fmla="*/ 6183107 h 6857967"/>
              <a:gd name="connsiteX813" fmla="*/ 57918 w 12191941"/>
              <a:gd name="connsiteY813" fmla="*/ 6254408 h 6857967"/>
              <a:gd name="connsiteX814" fmla="*/ 129219 w 12191941"/>
              <a:gd name="connsiteY814" fmla="*/ 6254408 h 6857967"/>
              <a:gd name="connsiteX815" fmla="*/ 129219 w 12191941"/>
              <a:gd name="connsiteY815" fmla="*/ 6183107 h 6857967"/>
              <a:gd name="connsiteX816" fmla="*/ 10040665 w 12191941"/>
              <a:gd name="connsiteY816" fmla="*/ 6040435 h 6857967"/>
              <a:gd name="connsiteX817" fmla="*/ 10040665 w 12191941"/>
              <a:gd name="connsiteY817" fmla="*/ 6111736 h 6857967"/>
              <a:gd name="connsiteX818" fmla="*/ 10111966 w 12191941"/>
              <a:gd name="connsiteY818" fmla="*/ 6111736 h 6857967"/>
              <a:gd name="connsiteX819" fmla="*/ 10111966 w 12191941"/>
              <a:gd name="connsiteY819" fmla="*/ 6040435 h 6857967"/>
              <a:gd name="connsiteX820" fmla="*/ 9898063 w 12191941"/>
              <a:gd name="connsiteY820" fmla="*/ 6040435 h 6857967"/>
              <a:gd name="connsiteX821" fmla="*/ 9898063 w 12191941"/>
              <a:gd name="connsiteY821" fmla="*/ 6111736 h 6857967"/>
              <a:gd name="connsiteX822" fmla="*/ 9969363 w 12191941"/>
              <a:gd name="connsiteY822" fmla="*/ 6111736 h 6857967"/>
              <a:gd name="connsiteX823" fmla="*/ 9969363 w 12191941"/>
              <a:gd name="connsiteY823" fmla="*/ 6040435 h 6857967"/>
              <a:gd name="connsiteX824" fmla="*/ 9755391 w 12191941"/>
              <a:gd name="connsiteY824" fmla="*/ 6040435 h 6857967"/>
              <a:gd name="connsiteX825" fmla="*/ 9755391 w 12191941"/>
              <a:gd name="connsiteY825" fmla="*/ 6111736 h 6857967"/>
              <a:gd name="connsiteX826" fmla="*/ 9826692 w 12191941"/>
              <a:gd name="connsiteY826" fmla="*/ 6111736 h 6857967"/>
              <a:gd name="connsiteX827" fmla="*/ 9826692 w 12191941"/>
              <a:gd name="connsiteY827" fmla="*/ 6040435 h 6857967"/>
              <a:gd name="connsiteX828" fmla="*/ 9612718 w 12191941"/>
              <a:gd name="connsiteY828" fmla="*/ 6040435 h 6857967"/>
              <a:gd name="connsiteX829" fmla="*/ 9612718 w 12191941"/>
              <a:gd name="connsiteY829" fmla="*/ 6111736 h 6857967"/>
              <a:gd name="connsiteX830" fmla="*/ 9684019 w 12191941"/>
              <a:gd name="connsiteY830" fmla="*/ 6111736 h 6857967"/>
              <a:gd name="connsiteX831" fmla="*/ 9684019 w 12191941"/>
              <a:gd name="connsiteY831" fmla="*/ 6040435 h 6857967"/>
              <a:gd name="connsiteX832" fmla="*/ 9470117 w 12191941"/>
              <a:gd name="connsiteY832" fmla="*/ 6040435 h 6857967"/>
              <a:gd name="connsiteX833" fmla="*/ 9470117 w 12191941"/>
              <a:gd name="connsiteY833" fmla="*/ 6111736 h 6857967"/>
              <a:gd name="connsiteX834" fmla="*/ 9541417 w 12191941"/>
              <a:gd name="connsiteY834" fmla="*/ 6111736 h 6857967"/>
              <a:gd name="connsiteX835" fmla="*/ 9541417 w 12191941"/>
              <a:gd name="connsiteY835" fmla="*/ 6040435 h 6857967"/>
              <a:gd name="connsiteX836" fmla="*/ 9327444 w 12191941"/>
              <a:gd name="connsiteY836" fmla="*/ 6040435 h 6857967"/>
              <a:gd name="connsiteX837" fmla="*/ 9327444 w 12191941"/>
              <a:gd name="connsiteY837" fmla="*/ 6111736 h 6857967"/>
              <a:gd name="connsiteX838" fmla="*/ 9398745 w 12191941"/>
              <a:gd name="connsiteY838" fmla="*/ 6111736 h 6857967"/>
              <a:gd name="connsiteX839" fmla="*/ 9398745 w 12191941"/>
              <a:gd name="connsiteY839" fmla="*/ 6040435 h 6857967"/>
              <a:gd name="connsiteX840" fmla="*/ 9184842 w 12191941"/>
              <a:gd name="connsiteY840" fmla="*/ 6040435 h 6857967"/>
              <a:gd name="connsiteX841" fmla="*/ 9184842 w 12191941"/>
              <a:gd name="connsiteY841" fmla="*/ 6111736 h 6857967"/>
              <a:gd name="connsiteX842" fmla="*/ 9256143 w 12191941"/>
              <a:gd name="connsiteY842" fmla="*/ 6111736 h 6857967"/>
              <a:gd name="connsiteX843" fmla="*/ 9256143 w 12191941"/>
              <a:gd name="connsiteY843" fmla="*/ 6040435 h 6857967"/>
              <a:gd name="connsiteX844" fmla="*/ 9042170 w 12191941"/>
              <a:gd name="connsiteY844" fmla="*/ 6040435 h 6857967"/>
              <a:gd name="connsiteX845" fmla="*/ 9042170 w 12191941"/>
              <a:gd name="connsiteY845" fmla="*/ 6111736 h 6857967"/>
              <a:gd name="connsiteX846" fmla="*/ 9113471 w 12191941"/>
              <a:gd name="connsiteY846" fmla="*/ 6111736 h 6857967"/>
              <a:gd name="connsiteX847" fmla="*/ 9113471 w 12191941"/>
              <a:gd name="connsiteY847" fmla="*/ 6040435 h 6857967"/>
              <a:gd name="connsiteX848" fmla="*/ 8899568 w 12191941"/>
              <a:gd name="connsiteY848" fmla="*/ 6040435 h 6857967"/>
              <a:gd name="connsiteX849" fmla="*/ 8899568 w 12191941"/>
              <a:gd name="connsiteY849" fmla="*/ 6111736 h 6857967"/>
              <a:gd name="connsiteX850" fmla="*/ 8970869 w 12191941"/>
              <a:gd name="connsiteY850" fmla="*/ 6111736 h 6857967"/>
              <a:gd name="connsiteX851" fmla="*/ 8970869 w 12191941"/>
              <a:gd name="connsiteY851" fmla="*/ 6040435 h 6857967"/>
              <a:gd name="connsiteX852" fmla="*/ 8756896 w 12191941"/>
              <a:gd name="connsiteY852" fmla="*/ 6040435 h 6857967"/>
              <a:gd name="connsiteX853" fmla="*/ 8756896 w 12191941"/>
              <a:gd name="connsiteY853" fmla="*/ 6111736 h 6857967"/>
              <a:gd name="connsiteX854" fmla="*/ 8828196 w 12191941"/>
              <a:gd name="connsiteY854" fmla="*/ 6111736 h 6857967"/>
              <a:gd name="connsiteX855" fmla="*/ 8828196 w 12191941"/>
              <a:gd name="connsiteY855" fmla="*/ 6040435 h 6857967"/>
              <a:gd name="connsiteX856" fmla="*/ 8614223 w 12191941"/>
              <a:gd name="connsiteY856" fmla="*/ 6040435 h 6857967"/>
              <a:gd name="connsiteX857" fmla="*/ 8614223 w 12191941"/>
              <a:gd name="connsiteY857" fmla="*/ 6111736 h 6857967"/>
              <a:gd name="connsiteX858" fmla="*/ 8685524 w 12191941"/>
              <a:gd name="connsiteY858" fmla="*/ 6111736 h 6857967"/>
              <a:gd name="connsiteX859" fmla="*/ 8685524 w 12191941"/>
              <a:gd name="connsiteY859" fmla="*/ 6040435 h 6857967"/>
              <a:gd name="connsiteX860" fmla="*/ 8471622 w 12191941"/>
              <a:gd name="connsiteY860" fmla="*/ 6040435 h 6857967"/>
              <a:gd name="connsiteX861" fmla="*/ 8471622 w 12191941"/>
              <a:gd name="connsiteY861" fmla="*/ 6111736 h 6857967"/>
              <a:gd name="connsiteX862" fmla="*/ 8542923 w 12191941"/>
              <a:gd name="connsiteY862" fmla="*/ 6111736 h 6857967"/>
              <a:gd name="connsiteX863" fmla="*/ 8542923 w 12191941"/>
              <a:gd name="connsiteY863" fmla="*/ 6040435 h 6857967"/>
              <a:gd name="connsiteX864" fmla="*/ 8328949 w 12191941"/>
              <a:gd name="connsiteY864" fmla="*/ 6040435 h 6857967"/>
              <a:gd name="connsiteX865" fmla="*/ 8328949 w 12191941"/>
              <a:gd name="connsiteY865" fmla="*/ 6111736 h 6857967"/>
              <a:gd name="connsiteX866" fmla="*/ 8400250 w 12191941"/>
              <a:gd name="connsiteY866" fmla="*/ 6111736 h 6857967"/>
              <a:gd name="connsiteX867" fmla="*/ 8400250 w 12191941"/>
              <a:gd name="connsiteY867" fmla="*/ 6040435 h 6857967"/>
              <a:gd name="connsiteX868" fmla="*/ 8186348 w 12191941"/>
              <a:gd name="connsiteY868" fmla="*/ 6040435 h 6857967"/>
              <a:gd name="connsiteX869" fmla="*/ 8186348 w 12191941"/>
              <a:gd name="connsiteY869" fmla="*/ 6111736 h 6857967"/>
              <a:gd name="connsiteX870" fmla="*/ 8257649 w 12191941"/>
              <a:gd name="connsiteY870" fmla="*/ 6111736 h 6857967"/>
              <a:gd name="connsiteX871" fmla="*/ 8257649 w 12191941"/>
              <a:gd name="connsiteY871" fmla="*/ 6040435 h 6857967"/>
              <a:gd name="connsiteX872" fmla="*/ 8043675 w 12191941"/>
              <a:gd name="connsiteY872" fmla="*/ 6040435 h 6857967"/>
              <a:gd name="connsiteX873" fmla="*/ 8043675 w 12191941"/>
              <a:gd name="connsiteY873" fmla="*/ 6111736 h 6857967"/>
              <a:gd name="connsiteX874" fmla="*/ 8114976 w 12191941"/>
              <a:gd name="connsiteY874" fmla="*/ 6111736 h 6857967"/>
              <a:gd name="connsiteX875" fmla="*/ 8114976 w 12191941"/>
              <a:gd name="connsiteY875" fmla="*/ 6040435 h 6857967"/>
              <a:gd name="connsiteX876" fmla="*/ 7901003 w 12191941"/>
              <a:gd name="connsiteY876" fmla="*/ 6040435 h 6857967"/>
              <a:gd name="connsiteX877" fmla="*/ 7901003 w 12191941"/>
              <a:gd name="connsiteY877" fmla="*/ 6111736 h 6857967"/>
              <a:gd name="connsiteX878" fmla="*/ 7972304 w 12191941"/>
              <a:gd name="connsiteY878" fmla="*/ 6111736 h 6857967"/>
              <a:gd name="connsiteX879" fmla="*/ 7972304 w 12191941"/>
              <a:gd name="connsiteY879" fmla="*/ 6040435 h 6857967"/>
              <a:gd name="connsiteX880" fmla="*/ 7758401 w 12191941"/>
              <a:gd name="connsiteY880" fmla="*/ 6040435 h 6857967"/>
              <a:gd name="connsiteX881" fmla="*/ 7758401 w 12191941"/>
              <a:gd name="connsiteY881" fmla="*/ 6111736 h 6857967"/>
              <a:gd name="connsiteX882" fmla="*/ 7829702 w 12191941"/>
              <a:gd name="connsiteY882" fmla="*/ 6111736 h 6857967"/>
              <a:gd name="connsiteX883" fmla="*/ 7829702 w 12191941"/>
              <a:gd name="connsiteY883" fmla="*/ 6040435 h 6857967"/>
              <a:gd name="connsiteX884" fmla="*/ 7615728 w 12191941"/>
              <a:gd name="connsiteY884" fmla="*/ 6040435 h 6857967"/>
              <a:gd name="connsiteX885" fmla="*/ 7615728 w 12191941"/>
              <a:gd name="connsiteY885" fmla="*/ 6111736 h 6857967"/>
              <a:gd name="connsiteX886" fmla="*/ 7687029 w 12191941"/>
              <a:gd name="connsiteY886" fmla="*/ 6111736 h 6857967"/>
              <a:gd name="connsiteX887" fmla="*/ 7687029 w 12191941"/>
              <a:gd name="connsiteY887" fmla="*/ 6040435 h 6857967"/>
              <a:gd name="connsiteX888" fmla="*/ 7473127 w 12191941"/>
              <a:gd name="connsiteY888" fmla="*/ 6040435 h 6857967"/>
              <a:gd name="connsiteX889" fmla="*/ 7473127 w 12191941"/>
              <a:gd name="connsiteY889" fmla="*/ 6111736 h 6857967"/>
              <a:gd name="connsiteX890" fmla="*/ 7544428 w 12191941"/>
              <a:gd name="connsiteY890" fmla="*/ 6111736 h 6857967"/>
              <a:gd name="connsiteX891" fmla="*/ 7544428 w 12191941"/>
              <a:gd name="connsiteY891" fmla="*/ 6040435 h 6857967"/>
              <a:gd name="connsiteX892" fmla="*/ 7330454 w 12191941"/>
              <a:gd name="connsiteY892" fmla="*/ 6040435 h 6857967"/>
              <a:gd name="connsiteX893" fmla="*/ 7330454 w 12191941"/>
              <a:gd name="connsiteY893" fmla="*/ 6111736 h 6857967"/>
              <a:gd name="connsiteX894" fmla="*/ 7401755 w 12191941"/>
              <a:gd name="connsiteY894" fmla="*/ 6111736 h 6857967"/>
              <a:gd name="connsiteX895" fmla="*/ 7401755 w 12191941"/>
              <a:gd name="connsiteY895" fmla="*/ 6040435 h 6857967"/>
              <a:gd name="connsiteX896" fmla="*/ 7187853 w 12191941"/>
              <a:gd name="connsiteY896" fmla="*/ 6040435 h 6857967"/>
              <a:gd name="connsiteX897" fmla="*/ 7187853 w 12191941"/>
              <a:gd name="connsiteY897" fmla="*/ 6111736 h 6857967"/>
              <a:gd name="connsiteX898" fmla="*/ 7259154 w 12191941"/>
              <a:gd name="connsiteY898" fmla="*/ 6111736 h 6857967"/>
              <a:gd name="connsiteX899" fmla="*/ 7259154 w 12191941"/>
              <a:gd name="connsiteY899" fmla="*/ 6040435 h 6857967"/>
              <a:gd name="connsiteX900" fmla="*/ 7045180 w 12191941"/>
              <a:gd name="connsiteY900" fmla="*/ 6040435 h 6857967"/>
              <a:gd name="connsiteX901" fmla="*/ 7045180 w 12191941"/>
              <a:gd name="connsiteY901" fmla="*/ 6111736 h 6857967"/>
              <a:gd name="connsiteX902" fmla="*/ 7116481 w 12191941"/>
              <a:gd name="connsiteY902" fmla="*/ 6111736 h 6857967"/>
              <a:gd name="connsiteX903" fmla="*/ 7116481 w 12191941"/>
              <a:gd name="connsiteY903" fmla="*/ 6040435 h 6857967"/>
              <a:gd name="connsiteX904" fmla="*/ 6902579 w 12191941"/>
              <a:gd name="connsiteY904" fmla="*/ 6040435 h 6857967"/>
              <a:gd name="connsiteX905" fmla="*/ 6902579 w 12191941"/>
              <a:gd name="connsiteY905" fmla="*/ 6111736 h 6857967"/>
              <a:gd name="connsiteX906" fmla="*/ 6973880 w 12191941"/>
              <a:gd name="connsiteY906" fmla="*/ 6111736 h 6857967"/>
              <a:gd name="connsiteX907" fmla="*/ 6973880 w 12191941"/>
              <a:gd name="connsiteY907" fmla="*/ 6040435 h 6857967"/>
              <a:gd name="connsiteX908" fmla="*/ 6759906 w 12191941"/>
              <a:gd name="connsiteY908" fmla="*/ 6040435 h 6857967"/>
              <a:gd name="connsiteX909" fmla="*/ 6759906 w 12191941"/>
              <a:gd name="connsiteY909" fmla="*/ 6111736 h 6857967"/>
              <a:gd name="connsiteX910" fmla="*/ 6831207 w 12191941"/>
              <a:gd name="connsiteY910" fmla="*/ 6111736 h 6857967"/>
              <a:gd name="connsiteX911" fmla="*/ 6831207 w 12191941"/>
              <a:gd name="connsiteY911" fmla="*/ 6040435 h 6857967"/>
              <a:gd name="connsiteX912" fmla="*/ 6617234 w 12191941"/>
              <a:gd name="connsiteY912" fmla="*/ 6040435 h 6857967"/>
              <a:gd name="connsiteX913" fmla="*/ 6617234 w 12191941"/>
              <a:gd name="connsiteY913" fmla="*/ 6111736 h 6857967"/>
              <a:gd name="connsiteX914" fmla="*/ 6688535 w 12191941"/>
              <a:gd name="connsiteY914" fmla="*/ 6111736 h 6857967"/>
              <a:gd name="connsiteX915" fmla="*/ 6688535 w 12191941"/>
              <a:gd name="connsiteY915" fmla="*/ 6040435 h 6857967"/>
              <a:gd name="connsiteX916" fmla="*/ 6474632 w 12191941"/>
              <a:gd name="connsiteY916" fmla="*/ 6040435 h 6857967"/>
              <a:gd name="connsiteX917" fmla="*/ 6474632 w 12191941"/>
              <a:gd name="connsiteY917" fmla="*/ 6111736 h 6857967"/>
              <a:gd name="connsiteX918" fmla="*/ 6545933 w 12191941"/>
              <a:gd name="connsiteY918" fmla="*/ 6111736 h 6857967"/>
              <a:gd name="connsiteX919" fmla="*/ 6545933 w 12191941"/>
              <a:gd name="connsiteY919" fmla="*/ 6040435 h 6857967"/>
              <a:gd name="connsiteX920" fmla="*/ 6331959 w 12191941"/>
              <a:gd name="connsiteY920" fmla="*/ 6040435 h 6857967"/>
              <a:gd name="connsiteX921" fmla="*/ 6331959 w 12191941"/>
              <a:gd name="connsiteY921" fmla="*/ 6111736 h 6857967"/>
              <a:gd name="connsiteX922" fmla="*/ 6403260 w 12191941"/>
              <a:gd name="connsiteY922" fmla="*/ 6111736 h 6857967"/>
              <a:gd name="connsiteX923" fmla="*/ 6403260 w 12191941"/>
              <a:gd name="connsiteY923" fmla="*/ 6040435 h 6857967"/>
              <a:gd name="connsiteX924" fmla="*/ 6189358 w 12191941"/>
              <a:gd name="connsiteY924" fmla="*/ 6040435 h 6857967"/>
              <a:gd name="connsiteX925" fmla="*/ 6189358 w 12191941"/>
              <a:gd name="connsiteY925" fmla="*/ 6111736 h 6857967"/>
              <a:gd name="connsiteX926" fmla="*/ 6260659 w 12191941"/>
              <a:gd name="connsiteY926" fmla="*/ 6111736 h 6857967"/>
              <a:gd name="connsiteX927" fmla="*/ 6260659 w 12191941"/>
              <a:gd name="connsiteY927" fmla="*/ 6040435 h 6857967"/>
              <a:gd name="connsiteX928" fmla="*/ 6046689 w 12191941"/>
              <a:gd name="connsiteY928" fmla="*/ 6040435 h 6857967"/>
              <a:gd name="connsiteX929" fmla="*/ 6046689 w 12191941"/>
              <a:gd name="connsiteY929" fmla="*/ 6111736 h 6857967"/>
              <a:gd name="connsiteX930" fmla="*/ 6117986 w 12191941"/>
              <a:gd name="connsiteY930" fmla="*/ 6111736 h 6857967"/>
              <a:gd name="connsiteX931" fmla="*/ 6117986 w 12191941"/>
              <a:gd name="connsiteY931" fmla="*/ 6040435 h 6857967"/>
              <a:gd name="connsiteX932" fmla="*/ 5904022 w 12191941"/>
              <a:gd name="connsiteY932" fmla="*/ 6040435 h 6857967"/>
              <a:gd name="connsiteX933" fmla="*/ 5904022 w 12191941"/>
              <a:gd name="connsiteY933" fmla="*/ 6111736 h 6857967"/>
              <a:gd name="connsiteX934" fmla="*/ 5975319 w 12191941"/>
              <a:gd name="connsiteY934" fmla="*/ 6111736 h 6857967"/>
              <a:gd name="connsiteX935" fmla="*/ 5975319 w 12191941"/>
              <a:gd name="connsiteY935" fmla="*/ 6040435 h 6857967"/>
              <a:gd name="connsiteX936" fmla="*/ 5761426 w 12191941"/>
              <a:gd name="connsiteY936" fmla="*/ 6040435 h 6857967"/>
              <a:gd name="connsiteX937" fmla="*/ 5761426 w 12191941"/>
              <a:gd name="connsiteY937" fmla="*/ 6111736 h 6857967"/>
              <a:gd name="connsiteX938" fmla="*/ 5832724 w 12191941"/>
              <a:gd name="connsiteY938" fmla="*/ 6111736 h 6857967"/>
              <a:gd name="connsiteX939" fmla="*/ 5832724 w 12191941"/>
              <a:gd name="connsiteY939" fmla="*/ 6040435 h 6857967"/>
              <a:gd name="connsiteX940" fmla="*/ 5618761 w 12191941"/>
              <a:gd name="connsiteY940" fmla="*/ 6040435 h 6857967"/>
              <a:gd name="connsiteX941" fmla="*/ 5618761 w 12191941"/>
              <a:gd name="connsiteY941" fmla="*/ 6111736 h 6857967"/>
              <a:gd name="connsiteX942" fmla="*/ 5690059 w 12191941"/>
              <a:gd name="connsiteY942" fmla="*/ 6111736 h 6857967"/>
              <a:gd name="connsiteX943" fmla="*/ 5690059 w 12191941"/>
              <a:gd name="connsiteY943" fmla="*/ 6040435 h 6857967"/>
              <a:gd name="connsiteX944" fmla="*/ 5476167 w 12191941"/>
              <a:gd name="connsiteY944" fmla="*/ 6040435 h 6857967"/>
              <a:gd name="connsiteX945" fmla="*/ 5476167 w 12191941"/>
              <a:gd name="connsiteY945" fmla="*/ 6111736 h 6857967"/>
              <a:gd name="connsiteX946" fmla="*/ 5547465 w 12191941"/>
              <a:gd name="connsiteY946" fmla="*/ 6111736 h 6857967"/>
              <a:gd name="connsiteX947" fmla="*/ 5547465 w 12191941"/>
              <a:gd name="connsiteY947" fmla="*/ 6040435 h 6857967"/>
              <a:gd name="connsiteX948" fmla="*/ 5333502 w 12191941"/>
              <a:gd name="connsiteY948" fmla="*/ 6040435 h 6857967"/>
              <a:gd name="connsiteX949" fmla="*/ 5333502 w 12191941"/>
              <a:gd name="connsiteY949" fmla="*/ 6111736 h 6857967"/>
              <a:gd name="connsiteX950" fmla="*/ 5404800 w 12191941"/>
              <a:gd name="connsiteY950" fmla="*/ 6111736 h 6857967"/>
              <a:gd name="connsiteX951" fmla="*/ 5404800 w 12191941"/>
              <a:gd name="connsiteY951" fmla="*/ 6040435 h 6857967"/>
              <a:gd name="connsiteX952" fmla="*/ 5190877 w 12191941"/>
              <a:gd name="connsiteY952" fmla="*/ 6040435 h 6857967"/>
              <a:gd name="connsiteX953" fmla="*/ 5190877 w 12191941"/>
              <a:gd name="connsiteY953" fmla="*/ 6111736 h 6857967"/>
              <a:gd name="connsiteX954" fmla="*/ 5262188 w 12191941"/>
              <a:gd name="connsiteY954" fmla="*/ 6111736 h 6857967"/>
              <a:gd name="connsiteX955" fmla="*/ 5262188 w 12191941"/>
              <a:gd name="connsiteY955" fmla="*/ 6040435 h 6857967"/>
              <a:gd name="connsiteX956" fmla="*/ 5048236 w 12191941"/>
              <a:gd name="connsiteY956" fmla="*/ 6040435 h 6857967"/>
              <a:gd name="connsiteX957" fmla="*/ 5048236 w 12191941"/>
              <a:gd name="connsiteY957" fmla="*/ 6111736 h 6857967"/>
              <a:gd name="connsiteX958" fmla="*/ 5119527 w 12191941"/>
              <a:gd name="connsiteY958" fmla="*/ 6111736 h 6857967"/>
              <a:gd name="connsiteX959" fmla="*/ 5119527 w 12191941"/>
              <a:gd name="connsiteY959" fmla="*/ 6040435 h 6857967"/>
              <a:gd name="connsiteX960" fmla="*/ 4906607 w 12191941"/>
              <a:gd name="connsiteY960" fmla="*/ 6040435 h 6857967"/>
              <a:gd name="connsiteX961" fmla="*/ 4906607 w 12191941"/>
              <a:gd name="connsiteY961" fmla="*/ 6111736 h 6857967"/>
              <a:gd name="connsiteX962" fmla="*/ 4977916 w 12191941"/>
              <a:gd name="connsiteY962" fmla="*/ 6111736 h 6857967"/>
              <a:gd name="connsiteX963" fmla="*/ 4977916 w 12191941"/>
              <a:gd name="connsiteY963" fmla="*/ 6040435 h 6857967"/>
              <a:gd name="connsiteX964" fmla="*/ 4764013 w 12191941"/>
              <a:gd name="connsiteY964" fmla="*/ 6040435 h 6857967"/>
              <a:gd name="connsiteX965" fmla="*/ 4764013 w 12191941"/>
              <a:gd name="connsiteY965" fmla="*/ 6111736 h 6857967"/>
              <a:gd name="connsiteX966" fmla="*/ 4835311 w 12191941"/>
              <a:gd name="connsiteY966" fmla="*/ 6111736 h 6857967"/>
              <a:gd name="connsiteX967" fmla="*/ 4835311 w 12191941"/>
              <a:gd name="connsiteY967" fmla="*/ 6040435 h 6857967"/>
              <a:gd name="connsiteX968" fmla="*/ 4621341 w 12191941"/>
              <a:gd name="connsiteY968" fmla="*/ 6040435 h 6857967"/>
              <a:gd name="connsiteX969" fmla="*/ 4621341 w 12191941"/>
              <a:gd name="connsiteY969" fmla="*/ 6111736 h 6857967"/>
              <a:gd name="connsiteX970" fmla="*/ 4692639 w 12191941"/>
              <a:gd name="connsiteY970" fmla="*/ 6111736 h 6857967"/>
              <a:gd name="connsiteX971" fmla="*/ 4692639 w 12191941"/>
              <a:gd name="connsiteY971" fmla="*/ 6040435 h 6857967"/>
              <a:gd name="connsiteX972" fmla="*/ 4478666 w 12191941"/>
              <a:gd name="connsiteY972" fmla="*/ 6040435 h 6857967"/>
              <a:gd name="connsiteX973" fmla="*/ 4478666 w 12191941"/>
              <a:gd name="connsiteY973" fmla="*/ 6111736 h 6857967"/>
              <a:gd name="connsiteX974" fmla="*/ 4549971 w 12191941"/>
              <a:gd name="connsiteY974" fmla="*/ 6111736 h 6857967"/>
              <a:gd name="connsiteX975" fmla="*/ 4549971 w 12191941"/>
              <a:gd name="connsiteY975" fmla="*/ 6040435 h 6857967"/>
              <a:gd name="connsiteX976" fmla="*/ 4336067 w 12191941"/>
              <a:gd name="connsiteY976" fmla="*/ 6040435 h 6857967"/>
              <a:gd name="connsiteX977" fmla="*/ 4336067 w 12191941"/>
              <a:gd name="connsiteY977" fmla="*/ 6111736 h 6857967"/>
              <a:gd name="connsiteX978" fmla="*/ 4407366 w 12191941"/>
              <a:gd name="connsiteY978" fmla="*/ 6111736 h 6857967"/>
              <a:gd name="connsiteX979" fmla="*/ 4407366 w 12191941"/>
              <a:gd name="connsiteY979" fmla="*/ 6040435 h 6857967"/>
              <a:gd name="connsiteX980" fmla="*/ 4193413 w 12191941"/>
              <a:gd name="connsiteY980" fmla="*/ 6040435 h 6857967"/>
              <a:gd name="connsiteX981" fmla="*/ 4193413 w 12191941"/>
              <a:gd name="connsiteY981" fmla="*/ 6111736 h 6857967"/>
              <a:gd name="connsiteX982" fmla="*/ 4264695 w 12191941"/>
              <a:gd name="connsiteY982" fmla="*/ 6111736 h 6857967"/>
              <a:gd name="connsiteX983" fmla="*/ 4264695 w 12191941"/>
              <a:gd name="connsiteY983" fmla="*/ 6040435 h 6857967"/>
              <a:gd name="connsiteX984" fmla="*/ 4050810 w 12191941"/>
              <a:gd name="connsiteY984" fmla="*/ 6040435 h 6857967"/>
              <a:gd name="connsiteX985" fmla="*/ 4050810 w 12191941"/>
              <a:gd name="connsiteY985" fmla="*/ 6111736 h 6857967"/>
              <a:gd name="connsiteX986" fmla="*/ 4122113 w 12191941"/>
              <a:gd name="connsiteY986" fmla="*/ 6111736 h 6857967"/>
              <a:gd name="connsiteX987" fmla="*/ 4122113 w 12191941"/>
              <a:gd name="connsiteY987" fmla="*/ 6040435 h 6857967"/>
              <a:gd name="connsiteX988" fmla="*/ 3908138 w 12191941"/>
              <a:gd name="connsiteY988" fmla="*/ 6040435 h 6857967"/>
              <a:gd name="connsiteX989" fmla="*/ 3908138 w 12191941"/>
              <a:gd name="connsiteY989" fmla="*/ 6111736 h 6857967"/>
              <a:gd name="connsiteX990" fmla="*/ 3979439 w 12191941"/>
              <a:gd name="connsiteY990" fmla="*/ 6111736 h 6857967"/>
              <a:gd name="connsiteX991" fmla="*/ 3979439 w 12191941"/>
              <a:gd name="connsiteY991" fmla="*/ 6040435 h 6857967"/>
              <a:gd name="connsiteX992" fmla="*/ 3765464 w 12191941"/>
              <a:gd name="connsiteY992" fmla="*/ 6040435 h 6857967"/>
              <a:gd name="connsiteX993" fmla="*/ 3765464 w 12191941"/>
              <a:gd name="connsiteY993" fmla="*/ 6111736 h 6857967"/>
              <a:gd name="connsiteX994" fmla="*/ 3836763 w 12191941"/>
              <a:gd name="connsiteY994" fmla="*/ 6111736 h 6857967"/>
              <a:gd name="connsiteX995" fmla="*/ 3836763 w 12191941"/>
              <a:gd name="connsiteY995" fmla="*/ 6040435 h 6857967"/>
              <a:gd name="connsiteX996" fmla="*/ 3622853 w 12191941"/>
              <a:gd name="connsiteY996" fmla="*/ 6040435 h 6857967"/>
              <a:gd name="connsiteX997" fmla="*/ 3622853 w 12191941"/>
              <a:gd name="connsiteY997" fmla="*/ 6111736 h 6857967"/>
              <a:gd name="connsiteX998" fmla="*/ 3694151 w 12191941"/>
              <a:gd name="connsiteY998" fmla="*/ 6111736 h 6857967"/>
              <a:gd name="connsiteX999" fmla="*/ 3694151 w 12191941"/>
              <a:gd name="connsiteY999" fmla="*/ 6040435 h 6857967"/>
              <a:gd name="connsiteX1000" fmla="*/ 3480203 w 12191941"/>
              <a:gd name="connsiteY1000" fmla="*/ 6040435 h 6857967"/>
              <a:gd name="connsiteX1001" fmla="*/ 3480203 w 12191941"/>
              <a:gd name="connsiteY1001" fmla="*/ 6111736 h 6857967"/>
              <a:gd name="connsiteX1002" fmla="*/ 3551511 w 12191941"/>
              <a:gd name="connsiteY1002" fmla="*/ 6111736 h 6857967"/>
              <a:gd name="connsiteX1003" fmla="*/ 3551511 w 12191941"/>
              <a:gd name="connsiteY1003" fmla="*/ 6040435 h 6857967"/>
              <a:gd name="connsiteX1004" fmla="*/ 3337579 w 12191941"/>
              <a:gd name="connsiteY1004" fmla="*/ 6040435 h 6857967"/>
              <a:gd name="connsiteX1005" fmla="*/ 3337579 w 12191941"/>
              <a:gd name="connsiteY1005" fmla="*/ 6111736 h 6857967"/>
              <a:gd name="connsiteX1006" fmla="*/ 3408880 w 12191941"/>
              <a:gd name="connsiteY1006" fmla="*/ 6111736 h 6857967"/>
              <a:gd name="connsiteX1007" fmla="*/ 3408880 w 12191941"/>
              <a:gd name="connsiteY1007" fmla="*/ 6040435 h 6857967"/>
              <a:gd name="connsiteX1008" fmla="*/ 3194906 w 12191941"/>
              <a:gd name="connsiteY1008" fmla="*/ 6040435 h 6857967"/>
              <a:gd name="connsiteX1009" fmla="*/ 3194906 w 12191941"/>
              <a:gd name="connsiteY1009" fmla="*/ 6111736 h 6857967"/>
              <a:gd name="connsiteX1010" fmla="*/ 3266208 w 12191941"/>
              <a:gd name="connsiteY1010" fmla="*/ 6111736 h 6857967"/>
              <a:gd name="connsiteX1011" fmla="*/ 3266208 w 12191941"/>
              <a:gd name="connsiteY1011" fmla="*/ 6040435 h 6857967"/>
              <a:gd name="connsiteX1012" fmla="*/ 3052305 w 12191941"/>
              <a:gd name="connsiteY1012" fmla="*/ 6040435 h 6857967"/>
              <a:gd name="connsiteX1013" fmla="*/ 3052305 w 12191941"/>
              <a:gd name="connsiteY1013" fmla="*/ 6111736 h 6857967"/>
              <a:gd name="connsiteX1014" fmla="*/ 3123607 w 12191941"/>
              <a:gd name="connsiteY1014" fmla="*/ 6111736 h 6857967"/>
              <a:gd name="connsiteX1015" fmla="*/ 3123607 w 12191941"/>
              <a:gd name="connsiteY1015" fmla="*/ 6040435 h 6857967"/>
              <a:gd name="connsiteX1016" fmla="*/ 2909634 w 12191941"/>
              <a:gd name="connsiteY1016" fmla="*/ 6040435 h 6857967"/>
              <a:gd name="connsiteX1017" fmla="*/ 2909634 w 12191941"/>
              <a:gd name="connsiteY1017" fmla="*/ 6111736 h 6857967"/>
              <a:gd name="connsiteX1018" fmla="*/ 2980934 w 12191941"/>
              <a:gd name="connsiteY1018" fmla="*/ 6111736 h 6857967"/>
              <a:gd name="connsiteX1019" fmla="*/ 2980934 w 12191941"/>
              <a:gd name="connsiteY1019" fmla="*/ 6040435 h 6857967"/>
              <a:gd name="connsiteX1020" fmla="*/ 2767033 w 12191941"/>
              <a:gd name="connsiteY1020" fmla="*/ 6040435 h 6857967"/>
              <a:gd name="connsiteX1021" fmla="*/ 2767033 w 12191941"/>
              <a:gd name="connsiteY1021" fmla="*/ 6111736 h 6857967"/>
              <a:gd name="connsiteX1022" fmla="*/ 2838334 w 12191941"/>
              <a:gd name="connsiteY1022" fmla="*/ 6111736 h 6857967"/>
              <a:gd name="connsiteX1023" fmla="*/ 2838334 w 12191941"/>
              <a:gd name="connsiteY1023" fmla="*/ 6040435 h 6857967"/>
              <a:gd name="connsiteX1024" fmla="*/ 2624361 w 12191941"/>
              <a:gd name="connsiteY1024" fmla="*/ 6040435 h 6857967"/>
              <a:gd name="connsiteX1025" fmla="*/ 2624361 w 12191941"/>
              <a:gd name="connsiteY1025" fmla="*/ 6111736 h 6857967"/>
              <a:gd name="connsiteX1026" fmla="*/ 2695662 w 12191941"/>
              <a:gd name="connsiteY1026" fmla="*/ 6111736 h 6857967"/>
              <a:gd name="connsiteX1027" fmla="*/ 2695662 w 12191941"/>
              <a:gd name="connsiteY1027" fmla="*/ 6040435 h 6857967"/>
              <a:gd name="connsiteX1028" fmla="*/ 2481690 w 12191941"/>
              <a:gd name="connsiteY1028" fmla="*/ 6040435 h 6857967"/>
              <a:gd name="connsiteX1029" fmla="*/ 2481690 w 12191941"/>
              <a:gd name="connsiteY1029" fmla="*/ 6111736 h 6857967"/>
              <a:gd name="connsiteX1030" fmla="*/ 2552991 w 12191941"/>
              <a:gd name="connsiteY1030" fmla="*/ 6111736 h 6857967"/>
              <a:gd name="connsiteX1031" fmla="*/ 2552991 w 12191941"/>
              <a:gd name="connsiteY1031" fmla="*/ 6040435 h 6857967"/>
              <a:gd name="connsiteX1032" fmla="*/ 2339091 w 12191941"/>
              <a:gd name="connsiteY1032" fmla="*/ 6040435 h 6857967"/>
              <a:gd name="connsiteX1033" fmla="*/ 2339091 w 12191941"/>
              <a:gd name="connsiteY1033" fmla="*/ 6111736 h 6857967"/>
              <a:gd name="connsiteX1034" fmla="*/ 2410392 w 12191941"/>
              <a:gd name="connsiteY1034" fmla="*/ 6111736 h 6857967"/>
              <a:gd name="connsiteX1035" fmla="*/ 2410392 w 12191941"/>
              <a:gd name="connsiteY1035" fmla="*/ 6040435 h 6857967"/>
              <a:gd name="connsiteX1036" fmla="*/ 2196420 w 12191941"/>
              <a:gd name="connsiteY1036" fmla="*/ 6040435 h 6857967"/>
              <a:gd name="connsiteX1037" fmla="*/ 2196420 w 12191941"/>
              <a:gd name="connsiteY1037" fmla="*/ 6111736 h 6857967"/>
              <a:gd name="connsiteX1038" fmla="*/ 2267721 w 12191941"/>
              <a:gd name="connsiteY1038" fmla="*/ 6111736 h 6857967"/>
              <a:gd name="connsiteX1039" fmla="*/ 2267721 w 12191941"/>
              <a:gd name="connsiteY1039" fmla="*/ 6040435 h 6857967"/>
              <a:gd name="connsiteX1040" fmla="*/ 2053813 w 12191941"/>
              <a:gd name="connsiteY1040" fmla="*/ 6040435 h 6857967"/>
              <a:gd name="connsiteX1041" fmla="*/ 2053813 w 12191941"/>
              <a:gd name="connsiteY1041" fmla="*/ 6111736 h 6857967"/>
              <a:gd name="connsiteX1042" fmla="*/ 2125117 w 12191941"/>
              <a:gd name="connsiteY1042" fmla="*/ 6111736 h 6857967"/>
              <a:gd name="connsiteX1043" fmla="*/ 2125117 w 12191941"/>
              <a:gd name="connsiteY1043" fmla="*/ 6040435 h 6857967"/>
              <a:gd name="connsiteX1044" fmla="*/ 1911141 w 12191941"/>
              <a:gd name="connsiteY1044" fmla="*/ 6040435 h 6857967"/>
              <a:gd name="connsiteX1045" fmla="*/ 1911141 w 12191941"/>
              <a:gd name="connsiteY1045" fmla="*/ 6111736 h 6857967"/>
              <a:gd name="connsiteX1046" fmla="*/ 1982442 w 12191941"/>
              <a:gd name="connsiteY1046" fmla="*/ 6111736 h 6857967"/>
              <a:gd name="connsiteX1047" fmla="*/ 1982442 w 12191941"/>
              <a:gd name="connsiteY1047" fmla="*/ 6040435 h 6857967"/>
              <a:gd name="connsiteX1048" fmla="*/ 1768471 w 12191941"/>
              <a:gd name="connsiteY1048" fmla="*/ 6040435 h 6857967"/>
              <a:gd name="connsiteX1049" fmla="*/ 1768471 w 12191941"/>
              <a:gd name="connsiteY1049" fmla="*/ 6111736 h 6857967"/>
              <a:gd name="connsiteX1050" fmla="*/ 1839771 w 12191941"/>
              <a:gd name="connsiteY1050" fmla="*/ 6111736 h 6857967"/>
              <a:gd name="connsiteX1051" fmla="*/ 1839771 w 12191941"/>
              <a:gd name="connsiteY1051" fmla="*/ 6040435 h 6857967"/>
              <a:gd name="connsiteX1052" fmla="*/ 1625870 w 12191941"/>
              <a:gd name="connsiteY1052" fmla="*/ 6040435 h 6857967"/>
              <a:gd name="connsiteX1053" fmla="*/ 1625870 w 12191941"/>
              <a:gd name="connsiteY1053" fmla="*/ 6111736 h 6857967"/>
              <a:gd name="connsiteX1054" fmla="*/ 1697171 w 12191941"/>
              <a:gd name="connsiteY1054" fmla="*/ 6111736 h 6857967"/>
              <a:gd name="connsiteX1055" fmla="*/ 1697171 w 12191941"/>
              <a:gd name="connsiteY1055" fmla="*/ 6040435 h 6857967"/>
              <a:gd name="connsiteX1056" fmla="*/ 1483200 w 12191941"/>
              <a:gd name="connsiteY1056" fmla="*/ 6040435 h 6857967"/>
              <a:gd name="connsiteX1057" fmla="*/ 1483200 w 12191941"/>
              <a:gd name="connsiteY1057" fmla="*/ 6111736 h 6857967"/>
              <a:gd name="connsiteX1058" fmla="*/ 1554500 w 12191941"/>
              <a:gd name="connsiteY1058" fmla="*/ 6111736 h 6857967"/>
              <a:gd name="connsiteX1059" fmla="*/ 1554500 w 12191941"/>
              <a:gd name="connsiteY1059" fmla="*/ 6040435 h 6857967"/>
              <a:gd name="connsiteX1060" fmla="*/ 1340599 w 12191941"/>
              <a:gd name="connsiteY1060" fmla="*/ 6040435 h 6857967"/>
              <a:gd name="connsiteX1061" fmla="*/ 1340599 w 12191941"/>
              <a:gd name="connsiteY1061" fmla="*/ 6111736 h 6857967"/>
              <a:gd name="connsiteX1062" fmla="*/ 1411901 w 12191941"/>
              <a:gd name="connsiteY1062" fmla="*/ 6111736 h 6857967"/>
              <a:gd name="connsiteX1063" fmla="*/ 1411901 w 12191941"/>
              <a:gd name="connsiteY1063" fmla="*/ 6040435 h 6857967"/>
              <a:gd name="connsiteX1064" fmla="*/ 1197930 w 12191941"/>
              <a:gd name="connsiteY1064" fmla="*/ 6040435 h 6857967"/>
              <a:gd name="connsiteX1065" fmla="*/ 1197930 w 12191941"/>
              <a:gd name="connsiteY1065" fmla="*/ 6111736 h 6857967"/>
              <a:gd name="connsiteX1066" fmla="*/ 1269231 w 12191941"/>
              <a:gd name="connsiteY1066" fmla="*/ 6111736 h 6857967"/>
              <a:gd name="connsiteX1067" fmla="*/ 1269231 w 12191941"/>
              <a:gd name="connsiteY1067" fmla="*/ 6040435 h 6857967"/>
              <a:gd name="connsiteX1068" fmla="*/ 1055312 w 12191941"/>
              <a:gd name="connsiteY1068" fmla="*/ 6040435 h 6857967"/>
              <a:gd name="connsiteX1069" fmla="*/ 1055312 w 12191941"/>
              <a:gd name="connsiteY1069" fmla="*/ 6111736 h 6857967"/>
              <a:gd name="connsiteX1070" fmla="*/ 1126613 w 12191941"/>
              <a:gd name="connsiteY1070" fmla="*/ 6111736 h 6857967"/>
              <a:gd name="connsiteX1071" fmla="*/ 1126613 w 12191941"/>
              <a:gd name="connsiteY1071" fmla="*/ 6040435 h 6857967"/>
              <a:gd name="connsiteX1072" fmla="*/ 912657 w 12191941"/>
              <a:gd name="connsiteY1072" fmla="*/ 6040435 h 6857967"/>
              <a:gd name="connsiteX1073" fmla="*/ 912657 w 12191941"/>
              <a:gd name="connsiteY1073" fmla="*/ 6111736 h 6857967"/>
              <a:gd name="connsiteX1074" fmla="*/ 983958 w 12191941"/>
              <a:gd name="connsiteY1074" fmla="*/ 6111736 h 6857967"/>
              <a:gd name="connsiteX1075" fmla="*/ 983958 w 12191941"/>
              <a:gd name="connsiteY1075" fmla="*/ 6040435 h 6857967"/>
              <a:gd name="connsiteX1076" fmla="*/ 771136 w 12191941"/>
              <a:gd name="connsiteY1076" fmla="*/ 6040435 h 6857967"/>
              <a:gd name="connsiteX1077" fmla="*/ 771136 w 12191941"/>
              <a:gd name="connsiteY1077" fmla="*/ 6111736 h 6857967"/>
              <a:gd name="connsiteX1078" fmla="*/ 842437 w 12191941"/>
              <a:gd name="connsiteY1078" fmla="*/ 6111736 h 6857967"/>
              <a:gd name="connsiteX1079" fmla="*/ 842437 w 12191941"/>
              <a:gd name="connsiteY1079" fmla="*/ 6040435 h 6857967"/>
              <a:gd name="connsiteX1080" fmla="*/ 628535 w 12191941"/>
              <a:gd name="connsiteY1080" fmla="*/ 6040435 h 6857967"/>
              <a:gd name="connsiteX1081" fmla="*/ 628535 w 12191941"/>
              <a:gd name="connsiteY1081" fmla="*/ 6111736 h 6857967"/>
              <a:gd name="connsiteX1082" fmla="*/ 699836 w 12191941"/>
              <a:gd name="connsiteY1082" fmla="*/ 6111736 h 6857967"/>
              <a:gd name="connsiteX1083" fmla="*/ 699836 w 12191941"/>
              <a:gd name="connsiteY1083" fmla="*/ 6040435 h 6857967"/>
              <a:gd name="connsiteX1084" fmla="*/ 485863 w 12191941"/>
              <a:gd name="connsiteY1084" fmla="*/ 6040435 h 6857967"/>
              <a:gd name="connsiteX1085" fmla="*/ 485863 w 12191941"/>
              <a:gd name="connsiteY1085" fmla="*/ 6111736 h 6857967"/>
              <a:gd name="connsiteX1086" fmla="*/ 557163 w 12191941"/>
              <a:gd name="connsiteY1086" fmla="*/ 6111736 h 6857967"/>
              <a:gd name="connsiteX1087" fmla="*/ 557163 w 12191941"/>
              <a:gd name="connsiteY1087" fmla="*/ 6040435 h 6857967"/>
              <a:gd name="connsiteX1088" fmla="*/ 343191 w 12191941"/>
              <a:gd name="connsiteY1088" fmla="*/ 6040435 h 6857967"/>
              <a:gd name="connsiteX1089" fmla="*/ 343191 w 12191941"/>
              <a:gd name="connsiteY1089" fmla="*/ 6111736 h 6857967"/>
              <a:gd name="connsiteX1090" fmla="*/ 414492 w 12191941"/>
              <a:gd name="connsiteY1090" fmla="*/ 6111736 h 6857967"/>
              <a:gd name="connsiteX1091" fmla="*/ 414492 w 12191941"/>
              <a:gd name="connsiteY1091" fmla="*/ 6040435 h 6857967"/>
              <a:gd name="connsiteX1092" fmla="*/ 200591 w 12191941"/>
              <a:gd name="connsiteY1092" fmla="*/ 6040435 h 6857967"/>
              <a:gd name="connsiteX1093" fmla="*/ 200591 w 12191941"/>
              <a:gd name="connsiteY1093" fmla="*/ 6111736 h 6857967"/>
              <a:gd name="connsiteX1094" fmla="*/ 271892 w 12191941"/>
              <a:gd name="connsiteY1094" fmla="*/ 6111736 h 6857967"/>
              <a:gd name="connsiteX1095" fmla="*/ 271892 w 12191941"/>
              <a:gd name="connsiteY1095" fmla="*/ 6040435 h 6857967"/>
              <a:gd name="connsiteX1096" fmla="*/ 57918 w 12191941"/>
              <a:gd name="connsiteY1096" fmla="*/ 6040435 h 6857967"/>
              <a:gd name="connsiteX1097" fmla="*/ 57918 w 12191941"/>
              <a:gd name="connsiteY1097" fmla="*/ 6111736 h 6857967"/>
              <a:gd name="connsiteX1098" fmla="*/ 129219 w 12191941"/>
              <a:gd name="connsiteY1098" fmla="*/ 6111736 h 6857967"/>
              <a:gd name="connsiteX1099" fmla="*/ 129219 w 12191941"/>
              <a:gd name="connsiteY1099" fmla="*/ 6040435 h 6857967"/>
              <a:gd name="connsiteX1100" fmla="*/ 0 w 12191941"/>
              <a:gd name="connsiteY1100" fmla="*/ 0 h 6857967"/>
              <a:gd name="connsiteX1101" fmla="*/ 12191941 w 12191941"/>
              <a:gd name="connsiteY1101" fmla="*/ 0 h 6857967"/>
              <a:gd name="connsiteX1102" fmla="*/ 12191941 w 12191941"/>
              <a:gd name="connsiteY1102" fmla="*/ 6857967 h 6857967"/>
              <a:gd name="connsiteX1103" fmla="*/ 0 w 12191941"/>
              <a:gd name="connsiteY1103" fmla="*/ 6857967 h 68579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  <a:cxn ang="0">
                <a:pos x="connsiteX229" y="connsiteY229"/>
              </a:cxn>
              <a:cxn ang="0">
                <a:pos x="connsiteX230" y="connsiteY230"/>
              </a:cxn>
              <a:cxn ang="0">
                <a:pos x="connsiteX231" y="connsiteY231"/>
              </a:cxn>
              <a:cxn ang="0">
                <a:pos x="connsiteX232" y="connsiteY232"/>
              </a:cxn>
              <a:cxn ang="0">
                <a:pos x="connsiteX233" y="connsiteY233"/>
              </a:cxn>
              <a:cxn ang="0">
                <a:pos x="connsiteX234" y="connsiteY234"/>
              </a:cxn>
              <a:cxn ang="0">
                <a:pos x="connsiteX235" y="connsiteY235"/>
              </a:cxn>
              <a:cxn ang="0">
                <a:pos x="connsiteX236" y="connsiteY236"/>
              </a:cxn>
              <a:cxn ang="0">
                <a:pos x="connsiteX237" y="connsiteY237"/>
              </a:cxn>
              <a:cxn ang="0">
                <a:pos x="connsiteX238" y="connsiteY238"/>
              </a:cxn>
              <a:cxn ang="0">
                <a:pos x="connsiteX239" y="connsiteY239"/>
              </a:cxn>
              <a:cxn ang="0">
                <a:pos x="connsiteX240" y="connsiteY240"/>
              </a:cxn>
              <a:cxn ang="0">
                <a:pos x="connsiteX241" y="connsiteY241"/>
              </a:cxn>
              <a:cxn ang="0">
                <a:pos x="connsiteX242" y="connsiteY242"/>
              </a:cxn>
              <a:cxn ang="0">
                <a:pos x="connsiteX243" y="connsiteY243"/>
              </a:cxn>
              <a:cxn ang="0">
                <a:pos x="connsiteX244" y="connsiteY244"/>
              </a:cxn>
              <a:cxn ang="0">
                <a:pos x="connsiteX245" y="connsiteY245"/>
              </a:cxn>
              <a:cxn ang="0">
                <a:pos x="connsiteX246" y="connsiteY246"/>
              </a:cxn>
              <a:cxn ang="0">
                <a:pos x="connsiteX247" y="connsiteY247"/>
              </a:cxn>
              <a:cxn ang="0">
                <a:pos x="connsiteX248" y="connsiteY248"/>
              </a:cxn>
              <a:cxn ang="0">
                <a:pos x="connsiteX249" y="connsiteY249"/>
              </a:cxn>
              <a:cxn ang="0">
                <a:pos x="connsiteX250" y="connsiteY250"/>
              </a:cxn>
              <a:cxn ang="0">
                <a:pos x="connsiteX251" y="connsiteY251"/>
              </a:cxn>
              <a:cxn ang="0">
                <a:pos x="connsiteX252" y="connsiteY252"/>
              </a:cxn>
              <a:cxn ang="0">
                <a:pos x="connsiteX253" y="connsiteY253"/>
              </a:cxn>
              <a:cxn ang="0">
                <a:pos x="connsiteX254" y="connsiteY254"/>
              </a:cxn>
              <a:cxn ang="0">
                <a:pos x="connsiteX255" y="connsiteY255"/>
              </a:cxn>
              <a:cxn ang="0">
                <a:pos x="connsiteX256" y="connsiteY256"/>
              </a:cxn>
              <a:cxn ang="0">
                <a:pos x="connsiteX257" y="connsiteY257"/>
              </a:cxn>
              <a:cxn ang="0">
                <a:pos x="connsiteX258" y="connsiteY258"/>
              </a:cxn>
              <a:cxn ang="0">
                <a:pos x="connsiteX259" y="connsiteY259"/>
              </a:cxn>
              <a:cxn ang="0">
                <a:pos x="connsiteX260" y="connsiteY260"/>
              </a:cxn>
              <a:cxn ang="0">
                <a:pos x="connsiteX261" y="connsiteY261"/>
              </a:cxn>
              <a:cxn ang="0">
                <a:pos x="connsiteX262" y="connsiteY262"/>
              </a:cxn>
              <a:cxn ang="0">
                <a:pos x="connsiteX263" y="connsiteY263"/>
              </a:cxn>
              <a:cxn ang="0">
                <a:pos x="connsiteX264" y="connsiteY264"/>
              </a:cxn>
              <a:cxn ang="0">
                <a:pos x="connsiteX265" y="connsiteY265"/>
              </a:cxn>
              <a:cxn ang="0">
                <a:pos x="connsiteX266" y="connsiteY266"/>
              </a:cxn>
              <a:cxn ang="0">
                <a:pos x="connsiteX267" y="connsiteY267"/>
              </a:cxn>
              <a:cxn ang="0">
                <a:pos x="connsiteX268" y="connsiteY268"/>
              </a:cxn>
              <a:cxn ang="0">
                <a:pos x="connsiteX269" y="connsiteY269"/>
              </a:cxn>
              <a:cxn ang="0">
                <a:pos x="connsiteX270" y="connsiteY270"/>
              </a:cxn>
              <a:cxn ang="0">
                <a:pos x="connsiteX271" y="connsiteY271"/>
              </a:cxn>
              <a:cxn ang="0">
                <a:pos x="connsiteX272" y="connsiteY272"/>
              </a:cxn>
              <a:cxn ang="0">
                <a:pos x="connsiteX273" y="connsiteY273"/>
              </a:cxn>
              <a:cxn ang="0">
                <a:pos x="connsiteX274" y="connsiteY274"/>
              </a:cxn>
              <a:cxn ang="0">
                <a:pos x="connsiteX275" y="connsiteY275"/>
              </a:cxn>
              <a:cxn ang="0">
                <a:pos x="connsiteX276" y="connsiteY276"/>
              </a:cxn>
              <a:cxn ang="0">
                <a:pos x="connsiteX277" y="connsiteY277"/>
              </a:cxn>
              <a:cxn ang="0">
                <a:pos x="connsiteX278" y="connsiteY278"/>
              </a:cxn>
              <a:cxn ang="0">
                <a:pos x="connsiteX279" y="connsiteY279"/>
              </a:cxn>
              <a:cxn ang="0">
                <a:pos x="connsiteX280" y="connsiteY280"/>
              </a:cxn>
              <a:cxn ang="0">
                <a:pos x="connsiteX281" y="connsiteY281"/>
              </a:cxn>
              <a:cxn ang="0">
                <a:pos x="connsiteX282" y="connsiteY282"/>
              </a:cxn>
              <a:cxn ang="0">
                <a:pos x="connsiteX283" y="connsiteY283"/>
              </a:cxn>
              <a:cxn ang="0">
                <a:pos x="connsiteX284" y="connsiteY284"/>
              </a:cxn>
              <a:cxn ang="0">
                <a:pos x="connsiteX285" y="connsiteY285"/>
              </a:cxn>
              <a:cxn ang="0">
                <a:pos x="connsiteX286" y="connsiteY286"/>
              </a:cxn>
              <a:cxn ang="0">
                <a:pos x="connsiteX287" y="connsiteY287"/>
              </a:cxn>
              <a:cxn ang="0">
                <a:pos x="connsiteX288" y="connsiteY288"/>
              </a:cxn>
              <a:cxn ang="0">
                <a:pos x="connsiteX289" y="connsiteY289"/>
              </a:cxn>
              <a:cxn ang="0">
                <a:pos x="connsiteX290" y="connsiteY290"/>
              </a:cxn>
              <a:cxn ang="0">
                <a:pos x="connsiteX291" y="connsiteY291"/>
              </a:cxn>
              <a:cxn ang="0">
                <a:pos x="connsiteX292" y="connsiteY292"/>
              </a:cxn>
              <a:cxn ang="0">
                <a:pos x="connsiteX293" y="connsiteY293"/>
              </a:cxn>
              <a:cxn ang="0">
                <a:pos x="connsiteX294" y="connsiteY294"/>
              </a:cxn>
              <a:cxn ang="0">
                <a:pos x="connsiteX295" y="connsiteY295"/>
              </a:cxn>
              <a:cxn ang="0">
                <a:pos x="connsiteX296" y="connsiteY296"/>
              </a:cxn>
              <a:cxn ang="0">
                <a:pos x="connsiteX297" y="connsiteY297"/>
              </a:cxn>
              <a:cxn ang="0">
                <a:pos x="connsiteX298" y="connsiteY298"/>
              </a:cxn>
              <a:cxn ang="0">
                <a:pos x="connsiteX299" y="connsiteY299"/>
              </a:cxn>
              <a:cxn ang="0">
                <a:pos x="connsiteX300" y="connsiteY300"/>
              </a:cxn>
              <a:cxn ang="0">
                <a:pos x="connsiteX301" y="connsiteY301"/>
              </a:cxn>
              <a:cxn ang="0">
                <a:pos x="connsiteX302" y="connsiteY302"/>
              </a:cxn>
              <a:cxn ang="0">
                <a:pos x="connsiteX303" y="connsiteY303"/>
              </a:cxn>
              <a:cxn ang="0">
                <a:pos x="connsiteX304" y="connsiteY304"/>
              </a:cxn>
              <a:cxn ang="0">
                <a:pos x="connsiteX305" y="connsiteY305"/>
              </a:cxn>
              <a:cxn ang="0">
                <a:pos x="connsiteX306" y="connsiteY306"/>
              </a:cxn>
              <a:cxn ang="0">
                <a:pos x="connsiteX307" y="connsiteY307"/>
              </a:cxn>
              <a:cxn ang="0">
                <a:pos x="connsiteX308" y="connsiteY308"/>
              </a:cxn>
              <a:cxn ang="0">
                <a:pos x="connsiteX309" y="connsiteY309"/>
              </a:cxn>
              <a:cxn ang="0">
                <a:pos x="connsiteX310" y="connsiteY310"/>
              </a:cxn>
              <a:cxn ang="0">
                <a:pos x="connsiteX311" y="connsiteY311"/>
              </a:cxn>
              <a:cxn ang="0">
                <a:pos x="connsiteX312" y="connsiteY312"/>
              </a:cxn>
              <a:cxn ang="0">
                <a:pos x="connsiteX313" y="connsiteY313"/>
              </a:cxn>
              <a:cxn ang="0">
                <a:pos x="connsiteX314" y="connsiteY314"/>
              </a:cxn>
              <a:cxn ang="0">
                <a:pos x="connsiteX315" y="connsiteY315"/>
              </a:cxn>
              <a:cxn ang="0">
                <a:pos x="connsiteX316" y="connsiteY316"/>
              </a:cxn>
              <a:cxn ang="0">
                <a:pos x="connsiteX317" y="connsiteY317"/>
              </a:cxn>
              <a:cxn ang="0">
                <a:pos x="connsiteX318" y="connsiteY318"/>
              </a:cxn>
              <a:cxn ang="0">
                <a:pos x="connsiteX319" y="connsiteY319"/>
              </a:cxn>
              <a:cxn ang="0">
                <a:pos x="connsiteX320" y="connsiteY320"/>
              </a:cxn>
              <a:cxn ang="0">
                <a:pos x="connsiteX321" y="connsiteY321"/>
              </a:cxn>
              <a:cxn ang="0">
                <a:pos x="connsiteX322" y="connsiteY322"/>
              </a:cxn>
              <a:cxn ang="0">
                <a:pos x="connsiteX323" y="connsiteY323"/>
              </a:cxn>
              <a:cxn ang="0">
                <a:pos x="connsiteX324" y="connsiteY324"/>
              </a:cxn>
              <a:cxn ang="0">
                <a:pos x="connsiteX325" y="connsiteY325"/>
              </a:cxn>
              <a:cxn ang="0">
                <a:pos x="connsiteX326" y="connsiteY326"/>
              </a:cxn>
              <a:cxn ang="0">
                <a:pos x="connsiteX327" y="connsiteY327"/>
              </a:cxn>
              <a:cxn ang="0">
                <a:pos x="connsiteX328" y="connsiteY328"/>
              </a:cxn>
              <a:cxn ang="0">
                <a:pos x="connsiteX329" y="connsiteY329"/>
              </a:cxn>
              <a:cxn ang="0">
                <a:pos x="connsiteX330" y="connsiteY330"/>
              </a:cxn>
              <a:cxn ang="0">
                <a:pos x="connsiteX331" y="connsiteY331"/>
              </a:cxn>
              <a:cxn ang="0">
                <a:pos x="connsiteX332" y="connsiteY332"/>
              </a:cxn>
              <a:cxn ang="0">
                <a:pos x="connsiteX333" y="connsiteY333"/>
              </a:cxn>
              <a:cxn ang="0">
                <a:pos x="connsiteX334" y="connsiteY334"/>
              </a:cxn>
              <a:cxn ang="0">
                <a:pos x="connsiteX335" y="connsiteY335"/>
              </a:cxn>
              <a:cxn ang="0">
                <a:pos x="connsiteX336" y="connsiteY336"/>
              </a:cxn>
              <a:cxn ang="0">
                <a:pos x="connsiteX337" y="connsiteY337"/>
              </a:cxn>
              <a:cxn ang="0">
                <a:pos x="connsiteX338" y="connsiteY338"/>
              </a:cxn>
              <a:cxn ang="0">
                <a:pos x="connsiteX339" y="connsiteY339"/>
              </a:cxn>
              <a:cxn ang="0">
                <a:pos x="connsiteX340" y="connsiteY340"/>
              </a:cxn>
              <a:cxn ang="0">
                <a:pos x="connsiteX341" y="connsiteY341"/>
              </a:cxn>
              <a:cxn ang="0">
                <a:pos x="connsiteX342" y="connsiteY342"/>
              </a:cxn>
              <a:cxn ang="0">
                <a:pos x="connsiteX343" y="connsiteY343"/>
              </a:cxn>
              <a:cxn ang="0">
                <a:pos x="connsiteX344" y="connsiteY344"/>
              </a:cxn>
              <a:cxn ang="0">
                <a:pos x="connsiteX345" y="connsiteY345"/>
              </a:cxn>
              <a:cxn ang="0">
                <a:pos x="connsiteX346" y="connsiteY346"/>
              </a:cxn>
              <a:cxn ang="0">
                <a:pos x="connsiteX347" y="connsiteY347"/>
              </a:cxn>
              <a:cxn ang="0">
                <a:pos x="connsiteX348" y="connsiteY348"/>
              </a:cxn>
              <a:cxn ang="0">
                <a:pos x="connsiteX349" y="connsiteY349"/>
              </a:cxn>
              <a:cxn ang="0">
                <a:pos x="connsiteX350" y="connsiteY350"/>
              </a:cxn>
              <a:cxn ang="0">
                <a:pos x="connsiteX351" y="connsiteY351"/>
              </a:cxn>
              <a:cxn ang="0">
                <a:pos x="connsiteX352" y="connsiteY352"/>
              </a:cxn>
              <a:cxn ang="0">
                <a:pos x="connsiteX353" y="connsiteY353"/>
              </a:cxn>
              <a:cxn ang="0">
                <a:pos x="connsiteX354" y="connsiteY354"/>
              </a:cxn>
              <a:cxn ang="0">
                <a:pos x="connsiteX355" y="connsiteY355"/>
              </a:cxn>
              <a:cxn ang="0">
                <a:pos x="connsiteX356" y="connsiteY356"/>
              </a:cxn>
              <a:cxn ang="0">
                <a:pos x="connsiteX357" y="connsiteY357"/>
              </a:cxn>
              <a:cxn ang="0">
                <a:pos x="connsiteX358" y="connsiteY358"/>
              </a:cxn>
              <a:cxn ang="0">
                <a:pos x="connsiteX359" y="connsiteY359"/>
              </a:cxn>
              <a:cxn ang="0">
                <a:pos x="connsiteX360" y="connsiteY360"/>
              </a:cxn>
              <a:cxn ang="0">
                <a:pos x="connsiteX361" y="connsiteY361"/>
              </a:cxn>
              <a:cxn ang="0">
                <a:pos x="connsiteX362" y="connsiteY362"/>
              </a:cxn>
              <a:cxn ang="0">
                <a:pos x="connsiteX363" y="connsiteY363"/>
              </a:cxn>
              <a:cxn ang="0">
                <a:pos x="connsiteX364" y="connsiteY364"/>
              </a:cxn>
              <a:cxn ang="0">
                <a:pos x="connsiteX365" y="connsiteY365"/>
              </a:cxn>
              <a:cxn ang="0">
                <a:pos x="connsiteX366" y="connsiteY366"/>
              </a:cxn>
              <a:cxn ang="0">
                <a:pos x="connsiteX367" y="connsiteY367"/>
              </a:cxn>
              <a:cxn ang="0">
                <a:pos x="connsiteX368" y="connsiteY368"/>
              </a:cxn>
              <a:cxn ang="0">
                <a:pos x="connsiteX369" y="connsiteY369"/>
              </a:cxn>
              <a:cxn ang="0">
                <a:pos x="connsiteX370" y="connsiteY370"/>
              </a:cxn>
              <a:cxn ang="0">
                <a:pos x="connsiteX371" y="connsiteY371"/>
              </a:cxn>
              <a:cxn ang="0">
                <a:pos x="connsiteX372" y="connsiteY372"/>
              </a:cxn>
              <a:cxn ang="0">
                <a:pos x="connsiteX373" y="connsiteY373"/>
              </a:cxn>
              <a:cxn ang="0">
                <a:pos x="connsiteX374" y="connsiteY374"/>
              </a:cxn>
              <a:cxn ang="0">
                <a:pos x="connsiteX375" y="connsiteY375"/>
              </a:cxn>
              <a:cxn ang="0">
                <a:pos x="connsiteX376" y="connsiteY376"/>
              </a:cxn>
              <a:cxn ang="0">
                <a:pos x="connsiteX377" y="connsiteY377"/>
              </a:cxn>
              <a:cxn ang="0">
                <a:pos x="connsiteX378" y="connsiteY378"/>
              </a:cxn>
              <a:cxn ang="0">
                <a:pos x="connsiteX379" y="connsiteY379"/>
              </a:cxn>
              <a:cxn ang="0">
                <a:pos x="connsiteX380" y="connsiteY380"/>
              </a:cxn>
              <a:cxn ang="0">
                <a:pos x="connsiteX381" y="connsiteY381"/>
              </a:cxn>
              <a:cxn ang="0">
                <a:pos x="connsiteX382" y="connsiteY382"/>
              </a:cxn>
              <a:cxn ang="0">
                <a:pos x="connsiteX383" y="connsiteY383"/>
              </a:cxn>
              <a:cxn ang="0">
                <a:pos x="connsiteX384" y="connsiteY384"/>
              </a:cxn>
              <a:cxn ang="0">
                <a:pos x="connsiteX385" y="connsiteY385"/>
              </a:cxn>
              <a:cxn ang="0">
                <a:pos x="connsiteX386" y="connsiteY386"/>
              </a:cxn>
              <a:cxn ang="0">
                <a:pos x="connsiteX387" y="connsiteY387"/>
              </a:cxn>
              <a:cxn ang="0">
                <a:pos x="connsiteX388" y="connsiteY388"/>
              </a:cxn>
              <a:cxn ang="0">
                <a:pos x="connsiteX389" y="connsiteY389"/>
              </a:cxn>
              <a:cxn ang="0">
                <a:pos x="connsiteX390" y="connsiteY390"/>
              </a:cxn>
              <a:cxn ang="0">
                <a:pos x="connsiteX391" y="connsiteY391"/>
              </a:cxn>
              <a:cxn ang="0">
                <a:pos x="connsiteX392" y="connsiteY392"/>
              </a:cxn>
              <a:cxn ang="0">
                <a:pos x="connsiteX393" y="connsiteY393"/>
              </a:cxn>
              <a:cxn ang="0">
                <a:pos x="connsiteX394" y="connsiteY394"/>
              </a:cxn>
              <a:cxn ang="0">
                <a:pos x="connsiteX395" y="connsiteY395"/>
              </a:cxn>
              <a:cxn ang="0">
                <a:pos x="connsiteX396" y="connsiteY396"/>
              </a:cxn>
              <a:cxn ang="0">
                <a:pos x="connsiteX397" y="connsiteY397"/>
              </a:cxn>
              <a:cxn ang="0">
                <a:pos x="connsiteX398" y="connsiteY398"/>
              </a:cxn>
              <a:cxn ang="0">
                <a:pos x="connsiteX399" y="connsiteY399"/>
              </a:cxn>
              <a:cxn ang="0">
                <a:pos x="connsiteX400" y="connsiteY400"/>
              </a:cxn>
              <a:cxn ang="0">
                <a:pos x="connsiteX401" y="connsiteY401"/>
              </a:cxn>
              <a:cxn ang="0">
                <a:pos x="connsiteX402" y="connsiteY402"/>
              </a:cxn>
              <a:cxn ang="0">
                <a:pos x="connsiteX403" y="connsiteY403"/>
              </a:cxn>
              <a:cxn ang="0">
                <a:pos x="connsiteX404" y="connsiteY404"/>
              </a:cxn>
              <a:cxn ang="0">
                <a:pos x="connsiteX405" y="connsiteY405"/>
              </a:cxn>
              <a:cxn ang="0">
                <a:pos x="connsiteX406" y="connsiteY406"/>
              </a:cxn>
              <a:cxn ang="0">
                <a:pos x="connsiteX407" y="connsiteY407"/>
              </a:cxn>
              <a:cxn ang="0">
                <a:pos x="connsiteX408" y="connsiteY408"/>
              </a:cxn>
              <a:cxn ang="0">
                <a:pos x="connsiteX409" y="connsiteY409"/>
              </a:cxn>
              <a:cxn ang="0">
                <a:pos x="connsiteX410" y="connsiteY410"/>
              </a:cxn>
              <a:cxn ang="0">
                <a:pos x="connsiteX411" y="connsiteY411"/>
              </a:cxn>
              <a:cxn ang="0">
                <a:pos x="connsiteX412" y="connsiteY412"/>
              </a:cxn>
              <a:cxn ang="0">
                <a:pos x="connsiteX413" y="connsiteY413"/>
              </a:cxn>
              <a:cxn ang="0">
                <a:pos x="connsiteX414" y="connsiteY414"/>
              </a:cxn>
              <a:cxn ang="0">
                <a:pos x="connsiteX415" y="connsiteY415"/>
              </a:cxn>
              <a:cxn ang="0">
                <a:pos x="connsiteX416" y="connsiteY416"/>
              </a:cxn>
              <a:cxn ang="0">
                <a:pos x="connsiteX417" y="connsiteY417"/>
              </a:cxn>
              <a:cxn ang="0">
                <a:pos x="connsiteX418" y="connsiteY418"/>
              </a:cxn>
              <a:cxn ang="0">
                <a:pos x="connsiteX419" y="connsiteY419"/>
              </a:cxn>
              <a:cxn ang="0">
                <a:pos x="connsiteX420" y="connsiteY420"/>
              </a:cxn>
              <a:cxn ang="0">
                <a:pos x="connsiteX421" y="connsiteY421"/>
              </a:cxn>
              <a:cxn ang="0">
                <a:pos x="connsiteX422" y="connsiteY422"/>
              </a:cxn>
              <a:cxn ang="0">
                <a:pos x="connsiteX423" y="connsiteY423"/>
              </a:cxn>
              <a:cxn ang="0">
                <a:pos x="connsiteX424" y="connsiteY424"/>
              </a:cxn>
              <a:cxn ang="0">
                <a:pos x="connsiteX425" y="connsiteY425"/>
              </a:cxn>
              <a:cxn ang="0">
                <a:pos x="connsiteX426" y="connsiteY426"/>
              </a:cxn>
              <a:cxn ang="0">
                <a:pos x="connsiteX427" y="connsiteY427"/>
              </a:cxn>
              <a:cxn ang="0">
                <a:pos x="connsiteX428" y="connsiteY428"/>
              </a:cxn>
              <a:cxn ang="0">
                <a:pos x="connsiteX429" y="connsiteY429"/>
              </a:cxn>
              <a:cxn ang="0">
                <a:pos x="connsiteX430" y="connsiteY430"/>
              </a:cxn>
              <a:cxn ang="0">
                <a:pos x="connsiteX431" y="connsiteY431"/>
              </a:cxn>
              <a:cxn ang="0">
                <a:pos x="connsiteX432" y="connsiteY432"/>
              </a:cxn>
              <a:cxn ang="0">
                <a:pos x="connsiteX433" y="connsiteY433"/>
              </a:cxn>
              <a:cxn ang="0">
                <a:pos x="connsiteX434" y="connsiteY434"/>
              </a:cxn>
              <a:cxn ang="0">
                <a:pos x="connsiteX435" y="connsiteY435"/>
              </a:cxn>
              <a:cxn ang="0">
                <a:pos x="connsiteX436" y="connsiteY436"/>
              </a:cxn>
              <a:cxn ang="0">
                <a:pos x="connsiteX437" y="connsiteY437"/>
              </a:cxn>
              <a:cxn ang="0">
                <a:pos x="connsiteX438" y="connsiteY438"/>
              </a:cxn>
              <a:cxn ang="0">
                <a:pos x="connsiteX439" y="connsiteY439"/>
              </a:cxn>
              <a:cxn ang="0">
                <a:pos x="connsiteX440" y="connsiteY440"/>
              </a:cxn>
              <a:cxn ang="0">
                <a:pos x="connsiteX441" y="connsiteY441"/>
              </a:cxn>
              <a:cxn ang="0">
                <a:pos x="connsiteX442" y="connsiteY442"/>
              </a:cxn>
              <a:cxn ang="0">
                <a:pos x="connsiteX443" y="connsiteY443"/>
              </a:cxn>
              <a:cxn ang="0">
                <a:pos x="connsiteX444" y="connsiteY444"/>
              </a:cxn>
              <a:cxn ang="0">
                <a:pos x="connsiteX445" y="connsiteY445"/>
              </a:cxn>
              <a:cxn ang="0">
                <a:pos x="connsiteX446" y="connsiteY446"/>
              </a:cxn>
              <a:cxn ang="0">
                <a:pos x="connsiteX447" y="connsiteY447"/>
              </a:cxn>
              <a:cxn ang="0">
                <a:pos x="connsiteX448" y="connsiteY448"/>
              </a:cxn>
              <a:cxn ang="0">
                <a:pos x="connsiteX449" y="connsiteY449"/>
              </a:cxn>
              <a:cxn ang="0">
                <a:pos x="connsiteX450" y="connsiteY450"/>
              </a:cxn>
              <a:cxn ang="0">
                <a:pos x="connsiteX451" y="connsiteY451"/>
              </a:cxn>
              <a:cxn ang="0">
                <a:pos x="connsiteX452" y="connsiteY452"/>
              </a:cxn>
              <a:cxn ang="0">
                <a:pos x="connsiteX453" y="connsiteY453"/>
              </a:cxn>
              <a:cxn ang="0">
                <a:pos x="connsiteX454" y="connsiteY454"/>
              </a:cxn>
              <a:cxn ang="0">
                <a:pos x="connsiteX455" y="connsiteY455"/>
              </a:cxn>
              <a:cxn ang="0">
                <a:pos x="connsiteX456" y="connsiteY456"/>
              </a:cxn>
              <a:cxn ang="0">
                <a:pos x="connsiteX457" y="connsiteY457"/>
              </a:cxn>
              <a:cxn ang="0">
                <a:pos x="connsiteX458" y="connsiteY458"/>
              </a:cxn>
              <a:cxn ang="0">
                <a:pos x="connsiteX459" y="connsiteY459"/>
              </a:cxn>
              <a:cxn ang="0">
                <a:pos x="connsiteX460" y="connsiteY460"/>
              </a:cxn>
              <a:cxn ang="0">
                <a:pos x="connsiteX461" y="connsiteY461"/>
              </a:cxn>
              <a:cxn ang="0">
                <a:pos x="connsiteX462" y="connsiteY462"/>
              </a:cxn>
              <a:cxn ang="0">
                <a:pos x="connsiteX463" y="connsiteY463"/>
              </a:cxn>
              <a:cxn ang="0">
                <a:pos x="connsiteX464" y="connsiteY464"/>
              </a:cxn>
              <a:cxn ang="0">
                <a:pos x="connsiteX465" y="connsiteY465"/>
              </a:cxn>
              <a:cxn ang="0">
                <a:pos x="connsiteX466" y="connsiteY466"/>
              </a:cxn>
              <a:cxn ang="0">
                <a:pos x="connsiteX467" y="connsiteY467"/>
              </a:cxn>
              <a:cxn ang="0">
                <a:pos x="connsiteX468" y="connsiteY468"/>
              </a:cxn>
              <a:cxn ang="0">
                <a:pos x="connsiteX469" y="connsiteY469"/>
              </a:cxn>
              <a:cxn ang="0">
                <a:pos x="connsiteX470" y="connsiteY470"/>
              </a:cxn>
              <a:cxn ang="0">
                <a:pos x="connsiteX471" y="connsiteY471"/>
              </a:cxn>
              <a:cxn ang="0">
                <a:pos x="connsiteX472" y="connsiteY472"/>
              </a:cxn>
              <a:cxn ang="0">
                <a:pos x="connsiteX473" y="connsiteY473"/>
              </a:cxn>
              <a:cxn ang="0">
                <a:pos x="connsiteX474" y="connsiteY474"/>
              </a:cxn>
              <a:cxn ang="0">
                <a:pos x="connsiteX475" y="connsiteY475"/>
              </a:cxn>
              <a:cxn ang="0">
                <a:pos x="connsiteX476" y="connsiteY476"/>
              </a:cxn>
              <a:cxn ang="0">
                <a:pos x="connsiteX477" y="connsiteY477"/>
              </a:cxn>
              <a:cxn ang="0">
                <a:pos x="connsiteX478" y="connsiteY478"/>
              </a:cxn>
              <a:cxn ang="0">
                <a:pos x="connsiteX479" y="connsiteY479"/>
              </a:cxn>
              <a:cxn ang="0">
                <a:pos x="connsiteX480" y="connsiteY480"/>
              </a:cxn>
              <a:cxn ang="0">
                <a:pos x="connsiteX481" y="connsiteY481"/>
              </a:cxn>
              <a:cxn ang="0">
                <a:pos x="connsiteX482" y="connsiteY482"/>
              </a:cxn>
              <a:cxn ang="0">
                <a:pos x="connsiteX483" y="connsiteY483"/>
              </a:cxn>
              <a:cxn ang="0">
                <a:pos x="connsiteX484" y="connsiteY484"/>
              </a:cxn>
              <a:cxn ang="0">
                <a:pos x="connsiteX485" y="connsiteY485"/>
              </a:cxn>
              <a:cxn ang="0">
                <a:pos x="connsiteX486" y="connsiteY486"/>
              </a:cxn>
              <a:cxn ang="0">
                <a:pos x="connsiteX487" y="connsiteY487"/>
              </a:cxn>
              <a:cxn ang="0">
                <a:pos x="connsiteX488" y="connsiteY488"/>
              </a:cxn>
              <a:cxn ang="0">
                <a:pos x="connsiteX489" y="connsiteY489"/>
              </a:cxn>
              <a:cxn ang="0">
                <a:pos x="connsiteX490" y="connsiteY490"/>
              </a:cxn>
              <a:cxn ang="0">
                <a:pos x="connsiteX491" y="connsiteY491"/>
              </a:cxn>
              <a:cxn ang="0">
                <a:pos x="connsiteX492" y="connsiteY492"/>
              </a:cxn>
              <a:cxn ang="0">
                <a:pos x="connsiteX493" y="connsiteY493"/>
              </a:cxn>
              <a:cxn ang="0">
                <a:pos x="connsiteX494" y="connsiteY494"/>
              </a:cxn>
              <a:cxn ang="0">
                <a:pos x="connsiteX495" y="connsiteY495"/>
              </a:cxn>
              <a:cxn ang="0">
                <a:pos x="connsiteX496" y="connsiteY496"/>
              </a:cxn>
              <a:cxn ang="0">
                <a:pos x="connsiteX497" y="connsiteY497"/>
              </a:cxn>
              <a:cxn ang="0">
                <a:pos x="connsiteX498" y="connsiteY498"/>
              </a:cxn>
              <a:cxn ang="0">
                <a:pos x="connsiteX499" y="connsiteY499"/>
              </a:cxn>
              <a:cxn ang="0">
                <a:pos x="connsiteX500" y="connsiteY500"/>
              </a:cxn>
              <a:cxn ang="0">
                <a:pos x="connsiteX501" y="connsiteY501"/>
              </a:cxn>
              <a:cxn ang="0">
                <a:pos x="connsiteX502" y="connsiteY502"/>
              </a:cxn>
              <a:cxn ang="0">
                <a:pos x="connsiteX503" y="connsiteY503"/>
              </a:cxn>
              <a:cxn ang="0">
                <a:pos x="connsiteX504" y="connsiteY504"/>
              </a:cxn>
              <a:cxn ang="0">
                <a:pos x="connsiteX505" y="connsiteY505"/>
              </a:cxn>
              <a:cxn ang="0">
                <a:pos x="connsiteX506" y="connsiteY506"/>
              </a:cxn>
              <a:cxn ang="0">
                <a:pos x="connsiteX507" y="connsiteY507"/>
              </a:cxn>
              <a:cxn ang="0">
                <a:pos x="connsiteX508" y="connsiteY508"/>
              </a:cxn>
              <a:cxn ang="0">
                <a:pos x="connsiteX509" y="connsiteY509"/>
              </a:cxn>
              <a:cxn ang="0">
                <a:pos x="connsiteX510" y="connsiteY510"/>
              </a:cxn>
              <a:cxn ang="0">
                <a:pos x="connsiteX511" y="connsiteY511"/>
              </a:cxn>
              <a:cxn ang="0">
                <a:pos x="connsiteX512" y="connsiteY512"/>
              </a:cxn>
              <a:cxn ang="0">
                <a:pos x="connsiteX513" y="connsiteY513"/>
              </a:cxn>
              <a:cxn ang="0">
                <a:pos x="connsiteX514" y="connsiteY514"/>
              </a:cxn>
              <a:cxn ang="0">
                <a:pos x="connsiteX515" y="connsiteY515"/>
              </a:cxn>
              <a:cxn ang="0">
                <a:pos x="connsiteX516" y="connsiteY516"/>
              </a:cxn>
              <a:cxn ang="0">
                <a:pos x="connsiteX517" y="connsiteY517"/>
              </a:cxn>
              <a:cxn ang="0">
                <a:pos x="connsiteX518" y="connsiteY518"/>
              </a:cxn>
              <a:cxn ang="0">
                <a:pos x="connsiteX519" y="connsiteY519"/>
              </a:cxn>
              <a:cxn ang="0">
                <a:pos x="connsiteX520" y="connsiteY520"/>
              </a:cxn>
              <a:cxn ang="0">
                <a:pos x="connsiteX521" y="connsiteY521"/>
              </a:cxn>
              <a:cxn ang="0">
                <a:pos x="connsiteX522" y="connsiteY522"/>
              </a:cxn>
              <a:cxn ang="0">
                <a:pos x="connsiteX523" y="connsiteY523"/>
              </a:cxn>
              <a:cxn ang="0">
                <a:pos x="connsiteX524" y="connsiteY524"/>
              </a:cxn>
              <a:cxn ang="0">
                <a:pos x="connsiteX525" y="connsiteY525"/>
              </a:cxn>
              <a:cxn ang="0">
                <a:pos x="connsiteX526" y="connsiteY526"/>
              </a:cxn>
              <a:cxn ang="0">
                <a:pos x="connsiteX527" y="connsiteY527"/>
              </a:cxn>
              <a:cxn ang="0">
                <a:pos x="connsiteX528" y="connsiteY528"/>
              </a:cxn>
              <a:cxn ang="0">
                <a:pos x="connsiteX529" y="connsiteY529"/>
              </a:cxn>
              <a:cxn ang="0">
                <a:pos x="connsiteX530" y="connsiteY530"/>
              </a:cxn>
              <a:cxn ang="0">
                <a:pos x="connsiteX531" y="connsiteY531"/>
              </a:cxn>
              <a:cxn ang="0">
                <a:pos x="connsiteX532" y="connsiteY532"/>
              </a:cxn>
              <a:cxn ang="0">
                <a:pos x="connsiteX533" y="connsiteY533"/>
              </a:cxn>
              <a:cxn ang="0">
                <a:pos x="connsiteX534" y="connsiteY534"/>
              </a:cxn>
              <a:cxn ang="0">
                <a:pos x="connsiteX535" y="connsiteY535"/>
              </a:cxn>
              <a:cxn ang="0">
                <a:pos x="connsiteX536" y="connsiteY536"/>
              </a:cxn>
              <a:cxn ang="0">
                <a:pos x="connsiteX537" y="connsiteY537"/>
              </a:cxn>
              <a:cxn ang="0">
                <a:pos x="connsiteX538" y="connsiteY538"/>
              </a:cxn>
              <a:cxn ang="0">
                <a:pos x="connsiteX539" y="connsiteY539"/>
              </a:cxn>
              <a:cxn ang="0">
                <a:pos x="connsiteX540" y="connsiteY540"/>
              </a:cxn>
              <a:cxn ang="0">
                <a:pos x="connsiteX541" y="connsiteY541"/>
              </a:cxn>
              <a:cxn ang="0">
                <a:pos x="connsiteX542" y="connsiteY542"/>
              </a:cxn>
              <a:cxn ang="0">
                <a:pos x="connsiteX543" y="connsiteY543"/>
              </a:cxn>
              <a:cxn ang="0">
                <a:pos x="connsiteX544" y="connsiteY544"/>
              </a:cxn>
              <a:cxn ang="0">
                <a:pos x="connsiteX545" y="connsiteY545"/>
              </a:cxn>
              <a:cxn ang="0">
                <a:pos x="connsiteX546" y="connsiteY546"/>
              </a:cxn>
              <a:cxn ang="0">
                <a:pos x="connsiteX547" y="connsiteY547"/>
              </a:cxn>
              <a:cxn ang="0">
                <a:pos x="connsiteX548" y="connsiteY548"/>
              </a:cxn>
              <a:cxn ang="0">
                <a:pos x="connsiteX549" y="connsiteY549"/>
              </a:cxn>
              <a:cxn ang="0">
                <a:pos x="connsiteX550" y="connsiteY550"/>
              </a:cxn>
              <a:cxn ang="0">
                <a:pos x="connsiteX551" y="connsiteY551"/>
              </a:cxn>
              <a:cxn ang="0">
                <a:pos x="connsiteX552" y="connsiteY552"/>
              </a:cxn>
              <a:cxn ang="0">
                <a:pos x="connsiteX553" y="connsiteY553"/>
              </a:cxn>
              <a:cxn ang="0">
                <a:pos x="connsiteX554" y="connsiteY554"/>
              </a:cxn>
              <a:cxn ang="0">
                <a:pos x="connsiteX555" y="connsiteY555"/>
              </a:cxn>
              <a:cxn ang="0">
                <a:pos x="connsiteX556" y="connsiteY556"/>
              </a:cxn>
              <a:cxn ang="0">
                <a:pos x="connsiteX557" y="connsiteY557"/>
              </a:cxn>
              <a:cxn ang="0">
                <a:pos x="connsiteX558" y="connsiteY558"/>
              </a:cxn>
              <a:cxn ang="0">
                <a:pos x="connsiteX559" y="connsiteY559"/>
              </a:cxn>
              <a:cxn ang="0">
                <a:pos x="connsiteX560" y="connsiteY560"/>
              </a:cxn>
              <a:cxn ang="0">
                <a:pos x="connsiteX561" y="connsiteY561"/>
              </a:cxn>
              <a:cxn ang="0">
                <a:pos x="connsiteX562" y="connsiteY562"/>
              </a:cxn>
              <a:cxn ang="0">
                <a:pos x="connsiteX563" y="connsiteY563"/>
              </a:cxn>
              <a:cxn ang="0">
                <a:pos x="connsiteX564" y="connsiteY564"/>
              </a:cxn>
              <a:cxn ang="0">
                <a:pos x="connsiteX565" y="connsiteY565"/>
              </a:cxn>
              <a:cxn ang="0">
                <a:pos x="connsiteX566" y="connsiteY566"/>
              </a:cxn>
              <a:cxn ang="0">
                <a:pos x="connsiteX567" y="connsiteY567"/>
              </a:cxn>
              <a:cxn ang="0">
                <a:pos x="connsiteX568" y="connsiteY568"/>
              </a:cxn>
              <a:cxn ang="0">
                <a:pos x="connsiteX569" y="connsiteY569"/>
              </a:cxn>
              <a:cxn ang="0">
                <a:pos x="connsiteX570" y="connsiteY570"/>
              </a:cxn>
              <a:cxn ang="0">
                <a:pos x="connsiteX571" y="connsiteY571"/>
              </a:cxn>
              <a:cxn ang="0">
                <a:pos x="connsiteX572" y="connsiteY572"/>
              </a:cxn>
              <a:cxn ang="0">
                <a:pos x="connsiteX573" y="connsiteY573"/>
              </a:cxn>
              <a:cxn ang="0">
                <a:pos x="connsiteX574" y="connsiteY574"/>
              </a:cxn>
              <a:cxn ang="0">
                <a:pos x="connsiteX575" y="connsiteY575"/>
              </a:cxn>
              <a:cxn ang="0">
                <a:pos x="connsiteX576" y="connsiteY576"/>
              </a:cxn>
              <a:cxn ang="0">
                <a:pos x="connsiteX577" y="connsiteY577"/>
              </a:cxn>
              <a:cxn ang="0">
                <a:pos x="connsiteX578" y="connsiteY578"/>
              </a:cxn>
              <a:cxn ang="0">
                <a:pos x="connsiteX579" y="connsiteY579"/>
              </a:cxn>
              <a:cxn ang="0">
                <a:pos x="connsiteX580" y="connsiteY580"/>
              </a:cxn>
              <a:cxn ang="0">
                <a:pos x="connsiteX581" y="connsiteY581"/>
              </a:cxn>
              <a:cxn ang="0">
                <a:pos x="connsiteX582" y="connsiteY582"/>
              </a:cxn>
              <a:cxn ang="0">
                <a:pos x="connsiteX583" y="connsiteY583"/>
              </a:cxn>
              <a:cxn ang="0">
                <a:pos x="connsiteX584" y="connsiteY584"/>
              </a:cxn>
              <a:cxn ang="0">
                <a:pos x="connsiteX585" y="connsiteY585"/>
              </a:cxn>
              <a:cxn ang="0">
                <a:pos x="connsiteX586" y="connsiteY586"/>
              </a:cxn>
              <a:cxn ang="0">
                <a:pos x="connsiteX587" y="connsiteY587"/>
              </a:cxn>
              <a:cxn ang="0">
                <a:pos x="connsiteX588" y="connsiteY588"/>
              </a:cxn>
              <a:cxn ang="0">
                <a:pos x="connsiteX589" y="connsiteY589"/>
              </a:cxn>
              <a:cxn ang="0">
                <a:pos x="connsiteX590" y="connsiteY590"/>
              </a:cxn>
              <a:cxn ang="0">
                <a:pos x="connsiteX591" y="connsiteY591"/>
              </a:cxn>
              <a:cxn ang="0">
                <a:pos x="connsiteX592" y="connsiteY592"/>
              </a:cxn>
              <a:cxn ang="0">
                <a:pos x="connsiteX593" y="connsiteY593"/>
              </a:cxn>
              <a:cxn ang="0">
                <a:pos x="connsiteX594" y="connsiteY594"/>
              </a:cxn>
              <a:cxn ang="0">
                <a:pos x="connsiteX595" y="connsiteY595"/>
              </a:cxn>
              <a:cxn ang="0">
                <a:pos x="connsiteX596" y="connsiteY596"/>
              </a:cxn>
              <a:cxn ang="0">
                <a:pos x="connsiteX597" y="connsiteY597"/>
              </a:cxn>
              <a:cxn ang="0">
                <a:pos x="connsiteX598" y="connsiteY598"/>
              </a:cxn>
              <a:cxn ang="0">
                <a:pos x="connsiteX599" y="connsiteY599"/>
              </a:cxn>
              <a:cxn ang="0">
                <a:pos x="connsiteX600" y="connsiteY600"/>
              </a:cxn>
              <a:cxn ang="0">
                <a:pos x="connsiteX601" y="connsiteY601"/>
              </a:cxn>
              <a:cxn ang="0">
                <a:pos x="connsiteX602" y="connsiteY602"/>
              </a:cxn>
              <a:cxn ang="0">
                <a:pos x="connsiteX603" y="connsiteY603"/>
              </a:cxn>
              <a:cxn ang="0">
                <a:pos x="connsiteX604" y="connsiteY604"/>
              </a:cxn>
              <a:cxn ang="0">
                <a:pos x="connsiteX605" y="connsiteY605"/>
              </a:cxn>
              <a:cxn ang="0">
                <a:pos x="connsiteX606" y="connsiteY606"/>
              </a:cxn>
              <a:cxn ang="0">
                <a:pos x="connsiteX607" y="connsiteY607"/>
              </a:cxn>
              <a:cxn ang="0">
                <a:pos x="connsiteX608" y="connsiteY608"/>
              </a:cxn>
              <a:cxn ang="0">
                <a:pos x="connsiteX609" y="connsiteY609"/>
              </a:cxn>
              <a:cxn ang="0">
                <a:pos x="connsiteX610" y="connsiteY610"/>
              </a:cxn>
              <a:cxn ang="0">
                <a:pos x="connsiteX611" y="connsiteY611"/>
              </a:cxn>
              <a:cxn ang="0">
                <a:pos x="connsiteX612" y="connsiteY612"/>
              </a:cxn>
              <a:cxn ang="0">
                <a:pos x="connsiteX613" y="connsiteY613"/>
              </a:cxn>
              <a:cxn ang="0">
                <a:pos x="connsiteX614" y="connsiteY614"/>
              </a:cxn>
              <a:cxn ang="0">
                <a:pos x="connsiteX615" y="connsiteY615"/>
              </a:cxn>
              <a:cxn ang="0">
                <a:pos x="connsiteX616" y="connsiteY616"/>
              </a:cxn>
              <a:cxn ang="0">
                <a:pos x="connsiteX617" y="connsiteY617"/>
              </a:cxn>
              <a:cxn ang="0">
                <a:pos x="connsiteX618" y="connsiteY618"/>
              </a:cxn>
              <a:cxn ang="0">
                <a:pos x="connsiteX619" y="connsiteY619"/>
              </a:cxn>
              <a:cxn ang="0">
                <a:pos x="connsiteX620" y="connsiteY620"/>
              </a:cxn>
              <a:cxn ang="0">
                <a:pos x="connsiteX621" y="connsiteY621"/>
              </a:cxn>
              <a:cxn ang="0">
                <a:pos x="connsiteX622" y="connsiteY622"/>
              </a:cxn>
              <a:cxn ang="0">
                <a:pos x="connsiteX623" y="connsiteY623"/>
              </a:cxn>
              <a:cxn ang="0">
                <a:pos x="connsiteX624" y="connsiteY624"/>
              </a:cxn>
              <a:cxn ang="0">
                <a:pos x="connsiteX625" y="connsiteY625"/>
              </a:cxn>
              <a:cxn ang="0">
                <a:pos x="connsiteX626" y="connsiteY626"/>
              </a:cxn>
              <a:cxn ang="0">
                <a:pos x="connsiteX627" y="connsiteY627"/>
              </a:cxn>
              <a:cxn ang="0">
                <a:pos x="connsiteX628" y="connsiteY628"/>
              </a:cxn>
              <a:cxn ang="0">
                <a:pos x="connsiteX629" y="connsiteY629"/>
              </a:cxn>
              <a:cxn ang="0">
                <a:pos x="connsiteX630" y="connsiteY630"/>
              </a:cxn>
              <a:cxn ang="0">
                <a:pos x="connsiteX631" y="connsiteY631"/>
              </a:cxn>
              <a:cxn ang="0">
                <a:pos x="connsiteX632" y="connsiteY632"/>
              </a:cxn>
              <a:cxn ang="0">
                <a:pos x="connsiteX633" y="connsiteY633"/>
              </a:cxn>
              <a:cxn ang="0">
                <a:pos x="connsiteX634" y="connsiteY634"/>
              </a:cxn>
              <a:cxn ang="0">
                <a:pos x="connsiteX635" y="connsiteY635"/>
              </a:cxn>
              <a:cxn ang="0">
                <a:pos x="connsiteX636" y="connsiteY636"/>
              </a:cxn>
              <a:cxn ang="0">
                <a:pos x="connsiteX637" y="connsiteY637"/>
              </a:cxn>
              <a:cxn ang="0">
                <a:pos x="connsiteX638" y="connsiteY638"/>
              </a:cxn>
              <a:cxn ang="0">
                <a:pos x="connsiteX639" y="connsiteY639"/>
              </a:cxn>
              <a:cxn ang="0">
                <a:pos x="connsiteX640" y="connsiteY640"/>
              </a:cxn>
              <a:cxn ang="0">
                <a:pos x="connsiteX641" y="connsiteY641"/>
              </a:cxn>
              <a:cxn ang="0">
                <a:pos x="connsiteX642" y="connsiteY642"/>
              </a:cxn>
              <a:cxn ang="0">
                <a:pos x="connsiteX643" y="connsiteY643"/>
              </a:cxn>
              <a:cxn ang="0">
                <a:pos x="connsiteX644" y="connsiteY644"/>
              </a:cxn>
              <a:cxn ang="0">
                <a:pos x="connsiteX645" y="connsiteY645"/>
              </a:cxn>
              <a:cxn ang="0">
                <a:pos x="connsiteX646" y="connsiteY646"/>
              </a:cxn>
              <a:cxn ang="0">
                <a:pos x="connsiteX647" y="connsiteY647"/>
              </a:cxn>
              <a:cxn ang="0">
                <a:pos x="connsiteX648" y="connsiteY648"/>
              </a:cxn>
              <a:cxn ang="0">
                <a:pos x="connsiteX649" y="connsiteY649"/>
              </a:cxn>
              <a:cxn ang="0">
                <a:pos x="connsiteX650" y="connsiteY650"/>
              </a:cxn>
              <a:cxn ang="0">
                <a:pos x="connsiteX651" y="connsiteY651"/>
              </a:cxn>
              <a:cxn ang="0">
                <a:pos x="connsiteX652" y="connsiteY652"/>
              </a:cxn>
              <a:cxn ang="0">
                <a:pos x="connsiteX653" y="connsiteY653"/>
              </a:cxn>
              <a:cxn ang="0">
                <a:pos x="connsiteX654" y="connsiteY654"/>
              </a:cxn>
              <a:cxn ang="0">
                <a:pos x="connsiteX655" y="connsiteY655"/>
              </a:cxn>
              <a:cxn ang="0">
                <a:pos x="connsiteX656" y="connsiteY656"/>
              </a:cxn>
              <a:cxn ang="0">
                <a:pos x="connsiteX657" y="connsiteY657"/>
              </a:cxn>
              <a:cxn ang="0">
                <a:pos x="connsiteX658" y="connsiteY658"/>
              </a:cxn>
              <a:cxn ang="0">
                <a:pos x="connsiteX659" y="connsiteY659"/>
              </a:cxn>
              <a:cxn ang="0">
                <a:pos x="connsiteX660" y="connsiteY660"/>
              </a:cxn>
              <a:cxn ang="0">
                <a:pos x="connsiteX661" y="connsiteY661"/>
              </a:cxn>
              <a:cxn ang="0">
                <a:pos x="connsiteX662" y="connsiteY662"/>
              </a:cxn>
              <a:cxn ang="0">
                <a:pos x="connsiteX663" y="connsiteY663"/>
              </a:cxn>
              <a:cxn ang="0">
                <a:pos x="connsiteX664" y="connsiteY664"/>
              </a:cxn>
              <a:cxn ang="0">
                <a:pos x="connsiteX665" y="connsiteY665"/>
              </a:cxn>
              <a:cxn ang="0">
                <a:pos x="connsiteX666" y="connsiteY666"/>
              </a:cxn>
              <a:cxn ang="0">
                <a:pos x="connsiteX667" y="connsiteY667"/>
              </a:cxn>
              <a:cxn ang="0">
                <a:pos x="connsiteX668" y="connsiteY668"/>
              </a:cxn>
              <a:cxn ang="0">
                <a:pos x="connsiteX669" y="connsiteY669"/>
              </a:cxn>
              <a:cxn ang="0">
                <a:pos x="connsiteX670" y="connsiteY670"/>
              </a:cxn>
              <a:cxn ang="0">
                <a:pos x="connsiteX671" y="connsiteY671"/>
              </a:cxn>
              <a:cxn ang="0">
                <a:pos x="connsiteX672" y="connsiteY672"/>
              </a:cxn>
              <a:cxn ang="0">
                <a:pos x="connsiteX673" y="connsiteY673"/>
              </a:cxn>
              <a:cxn ang="0">
                <a:pos x="connsiteX674" y="connsiteY674"/>
              </a:cxn>
              <a:cxn ang="0">
                <a:pos x="connsiteX675" y="connsiteY675"/>
              </a:cxn>
              <a:cxn ang="0">
                <a:pos x="connsiteX676" y="connsiteY676"/>
              </a:cxn>
              <a:cxn ang="0">
                <a:pos x="connsiteX677" y="connsiteY677"/>
              </a:cxn>
              <a:cxn ang="0">
                <a:pos x="connsiteX678" y="connsiteY678"/>
              </a:cxn>
              <a:cxn ang="0">
                <a:pos x="connsiteX679" y="connsiteY679"/>
              </a:cxn>
              <a:cxn ang="0">
                <a:pos x="connsiteX680" y="connsiteY680"/>
              </a:cxn>
              <a:cxn ang="0">
                <a:pos x="connsiteX681" y="connsiteY681"/>
              </a:cxn>
              <a:cxn ang="0">
                <a:pos x="connsiteX682" y="connsiteY682"/>
              </a:cxn>
              <a:cxn ang="0">
                <a:pos x="connsiteX683" y="connsiteY683"/>
              </a:cxn>
              <a:cxn ang="0">
                <a:pos x="connsiteX684" y="connsiteY684"/>
              </a:cxn>
              <a:cxn ang="0">
                <a:pos x="connsiteX685" y="connsiteY685"/>
              </a:cxn>
              <a:cxn ang="0">
                <a:pos x="connsiteX686" y="connsiteY686"/>
              </a:cxn>
              <a:cxn ang="0">
                <a:pos x="connsiteX687" y="connsiteY687"/>
              </a:cxn>
              <a:cxn ang="0">
                <a:pos x="connsiteX688" y="connsiteY688"/>
              </a:cxn>
              <a:cxn ang="0">
                <a:pos x="connsiteX689" y="connsiteY689"/>
              </a:cxn>
              <a:cxn ang="0">
                <a:pos x="connsiteX690" y="connsiteY690"/>
              </a:cxn>
              <a:cxn ang="0">
                <a:pos x="connsiteX691" y="connsiteY691"/>
              </a:cxn>
              <a:cxn ang="0">
                <a:pos x="connsiteX692" y="connsiteY692"/>
              </a:cxn>
              <a:cxn ang="0">
                <a:pos x="connsiteX693" y="connsiteY693"/>
              </a:cxn>
              <a:cxn ang="0">
                <a:pos x="connsiteX694" y="connsiteY694"/>
              </a:cxn>
              <a:cxn ang="0">
                <a:pos x="connsiteX695" y="connsiteY695"/>
              </a:cxn>
              <a:cxn ang="0">
                <a:pos x="connsiteX696" y="connsiteY696"/>
              </a:cxn>
              <a:cxn ang="0">
                <a:pos x="connsiteX697" y="connsiteY697"/>
              </a:cxn>
              <a:cxn ang="0">
                <a:pos x="connsiteX698" y="connsiteY698"/>
              </a:cxn>
              <a:cxn ang="0">
                <a:pos x="connsiteX699" y="connsiteY699"/>
              </a:cxn>
              <a:cxn ang="0">
                <a:pos x="connsiteX700" y="connsiteY700"/>
              </a:cxn>
              <a:cxn ang="0">
                <a:pos x="connsiteX701" y="connsiteY701"/>
              </a:cxn>
              <a:cxn ang="0">
                <a:pos x="connsiteX702" y="connsiteY702"/>
              </a:cxn>
              <a:cxn ang="0">
                <a:pos x="connsiteX703" y="connsiteY703"/>
              </a:cxn>
              <a:cxn ang="0">
                <a:pos x="connsiteX704" y="connsiteY704"/>
              </a:cxn>
              <a:cxn ang="0">
                <a:pos x="connsiteX705" y="connsiteY705"/>
              </a:cxn>
              <a:cxn ang="0">
                <a:pos x="connsiteX706" y="connsiteY706"/>
              </a:cxn>
              <a:cxn ang="0">
                <a:pos x="connsiteX707" y="connsiteY707"/>
              </a:cxn>
              <a:cxn ang="0">
                <a:pos x="connsiteX708" y="connsiteY708"/>
              </a:cxn>
              <a:cxn ang="0">
                <a:pos x="connsiteX709" y="connsiteY709"/>
              </a:cxn>
              <a:cxn ang="0">
                <a:pos x="connsiteX710" y="connsiteY710"/>
              </a:cxn>
              <a:cxn ang="0">
                <a:pos x="connsiteX711" y="connsiteY711"/>
              </a:cxn>
              <a:cxn ang="0">
                <a:pos x="connsiteX712" y="connsiteY712"/>
              </a:cxn>
              <a:cxn ang="0">
                <a:pos x="connsiteX713" y="connsiteY713"/>
              </a:cxn>
              <a:cxn ang="0">
                <a:pos x="connsiteX714" y="connsiteY714"/>
              </a:cxn>
              <a:cxn ang="0">
                <a:pos x="connsiteX715" y="connsiteY715"/>
              </a:cxn>
              <a:cxn ang="0">
                <a:pos x="connsiteX716" y="connsiteY716"/>
              </a:cxn>
              <a:cxn ang="0">
                <a:pos x="connsiteX717" y="connsiteY717"/>
              </a:cxn>
              <a:cxn ang="0">
                <a:pos x="connsiteX718" y="connsiteY718"/>
              </a:cxn>
              <a:cxn ang="0">
                <a:pos x="connsiteX719" y="connsiteY719"/>
              </a:cxn>
              <a:cxn ang="0">
                <a:pos x="connsiteX720" y="connsiteY720"/>
              </a:cxn>
              <a:cxn ang="0">
                <a:pos x="connsiteX721" y="connsiteY721"/>
              </a:cxn>
              <a:cxn ang="0">
                <a:pos x="connsiteX722" y="connsiteY722"/>
              </a:cxn>
              <a:cxn ang="0">
                <a:pos x="connsiteX723" y="connsiteY723"/>
              </a:cxn>
              <a:cxn ang="0">
                <a:pos x="connsiteX724" y="connsiteY724"/>
              </a:cxn>
              <a:cxn ang="0">
                <a:pos x="connsiteX725" y="connsiteY725"/>
              </a:cxn>
              <a:cxn ang="0">
                <a:pos x="connsiteX726" y="connsiteY726"/>
              </a:cxn>
              <a:cxn ang="0">
                <a:pos x="connsiteX727" y="connsiteY727"/>
              </a:cxn>
              <a:cxn ang="0">
                <a:pos x="connsiteX728" y="connsiteY728"/>
              </a:cxn>
              <a:cxn ang="0">
                <a:pos x="connsiteX729" y="connsiteY729"/>
              </a:cxn>
              <a:cxn ang="0">
                <a:pos x="connsiteX730" y="connsiteY730"/>
              </a:cxn>
              <a:cxn ang="0">
                <a:pos x="connsiteX731" y="connsiteY731"/>
              </a:cxn>
              <a:cxn ang="0">
                <a:pos x="connsiteX732" y="connsiteY732"/>
              </a:cxn>
              <a:cxn ang="0">
                <a:pos x="connsiteX733" y="connsiteY733"/>
              </a:cxn>
              <a:cxn ang="0">
                <a:pos x="connsiteX734" y="connsiteY734"/>
              </a:cxn>
              <a:cxn ang="0">
                <a:pos x="connsiteX735" y="connsiteY735"/>
              </a:cxn>
              <a:cxn ang="0">
                <a:pos x="connsiteX736" y="connsiteY736"/>
              </a:cxn>
              <a:cxn ang="0">
                <a:pos x="connsiteX737" y="connsiteY737"/>
              </a:cxn>
              <a:cxn ang="0">
                <a:pos x="connsiteX738" y="connsiteY738"/>
              </a:cxn>
              <a:cxn ang="0">
                <a:pos x="connsiteX739" y="connsiteY739"/>
              </a:cxn>
              <a:cxn ang="0">
                <a:pos x="connsiteX740" y="connsiteY740"/>
              </a:cxn>
              <a:cxn ang="0">
                <a:pos x="connsiteX741" y="connsiteY741"/>
              </a:cxn>
              <a:cxn ang="0">
                <a:pos x="connsiteX742" y="connsiteY742"/>
              </a:cxn>
              <a:cxn ang="0">
                <a:pos x="connsiteX743" y="connsiteY743"/>
              </a:cxn>
              <a:cxn ang="0">
                <a:pos x="connsiteX744" y="connsiteY744"/>
              </a:cxn>
              <a:cxn ang="0">
                <a:pos x="connsiteX745" y="connsiteY745"/>
              </a:cxn>
              <a:cxn ang="0">
                <a:pos x="connsiteX746" y="connsiteY746"/>
              </a:cxn>
              <a:cxn ang="0">
                <a:pos x="connsiteX747" y="connsiteY747"/>
              </a:cxn>
              <a:cxn ang="0">
                <a:pos x="connsiteX748" y="connsiteY748"/>
              </a:cxn>
              <a:cxn ang="0">
                <a:pos x="connsiteX749" y="connsiteY749"/>
              </a:cxn>
              <a:cxn ang="0">
                <a:pos x="connsiteX750" y="connsiteY750"/>
              </a:cxn>
              <a:cxn ang="0">
                <a:pos x="connsiteX751" y="connsiteY751"/>
              </a:cxn>
              <a:cxn ang="0">
                <a:pos x="connsiteX752" y="connsiteY752"/>
              </a:cxn>
              <a:cxn ang="0">
                <a:pos x="connsiteX753" y="connsiteY753"/>
              </a:cxn>
              <a:cxn ang="0">
                <a:pos x="connsiteX754" y="connsiteY754"/>
              </a:cxn>
              <a:cxn ang="0">
                <a:pos x="connsiteX755" y="connsiteY755"/>
              </a:cxn>
              <a:cxn ang="0">
                <a:pos x="connsiteX756" y="connsiteY756"/>
              </a:cxn>
              <a:cxn ang="0">
                <a:pos x="connsiteX757" y="connsiteY757"/>
              </a:cxn>
              <a:cxn ang="0">
                <a:pos x="connsiteX758" y="connsiteY758"/>
              </a:cxn>
              <a:cxn ang="0">
                <a:pos x="connsiteX759" y="connsiteY759"/>
              </a:cxn>
              <a:cxn ang="0">
                <a:pos x="connsiteX760" y="connsiteY760"/>
              </a:cxn>
              <a:cxn ang="0">
                <a:pos x="connsiteX761" y="connsiteY761"/>
              </a:cxn>
              <a:cxn ang="0">
                <a:pos x="connsiteX762" y="connsiteY762"/>
              </a:cxn>
              <a:cxn ang="0">
                <a:pos x="connsiteX763" y="connsiteY763"/>
              </a:cxn>
              <a:cxn ang="0">
                <a:pos x="connsiteX764" y="connsiteY764"/>
              </a:cxn>
              <a:cxn ang="0">
                <a:pos x="connsiteX765" y="connsiteY765"/>
              </a:cxn>
              <a:cxn ang="0">
                <a:pos x="connsiteX766" y="connsiteY766"/>
              </a:cxn>
              <a:cxn ang="0">
                <a:pos x="connsiteX767" y="connsiteY767"/>
              </a:cxn>
              <a:cxn ang="0">
                <a:pos x="connsiteX768" y="connsiteY768"/>
              </a:cxn>
              <a:cxn ang="0">
                <a:pos x="connsiteX769" y="connsiteY769"/>
              </a:cxn>
              <a:cxn ang="0">
                <a:pos x="connsiteX770" y="connsiteY770"/>
              </a:cxn>
              <a:cxn ang="0">
                <a:pos x="connsiteX771" y="connsiteY771"/>
              </a:cxn>
              <a:cxn ang="0">
                <a:pos x="connsiteX772" y="connsiteY772"/>
              </a:cxn>
              <a:cxn ang="0">
                <a:pos x="connsiteX773" y="connsiteY773"/>
              </a:cxn>
              <a:cxn ang="0">
                <a:pos x="connsiteX774" y="connsiteY774"/>
              </a:cxn>
              <a:cxn ang="0">
                <a:pos x="connsiteX775" y="connsiteY775"/>
              </a:cxn>
              <a:cxn ang="0">
                <a:pos x="connsiteX776" y="connsiteY776"/>
              </a:cxn>
              <a:cxn ang="0">
                <a:pos x="connsiteX777" y="connsiteY777"/>
              </a:cxn>
              <a:cxn ang="0">
                <a:pos x="connsiteX778" y="connsiteY778"/>
              </a:cxn>
              <a:cxn ang="0">
                <a:pos x="connsiteX779" y="connsiteY779"/>
              </a:cxn>
              <a:cxn ang="0">
                <a:pos x="connsiteX780" y="connsiteY780"/>
              </a:cxn>
              <a:cxn ang="0">
                <a:pos x="connsiteX781" y="connsiteY781"/>
              </a:cxn>
              <a:cxn ang="0">
                <a:pos x="connsiteX782" y="connsiteY782"/>
              </a:cxn>
              <a:cxn ang="0">
                <a:pos x="connsiteX783" y="connsiteY783"/>
              </a:cxn>
              <a:cxn ang="0">
                <a:pos x="connsiteX784" y="connsiteY784"/>
              </a:cxn>
              <a:cxn ang="0">
                <a:pos x="connsiteX785" y="connsiteY785"/>
              </a:cxn>
              <a:cxn ang="0">
                <a:pos x="connsiteX786" y="connsiteY786"/>
              </a:cxn>
              <a:cxn ang="0">
                <a:pos x="connsiteX787" y="connsiteY787"/>
              </a:cxn>
              <a:cxn ang="0">
                <a:pos x="connsiteX788" y="connsiteY788"/>
              </a:cxn>
              <a:cxn ang="0">
                <a:pos x="connsiteX789" y="connsiteY789"/>
              </a:cxn>
              <a:cxn ang="0">
                <a:pos x="connsiteX790" y="connsiteY790"/>
              </a:cxn>
              <a:cxn ang="0">
                <a:pos x="connsiteX791" y="connsiteY791"/>
              </a:cxn>
              <a:cxn ang="0">
                <a:pos x="connsiteX792" y="connsiteY792"/>
              </a:cxn>
              <a:cxn ang="0">
                <a:pos x="connsiteX793" y="connsiteY793"/>
              </a:cxn>
              <a:cxn ang="0">
                <a:pos x="connsiteX794" y="connsiteY794"/>
              </a:cxn>
              <a:cxn ang="0">
                <a:pos x="connsiteX795" y="connsiteY795"/>
              </a:cxn>
              <a:cxn ang="0">
                <a:pos x="connsiteX796" y="connsiteY796"/>
              </a:cxn>
              <a:cxn ang="0">
                <a:pos x="connsiteX797" y="connsiteY797"/>
              </a:cxn>
              <a:cxn ang="0">
                <a:pos x="connsiteX798" y="connsiteY798"/>
              </a:cxn>
              <a:cxn ang="0">
                <a:pos x="connsiteX799" y="connsiteY799"/>
              </a:cxn>
              <a:cxn ang="0">
                <a:pos x="connsiteX800" y="connsiteY800"/>
              </a:cxn>
              <a:cxn ang="0">
                <a:pos x="connsiteX801" y="connsiteY801"/>
              </a:cxn>
              <a:cxn ang="0">
                <a:pos x="connsiteX802" y="connsiteY802"/>
              </a:cxn>
              <a:cxn ang="0">
                <a:pos x="connsiteX803" y="connsiteY803"/>
              </a:cxn>
              <a:cxn ang="0">
                <a:pos x="connsiteX804" y="connsiteY804"/>
              </a:cxn>
              <a:cxn ang="0">
                <a:pos x="connsiteX805" y="connsiteY805"/>
              </a:cxn>
              <a:cxn ang="0">
                <a:pos x="connsiteX806" y="connsiteY806"/>
              </a:cxn>
              <a:cxn ang="0">
                <a:pos x="connsiteX807" y="connsiteY807"/>
              </a:cxn>
              <a:cxn ang="0">
                <a:pos x="connsiteX808" y="connsiteY808"/>
              </a:cxn>
              <a:cxn ang="0">
                <a:pos x="connsiteX809" y="connsiteY809"/>
              </a:cxn>
              <a:cxn ang="0">
                <a:pos x="connsiteX810" y="connsiteY810"/>
              </a:cxn>
              <a:cxn ang="0">
                <a:pos x="connsiteX811" y="connsiteY811"/>
              </a:cxn>
              <a:cxn ang="0">
                <a:pos x="connsiteX812" y="connsiteY812"/>
              </a:cxn>
              <a:cxn ang="0">
                <a:pos x="connsiteX813" y="connsiteY813"/>
              </a:cxn>
              <a:cxn ang="0">
                <a:pos x="connsiteX814" y="connsiteY814"/>
              </a:cxn>
              <a:cxn ang="0">
                <a:pos x="connsiteX815" y="connsiteY815"/>
              </a:cxn>
              <a:cxn ang="0">
                <a:pos x="connsiteX816" y="connsiteY816"/>
              </a:cxn>
              <a:cxn ang="0">
                <a:pos x="connsiteX817" y="connsiteY817"/>
              </a:cxn>
              <a:cxn ang="0">
                <a:pos x="connsiteX818" y="connsiteY818"/>
              </a:cxn>
              <a:cxn ang="0">
                <a:pos x="connsiteX819" y="connsiteY819"/>
              </a:cxn>
              <a:cxn ang="0">
                <a:pos x="connsiteX820" y="connsiteY820"/>
              </a:cxn>
              <a:cxn ang="0">
                <a:pos x="connsiteX821" y="connsiteY821"/>
              </a:cxn>
              <a:cxn ang="0">
                <a:pos x="connsiteX822" y="connsiteY822"/>
              </a:cxn>
              <a:cxn ang="0">
                <a:pos x="connsiteX823" y="connsiteY823"/>
              </a:cxn>
              <a:cxn ang="0">
                <a:pos x="connsiteX824" y="connsiteY824"/>
              </a:cxn>
              <a:cxn ang="0">
                <a:pos x="connsiteX825" y="connsiteY825"/>
              </a:cxn>
              <a:cxn ang="0">
                <a:pos x="connsiteX826" y="connsiteY826"/>
              </a:cxn>
              <a:cxn ang="0">
                <a:pos x="connsiteX827" y="connsiteY827"/>
              </a:cxn>
              <a:cxn ang="0">
                <a:pos x="connsiteX828" y="connsiteY828"/>
              </a:cxn>
              <a:cxn ang="0">
                <a:pos x="connsiteX829" y="connsiteY829"/>
              </a:cxn>
              <a:cxn ang="0">
                <a:pos x="connsiteX830" y="connsiteY830"/>
              </a:cxn>
              <a:cxn ang="0">
                <a:pos x="connsiteX831" y="connsiteY831"/>
              </a:cxn>
              <a:cxn ang="0">
                <a:pos x="connsiteX832" y="connsiteY832"/>
              </a:cxn>
              <a:cxn ang="0">
                <a:pos x="connsiteX833" y="connsiteY833"/>
              </a:cxn>
              <a:cxn ang="0">
                <a:pos x="connsiteX834" y="connsiteY834"/>
              </a:cxn>
              <a:cxn ang="0">
                <a:pos x="connsiteX835" y="connsiteY835"/>
              </a:cxn>
              <a:cxn ang="0">
                <a:pos x="connsiteX836" y="connsiteY836"/>
              </a:cxn>
              <a:cxn ang="0">
                <a:pos x="connsiteX837" y="connsiteY837"/>
              </a:cxn>
              <a:cxn ang="0">
                <a:pos x="connsiteX838" y="connsiteY838"/>
              </a:cxn>
              <a:cxn ang="0">
                <a:pos x="connsiteX839" y="connsiteY839"/>
              </a:cxn>
              <a:cxn ang="0">
                <a:pos x="connsiteX840" y="connsiteY840"/>
              </a:cxn>
              <a:cxn ang="0">
                <a:pos x="connsiteX841" y="connsiteY841"/>
              </a:cxn>
              <a:cxn ang="0">
                <a:pos x="connsiteX842" y="connsiteY842"/>
              </a:cxn>
              <a:cxn ang="0">
                <a:pos x="connsiteX843" y="connsiteY843"/>
              </a:cxn>
              <a:cxn ang="0">
                <a:pos x="connsiteX844" y="connsiteY844"/>
              </a:cxn>
              <a:cxn ang="0">
                <a:pos x="connsiteX845" y="connsiteY845"/>
              </a:cxn>
              <a:cxn ang="0">
                <a:pos x="connsiteX846" y="connsiteY846"/>
              </a:cxn>
              <a:cxn ang="0">
                <a:pos x="connsiteX847" y="connsiteY847"/>
              </a:cxn>
              <a:cxn ang="0">
                <a:pos x="connsiteX848" y="connsiteY848"/>
              </a:cxn>
              <a:cxn ang="0">
                <a:pos x="connsiteX849" y="connsiteY849"/>
              </a:cxn>
              <a:cxn ang="0">
                <a:pos x="connsiteX850" y="connsiteY850"/>
              </a:cxn>
              <a:cxn ang="0">
                <a:pos x="connsiteX851" y="connsiteY851"/>
              </a:cxn>
              <a:cxn ang="0">
                <a:pos x="connsiteX852" y="connsiteY852"/>
              </a:cxn>
              <a:cxn ang="0">
                <a:pos x="connsiteX853" y="connsiteY853"/>
              </a:cxn>
              <a:cxn ang="0">
                <a:pos x="connsiteX854" y="connsiteY854"/>
              </a:cxn>
              <a:cxn ang="0">
                <a:pos x="connsiteX855" y="connsiteY855"/>
              </a:cxn>
              <a:cxn ang="0">
                <a:pos x="connsiteX856" y="connsiteY856"/>
              </a:cxn>
              <a:cxn ang="0">
                <a:pos x="connsiteX857" y="connsiteY857"/>
              </a:cxn>
              <a:cxn ang="0">
                <a:pos x="connsiteX858" y="connsiteY858"/>
              </a:cxn>
              <a:cxn ang="0">
                <a:pos x="connsiteX859" y="connsiteY859"/>
              </a:cxn>
              <a:cxn ang="0">
                <a:pos x="connsiteX860" y="connsiteY860"/>
              </a:cxn>
              <a:cxn ang="0">
                <a:pos x="connsiteX861" y="connsiteY861"/>
              </a:cxn>
              <a:cxn ang="0">
                <a:pos x="connsiteX862" y="connsiteY862"/>
              </a:cxn>
              <a:cxn ang="0">
                <a:pos x="connsiteX863" y="connsiteY863"/>
              </a:cxn>
              <a:cxn ang="0">
                <a:pos x="connsiteX864" y="connsiteY864"/>
              </a:cxn>
              <a:cxn ang="0">
                <a:pos x="connsiteX865" y="connsiteY865"/>
              </a:cxn>
              <a:cxn ang="0">
                <a:pos x="connsiteX866" y="connsiteY866"/>
              </a:cxn>
              <a:cxn ang="0">
                <a:pos x="connsiteX867" y="connsiteY867"/>
              </a:cxn>
              <a:cxn ang="0">
                <a:pos x="connsiteX868" y="connsiteY868"/>
              </a:cxn>
              <a:cxn ang="0">
                <a:pos x="connsiteX869" y="connsiteY869"/>
              </a:cxn>
              <a:cxn ang="0">
                <a:pos x="connsiteX870" y="connsiteY870"/>
              </a:cxn>
              <a:cxn ang="0">
                <a:pos x="connsiteX871" y="connsiteY871"/>
              </a:cxn>
              <a:cxn ang="0">
                <a:pos x="connsiteX872" y="connsiteY872"/>
              </a:cxn>
              <a:cxn ang="0">
                <a:pos x="connsiteX873" y="connsiteY873"/>
              </a:cxn>
              <a:cxn ang="0">
                <a:pos x="connsiteX874" y="connsiteY874"/>
              </a:cxn>
              <a:cxn ang="0">
                <a:pos x="connsiteX875" y="connsiteY875"/>
              </a:cxn>
              <a:cxn ang="0">
                <a:pos x="connsiteX876" y="connsiteY876"/>
              </a:cxn>
              <a:cxn ang="0">
                <a:pos x="connsiteX877" y="connsiteY877"/>
              </a:cxn>
              <a:cxn ang="0">
                <a:pos x="connsiteX878" y="connsiteY878"/>
              </a:cxn>
              <a:cxn ang="0">
                <a:pos x="connsiteX879" y="connsiteY879"/>
              </a:cxn>
              <a:cxn ang="0">
                <a:pos x="connsiteX880" y="connsiteY880"/>
              </a:cxn>
              <a:cxn ang="0">
                <a:pos x="connsiteX881" y="connsiteY881"/>
              </a:cxn>
              <a:cxn ang="0">
                <a:pos x="connsiteX882" y="connsiteY882"/>
              </a:cxn>
              <a:cxn ang="0">
                <a:pos x="connsiteX883" y="connsiteY883"/>
              </a:cxn>
              <a:cxn ang="0">
                <a:pos x="connsiteX884" y="connsiteY884"/>
              </a:cxn>
              <a:cxn ang="0">
                <a:pos x="connsiteX885" y="connsiteY885"/>
              </a:cxn>
              <a:cxn ang="0">
                <a:pos x="connsiteX886" y="connsiteY886"/>
              </a:cxn>
              <a:cxn ang="0">
                <a:pos x="connsiteX887" y="connsiteY887"/>
              </a:cxn>
              <a:cxn ang="0">
                <a:pos x="connsiteX888" y="connsiteY888"/>
              </a:cxn>
              <a:cxn ang="0">
                <a:pos x="connsiteX889" y="connsiteY889"/>
              </a:cxn>
              <a:cxn ang="0">
                <a:pos x="connsiteX890" y="connsiteY890"/>
              </a:cxn>
              <a:cxn ang="0">
                <a:pos x="connsiteX891" y="connsiteY891"/>
              </a:cxn>
              <a:cxn ang="0">
                <a:pos x="connsiteX892" y="connsiteY892"/>
              </a:cxn>
              <a:cxn ang="0">
                <a:pos x="connsiteX893" y="connsiteY893"/>
              </a:cxn>
              <a:cxn ang="0">
                <a:pos x="connsiteX894" y="connsiteY894"/>
              </a:cxn>
              <a:cxn ang="0">
                <a:pos x="connsiteX895" y="connsiteY895"/>
              </a:cxn>
              <a:cxn ang="0">
                <a:pos x="connsiteX896" y="connsiteY896"/>
              </a:cxn>
              <a:cxn ang="0">
                <a:pos x="connsiteX897" y="connsiteY897"/>
              </a:cxn>
              <a:cxn ang="0">
                <a:pos x="connsiteX898" y="connsiteY898"/>
              </a:cxn>
              <a:cxn ang="0">
                <a:pos x="connsiteX899" y="connsiteY899"/>
              </a:cxn>
              <a:cxn ang="0">
                <a:pos x="connsiteX900" y="connsiteY900"/>
              </a:cxn>
              <a:cxn ang="0">
                <a:pos x="connsiteX901" y="connsiteY901"/>
              </a:cxn>
              <a:cxn ang="0">
                <a:pos x="connsiteX902" y="connsiteY902"/>
              </a:cxn>
              <a:cxn ang="0">
                <a:pos x="connsiteX903" y="connsiteY903"/>
              </a:cxn>
              <a:cxn ang="0">
                <a:pos x="connsiteX904" y="connsiteY904"/>
              </a:cxn>
              <a:cxn ang="0">
                <a:pos x="connsiteX905" y="connsiteY905"/>
              </a:cxn>
              <a:cxn ang="0">
                <a:pos x="connsiteX906" y="connsiteY906"/>
              </a:cxn>
              <a:cxn ang="0">
                <a:pos x="connsiteX907" y="connsiteY907"/>
              </a:cxn>
              <a:cxn ang="0">
                <a:pos x="connsiteX908" y="connsiteY908"/>
              </a:cxn>
              <a:cxn ang="0">
                <a:pos x="connsiteX909" y="connsiteY909"/>
              </a:cxn>
              <a:cxn ang="0">
                <a:pos x="connsiteX910" y="connsiteY910"/>
              </a:cxn>
              <a:cxn ang="0">
                <a:pos x="connsiteX911" y="connsiteY911"/>
              </a:cxn>
              <a:cxn ang="0">
                <a:pos x="connsiteX912" y="connsiteY912"/>
              </a:cxn>
              <a:cxn ang="0">
                <a:pos x="connsiteX913" y="connsiteY913"/>
              </a:cxn>
              <a:cxn ang="0">
                <a:pos x="connsiteX914" y="connsiteY914"/>
              </a:cxn>
              <a:cxn ang="0">
                <a:pos x="connsiteX915" y="connsiteY915"/>
              </a:cxn>
              <a:cxn ang="0">
                <a:pos x="connsiteX916" y="connsiteY916"/>
              </a:cxn>
              <a:cxn ang="0">
                <a:pos x="connsiteX917" y="connsiteY917"/>
              </a:cxn>
              <a:cxn ang="0">
                <a:pos x="connsiteX918" y="connsiteY918"/>
              </a:cxn>
              <a:cxn ang="0">
                <a:pos x="connsiteX919" y="connsiteY919"/>
              </a:cxn>
              <a:cxn ang="0">
                <a:pos x="connsiteX920" y="connsiteY920"/>
              </a:cxn>
              <a:cxn ang="0">
                <a:pos x="connsiteX921" y="connsiteY921"/>
              </a:cxn>
              <a:cxn ang="0">
                <a:pos x="connsiteX922" y="connsiteY922"/>
              </a:cxn>
              <a:cxn ang="0">
                <a:pos x="connsiteX923" y="connsiteY923"/>
              </a:cxn>
              <a:cxn ang="0">
                <a:pos x="connsiteX924" y="connsiteY924"/>
              </a:cxn>
              <a:cxn ang="0">
                <a:pos x="connsiteX925" y="connsiteY925"/>
              </a:cxn>
              <a:cxn ang="0">
                <a:pos x="connsiteX926" y="connsiteY926"/>
              </a:cxn>
              <a:cxn ang="0">
                <a:pos x="connsiteX927" y="connsiteY927"/>
              </a:cxn>
              <a:cxn ang="0">
                <a:pos x="connsiteX928" y="connsiteY928"/>
              </a:cxn>
              <a:cxn ang="0">
                <a:pos x="connsiteX929" y="connsiteY929"/>
              </a:cxn>
              <a:cxn ang="0">
                <a:pos x="connsiteX930" y="connsiteY930"/>
              </a:cxn>
              <a:cxn ang="0">
                <a:pos x="connsiteX931" y="connsiteY931"/>
              </a:cxn>
              <a:cxn ang="0">
                <a:pos x="connsiteX932" y="connsiteY932"/>
              </a:cxn>
              <a:cxn ang="0">
                <a:pos x="connsiteX933" y="connsiteY933"/>
              </a:cxn>
              <a:cxn ang="0">
                <a:pos x="connsiteX934" y="connsiteY934"/>
              </a:cxn>
              <a:cxn ang="0">
                <a:pos x="connsiteX935" y="connsiteY935"/>
              </a:cxn>
              <a:cxn ang="0">
                <a:pos x="connsiteX936" y="connsiteY936"/>
              </a:cxn>
              <a:cxn ang="0">
                <a:pos x="connsiteX937" y="connsiteY937"/>
              </a:cxn>
              <a:cxn ang="0">
                <a:pos x="connsiteX938" y="connsiteY938"/>
              </a:cxn>
              <a:cxn ang="0">
                <a:pos x="connsiteX939" y="connsiteY939"/>
              </a:cxn>
              <a:cxn ang="0">
                <a:pos x="connsiteX940" y="connsiteY940"/>
              </a:cxn>
              <a:cxn ang="0">
                <a:pos x="connsiteX941" y="connsiteY941"/>
              </a:cxn>
              <a:cxn ang="0">
                <a:pos x="connsiteX942" y="connsiteY942"/>
              </a:cxn>
              <a:cxn ang="0">
                <a:pos x="connsiteX943" y="connsiteY943"/>
              </a:cxn>
              <a:cxn ang="0">
                <a:pos x="connsiteX944" y="connsiteY944"/>
              </a:cxn>
              <a:cxn ang="0">
                <a:pos x="connsiteX945" y="connsiteY945"/>
              </a:cxn>
              <a:cxn ang="0">
                <a:pos x="connsiteX946" y="connsiteY946"/>
              </a:cxn>
              <a:cxn ang="0">
                <a:pos x="connsiteX947" y="connsiteY947"/>
              </a:cxn>
              <a:cxn ang="0">
                <a:pos x="connsiteX948" y="connsiteY948"/>
              </a:cxn>
              <a:cxn ang="0">
                <a:pos x="connsiteX949" y="connsiteY949"/>
              </a:cxn>
              <a:cxn ang="0">
                <a:pos x="connsiteX950" y="connsiteY950"/>
              </a:cxn>
              <a:cxn ang="0">
                <a:pos x="connsiteX951" y="connsiteY951"/>
              </a:cxn>
              <a:cxn ang="0">
                <a:pos x="connsiteX952" y="connsiteY952"/>
              </a:cxn>
              <a:cxn ang="0">
                <a:pos x="connsiteX953" y="connsiteY953"/>
              </a:cxn>
              <a:cxn ang="0">
                <a:pos x="connsiteX954" y="connsiteY954"/>
              </a:cxn>
              <a:cxn ang="0">
                <a:pos x="connsiteX955" y="connsiteY955"/>
              </a:cxn>
              <a:cxn ang="0">
                <a:pos x="connsiteX956" y="connsiteY956"/>
              </a:cxn>
              <a:cxn ang="0">
                <a:pos x="connsiteX957" y="connsiteY957"/>
              </a:cxn>
              <a:cxn ang="0">
                <a:pos x="connsiteX958" y="connsiteY958"/>
              </a:cxn>
              <a:cxn ang="0">
                <a:pos x="connsiteX959" y="connsiteY959"/>
              </a:cxn>
              <a:cxn ang="0">
                <a:pos x="connsiteX960" y="connsiteY960"/>
              </a:cxn>
              <a:cxn ang="0">
                <a:pos x="connsiteX961" y="connsiteY961"/>
              </a:cxn>
              <a:cxn ang="0">
                <a:pos x="connsiteX962" y="connsiteY962"/>
              </a:cxn>
              <a:cxn ang="0">
                <a:pos x="connsiteX963" y="connsiteY963"/>
              </a:cxn>
              <a:cxn ang="0">
                <a:pos x="connsiteX964" y="connsiteY964"/>
              </a:cxn>
              <a:cxn ang="0">
                <a:pos x="connsiteX965" y="connsiteY965"/>
              </a:cxn>
              <a:cxn ang="0">
                <a:pos x="connsiteX966" y="connsiteY966"/>
              </a:cxn>
              <a:cxn ang="0">
                <a:pos x="connsiteX967" y="connsiteY967"/>
              </a:cxn>
              <a:cxn ang="0">
                <a:pos x="connsiteX968" y="connsiteY968"/>
              </a:cxn>
              <a:cxn ang="0">
                <a:pos x="connsiteX969" y="connsiteY969"/>
              </a:cxn>
              <a:cxn ang="0">
                <a:pos x="connsiteX970" y="connsiteY970"/>
              </a:cxn>
              <a:cxn ang="0">
                <a:pos x="connsiteX971" y="connsiteY971"/>
              </a:cxn>
              <a:cxn ang="0">
                <a:pos x="connsiteX972" y="connsiteY972"/>
              </a:cxn>
              <a:cxn ang="0">
                <a:pos x="connsiteX973" y="connsiteY973"/>
              </a:cxn>
              <a:cxn ang="0">
                <a:pos x="connsiteX974" y="connsiteY974"/>
              </a:cxn>
              <a:cxn ang="0">
                <a:pos x="connsiteX975" y="connsiteY975"/>
              </a:cxn>
              <a:cxn ang="0">
                <a:pos x="connsiteX976" y="connsiteY976"/>
              </a:cxn>
              <a:cxn ang="0">
                <a:pos x="connsiteX977" y="connsiteY977"/>
              </a:cxn>
              <a:cxn ang="0">
                <a:pos x="connsiteX978" y="connsiteY978"/>
              </a:cxn>
              <a:cxn ang="0">
                <a:pos x="connsiteX979" y="connsiteY979"/>
              </a:cxn>
              <a:cxn ang="0">
                <a:pos x="connsiteX980" y="connsiteY980"/>
              </a:cxn>
              <a:cxn ang="0">
                <a:pos x="connsiteX981" y="connsiteY981"/>
              </a:cxn>
              <a:cxn ang="0">
                <a:pos x="connsiteX982" y="connsiteY982"/>
              </a:cxn>
              <a:cxn ang="0">
                <a:pos x="connsiteX983" y="connsiteY983"/>
              </a:cxn>
              <a:cxn ang="0">
                <a:pos x="connsiteX984" y="connsiteY984"/>
              </a:cxn>
              <a:cxn ang="0">
                <a:pos x="connsiteX985" y="connsiteY985"/>
              </a:cxn>
              <a:cxn ang="0">
                <a:pos x="connsiteX986" y="connsiteY986"/>
              </a:cxn>
              <a:cxn ang="0">
                <a:pos x="connsiteX987" y="connsiteY987"/>
              </a:cxn>
              <a:cxn ang="0">
                <a:pos x="connsiteX988" y="connsiteY988"/>
              </a:cxn>
              <a:cxn ang="0">
                <a:pos x="connsiteX989" y="connsiteY989"/>
              </a:cxn>
              <a:cxn ang="0">
                <a:pos x="connsiteX990" y="connsiteY990"/>
              </a:cxn>
              <a:cxn ang="0">
                <a:pos x="connsiteX991" y="connsiteY991"/>
              </a:cxn>
              <a:cxn ang="0">
                <a:pos x="connsiteX992" y="connsiteY992"/>
              </a:cxn>
              <a:cxn ang="0">
                <a:pos x="connsiteX993" y="connsiteY993"/>
              </a:cxn>
              <a:cxn ang="0">
                <a:pos x="connsiteX994" y="connsiteY994"/>
              </a:cxn>
              <a:cxn ang="0">
                <a:pos x="connsiteX995" y="connsiteY995"/>
              </a:cxn>
              <a:cxn ang="0">
                <a:pos x="connsiteX996" y="connsiteY996"/>
              </a:cxn>
              <a:cxn ang="0">
                <a:pos x="connsiteX997" y="connsiteY997"/>
              </a:cxn>
              <a:cxn ang="0">
                <a:pos x="connsiteX998" y="connsiteY998"/>
              </a:cxn>
              <a:cxn ang="0">
                <a:pos x="connsiteX999" y="connsiteY999"/>
              </a:cxn>
              <a:cxn ang="0">
                <a:pos x="connsiteX1000" y="connsiteY1000"/>
              </a:cxn>
              <a:cxn ang="0">
                <a:pos x="connsiteX1001" y="connsiteY1001"/>
              </a:cxn>
              <a:cxn ang="0">
                <a:pos x="connsiteX1002" y="connsiteY1002"/>
              </a:cxn>
              <a:cxn ang="0">
                <a:pos x="connsiteX1003" y="connsiteY1003"/>
              </a:cxn>
              <a:cxn ang="0">
                <a:pos x="connsiteX1004" y="connsiteY1004"/>
              </a:cxn>
              <a:cxn ang="0">
                <a:pos x="connsiteX1005" y="connsiteY1005"/>
              </a:cxn>
              <a:cxn ang="0">
                <a:pos x="connsiteX1006" y="connsiteY1006"/>
              </a:cxn>
              <a:cxn ang="0">
                <a:pos x="connsiteX1007" y="connsiteY1007"/>
              </a:cxn>
              <a:cxn ang="0">
                <a:pos x="connsiteX1008" y="connsiteY1008"/>
              </a:cxn>
              <a:cxn ang="0">
                <a:pos x="connsiteX1009" y="connsiteY1009"/>
              </a:cxn>
              <a:cxn ang="0">
                <a:pos x="connsiteX1010" y="connsiteY1010"/>
              </a:cxn>
              <a:cxn ang="0">
                <a:pos x="connsiteX1011" y="connsiteY1011"/>
              </a:cxn>
              <a:cxn ang="0">
                <a:pos x="connsiteX1012" y="connsiteY1012"/>
              </a:cxn>
              <a:cxn ang="0">
                <a:pos x="connsiteX1013" y="connsiteY1013"/>
              </a:cxn>
              <a:cxn ang="0">
                <a:pos x="connsiteX1014" y="connsiteY1014"/>
              </a:cxn>
              <a:cxn ang="0">
                <a:pos x="connsiteX1015" y="connsiteY1015"/>
              </a:cxn>
              <a:cxn ang="0">
                <a:pos x="connsiteX1016" y="connsiteY1016"/>
              </a:cxn>
              <a:cxn ang="0">
                <a:pos x="connsiteX1017" y="connsiteY1017"/>
              </a:cxn>
              <a:cxn ang="0">
                <a:pos x="connsiteX1018" y="connsiteY1018"/>
              </a:cxn>
              <a:cxn ang="0">
                <a:pos x="connsiteX1019" y="connsiteY1019"/>
              </a:cxn>
              <a:cxn ang="0">
                <a:pos x="connsiteX1020" y="connsiteY1020"/>
              </a:cxn>
              <a:cxn ang="0">
                <a:pos x="connsiteX1021" y="connsiteY1021"/>
              </a:cxn>
              <a:cxn ang="0">
                <a:pos x="connsiteX1022" y="connsiteY1022"/>
              </a:cxn>
              <a:cxn ang="0">
                <a:pos x="connsiteX1023" y="connsiteY1023"/>
              </a:cxn>
              <a:cxn ang="0">
                <a:pos x="connsiteX1024" y="connsiteY1024"/>
              </a:cxn>
              <a:cxn ang="0">
                <a:pos x="connsiteX1025" y="connsiteY1025"/>
              </a:cxn>
              <a:cxn ang="0">
                <a:pos x="connsiteX1026" y="connsiteY1026"/>
              </a:cxn>
              <a:cxn ang="0">
                <a:pos x="connsiteX1027" y="connsiteY1027"/>
              </a:cxn>
              <a:cxn ang="0">
                <a:pos x="connsiteX1028" y="connsiteY1028"/>
              </a:cxn>
              <a:cxn ang="0">
                <a:pos x="connsiteX1029" y="connsiteY1029"/>
              </a:cxn>
              <a:cxn ang="0">
                <a:pos x="connsiteX1030" y="connsiteY1030"/>
              </a:cxn>
              <a:cxn ang="0">
                <a:pos x="connsiteX1031" y="connsiteY1031"/>
              </a:cxn>
              <a:cxn ang="0">
                <a:pos x="connsiteX1032" y="connsiteY1032"/>
              </a:cxn>
              <a:cxn ang="0">
                <a:pos x="connsiteX1033" y="connsiteY1033"/>
              </a:cxn>
              <a:cxn ang="0">
                <a:pos x="connsiteX1034" y="connsiteY1034"/>
              </a:cxn>
              <a:cxn ang="0">
                <a:pos x="connsiteX1035" y="connsiteY1035"/>
              </a:cxn>
              <a:cxn ang="0">
                <a:pos x="connsiteX1036" y="connsiteY1036"/>
              </a:cxn>
              <a:cxn ang="0">
                <a:pos x="connsiteX1037" y="connsiteY1037"/>
              </a:cxn>
              <a:cxn ang="0">
                <a:pos x="connsiteX1038" y="connsiteY1038"/>
              </a:cxn>
              <a:cxn ang="0">
                <a:pos x="connsiteX1039" y="connsiteY1039"/>
              </a:cxn>
              <a:cxn ang="0">
                <a:pos x="connsiteX1040" y="connsiteY1040"/>
              </a:cxn>
              <a:cxn ang="0">
                <a:pos x="connsiteX1041" y="connsiteY1041"/>
              </a:cxn>
              <a:cxn ang="0">
                <a:pos x="connsiteX1042" y="connsiteY1042"/>
              </a:cxn>
              <a:cxn ang="0">
                <a:pos x="connsiteX1043" y="connsiteY1043"/>
              </a:cxn>
              <a:cxn ang="0">
                <a:pos x="connsiteX1044" y="connsiteY1044"/>
              </a:cxn>
              <a:cxn ang="0">
                <a:pos x="connsiteX1045" y="connsiteY1045"/>
              </a:cxn>
              <a:cxn ang="0">
                <a:pos x="connsiteX1046" y="connsiteY1046"/>
              </a:cxn>
              <a:cxn ang="0">
                <a:pos x="connsiteX1047" y="connsiteY1047"/>
              </a:cxn>
              <a:cxn ang="0">
                <a:pos x="connsiteX1048" y="connsiteY1048"/>
              </a:cxn>
              <a:cxn ang="0">
                <a:pos x="connsiteX1049" y="connsiteY1049"/>
              </a:cxn>
              <a:cxn ang="0">
                <a:pos x="connsiteX1050" y="connsiteY1050"/>
              </a:cxn>
              <a:cxn ang="0">
                <a:pos x="connsiteX1051" y="connsiteY1051"/>
              </a:cxn>
              <a:cxn ang="0">
                <a:pos x="connsiteX1052" y="connsiteY1052"/>
              </a:cxn>
              <a:cxn ang="0">
                <a:pos x="connsiteX1053" y="connsiteY1053"/>
              </a:cxn>
              <a:cxn ang="0">
                <a:pos x="connsiteX1054" y="connsiteY1054"/>
              </a:cxn>
              <a:cxn ang="0">
                <a:pos x="connsiteX1055" y="connsiteY1055"/>
              </a:cxn>
              <a:cxn ang="0">
                <a:pos x="connsiteX1056" y="connsiteY1056"/>
              </a:cxn>
              <a:cxn ang="0">
                <a:pos x="connsiteX1057" y="connsiteY1057"/>
              </a:cxn>
              <a:cxn ang="0">
                <a:pos x="connsiteX1058" y="connsiteY1058"/>
              </a:cxn>
              <a:cxn ang="0">
                <a:pos x="connsiteX1059" y="connsiteY1059"/>
              </a:cxn>
              <a:cxn ang="0">
                <a:pos x="connsiteX1060" y="connsiteY1060"/>
              </a:cxn>
              <a:cxn ang="0">
                <a:pos x="connsiteX1061" y="connsiteY1061"/>
              </a:cxn>
              <a:cxn ang="0">
                <a:pos x="connsiteX1062" y="connsiteY1062"/>
              </a:cxn>
              <a:cxn ang="0">
                <a:pos x="connsiteX1063" y="connsiteY1063"/>
              </a:cxn>
              <a:cxn ang="0">
                <a:pos x="connsiteX1064" y="connsiteY1064"/>
              </a:cxn>
              <a:cxn ang="0">
                <a:pos x="connsiteX1065" y="connsiteY1065"/>
              </a:cxn>
              <a:cxn ang="0">
                <a:pos x="connsiteX1066" y="connsiteY1066"/>
              </a:cxn>
              <a:cxn ang="0">
                <a:pos x="connsiteX1067" y="connsiteY1067"/>
              </a:cxn>
              <a:cxn ang="0">
                <a:pos x="connsiteX1068" y="connsiteY1068"/>
              </a:cxn>
              <a:cxn ang="0">
                <a:pos x="connsiteX1069" y="connsiteY1069"/>
              </a:cxn>
              <a:cxn ang="0">
                <a:pos x="connsiteX1070" y="connsiteY1070"/>
              </a:cxn>
              <a:cxn ang="0">
                <a:pos x="connsiteX1071" y="connsiteY1071"/>
              </a:cxn>
              <a:cxn ang="0">
                <a:pos x="connsiteX1072" y="connsiteY1072"/>
              </a:cxn>
              <a:cxn ang="0">
                <a:pos x="connsiteX1073" y="connsiteY1073"/>
              </a:cxn>
              <a:cxn ang="0">
                <a:pos x="connsiteX1074" y="connsiteY1074"/>
              </a:cxn>
              <a:cxn ang="0">
                <a:pos x="connsiteX1075" y="connsiteY1075"/>
              </a:cxn>
              <a:cxn ang="0">
                <a:pos x="connsiteX1076" y="connsiteY1076"/>
              </a:cxn>
              <a:cxn ang="0">
                <a:pos x="connsiteX1077" y="connsiteY1077"/>
              </a:cxn>
              <a:cxn ang="0">
                <a:pos x="connsiteX1078" y="connsiteY1078"/>
              </a:cxn>
              <a:cxn ang="0">
                <a:pos x="connsiteX1079" y="connsiteY1079"/>
              </a:cxn>
              <a:cxn ang="0">
                <a:pos x="connsiteX1080" y="connsiteY1080"/>
              </a:cxn>
              <a:cxn ang="0">
                <a:pos x="connsiteX1081" y="connsiteY1081"/>
              </a:cxn>
              <a:cxn ang="0">
                <a:pos x="connsiteX1082" y="connsiteY1082"/>
              </a:cxn>
              <a:cxn ang="0">
                <a:pos x="connsiteX1083" y="connsiteY1083"/>
              </a:cxn>
              <a:cxn ang="0">
                <a:pos x="connsiteX1084" y="connsiteY1084"/>
              </a:cxn>
              <a:cxn ang="0">
                <a:pos x="connsiteX1085" y="connsiteY1085"/>
              </a:cxn>
              <a:cxn ang="0">
                <a:pos x="connsiteX1086" y="connsiteY1086"/>
              </a:cxn>
              <a:cxn ang="0">
                <a:pos x="connsiteX1087" y="connsiteY1087"/>
              </a:cxn>
              <a:cxn ang="0">
                <a:pos x="connsiteX1088" y="connsiteY1088"/>
              </a:cxn>
              <a:cxn ang="0">
                <a:pos x="connsiteX1089" y="connsiteY1089"/>
              </a:cxn>
              <a:cxn ang="0">
                <a:pos x="connsiteX1090" y="connsiteY1090"/>
              </a:cxn>
              <a:cxn ang="0">
                <a:pos x="connsiteX1091" y="connsiteY1091"/>
              </a:cxn>
              <a:cxn ang="0">
                <a:pos x="connsiteX1092" y="connsiteY1092"/>
              </a:cxn>
              <a:cxn ang="0">
                <a:pos x="connsiteX1093" y="connsiteY1093"/>
              </a:cxn>
              <a:cxn ang="0">
                <a:pos x="connsiteX1094" y="connsiteY1094"/>
              </a:cxn>
              <a:cxn ang="0">
                <a:pos x="connsiteX1095" y="connsiteY1095"/>
              </a:cxn>
              <a:cxn ang="0">
                <a:pos x="connsiteX1096" y="connsiteY1096"/>
              </a:cxn>
              <a:cxn ang="0">
                <a:pos x="connsiteX1097" y="connsiteY1097"/>
              </a:cxn>
              <a:cxn ang="0">
                <a:pos x="connsiteX1098" y="connsiteY1098"/>
              </a:cxn>
              <a:cxn ang="0">
                <a:pos x="connsiteX1099" y="connsiteY1099"/>
              </a:cxn>
              <a:cxn ang="0">
                <a:pos x="connsiteX1100" y="connsiteY1100"/>
              </a:cxn>
              <a:cxn ang="0">
                <a:pos x="connsiteX1101" y="connsiteY1101"/>
              </a:cxn>
              <a:cxn ang="0">
                <a:pos x="connsiteX1102" y="connsiteY1102"/>
              </a:cxn>
              <a:cxn ang="0">
                <a:pos x="connsiteX1103" y="connsiteY1103"/>
              </a:cxn>
            </a:cxnLst>
            <a:rect l="l" t="t" r="r" b="b"/>
            <a:pathLst>
              <a:path w="12191941" h="6857967">
                <a:moveTo>
                  <a:pt x="9042170" y="6474347"/>
                </a:moveTo>
                <a:lnTo>
                  <a:pt x="9042170" y="6545648"/>
                </a:lnTo>
                <a:lnTo>
                  <a:pt x="9113471" y="6545648"/>
                </a:lnTo>
                <a:lnTo>
                  <a:pt x="9113471" y="6474347"/>
                </a:lnTo>
                <a:close/>
                <a:moveTo>
                  <a:pt x="8899568" y="6474347"/>
                </a:moveTo>
                <a:lnTo>
                  <a:pt x="8899568" y="6545648"/>
                </a:lnTo>
                <a:lnTo>
                  <a:pt x="8970869" y="6545648"/>
                </a:lnTo>
                <a:lnTo>
                  <a:pt x="8970869" y="6474347"/>
                </a:lnTo>
                <a:close/>
                <a:moveTo>
                  <a:pt x="8756896" y="6474347"/>
                </a:moveTo>
                <a:lnTo>
                  <a:pt x="8756896" y="6545648"/>
                </a:lnTo>
                <a:lnTo>
                  <a:pt x="8828196" y="6545648"/>
                </a:lnTo>
                <a:lnTo>
                  <a:pt x="8828196" y="6474347"/>
                </a:lnTo>
                <a:close/>
                <a:moveTo>
                  <a:pt x="8614223" y="6474347"/>
                </a:moveTo>
                <a:lnTo>
                  <a:pt x="8614223" y="6545648"/>
                </a:lnTo>
                <a:lnTo>
                  <a:pt x="8685524" y="6545648"/>
                </a:lnTo>
                <a:lnTo>
                  <a:pt x="8685524" y="6474347"/>
                </a:lnTo>
                <a:close/>
                <a:moveTo>
                  <a:pt x="8471622" y="6474347"/>
                </a:moveTo>
                <a:lnTo>
                  <a:pt x="8471622" y="6545648"/>
                </a:lnTo>
                <a:lnTo>
                  <a:pt x="8542923" y="6545648"/>
                </a:lnTo>
                <a:lnTo>
                  <a:pt x="8542923" y="6474347"/>
                </a:lnTo>
                <a:close/>
                <a:moveTo>
                  <a:pt x="8328949" y="6474347"/>
                </a:moveTo>
                <a:lnTo>
                  <a:pt x="8328949" y="6545648"/>
                </a:lnTo>
                <a:lnTo>
                  <a:pt x="8400250" y="6545648"/>
                </a:lnTo>
                <a:lnTo>
                  <a:pt x="8400250" y="6474347"/>
                </a:lnTo>
                <a:close/>
                <a:moveTo>
                  <a:pt x="8186348" y="6474347"/>
                </a:moveTo>
                <a:lnTo>
                  <a:pt x="8186348" y="6545648"/>
                </a:lnTo>
                <a:lnTo>
                  <a:pt x="8257649" y="6545648"/>
                </a:lnTo>
                <a:lnTo>
                  <a:pt x="8257649" y="6474347"/>
                </a:lnTo>
                <a:close/>
                <a:moveTo>
                  <a:pt x="8043675" y="6474347"/>
                </a:moveTo>
                <a:lnTo>
                  <a:pt x="8043675" y="6545648"/>
                </a:lnTo>
                <a:lnTo>
                  <a:pt x="8114976" y="6545648"/>
                </a:lnTo>
                <a:lnTo>
                  <a:pt x="8114976" y="6474347"/>
                </a:lnTo>
                <a:close/>
                <a:moveTo>
                  <a:pt x="7901003" y="6474347"/>
                </a:moveTo>
                <a:lnTo>
                  <a:pt x="7901003" y="6545648"/>
                </a:lnTo>
                <a:lnTo>
                  <a:pt x="7972304" y="6545648"/>
                </a:lnTo>
                <a:lnTo>
                  <a:pt x="7972304" y="6474347"/>
                </a:lnTo>
                <a:close/>
                <a:moveTo>
                  <a:pt x="7758401" y="6474347"/>
                </a:moveTo>
                <a:lnTo>
                  <a:pt x="7758401" y="6545648"/>
                </a:lnTo>
                <a:lnTo>
                  <a:pt x="7829702" y="6545648"/>
                </a:lnTo>
                <a:lnTo>
                  <a:pt x="7829702" y="6474347"/>
                </a:lnTo>
                <a:close/>
                <a:moveTo>
                  <a:pt x="7615728" y="6474347"/>
                </a:moveTo>
                <a:lnTo>
                  <a:pt x="7615728" y="6545648"/>
                </a:lnTo>
                <a:lnTo>
                  <a:pt x="7687029" y="6545648"/>
                </a:lnTo>
                <a:lnTo>
                  <a:pt x="7687029" y="6474347"/>
                </a:lnTo>
                <a:close/>
                <a:moveTo>
                  <a:pt x="7473127" y="6474347"/>
                </a:moveTo>
                <a:lnTo>
                  <a:pt x="7473127" y="6545648"/>
                </a:lnTo>
                <a:lnTo>
                  <a:pt x="7544428" y="6545648"/>
                </a:lnTo>
                <a:lnTo>
                  <a:pt x="7544428" y="6474347"/>
                </a:lnTo>
                <a:close/>
                <a:moveTo>
                  <a:pt x="7330454" y="6474347"/>
                </a:moveTo>
                <a:lnTo>
                  <a:pt x="7330454" y="6545648"/>
                </a:lnTo>
                <a:lnTo>
                  <a:pt x="7401755" y="6545648"/>
                </a:lnTo>
                <a:lnTo>
                  <a:pt x="7401755" y="6474347"/>
                </a:lnTo>
                <a:close/>
                <a:moveTo>
                  <a:pt x="7187853" y="6474347"/>
                </a:moveTo>
                <a:lnTo>
                  <a:pt x="7187853" y="6545648"/>
                </a:lnTo>
                <a:lnTo>
                  <a:pt x="7259154" y="6545648"/>
                </a:lnTo>
                <a:lnTo>
                  <a:pt x="7259154" y="6474347"/>
                </a:lnTo>
                <a:close/>
                <a:moveTo>
                  <a:pt x="7045180" y="6474347"/>
                </a:moveTo>
                <a:lnTo>
                  <a:pt x="7045180" y="6545648"/>
                </a:lnTo>
                <a:lnTo>
                  <a:pt x="7116481" y="6545648"/>
                </a:lnTo>
                <a:lnTo>
                  <a:pt x="7116481" y="6474347"/>
                </a:lnTo>
                <a:close/>
                <a:moveTo>
                  <a:pt x="6902579" y="6474347"/>
                </a:moveTo>
                <a:lnTo>
                  <a:pt x="6902579" y="6545648"/>
                </a:lnTo>
                <a:lnTo>
                  <a:pt x="6973880" y="6545648"/>
                </a:lnTo>
                <a:lnTo>
                  <a:pt x="6973880" y="6474347"/>
                </a:lnTo>
                <a:close/>
                <a:moveTo>
                  <a:pt x="6759906" y="6474347"/>
                </a:moveTo>
                <a:lnTo>
                  <a:pt x="6759906" y="6545648"/>
                </a:lnTo>
                <a:lnTo>
                  <a:pt x="6831207" y="6545648"/>
                </a:lnTo>
                <a:lnTo>
                  <a:pt x="6831207" y="6474347"/>
                </a:lnTo>
                <a:close/>
                <a:moveTo>
                  <a:pt x="6617234" y="6474347"/>
                </a:moveTo>
                <a:lnTo>
                  <a:pt x="6617234" y="6545648"/>
                </a:lnTo>
                <a:lnTo>
                  <a:pt x="6688535" y="6545648"/>
                </a:lnTo>
                <a:lnTo>
                  <a:pt x="6688535" y="6474347"/>
                </a:lnTo>
                <a:close/>
                <a:moveTo>
                  <a:pt x="6474632" y="6474347"/>
                </a:moveTo>
                <a:lnTo>
                  <a:pt x="6474632" y="6545648"/>
                </a:lnTo>
                <a:lnTo>
                  <a:pt x="6545933" y="6545648"/>
                </a:lnTo>
                <a:lnTo>
                  <a:pt x="6545933" y="6474347"/>
                </a:lnTo>
                <a:close/>
                <a:moveTo>
                  <a:pt x="6331959" y="6474347"/>
                </a:moveTo>
                <a:lnTo>
                  <a:pt x="6331959" y="6545648"/>
                </a:lnTo>
                <a:lnTo>
                  <a:pt x="6403260" y="6545648"/>
                </a:lnTo>
                <a:lnTo>
                  <a:pt x="6403260" y="6474347"/>
                </a:lnTo>
                <a:close/>
                <a:moveTo>
                  <a:pt x="6189358" y="6474347"/>
                </a:moveTo>
                <a:lnTo>
                  <a:pt x="6189358" y="6545648"/>
                </a:lnTo>
                <a:lnTo>
                  <a:pt x="6260659" y="6545648"/>
                </a:lnTo>
                <a:lnTo>
                  <a:pt x="6260659" y="6474347"/>
                </a:lnTo>
                <a:close/>
                <a:moveTo>
                  <a:pt x="6046689" y="6474347"/>
                </a:moveTo>
                <a:lnTo>
                  <a:pt x="6046689" y="6545648"/>
                </a:lnTo>
                <a:lnTo>
                  <a:pt x="6117986" y="6545648"/>
                </a:lnTo>
                <a:lnTo>
                  <a:pt x="6117986" y="6474347"/>
                </a:lnTo>
                <a:close/>
                <a:moveTo>
                  <a:pt x="5904022" y="6474347"/>
                </a:moveTo>
                <a:lnTo>
                  <a:pt x="5904022" y="6545648"/>
                </a:lnTo>
                <a:lnTo>
                  <a:pt x="5975319" y="6545648"/>
                </a:lnTo>
                <a:lnTo>
                  <a:pt x="5975319" y="6474347"/>
                </a:lnTo>
                <a:close/>
                <a:moveTo>
                  <a:pt x="5761426" y="6474347"/>
                </a:moveTo>
                <a:lnTo>
                  <a:pt x="5761426" y="6545648"/>
                </a:lnTo>
                <a:lnTo>
                  <a:pt x="5832724" y="6545648"/>
                </a:lnTo>
                <a:lnTo>
                  <a:pt x="5832724" y="6474347"/>
                </a:lnTo>
                <a:close/>
                <a:moveTo>
                  <a:pt x="5618761" y="6474347"/>
                </a:moveTo>
                <a:lnTo>
                  <a:pt x="5618761" y="6545648"/>
                </a:lnTo>
                <a:lnTo>
                  <a:pt x="5690059" y="6545648"/>
                </a:lnTo>
                <a:lnTo>
                  <a:pt x="5690059" y="6474347"/>
                </a:lnTo>
                <a:close/>
                <a:moveTo>
                  <a:pt x="5476167" y="6474347"/>
                </a:moveTo>
                <a:lnTo>
                  <a:pt x="5476167" y="6545648"/>
                </a:lnTo>
                <a:lnTo>
                  <a:pt x="5547463" y="6545648"/>
                </a:lnTo>
                <a:lnTo>
                  <a:pt x="5547463" y="6474347"/>
                </a:lnTo>
                <a:close/>
                <a:moveTo>
                  <a:pt x="5333500" y="6474347"/>
                </a:moveTo>
                <a:lnTo>
                  <a:pt x="5333500" y="6545648"/>
                </a:lnTo>
                <a:lnTo>
                  <a:pt x="5404799" y="6545648"/>
                </a:lnTo>
                <a:lnTo>
                  <a:pt x="5404799" y="6474347"/>
                </a:lnTo>
                <a:close/>
                <a:moveTo>
                  <a:pt x="5190877" y="6474347"/>
                </a:moveTo>
                <a:lnTo>
                  <a:pt x="5190877" y="6545648"/>
                </a:lnTo>
                <a:lnTo>
                  <a:pt x="5262188" y="6545648"/>
                </a:lnTo>
                <a:lnTo>
                  <a:pt x="5262188" y="6474347"/>
                </a:lnTo>
                <a:close/>
                <a:moveTo>
                  <a:pt x="5048236" y="6474347"/>
                </a:moveTo>
                <a:lnTo>
                  <a:pt x="5048236" y="6545648"/>
                </a:lnTo>
                <a:lnTo>
                  <a:pt x="5119527" y="6545648"/>
                </a:lnTo>
                <a:lnTo>
                  <a:pt x="5119527" y="6474347"/>
                </a:lnTo>
                <a:close/>
                <a:moveTo>
                  <a:pt x="4906607" y="6474347"/>
                </a:moveTo>
                <a:lnTo>
                  <a:pt x="4906607" y="6545648"/>
                </a:lnTo>
                <a:lnTo>
                  <a:pt x="4977916" y="6545648"/>
                </a:lnTo>
                <a:lnTo>
                  <a:pt x="4977916" y="6474347"/>
                </a:lnTo>
                <a:close/>
                <a:moveTo>
                  <a:pt x="4764013" y="6474347"/>
                </a:moveTo>
                <a:lnTo>
                  <a:pt x="4764013" y="6545648"/>
                </a:lnTo>
                <a:lnTo>
                  <a:pt x="4835311" y="6545648"/>
                </a:lnTo>
                <a:lnTo>
                  <a:pt x="4835311" y="6474347"/>
                </a:lnTo>
                <a:close/>
                <a:moveTo>
                  <a:pt x="4621341" y="6474347"/>
                </a:moveTo>
                <a:lnTo>
                  <a:pt x="4621341" y="6545648"/>
                </a:lnTo>
                <a:lnTo>
                  <a:pt x="4692639" y="6545648"/>
                </a:lnTo>
                <a:lnTo>
                  <a:pt x="4692639" y="6474347"/>
                </a:lnTo>
                <a:close/>
                <a:moveTo>
                  <a:pt x="4478666" y="6474347"/>
                </a:moveTo>
                <a:lnTo>
                  <a:pt x="4478666" y="6545648"/>
                </a:lnTo>
                <a:lnTo>
                  <a:pt x="4549969" y="6545648"/>
                </a:lnTo>
                <a:lnTo>
                  <a:pt x="4549969" y="6474347"/>
                </a:lnTo>
                <a:close/>
                <a:moveTo>
                  <a:pt x="4336061" y="6474347"/>
                </a:moveTo>
                <a:lnTo>
                  <a:pt x="4336061" y="6545648"/>
                </a:lnTo>
                <a:lnTo>
                  <a:pt x="4407362" y="6545648"/>
                </a:lnTo>
                <a:lnTo>
                  <a:pt x="4407362" y="6474347"/>
                </a:lnTo>
                <a:close/>
                <a:moveTo>
                  <a:pt x="4193412" y="6474347"/>
                </a:moveTo>
                <a:lnTo>
                  <a:pt x="4193412" y="6545648"/>
                </a:lnTo>
                <a:lnTo>
                  <a:pt x="4264695" y="6545648"/>
                </a:lnTo>
                <a:lnTo>
                  <a:pt x="4264695" y="6474347"/>
                </a:lnTo>
                <a:close/>
                <a:moveTo>
                  <a:pt x="4050809" y="6474347"/>
                </a:moveTo>
                <a:lnTo>
                  <a:pt x="4050809" y="6545648"/>
                </a:lnTo>
                <a:lnTo>
                  <a:pt x="4122113" y="6545648"/>
                </a:lnTo>
                <a:lnTo>
                  <a:pt x="4122113" y="6474347"/>
                </a:lnTo>
                <a:close/>
                <a:moveTo>
                  <a:pt x="3908136" y="6474347"/>
                </a:moveTo>
                <a:lnTo>
                  <a:pt x="3908136" y="6545648"/>
                </a:lnTo>
                <a:lnTo>
                  <a:pt x="3979438" y="6545648"/>
                </a:lnTo>
                <a:lnTo>
                  <a:pt x="3979438" y="6474347"/>
                </a:lnTo>
                <a:close/>
                <a:moveTo>
                  <a:pt x="3765462" y="6474347"/>
                </a:moveTo>
                <a:lnTo>
                  <a:pt x="3765462" y="6545648"/>
                </a:lnTo>
                <a:lnTo>
                  <a:pt x="3836763" y="6545648"/>
                </a:lnTo>
                <a:lnTo>
                  <a:pt x="3836763" y="6474347"/>
                </a:lnTo>
                <a:close/>
                <a:moveTo>
                  <a:pt x="3622851" y="6474347"/>
                </a:moveTo>
                <a:lnTo>
                  <a:pt x="3622851" y="6545648"/>
                </a:lnTo>
                <a:lnTo>
                  <a:pt x="3694151" y="6545648"/>
                </a:lnTo>
                <a:lnTo>
                  <a:pt x="3694151" y="6474347"/>
                </a:lnTo>
                <a:close/>
                <a:moveTo>
                  <a:pt x="3480203" y="6474347"/>
                </a:moveTo>
                <a:lnTo>
                  <a:pt x="3480203" y="6545648"/>
                </a:lnTo>
                <a:lnTo>
                  <a:pt x="3551509" y="6545648"/>
                </a:lnTo>
                <a:lnTo>
                  <a:pt x="3551509" y="6474347"/>
                </a:lnTo>
                <a:close/>
                <a:moveTo>
                  <a:pt x="3337579" y="6474347"/>
                </a:moveTo>
                <a:lnTo>
                  <a:pt x="3337579" y="6545648"/>
                </a:lnTo>
                <a:lnTo>
                  <a:pt x="3408880" y="6545648"/>
                </a:lnTo>
                <a:lnTo>
                  <a:pt x="3408880" y="6474347"/>
                </a:lnTo>
                <a:close/>
                <a:moveTo>
                  <a:pt x="3194905" y="6474347"/>
                </a:moveTo>
                <a:lnTo>
                  <a:pt x="3194905" y="6545648"/>
                </a:lnTo>
                <a:lnTo>
                  <a:pt x="3266206" y="6545648"/>
                </a:lnTo>
                <a:lnTo>
                  <a:pt x="3266206" y="6474347"/>
                </a:lnTo>
                <a:close/>
                <a:moveTo>
                  <a:pt x="3052304" y="6474347"/>
                </a:moveTo>
                <a:lnTo>
                  <a:pt x="3052304" y="6545648"/>
                </a:lnTo>
                <a:lnTo>
                  <a:pt x="3123606" y="6545648"/>
                </a:lnTo>
                <a:lnTo>
                  <a:pt x="3123606" y="6474347"/>
                </a:lnTo>
                <a:close/>
                <a:moveTo>
                  <a:pt x="2909633" y="6474347"/>
                </a:moveTo>
                <a:lnTo>
                  <a:pt x="2909633" y="6545648"/>
                </a:lnTo>
                <a:lnTo>
                  <a:pt x="2980934" y="6545648"/>
                </a:lnTo>
                <a:lnTo>
                  <a:pt x="2980934" y="6474347"/>
                </a:lnTo>
                <a:close/>
                <a:moveTo>
                  <a:pt x="2767033" y="6474347"/>
                </a:moveTo>
                <a:lnTo>
                  <a:pt x="2767033" y="6545648"/>
                </a:lnTo>
                <a:lnTo>
                  <a:pt x="2838334" y="6545648"/>
                </a:lnTo>
                <a:lnTo>
                  <a:pt x="2838334" y="6474347"/>
                </a:lnTo>
                <a:close/>
                <a:moveTo>
                  <a:pt x="2624360" y="6474347"/>
                </a:moveTo>
                <a:lnTo>
                  <a:pt x="2624360" y="6545648"/>
                </a:lnTo>
                <a:lnTo>
                  <a:pt x="2695661" y="6545648"/>
                </a:lnTo>
                <a:lnTo>
                  <a:pt x="2695661" y="6474347"/>
                </a:lnTo>
                <a:close/>
                <a:moveTo>
                  <a:pt x="2481690" y="6474347"/>
                </a:moveTo>
                <a:lnTo>
                  <a:pt x="2481690" y="6545648"/>
                </a:lnTo>
                <a:lnTo>
                  <a:pt x="2552990" y="6545648"/>
                </a:lnTo>
                <a:lnTo>
                  <a:pt x="2552990" y="6474347"/>
                </a:lnTo>
                <a:close/>
                <a:moveTo>
                  <a:pt x="2339090" y="6474347"/>
                </a:moveTo>
                <a:lnTo>
                  <a:pt x="2339090" y="6545648"/>
                </a:lnTo>
                <a:lnTo>
                  <a:pt x="2410390" y="6545648"/>
                </a:lnTo>
                <a:lnTo>
                  <a:pt x="2410390" y="6474347"/>
                </a:lnTo>
                <a:close/>
                <a:moveTo>
                  <a:pt x="2196420" y="6474347"/>
                </a:moveTo>
                <a:lnTo>
                  <a:pt x="2196420" y="6545648"/>
                </a:lnTo>
                <a:lnTo>
                  <a:pt x="2267720" y="6545648"/>
                </a:lnTo>
                <a:lnTo>
                  <a:pt x="2267720" y="6474347"/>
                </a:lnTo>
                <a:close/>
                <a:moveTo>
                  <a:pt x="2053813" y="6474347"/>
                </a:moveTo>
                <a:lnTo>
                  <a:pt x="2053813" y="6545648"/>
                </a:lnTo>
                <a:lnTo>
                  <a:pt x="2125117" y="6545648"/>
                </a:lnTo>
                <a:lnTo>
                  <a:pt x="2125117" y="6474347"/>
                </a:lnTo>
                <a:close/>
                <a:moveTo>
                  <a:pt x="1911141" y="6474347"/>
                </a:moveTo>
                <a:lnTo>
                  <a:pt x="1911141" y="6545648"/>
                </a:lnTo>
                <a:lnTo>
                  <a:pt x="1982442" y="6545648"/>
                </a:lnTo>
                <a:lnTo>
                  <a:pt x="1982442" y="6474347"/>
                </a:lnTo>
                <a:close/>
                <a:moveTo>
                  <a:pt x="1768470" y="6474347"/>
                </a:moveTo>
                <a:lnTo>
                  <a:pt x="1768470" y="6545648"/>
                </a:lnTo>
                <a:lnTo>
                  <a:pt x="1839771" y="6545648"/>
                </a:lnTo>
                <a:lnTo>
                  <a:pt x="1839771" y="6474347"/>
                </a:lnTo>
                <a:close/>
                <a:moveTo>
                  <a:pt x="1625870" y="6474347"/>
                </a:moveTo>
                <a:lnTo>
                  <a:pt x="1625870" y="6545648"/>
                </a:lnTo>
                <a:lnTo>
                  <a:pt x="1697170" y="6545648"/>
                </a:lnTo>
                <a:lnTo>
                  <a:pt x="1697170" y="6474347"/>
                </a:lnTo>
                <a:close/>
                <a:moveTo>
                  <a:pt x="1483199" y="6474347"/>
                </a:moveTo>
                <a:lnTo>
                  <a:pt x="1483199" y="6545648"/>
                </a:lnTo>
                <a:lnTo>
                  <a:pt x="1554500" y="6545648"/>
                </a:lnTo>
                <a:lnTo>
                  <a:pt x="1554500" y="6474347"/>
                </a:lnTo>
                <a:close/>
                <a:moveTo>
                  <a:pt x="1340599" y="6474347"/>
                </a:moveTo>
                <a:lnTo>
                  <a:pt x="1340599" y="6545648"/>
                </a:lnTo>
                <a:lnTo>
                  <a:pt x="1411899" y="6545648"/>
                </a:lnTo>
                <a:lnTo>
                  <a:pt x="1411899" y="6474347"/>
                </a:lnTo>
                <a:close/>
                <a:moveTo>
                  <a:pt x="1197929" y="6474347"/>
                </a:moveTo>
                <a:lnTo>
                  <a:pt x="1197929" y="6545648"/>
                </a:lnTo>
                <a:lnTo>
                  <a:pt x="1269230" y="6545648"/>
                </a:lnTo>
                <a:lnTo>
                  <a:pt x="1269230" y="6474347"/>
                </a:lnTo>
                <a:close/>
                <a:moveTo>
                  <a:pt x="1055311" y="6474347"/>
                </a:moveTo>
                <a:lnTo>
                  <a:pt x="1055311" y="6545648"/>
                </a:lnTo>
                <a:lnTo>
                  <a:pt x="1126612" y="6545648"/>
                </a:lnTo>
                <a:lnTo>
                  <a:pt x="1126612" y="6474347"/>
                </a:lnTo>
                <a:close/>
                <a:moveTo>
                  <a:pt x="912657" y="6474347"/>
                </a:moveTo>
                <a:lnTo>
                  <a:pt x="912657" y="6545648"/>
                </a:lnTo>
                <a:lnTo>
                  <a:pt x="983958" y="6545648"/>
                </a:lnTo>
                <a:lnTo>
                  <a:pt x="983958" y="6474347"/>
                </a:lnTo>
                <a:close/>
                <a:moveTo>
                  <a:pt x="771135" y="6474347"/>
                </a:moveTo>
                <a:lnTo>
                  <a:pt x="771135" y="6545648"/>
                </a:lnTo>
                <a:lnTo>
                  <a:pt x="842436" y="6545648"/>
                </a:lnTo>
                <a:lnTo>
                  <a:pt x="842436" y="6474347"/>
                </a:lnTo>
                <a:close/>
                <a:moveTo>
                  <a:pt x="628534" y="6474347"/>
                </a:moveTo>
                <a:lnTo>
                  <a:pt x="628534" y="6545648"/>
                </a:lnTo>
                <a:lnTo>
                  <a:pt x="699835" y="6545648"/>
                </a:lnTo>
                <a:lnTo>
                  <a:pt x="699835" y="6474347"/>
                </a:lnTo>
                <a:close/>
                <a:moveTo>
                  <a:pt x="485863" y="6474347"/>
                </a:moveTo>
                <a:lnTo>
                  <a:pt x="485863" y="6545648"/>
                </a:lnTo>
                <a:lnTo>
                  <a:pt x="557163" y="6545648"/>
                </a:lnTo>
                <a:lnTo>
                  <a:pt x="557163" y="6474347"/>
                </a:lnTo>
                <a:close/>
                <a:moveTo>
                  <a:pt x="343191" y="6474347"/>
                </a:moveTo>
                <a:lnTo>
                  <a:pt x="343191" y="6545648"/>
                </a:lnTo>
                <a:lnTo>
                  <a:pt x="414492" y="6545648"/>
                </a:lnTo>
                <a:lnTo>
                  <a:pt x="414492" y="6474347"/>
                </a:lnTo>
                <a:close/>
                <a:moveTo>
                  <a:pt x="200587" y="6474347"/>
                </a:moveTo>
                <a:lnTo>
                  <a:pt x="200587" y="6545648"/>
                </a:lnTo>
                <a:lnTo>
                  <a:pt x="271888" y="6545648"/>
                </a:lnTo>
                <a:lnTo>
                  <a:pt x="271888" y="6474347"/>
                </a:lnTo>
                <a:close/>
                <a:moveTo>
                  <a:pt x="57918" y="6474347"/>
                </a:moveTo>
                <a:lnTo>
                  <a:pt x="57918" y="6545648"/>
                </a:lnTo>
                <a:lnTo>
                  <a:pt x="129219" y="6545648"/>
                </a:lnTo>
                <a:lnTo>
                  <a:pt x="129219" y="6474347"/>
                </a:lnTo>
                <a:close/>
                <a:moveTo>
                  <a:pt x="10040665" y="6325709"/>
                </a:moveTo>
                <a:lnTo>
                  <a:pt x="10040665" y="6397010"/>
                </a:lnTo>
                <a:lnTo>
                  <a:pt x="10111966" y="6397010"/>
                </a:lnTo>
                <a:lnTo>
                  <a:pt x="10111966" y="6325709"/>
                </a:lnTo>
                <a:close/>
                <a:moveTo>
                  <a:pt x="9898063" y="6325709"/>
                </a:moveTo>
                <a:lnTo>
                  <a:pt x="9898063" y="6397010"/>
                </a:lnTo>
                <a:lnTo>
                  <a:pt x="9969363" y="6397010"/>
                </a:lnTo>
                <a:lnTo>
                  <a:pt x="9969363" y="6325709"/>
                </a:lnTo>
                <a:close/>
                <a:moveTo>
                  <a:pt x="9755391" y="6325709"/>
                </a:moveTo>
                <a:lnTo>
                  <a:pt x="9755391" y="6397010"/>
                </a:lnTo>
                <a:lnTo>
                  <a:pt x="9826692" y="6397010"/>
                </a:lnTo>
                <a:lnTo>
                  <a:pt x="9826692" y="6325709"/>
                </a:lnTo>
                <a:close/>
                <a:moveTo>
                  <a:pt x="9612718" y="6325709"/>
                </a:moveTo>
                <a:lnTo>
                  <a:pt x="9612718" y="6397010"/>
                </a:lnTo>
                <a:lnTo>
                  <a:pt x="9684019" y="6397010"/>
                </a:lnTo>
                <a:lnTo>
                  <a:pt x="9684019" y="6325709"/>
                </a:lnTo>
                <a:close/>
                <a:moveTo>
                  <a:pt x="9470117" y="6325709"/>
                </a:moveTo>
                <a:lnTo>
                  <a:pt x="9470117" y="6397010"/>
                </a:lnTo>
                <a:lnTo>
                  <a:pt x="9541417" y="6397010"/>
                </a:lnTo>
                <a:lnTo>
                  <a:pt x="9541417" y="6325709"/>
                </a:lnTo>
                <a:close/>
                <a:moveTo>
                  <a:pt x="9327444" y="6325709"/>
                </a:moveTo>
                <a:lnTo>
                  <a:pt x="9327444" y="6397010"/>
                </a:lnTo>
                <a:lnTo>
                  <a:pt x="9398745" y="6397010"/>
                </a:lnTo>
                <a:lnTo>
                  <a:pt x="9398745" y="6325709"/>
                </a:lnTo>
                <a:close/>
                <a:moveTo>
                  <a:pt x="9184842" y="6325709"/>
                </a:moveTo>
                <a:lnTo>
                  <a:pt x="9184842" y="6397010"/>
                </a:lnTo>
                <a:lnTo>
                  <a:pt x="9256143" y="6397010"/>
                </a:lnTo>
                <a:lnTo>
                  <a:pt x="9256143" y="6325709"/>
                </a:lnTo>
                <a:close/>
                <a:moveTo>
                  <a:pt x="9042170" y="6325709"/>
                </a:moveTo>
                <a:lnTo>
                  <a:pt x="9042170" y="6397010"/>
                </a:lnTo>
                <a:lnTo>
                  <a:pt x="9113471" y="6397010"/>
                </a:lnTo>
                <a:lnTo>
                  <a:pt x="9113471" y="6325709"/>
                </a:lnTo>
                <a:close/>
                <a:moveTo>
                  <a:pt x="8899568" y="6325709"/>
                </a:moveTo>
                <a:lnTo>
                  <a:pt x="8899568" y="6397010"/>
                </a:lnTo>
                <a:lnTo>
                  <a:pt x="8970869" y="6397010"/>
                </a:lnTo>
                <a:lnTo>
                  <a:pt x="8970869" y="6325709"/>
                </a:lnTo>
                <a:close/>
                <a:moveTo>
                  <a:pt x="8756896" y="6325709"/>
                </a:moveTo>
                <a:lnTo>
                  <a:pt x="8756896" y="6397010"/>
                </a:lnTo>
                <a:lnTo>
                  <a:pt x="8828196" y="6397010"/>
                </a:lnTo>
                <a:lnTo>
                  <a:pt x="8828196" y="6325709"/>
                </a:lnTo>
                <a:close/>
                <a:moveTo>
                  <a:pt x="8614223" y="6325709"/>
                </a:moveTo>
                <a:lnTo>
                  <a:pt x="8614223" y="6397010"/>
                </a:lnTo>
                <a:lnTo>
                  <a:pt x="8685524" y="6397010"/>
                </a:lnTo>
                <a:lnTo>
                  <a:pt x="8685524" y="6325709"/>
                </a:lnTo>
                <a:close/>
                <a:moveTo>
                  <a:pt x="8471622" y="6325709"/>
                </a:moveTo>
                <a:lnTo>
                  <a:pt x="8471622" y="6397010"/>
                </a:lnTo>
                <a:lnTo>
                  <a:pt x="8542923" y="6397010"/>
                </a:lnTo>
                <a:lnTo>
                  <a:pt x="8542923" y="6325709"/>
                </a:lnTo>
                <a:close/>
                <a:moveTo>
                  <a:pt x="8328949" y="6325709"/>
                </a:moveTo>
                <a:lnTo>
                  <a:pt x="8328949" y="6397010"/>
                </a:lnTo>
                <a:lnTo>
                  <a:pt x="8400250" y="6397010"/>
                </a:lnTo>
                <a:lnTo>
                  <a:pt x="8400250" y="6325709"/>
                </a:lnTo>
                <a:close/>
                <a:moveTo>
                  <a:pt x="8186348" y="6325709"/>
                </a:moveTo>
                <a:lnTo>
                  <a:pt x="8186348" y="6397010"/>
                </a:lnTo>
                <a:lnTo>
                  <a:pt x="8257649" y="6397010"/>
                </a:lnTo>
                <a:lnTo>
                  <a:pt x="8257649" y="6325709"/>
                </a:lnTo>
                <a:close/>
                <a:moveTo>
                  <a:pt x="8043675" y="6325709"/>
                </a:moveTo>
                <a:lnTo>
                  <a:pt x="8043675" y="6397010"/>
                </a:lnTo>
                <a:lnTo>
                  <a:pt x="8114976" y="6397010"/>
                </a:lnTo>
                <a:lnTo>
                  <a:pt x="8114976" y="6325709"/>
                </a:lnTo>
                <a:close/>
                <a:moveTo>
                  <a:pt x="7901003" y="6325709"/>
                </a:moveTo>
                <a:lnTo>
                  <a:pt x="7901003" y="6397010"/>
                </a:lnTo>
                <a:lnTo>
                  <a:pt x="7972304" y="6397010"/>
                </a:lnTo>
                <a:lnTo>
                  <a:pt x="7972304" y="6325709"/>
                </a:lnTo>
                <a:close/>
                <a:moveTo>
                  <a:pt x="7758401" y="6325709"/>
                </a:moveTo>
                <a:lnTo>
                  <a:pt x="7758401" y="6397010"/>
                </a:lnTo>
                <a:lnTo>
                  <a:pt x="7829702" y="6397010"/>
                </a:lnTo>
                <a:lnTo>
                  <a:pt x="7829702" y="6325709"/>
                </a:lnTo>
                <a:close/>
                <a:moveTo>
                  <a:pt x="7615728" y="6325709"/>
                </a:moveTo>
                <a:lnTo>
                  <a:pt x="7615728" y="6397010"/>
                </a:lnTo>
                <a:lnTo>
                  <a:pt x="7687029" y="6397010"/>
                </a:lnTo>
                <a:lnTo>
                  <a:pt x="7687029" y="6325709"/>
                </a:lnTo>
                <a:close/>
                <a:moveTo>
                  <a:pt x="7473127" y="6325709"/>
                </a:moveTo>
                <a:lnTo>
                  <a:pt x="7473127" y="6397010"/>
                </a:lnTo>
                <a:lnTo>
                  <a:pt x="7544428" y="6397010"/>
                </a:lnTo>
                <a:lnTo>
                  <a:pt x="7544428" y="6325709"/>
                </a:lnTo>
                <a:close/>
                <a:moveTo>
                  <a:pt x="7330454" y="6325709"/>
                </a:moveTo>
                <a:lnTo>
                  <a:pt x="7330454" y="6397010"/>
                </a:lnTo>
                <a:lnTo>
                  <a:pt x="7401755" y="6397010"/>
                </a:lnTo>
                <a:lnTo>
                  <a:pt x="7401755" y="6325709"/>
                </a:lnTo>
                <a:close/>
                <a:moveTo>
                  <a:pt x="7187853" y="6325709"/>
                </a:moveTo>
                <a:lnTo>
                  <a:pt x="7187853" y="6397010"/>
                </a:lnTo>
                <a:lnTo>
                  <a:pt x="7259154" y="6397010"/>
                </a:lnTo>
                <a:lnTo>
                  <a:pt x="7259154" y="6325709"/>
                </a:lnTo>
                <a:close/>
                <a:moveTo>
                  <a:pt x="7045180" y="6325709"/>
                </a:moveTo>
                <a:lnTo>
                  <a:pt x="7045180" y="6397010"/>
                </a:lnTo>
                <a:lnTo>
                  <a:pt x="7116481" y="6397010"/>
                </a:lnTo>
                <a:lnTo>
                  <a:pt x="7116481" y="6325709"/>
                </a:lnTo>
                <a:close/>
                <a:moveTo>
                  <a:pt x="6902579" y="6325709"/>
                </a:moveTo>
                <a:lnTo>
                  <a:pt x="6902579" y="6397010"/>
                </a:lnTo>
                <a:lnTo>
                  <a:pt x="6973880" y="6397010"/>
                </a:lnTo>
                <a:lnTo>
                  <a:pt x="6973880" y="6325709"/>
                </a:lnTo>
                <a:close/>
                <a:moveTo>
                  <a:pt x="6759906" y="6325709"/>
                </a:moveTo>
                <a:lnTo>
                  <a:pt x="6759906" y="6397010"/>
                </a:lnTo>
                <a:lnTo>
                  <a:pt x="6831207" y="6397010"/>
                </a:lnTo>
                <a:lnTo>
                  <a:pt x="6831207" y="6325709"/>
                </a:lnTo>
                <a:close/>
                <a:moveTo>
                  <a:pt x="6617234" y="6325709"/>
                </a:moveTo>
                <a:lnTo>
                  <a:pt x="6617234" y="6397010"/>
                </a:lnTo>
                <a:lnTo>
                  <a:pt x="6688535" y="6397010"/>
                </a:lnTo>
                <a:lnTo>
                  <a:pt x="6688535" y="6325709"/>
                </a:lnTo>
                <a:close/>
                <a:moveTo>
                  <a:pt x="6474632" y="6325709"/>
                </a:moveTo>
                <a:lnTo>
                  <a:pt x="6474632" y="6397010"/>
                </a:lnTo>
                <a:lnTo>
                  <a:pt x="6545933" y="6397010"/>
                </a:lnTo>
                <a:lnTo>
                  <a:pt x="6545933" y="6325709"/>
                </a:lnTo>
                <a:close/>
                <a:moveTo>
                  <a:pt x="6331959" y="6325709"/>
                </a:moveTo>
                <a:lnTo>
                  <a:pt x="6331959" y="6397010"/>
                </a:lnTo>
                <a:lnTo>
                  <a:pt x="6403260" y="6397010"/>
                </a:lnTo>
                <a:lnTo>
                  <a:pt x="6403260" y="6325709"/>
                </a:lnTo>
                <a:close/>
                <a:moveTo>
                  <a:pt x="6189358" y="6325709"/>
                </a:moveTo>
                <a:lnTo>
                  <a:pt x="6189358" y="6397010"/>
                </a:lnTo>
                <a:lnTo>
                  <a:pt x="6260659" y="6397010"/>
                </a:lnTo>
                <a:lnTo>
                  <a:pt x="6260659" y="6325709"/>
                </a:lnTo>
                <a:close/>
                <a:moveTo>
                  <a:pt x="6046689" y="6325709"/>
                </a:moveTo>
                <a:lnTo>
                  <a:pt x="6046689" y="6397010"/>
                </a:lnTo>
                <a:lnTo>
                  <a:pt x="6117986" y="6397010"/>
                </a:lnTo>
                <a:lnTo>
                  <a:pt x="6117986" y="6325709"/>
                </a:lnTo>
                <a:close/>
                <a:moveTo>
                  <a:pt x="5904022" y="6325709"/>
                </a:moveTo>
                <a:lnTo>
                  <a:pt x="5904022" y="6397010"/>
                </a:lnTo>
                <a:lnTo>
                  <a:pt x="5975319" y="6397010"/>
                </a:lnTo>
                <a:lnTo>
                  <a:pt x="5975319" y="6325709"/>
                </a:lnTo>
                <a:close/>
                <a:moveTo>
                  <a:pt x="5761426" y="6325709"/>
                </a:moveTo>
                <a:lnTo>
                  <a:pt x="5761426" y="6397010"/>
                </a:lnTo>
                <a:lnTo>
                  <a:pt x="5832724" y="6397010"/>
                </a:lnTo>
                <a:lnTo>
                  <a:pt x="5832724" y="6325709"/>
                </a:lnTo>
                <a:close/>
                <a:moveTo>
                  <a:pt x="5618761" y="6325709"/>
                </a:moveTo>
                <a:lnTo>
                  <a:pt x="5618761" y="6397010"/>
                </a:lnTo>
                <a:lnTo>
                  <a:pt x="5690059" y="6397010"/>
                </a:lnTo>
                <a:lnTo>
                  <a:pt x="5690059" y="6325709"/>
                </a:lnTo>
                <a:close/>
                <a:moveTo>
                  <a:pt x="5476167" y="6325709"/>
                </a:moveTo>
                <a:lnTo>
                  <a:pt x="5476167" y="6397010"/>
                </a:lnTo>
                <a:lnTo>
                  <a:pt x="5547465" y="6397010"/>
                </a:lnTo>
                <a:lnTo>
                  <a:pt x="5547465" y="6325709"/>
                </a:lnTo>
                <a:close/>
                <a:moveTo>
                  <a:pt x="5333500" y="6325709"/>
                </a:moveTo>
                <a:lnTo>
                  <a:pt x="5333500" y="6397010"/>
                </a:lnTo>
                <a:lnTo>
                  <a:pt x="5404799" y="6397010"/>
                </a:lnTo>
                <a:lnTo>
                  <a:pt x="5404799" y="6325709"/>
                </a:lnTo>
                <a:close/>
                <a:moveTo>
                  <a:pt x="5190877" y="6325709"/>
                </a:moveTo>
                <a:lnTo>
                  <a:pt x="5190877" y="6397010"/>
                </a:lnTo>
                <a:lnTo>
                  <a:pt x="5262188" y="6397010"/>
                </a:lnTo>
                <a:lnTo>
                  <a:pt x="5262188" y="6325709"/>
                </a:lnTo>
                <a:close/>
                <a:moveTo>
                  <a:pt x="5048236" y="6325709"/>
                </a:moveTo>
                <a:lnTo>
                  <a:pt x="5048236" y="6397010"/>
                </a:lnTo>
                <a:lnTo>
                  <a:pt x="5119527" y="6397010"/>
                </a:lnTo>
                <a:lnTo>
                  <a:pt x="5119527" y="6325709"/>
                </a:lnTo>
                <a:close/>
                <a:moveTo>
                  <a:pt x="4906607" y="6325709"/>
                </a:moveTo>
                <a:lnTo>
                  <a:pt x="4906607" y="6397010"/>
                </a:lnTo>
                <a:lnTo>
                  <a:pt x="4977916" y="6397010"/>
                </a:lnTo>
                <a:lnTo>
                  <a:pt x="4977916" y="6325709"/>
                </a:lnTo>
                <a:close/>
                <a:moveTo>
                  <a:pt x="4764013" y="6325709"/>
                </a:moveTo>
                <a:lnTo>
                  <a:pt x="4764013" y="6397010"/>
                </a:lnTo>
                <a:lnTo>
                  <a:pt x="4835311" y="6397010"/>
                </a:lnTo>
                <a:lnTo>
                  <a:pt x="4835311" y="6325709"/>
                </a:lnTo>
                <a:close/>
                <a:moveTo>
                  <a:pt x="4621341" y="6325709"/>
                </a:moveTo>
                <a:lnTo>
                  <a:pt x="4621341" y="6397010"/>
                </a:lnTo>
                <a:lnTo>
                  <a:pt x="4692639" y="6397010"/>
                </a:lnTo>
                <a:lnTo>
                  <a:pt x="4692639" y="6325709"/>
                </a:lnTo>
                <a:close/>
                <a:moveTo>
                  <a:pt x="4478666" y="6325709"/>
                </a:moveTo>
                <a:lnTo>
                  <a:pt x="4478666" y="6397010"/>
                </a:lnTo>
                <a:lnTo>
                  <a:pt x="4549969" y="6397010"/>
                </a:lnTo>
                <a:lnTo>
                  <a:pt x="4549969" y="6325709"/>
                </a:lnTo>
                <a:close/>
                <a:moveTo>
                  <a:pt x="4336067" y="6325709"/>
                </a:moveTo>
                <a:lnTo>
                  <a:pt x="4336067" y="6397010"/>
                </a:lnTo>
                <a:lnTo>
                  <a:pt x="4407366" y="6397010"/>
                </a:lnTo>
                <a:lnTo>
                  <a:pt x="4407366" y="6325709"/>
                </a:lnTo>
                <a:close/>
                <a:moveTo>
                  <a:pt x="4193413" y="6325709"/>
                </a:moveTo>
                <a:lnTo>
                  <a:pt x="4193413" y="6397010"/>
                </a:lnTo>
                <a:lnTo>
                  <a:pt x="4264695" y="6397010"/>
                </a:lnTo>
                <a:lnTo>
                  <a:pt x="4264695" y="6325709"/>
                </a:lnTo>
                <a:close/>
                <a:moveTo>
                  <a:pt x="4050810" y="6325709"/>
                </a:moveTo>
                <a:lnTo>
                  <a:pt x="4050810" y="6397010"/>
                </a:lnTo>
                <a:lnTo>
                  <a:pt x="4122113" y="6397010"/>
                </a:lnTo>
                <a:lnTo>
                  <a:pt x="4122113" y="6325709"/>
                </a:lnTo>
                <a:close/>
                <a:moveTo>
                  <a:pt x="3908136" y="6325709"/>
                </a:moveTo>
                <a:lnTo>
                  <a:pt x="3908136" y="6397010"/>
                </a:lnTo>
                <a:lnTo>
                  <a:pt x="3979438" y="6397010"/>
                </a:lnTo>
                <a:lnTo>
                  <a:pt x="3979438" y="6325709"/>
                </a:lnTo>
                <a:close/>
                <a:moveTo>
                  <a:pt x="3765462" y="6325709"/>
                </a:moveTo>
                <a:lnTo>
                  <a:pt x="3765462" y="6397010"/>
                </a:lnTo>
                <a:lnTo>
                  <a:pt x="3836763" y="6397010"/>
                </a:lnTo>
                <a:lnTo>
                  <a:pt x="3836763" y="6325709"/>
                </a:lnTo>
                <a:close/>
                <a:moveTo>
                  <a:pt x="3622851" y="6325709"/>
                </a:moveTo>
                <a:lnTo>
                  <a:pt x="3622851" y="6397010"/>
                </a:lnTo>
                <a:lnTo>
                  <a:pt x="3694151" y="6397010"/>
                </a:lnTo>
                <a:lnTo>
                  <a:pt x="3694151" y="6325709"/>
                </a:lnTo>
                <a:close/>
                <a:moveTo>
                  <a:pt x="3480203" y="6325709"/>
                </a:moveTo>
                <a:lnTo>
                  <a:pt x="3480203" y="6397010"/>
                </a:lnTo>
                <a:lnTo>
                  <a:pt x="3551509" y="6397010"/>
                </a:lnTo>
                <a:lnTo>
                  <a:pt x="3551509" y="6325709"/>
                </a:lnTo>
                <a:close/>
                <a:moveTo>
                  <a:pt x="3337580" y="6325709"/>
                </a:moveTo>
                <a:lnTo>
                  <a:pt x="3337580" y="6397010"/>
                </a:lnTo>
                <a:lnTo>
                  <a:pt x="3408881" y="6397010"/>
                </a:lnTo>
                <a:lnTo>
                  <a:pt x="3408881" y="6325709"/>
                </a:lnTo>
                <a:close/>
                <a:moveTo>
                  <a:pt x="3194905" y="6325709"/>
                </a:moveTo>
                <a:lnTo>
                  <a:pt x="3194905" y="6397010"/>
                </a:lnTo>
                <a:lnTo>
                  <a:pt x="3266208" y="6397010"/>
                </a:lnTo>
                <a:lnTo>
                  <a:pt x="3266208" y="6325709"/>
                </a:lnTo>
                <a:close/>
                <a:moveTo>
                  <a:pt x="3052305" y="6325709"/>
                </a:moveTo>
                <a:lnTo>
                  <a:pt x="3052305" y="6397010"/>
                </a:lnTo>
                <a:lnTo>
                  <a:pt x="3123607" y="6397010"/>
                </a:lnTo>
                <a:lnTo>
                  <a:pt x="3123607" y="6325709"/>
                </a:lnTo>
                <a:close/>
                <a:moveTo>
                  <a:pt x="2909633" y="6325709"/>
                </a:moveTo>
                <a:lnTo>
                  <a:pt x="2909633" y="6397010"/>
                </a:lnTo>
                <a:lnTo>
                  <a:pt x="2980934" y="6397010"/>
                </a:lnTo>
                <a:lnTo>
                  <a:pt x="2980934" y="6325709"/>
                </a:lnTo>
                <a:close/>
                <a:moveTo>
                  <a:pt x="2767033" y="6325709"/>
                </a:moveTo>
                <a:lnTo>
                  <a:pt x="2767033" y="6397010"/>
                </a:lnTo>
                <a:lnTo>
                  <a:pt x="2838334" y="6397010"/>
                </a:lnTo>
                <a:lnTo>
                  <a:pt x="2838334" y="6325709"/>
                </a:lnTo>
                <a:close/>
                <a:moveTo>
                  <a:pt x="2624361" y="6325709"/>
                </a:moveTo>
                <a:lnTo>
                  <a:pt x="2624361" y="6397010"/>
                </a:lnTo>
                <a:lnTo>
                  <a:pt x="2695661" y="6397010"/>
                </a:lnTo>
                <a:lnTo>
                  <a:pt x="2695661" y="6325709"/>
                </a:lnTo>
                <a:close/>
                <a:moveTo>
                  <a:pt x="2481690" y="6325709"/>
                </a:moveTo>
                <a:lnTo>
                  <a:pt x="2481690" y="6397010"/>
                </a:lnTo>
                <a:lnTo>
                  <a:pt x="2552991" y="6397010"/>
                </a:lnTo>
                <a:lnTo>
                  <a:pt x="2552991" y="6325709"/>
                </a:lnTo>
                <a:close/>
                <a:moveTo>
                  <a:pt x="2339091" y="6325709"/>
                </a:moveTo>
                <a:lnTo>
                  <a:pt x="2339091" y="6397010"/>
                </a:lnTo>
                <a:lnTo>
                  <a:pt x="2410390" y="6397010"/>
                </a:lnTo>
                <a:lnTo>
                  <a:pt x="2410390" y="6325709"/>
                </a:lnTo>
                <a:close/>
                <a:moveTo>
                  <a:pt x="2196420" y="6325709"/>
                </a:moveTo>
                <a:lnTo>
                  <a:pt x="2196420" y="6397010"/>
                </a:lnTo>
                <a:lnTo>
                  <a:pt x="2267720" y="6397010"/>
                </a:lnTo>
                <a:lnTo>
                  <a:pt x="2267720" y="6325709"/>
                </a:lnTo>
                <a:close/>
                <a:moveTo>
                  <a:pt x="2053813" y="6325709"/>
                </a:moveTo>
                <a:lnTo>
                  <a:pt x="2053813" y="6397010"/>
                </a:lnTo>
                <a:lnTo>
                  <a:pt x="2125117" y="6397010"/>
                </a:lnTo>
                <a:lnTo>
                  <a:pt x="2125117" y="6325709"/>
                </a:lnTo>
                <a:close/>
                <a:moveTo>
                  <a:pt x="1911141" y="6325709"/>
                </a:moveTo>
                <a:lnTo>
                  <a:pt x="1911141" y="6397010"/>
                </a:lnTo>
                <a:lnTo>
                  <a:pt x="1982442" y="6397010"/>
                </a:lnTo>
                <a:lnTo>
                  <a:pt x="1982442" y="6325709"/>
                </a:lnTo>
                <a:close/>
                <a:moveTo>
                  <a:pt x="1768470" y="6325709"/>
                </a:moveTo>
                <a:lnTo>
                  <a:pt x="1768470" y="6397010"/>
                </a:lnTo>
                <a:lnTo>
                  <a:pt x="1839771" y="6397010"/>
                </a:lnTo>
                <a:lnTo>
                  <a:pt x="1839771" y="6325709"/>
                </a:lnTo>
                <a:close/>
                <a:moveTo>
                  <a:pt x="1625870" y="6325709"/>
                </a:moveTo>
                <a:lnTo>
                  <a:pt x="1625870" y="6397010"/>
                </a:lnTo>
                <a:lnTo>
                  <a:pt x="1697170" y="6397010"/>
                </a:lnTo>
                <a:lnTo>
                  <a:pt x="1697170" y="6325709"/>
                </a:lnTo>
                <a:close/>
                <a:moveTo>
                  <a:pt x="1483199" y="6325709"/>
                </a:moveTo>
                <a:lnTo>
                  <a:pt x="1483199" y="6397010"/>
                </a:lnTo>
                <a:lnTo>
                  <a:pt x="1554500" y="6397010"/>
                </a:lnTo>
                <a:lnTo>
                  <a:pt x="1554500" y="6325709"/>
                </a:lnTo>
                <a:close/>
                <a:moveTo>
                  <a:pt x="1340599" y="6325709"/>
                </a:moveTo>
                <a:lnTo>
                  <a:pt x="1340599" y="6397010"/>
                </a:lnTo>
                <a:lnTo>
                  <a:pt x="1411899" y="6397010"/>
                </a:lnTo>
                <a:lnTo>
                  <a:pt x="1411899" y="6325709"/>
                </a:lnTo>
                <a:close/>
                <a:moveTo>
                  <a:pt x="1197929" y="6325709"/>
                </a:moveTo>
                <a:lnTo>
                  <a:pt x="1197929" y="6397010"/>
                </a:lnTo>
                <a:lnTo>
                  <a:pt x="1269230" y="6397010"/>
                </a:lnTo>
                <a:lnTo>
                  <a:pt x="1269230" y="6325709"/>
                </a:lnTo>
                <a:close/>
                <a:moveTo>
                  <a:pt x="1055311" y="6325709"/>
                </a:moveTo>
                <a:lnTo>
                  <a:pt x="1055311" y="6397010"/>
                </a:lnTo>
                <a:lnTo>
                  <a:pt x="1126612" y="6397010"/>
                </a:lnTo>
                <a:lnTo>
                  <a:pt x="1126612" y="6325709"/>
                </a:lnTo>
                <a:close/>
                <a:moveTo>
                  <a:pt x="912657" y="6325709"/>
                </a:moveTo>
                <a:lnTo>
                  <a:pt x="912657" y="6397010"/>
                </a:lnTo>
                <a:lnTo>
                  <a:pt x="983958" y="6397010"/>
                </a:lnTo>
                <a:lnTo>
                  <a:pt x="983958" y="6325709"/>
                </a:lnTo>
                <a:close/>
                <a:moveTo>
                  <a:pt x="771136" y="6325709"/>
                </a:moveTo>
                <a:lnTo>
                  <a:pt x="771136" y="6397010"/>
                </a:lnTo>
                <a:lnTo>
                  <a:pt x="842437" y="6397010"/>
                </a:lnTo>
                <a:lnTo>
                  <a:pt x="842437" y="6325709"/>
                </a:lnTo>
                <a:close/>
                <a:moveTo>
                  <a:pt x="628534" y="6325709"/>
                </a:moveTo>
                <a:lnTo>
                  <a:pt x="628534" y="6397010"/>
                </a:lnTo>
                <a:lnTo>
                  <a:pt x="699835" y="6397010"/>
                </a:lnTo>
                <a:lnTo>
                  <a:pt x="699835" y="6325709"/>
                </a:lnTo>
                <a:close/>
                <a:moveTo>
                  <a:pt x="485863" y="6325709"/>
                </a:moveTo>
                <a:lnTo>
                  <a:pt x="485863" y="6397010"/>
                </a:lnTo>
                <a:lnTo>
                  <a:pt x="557163" y="6397010"/>
                </a:lnTo>
                <a:lnTo>
                  <a:pt x="557163" y="6325709"/>
                </a:lnTo>
                <a:close/>
                <a:moveTo>
                  <a:pt x="343191" y="6325709"/>
                </a:moveTo>
                <a:lnTo>
                  <a:pt x="343191" y="6397010"/>
                </a:lnTo>
                <a:lnTo>
                  <a:pt x="414492" y="6397010"/>
                </a:lnTo>
                <a:lnTo>
                  <a:pt x="414492" y="6325709"/>
                </a:lnTo>
                <a:close/>
                <a:moveTo>
                  <a:pt x="200590" y="6325709"/>
                </a:moveTo>
                <a:lnTo>
                  <a:pt x="200590" y="6397010"/>
                </a:lnTo>
                <a:lnTo>
                  <a:pt x="271891" y="6397010"/>
                </a:lnTo>
                <a:lnTo>
                  <a:pt x="271891" y="6325709"/>
                </a:lnTo>
                <a:close/>
                <a:moveTo>
                  <a:pt x="57918" y="6325709"/>
                </a:moveTo>
                <a:lnTo>
                  <a:pt x="57918" y="6397010"/>
                </a:lnTo>
                <a:lnTo>
                  <a:pt x="129219" y="6397010"/>
                </a:lnTo>
                <a:lnTo>
                  <a:pt x="129219" y="6325709"/>
                </a:lnTo>
                <a:close/>
                <a:moveTo>
                  <a:pt x="9755391" y="6183107"/>
                </a:moveTo>
                <a:lnTo>
                  <a:pt x="9755391" y="6254408"/>
                </a:lnTo>
                <a:lnTo>
                  <a:pt x="9826692" y="6254408"/>
                </a:lnTo>
                <a:lnTo>
                  <a:pt x="9826692" y="6183107"/>
                </a:lnTo>
                <a:close/>
                <a:moveTo>
                  <a:pt x="9612718" y="6183107"/>
                </a:moveTo>
                <a:lnTo>
                  <a:pt x="9612718" y="6254408"/>
                </a:lnTo>
                <a:lnTo>
                  <a:pt x="9684019" y="6254408"/>
                </a:lnTo>
                <a:lnTo>
                  <a:pt x="9684019" y="6183107"/>
                </a:lnTo>
                <a:close/>
                <a:moveTo>
                  <a:pt x="9470117" y="6183107"/>
                </a:moveTo>
                <a:lnTo>
                  <a:pt x="9470117" y="6254408"/>
                </a:lnTo>
                <a:lnTo>
                  <a:pt x="9541417" y="6254408"/>
                </a:lnTo>
                <a:lnTo>
                  <a:pt x="9541417" y="6183107"/>
                </a:lnTo>
                <a:close/>
                <a:moveTo>
                  <a:pt x="9327444" y="6183107"/>
                </a:moveTo>
                <a:lnTo>
                  <a:pt x="9327444" y="6254408"/>
                </a:lnTo>
                <a:lnTo>
                  <a:pt x="9398745" y="6254408"/>
                </a:lnTo>
                <a:lnTo>
                  <a:pt x="9398745" y="6183107"/>
                </a:lnTo>
                <a:close/>
                <a:moveTo>
                  <a:pt x="9184842" y="6183107"/>
                </a:moveTo>
                <a:lnTo>
                  <a:pt x="9184842" y="6254408"/>
                </a:lnTo>
                <a:lnTo>
                  <a:pt x="9256143" y="6254408"/>
                </a:lnTo>
                <a:lnTo>
                  <a:pt x="9256143" y="6183107"/>
                </a:lnTo>
                <a:close/>
                <a:moveTo>
                  <a:pt x="9042170" y="6183107"/>
                </a:moveTo>
                <a:lnTo>
                  <a:pt x="9042170" y="6254408"/>
                </a:lnTo>
                <a:lnTo>
                  <a:pt x="9113471" y="6254408"/>
                </a:lnTo>
                <a:lnTo>
                  <a:pt x="9113471" y="6183107"/>
                </a:lnTo>
                <a:close/>
                <a:moveTo>
                  <a:pt x="8899568" y="6183107"/>
                </a:moveTo>
                <a:lnTo>
                  <a:pt x="8899568" y="6254408"/>
                </a:lnTo>
                <a:lnTo>
                  <a:pt x="8970869" y="6254408"/>
                </a:lnTo>
                <a:lnTo>
                  <a:pt x="8970869" y="6183107"/>
                </a:lnTo>
                <a:close/>
                <a:moveTo>
                  <a:pt x="8756896" y="6183107"/>
                </a:moveTo>
                <a:lnTo>
                  <a:pt x="8756896" y="6254408"/>
                </a:lnTo>
                <a:lnTo>
                  <a:pt x="8828196" y="6254408"/>
                </a:lnTo>
                <a:lnTo>
                  <a:pt x="8828196" y="6183107"/>
                </a:lnTo>
                <a:close/>
                <a:moveTo>
                  <a:pt x="8614223" y="6183107"/>
                </a:moveTo>
                <a:lnTo>
                  <a:pt x="8614223" y="6254408"/>
                </a:lnTo>
                <a:lnTo>
                  <a:pt x="8685524" y="6254408"/>
                </a:lnTo>
                <a:lnTo>
                  <a:pt x="8685524" y="6183107"/>
                </a:lnTo>
                <a:close/>
                <a:moveTo>
                  <a:pt x="8471622" y="6183107"/>
                </a:moveTo>
                <a:lnTo>
                  <a:pt x="8471622" y="6254408"/>
                </a:lnTo>
                <a:lnTo>
                  <a:pt x="8542923" y="6254408"/>
                </a:lnTo>
                <a:lnTo>
                  <a:pt x="8542923" y="6183107"/>
                </a:lnTo>
                <a:close/>
                <a:moveTo>
                  <a:pt x="8328949" y="6183107"/>
                </a:moveTo>
                <a:lnTo>
                  <a:pt x="8328949" y="6254408"/>
                </a:lnTo>
                <a:lnTo>
                  <a:pt x="8400250" y="6254408"/>
                </a:lnTo>
                <a:lnTo>
                  <a:pt x="8400250" y="6183107"/>
                </a:lnTo>
                <a:close/>
                <a:moveTo>
                  <a:pt x="8186348" y="6183107"/>
                </a:moveTo>
                <a:lnTo>
                  <a:pt x="8186348" y="6254408"/>
                </a:lnTo>
                <a:lnTo>
                  <a:pt x="8257649" y="6254408"/>
                </a:lnTo>
                <a:lnTo>
                  <a:pt x="8257649" y="6183107"/>
                </a:lnTo>
                <a:close/>
                <a:moveTo>
                  <a:pt x="8043675" y="6183107"/>
                </a:moveTo>
                <a:lnTo>
                  <a:pt x="8043675" y="6254408"/>
                </a:lnTo>
                <a:lnTo>
                  <a:pt x="8114976" y="6254408"/>
                </a:lnTo>
                <a:lnTo>
                  <a:pt x="8114976" y="6183107"/>
                </a:lnTo>
                <a:close/>
                <a:moveTo>
                  <a:pt x="7901003" y="6183107"/>
                </a:moveTo>
                <a:lnTo>
                  <a:pt x="7901003" y="6254408"/>
                </a:lnTo>
                <a:lnTo>
                  <a:pt x="7972304" y="6254408"/>
                </a:lnTo>
                <a:lnTo>
                  <a:pt x="7972304" y="6183107"/>
                </a:lnTo>
                <a:close/>
                <a:moveTo>
                  <a:pt x="7758401" y="6183107"/>
                </a:moveTo>
                <a:lnTo>
                  <a:pt x="7758401" y="6254408"/>
                </a:lnTo>
                <a:lnTo>
                  <a:pt x="7829702" y="6254408"/>
                </a:lnTo>
                <a:lnTo>
                  <a:pt x="7829702" y="6183107"/>
                </a:lnTo>
                <a:close/>
                <a:moveTo>
                  <a:pt x="7615728" y="6183107"/>
                </a:moveTo>
                <a:lnTo>
                  <a:pt x="7615728" y="6254408"/>
                </a:lnTo>
                <a:lnTo>
                  <a:pt x="7687029" y="6254408"/>
                </a:lnTo>
                <a:lnTo>
                  <a:pt x="7687029" y="6183107"/>
                </a:lnTo>
                <a:close/>
                <a:moveTo>
                  <a:pt x="7473127" y="6183107"/>
                </a:moveTo>
                <a:lnTo>
                  <a:pt x="7473127" y="6254408"/>
                </a:lnTo>
                <a:lnTo>
                  <a:pt x="7544428" y="6254408"/>
                </a:lnTo>
                <a:lnTo>
                  <a:pt x="7544428" y="6183107"/>
                </a:lnTo>
                <a:close/>
                <a:moveTo>
                  <a:pt x="7330454" y="6183107"/>
                </a:moveTo>
                <a:lnTo>
                  <a:pt x="7330454" y="6254408"/>
                </a:lnTo>
                <a:lnTo>
                  <a:pt x="7401755" y="6254408"/>
                </a:lnTo>
                <a:lnTo>
                  <a:pt x="7401755" y="6183107"/>
                </a:lnTo>
                <a:close/>
                <a:moveTo>
                  <a:pt x="7187853" y="6183107"/>
                </a:moveTo>
                <a:lnTo>
                  <a:pt x="7187853" y="6254408"/>
                </a:lnTo>
                <a:lnTo>
                  <a:pt x="7259154" y="6254408"/>
                </a:lnTo>
                <a:lnTo>
                  <a:pt x="7259154" y="6183107"/>
                </a:lnTo>
                <a:close/>
                <a:moveTo>
                  <a:pt x="7045180" y="6183107"/>
                </a:moveTo>
                <a:lnTo>
                  <a:pt x="7045180" y="6254408"/>
                </a:lnTo>
                <a:lnTo>
                  <a:pt x="7116481" y="6254408"/>
                </a:lnTo>
                <a:lnTo>
                  <a:pt x="7116481" y="6183107"/>
                </a:lnTo>
                <a:close/>
                <a:moveTo>
                  <a:pt x="6902579" y="6183107"/>
                </a:moveTo>
                <a:lnTo>
                  <a:pt x="6902579" y="6254408"/>
                </a:lnTo>
                <a:lnTo>
                  <a:pt x="6973880" y="6254408"/>
                </a:lnTo>
                <a:lnTo>
                  <a:pt x="6973880" y="6183107"/>
                </a:lnTo>
                <a:close/>
                <a:moveTo>
                  <a:pt x="6759906" y="6183107"/>
                </a:moveTo>
                <a:lnTo>
                  <a:pt x="6759906" y="6254408"/>
                </a:lnTo>
                <a:lnTo>
                  <a:pt x="6831207" y="6254408"/>
                </a:lnTo>
                <a:lnTo>
                  <a:pt x="6831207" y="6183107"/>
                </a:lnTo>
                <a:close/>
                <a:moveTo>
                  <a:pt x="6617234" y="6183107"/>
                </a:moveTo>
                <a:lnTo>
                  <a:pt x="6617234" y="6254408"/>
                </a:lnTo>
                <a:lnTo>
                  <a:pt x="6688535" y="6254408"/>
                </a:lnTo>
                <a:lnTo>
                  <a:pt x="6688535" y="6183107"/>
                </a:lnTo>
                <a:close/>
                <a:moveTo>
                  <a:pt x="6474632" y="6183107"/>
                </a:moveTo>
                <a:lnTo>
                  <a:pt x="6474632" y="6254408"/>
                </a:lnTo>
                <a:lnTo>
                  <a:pt x="6545933" y="6254408"/>
                </a:lnTo>
                <a:lnTo>
                  <a:pt x="6545933" y="6183107"/>
                </a:lnTo>
                <a:close/>
                <a:moveTo>
                  <a:pt x="6331959" y="6183107"/>
                </a:moveTo>
                <a:lnTo>
                  <a:pt x="6331959" y="6254408"/>
                </a:lnTo>
                <a:lnTo>
                  <a:pt x="6403260" y="6254408"/>
                </a:lnTo>
                <a:lnTo>
                  <a:pt x="6403260" y="6183107"/>
                </a:lnTo>
                <a:close/>
                <a:moveTo>
                  <a:pt x="6189358" y="6183107"/>
                </a:moveTo>
                <a:lnTo>
                  <a:pt x="6189358" y="6254408"/>
                </a:lnTo>
                <a:lnTo>
                  <a:pt x="6260659" y="6254408"/>
                </a:lnTo>
                <a:lnTo>
                  <a:pt x="6260659" y="6183107"/>
                </a:lnTo>
                <a:close/>
                <a:moveTo>
                  <a:pt x="6046689" y="6183107"/>
                </a:moveTo>
                <a:lnTo>
                  <a:pt x="6046689" y="6254408"/>
                </a:lnTo>
                <a:lnTo>
                  <a:pt x="6117986" y="6254408"/>
                </a:lnTo>
                <a:lnTo>
                  <a:pt x="6117986" y="6183107"/>
                </a:lnTo>
                <a:close/>
                <a:moveTo>
                  <a:pt x="5904022" y="6183107"/>
                </a:moveTo>
                <a:lnTo>
                  <a:pt x="5904022" y="6254408"/>
                </a:lnTo>
                <a:lnTo>
                  <a:pt x="5975319" y="6254408"/>
                </a:lnTo>
                <a:lnTo>
                  <a:pt x="5975319" y="6183107"/>
                </a:lnTo>
                <a:close/>
                <a:moveTo>
                  <a:pt x="5761426" y="6183107"/>
                </a:moveTo>
                <a:lnTo>
                  <a:pt x="5761426" y="6254408"/>
                </a:lnTo>
                <a:lnTo>
                  <a:pt x="5832724" y="6254408"/>
                </a:lnTo>
                <a:lnTo>
                  <a:pt x="5832724" y="6183107"/>
                </a:lnTo>
                <a:close/>
                <a:moveTo>
                  <a:pt x="5618761" y="6183107"/>
                </a:moveTo>
                <a:lnTo>
                  <a:pt x="5618761" y="6254408"/>
                </a:lnTo>
                <a:lnTo>
                  <a:pt x="5690059" y="6254408"/>
                </a:lnTo>
                <a:lnTo>
                  <a:pt x="5690059" y="6183107"/>
                </a:lnTo>
                <a:close/>
                <a:moveTo>
                  <a:pt x="5476167" y="6183107"/>
                </a:moveTo>
                <a:lnTo>
                  <a:pt x="5476167" y="6254408"/>
                </a:lnTo>
                <a:lnTo>
                  <a:pt x="5547465" y="6254408"/>
                </a:lnTo>
                <a:lnTo>
                  <a:pt x="5547465" y="6183107"/>
                </a:lnTo>
                <a:close/>
                <a:moveTo>
                  <a:pt x="5333502" y="6183107"/>
                </a:moveTo>
                <a:lnTo>
                  <a:pt x="5333502" y="6254408"/>
                </a:lnTo>
                <a:lnTo>
                  <a:pt x="5404799" y="6254408"/>
                </a:lnTo>
                <a:lnTo>
                  <a:pt x="5404799" y="6183107"/>
                </a:lnTo>
                <a:close/>
                <a:moveTo>
                  <a:pt x="5190877" y="6183107"/>
                </a:moveTo>
                <a:lnTo>
                  <a:pt x="5190877" y="6254408"/>
                </a:lnTo>
                <a:lnTo>
                  <a:pt x="5262188" y="6254408"/>
                </a:lnTo>
                <a:lnTo>
                  <a:pt x="5262188" y="6183107"/>
                </a:lnTo>
                <a:close/>
                <a:moveTo>
                  <a:pt x="5048236" y="6183107"/>
                </a:moveTo>
                <a:lnTo>
                  <a:pt x="5048236" y="6254408"/>
                </a:lnTo>
                <a:lnTo>
                  <a:pt x="5119527" y="6254408"/>
                </a:lnTo>
                <a:lnTo>
                  <a:pt x="5119527" y="6183107"/>
                </a:lnTo>
                <a:close/>
                <a:moveTo>
                  <a:pt x="4906607" y="6183107"/>
                </a:moveTo>
                <a:lnTo>
                  <a:pt x="4906607" y="6254408"/>
                </a:lnTo>
                <a:lnTo>
                  <a:pt x="4977916" y="6254408"/>
                </a:lnTo>
                <a:lnTo>
                  <a:pt x="4977916" y="6183107"/>
                </a:lnTo>
                <a:close/>
                <a:moveTo>
                  <a:pt x="4764013" y="6183107"/>
                </a:moveTo>
                <a:lnTo>
                  <a:pt x="4764013" y="6254408"/>
                </a:lnTo>
                <a:lnTo>
                  <a:pt x="4835311" y="6254408"/>
                </a:lnTo>
                <a:lnTo>
                  <a:pt x="4835311" y="6183107"/>
                </a:lnTo>
                <a:close/>
                <a:moveTo>
                  <a:pt x="4621341" y="6183107"/>
                </a:moveTo>
                <a:lnTo>
                  <a:pt x="4621341" y="6254408"/>
                </a:lnTo>
                <a:lnTo>
                  <a:pt x="4692639" y="6254408"/>
                </a:lnTo>
                <a:lnTo>
                  <a:pt x="4692639" y="6183107"/>
                </a:lnTo>
                <a:close/>
                <a:moveTo>
                  <a:pt x="4478666" y="6183107"/>
                </a:moveTo>
                <a:lnTo>
                  <a:pt x="4478666" y="6254408"/>
                </a:lnTo>
                <a:lnTo>
                  <a:pt x="4549969" y="6254408"/>
                </a:lnTo>
                <a:lnTo>
                  <a:pt x="4549969" y="6183107"/>
                </a:lnTo>
                <a:close/>
                <a:moveTo>
                  <a:pt x="4336067" y="6183107"/>
                </a:moveTo>
                <a:lnTo>
                  <a:pt x="4336067" y="6254408"/>
                </a:lnTo>
                <a:lnTo>
                  <a:pt x="4407366" y="6254408"/>
                </a:lnTo>
                <a:lnTo>
                  <a:pt x="4407366" y="6183107"/>
                </a:lnTo>
                <a:close/>
                <a:moveTo>
                  <a:pt x="4193413" y="6183107"/>
                </a:moveTo>
                <a:lnTo>
                  <a:pt x="4193413" y="6254408"/>
                </a:lnTo>
                <a:lnTo>
                  <a:pt x="4264695" y="6254408"/>
                </a:lnTo>
                <a:lnTo>
                  <a:pt x="4264695" y="6183107"/>
                </a:lnTo>
                <a:close/>
                <a:moveTo>
                  <a:pt x="4050810" y="6183107"/>
                </a:moveTo>
                <a:lnTo>
                  <a:pt x="4050810" y="6254408"/>
                </a:lnTo>
                <a:lnTo>
                  <a:pt x="4122113" y="6254408"/>
                </a:lnTo>
                <a:lnTo>
                  <a:pt x="4122113" y="6183107"/>
                </a:lnTo>
                <a:close/>
                <a:moveTo>
                  <a:pt x="3908136" y="6183107"/>
                </a:moveTo>
                <a:lnTo>
                  <a:pt x="3908136" y="6254408"/>
                </a:lnTo>
                <a:lnTo>
                  <a:pt x="3979438" y="6254408"/>
                </a:lnTo>
                <a:lnTo>
                  <a:pt x="3979438" y="6183107"/>
                </a:lnTo>
                <a:close/>
                <a:moveTo>
                  <a:pt x="3765462" y="6183107"/>
                </a:moveTo>
                <a:lnTo>
                  <a:pt x="3765462" y="6254408"/>
                </a:lnTo>
                <a:lnTo>
                  <a:pt x="3836763" y="6254408"/>
                </a:lnTo>
                <a:lnTo>
                  <a:pt x="3836763" y="6183107"/>
                </a:lnTo>
                <a:close/>
                <a:moveTo>
                  <a:pt x="3622851" y="6183107"/>
                </a:moveTo>
                <a:lnTo>
                  <a:pt x="3622851" y="6254408"/>
                </a:lnTo>
                <a:lnTo>
                  <a:pt x="3694151" y="6254408"/>
                </a:lnTo>
                <a:lnTo>
                  <a:pt x="3694151" y="6183107"/>
                </a:lnTo>
                <a:close/>
                <a:moveTo>
                  <a:pt x="3480203" y="6183107"/>
                </a:moveTo>
                <a:lnTo>
                  <a:pt x="3480203" y="6254408"/>
                </a:lnTo>
                <a:lnTo>
                  <a:pt x="3551509" y="6254408"/>
                </a:lnTo>
                <a:lnTo>
                  <a:pt x="3551509" y="6183107"/>
                </a:lnTo>
                <a:close/>
                <a:moveTo>
                  <a:pt x="3337580" y="6183107"/>
                </a:moveTo>
                <a:lnTo>
                  <a:pt x="3337580" y="6254408"/>
                </a:lnTo>
                <a:lnTo>
                  <a:pt x="3408881" y="6254408"/>
                </a:lnTo>
                <a:lnTo>
                  <a:pt x="3408881" y="6183107"/>
                </a:lnTo>
                <a:close/>
                <a:moveTo>
                  <a:pt x="3194906" y="6183107"/>
                </a:moveTo>
                <a:lnTo>
                  <a:pt x="3194906" y="6254408"/>
                </a:lnTo>
                <a:lnTo>
                  <a:pt x="3266208" y="6254408"/>
                </a:lnTo>
                <a:lnTo>
                  <a:pt x="3266208" y="6183107"/>
                </a:lnTo>
                <a:close/>
                <a:moveTo>
                  <a:pt x="3052305" y="6183107"/>
                </a:moveTo>
                <a:lnTo>
                  <a:pt x="3052305" y="6254408"/>
                </a:lnTo>
                <a:lnTo>
                  <a:pt x="3123607" y="6254408"/>
                </a:lnTo>
                <a:lnTo>
                  <a:pt x="3123607" y="6183107"/>
                </a:lnTo>
                <a:close/>
                <a:moveTo>
                  <a:pt x="2909634" y="6183107"/>
                </a:moveTo>
                <a:lnTo>
                  <a:pt x="2909634" y="6254408"/>
                </a:lnTo>
                <a:lnTo>
                  <a:pt x="2980934" y="6254408"/>
                </a:lnTo>
                <a:lnTo>
                  <a:pt x="2980934" y="6183107"/>
                </a:lnTo>
                <a:close/>
                <a:moveTo>
                  <a:pt x="2767033" y="6183107"/>
                </a:moveTo>
                <a:lnTo>
                  <a:pt x="2767033" y="6254408"/>
                </a:lnTo>
                <a:lnTo>
                  <a:pt x="2838334" y="6254408"/>
                </a:lnTo>
                <a:lnTo>
                  <a:pt x="2838334" y="6183107"/>
                </a:lnTo>
                <a:close/>
                <a:moveTo>
                  <a:pt x="2624361" y="6183107"/>
                </a:moveTo>
                <a:lnTo>
                  <a:pt x="2624361" y="6254408"/>
                </a:lnTo>
                <a:lnTo>
                  <a:pt x="2695661" y="6254408"/>
                </a:lnTo>
                <a:lnTo>
                  <a:pt x="2695661" y="6183107"/>
                </a:lnTo>
                <a:close/>
                <a:moveTo>
                  <a:pt x="2481690" y="6183107"/>
                </a:moveTo>
                <a:lnTo>
                  <a:pt x="2481690" y="6254408"/>
                </a:lnTo>
                <a:lnTo>
                  <a:pt x="2552991" y="6254408"/>
                </a:lnTo>
                <a:lnTo>
                  <a:pt x="2552991" y="6183107"/>
                </a:lnTo>
                <a:close/>
                <a:moveTo>
                  <a:pt x="2339091" y="6183107"/>
                </a:moveTo>
                <a:lnTo>
                  <a:pt x="2339091" y="6254408"/>
                </a:lnTo>
                <a:lnTo>
                  <a:pt x="2410392" y="6254408"/>
                </a:lnTo>
                <a:lnTo>
                  <a:pt x="2410392" y="6183107"/>
                </a:lnTo>
                <a:close/>
                <a:moveTo>
                  <a:pt x="2196420" y="6183107"/>
                </a:moveTo>
                <a:lnTo>
                  <a:pt x="2196420" y="6254408"/>
                </a:lnTo>
                <a:lnTo>
                  <a:pt x="2267721" y="6254408"/>
                </a:lnTo>
                <a:lnTo>
                  <a:pt x="2267721" y="6183107"/>
                </a:lnTo>
                <a:close/>
                <a:moveTo>
                  <a:pt x="2053813" y="6183107"/>
                </a:moveTo>
                <a:lnTo>
                  <a:pt x="2053813" y="6254408"/>
                </a:lnTo>
                <a:lnTo>
                  <a:pt x="2125117" y="6254408"/>
                </a:lnTo>
                <a:lnTo>
                  <a:pt x="2125117" y="6183107"/>
                </a:lnTo>
                <a:close/>
                <a:moveTo>
                  <a:pt x="1911141" y="6183107"/>
                </a:moveTo>
                <a:lnTo>
                  <a:pt x="1911141" y="6254408"/>
                </a:lnTo>
                <a:lnTo>
                  <a:pt x="1982442" y="6254408"/>
                </a:lnTo>
                <a:lnTo>
                  <a:pt x="1982442" y="6183107"/>
                </a:lnTo>
                <a:close/>
                <a:moveTo>
                  <a:pt x="1768470" y="6183107"/>
                </a:moveTo>
                <a:lnTo>
                  <a:pt x="1768470" y="6254408"/>
                </a:lnTo>
                <a:lnTo>
                  <a:pt x="1839771" y="6254408"/>
                </a:lnTo>
                <a:lnTo>
                  <a:pt x="1839771" y="6183107"/>
                </a:lnTo>
                <a:close/>
                <a:moveTo>
                  <a:pt x="1625870" y="6183107"/>
                </a:moveTo>
                <a:lnTo>
                  <a:pt x="1625870" y="6254408"/>
                </a:lnTo>
                <a:lnTo>
                  <a:pt x="1697171" y="6254408"/>
                </a:lnTo>
                <a:lnTo>
                  <a:pt x="1697171" y="6183107"/>
                </a:lnTo>
                <a:close/>
                <a:moveTo>
                  <a:pt x="1483199" y="6183107"/>
                </a:moveTo>
                <a:lnTo>
                  <a:pt x="1483199" y="6254408"/>
                </a:lnTo>
                <a:lnTo>
                  <a:pt x="1554500" y="6254408"/>
                </a:lnTo>
                <a:lnTo>
                  <a:pt x="1554500" y="6183107"/>
                </a:lnTo>
                <a:close/>
                <a:moveTo>
                  <a:pt x="1340599" y="6183107"/>
                </a:moveTo>
                <a:lnTo>
                  <a:pt x="1340599" y="6254408"/>
                </a:lnTo>
                <a:lnTo>
                  <a:pt x="1411901" y="6254408"/>
                </a:lnTo>
                <a:lnTo>
                  <a:pt x="1411901" y="6183107"/>
                </a:lnTo>
                <a:close/>
                <a:moveTo>
                  <a:pt x="1197929" y="6183107"/>
                </a:moveTo>
                <a:lnTo>
                  <a:pt x="1197929" y="6254408"/>
                </a:lnTo>
                <a:lnTo>
                  <a:pt x="1269230" y="6254408"/>
                </a:lnTo>
                <a:lnTo>
                  <a:pt x="1269230" y="6183107"/>
                </a:lnTo>
                <a:close/>
                <a:moveTo>
                  <a:pt x="1055311" y="6183107"/>
                </a:moveTo>
                <a:lnTo>
                  <a:pt x="1055311" y="6254408"/>
                </a:lnTo>
                <a:lnTo>
                  <a:pt x="1126612" y="6254408"/>
                </a:lnTo>
                <a:lnTo>
                  <a:pt x="1126612" y="6183107"/>
                </a:lnTo>
                <a:close/>
                <a:moveTo>
                  <a:pt x="912657" y="6183107"/>
                </a:moveTo>
                <a:lnTo>
                  <a:pt x="912657" y="6254408"/>
                </a:lnTo>
                <a:lnTo>
                  <a:pt x="983958" y="6254408"/>
                </a:lnTo>
                <a:lnTo>
                  <a:pt x="983958" y="6183107"/>
                </a:lnTo>
                <a:close/>
                <a:moveTo>
                  <a:pt x="771136" y="6183107"/>
                </a:moveTo>
                <a:lnTo>
                  <a:pt x="771136" y="6254408"/>
                </a:lnTo>
                <a:lnTo>
                  <a:pt x="842437" y="6254408"/>
                </a:lnTo>
                <a:lnTo>
                  <a:pt x="842437" y="6183107"/>
                </a:lnTo>
                <a:close/>
                <a:moveTo>
                  <a:pt x="628534" y="6183107"/>
                </a:moveTo>
                <a:lnTo>
                  <a:pt x="628534" y="6254408"/>
                </a:lnTo>
                <a:lnTo>
                  <a:pt x="699835" y="6254408"/>
                </a:lnTo>
                <a:lnTo>
                  <a:pt x="699835" y="6183107"/>
                </a:lnTo>
                <a:close/>
                <a:moveTo>
                  <a:pt x="485863" y="6183107"/>
                </a:moveTo>
                <a:lnTo>
                  <a:pt x="485863" y="6254408"/>
                </a:lnTo>
                <a:lnTo>
                  <a:pt x="557163" y="6254408"/>
                </a:lnTo>
                <a:lnTo>
                  <a:pt x="557163" y="6183107"/>
                </a:lnTo>
                <a:close/>
                <a:moveTo>
                  <a:pt x="343191" y="6183107"/>
                </a:moveTo>
                <a:lnTo>
                  <a:pt x="343191" y="6254408"/>
                </a:lnTo>
                <a:lnTo>
                  <a:pt x="414492" y="6254408"/>
                </a:lnTo>
                <a:lnTo>
                  <a:pt x="414492" y="6183107"/>
                </a:lnTo>
                <a:close/>
                <a:moveTo>
                  <a:pt x="200590" y="6183107"/>
                </a:moveTo>
                <a:lnTo>
                  <a:pt x="200590" y="6254408"/>
                </a:lnTo>
                <a:lnTo>
                  <a:pt x="271891" y="6254408"/>
                </a:lnTo>
                <a:lnTo>
                  <a:pt x="271891" y="6183107"/>
                </a:lnTo>
                <a:close/>
                <a:moveTo>
                  <a:pt x="57918" y="6183107"/>
                </a:moveTo>
                <a:lnTo>
                  <a:pt x="57918" y="6254408"/>
                </a:lnTo>
                <a:lnTo>
                  <a:pt x="129219" y="6254408"/>
                </a:lnTo>
                <a:lnTo>
                  <a:pt x="129219" y="6183107"/>
                </a:lnTo>
                <a:close/>
                <a:moveTo>
                  <a:pt x="10040665" y="6040435"/>
                </a:moveTo>
                <a:lnTo>
                  <a:pt x="10040665" y="6111736"/>
                </a:lnTo>
                <a:lnTo>
                  <a:pt x="10111966" y="6111736"/>
                </a:lnTo>
                <a:lnTo>
                  <a:pt x="10111966" y="6040435"/>
                </a:lnTo>
                <a:close/>
                <a:moveTo>
                  <a:pt x="9898063" y="6040435"/>
                </a:moveTo>
                <a:lnTo>
                  <a:pt x="9898063" y="6111736"/>
                </a:lnTo>
                <a:lnTo>
                  <a:pt x="9969363" y="6111736"/>
                </a:lnTo>
                <a:lnTo>
                  <a:pt x="9969363" y="6040435"/>
                </a:lnTo>
                <a:close/>
                <a:moveTo>
                  <a:pt x="9755391" y="6040435"/>
                </a:moveTo>
                <a:lnTo>
                  <a:pt x="9755391" y="6111736"/>
                </a:lnTo>
                <a:lnTo>
                  <a:pt x="9826692" y="6111736"/>
                </a:lnTo>
                <a:lnTo>
                  <a:pt x="9826692" y="6040435"/>
                </a:lnTo>
                <a:close/>
                <a:moveTo>
                  <a:pt x="9612718" y="6040435"/>
                </a:moveTo>
                <a:lnTo>
                  <a:pt x="9612718" y="6111736"/>
                </a:lnTo>
                <a:lnTo>
                  <a:pt x="9684019" y="6111736"/>
                </a:lnTo>
                <a:lnTo>
                  <a:pt x="9684019" y="6040435"/>
                </a:lnTo>
                <a:close/>
                <a:moveTo>
                  <a:pt x="9470117" y="6040435"/>
                </a:moveTo>
                <a:lnTo>
                  <a:pt x="9470117" y="6111736"/>
                </a:lnTo>
                <a:lnTo>
                  <a:pt x="9541417" y="6111736"/>
                </a:lnTo>
                <a:lnTo>
                  <a:pt x="9541417" y="6040435"/>
                </a:lnTo>
                <a:close/>
                <a:moveTo>
                  <a:pt x="9327444" y="6040435"/>
                </a:moveTo>
                <a:lnTo>
                  <a:pt x="9327444" y="6111736"/>
                </a:lnTo>
                <a:lnTo>
                  <a:pt x="9398745" y="6111736"/>
                </a:lnTo>
                <a:lnTo>
                  <a:pt x="9398745" y="6040435"/>
                </a:lnTo>
                <a:close/>
                <a:moveTo>
                  <a:pt x="9184842" y="6040435"/>
                </a:moveTo>
                <a:lnTo>
                  <a:pt x="9184842" y="6111736"/>
                </a:lnTo>
                <a:lnTo>
                  <a:pt x="9256143" y="6111736"/>
                </a:lnTo>
                <a:lnTo>
                  <a:pt x="9256143" y="6040435"/>
                </a:lnTo>
                <a:close/>
                <a:moveTo>
                  <a:pt x="9042170" y="6040435"/>
                </a:moveTo>
                <a:lnTo>
                  <a:pt x="9042170" y="6111736"/>
                </a:lnTo>
                <a:lnTo>
                  <a:pt x="9113471" y="6111736"/>
                </a:lnTo>
                <a:lnTo>
                  <a:pt x="9113471" y="6040435"/>
                </a:lnTo>
                <a:close/>
                <a:moveTo>
                  <a:pt x="8899568" y="6040435"/>
                </a:moveTo>
                <a:lnTo>
                  <a:pt x="8899568" y="6111736"/>
                </a:lnTo>
                <a:lnTo>
                  <a:pt x="8970869" y="6111736"/>
                </a:lnTo>
                <a:lnTo>
                  <a:pt x="8970869" y="6040435"/>
                </a:lnTo>
                <a:close/>
                <a:moveTo>
                  <a:pt x="8756896" y="6040435"/>
                </a:moveTo>
                <a:lnTo>
                  <a:pt x="8756896" y="6111736"/>
                </a:lnTo>
                <a:lnTo>
                  <a:pt x="8828196" y="6111736"/>
                </a:lnTo>
                <a:lnTo>
                  <a:pt x="8828196" y="6040435"/>
                </a:lnTo>
                <a:close/>
                <a:moveTo>
                  <a:pt x="8614223" y="6040435"/>
                </a:moveTo>
                <a:lnTo>
                  <a:pt x="8614223" y="6111736"/>
                </a:lnTo>
                <a:lnTo>
                  <a:pt x="8685524" y="6111736"/>
                </a:lnTo>
                <a:lnTo>
                  <a:pt x="8685524" y="6040435"/>
                </a:lnTo>
                <a:close/>
                <a:moveTo>
                  <a:pt x="8471622" y="6040435"/>
                </a:moveTo>
                <a:lnTo>
                  <a:pt x="8471622" y="6111736"/>
                </a:lnTo>
                <a:lnTo>
                  <a:pt x="8542923" y="6111736"/>
                </a:lnTo>
                <a:lnTo>
                  <a:pt x="8542923" y="6040435"/>
                </a:lnTo>
                <a:close/>
                <a:moveTo>
                  <a:pt x="8328949" y="6040435"/>
                </a:moveTo>
                <a:lnTo>
                  <a:pt x="8328949" y="6111736"/>
                </a:lnTo>
                <a:lnTo>
                  <a:pt x="8400250" y="6111736"/>
                </a:lnTo>
                <a:lnTo>
                  <a:pt x="8400250" y="6040435"/>
                </a:lnTo>
                <a:close/>
                <a:moveTo>
                  <a:pt x="8186348" y="6040435"/>
                </a:moveTo>
                <a:lnTo>
                  <a:pt x="8186348" y="6111736"/>
                </a:lnTo>
                <a:lnTo>
                  <a:pt x="8257649" y="6111736"/>
                </a:lnTo>
                <a:lnTo>
                  <a:pt x="8257649" y="6040435"/>
                </a:lnTo>
                <a:close/>
                <a:moveTo>
                  <a:pt x="8043675" y="6040435"/>
                </a:moveTo>
                <a:lnTo>
                  <a:pt x="8043675" y="6111736"/>
                </a:lnTo>
                <a:lnTo>
                  <a:pt x="8114976" y="6111736"/>
                </a:lnTo>
                <a:lnTo>
                  <a:pt x="8114976" y="6040435"/>
                </a:lnTo>
                <a:close/>
                <a:moveTo>
                  <a:pt x="7901003" y="6040435"/>
                </a:moveTo>
                <a:lnTo>
                  <a:pt x="7901003" y="6111736"/>
                </a:lnTo>
                <a:lnTo>
                  <a:pt x="7972304" y="6111736"/>
                </a:lnTo>
                <a:lnTo>
                  <a:pt x="7972304" y="6040435"/>
                </a:lnTo>
                <a:close/>
                <a:moveTo>
                  <a:pt x="7758401" y="6040435"/>
                </a:moveTo>
                <a:lnTo>
                  <a:pt x="7758401" y="6111736"/>
                </a:lnTo>
                <a:lnTo>
                  <a:pt x="7829702" y="6111736"/>
                </a:lnTo>
                <a:lnTo>
                  <a:pt x="7829702" y="6040435"/>
                </a:lnTo>
                <a:close/>
                <a:moveTo>
                  <a:pt x="7615728" y="6040435"/>
                </a:moveTo>
                <a:lnTo>
                  <a:pt x="7615728" y="6111736"/>
                </a:lnTo>
                <a:lnTo>
                  <a:pt x="7687029" y="6111736"/>
                </a:lnTo>
                <a:lnTo>
                  <a:pt x="7687029" y="6040435"/>
                </a:lnTo>
                <a:close/>
                <a:moveTo>
                  <a:pt x="7473127" y="6040435"/>
                </a:moveTo>
                <a:lnTo>
                  <a:pt x="7473127" y="6111736"/>
                </a:lnTo>
                <a:lnTo>
                  <a:pt x="7544428" y="6111736"/>
                </a:lnTo>
                <a:lnTo>
                  <a:pt x="7544428" y="6040435"/>
                </a:lnTo>
                <a:close/>
                <a:moveTo>
                  <a:pt x="7330454" y="6040435"/>
                </a:moveTo>
                <a:lnTo>
                  <a:pt x="7330454" y="6111736"/>
                </a:lnTo>
                <a:lnTo>
                  <a:pt x="7401755" y="6111736"/>
                </a:lnTo>
                <a:lnTo>
                  <a:pt x="7401755" y="6040435"/>
                </a:lnTo>
                <a:close/>
                <a:moveTo>
                  <a:pt x="7187853" y="6040435"/>
                </a:moveTo>
                <a:lnTo>
                  <a:pt x="7187853" y="6111736"/>
                </a:lnTo>
                <a:lnTo>
                  <a:pt x="7259154" y="6111736"/>
                </a:lnTo>
                <a:lnTo>
                  <a:pt x="7259154" y="6040435"/>
                </a:lnTo>
                <a:close/>
                <a:moveTo>
                  <a:pt x="7045180" y="6040435"/>
                </a:moveTo>
                <a:lnTo>
                  <a:pt x="7045180" y="6111736"/>
                </a:lnTo>
                <a:lnTo>
                  <a:pt x="7116481" y="6111736"/>
                </a:lnTo>
                <a:lnTo>
                  <a:pt x="7116481" y="6040435"/>
                </a:lnTo>
                <a:close/>
                <a:moveTo>
                  <a:pt x="6902579" y="6040435"/>
                </a:moveTo>
                <a:lnTo>
                  <a:pt x="6902579" y="6111736"/>
                </a:lnTo>
                <a:lnTo>
                  <a:pt x="6973880" y="6111736"/>
                </a:lnTo>
                <a:lnTo>
                  <a:pt x="6973880" y="6040435"/>
                </a:lnTo>
                <a:close/>
                <a:moveTo>
                  <a:pt x="6759906" y="6040435"/>
                </a:moveTo>
                <a:lnTo>
                  <a:pt x="6759906" y="6111736"/>
                </a:lnTo>
                <a:lnTo>
                  <a:pt x="6831207" y="6111736"/>
                </a:lnTo>
                <a:lnTo>
                  <a:pt x="6831207" y="6040435"/>
                </a:lnTo>
                <a:close/>
                <a:moveTo>
                  <a:pt x="6617234" y="6040435"/>
                </a:moveTo>
                <a:lnTo>
                  <a:pt x="6617234" y="6111736"/>
                </a:lnTo>
                <a:lnTo>
                  <a:pt x="6688535" y="6111736"/>
                </a:lnTo>
                <a:lnTo>
                  <a:pt x="6688535" y="6040435"/>
                </a:lnTo>
                <a:close/>
                <a:moveTo>
                  <a:pt x="6474632" y="6040435"/>
                </a:moveTo>
                <a:lnTo>
                  <a:pt x="6474632" y="6111736"/>
                </a:lnTo>
                <a:lnTo>
                  <a:pt x="6545933" y="6111736"/>
                </a:lnTo>
                <a:lnTo>
                  <a:pt x="6545933" y="6040435"/>
                </a:lnTo>
                <a:close/>
                <a:moveTo>
                  <a:pt x="6331959" y="6040435"/>
                </a:moveTo>
                <a:lnTo>
                  <a:pt x="6331959" y="6111736"/>
                </a:lnTo>
                <a:lnTo>
                  <a:pt x="6403260" y="6111736"/>
                </a:lnTo>
                <a:lnTo>
                  <a:pt x="6403260" y="6040435"/>
                </a:lnTo>
                <a:close/>
                <a:moveTo>
                  <a:pt x="6189358" y="6040435"/>
                </a:moveTo>
                <a:lnTo>
                  <a:pt x="6189358" y="6111736"/>
                </a:lnTo>
                <a:lnTo>
                  <a:pt x="6260659" y="6111736"/>
                </a:lnTo>
                <a:lnTo>
                  <a:pt x="6260659" y="6040435"/>
                </a:lnTo>
                <a:close/>
                <a:moveTo>
                  <a:pt x="6046689" y="6040435"/>
                </a:moveTo>
                <a:lnTo>
                  <a:pt x="6046689" y="6111736"/>
                </a:lnTo>
                <a:lnTo>
                  <a:pt x="6117986" y="6111736"/>
                </a:lnTo>
                <a:lnTo>
                  <a:pt x="6117986" y="6040435"/>
                </a:lnTo>
                <a:close/>
                <a:moveTo>
                  <a:pt x="5904022" y="6040435"/>
                </a:moveTo>
                <a:lnTo>
                  <a:pt x="5904022" y="6111736"/>
                </a:lnTo>
                <a:lnTo>
                  <a:pt x="5975319" y="6111736"/>
                </a:lnTo>
                <a:lnTo>
                  <a:pt x="5975319" y="6040435"/>
                </a:lnTo>
                <a:close/>
                <a:moveTo>
                  <a:pt x="5761426" y="6040435"/>
                </a:moveTo>
                <a:lnTo>
                  <a:pt x="5761426" y="6111736"/>
                </a:lnTo>
                <a:lnTo>
                  <a:pt x="5832724" y="6111736"/>
                </a:lnTo>
                <a:lnTo>
                  <a:pt x="5832724" y="6040435"/>
                </a:lnTo>
                <a:close/>
                <a:moveTo>
                  <a:pt x="5618761" y="6040435"/>
                </a:moveTo>
                <a:lnTo>
                  <a:pt x="5618761" y="6111736"/>
                </a:lnTo>
                <a:lnTo>
                  <a:pt x="5690059" y="6111736"/>
                </a:lnTo>
                <a:lnTo>
                  <a:pt x="5690059" y="6040435"/>
                </a:lnTo>
                <a:close/>
                <a:moveTo>
                  <a:pt x="5476167" y="6040435"/>
                </a:moveTo>
                <a:lnTo>
                  <a:pt x="5476167" y="6111736"/>
                </a:lnTo>
                <a:lnTo>
                  <a:pt x="5547465" y="6111736"/>
                </a:lnTo>
                <a:lnTo>
                  <a:pt x="5547465" y="6040435"/>
                </a:lnTo>
                <a:close/>
                <a:moveTo>
                  <a:pt x="5333502" y="6040435"/>
                </a:moveTo>
                <a:lnTo>
                  <a:pt x="5333502" y="6111736"/>
                </a:lnTo>
                <a:lnTo>
                  <a:pt x="5404800" y="6111736"/>
                </a:lnTo>
                <a:lnTo>
                  <a:pt x="5404800" y="6040435"/>
                </a:lnTo>
                <a:close/>
                <a:moveTo>
                  <a:pt x="5190877" y="6040435"/>
                </a:moveTo>
                <a:lnTo>
                  <a:pt x="5190877" y="6111736"/>
                </a:lnTo>
                <a:lnTo>
                  <a:pt x="5262188" y="6111736"/>
                </a:lnTo>
                <a:lnTo>
                  <a:pt x="5262188" y="6040435"/>
                </a:lnTo>
                <a:close/>
                <a:moveTo>
                  <a:pt x="5048236" y="6040435"/>
                </a:moveTo>
                <a:lnTo>
                  <a:pt x="5048236" y="6111736"/>
                </a:lnTo>
                <a:lnTo>
                  <a:pt x="5119527" y="6111736"/>
                </a:lnTo>
                <a:lnTo>
                  <a:pt x="5119527" y="6040435"/>
                </a:lnTo>
                <a:close/>
                <a:moveTo>
                  <a:pt x="4906607" y="6040435"/>
                </a:moveTo>
                <a:lnTo>
                  <a:pt x="4906607" y="6111736"/>
                </a:lnTo>
                <a:lnTo>
                  <a:pt x="4977916" y="6111736"/>
                </a:lnTo>
                <a:lnTo>
                  <a:pt x="4977916" y="6040435"/>
                </a:lnTo>
                <a:close/>
                <a:moveTo>
                  <a:pt x="4764013" y="6040435"/>
                </a:moveTo>
                <a:lnTo>
                  <a:pt x="4764013" y="6111736"/>
                </a:lnTo>
                <a:lnTo>
                  <a:pt x="4835311" y="6111736"/>
                </a:lnTo>
                <a:lnTo>
                  <a:pt x="4835311" y="6040435"/>
                </a:lnTo>
                <a:close/>
                <a:moveTo>
                  <a:pt x="4621341" y="6040435"/>
                </a:moveTo>
                <a:lnTo>
                  <a:pt x="4621341" y="6111736"/>
                </a:lnTo>
                <a:lnTo>
                  <a:pt x="4692639" y="6111736"/>
                </a:lnTo>
                <a:lnTo>
                  <a:pt x="4692639" y="6040435"/>
                </a:lnTo>
                <a:close/>
                <a:moveTo>
                  <a:pt x="4478666" y="6040435"/>
                </a:moveTo>
                <a:lnTo>
                  <a:pt x="4478666" y="6111736"/>
                </a:lnTo>
                <a:lnTo>
                  <a:pt x="4549971" y="6111736"/>
                </a:lnTo>
                <a:lnTo>
                  <a:pt x="4549971" y="6040435"/>
                </a:lnTo>
                <a:close/>
                <a:moveTo>
                  <a:pt x="4336067" y="6040435"/>
                </a:moveTo>
                <a:lnTo>
                  <a:pt x="4336067" y="6111736"/>
                </a:lnTo>
                <a:lnTo>
                  <a:pt x="4407366" y="6111736"/>
                </a:lnTo>
                <a:lnTo>
                  <a:pt x="4407366" y="6040435"/>
                </a:lnTo>
                <a:close/>
                <a:moveTo>
                  <a:pt x="4193413" y="6040435"/>
                </a:moveTo>
                <a:lnTo>
                  <a:pt x="4193413" y="6111736"/>
                </a:lnTo>
                <a:lnTo>
                  <a:pt x="4264695" y="6111736"/>
                </a:lnTo>
                <a:lnTo>
                  <a:pt x="4264695" y="6040435"/>
                </a:lnTo>
                <a:close/>
                <a:moveTo>
                  <a:pt x="4050810" y="6040435"/>
                </a:moveTo>
                <a:lnTo>
                  <a:pt x="4050810" y="6111736"/>
                </a:lnTo>
                <a:lnTo>
                  <a:pt x="4122113" y="6111736"/>
                </a:lnTo>
                <a:lnTo>
                  <a:pt x="4122113" y="6040435"/>
                </a:lnTo>
                <a:close/>
                <a:moveTo>
                  <a:pt x="3908138" y="6040435"/>
                </a:moveTo>
                <a:lnTo>
                  <a:pt x="3908138" y="6111736"/>
                </a:lnTo>
                <a:lnTo>
                  <a:pt x="3979439" y="6111736"/>
                </a:lnTo>
                <a:lnTo>
                  <a:pt x="3979439" y="6040435"/>
                </a:lnTo>
                <a:close/>
                <a:moveTo>
                  <a:pt x="3765464" y="6040435"/>
                </a:moveTo>
                <a:lnTo>
                  <a:pt x="3765464" y="6111736"/>
                </a:lnTo>
                <a:lnTo>
                  <a:pt x="3836763" y="6111736"/>
                </a:lnTo>
                <a:lnTo>
                  <a:pt x="3836763" y="6040435"/>
                </a:lnTo>
                <a:close/>
                <a:moveTo>
                  <a:pt x="3622853" y="6040435"/>
                </a:moveTo>
                <a:lnTo>
                  <a:pt x="3622853" y="6111736"/>
                </a:lnTo>
                <a:lnTo>
                  <a:pt x="3694151" y="6111736"/>
                </a:lnTo>
                <a:lnTo>
                  <a:pt x="3694151" y="6040435"/>
                </a:lnTo>
                <a:close/>
                <a:moveTo>
                  <a:pt x="3480203" y="6040435"/>
                </a:moveTo>
                <a:lnTo>
                  <a:pt x="3480203" y="6111736"/>
                </a:lnTo>
                <a:lnTo>
                  <a:pt x="3551511" y="6111736"/>
                </a:lnTo>
                <a:lnTo>
                  <a:pt x="3551511" y="6040435"/>
                </a:lnTo>
                <a:close/>
                <a:moveTo>
                  <a:pt x="3337579" y="6040435"/>
                </a:moveTo>
                <a:lnTo>
                  <a:pt x="3337579" y="6111736"/>
                </a:lnTo>
                <a:lnTo>
                  <a:pt x="3408880" y="6111736"/>
                </a:lnTo>
                <a:lnTo>
                  <a:pt x="3408880" y="6040435"/>
                </a:lnTo>
                <a:close/>
                <a:moveTo>
                  <a:pt x="3194906" y="6040435"/>
                </a:moveTo>
                <a:lnTo>
                  <a:pt x="3194906" y="6111736"/>
                </a:lnTo>
                <a:lnTo>
                  <a:pt x="3266208" y="6111736"/>
                </a:lnTo>
                <a:lnTo>
                  <a:pt x="3266208" y="6040435"/>
                </a:lnTo>
                <a:close/>
                <a:moveTo>
                  <a:pt x="3052305" y="6040435"/>
                </a:moveTo>
                <a:lnTo>
                  <a:pt x="3052305" y="6111736"/>
                </a:lnTo>
                <a:lnTo>
                  <a:pt x="3123607" y="6111736"/>
                </a:lnTo>
                <a:lnTo>
                  <a:pt x="3123607" y="6040435"/>
                </a:lnTo>
                <a:close/>
                <a:moveTo>
                  <a:pt x="2909634" y="6040435"/>
                </a:moveTo>
                <a:lnTo>
                  <a:pt x="2909634" y="6111736"/>
                </a:lnTo>
                <a:lnTo>
                  <a:pt x="2980934" y="6111736"/>
                </a:lnTo>
                <a:lnTo>
                  <a:pt x="2980934" y="6040435"/>
                </a:lnTo>
                <a:close/>
                <a:moveTo>
                  <a:pt x="2767033" y="6040435"/>
                </a:moveTo>
                <a:lnTo>
                  <a:pt x="2767033" y="6111736"/>
                </a:lnTo>
                <a:lnTo>
                  <a:pt x="2838334" y="6111736"/>
                </a:lnTo>
                <a:lnTo>
                  <a:pt x="2838334" y="6040435"/>
                </a:lnTo>
                <a:close/>
                <a:moveTo>
                  <a:pt x="2624361" y="6040435"/>
                </a:moveTo>
                <a:lnTo>
                  <a:pt x="2624361" y="6111736"/>
                </a:lnTo>
                <a:lnTo>
                  <a:pt x="2695662" y="6111736"/>
                </a:lnTo>
                <a:lnTo>
                  <a:pt x="2695662" y="6040435"/>
                </a:lnTo>
                <a:close/>
                <a:moveTo>
                  <a:pt x="2481690" y="6040435"/>
                </a:moveTo>
                <a:lnTo>
                  <a:pt x="2481690" y="6111736"/>
                </a:lnTo>
                <a:lnTo>
                  <a:pt x="2552991" y="6111736"/>
                </a:lnTo>
                <a:lnTo>
                  <a:pt x="2552991" y="6040435"/>
                </a:lnTo>
                <a:close/>
                <a:moveTo>
                  <a:pt x="2339091" y="6040435"/>
                </a:moveTo>
                <a:lnTo>
                  <a:pt x="2339091" y="6111736"/>
                </a:lnTo>
                <a:lnTo>
                  <a:pt x="2410392" y="6111736"/>
                </a:lnTo>
                <a:lnTo>
                  <a:pt x="2410392" y="6040435"/>
                </a:lnTo>
                <a:close/>
                <a:moveTo>
                  <a:pt x="2196420" y="6040435"/>
                </a:moveTo>
                <a:lnTo>
                  <a:pt x="2196420" y="6111736"/>
                </a:lnTo>
                <a:lnTo>
                  <a:pt x="2267721" y="6111736"/>
                </a:lnTo>
                <a:lnTo>
                  <a:pt x="2267721" y="6040435"/>
                </a:lnTo>
                <a:close/>
                <a:moveTo>
                  <a:pt x="2053813" y="6040435"/>
                </a:moveTo>
                <a:lnTo>
                  <a:pt x="2053813" y="6111736"/>
                </a:lnTo>
                <a:lnTo>
                  <a:pt x="2125117" y="6111736"/>
                </a:lnTo>
                <a:lnTo>
                  <a:pt x="2125117" y="6040435"/>
                </a:lnTo>
                <a:close/>
                <a:moveTo>
                  <a:pt x="1911141" y="6040435"/>
                </a:moveTo>
                <a:lnTo>
                  <a:pt x="1911141" y="6111736"/>
                </a:lnTo>
                <a:lnTo>
                  <a:pt x="1982442" y="6111736"/>
                </a:lnTo>
                <a:lnTo>
                  <a:pt x="1982442" y="6040435"/>
                </a:lnTo>
                <a:close/>
                <a:moveTo>
                  <a:pt x="1768471" y="6040435"/>
                </a:moveTo>
                <a:lnTo>
                  <a:pt x="1768471" y="6111736"/>
                </a:lnTo>
                <a:lnTo>
                  <a:pt x="1839771" y="6111736"/>
                </a:lnTo>
                <a:lnTo>
                  <a:pt x="1839771" y="6040435"/>
                </a:lnTo>
                <a:close/>
                <a:moveTo>
                  <a:pt x="1625870" y="6040435"/>
                </a:moveTo>
                <a:lnTo>
                  <a:pt x="1625870" y="6111736"/>
                </a:lnTo>
                <a:lnTo>
                  <a:pt x="1697171" y="6111736"/>
                </a:lnTo>
                <a:lnTo>
                  <a:pt x="1697171" y="6040435"/>
                </a:lnTo>
                <a:close/>
                <a:moveTo>
                  <a:pt x="1483200" y="6040435"/>
                </a:moveTo>
                <a:lnTo>
                  <a:pt x="1483200" y="6111736"/>
                </a:lnTo>
                <a:lnTo>
                  <a:pt x="1554500" y="6111736"/>
                </a:lnTo>
                <a:lnTo>
                  <a:pt x="1554500" y="6040435"/>
                </a:lnTo>
                <a:close/>
                <a:moveTo>
                  <a:pt x="1340599" y="6040435"/>
                </a:moveTo>
                <a:lnTo>
                  <a:pt x="1340599" y="6111736"/>
                </a:lnTo>
                <a:lnTo>
                  <a:pt x="1411901" y="6111736"/>
                </a:lnTo>
                <a:lnTo>
                  <a:pt x="1411901" y="6040435"/>
                </a:lnTo>
                <a:close/>
                <a:moveTo>
                  <a:pt x="1197930" y="6040435"/>
                </a:moveTo>
                <a:lnTo>
                  <a:pt x="1197930" y="6111736"/>
                </a:lnTo>
                <a:lnTo>
                  <a:pt x="1269231" y="6111736"/>
                </a:lnTo>
                <a:lnTo>
                  <a:pt x="1269231" y="6040435"/>
                </a:lnTo>
                <a:close/>
                <a:moveTo>
                  <a:pt x="1055312" y="6040435"/>
                </a:moveTo>
                <a:lnTo>
                  <a:pt x="1055312" y="6111736"/>
                </a:lnTo>
                <a:lnTo>
                  <a:pt x="1126613" y="6111736"/>
                </a:lnTo>
                <a:lnTo>
                  <a:pt x="1126613" y="6040435"/>
                </a:lnTo>
                <a:close/>
                <a:moveTo>
                  <a:pt x="912657" y="6040435"/>
                </a:moveTo>
                <a:lnTo>
                  <a:pt x="912657" y="6111736"/>
                </a:lnTo>
                <a:lnTo>
                  <a:pt x="983958" y="6111736"/>
                </a:lnTo>
                <a:lnTo>
                  <a:pt x="983958" y="6040435"/>
                </a:lnTo>
                <a:close/>
                <a:moveTo>
                  <a:pt x="771136" y="6040435"/>
                </a:moveTo>
                <a:lnTo>
                  <a:pt x="771136" y="6111736"/>
                </a:lnTo>
                <a:lnTo>
                  <a:pt x="842437" y="6111736"/>
                </a:lnTo>
                <a:lnTo>
                  <a:pt x="842437" y="6040435"/>
                </a:lnTo>
                <a:close/>
                <a:moveTo>
                  <a:pt x="628535" y="6040435"/>
                </a:moveTo>
                <a:lnTo>
                  <a:pt x="628535" y="6111736"/>
                </a:lnTo>
                <a:lnTo>
                  <a:pt x="699836" y="6111736"/>
                </a:lnTo>
                <a:lnTo>
                  <a:pt x="699836" y="6040435"/>
                </a:lnTo>
                <a:close/>
                <a:moveTo>
                  <a:pt x="485863" y="6040435"/>
                </a:moveTo>
                <a:lnTo>
                  <a:pt x="485863" y="6111736"/>
                </a:lnTo>
                <a:lnTo>
                  <a:pt x="557163" y="6111736"/>
                </a:lnTo>
                <a:lnTo>
                  <a:pt x="557163" y="6040435"/>
                </a:lnTo>
                <a:close/>
                <a:moveTo>
                  <a:pt x="343191" y="6040435"/>
                </a:moveTo>
                <a:lnTo>
                  <a:pt x="343191" y="6111736"/>
                </a:lnTo>
                <a:lnTo>
                  <a:pt x="414492" y="6111736"/>
                </a:lnTo>
                <a:lnTo>
                  <a:pt x="414492" y="6040435"/>
                </a:lnTo>
                <a:close/>
                <a:moveTo>
                  <a:pt x="200591" y="6040435"/>
                </a:moveTo>
                <a:lnTo>
                  <a:pt x="200591" y="6111736"/>
                </a:lnTo>
                <a:lnTo>
                  <a:pt x="271892" y="6111736"/>
                </a:lnTo>
                <a:lnTo>
                  <a:pt x="271892" y="6040435"/>
                </a:lnTo>
                <a:close/>
                <a:moveTo>
                  <a:pt x="57918" y="6040435"/>
                </a:moveTo>
                <a:lnTo>
                  <a:pt x="57918" y="6111736"/>
                </a:lnTo>
                <a:lnTo>
                  <a:pt x="129219" y="6111736"/>
                </a:lnTo>
                <a:lnTo>
                  <a:pt x="129219" y="6040435"/>
                </a:lnTo>
                <a:close/>
                <a:moveTo>
                  <a:pt x="0" y="0"/>
                </a:moveTo>
                <a:lnTo>
                  <a:pt x="12191941" y="0"/>
                </a:lnTo>
                <a:lnTo>
                  <a:pt x="12191941" y="6857967"/>
                </a:lnTo>
                <a:lnTo>
                  <a:pt x="0" y="6857967"/>
                </a:lnTo>
                <a:close/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bIns="900000" anchor="b">
            <a:noAutofit/>
          </a:bodyPr>
          <a:lstStyle>
            <a:lvl1pPr marL="0" indent="0">
              <a:buNone/>
              <a:defRPr b="0"/>
            </a:lvl1pPr>
          </a:lstStyle>
          <a:p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lik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ier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n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ies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en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fbeelding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it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de Templafy </a:t>
            </a: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ibliotheek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/>
            </a:r>
            <a:b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</a:b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óf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lik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met de </a:t>
            </a: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echtermuisknop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n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ies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voor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Opvulling</a:t>
            </a:r>
            <a:r>
              <a:rPr lang="en-GB" sz="1463" i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&gt; </a:t>
            </a:r>
            <a:r>
              <a:rPr lang="en-GB" sz="1463" i="1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fbeelding</a:t>
            </a:r>
            <a:endParaRPr lang="en-US"/>
          </a:p>
        </p:txBody>
      </p:sp>
      <p:sp>
        <p:nvSpPr>
          <p:cNvPr id="250" name="Text Placeholder 249">
            <a:extLst>
              <a:ext uri="{FF2B5EF4-FFF2-40B4-BE49-F238E27FC236}">
                <a16:creationId xmlns:a16="http://schemas.microsoft.com/office/drawing/2014/main" id="{E0748938-00AC-4F09-808F-788D0CB4BC56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 bwMode="auto">
          <a:xfrm>
            <a:off x="2202878" y="33"/>
            <a:ext cx="7717106" cy="6857968"/>
          </a:xfrm>
          <a:custGeom>
            <a:avLst/>
            <a:gdLst>
              <a:gd name="connsiteX0" fmla="*/ 6330995 w 9497977"/>
              <a:gd name="connsiteY0" fmla="*/ 6474347 h 6857968"/>
              <a:gd name="connsiteX1" fmla="*/ 6330995 w 9497977"/>
              <a:gd name="connsiteY1" fmla="*/ 6545648 h 6857968"/>
              <a:gd name="connsiteX2" fmla="*/ 6402296 w 9497977"/>
              <a:gd name="connsiteY2" fmla="*/ 6545648 h 6857968"/>
              <a:gd name="connsiteX3" fmla="*/ 6402296 w 9497977"/>
              <a:gd name="connsiteY3" fmla="*/ 6474347 h 6857968"/>
              <a:gd name="connsiteX4" fmla="*/ 6188393 w 9497977"/>
              <a:gd name="connsiteY4" fmla="*/ 6474347 h 6857968"/>
              <a:gd name="connsiteX5" fmla="*/ 6188393 w 9497977"/>
              <a:gd name="connsiteY5" fmla="*/ 6545648 h 6857968"/>
              <a:gd name="connsiteX6" fmla="*/ 6259694 w 9497977"/>
              <a:gd name="connsiteY6" fmla="*/ 6545648 h 6857968"/>
              <a:gd name="connsiteX7" fmla="*/ 6259694 w 9497977"/>
              <a:gd name="connsiteY7" fmla="*/ 6474347 h 6857968"/>
              <a:gd name="connsiteX8" fmla="*/ 6045721 w 9497977"/>
              <a:gd name="connsiteY8" fmla="*/ 6474347 h 6857968"/>
              <a:gd name="connsiteX9" fmla="*/ 6045721 w 9497977"/>
              <a:gd name="connsiteY9" fmla="*/ 6545648 h 6857968"/>
              <a:gd name="connsiteX10" fmla="*/ 6117021 w 9497977"/>
              <a:gd name="connsiteY10" fmla="*/ 6545648 h 6857968"/>
              <a:gd name="connsiteX11" fmla="*/ 6117021 w 9497977"/>
              <a:gd name="connsiteY11" fmla="*/ 6474347 h 6857968"/>
              <a:gd name="connsiteX12" fmla="*/ 5903048 w 9497977"/>
              <a:gd name="connsiteY12" fmla="*/ 6474347 h 6857968"/>
              <a:gd name="connsiteX13" fmla="*/ 5903048 w 9497977"/>
              <a:gd name="connsiteY13" fmla="*/ 6545648 h 6857968"/>
              <a:gd name="connsiteX14" fmla="*/ 5974349 w 9497977"/>
              <a:gd name="connsiteY14" fmla="*/ 6545648 h 6857968"/>
              <a:gd name="connsiteX15" fmla="*/ 5974349 w 9497977"/>
              <a:gd name="connsiteY15" fmla="*/ 6474347 h 6857968"/>
              <a:gd name="connsiteX16" fmla="*/ 5760447 w 9497977"/>
              <a:gd name="connsiteY16" fmla="*/ 6474347 h 6857968"/>
              <a:gd name="connsiteX17" fmla="*/ 5760447 w 9497977"/>
              <a:gd name="connsiteY17" fmla="*/ 6545648 h 6857968"/>
              <a:gd name="connsiteX18" fmla="*/ 5831748 w 9497977"/>
              <a:gd name="connsiteY18" fmla="*/ 6545648 h 6857968"/>
              <a:gd name="connsiteX19" fmla="*/ 5831748 w 9497977"/>
              <a:gd name="connsiteY19" fmla="*/ 6474347 h 6857968"/>
              <a:gd name="connsiteX20" fmla="*/ 5617774 w 9497977"/>
              <a:gd name="connsiteY20" fmla="*/ 6474347 h 6857968"/>
              <a:gd name="connsiteX21" fmla="*/ 5617774 w 9497977"/>
              <a:gd name="connsiteY21" fmla="*/ 6545648 h 6857968"/>
              <a:gd name="connsiteX22" fmla="*/ 5689075 w 9497977"/>
              <a:gd name="connsiteY22" fmla="*/ 6545648 h 6857968"/>
              <a:gd name="connsiteX23" fmla="*/ 5689075 w 9497977"/>
              <a:gd name="connsiteY23" fmla="*/ 6474347 h 6857968"/>
              <a:gd name="connsiteX24" fmla="*/ 5475173 w 9497977"/>
              <a:gd name="connsiteY24" fmla="*/ 6474347 h 6857968"/>
              <a:gd name="connsiteX25" fmla="*/ 5475173 w 9497977"/>
              <a:gd name="connsiteY25" fmla="*/ 6545648 h 6857968"/>
              <a:gd name="connsiteX26" fmla="*/ 5546474 w 9497977"/>
              <a:gd name="connsiteY26" fmla="*/ 6545648 h 6857968"/>
              <a:gd name="connsiteX27" fmla="*/ 5546474 w 9497977"/>
              <a:gd name="connsiteY27" fmla="*/ 6474347 h 6857968"/>
              <a:gd name="connsiteX28" fmla="*/ 5332500 w 9497977"/>
              <a:gd name="connsiteY28" fmla="*/ 6474347 h 6857968"/>
              <a:gd name="connsiteX29" fmla="*/ 5332500 w 9497977"/>
              <a:gd name="connsiteY29" fmla="*/ 6545648 h 6857968"/>
              <a:gd name="connsiteX30" fmla="*/ 5403801 w 9497977"/>
              <a:gd name="connsiteY30" fmla="*/ 6545648 h 6857968"/>
              <a:gd name="connsiteX31" fmla="*/ 5403801 w 9497977"/>
              <a:gd name="connsiteY31" fmla="*/ 6474347 h 6857968"/>
              <a:gd name="connsiteX32" fmla="*/ 5189828 w 9497977"/>
              <a:gd name="connsiteY32" fmla="*/ 6474347 h 6857968"/>
              <a:gd name="connsiteX33" fmla="*/ 5189828 w 9497977"/>
              <a:gd name="connsiteY33" fmla="*/ 6545648 h 6857968"/>
              <a:gd name="connsiteX34" fmla="*/ 5261129 w 9497977"/>
              <a:gd name="connsiteY34" fmla="*/ 6545648 h 6857968"/>
              <a:gd name="connsiteX35" fmla="*/ 5261129 w 9497977"/>
              <a:gd name="connsiteY35" fmla="*/ 6474347 h 6857968"/>
              <a:gd name="connsiteX36" fmla="*/ 5047226 w 9497977"/>
              <a:gd name="connsiteY36" fmla="*/ 6474347 h 6857968"/>
              <a:gd name="connsiteX37" fmla="*/ 5047226 w 9497977"/>
              <a:gd name="connsiteY37" fmla="*/ 6545648 h 6857968"/>
              <a:gd name="connsiteX38" fmla="*/ 5118527 w 9497977"/>
              <a:gd name="connsiteY38" fmla="*/ 6545648 h 6857968"/>
              <a:gd name="connsiteX39" fmla="*/ 5118527 w 9497977"/>
              <a:gd name="connsiteY39" fmla="*/ 6474347 h 6857968"/>
              <a:gd name="connsiteX40" fmla="*/ 4904553 w 9497977"/>
              <a:gd name="connsiteY40" fmla="*/ 6474347 h 6857968"/>
              <a:gd name="connsiteX41" fmla="*/ 4904553 w 9497977"/>
              <a:gd name="connsiteY41" fmla="*/ 6545648 h 6857968"/>
              <a:gd name="connsiteX42" fmla="*/ 4975854 w 9497977"/>
              <a:gd name="connsiteY42" fmla="*/ 6545648 h 6857968"/>
              <a:gd name="connsiteX43" fmla="*/ 4975854 w 9497977"/>
              <a:gd name="connsiteY43" fmla="*/ 6474347 h 6857968"/>
              <a:gd name="connsiteX44" fmla="*/ 4761952 w 9497977"/>
              <a:gd name="connsiteY44" fmla="*/ 6474347 h 6857968"/>
              <a:gd name="connsiteX45" fmla="*/ 4761952 w 9497977"/>
              <a:gd name="connsiteY45" fmla="*/ 6545648 h 6857968"/>
              <a:gd name="connsiteX46" fmla="*/ 4833253 w 9497977"/>
              <a:gd name="connsiteY46" fmla="*/ 6545648 h 6857968"/>
              <a:gd name="connsiteX47" fmla="*/ 4833253 w 9497977"/>
              <a:gd name="connsiteY47" fmla="*/ 6474347 h 6857968"/>
              <a:gd name="connsiteX48" fmla="*/ 4619279 w 9497977"/>
              <a:gd name="connsiteY48" fmla="*/ 6474347 h 6857968"/>
              <a:gd name="connsiteX49" fmla="*/ 4619279 w 9497977"/>
              <a:gd name="connsiteY49" fmla="*/ 6545648 h 6857968"/>
              <a:gd name="connsiteX50" fmla="*/ 4690580 w 9497977"/>
              <a:gd name="connsiteY50" fmla="*/ 6545648 h 6857968"/>
              <a:gd name="connsiteX51" fmla="*/ 4690580 w 9497977"/>
              <a:gd name="connsiteY51" fmla="*/ 6474347 h 6857968"/>
              <a:gd name="connsiteX52" fmla="*/ 4476678 w 9497977"/>
              <a:gd name="connsiteY52" fmla="*/ 6474347 h 6857968"/>
              <a:gd name="connsiteX53" fmla="*/ 4476678 w 9497977"/>
              <a:gd name="connsiteY53" fmla="*/ 6545648 h 6857968"/>
              <a:gd name="connsiteX54" fmla="*/ 4547979 w 9497977"/>
              <a:gd name="connsiteY54" fmla="*/ 6545648 h 6857968"/>
              <a:gd name="connsiteX55" fmla="*/ 4547979 w 9497977"/>
              <a:gd name="connsiteY55" fmla="*/ 6474347 h 6857968"/>
              <a:gd name="connsiteX56" fmla="*/ 4334005 w 9497977"/>
              <a:gd name="connsiteY56" fmla="*/ 6474347 h 6857968"/>
              <a:gd name="connsiteX57" fmla="*/ 4334005 w 9497977"/>
              <a:gd name="connsiteY57" fmla="*/ 6545648 h 6857968"/>
              <a:gd name="connsiteX58" fmla="*/ 4405306 w 9497977"/>
              <a:gd name="connsiteY58" fmla="*/ 6545648 h 6857968"/>
              <a:gd name="connsiteX59" fmla="*/ 4405306 w 9497977"/>
              <a:gd name="connsiteY59" fmla="*/ 6474347 h 6857968"/>
              <a:gd name="connsiteX60" fmla="*/ 4191404 w 9497977"/>
              <a:gd name="connsiteY60" fmla="*/ 6474347 h 6857968"/>
              <a:gd name="connsiteX61" fmla="*/ 4191404 w 9497977"/>
              <a:gd name="connsiteY61" fmla="*/ 6545648 h 6857968"/>
              <a:gd name="connsiteX62" fmla="*/ 4262705 w 9497977"/>
              <a:gd name="connsiteY62" fmla="*/ 6545648 h 6857968"/>
              <a:gd name="connsiteX63" fmla="*/ 4262705 w 9497977"/>
              <a:gd name="connsiteY63" fmla="*/ 6474347 h 6857968"/>
              <a:gd name="connsiteX64" fmla="*/ 4048731 w 9497977"/>
              <a:gd name="connsiteY64" fmla="*/ 6474347 h 6857968"/>
              <a:gd name="connsiteX65" fmla="*/ 4048731 w 9497977"/>
              <a:gd name="connsiteY65" fmla="*/ 6545648 h 6857968"/>
              <a:gd name="connsiteX66" fmla="*/ 4120032 w 9497977"/>
              <a:gd name="connsiteY66" fmla="*/ 6545648 h 6857968"/>
              <a:gd name="connsiteX67" fmla="*/ 4120032 w 9497977"/>
              <a:gd name="connsiteY67" fmla="*/ 6474347 h 6857968"/>
              <a:gd name="connsiteX68" fmla="*/ 3906059 w 9497977"/>
              <a:gd name="connsiteY68" fmla="*/ 6474347 h 6857968"/>
              <a:gd name="connsiteX69" fmla="*/ 3906059 w 9497977"/>
              <a:gd name="connsiteY69" fmla="*/ 6545648 h 6857968"/>
              <a:gd name="connsiteX70" fmla="*/ 3977360 w 9497977"/>
              <a:gd name="connsiteY70" fmla="*/ 6545648 h 6857968"/>
              <a:gd name="connsiteX71" fmla="*/ 3977360 w 9497977"/>
              <a:gd name="connsiteY71" fmla="*/ 6474347 h 6857968"/>
              <a:gd name="connsiteX72" fmla="*/ 3763457 w 9497977"/>
              <a:gd name="connsiteY72" fmla="*/ 6474347 h 6857968"/>
              <a:gd name="connsiteX73" fmla="*/ 3763457 w 9497977"/>
              <a:gd name="connsiteY73" fmla="*/ 6545648 h 6857968"/>
              <a:gd name="connsiteX74" fmla="*/ 3834758 w 9497977"/>
              <a:gd name="connsiteY74" fmla="*/ 6545648 h 6857968"/>
              <a:gd name="connsiteX75" fmla="*/ 3834758 w 9497977"/>
              <a:gd name="connsiteY75" fmla="*/ 6474347 h 6857968"/>
              <a:gd name="connsiteX76" fmla="*/ 3620784 w 9497977"/>
              <a:gd name="connsiteY76" fmla="*/ 6474347 h 6857968"/>
              <a:gd name="connsiteX77" fmla="*/ 3620784 w 9497977"/>
              <a:gd name="connsiteY77" fmla="*/ 6545648 h 6857968"/>
              <a:gd name="connsiteX78" fmla="*/ 3692085 w 9497977"/>
              <a:gd name="connsiteY78" fmla="*/ 6545648 h 6857968"/>
              <a:gd name="connsiteX79" fmla="*/ 3692085 w 9497977"/>
              <a:gd name="connsiteY79" fmla="*/ 6474347 h 6857968"/>
              <a:gd name="connsiteX80" fmla="*/ 3478184 w 9497977"/>
              <a:gd name="connsiteY80" fmla="*/ 6474347 h 6857968"/>
              <a:gd name="connsiteX81" fmla="*/ 3478184 w 9497977"/>
              <a:gd name="connsiteY81" fmla="*/ 6545648 h 6857968"/>
              <a:gd name="connsiteX82" fmla="*/ 3549484 w 9497977"/>
              <a:gd name="connsiteY82" fmla="*/ 6545648 h 6857968"/>
              <a:gd name="connsiteX83" fmla="*/ 3549484 w 9497977"/>
              <a:gd name="connsiteY83" fmla="*/ 6474347 h 6857968"/>
              <a:gd name="connsiteX84" fmla="*/ 3335511 w 9497977"/>
              <a:gd name="connsiteY84" fmla="*/ 6474347 h 6857968"/>
              <a:gd name="connsiteX85" fmla="*/ 3335511 w 9497977"/>
              <a:gd name="connsiteY85" fmla="*/ 6545648 h 6857968"/>
              <a:gd name="connsiteX86" fmla="*/ 3406811 w 9497977"/>
              <a:gd name="connsiteY86" fmla="*/ 6545648 h 6857968"/>
              <a:gd name="connsiteX87" fmla="*/ 3406811 w 9497977"/>
              <a:gd name="connsiteY87" fmla="*/ 6474347 h 6857968"/>
              <a:gd name="connsiteX88" fmla="*/ 3192839 w 9497977"/>
              <a:gd name="connsiteY88" fmla="*/ 6474347 h 6857968"/>
              <a:gd name="connsiteX89" fmla="*/ 3192839 w 9497977"/>
              <a:gd name="connsiteY89" fmla="*/ 6545648 h 6857968"/>
              <a:gd name="connsiteX90" fmla="*/ 3264139 w 9497977"/>
              <a:gd name="connsiteY90" fmla="*/ 6545648 h 6857968"/>
              <a:gd name="connsiteX91" fmla="*/ 3264139 w 9497977"/>
              <a:gd name="connsiteY91" fmla="*/ 6474347 h 6857968"/>
              <a:gd name="connsiteX92" fmla="*/ 3050237 w 9497977"/>
              <a:gd name="connsiteY92" fmla="*/ 6474347 h 6857968"/>
              <a:gd name="connsiteX93" fmla="*/ 3050237 w 9497977"/>
              <a:gd name="connsiteY93" fmla="*/ 6545648 h 6857968"/>
              <a:gd name="connsiteX94" fmla="*/ 3121537 w 9497977"/>
              <a:gd name="connsiteY94" fmla="*/ 6545648 h 6857968"/>
              <a:gd name="connsiteX95" fmla="*/ 3121537 w 9497977"/>
              <a:gd name="connsiteY95" fmla="*/ 6474347 h 6857968"/>
              <a:gd name="connsiteX96" fmla="*/ 2907564 w 9497977"/>
              <a:gd name="connsiteY96" fmla="*/ 6474347 h 6857968"/>
              <a:gd name="connsiteX97" fmla="*/ 2907564 w 9497977"/>
              <a:gd name="connsiteY97" fmla="*/ 6545648 h 6857968"/>
              <a:gd name="connsiteX98" fmla="*/ 2978865 w 9497977"/>
              <a:gd name="connsiteY98" fmla="*/ 6545648 h 6857968"/>
              <a:gd name="connsiteX99" fmla="*/ 2978865 w 9497977"/>
              <a:gd name="connsiteY99" fmla="*/ 6474347 h 6857968"/>
              <a:gd name="connsiteX100" fmla="*/ 2764962 w 9497977"/>
              <a:gd name="connsiteY100" fmla="*/ 6474347 h 6857968"/>
              <a:gd name="connsiteX101" fmla="*/ 2764962 w 9497977"/>
              <a:gd name="connsiteY101" fmla="*/ 6545648 h 6857968"/>
              <a:gd name="connsiteX102" fmla="*/ 2836263 w 9497977"/>
              <a:gd name="connsiteY102" fmla="*/ 6545648 h 6857968"/>
              <a:gd name="connsiteX103" fmla="*/ 2836263 w 9497977"/>
              <a:gd name="connsiteY103" fmla="*/ 6474347 h 6857968"/>
              <a:gd name="connsiteX104" fmla="*/ 2622291 w 9497977"/>
              <a:gd name="connsiteY104" fmla="*/ 6474347 h 6857968"/>
              <a:gd name="connsiteX105" fmla="*/ 2622291 w 9497977"/>
              <a:gd name="connsiteY105" fmla="*/ 6545648 h 6857968"/>
              <a:gd name="connsiteX106" fmla="*/ 2693591 w 9497977"/>
              <a:gd name="connsiteY106" fmla="*/ 6545648 h 6857968"/>
              <a:gd name="connsiteX107" fmla="*/ 2693591 w 9497977"/>
              <a:gd name="connsiteY107" fmla="*/ 6474347 h 6857968"/>
              <a:gd name="connsiteX108" fmla="*/ 2479688 w 9497977"/>
              <a:gd name="connsiteY108" fmla="*/ 6474347 h 6857968"/>
              <a:gd name="connsiteX109" fmla="*/ 2479688 w 9497977"/>
              <a:gd name="connsiteY109" fmla="*/ 6545648 h 6857968"/>
              <a:gd name="connsiteX110" fmla="*/ 2550990 w 9497977"/>
              <a:gd name="connsiteY110" fmla="*/ 6545648 h 6857968"/>
              <a:gd name="connsiteX111" fmla="*/ 2550990 w 9497977"/>
              <a:gd name="connsiteY111" fmla="*/ 6474347 h 6857968"/>
              <a:gd name="connsiteX112" fmla="*/ 2337016 w 9497977"/>
              <a:gd name="connsiteY112" fmla="*/ 6474347 h 6857968"/>
              <a:gd name="connsiteX113" fmla="*/ 2337016 w 9497977"/>
              <a:gd name="connsiteY113" fmla="*/ 6545648 h 6857968"/>
              <a:gd name="connsiteX114" fmla="*/ 2408317 w 9497977"/>
              <a:gd name="connsiteY114" fmla="*/ 6545648 h 6857968"/>
              <a:gd name="connsiteX115" fmla="*/ 2408317 w 9497977"/>
              <a:gd name="connsiteY115" fmla="*/ 6474347 h 6857968"/>
              <a:gd name="connsiteX116" fmla="*/ 2195429 w 9497977"/>
              <a:gd name="connsiteY116" fmla="*/ 6474347 h 6857968"/>
              <a:gd name="connsiteX117" fmla="*/ 2195429 w 9497977"/>
              <a:gd name="connsiteY117" fmla="*/ 6545648 h 6857968"/>
              <a:gd name="connsiteX118" fmla="*/ 2266731 w 9497977"/>
              <a:gd name="connsiteY118" fmla="*/ 6545648 h 6857968"/>
              <a:gd name="connsiteX119" fmla="*/ 2266731 w 9497977"/>
              <a:gd name="connsiteY119" fmla="*/ 6474347 h 6857968"/>
              <a:gd name="connsiteX120" fmla="*/ 2052828 w 9497977"/>
              <a:gd name="connsiteY120" fmla="*/ 6474347 h 6857968"/>
              <a:gd name="connsiteX121" fmla="*/ 2052828 w 9497977"/>
              <a:gd name="connsiteY121" fmla="*/ 6545648 h 6857968"/>
              <a:gd name="connsiteX122" fmla="*/ 2124128 w 9497977"/>
              <a:gd name="connsiteY122" fmla="*/ 6545648 h 6857968"/>
              <a:gd name="connsiteX123" fmla="*/ 2124128 w 9497977"/>
              <a:gd name="connsiteY123" fmla="*/ 6474347 h 6857968"/>
              <a:gd name="connsiteX124" fmla="*/ 1910155 w 9497977"/>
              <a:gd name="connsiteY124" fmla="*/ 6474347 h 6857968"/>
              <a:gd name="connsiteX125" fmla="*/ 1910155 w 9497977"/>
              <a:gd name="connsiteY125" fmla="*/ 6545648 h 6857968"/>
              <a:gd name="connsiteX126" fmla="*/ 1981455 w 9497977"/>
              <a:gd name="connsiteY126" fmla="*/ 6545648 h 6857968"/>
              <a:gd name="connsiteX127" fmla="*/ 1981455 w 9497977"/>
              <a:gd name="connsiteY127" fmla="*/ 6474347 h 6857968"/>
              <a:gd name="connsiteX128" fmla="*/ 1767483 w 9497977"/>
              <a:gd name="connsiteY128" fmla="*/ 6474347 h 6857968"/>
              <a:gd name="connsiteX129" fmla="*/ 1767483 w 9497977"/>
              <a:gd name="connsiteY129" fmla="*/ 6545648 h 6857968"/>
              <a:gd name="connsiteX130" fmla="*/ 1838783 w 9497977"/>
              <a:gd name="connsiteY130" fmla="*/ 6545648 h 6857968"/>
              <a:gd name="connsiteX131" fmla="*/ 1838783 w 9497977"/>
              <a:gd name="connsiteY131" fmla="*/ 6474347 h 6857968"/>
              <a:gd name="connsiteX132" fmla="*/ 1624882 w 9497977"/>
              <a:gd name="connsiteY132" fmla="*/ 6474347 h 6857968"/>
              <a:gd name="connsiteX133" fmla="*/ 1624882 w 9497977"/>
              <a:gd name="connsiteY133" fmla="*/ 6545648 h 6857968"/>
              <a:gd name="connsiteX134" fmla="*/ 1696183 w 9497977"/>
              <a:gd name="connsiteY134" fmla="*/ 6545648 h 6857968"/>
              <a:gd name="connsiteX135" fmla="*/ 1696183 w 9497977"/>
              <a:gd name="connsiteY135" fmla="*/ 6474347 h 6857968"/>
              <a:gd name="connsiteX136" fmla="*/ 1482215 w 9497977"/>
              <a:gd name="connsiteY136" fmla="*/ 6474347 h 6857968"/>
              <a:gd name="connsiteX137" fmla="*/ 1482215 w 9497977"/>
              <a:gd name="connsiteY137" fmla="*/ 6545648 h 6857968"/>
              <a:gd name="connsiteX138" fmla="*/ 1553511 w 9497977"/>
              <a:gd name="connsiteY138" fmla="*/ 6545648 h 6857968"/>
              <a:gd name="connsiteX139" fmla="*/ 1553511 w 9497977"/>
              <a:gd name="connsiteY139" fmla="*/ 6474347 h 6857968"/>
              <a:gd name="connsiteX140" fmla="*/ 1339617 w 9497977"/>
              <a:gd name="connsiteY140" fmla="*/ 6474347 h 6857968"/>
              <a:gd name="connsiteX141" fmla="*/ 1339617 w 9497977"/>
              <a:gd name="connsiteY141" fmla="*/ 6545648 h 6857968"/>
              <a:gd name="connsiteX142" fmla="*/ 1410920 w 9497977"/>
              <a:gd name="connsiteY142" fmla="*/ 6545648 h 6857968"/>
              <a:gd name="connsiteX143" fmla="*/ 1410920 w 9497977"/>
              <a:gd name="connsiteY143" fmla="*/ 6474347 h 6857968"/>
              <a:gd name="connsiteX144" fmla="*/ 1196941 w 9497977"/>
              <a:gd name="connsiteY144" fmla="*/ 6474347 h 6857968"/>
              <a:gd name="connsiteX145" fmla="*/ 1196941 w 9497977"/>
              <a:gd name="connsiteY145" fmla="*/ 6545648 h 6857968"/>
              <a:gd name="connsiteX146" fmla="*/ 1268245 w 9497977"/>
              <a:gd name="connsiteY146" fmla="*/ 6545648 h 6857968"/>
              <a:gd name="connsiteX147" fmla="*/ 1268245 w 9497977"/>
              <a:gd name="connsiteY147" fmla="*/ 6474347 h 6857968"/>
              <a:gd name="connsiteX148" fmla="*/ 1054277 w 9497977"/>
              <a:gd name="connsiteY148" fmla="*/ 6474347 h 6857968"/>
              <a:gd name="connsiteX149" fmla="*/ 1054277 w 9497977"/>
              <a:gd name="connsiteY149" fmla="*/ 6545648 h 6857968"/>
              <a:gd name="connsiteX150" fmla="*/ 1125575 w 9497977"/>
              <a:gd name="connsiteY150" fmla="*/ 6545648 h 6857968"/>
              <a:gd name="connsiteX151" fmla="*/ 1125575 w 9497977"/>
              <a:gd name="connsiteY151" fmla="*/ 6474347 h 6857968"/>
              <a:gd name="connsiteX152" fmla="*/ 911663 w 9497977"/>
              <a:gd name="connsiteY152" fmla="*/ 6474347 h 6857968"/>
              <a:gd name="connsiteX153" fmla="*/ 911663 w 9497977"/>
              <a:gd name="connsiteY153" fmla="*/ 6545648 h 6857968"/>
              <a:gd name="connsiteX154" fmla="*/ 982964 w 9497977"/>
              <a:gd name="connsiteY154" fmla="*/ 6545648 h 6857968"/>
              <a:gd name="connsiteX155" fmla="*/ 982964 w 9497977"/>
              <a:gd name="connsiteY155" fmla="*/ 6474347 h 6857968"/>
              <a:gd name="connsiteX156" fmla="*/ 769001 w 9497977"/>
              <a:gd name="connsiteY156" fmla="*/ 6474347 h 6857968"/>
              <a:gd name="connsiteX157" fmla="*/ 769001 w 9497977"/>
              <a:gd name="connsiteY157" fmla="*/ 6545648 h 6857968"/>
              <a:gd name="connsiteX158" fmla="*/ 840299 w 9497977"/>
              <a:gd name="connsiteY158" fmla="*/ 6545648 h 6857968"/>
              <a:gd name="connsiteX159" fmla="*/ 840299 w 9497977"/>
              <a:gd name="connsiteY159" fmla="*/ 6474347 h 6857968"/>
              <a:gd name="connsiteX160" fmla="*/ 626392 w 9497977"/>
              <a:gd name="connsiteY160" fmla="*/ 6474347 h 6857968"/>
              <a:gd name="connsiteX161" fmla="*/ 626392 w 9497977"/>
              <a:gd name="connsiteY161" fmla="*/ 6545648 h 6857968"/>
              <a:gd name="connsiteX162" fmla="*/ 697691 w 9497977"/>
              <a:gd name="connsiteY162" fmla="*/ 6545648 h 6857968"/>
              <a:gd name="connsiteX163" fmla="*/ 697691 w 9497977"/>
              <a:gd name="connsiteY163" fmla="*/ 6474347 h 6857968"/>
              <a:gd name="connsiteX164" fmla="*/ 483718 w 9497977"/>
              <a:gd name="connsiteY164" fmla="*/ 6474347 h 6857968"/>
              <a:gd name="connsiteX165" fmla="*/ 483718 w 9497977"/>
              <a:gd name="connsiteY165" fmla="*/ 6545648 h 6857968"/>
              <a:gd name="connsiteX166" fmla="*/ 555020 w 9497977"/>
              <a:gd name="connsiteY166" fmla="*/ 6545648 h 6857968"/>
              <a:gd name="connsiteX167" fmla="*/ 555020 w 9497977"/>
              <a:gd name="connsiteY167" fmla="*/ 6474347 h 6857968"/>
              <a:gd name="connsiteX168" fmla="*/ 7329490 w 9497977"/>
              <a:gd name="connsiteY168" fmla="*/ 6325709 h 6857968"/>
              <a:gd name="connsiteX169" fmla="*/ 7329490 w 9497977"/>
              <a:gd name="connsiteY169" fmla="*/ 6397010 h 6857968"/>
              <a:gd name="connsiteX170" fmla="*/ 7400791 w 9497977"/>
              <a:gd name="connsiteY170" fmla="*/ 6397010 h 6857968"/>
              <a:gd name="connsiteX171" fmla="*/ 7400791 w 9497977"/>
              <a:gd name="connsiteY171" fmla="*/ 6325709 h 6857968"/>
              <a:gd name="connsiteX172" fmla="*/ 7186888 w 9497977"/>
              <a:gd name="connsiteY172" fmla="*/ 6325709 h 6857968"/>
              <a:gd name="connsiteX173" fmla="*/ 7186888 w 9497977"/>
              <a:gd name="connsiteY173" fmla="*/ 6397010 h 6857968"/>
              <a:gd name="connsiteX174" fmla="*/ 7258188 w 9497977"/>
              <a:gd name="connsiteY174" fmla="*/ 6397010 h 6857968"/>
              <a:gd name="connsiteX175" fmla="*/ 7258188 w 9497977"/>
              <a:gd name="connsiteY175" fmla="*/ 6325709 h 6857968"/>
              <a:gd name="connsiteX176" fmla="*/ 7044216 w 9497977"/>
              <a:gd name="connsiteY176" fmla="*/ 6325709 h 6857968"/>
              <a:gd name="connsiteX177" fmla="*/ 7044216 w 9497977"/>
              <a:gd name="connsiteY177" fmla="*/ 6397010 h 6857968"/>
              <a:gd name="connsiteX178" fmla="*/ 7115517 w 9497977"/>
              <a:gd name="connsiteY178" fmla="*/ 6397010 h 6857968"/>
              <a:gd name="connsiteX179" fmla="*/ 7115517 w 9497977"/>
              <a:gd name="connsiteY179" fmla="*/ 6325709 h 6857968"/>
              <a:gd name="connsiteX180" fmla="*/ 6901543 w 9497977"/>
              <a:gd name="connsiteY180" fmla="*/ 6325709 h 6857968"/>
              <a:gd name="connsiteX181" fmla="*/ 6901543 w 9497977"/>
              <a:gd name="connsiteY181" fmla="*/ 6397010 h 6857968"/>
              <a:gd name="connsiteX182" fmla="*/ 6972844 w 9497977"/>
              <a:gd name="connsiteY182" fmla="*/ 6397010 h 6857968"/>
              <a:gd name="connsiteX183" fmla="*/ 6972844 w 9497977"/>
              <a:gd name="connsiteY183" fmla="*/ 6325709 h 6857968"/>
              <a:gd name="connsiteX184" fmla="*/ 6758942 w 9497977"/>
              <a:gd name="connsiteY184" fmla="*/ 6325709 h 6857968"/>
              <a:gd name="connsiteX185" fmla="*/ 6758942 w 9497977"/>
              <a:gd name="connsiteY185" fmla="*/ 6397010 h 6857968"/>
              <a:gd name="connsiteX186" fmla="*/ 6830242 w 9497977"/>
              <a:gd name="connsiteY186" fmla="*/ 6397010 h 6857968"/>
              <a:gd name="connsiteX187" fmla="*/ 6830242 w 9497977"/>
              <a:gd name="connsiteY187" fmla="*/ 6325709 h 6857968"/>
              <a:gd name="connsiteX188" fmla="*/ 6616269 w 9497977"/>
              <a:gd name="connsiteY188" fmla="*/ 6325709 h 6857968"/>
              <a:gd name="connsiteX189" fmla="*/ 6616269 w 9497977"/>
              <a:gd name="connsiteY189" fmla="*/ 6397010 h 6857968"/>
              <a:gd name="connsiteX190" fmla="*/ 6687570 w 9497977"/>
              <a:gd name="connsiteY190" fmla="*/ 6397010 h 6857968"/>
              <a:gd name="connsiteX191" fmla="*/ 6687570 w 9497977"/>
              <a:gd name="connsiteY191" fmla="*/ 6325709 h 6857968"/>
              <a:gd name="connsiteX192" fmla="*/ 6473667 w 9497977"/>
              <a:gd name="connsiteY192" fmla="*/ 6325709 h 6857968"/>
              <a:gd name="connsiteX193" fmla="*/ 6473667 w 9497977"/>
              <a:gd name="connsiteY193" fmla="*/ 6397010 h 6857968"/>
              <a:gd name="connsiteX194" fmla="*/ 6544968 w 9497977"/>
              <a:gd name="connsiteY194" fmla="*/ 6397010 h 6857968"/>
              <a:gd name="connsiteX195" fmla="*/ 6544968 w 9497977"/>
              <a:gd name="connsiteY195" fmla="*/ 6325709 h 6857968"/>
              <a:gd name="connsiteX196" fmla="*/ 6330995 w 9497977"/>
              <a:gd name="connsiteY196" fmla="*/ 6325709 h 6857968"/>
              <a:gd name="connsiteX197" fmla="*/ 6330995 w 9497977"/>
              <a:gd name="connsiteY197" fmla="*/ 6397010 h 6857968"/>
              <a:gd name="connsiteX198" fmla="*/ 6402296 w 9497977"/>
              <a:gd name="connsiteY198" fmla="*/ 6397010 h 6857968"/>
              <a:gd name="connsiteX199" fmla="*/ 6402296 w 9497977"/>
              <a:gd name="connsiteY199" fmla="*/ 6325709 h 6857968"/>
              <a:gd name="connsiteX200" fmla="*/ 6188393 w 9497977"/>
              <a:gd name="connsiteY200" fmla="*/ 6325709 h 6857968"/>
              <a:gd name="connsiteX201" fmla="*/ 6188393 w 9497977"/>
              <a:gd name="connsiteY201" fmla="*/ 6397010 h 6857968"/>
              <a:gd name="connsiteX202" fmla="*/ 6259694 w 9497977"/>
              <a:gd name="connsiteY202" fmla="*/ 6397010 h 6857968"/>
              <a:gd name="connsiteX203" fmla="*/ 6259694 w 9497977"/>
              <a:gd name="connsiteY203" fmla="*/ 6325709 h 6857968"/>
              <a:gd name="connsiteX204" fmla="*/ 6045721 w 9497977"/>
              <a:gd name="connsiteY204" fmla="*/ 6325709 h 6857968"/>
              <a:gd name="connsiteX205" fmla="*/ 6045721 w 9497977"/>
              <a:gd name="connsiteY205" fmla="*/ 6397010 h 6857968"/>
              <a:gd name="connsiteX206" fmla="*/ 6117021 w 9497977"/>
              <a:gd name="connsiteY206" fmla="*/ 6397010 h 6857968"/>
              <a:gd name="connsiteX207" fmla="*/ 6117021 w 9497977"/>
              <a:gd name="connsiteY207" fmla="*/ 6325709 h 6857968"/>
              <a:gd name="connsiteX208" fmla="*/ 5903048 w 9497977"/>
              <a:gd name="connsiteY208" fmla="*/ 6325709 h 6857968"/>
              <a:gd name="connsiteX209" fmla="*/ 5903048 w 9497977"/>
              <a:gd name="connsiteY209" fmla="*/ 6397010 h 6857968"/>
              <a:gd name="connsiteX210" fmla="*/ 5974349 w 9497977"/>
              <a:gd name="connsiteY210" fmla="*/ 6397010 h 6857968"/>
              <a:gd name="connsiteX211" fmla="*/ 5974349 w 9497977"/>
              <a:gd name="connsiteY211" fmla="*/ 6325709 h 6857968"/>
              <a:gd name="connsiteX212" fmla="*/ 5760447 w 9497977"/>
              <a:gd name="connsiteY212" fmla="*/ 6325709 h 6857968"/>
              <a:gd name="connsiteX213" fmla="*/ 5760447 w 9497977"/>
              <a:gd name="connsiteY213" fmla="*/ 6397010 h 6857968"/>
              <a:gd name="connsiteX214" fmla="*/ 5831748 w 9497977"/>
              <a:gd name="connsiteY214" fmla="*/ 6397010 h 6857968"/>
              <a:gd name="connsiteX215" fmla="*/ 5831748 w 9497977"/>
              <a:gd name="connsiteY215" fmla="*/ 6325709 h 6857968"/>
              <a:gd name="connsiteX216" fmla="*/ 5617774 w 9497977"/>
              <a:gd name="connsiteY216" fmla="*/ 6325709 h 6857968"/>
              <a:gd name="connsiteX217" fmla="*/ 5617774 w 9497977"/>
              <a:gd name="connsiteY217" fmla="*/ 6397010 h 6857968"/>
              <a:gd name="connsiteX218" fmla="*/ 5689075 w 9497977"/>
              <a:gd name="connsiteY218" fmla="*/ 6397010 h 6857968"/>
              <a:gd name="connsiteX219" fmla="*/ 5689075 w 9497977"/>
              <a:gd name="connsiteY219" fmla="*/ 6325709 h 6857968"/>
              <a:gd name="connsiteX220" fmla="*/ 5475173 w 9497977"/>
              <a:gd name="connsiteY220" fmla="*/ 6325709 h 6857968"/>
              <a:gd name="connsiteX221" fmla="*/ 5475173 w 9497977"/>
              <a:gd name="connsiteY221" fmla="*/ 6397010 h 6857968"/>
              <a:gd name="connsiteX222" fmla="*/ 5546474 w 9497977"/>
              <a:gd name="connsiteY222" fmla="*/ 6397010 h 6857968"/>
              <a:gd name="connsiteX223" fmla="*/ 5546474 w 9497977"/>
              <a:gd name="connsiteY223" fmla="*/ 6325709 h 6857968"/>
              <a:gd name="connsiteX224" fmla="*/ 5332500 w 9497977"/>
              <a:gd name="connsiteY224" fmla="*/ 6325709 h 6857968"/>
              <a:gd name="connsiteX225" fmla="*/ 5332500 w 9497977"/>
              <a:gd name="connsiteY225" fmla="*/ 6397010 h 6857968"/>
              <a:gd name="connsiteX226" fmla="*/ 5403801 w 9497977"/>
              <a:gd name="connsiteY226" fmla="*/ 6397010 h 6857968"/>
              <a:gd name="connsiteX227" fmla="*/ 5403801 w 9497977"/>
              <a:gd name="connsiteY227" fmla="*/ 6325709 h 6857968"/>
              <a:gd name="connsiteX228" fmla="*/ 5189828 w 9497977"/>
              <a:gd name="connsiteY228" fmla="*/ 6325709 h 6857968"/>
              <a:gd name="connsiteX229" fmla="*/ 5189828 w 9497977"/>
              <a:gd name="connsiteY229" fmla="*/ 6397010 h 6857968"/>
              <a:gd name="connsiteX230" fmla="*/ 5261129 w 9497977"/>
              <a:gd name="connsiteY230" fmla="*/ 6397010 h 6857968"/>
              <a:gd name="connsiteX231" fmla="*/ 5261129 w 9497977"/>
              <a:gd name="connsiteY231" fmla="*/ 6325709 h 6857968"/>
              <a:gd name="connsiteX232" fmla="*/ 5047226 w 9497977"/>
              <a:gd name="connsiteY232" fmla="*/ 6325709 h 6857968"/>
              <a:gd name="connsiteX233" fmla="*/ 5047226 w 9497977"/>
              <a:gd name="connsiteY233" fmla="*/ 6397010 h 6857968"/>
              <a:gd name="connsiteX234" fmla="*/ 5118527 w 9497977"/>
              <a:gd name="connsiteY234" fmla="*/ 6397010 h 6857968"/>
              <a:gd name="connsiteX235" fmla="*/ 5118527 w 9497977"/>
              <a:gd name="connsiteY235" fmla="*/ 6325709 h 6857968"/>
              <a:gd name="connsiteX236" fmla="*/ 4904553 w 9497977"/>
              <a:gd name="connsiteY236" fmla="*/ 6325709 h 6857968"/>
              <a:gd name="connsiteX237" fmla="*/ 4904553 w 9497977"/>
              <a:gd name="connsiteY237" fmla="*/ 6397010 h 6857968"/>
              <a:gd name="connsiteX238" fmla="*/ 4975854 w 9497977"/>
              <a:gd name="connsiteY238" fmla="*/ 6397010 h 6857968"/>
              <a:gd name="connsiteX239" fmla="*/ 4975854 w 9497977"/>
              <a:gd name="connsiteY239" fmla="*/ 6325709 h 6857968"/>
              <a:gd name="connsiteX240" fmla="*/ 4761952 w 9497977"/>
              <a:gd name="connsiteY240" fmla="*/ 6325709 h 6857968"/>
              <a:gd name="connsiteX241" fmla="*/ 4761952 w 9497977"/>
              <a:gd name="connsiteY241" fmla="*/ 6397010 h 6857968"/>
              <a:gd name="connsiteX242" fmla="*/ 4833253 w 9497977"/>
              <a:gd name="connsiteY242" fmla="*/ 6397010 h 6857968"/>
              <a:gd name="connsiteX243" fmla="*/ 4833253 w 9497977"/>
              <a:gd name="connsiteY243" fmla="*/ 6325709 h 6857968"/>
              <a:gd name="connsiteX244" fmla="*/ 4619279 w 9497977"/>
              <a:gd name="connsiteY244" fmla="*/ 6325709 h 6857968"/>
              <a:gd name="connsiteX245" fmla="*/ 4619279 w 9497977"/>
              <a:gd name="connsiteY245" fmla="*/ 6397010 h 6857968"/>
              <a:gd name="connsiteX246" fmla="*/ 4690580 w 9497977"/>
              <a:gd name="connsiteY246" fmla="*/ 6397010 h 6857968"/>
              <a:gd name="connsiteX247" fmla="*/ 4690580 w 9497977"/>
              <a:gd name="connsiteY247" fmla="*/ 6325709 h 6857968"/>
              <a:gd name="connsiteX248" fmla="*/ 4476678 w 9497977"/>
              <a:gd name="connsiteY248" fmla="*/ 6325709 h 6857968"/>
              <a:gd name="connsiteX249" fmla="*/ 4476678 w 9497977"/>
              <a:gd name="connsiteY249" fmla="*/ 6397010 h 6857968"/>
              <a:gd name="connsiteX250" fmla="*/ 4547979 w 9497977"/>
              <a:gd name="connsiteY250" fmla="*/ 6397010 h 6857968"/>
              <a:gd name="connsiteX251" fmla="*/ 4547979 w 9497977"/>
              <a:gd name="connsiteY251" fmla="*/ 6325709 h 6857968"/>
              <a:gd name="connsiteX252" fmla="*/ 4334005 w 9497977"/>
              <a:gd name="connsiteY252" fmla="*/ 6325709 h 6857968"/>
              <a:gd name="connsiteX253" fmla="*/ 4334005 w 9497977"/>
              <a:gd name="connsiteY253" fmla="*/ 6397010 h 6857968"/>
              <a:gd name="connsiteX254" fmla="*/ 4405306 w 9497977"/>
              <a:gd name="connsiteY254" fmla="*/ 6397010 h 6857968"/>
              <a:gd name="connsiteX255" fmla="*/ 4405306 w 9497977"/>
              <a:gd name="connsiteY255" fmla="*/ 6325709 h 6857968"/>
              <a:gd name="connsiteX256" fmla="*/ 4191404 w 9497977"/>
              <a:gd name="connsiteY256" fmla="*/ 6325709 h 6857968"/>
              <a:gd name="connsiteX257" fmla="*/ 4191404 w 9497977"/>
              <a:gd name="connsiteY257" fmla="*/ 6397010 h 6857968"/>
              <a:gd name="connsiteX258" fmla="*/ 4262705 w 9497977"/>
              <a:gd name="connsiteY258" fmla="*/ 6397010 h 6857968"/>
              <a:gd name="connsiteX259" fmla="*/ 4262705 w 9497977"/>
              <a:gd name="connsiteY259" fmla="*/ 6325709 h 6857968"/>
              <a:gd name="connsiteX260" fmla="*/ 4048731 w 9497977"/>
              <a:gd name="connsiteY260" fmla="*/ 6325709 h 6857968"/>
              <a:gd name="connsiteX261" fmla="*/ 4048731 w 9497977"/>
              <a:gd name="connsiteY261" fmla="*/ 6397010 h 6857968"/>
              <a:gd name="connsiteX262" fmla="*/ 4120032 w 9497977"/>
              <a:gd name="connsiteY262" fmla="*/ 6397010 h 6857968"/>
              <a:gd name="connsiteX263" fmla="*/ 4120032 w 9497977"/>
              <a:gd name="connsiteY263" fmla="*/ 6325709 h 6857968"/>
              <a:gd name="connsiteX264" fmla="*/ 3906059 w 9497977"/>
              <a:gd name="connsiteY264" fmla="*/ 6325709 h 6857968"/>
              <a:gd name="connsiteX265" fmla="*/ 3906059 w 9497977"/>
              <a:gd name="connsiteY265" fmla="*/ 6397010 h 6857968"/>
              <a:gd name="connsiteX266" fmla="*/ 3977360 w 9497977"/>
              <a:gd name="connsiteY266" fmla="*/ 6397010 h 6857968"/>
              <a:gd name="connsiteX267" fmla="*/ 3977360 w 9497977"/>
              <a:gd name="connsiteY267" fmla="*/ 6325709 h 6857968"/>
              <a:gd name="connsiteX268" fmla="*/ 3763457 w 9497977"/>
              <a:gd name="connsiteY268" fmla="*/ 6325709 h 6857968"/>
              <a:gd name="connsiteX269" fmla="*/ 3763457 w 9497977"/>
              <a:gd name="connsiteY269" fmla="*/ 6397010 h 6857968"/>
              <a:gd name="connsiteX270" fmla="*/ 3834758 w 9497977"/>
              <a:gd name="connsiteY270" fmla="*/ 6397010 h 6857968"/>
              <a:gd name="connsiteX271" fmla="*/ 3834758 w 9497977"/>
              <a:gd name="connsiteY271" fmla="*/ 6325709 h 6857968"/>
              <a:gd name="connsiteX272" fmla="*/ 3620784 w 9497977"/>
              <a:gd name="connsiteY272" fmla="*/ 6325709 h 6857968"/>
              <a:gd name="connsiteX273" fmla="*/ 3620784 w 9497977"/>
              <a:gd name="connsiteY273" fmla="*/ 6397010 h 6857968"/>
              <a:gd name="connsiteX274" fmla="*/ 3692085 w 9497977"/>
              <a:gd name="connsiteY274" fmla="*/ 6397010 h 6857968"/>
              <a:gd name="connsiteX275" fmla="*/ 3692085 w 9497977"/>
              <a:gd name="connsiteY275" fmla="*/ 6325709 h 6857968"/>
              <a:gd name="connsiteX276" fmla="*/ 3478184 w 9497977"/>
              <a:gd name="connsiteY276" fmla="*/ 6325709 h 6857968"/>
              <a:gd name="connsiteX277" fmla="*/ 3478184 w 9497977"/>
              <a:gd name="connsiteY277" fmla="*/ 6397010 h 6857968"/>
              <a:gd name="connsiteX278" fmla="*/ 3549484 w 9497977"/>
              <a:gd name="connsiteY278" fmla="*/ 6397010 h 6857968"/>
              <a:gd name="connsiteX279" fmla="*/ 3549484 w 9497977"/>
              <a:gd name="connsiteY279" fmla="*/ 6325709 h 6857968"/>
              <a:gd name="connsiteX280" fmla="*/ 3335511 w 9497977"/>
              <a:gd name="connsiteY280" fmla="*/ 6325709 h 6857968"/>
              <a:gd name="connsiteX281" fmla="*/ 3335511 w 9497977"/>
              <a:gd name="connsiteY281" fmla="*/ 6397010 h 6857968"/>
              <a:gd name="connsiteX282" fmla="*/ 3406811 w 9497977"/>
              <a:gd name="connsiteY282" fmla="*/ 6397010 h 6857968"/>
              <a:gd name="connsiteX283" fmla="*/ 3406811 w 9497977"/>
              <a:gd name="connsiteY283" fmla="*/ 6325709 h 6857968"/>
              <a:gd name="connsiteX284" fmla="*/ 3192839 w 9497977"/>
              <a:gd name="connsiteY284" fmla="*/ 6325709 h 6857968"/>
              <a:gd name="connsiteX285" fmla="*/ 3192839 w 9497977"/>
              <a:gd name="connsiteY285" fmla="*/ 6397010 h 6857968"/>
              <a:gd name="connsiteX286" fmla="*/ 3264139 w 9497977"/>
              <a:gd name="connsiteY286" fmla="*/ 6397010 h 6857968"/>
              <a:gd name="connsiteX287" fmla="*/ 3264139 w 9497977"/>
              <a:gd name="connsiteY287" fmla="*/ 6325709 h 6857968"/>
              <a:gd name="connsiteX288" fmla="*/ 3050237 w 9497977"/>
              <a:gd name="connsiteY288" fmla="*/ 6325709 h 6857968"/>
              <a:gd name="connsiteX289" fmla="*/ 3050237 w 9497977"/>
              <a:gd name="connsiteY289" fmla="*/ 6397010 h 6857968"/>
              <a:gd name="connsiteX290" fmla="*/ 3121537 w 9497977"/>
              <a:gd name="connsiteY290" fmla="*/ 6397010 h 6857968"/>
              <a:gd name="connsiteX291" fmla="*/ 3121537 w 9497977"/>
              <a:gd name="connsiteY291" fmla="*/ 6325709 h 6857968"/>
              <a:gd name="connsiteX292" fmla="*/ 2907564 w 9497977"/>
              <a:gd name="connsiteY292" fmla="*/ 6325709 h 6857968"/>
              <a:gd name="connsiteX293" fmla="*/ 2907564 w 9497977"/>
              <a:gd name="connsiteY293" fmla="*/ 6397010 h 6857968"/>
              <a:gd name="connsiteX294" fmla="*/ 2978865 w 9497977"/>
              <a:gd name="connsiteY294" fmla="*/ 6397010 h 6857968"/>
              <a:gd name="connsiteX295" fmla="*/ 2978865 w 9497977"/>
              <a:gd name="connsiteY295" fmla="*/ 6325709 h 6857968"/>
              <a:gd name="connsiteX296" fmla="*/ 2764962 w 9497977"/>
              <a:gd name="connsiteY296" fmla="*/ 6325709 h 6857968"/>
              <a:gd name="connsiteX297" fmla="*/ 2764962 w 9497977"/>
              <a:gd name="connsiteY297" fmla="*/ 6397010 h 6857968"/>
              <a:gd name="connsiteX298" fmla="*/ 2836263 w 9497977"/>
              <a:gd name="connsiteY298" fmla="*/ 6397010 h 6857968"/>
              <a:gd name="connsiteX299" fmla="*/ 2836263 w 9497977"/>
              <a:gd name="connsiteY299" fmla="*/ 6325709 h 6857968"/>
              <a:gd name="connsiteX300" fmla="*/ 2622291 w 9497977"/>
              <a:gd name="connsiteY300" fmla="*/ 6325709 h 6857968"/>
              <a:gd name="connsiteX301" fmla="*/ 2622291 w 9497977"/>
              <a:gd name="connsiteY301" fmla="*/ 6397010 h 6857968"/>
              <a:gd name="connsiteX302" fmla="*/ 2693591 w 9497977"/>
              <a:gd name="connsiteY302" fmla="*/ 6397010 h 6857968"/>
              <a:gd name="connsiteX303" fmla="*/ 2693591 w 9497977"/>
              <a:gd name="connsiteY303" fmla="*/ 6325709 h 6857968"/>
              <a:gd name="connsiteX304" fmla="*/ 2479688 w 9497977"/>
              <a:gd name="connsiteY304" fmla="*/ 6325709 h 6857968"/>
              <a:gd name="connsiteX305" fmla="*/ 2479688 w 9497977"/>
              <a:gd name="connsiteY305" fmla="*/ 6397010 h 6857968"/>
              <a:gd name="connsiteX306" fmla="*/ 2550990 w 9497977"/>
              <a:gd name="connsiteY306" fmla="*/ 6397010 h 6857968"/>
              <a:gd name="connsiteX307" fmla="*/ 2550990 w 9497977"/>
              <a:gd name="connsiteY307" fmla="*/ 6325709 h 6857968"/>
              <a:gd name="connsiteX308" fmla="*/ 2337016 w 9497977"/>
              <a:gd name="connsiteY308" fmla="*/ 6325709 h 6857968"/>
              <a:gd name="connsiteX309" fmla="*/ 2337016 w 9497977"/>
              <a:gd name="connsiteY309" fmla="*/ 6397010 h 6857968"/>
              <a:gd name="connsiteX310" fmla="*/ 2408317 w 9497977"/>
              <a:gd name="connsiteY310" fmla="*/ 6397010 h 6857968"/>
              <a:gd name="connsiteX311" fmla="*/ 2408317 w 9497977"/>
              <a:gd name="connsiteY311" fmla="*/ 6325709 h 6857968"/>
              <a:gd name="connsiteX312" fmla="*/ 2195429 w 9497977"/>
              <a:gd name="connsiteY312" fmla="*/ 6325709 h 6857968"/>
              <a:gd name="connsiteX313" fmla="*/ 2195429 w 9497977"/>
              <a:gd name="connsiteY313" fmla="*/ 6397010 h 6857968"/>
              <a:gd name="connsiteX314" fmla="*/ 2266731 w 9497977"/>
              <a:gd name="connsiteY314" fmla="*/ 6397010 h 6857968"/>
              <a:gd name="connsiteX315" fmla="*/ 2266731 w 9497977"/>
              <a:gd name="connsiteY315" fmla="*/ 6325709 h 6857968"/>
              <a:gd name="connsiteX316" fmla="*/ 2052828 w 9497977"/>
              <a:gd name="connsiteY316" fmla="*/ 6325709 h 6857968"/>
              <a:gd name="connsiteX317" fmla="*/ 2052828 w 9497977"/>
              <a:gd name="connsiteY317" fmla="*/ 6397010 h 6857968"/>
              <a:gd name="connsiteX318" fmla="*/ 2124128 w 9497977"/>
              <a:gd name="connsiteY318" fmla="*/ 6397010 h 6857968"/>
              <a:gd name="connsiteX319" fmla="*/ 2124128 w 9497977"/>
              <a:gd name="connsiteY319" fmla="*/ 6325709 h 6857968"/>
              <a:gd name="connsiteX320" fmla="*/ 1910155 w 9497977"/>
              <a:gd name="connsiteY320" fmla="*/ 6325709 h 6857968"/>
              <a:gd name="connsiteX321" fmla="*/ 1910155 w 9497977"/>
              <a:gd name="connsiteY321" fmla="*/ 6397010 h 6857968"/>
              <a:gd name="connsiteX322" fmla="*/ 1981455 w 9497977"/>
              <a:gd name="connsiteY322" fmla="*/ 6397010 h 6857968"/>
              <a:gd name="connsiteX323" fmla="*/ 1981455 w 9497977"/>
              <a:gd name="connsiteY323" fmla="*/ 6325709 h 6857968"/>
              <a:gd name="connsiteX324" fmla="*/ 1767483 w 9497977"/>
              <a:gd name="connsiteY324" fmla="*/ 6325709 h 6857968"/>
              <a:gd name="connsiteX325" fmla="*/ 1767483 w 9497977"/>
              <a:gd name="connsiteY325" fmla="*/ 6397010 h 6857968"/>
              <a:gd name="connsiteX326" fmla="*/ 1838783 w 9497977"/>
              <a:gd name="connsiteY326" fmla="*/ 6397010 h 6857968"/>
              <a:gd name="connsiteX327" fmla="*/ 1838783 w 9497977"/>
              <a:gd name="connsiteY327" fmla="*/ 6325709 h 6857968"/>
              <a:gd name="connsiteX328" fmla="*/ 1624882 w 9497977"/>
              <a:gd name="connsiteY328" fmla="*/ 6325709 h 6857968"/>
              <a:gd name="connsiteX329" fmla="*/ 1624882 w 9497977"/>
              <a:gd name="connsiteY329" fmla="*/ 6397010 h 6857968"/>
              <a:gd name="connsiteX330" fmla="*/ 1696183 w 9497977"/>
              <a:gd name="connsiteY330" fmla="*/ 6397010 h 6857968"/>
              <a:gd name="connsiteX331" fmla="*/ 1696183 w 9497977"/>
              <a:gd name="connsiteY331" fmla="*/ 6325709 h 6857968"/>
              <a:gd name="connsiteX332" fmla="*/ 1482215 w 9497977"/>
              <a:gd name="connsiteY332" fmla="*/ 6325709 h 6857968"/>
              <a:gd name="connsiteX333" fmla="*/ 1482215 w 9497977"/>
              <a:gd name="connsiteY333" fmla="*/ 6397010 h 6857968"/>
              <a:gd name="connsiteX334" fmla="*/ 1553511 w 9497977"/>
              <a:gd name="connsiteY334" fmla="*/ 6397010 h 6857968"/>
              <a:gd name="connsiteX335" fmla="*/ 1553511 w 9497977"/>
              <a:gd name="connsiteY335" fmla="*/ 6325709 h 6857968"/>
              <a:gd name="connsiteX336" fmla="*/ 1339621 w 9497977"/>
              <a:gd name="connsiteY336" fmla="*/ 6325709 h 6857968"/>
              <a:gd name="connsiteX337" fmla="*/ 1339621 w 9497977"/>
              <a:gd name="connsiteY337" fmla="*/ 6397010 h 6857968"/>
              <a:gd name="connsiteX338" fmla="*/ 1410920 w 9497977"/>
              <a:gd name="connsiteY338" fmla="*/ 6397010 h 6857968"/>
              <a:gd name="connsiteX339" fmla="*/ 1410920 w 9497977"/>
              <a:gd name="connsiteY339" fmla="*/ 6325709 h 6857968"/>
              <a:gd name="connsiteX340" fmla="*/ 1196941 w 9497977"/>
              <a:gd name="connsiteY340" fmla="*/ 6325709 h 6857968"/>
              <a:gd name="connsiteX341" fmla="*/ 1196941 w 9497977"/>
              <a:gd name="connsiteY341" fmla="*/ 6397010 h 6857968"/>
              <a:gd name="connsiteX342" fmla="*/ 1268245 w 9497977"/>
              <a:gd name="connsiteY342" fmla="*/ 6397010 h 6857968"/>
              <a:gd name="connsiteX343" fmla="*/ 1268245 w 9497977"/>
              <a:gd name="connsiteY343" fmla="*/ 6325709 h 6857968"/>
              <a:gd name="connsiteX344" fmla="*/ 1054277 w 9497977"/>
              <a:gd name="connsiteY344" fmla="*/ 6325709 h 6857968"/>
              <a:gd name="connsiteX345" fmla="*/ 1054277 w 9497977"/>
              <a:gd name="connsiteY345" fmla="*/ 6397010 h 6857968"/>
              <a:gd name="connsiteX346" fmla="*/ 1125575 w 9497977"/>
              <a:gd name="connsiteY346" fmla="*/ 6397010 h 6857968"/>
              <a:gd name="connsiteX347" fmla="*/ 1125575 w 9497977"/>
              <a:gd name="connsiteY347" fmla="*/ 6325709 h 6857968"/>
              <a:gd name="connsiteX348" fmla="*/ 911663 w 9497977"/>
              <a:gd name="connsiteY348" fmla="*/ 6325709 h 6857968"/>
              <a:gd name="connsiteX349" fmla="*/ 911663 w 9497977"/>
              <a:gd name="connsiteY349" fmla="*/ 6397010 h 6857968"/>
              <a:gd name="connsiteX350" fmla="*/ 982964 w 9497977"/>
              <a:gd name="connsiteY350" fmla="*/ 6397010 h 6857968"/>
              <a:gd name="connsiteX351" fmla="*/ 982964 w 9497977"/>
              <a:gd name="connsiteY351" fmla="*/ 6325709 h 6857968"/>
              <a:gd name="connsiteX352" fmla="*/ 769001 w 9497977"/>
              <a:gd name="connsiteY352" fmla="*/ 6325709 h 6857968"/>
              <a:gd name="connsiteX353" fmla="*/ 769001 w 9497977"/>
              <a:gd name="connsiteY353" fmla="*/ 6397010 h 6857968"/>
              <a:gd name="connsiteX354" fmla="*/ 840299 w 9497977"/>
              <a:gd name="connsiteY354" fmla="*/ 6397010 h 6857968"/>
              <a:gd name="connsiteX355" fmla="*/ 840299 w 9497977"/>
              <a:gd name="connsiteY355" fmla="*/ 6325709 h 6857968"/>
              <a:gd name="connsiteX356" fmla="*/ 626392 w 9497977"/>
              <a:gd name="connsiteY356" fmla="*/ 6325709 h 6857968"/>
              <a:gd name="connsiteX357" fmla="*/ 626392 w 9497977"/>
              <a:gd name="connsiteY357" fmla="*/ 6397010 h 6857968"/>
              <a:gd name="connsiteX358" fmla="*/ 697691 w 9497977"/>
              <a:gd name="connsiteY358" fmla="*/ 6397010 h 6857968"/>
              <a:gd name="connsiteX359" fmla="*/ 697691 w 9497977"/>
              <a:gd name="connsiteY359" fmla="*/ 6325709 h 6857968"/>
              <a:gd name="connsiteX360" fmla="*/ 7044216 w 9497977"/>
              <a:gd name="connsiteY360" fmla="*/ 6183107 h 6857968"/>
              <a:gd name="connsiteX361" fmla="*/ 7044216 w 9497977"/>
              <a:gd name="connsiteY361" fmla="*/ 6254408 h 6857968"/>
              <a:gd name="connsiteX362" fmla="*/ 7115517 w 9497977"/>
              <a:gd name="connsiteY362" fmla="*/ 6254408 h 6857968"/>
              <a:gd name="connsiteX363" fmla="*/ 7115517 w 9497977"/>
              <a:gd name="connsiteY363" fmla="*/ 6183107 h 6857968"/>
              <a:gd name="connsiteX364" fmla="*/ 6901543 w 9497977"/>
              <a:gd name="connsiteY364" fmla="*/ 6183107 h 6857968"/>
              <a:gd name="connsiteX365" fmla="*/ 6901543 w 9497977"/>
              <a:gd name="connsiteY365" fmla="*/ 6254408 h 6857968"/>
              <a:gd name="connsiteX366" fmla="*/ 6972844 w 9497977"/>
              <a:gd name="connsiteY366" fmla="*/ 6254408 h 6857968"/>
              <a:gd name="connsiteX367" fmla="*/ 6972844 w 9497977"/>
              <a:gd name="connsiteY367" fmla="*/ 6183107 h 6857968"/>
              <a:gd name="connsiteX368" fmla="*/ 6758942 w 9497977"/>
              <a:gd name="connsiteY368" fmla="*/ 6183107 h 6857968"/>
              <a:gd name="connsiteX369" fmla="*/ 6758942 w 9497977"/>
              <a:gd name="connsiteY369" fmla="*/ 6254408 h 6857968"/>
              <a:gd name="connsiteX370" fmla="*/ 6830242 w 9497977"/>
              <a:gd name="connsiteY370" fmla="*/ 6254408 h 6857968"/>
              <a:gd name="connsiteX371" fmla="*/ 6830242 w 9497977"/>
              <a:gd name="connsiteY371" fmla="*/ 6183107 h 6857968"/>
              <a:gd name="connsiteX372" fmla="*/ 6616269 w 9497977"/>
              <a:gd name="connsiteY372" fmla="*/ 6183107 h 6857968"/>
              <a:gd name="connsiteX373" fmla="*/ 6616269 w 9497977"/>
              <a:gd name="connsiteY373" fmla="*/ 6254408 h 6857968"/>
              <a:gd name="connsiteX374" fmla="*/ 6687570 w 9497977"/>
              <a:gd name="connsiteY374" fmla="*/ 6254408 h 6857968"/>
              <a:gd name="connsiteX375" fmla="*/ 6687570 w 9497977"/>
              <a:gd name="connsiteY375" fmla="*/ 6183107 h 6857968"/>
              <a:gd name="connsiteX376" fmla="*/ 6473667 w 9497977"/>
              <a:gd name="connsiteY376" fmla="*/ 6183107 h 6857968"/>
              <a:gd name="connsiteX377" fmla="*/ 6473667 w 9497977"/>
              <a:gd name="connsiteY377" fmla="*/ 6254408 h 6857968"/>
              <a:gd name="connsiteX378" fmla="*/ 6544968 w 9497977"/>
              <a:gd name="connsiteY378" fmla="*/ 6254408 h 6857968"/>
              <a:gd name="connsiteX379" fmla="*/ 6544968 w 9497977"/>
              <a:gd name="connsiteY379" fmla="*/ 6183107 h 6857968"/>
              <a:gd name="connsiteX380" fmla="*/ 6330995 w 9497977"/>
              <a:gd name="connsiteY380" fmla="*/ 6183107 h 6857968"/>
              <a:gd name="connsiteX381" fmla="*/ 6330995 w 9497977"/>
              <a:gd name="connsiteY381" fmla="*/ 6254408 h 6857968"/>
              <a:gd name="connsiteX382" fmla="*/ 6402296 w 9497977"/>
              <a:gd name="connsiteY382" fmla="*/ 6254408 h 6857968"/>
              <a:gd name="connsiteX383" fmla="*/ 6402296 w 9497977"/>
              <a:gd name="connsiteY383" fmla="*/ 6183107 h 6857968"/>
              <a:gd name="connsiteX384" fmla="*/ 6188393 w 9497977"/>
              <a:gd name="connsiteY384" fmla="*/ 6183107 h 6857968"/>
              <a:gd name="connsiteX385" fmla="*/ 6188393 w 9497977"/>
              <a:gd name="connsiteY385" fmla="*/ 6254408 h 6857968"/>
              <a:gd name="connsiteX386" fmla="*/ 6259694 w 9497977"/>
              <a:gd name="connsiteY386" fmla="*/ 6254408 h 6857968"/>
              <a:gd name="connsiteX387" fmla="*/ 6259694 w 9497977"/>
              <a:gd name="connsiteY387" fmla="*/ 6183107 h 6857968"/>
              <a:gd name="connsiteX388" fmla="*/ 6045721 w 9497977"/>
              <a:gd name="connsiteY388" fmla="*/ 6183107 h 6857968"/>
              <a:gd name="connsiteX389" fmla="*/ 6045721 w 9497977"/>
              <a:gd name="connsiteY389" fmla="*/ 6254408 h 6857968"/>
              <a:gd name="connsiteX390" fmla="*/ 6117021 w 9497977"/>
              <a:gd name="connsiteY390" fmla="*/ 6254408 h 6857968"/>
              <a:gd name="connsiteX391" fmla="*/ 6117021 w 9497977"/>
              <a:gd name="connsiteY391" fmla="*/ 6183107 h 6857968"/>
              <a:gd name="connsiteX392" fmla="*/ 5903048 w 9497977"/>
              <a:gd name="connsiteY392" fmla="*/ 6183107 h 6857968"/>
              <a:gd name="connsiteX393" fmla="*/ 5903048 w 9497977"/>
              <a:gd name="connsiteY393" fmla="*/ 6254408 h 6857968"/>
              <a:gd name="connsiteX394" fmla="*/ 5974349 w 9497977"/>
              <a:gd name="connsiteY394" fmla="*/ 6254408 h 6857968"/>
              <a:gd name="connsiteX395" fmla="*/ 5974349 w 9497977"/>
              <a:gd name="connsiteY395" fmla="*/ 6183107 h 6857968"/>
              <a:gd name="connsiteX396" fmla="*/ 5760447 w 9497977"/>
              <a:gd name="connsiteY396" fmla="*/ 6183107 h 6857968"/>
              <a:gd name="connsiteX397" fmla="*/ 5760447 w 9497977"/>
              <a:gd name="connsiteY397" fmla="*/ 6254408 h 6857968"/>
              <a:gd name="connsiteX398" fmla="*/ 5831748 w 9497977"/>
              <a:gd name="connsiteY398" fmla="*/ 6254408 h 6857968"/>
              <a:gd name="connsiteX399" fmla="*/ 5831748 w 9497977"/>
              <a:gd name="connsiteY399" fmla="*/ 6183107 h 6857968"/>
              <a:gd name="connsiteX400" fmla="*/ 5617774 w 9497977"/>
              <a:gd name="connsiteY400" fmla="*/ 6183107 h 6857968"/>
              <a:gd name="connsiteX401" fmla="*/ 5617774 w 9497977"/>
              <a:gd name="connsiteY401" fmla="*/ 6254408 h 6857968"/>
              <a:gd name="connsiteX402" fmla="*/ 5689075 w 9497977"/>
              <a:gd name="connsiteY402" fmla="*/ 6254408 h 6857968"/>
              <a:gd name="connsiteX403" fmla="*/ 5689075 w 9497977"/>
              <a:gd name="connsiteY403" fmla="*/ 6183107 h 6857968"/>
              <a:gd name="connsiteX404" fmla="*/ 5475173 w 9497977"/>
              <a:gd name="connsiteY404" fmla="*/ 6183107 h 6857968"/>
              <a:gd name="connsiteX405" fmla="*/ 5475173 w 9497977"/>
              <a:gd name="connsiteY405" fmla="*/ 6254408 h 6857968"/>
              <a:gd name="connsiteX406" fmla="*/ 5546474 w 9497977"/>
              <a:gd name="connsiteY406" fmla="*/ 6254408 h 6857968"/>
              <a:gd name="connsiteX407" fmla="*/ 5546474 w 9497977"/>
              <a:gd name="connsiteY407" fmla="*/ 6183107 h 6857968"/>
              <a:gd name="connsiteX408" fmla="*/ 5332500 w 9497977"/>
              <a:gd name="connsiteY408" fmla="*/ 6183107 h 6857968"/>
              <a:gd name="connsiteX409" fmla="*/ 5332500 w 9497977"/>
              <a:gd name="connsiteY409" fmla="*/ 6254408 h 6857968"/>
              <a:gd name="connsiteX410" fmla="*/ 5403801 w 9497977"/>
              <a:gd name="connsiteY410" fmla="*/ 6254408 h 6857968"/>
              <a:gd name="connsiteX411" fmla="*/ 5403801 w 9497977"/>
              <a:gd name="connsiteY411" fmla="*/ 6183107 h 6857968"/>
              <a:gd name="connsiteX412" fmla="*/ 5189828 w 9497977"/>
              <a:gd name="connsiteY412" fmla="*/ 6183107 h 6857968"/>
              <a:gd name="connsiteX413" fmla="*/ 5189828 w 9497977"/>
              <a:gd name="connsiteY413" fmla="*/ 6254408 h 6857968"/>
              <a:gd name="connsiteX414" fmla="*/ 5261129 w 9497977"/>
              <a:gd name="connsiteY414" fmla="*/ 6254408 h 6857968"/>
              <a:gd name="connsiteX415" fmla="*/ 5261129 w 9497977"/>
              <a:gd name="connsiteY415" fmla="*/ 6183107 h 6857968"/>
              <a:gd name="connsiteX416" fmla="*/ 5047226 w 9497977"/>
              <a:gd name="connsiteY416" fmla="*/ 6183107 h 6857968"/>
              <a:gd name="connsiteX417" fmla="*/ 5047226 w 9497977"/>
              <a:gd name="connsiteY417" fmla="*/ 6254408 h 6857968"/>
              <a:gd name="connsiteX418" fmla="*/ 5118527 w 9497977"/>
              <a:gd name="connsiteY418" fmla="*/ 6254408 h 6857968"/>
              <a:gd name="connsiteX419" fmla="*/ 5118527 w 9497977"/>
              <a:gd name="connsiteY419" fmla="*/ 6183107 h 6857968"/>
              <a:gd name="connsiteX420" fmla="*/ 4904553 w 9497977"/>
              <a:gd name="connsiteY420" fmla="*/ 6183107 h 6857968"/>
              <a:gd name="connsiteX421" fmla="*/ 4904553 w 9497977"/>
              <a:gd name="connsiteY421" fmla="*/ 6254408 h 6857968"/>
              <a:gd name="connsiteX422" fmla="*/ 4975854 w 9497977"/>
              <a:gd name="connsiteY422" fmla="*/ 6254408 h 6857968"/>
              <a:gd name="connsiteX423" fmla="*/ 4975854 w 9497977"/>
              <a:gd name="connsiteY423" fmla="*/ 6183107 h 6857968"/>
              <a:gd name="connsiteX424" fmla="*/ 4761952 w 9497977"/>
              <a:gd name="connsiteY424" fmla="*/ 6183107 h 6857968"/>
              <a:gd name="connsiteX425" fmla="*/ 4761952 w 9497977"/>
              <a:gd name="connsiteY425" fmla="*/ 6254408 h 6857968"/>
              <a:gd name="connsiteX426" fmla="*/ 4833253 w 9497977"/>
              <a:gd name="connsiteY426" fmla="*/ 6254408 h 6857968"/>
              <a:gd name="connsiteX427" fmla="*/ 4833253 w 9497977"/>
              <a:gd name="connsiteY427" fmla="*/ 6183107 h 6857968"/>
              <a:gd name="connsiteX428" fmla="*/ 4619279 w 9497977"/>
              <a:gd name="connsiteY428" fmla="*/ 6183107 h 6857968"/>
              <a:gd name="connsiteX429" fmla="*/ 4619279 w 9497977"/>
              <a:gd name="connsiteY429" fmla="*/ 6254408 h 6857968"/>
              <a:gd name="connsiteX430" fmla="*/ 4690580 w 9497977"/>
              <a:gd name="connsiteY430" fmla="*/ 6254408 h 6857968"/>
              <a:gd name="connsiteX431" fmla="*/ 4690580 w 9497977"/>
              <a:gd name="connsiteY431" fmla="*/ 6183107 h 6857968"/>
              <a:gd name="connsiteX432" fmla="*/ 4476678 w 9497977"/>
              <a:gd name="connsiteY432" fmla="*/ 6183107 h 6857968"/>
              <a:gd name="connsiteX433" fmla="*/ 4476678 w 9497977"/>
              <a:gd name="connsiteY433" fmla="*/ 6254408 h 6857968"/>
              <a:gd name="connsiteX434" fmla="*/ 4547979 w 9497977"/>
              <a:gd name="connsiteY434" fmla="*/ 6254408 h 6857968"/>
              <a:gd name="connsiteX435" fmla="*/ 4547979 w 9497977"/>
              <a:gd name="connsiteY435" fmla="*/ 6183107 h 6857968"/>
              <a:gd name="connsiteX436" fmla="*/ 4334005 w 9497977"/>
              <a:gd name="connsiteY436" fmla="*/ 6183107 h 6857968"/>
              <a:gd name="connsiteX437" fmla="*/ 4334005 w 9497977"/>
              <a:gd name="connsiteY437" fmla="*/ 6254408 h 6857968"/>
              <a:gd name="connsiteX438" fmla="*/ 4405306 w 9497977"/>
              <a:gd name="connsiteY438" fmla="*/ 6254408 h 6857968"/>
              <a:gd name="connsiteX439" fmla="*/ 4405306 w 9497977"/>
              <a:gd name="connsiteY439" fmla="*/ 6183107 h 6857968"/>
              <a:gd name="connsiteX440" fmla="*/ 4191404 w 9497977"/>
              <a:gd name="connsiteY440" fmla="*/ 6183107 h 6857968"/>
              <a:gd name="connsiteX441" fmla="*/ 4191404 w 9497977"/>
              <a:gd name="connsiteY441" fmla="*/ 6254408 h 6857968"/>
              <a:gd name="connsiteX442" fmla="*/ 4262705 w 9497977"/>
              <a:gd name="connsiteY442" fmla="*/ 6254408 h 6857968"/>
              <a:gd name="connsiteX443" fmla="*/ 4262705 w 9497977"/>
              <a:gd name="connsiteY443" fmla="*/ 6183107 h 6857968"/>
              <a:gd name="connsiteX444" fmla="*/ 4048731 w 9497977"/>
              <a:gd name="connsiteY444" fmla="*/ 6183107 h 6857968"/>
              <a:gd name="connsiteX445" fmla="*/ 4048731 w 9497977"/>
              <a:gd name="connsiteY445" fmla="*/ 6254408 h 6857968"/>
              <a:gd name="connsiteX446" fmla="*/ 4120032 w 9497977"/>
              <a:gd name="connsiteY446" fmla="*/ 6254408 h 6857968"/>
              <a:gd name="connsiteX447" fmla="*/ 4120032 w 9497977"/>
              <a:gd name="connsiteY447" fmla="*/ 6183107 h 6857968"/>
              <a:gd name="connsiteX448" fmla="*/ 3906059 w 9497977"/>
              <a:gd name="connsiteY448" fmla="*/ 6183107 h 6857968"/>
              <a:gd name="connsiteX449" fmla="*/ 3906059 w 9497977"/>
              <a:gd name="connsiteY449" fmla="*/ 6254408 h 6857968"/>
              <a:gd name="connsiteX450" fmla="*/ 3977360 w 9497977"/>
              <a:gd name="connsiteY450" fmla="*/ 6254408 h 6857968"/>
              <a:gd name="connsiteX451" fmla="*/ 3977360 w 9497977"/>
              <a:gd name="connsiteY451" fmla="*/ 6183107 h 6857968"/>
              <a:gd name="connsiteX452" fmla="*/ 3763457 w 9497977"/>
              <a:gd name="connsiteY452" fmla="*/ 6183107 h 6857968"/>
              <a:gd name="connsiteX453" fmla="*/ 3763457 w 9497977"/>
              <a:gd name="connsiteY453" fmla="*/ 6254408 h 6857968"/>
              <a:gd name="connsiteX454" fmla="*/ 3834758 w 9497977"/>
              <a:gd name="connsiteY454" fmla="*/ 6254408 h 6857968"/>
              <a:gd name="connsiteX455" fmla="*/ 3834758 w 9497977"/>
              <a:gd name="connsiteY455" fmla="*/ 6183107 h 6857968"/>
              <a:gd name="connsiteX456" fmla="*/ 3620784 w 9497977"/>
              <a:gd name="connsiteY456" fmla="*/ 6183107 h 6857968"/>
              <a:gd name="connsiteX457" fmla="*/ 3620784 w 9497977"/>
              <a:gd name="connsiteY457" fmla="*/ 6254408 h 6857968"/>
              <a:gd name="connsiteX458" fmla="*/ 3692085 w 9497977"/>
              <a:gd name="connsiteY458" fmla="*/ 6254408 h 6857968"/>
              <a:gd name="connsiteX459" fmla="*/ 3692085 w 9497977"/>
              <a:gd name="connsiteY459" fmla="*/ 6183107 h 6857968"/>
              <a:gd name="connsiteX460" fmla="*/ 3478184 w 9497977"/>
              <a:gd name="connsiteY460" fmla="*/ 6183107 h 6857968"/>
              <a:gd name="connsiteX461" fmla="*/ 3478184 w 9497977"/>
              <a:gd name="connsiteY461" fmla="*/ 6254408 h 6857968"/>
              <a:gd name="connsiteX462" fmla="*/ 3549484 w 9497977"/>
              <a:gd name="connsiteY462" fmla="*/ 6254408 h 6857968"/>
              <a:gd name="connsiteX463" fmla="*/ 3549484 w 9497977"/>
              <a:gd name="connsiteY463" fmla="*/ 6183107 h 6857968"/>
              <a:gd name="connsiteX464" fmla="*/ 3335511 w 9497977"/>
              <a:gd name="connsiteY464" fmla="*/ 6183107 h 6857968"/>
              <a:gd name="connsiteX465" fmla="*/ 3335511 w 9497977"/>
              <a:gd name="connsiteY465" fmla="*/ 6254408 h 6857968"/>
              <a:gd name="connsiteX466" fmla="*/ 3406811 w 9497977"/>
              <a:gd name="connsiteY466" fmla="*/ 6254408 h 6857968"/>
              <a:gd name="connsiteX467" fmla="*/ 3406811 w 9497977"/>
              <a:gd name="connsiteY467" fmla="*/ 6183107 h 6857968"/>
              <a:gd name="connsiteX468" fmla="*/ 3192839 w 9497977"/>
              <a:gd name="connsiteY468" fmla="*/ 6183107 h 6857968"/>
              <a:gd name="connsiteX469" fmla="*/ 3192839 w 9497977"/>
              <a:gd name="connsiteY469" fmla="*/ 6254408 h 6857968"/>
              <a:gd name="connsiteX470" fmla="*/ 3264139 w 9497977"/>
              <a:gd name="connsiteY470" fmla="*/ 6254408 h 6857968"/>
              <a:gd name="connsiteX471" fmla="*/ 3264139 w 9497977"/>
              <a:gd name="connsiteY471" fmla="*/ 6183107 h 6857968"/>
              <a:gd name="connsiteX472" fmla="*/ 3050237 w 9497977"/>
              <a:gd name="connsiteY472" fmla="*/ 6183107 h 6857968"/>
              <a:gd name="connsiteX473" fmla="*/ 3050237 w 9497977"/>
              <a:gd name="connsiteY473" fmla="*/ 6254408 h 6857968"/>
              <a:gd name="connsiteX474" fmla="*/ 3121537 w 9497977"/>
              <a:gd name="connsiteY474" fmla="*/ 6254408 h 6857968"/>
              <a:gd name="connsiteX475" fmla="*/ 3121537 w 9497977"/>
              <a:gd name="connsiteY475" fmla="*/ 6183107 h 6857968"/>
              <a:gd name="connsiteX476" fmla="*/ 2907564 w 9497977"/>
              <a:gd name="connsiteY476" fmla="*/ 6183107 h 6857968"/>
              <a:gd name="connsiteX477" fmla="*/ 2907564 w 9497977"/>
              <a:gd name="connsiteY477" fmla="*/ 6254408 h 6857968"/>
              <a:gd name="connsiteX478" fmla="*/ 2978865 w 9497977"/>
              <a:gd name="connsiteY478" fmla="*/ 6254408 h 6857968"/>
              <a:gd name="connsiteX479" fmla="*/ 2978865 w 9497977"/>
              <a:gd name="connsiteY479" fmla="*/ 6183107 h 6857968"/>
              <a:gd name="connsiteX480" fmla="*/ 2764962 w 9497977"/>
              <a:gd name="connsiteY480" fmla="*/ 6183107 h 6857968"/>
              <a:gd name="connsiteX481" fmla="*/ 2764962 w 9497977"/>
              <a:gd name="connsiteY481" fmla="*/ 6254408 h 6857968"/>
              <a:gd name="connsiteX482" fmla="*/ 2836263 w 9497977"/>
              <a:gd name="connsiteY482" fmla="*/ 6254408 h 6857968"/>
              <a:gd name="connsiteX483" fmla="*/ 2836263 w 9497977"/>
              <a:gd name="connsiteY483" fmla="*/ 6183107 h 6857968"/>
              <a:gd name="connsiteX484" fmla="*/ 2622291 w 9497977"/>
              <a:gd name="connsiteY484" fmla="*/ 6183107 h 6857968"/>
              <a:gd name="connsiteX485" fmla="*/ 2622291 w 9497977"/>
              <a:gd name="connsiteY485" fmla="*/ 6254408 h 6857968"/>
              <a:gd name="connsiteX486" fmla="*/ 2693591 w 9497977"/>
              <a:gd name="connsiteY486" fmla="*/ 6254408 h 6857968"/>
              <a:gd name="connsiteX487" fmla="*/ 2693591 w 9497977"/>
              <a:gd name="connsiteY487" fmla="*/ 6183107 h 6857968"/>
              <a:gd name="connsiteX488" fmla="*/ 2479688 w 9497977"/>
              <a:gd name="connsiteY488" fmla="*/ 6183107 h 6857968"/>
              <a:gd name="connsiteX489" fmla="*/ 2479688 w 9497977"/>
              <a:gd name="connsiteY489" fmla="*/ 6254408 h 6857968"/>
              <a:gd name="connsiteX490" fmla="*/ 2550990 w 9497977"/>
              <a:gd name="connsiteY490" fmla="*/ 6254408 h 6857968"/>
              <a:gd name="connsiteX491" fmla="*/ 2550990 w 9497977"/>
              <a:gd name="connsiteY491" fmla="*/ 6183107 h 6857968"/>
              <a:gd name="connsiteX492" fmla="*/ 2337016 w 9497977"/>
              <a:gd name="connsiteY492" fmla="*/ 6183107 h 6857968"/>
              <a:gd name="connsiteX493" fmla="*/ 2337016 w 9497977"/>
              <a:gd name="connsiteY493" fmla="*/ 6254408 h 6857968"/>
              <a:gd name="connsiteX494" fmla="*/ 2408317 w 9497977"/>
              <a:gd name="connsiteY494" fmla="*/ 6254408 h 6857968"/>
              <a:gd name="connsiteX495" fmla="*/ 2408317 w 9497977"/>
              <a:gd name="connsiteY495" fmla="*/ 6183107 h 6857968"/>
              <a:gd name="connsiteX496" fmla="*/ 2195429 w 9497977"/>
              <a:gd name="connsiteY496" fmla="*/ 6183107 h 6857968"/>
              <a:gd name="connsiteX497" fmla="*/ 2195429 w 9497977"/>
              <a:gd name="connsiteY497" fmla="*/ 6254408 h 6857968"/>
              <a:gd name="connsiteX498" fmla="*/ 2266731 w 9497977"/>
              <a:gd name="connsiteY498" fmla="*/ 6254408 h 6857968"/>
              <a:gd name="connsiteX499" fmla="*/ 2266731 w 9497977"/>
              <a:gd name="connsiteY499" fmla="*/ 6183107 h 6857968"/>
              <a:gd name="connsiteX500" fmla="*/ 2052828 w 9497977"/>
              <a:gd name="connsiteY500" fmla="*/ 6183107 h 6857968"/>
              <a:gd name="connsiteX501" fmla="*/ 2052828 w 9497977"/>
              <a:gd name="connsiteY501" fmla="*/ 6254408 h 6857968"/>
              <a:gd name="connsiteX502" fmla="*/ 2124128 w 9497977"/>
              <a:gd name="connsiteY502" fmla="*/ 6254408 h 6857968"/>
              <a:gd name="connsiteX503" fmla="*/ 2124128 w 9497977"/>
              <a:gd name="connsiteY503" fmla="*/ 6183107 h 6857968"/>
              <a:gd name="connsiteX504" fmla="*/ 1910155 w 9497977"/>
              <a:gd name="connsiteY504" fmla="*/ 6183107 h 6857968"/>
              <a:gd name="connsiteX505" fmla="*/ 1910155 w 9497977"/>
              <a:gd name="connsiteY505" fmla="*/ 6254408 h 6857968"/>
              <a:gd name="connsiteX506" fmla="*/ 1981455 w 9497977"/>
              <a:gd name="connsiteY506" fmla="*/ 6254408 h 6857968"/>
              <a:gd name="connsiteX507" fmla="*/ 1981455 w 9497977"/>
              <a:gd name="connsiteY507" fmla="*/ 6183107 h 6857968"/>
              <a:gd name="connsiteX508" fmla="*/ 1767483 w 9497977"/>
              <a:gd name="connsiteY508" fmla="*/ 6183107 h 6857968"/>
              <a:gd name="connsiteX509" fmla="*/ 1767483 w 9497977"/>
              <a:gd name="connsiteY509" fmla="*/ 6254408 h 6857968"/>
              <a:gd name="connsiteX510" fmla="*/ 1838783 w 9497977"/>
              <a:gd name="connsiteY510" fmla="*/ 6254408 h 6857968"/>
              <a:gd name="connsiteX511" fmla="*/ 1838783 w 9497977"/>
              <a:gd name="connsiteY511" fmla="*/ 6183107 h 6857968"/>
              <a:gd name="connsiteX512" fmla="*/ 1624882 w 9497977"/>
              <a:gd name="connsiteY512" fmla="*/ 6183107 h 6857968"/>
              <a:gd name="connsiteX513" fmla="*/ 1624882 w 9497977"/>
              <a:gd name="connsiteY513" fmla="*/ 6254408 h 6857968"/>
              <a:gd name="connsiteX514" fmla="*/ 1696183 w 9497977"/>
              <a:gd name="connsiteY514" fmla="*/ 6254408 h 6857968"/>
              <a:gd name="connsiteX515" fmla="*/ 1696183 w 9497977"/>
              <a:gd name="connsiteY515" fmla="*/ 6183107 h 6857968"/>
              <a:gd name="connsiteX516" fmla="*/ 1482215 w 9497977"/>
              <a:gd name="connsiteY516" fmla="*/ 6183107 h 6857968"/>
              <a:gd name="connsiteX517" fmla="*/ 1482215 w 9497977"/>
              <a:gd name="connsiteY517" fmla="*/ 6254408 h 6857968"/>
              <a:gd name="connsiteX518" fmla="*/ 1553511 w 9497977"/>
              <a:gd name="connsiteY518" fmla="*/ 6254408 h 6857968"/>
              <a:gd name="connsiteX519" fmla="*/ 1553511 w 9497977"/>
              <a:gd name="connsiteY519" fmla="*/ 6183107 h 6857968"/>
              <a:gd name="connsiteX520" fmla="*/ 1339621 w 9497977"/>
              <a:gd name="connsiteY520" fmla="*/ 6183107 h 6857968"/>
              <a:gd name="connsiteX521" fmla="*/ 1339621 w 9497977"/>
              <a:gd name="connsiteY521" fmla="*/ 6254408 h 6857968"/>
              <a:gd name="connsiteX522" fmla="*/ 1410920 w 9497977"/>
              <a:gd name="connsiteY522" fmla="*/ 6254408 h 6857968"/>
              <a:gd name="connsiteX523" fmla="*/ 1410920 w 9497977"/>
              <a:gd name="connsiteY523" fmla="*/ 6183107 h 6857968"/>
              <a:gd name="connsiteX524" fmla="*/ 1196948 w 9497977"/>
              <a:gd name="connsiteY524" fmla="*/ 6183107 h 6857968"/>
              <a:gd name="connsiteX525" fmla="*/ 1196948 w 9497977"/>
              <a:gd name="connsiteY525" fmla="*/ 6254408 h 6857968"/>
              <a:gd name="connsiteX526" fmla="*/ 1268245 w 9497977"/>
              <a:gd name="connsiteY526" fmla="*/ 6254408 h 6857968"/>
              <a:gd name="connsiteX527" fmla="*/ 1268245 w 9497977"/>
              <a:gd name="connsiteY527" fmla="*/ 6183107 h 6857968"/>
              <a:gd name="connsiteX528" fmla="*/ 1054277 w 9497977"/>
              <a:gd name="connsiteY528" fmla="*/ 6183107 h 6857968"/>
              <a:gd name="connsiteX529" fmla="*/ 1054277 w 9497977"/>
              <a:gd name="connsiteY529" fmla="*/ 6254408 h 6857968"/>
              <a:gd name="connsiteX530" fmla="*/ 1125575 w 9497977"/>
              <a:gd name="connsiteY530" fmla="*/ 6254408 h 6857968"/>
              <a:gd name="connsiteX531" fmla="*/ 1125575 w 9497977"/>
              <a:gd name="connsiteY531" fmla="*/ 6183107 h 6857968"/>
              <a:gd name="connsiteX532" fmla="*/ 911663 w 9497977"/>
              <a:gd name="connsiteY532" fmla="*/ 6183107 h 6857968"/>
              <a:gd name="connsiteX533" fmla="*/ 911663 w 9497977"/>
              <a:gd name="connsiteY533" fmla="*/ 6254408 h 6857968"/>
              <a:gd name="connsiteX534" fmla="*/ 982964 w 9497977"/>
              <a:gd name="connsiteY534" fmla="*/ 6254408 h 6857968"/>
              <a:gd name="connsiteX535" fmla="*/ 982964 w 9497977"/>
              <a:gd name="connsiteY535" fmla="*/ 6183107 h 6857968"/>
              <a:gd name="connsiteX536" fmla="*/ 769001 w 9497977"/>
              <a:gd name="connsiteY536" fmla="*/ 6183107 h 6857968"/>
              <a:gd name="connsiteX537" fmla="*/ 769001 w 9497977"/>
              <a:gd name="connsiteY537" fmla="*/ 6254408 h 6857968"/>
              <a:gd name="connsiteX538" fmla="*/ 840299 w 9497977"/>
              <a:gd name="connsiteY538" fmla="*/ 6254408 h 6857968"/>
              <a:gd name="connsiteX539" fmla="*/ 840299 w 9497977"/>
              <a:gd name="connsiteY539" fmla="*/ 6183107 h 6857968"/>
              <a:gd name="connsiteX540" fmla="*/ 7329490 w 9497977"/>
              <a:gd name="connsiteY540" fmla="*/ 6040435 h 6857968"/>
              <a:gd name="connsiteX541" fmla="*/ 7329490 w 9497977"/>
              <a:gd name="connsiteY541" fmla="*/ 6111736 h 6857968"/>
              <a:gd name="connsiteX542" fmla="*/ 7400791 w 9497977"/>
              <a:gd name="connsiteY542" fmla="*/ 6111736 h 6857968"/>
              <a:gd name="connsiteX543" fmla="*/ 7400791 w 9497977"/>
              <a:gd name="connsiteY543" fmla="*/ 6040435 h 6857968"/>
              <a:gd name="connsiteX544" fmla="*/ 7186888 w 9497977"/>
              <a:gd name="connsiteY544" fmla="*/ 6040435 h 6857968"/>
              <a:gd name="connsiteX545" fmla="*/ 7186888 w 9497977"/>
              <a:gd name="connsiteY545" fmla="*/ 6111736 h 6857968"/>
              <a:gd name="connsiteX546" fmla="*/ 7258188 w 9497977"/>
              <a:gd name="connsiteY546" fmla="*/ 6111736 h 6857968"/>
              <a:gd name="connsiteX547" fmla="*/ 7258188 w 9497977"/>
              <a:gd name="connsiteY547" fmla="*/ 6040435 h 6857968"/>
              <a:gd name="connsiteX548" fmla="*/ 7044216 w 9497977"/>
              <a:gd name="connsiteY548" fmla="*/ 6040435 h 6857968"/>
              <a:gd name="connsiteX549" fmla="*/ 7044216 w 9497977"/>
              <a:gd name="connsiteY549" fmla="*/ 6111736 h 6857968"/>
              <a:gd name="connsiteX550" fmla="*/ 7115517 w 9497977"/>
              <a:gd name="connsiteY550" fmla="*/ 6111736 h 6857968"/>
              <a:gd name="connsiteX551" fmla="*/ 7115517 w 9497977"/>
              <a:gd name="connsiteY551" fmla="*/ 6040435 h 6857968"/>
              <a:gd name="connsiteX552" fmla="*/ 6901543 w 9497977"/>
              <a:gd name="connsiteY552" fmla="*/ 6040435 h 6857968"/>
              <a:gd name="connsiteX553" fmla="*/ 6901543 w 9497977"/>
              <a:gd name="connsiteY553" fmla="*/ 6111736 h 6857968"/>
              <a:gd name="connsiteX554" fmla="*/ 6972844 w 9497977"/>
              <a:gd name="connsiteY554" fmla="*/ 6111736 h 6857968"/>
              <a:gd name="connsiteX555" fmla="*/ 6972844 w 9497977"/>
              <a:gd name="connsiteY555" fmla="*/ 6040435 h 6857968"/>
              <a:gd name="connsiteX556" fmla="*/ 6758942 w 9497977"/>
              <a:gd name="connsiteY556" fmla="*/ 6040435 h 6857968"/>
              <a:gd name="connsiteX557" fmla="*/ 6758942 w 9497977"/>
              <a:gd name="connsiteY557" fmla="*/ 6111736 h 6857968"/>
              <a:gd name="connsiteX558" fmla="*/ 6830242 w 9497977"/>
              <a:gd name="connsiteY558" fmla="*/ 6111736 h 6857968"/>
              <a:gd name="connsiteX559" fmla="*/ 6830242 w 9497977"/>
              <a:gd name="connsiteY559" fmla="*/ 6040435 h 6857968"/>
              <a:gd name="connsiteX560" fmla="*/ 6616269 w 9497977"/>
              <a:gd name="connsiteY560" fmla="*/ 6040435 h 6857968"/>
              <a:gd name="connsiteX561" fmla="*/ 6616269 w 9497977"/>
              <a:gd name="connsiteY561" fmla="*/ 6111736 h 6857968"/>
              <a:gd name="connsiteX562" fmla="*/ 6687570 w 9497977"/>
              <a:gd name="connsiteY562" fmla="*/ 6111736 h 6857968"/>
              <a:gd name="connsiteX563" fmla="*/ 6687570 w 9497977"/>
              <a:gd name="connsiteY563" fmla="*/ 6040435 h 6857968"/>
              <a:gd name="connsiteX564" fmla="*/ 6473667 w 9497977"/>
              <a:gd name="connsiteY564" fmla="*/ 6040435 h 6857968"/>
              <a:gd name="connsiteX565" fmla="*/ 6473667 w 9497977"/>
              <a:gd name="connsiteY565" fmla="*/ 6111736 h 6857968"/>
              <a:gd name="connsiteX566" fmla="*/ 6544968 w 9497977"/>
              <a:gd name="connsiteY566" fmla="*/ 6111736 h 6857968"/>
              <a:gd name="connsiteX567" fmla="*/ 6544968 w 9497977"/>
              <a:gd name="connsiteY567" fmla="*/ 6040435 h 6857968"/>
              <a:gd name="connsiteX568" fmla="*/ 6330995 w 9497977"/>
              <a:gd name="connsiteY568" fmla="*/ 6040435 h 6857968"/>
              <a:gd name="connsiteX569" fmla="*/ 6330995 w 9497977"/>
              <a:gd name="connsiteY569" fmla="*/ 6111736 h 6857968"/>
              <a:gd name="connsiteX570" fmla="*/ 6402296 w 9497977"/>
              <a:gd name="connsiteY570" fmla="*/ 6111736 h 6857968"/>
              <a:gd name="connsiteX571" fmla="*/ 6402296 w 9497977"/>
              <a:gd name="connsiteY571" fmla="*/ 6040435 h 6857968"/>
              <a:gd name="connsiteX572" fmla="*/ 6188393 w 9497977"/>
              <a:gd name="connsiteY572" fmla="*/ 6040435 h 6857968"/>
              <a:gd name="connsiteX573" fmla="*/ 6188393 w 9497977"/>
              <a:gd name="connsiteY573" fmla="*/ 6111736 h 6857968"/>
              <a:gd name="connsiteX574" fmla="*/ 6259694 w 9497977"/>
              <a:gd name="connsiteY574" fmla="*/ 6111736 h 6857968"/>
              <a:gd name="connsiteX575" fmla="*/ 6259694 w 9497977"/>
              <a:gd name="connsiteY575" fmla="*/ 6040435 h 6857968"/>
              <a:gd name="connsiteX576" fmla="*/ 6045721 w 9497977"/>
              <a:gd name="connsiteY576" fmla="*/ 6040435 h 6857968"/>
              <a:gd name="connsiteX577" fmla="*/ 6045721 w 9497977"/>
              <a:gd name="connsiteY577" fmla="*/ 6111736 h 6857968"/>
              <a:gd name="connsiteX578" fmla="*/ 6117021 w 9497977"/>
              <a:gd name="connsiteY578" fmla="*/ 6111736 h 6857968"/>
              <a:gd name="connsiteX579" fmla="*/ 6117021 w 9497977"/>
              <a:gd name="connsiteY579" fmla="*/ 6040435 h 6857968"/>
              <a:gd name="connsiteX580" fmla="*/ 5903048 w 9497977"/>
              <a:gd name="connsiteY580" fmla="*/ 6040435 h 6857968"/>
              <a:gd name="connsiteX581" fmla="*/ 5903048 w 9497977"/>
              <a:gd name="connsiteY581" fmla="*/ 6111736 h 6857968"/>
              <a:gd name="connsiteX582" fmla="*/ 5974349 w 9497977"/>
              <a:gd name="connsiteY582" fmla="*/ 6111736 h 6857968"/>
              <a:gd name="connsiteX583" fmla="*/ 5974349 w 9497977"/>
              <a:gd name="connsiteY583" fmla="*/ 6040435 h 6857968"/>
              <a:gd name="connsiteX584" fmla="*/ 5760447 w 9497977"/>
              <a:gd name="connsiteY584" fmla="*/ 6040435 h 6857968"/>
              <a:gd name="connsiteX585" fmla="*/ 5760447 w 9497977"/>
              <a:gd name="connsiteY585" fmla="*/ 6111736 h 6857968"/>
              <a:gd name="connsiteX586" fmla="*/ 5831748 w 9497977"/>
              <a:gd name="connsiteY586" fmla="*/ 6111736 h 6857968"/>
              <a:gd name="connsiteX587" fmla="*/ 5831748 w 9497977"/>
              <a:gd name="connsiteY587" fmla="*/ 6040435 h 6857968"/>
              <a:gd name="connsiteX588" fmla="*/ 5617774 w 9497977"/>
              <a:gd name="connsiteY588" fmla="*/ 6040435 h 6857968"/>
              <a:gd name="connsiteX589" fmla="*/ 5617774 w 9497977"/>
              <a:gd name="connsiteY589" fmla="*/ 6111736 h 6857968"/>
              <a:gd name="connsiteX590" fmla="*/ 5689075 w 9497977"/>
              <a:gd name="connsiteY590" fmla="*/ 6111736 h 6857968"/>
              <a:gd name="connsiteX591" fmla="*/ 5689075 w 9497977"/>
              <a:gd name="connsiteY591" fmla="*/ 6040435 h 6857968"/>
              <a:gd name="connsiteX592" fmla="*/ 5475173 w 9497977"/>
              <a:gd name="connsiteY592" fmla="*/ 6040435 h 6857968"/>
              <a:gd name="connsiteX593" fmla="*/ 5475173 w 9497977"/>
              <a:gd name="connsiteY593" fmla="*/ 6111736 h 6857968"/>
              <a:gd name="connsiteX594" fmla="*/ 5546474 w 9497977"/>
              <a:gd name="connsiteY594" fmla="*/ 6111736 h 6857968"/>
              <a:gd name="connsiteX595" fmla="*/ 5546474 w 9497977"/>
              <a:gd name="connsiteY595" fmla="*/ 6040435 h 6857968"/>
              <a:gd name="connsiteX596" fmla="*/ 5332500 w 9497977"/>
              <a:gd name="connsiteY596" fmla="*/ 6040435 h 6857968"/>
              <a:gd name="connsiteX597" fmla="*/ 5332500 w 9497977"/>
              <a:gd name="connsiteY597" fmla="*/ 6111736 h 6857968"/>
              <a:gd name="connsiteX598" fmla="*/ 5403801 w 9497977"/>
              <a:gd name="connsiteY598" fmla="*/ 6111736 h 6857968"/>
              <a:gd name="connsiteX599" fmla="*/ 5403801 w 9497977"/>
              <a:gd name="connsiteY599" fmla="*/ 6040435 h 6857968"/>
              <a:gd name="connsiteX600" fmla="*/ 5189828 w 9497977"/>
              <a:gd name="connsiteY600" fmla="*/ 6040435 h 6857968"/>
              <a:gd name="connsiteX601" fmla="*/ 5189828 w 9497977"/>
              <a:gd name="connsiteY601" fmla="*/ 6111736 h 6857968"/>
              <a:gd name="connsiteX602" fmla="*/ 5261129 w 9497977"/>
              <a:gd name="connsiteY602" fmla="*/ 6111736 h 6857968"/>
              <a:gd name="connsiteX603" fmla="*/ 5261129 w 9497977"/>
              <a:gd name="connsiteY603" fmla="*/ 6040435 h 6857968"/>
              <a:gd name="connsiteX604" fmla="*/ 5047226 w 9497977"/>
              <a:gd name="connsiteY604" fmla="*/ 6040435 h 6857968"/>
              <a:gd name="connsiteX605" fmla="*/ 5047226 w 9497977"/>
              <a:gd name="connsiteY605" fmla="*/ 6111736 h 6857968"/>
              <a:gd name="connsiteX606" fmla="*/ 5118527 w 9497977"/>
              <a:gd name="connsiteY606" fmla="*/ 6111736 h 6857968"/>
              <a:gd name="connsiteX607" fmla="*/ 5118527 w 9497977"/>
              <a:gd name="connsiteY607" fmla="*/ 6040435 h 6857968"/>
              <a:gd name="connsiteX608" fmla="*/ 4904553 w 9497977"/>
              <a:gd name="connsiteY608" fmla="*/ 6040435 h 6857968"/>
              <a:gd name="connsiteX609" fmla="*/ 4904553 w 9497977"/>
              <a:gd name="connsiteY609" fmla="*/ 6111736 h 6857968"/>
              <a:gd name="connsiteX610" fmla="*/ 4975854 w 9497977"/>
              <a:gd name="connsiteY610" fmla="*/ 6111736 h 6857968"/>
              <a:gd name="connsiteX611" fmla="*/ 4975854 w 9497977"/>
              <a:gd name="connsiteY611" fmla="*/ 6040435 h 6857968"/>
              <a:gd name="connsiteX612" fmla="*/ 4761952 w 9497977"/>
              <a:gd name="connsiteY612" fmla="*/ 6040435 h 6857968"/>
              <a:gd name="connsiteX613" fmla="*/ 4761952 w 9497977"/>
              <a:gd name="connsiteY613" fmla="*/ 6111736 h 6857968"/>
              <a:gd name="connsiteX614" fmla="*/ 4833253 w 9497977"/>
              <a:gd name="connsiteY614" fmla="*/ 6111736 h 6857968"/>
              <a:gd name="connsiteX615" fmla="*/ 4833253 w 9497977"/>
              <a:gd name="connsiteY615" fmla="*/ 6040435 h 6857968"/>
              <a:gd name="connsiteX616" fmla="*/ 4619279 w 9497977"/>
              <a:gd name="connsiteY616" fmla="*/ 6040435 h 6857968"/>
              <a:gd name="connsiteX617" fmla="*/ 4619279 w 9497977"/>
              <a:gd name="connsiteY617" fmla="*/ 6111736 h 6857968"/>
              <a:gd name="connsiteX618" fmla="*/ 4690580 w 9497977"/>
              <a:gd name="connsiteY618" fmla="*/ 6111736 h 6857968"/>
              <a:gd name="connsiteX619" fmla="*/ 4690580 w 9497977"/>
              <a:gd name="connsiteY619" fmla="*/ 6040435 h 6857968"/>
              <a:gd name="connsiteX620" fmla="*/ 4476678 w 9497977"/>
              <a:gd name="connsiteY620" fmla="*/ 6040435 h 6857968"/>
              <a:gd name="connsiteX621" fmla="*/ 4476678 w 9497977"/>
              <a:gd name="connsiteY621" fmla="*/ 6111736 h 6857968"/>
              <a:gd name="connsiteX622" fmla="*/ 4547979 w 9497977"/>
              <a:gd name="connsiteY622" fmla="*/ 6111736 h 6857968"/>
              <a:gd name="connsiteX623" fmla="*/ 4547979 w 9497977"/>
              <a:gd name="connsiteY623" fmla="*/ 6040435 h 6857968"/>
              <a:gd name="connsiteX624" fmla="*/ 4334005 w 9497977"/>
              <a:gd name="connsiteY624" fmla="*/ 6040435 h 6857968"/>
              <a:gd name="connsiteX625" fmla="*/ 4334005 w 9497977"/>
              <a:gd name="connsiteY625" fmla="*/ 6111736 h 6857968"/>
              <a:gd name="connsiteX626" fmla="*/ 4405306 w 9497977"/>
              <a:gd name="connsiteY626" fmla="*/ 6111736 h 6857968"/>
              <a:gd name="connsiteX627" fmla="*/ 4405306 w 9497977"/>
              <a:gd name="connsiteY627" fmla="*/ 6040435 h 6857968"/>
              <a:gd name="connsiteX628" fmla="*/ 4191404 w 9497977"/>
              <a:gd name="connsiteY628" fmla="*/ 6040435 h 6857968"/>
              <a:gd name="connsiteX629" fmla="*/ 4191404 w 9497977"/>
              <a:gd name="connsiteY629" fmla="*/ 6111736 h 6857968"/>
              <a:gd name="connsiteX630" fmla="*/ 4262705 w 9497977"/>
              <a:gd name="connsiteY630" fmla="*/ 6111736 h 6857968"/>
              <a:gd name="connsiteX631" fmla="*/ 4262705 w 9497977"/>
              <a:gd name="connsiteY631" fmla="*/ 6040435 h 6857968"/>
              <a:gd name="connsiteX632" fmla="*/ 4048731 w 9497977"/>
              <a:gd name="connsiteY632" fmla="*/ 6040435 h 6857968"/>
              <a:gd name="connsiteX633" fmla="*/ 4048731 w 9497977"/>
              <a:gd name="connsiteY633" fmla="*/ 6111736 h 6857968"/>
              <a:gd name="connsiteX634" fmla="*/ 4120032 w 9497977"/>
              <a:gd name="connsiteY634" fmla="*/ 6111736 h 6857968"/>
              <a:gd name="connsiteX635" fmla="*/ 4120032 w 9497977"/>
              <a:gd name="connsiteY635" fmla="*/ 6040435 h 6857968"/>
              <a:gd name="connsiteX636" fmla="*/ 3906059 w 9497977"/>
              <a:gd name="connsiteY636" fmla="*/ 6040435 h 6857968"/>
              <a:gd name="connsiteX637" fmla="*/ 3906059 w 9497977"/>
              <a:gd name="connsiteY637" fmla="*/ 6111736 h 6857968"/>
              <a:gd name="connsiteX638" fmla="*/ 3977360 w 9497977"/>
              <a:gd name="connsiteY638" fmla="*/ 6111736 h 6857968"/>
              <a:gd name="connsiteX639" fmla="*/ 3977360 w 9497977"/>
              <a:gd name="connsiteY639" fmla="*/ 6040435 h 6857968"/>
              <a:gd name="connsiteX640" fmla="*/ 3763457 w 9497977"/>
              <a:gd name="connsiteY640" fmla="*/ 6040435 h 6857968"/>
              <a:gd name="connsiteX641" fmla="*/ 3763457 w 9497977"/>
              <a:gd name="connsiteY641" fmla="*/ 6111736 h 6857968"/>
              <a:gd name="connsiteX642" fmla="*/ 3834758 w 9497977"/>
              <a:gd name="connsiteY642" fmla="*/ 6111736 h 6857968"/>
              <a:gd name="connsiteX643" fmla="*/ 3834758 w 9497977"/>
              <a:gd name="connsiteY643" fmla="*/ 6040435 h 6857968"/>
              <a:gd name="connsiteX644" fmla="*/ 3620784 w 9497977"/>
              <a:gd name="connsiteY644" fmla="*/ 6040435 h 6857968"/>
              <a:gd name="connsiteX645" fmla="*/ 3620784 w 9497977"/>
              <a:gd name="connsiteY645" fmla="*/ 6111736 h 6857968"/>
              <a:gd name="connsiteX646" fmla="*/ 3692085 w 9497977"/>
              <a:gd name="connsiteY646" fmla="*/ 6111736 h 6857968"/>
              <a:gd name="connsiteX647" fmla="*/ 3692085 w 9497977"/>
              <a:gd name="connsiteY647" fmla="*/ 6040435 h 6857968"/>
              <a:gd name="connsiteX648" fmla="*/ 3478184 w 9497977"/>
              <a:gd name="connsiteY648" fmla="*/ 6040435 h 6857968"/>
              <a:gd name="connsiteX649" fmla="*/ 3478184 w 9497977"/>
              <a:gd name="connsiteY649" fmla="*/ 6111736 h 6857968"/>
              <a:gd name="connsiteX650" fmla="*/ 3549484 w 9497977"/>
              <a:gd name="connsiteY650" fmla="*/ 6111736 h 6857968"/>
              <a:gd name="connsiteX651" fmla="*/ 3549484 w 9497977"/>
              <a:gd name="connsiteY651" fmla="*/ 6040435 h 6857968"/>
              <a:gd name="connsiteX652" fmla="*/ 3335511 w 9497977"/>
              <a:gd name="connsiteY652" fmla="*/ 6040435 h 6857968"/>
              <a:gd name="connsiteX653" fmla="*/ 3335511 w 9497977"/>
              <a:gd name="connsiteY653" fmla="*/ 6111736 h 6857968"/>
              <a:gd name="connsiteX654" fmla="*/ 3406811 w 9497977"/>
              <a:gd name="connsiteY654" fmla="*/ 6111736 h 6857968"/>
              <a:gd name="connsiteX655" fmla="*/ 3406811 w 9497977"/>
              <a:gd name="connsiteY655" fmla="*/ 6040435 h 6857968"/>
              <a:gd name="connsiteX656" fmla="*/ 3192839 w 9497977"/>
              <a:gd name="connsiteY656" fmla="*/ 6040435 h 6857968"/>
              <a:gd name="connsiteX657" fmla="*/ 3192839 w 9497977"/>
              <a:gd name="connsiteY657" fmla="*/ 6111736 h 6857968"/>
              <a:gd name="connsiteX658" fmla="*/ 3264139 w 9497977"/>
              <a:gd name="connsiteY658" fmla="*/ 6111736 h 6857968"/>
              <a:gd name="connsiteX659" fmla="*/ 3264139 w 9497977"/>
              <a:gd name="connsiteY659" fmla="*/ 6040435 h 6857968"/>
              <a:gd name="connsiteX660" fmla="*/ 3050237 w 9497977"/>
              <a:gd name="connsiteY660" fmla="*/ 6040435 h 6857968"/>
              <a:gd name="connsiteX661" fmla="*/ 3050237 w 9497977"/>
              <a:gd name="connsiteY661" fmla="*/ 6111736 h 6857968"/>
              <a:gd name="connsiteX662" fmla="*/ 3121537 w 9497977"/>
              <a:gd name="connsiteY662" fmla="*/ 6111736 h 6857968"/>
              <a:gd name="connsiteX663" fmla="*/ 3121537 w 9497977"/>
              <a:gd name="connsiteY663" fmla="*/ 6040435 h 6857968"/>
              <a:gd name="connsiteX664" fmla="*/ 2907564 w 9497977"/>
              <a:gd name="connsiteY664" fmla="*/ 6040435 h 6857968"/>
              <a:gd name="connsiteX665" fmla="*/ 2907564 w 9497977"/>
              <a:gd name="connsiteY665" fmla="*/ 6111736 h 6857968"/>
              <a:gd name="connsiteX666" fmla="*/ 2978865 w 9497977"/>
              <a:gd name="connsiteY666" fmla="*/ 6111736 h 6857968"/>
              <a:gd name="connsiteX667" fmla="*/ 2978865 w 9497977"/>
              <a:gd name="connsiteY667" fmla="*/ 6040435 h 6857968"/>
              <a:gd name="connsiteX668" fmla="*/ 2764962 w 9497977"/>
              <a:gd name="connsiteY668" fmla="*/ 6040435 h 6857968"/>
              <a:gd name="connsiteX669" fmla="*/ 2764962 w 9497977"/>
              <a:gd name="connsiteY669" fmla="*/ 6111736 h 6857968"/>
              <a:gd name="connsiteX670" fmla="*/ 2836263 w 9497977"/>
              <a:gd name="connsiteY670" fmla="*/ 6111736 h 6857968"/>
              <a:gd name="connsiteX671" fmla="*/ 2836263 w 9497977"/>
              <a:gd name="connsiteY671" fmla="*/ 6040435 h 6857968"/>
              <a:gd name="connsiteX672" fmla="*/ 2622291 w 9497977"/>
              <a:gd name="connsiteY672" fmla="*/ 6040435 h 6857968"/>
              <a:gd name="connsiteX673" fmla="*/ 2622291 w 9497977"/>
              <a:gd name="connsiteY673" fmla="*/ 6111736 h 6857968"/>
              <a:gd name="connsiteX674" fmla="*/ 2693591 w 9497977"/>
              <a:gd name="connsiteY674" fmla="*/ 6111736 h 6857968"/>
              <a:gd name="connsiteX675" fmla="*/ 2693591 w 9497977"/>
              <a:gd name="connsiteY675" fmla="*/ 6040435 h 6857968"/>
              <a:gd name="connsiteX676" fmla="*/ 2479688 w 9497977"/>
              <a:gd name="connsiteY676" fmla="*/ 6040435 h 6857968"/>
              <a:gd name="connsiteX677" fmla="*/ 2479688 w 9497977"/>
              <a:gd name="connsiteY677" fmla="*/ 6111736 h 6857968"/>
              <a:gd name="connsiteX678" fmla="*/ 2550990 w 9497977"/>
              <a:gd name="connsiteY678" fmla="*/ 6111736 h 6857968"/>
              <a:gd name="connsiteX679" fmla="*/ 2550990 w 9497977"/>
              <a:gd name="connsiteY679" fmla="*/ 6040435 h 6857968"/>
              <a:gd name="connsiteX680" fmla="*/ 2337016 w 9497977"/>
              <a:gd name="connsiteY680" fmla="*/ 6040435 h 6857968"/>
              <a:gd name="connsiteX681" fmla="*/ 2337016 w 9497977"/>
              <a:gd name="connsiteY681" fmla="*/ 6111736 h 6857968"/>
              <a:gd name="connsiteX682" fmla="*/ 2408317 w 9497977"/>
              <a:gd name="connsiteY682" fmla="*/ 6111736 h 6857968"/>
              <a:gd name="connsiteX683" fmla="*/ 2408317 w 9497977"/>
              <a:gd name="connsiteY683" fmla="*/ 6040435 h 6857968"/>
              <a:gd name="connsiteX684" fmla="*/ 2195429 w 9497977"/>
              <a:gd name="connsiteY684" fmla="*/ 6040435 h 6857968"/>
              <a:gd name="connsiteX685" fmla="*/ 2195429 w 9497977"/>
              <a:gd name="connsiteY685" fmla="*/ 6111736 h 6857968"/>
              <a:gd name="connsiteX686" fmla="*/ 2266731 w 9497977"/>
              <a:gd name="connsiteY686" fmla="*/ 6111736 h 6857968"/>
              <a:gd name="connsiteX687" fmla="*/ 2266731 w 9497977"/>
              <a:gd name="connsiteY687" fmla="*/ 6040435 h 6857968"/>
              <a:gd name="connsiteX688" fmla="*/ 2052828 w 9497977"/>
              <a:gd name="connsiteY688" fmla="*/ 6040435 h 6857968"/>
              <a:gd name="connsiteX689" fmla="*/ 2052828 w 9497977"/>
              <a:gd name="connsiteY689" fmla="*/ 6111736 h 6857968"/>
              <a:gd name="connsiteX690" fmla="*/ 2124128 w 9497977"/>
              <a:gd name="connsiteY690" fmla="*/ 6111736 h 6857968"/>
              <a:gd name="connsiteX691" fmla="*/ 2124128 w 9497977"/>
              <a:gd name="connsiteY691" fmla="*/ 6040435 h 6857968"/>
              <a:gd name="connsiteX692" fmla="*/ 1910155 w 9497977"/>
              <a:gd name="connsiteY692" fmla="*/ 6040435 h 6857968"/>
              <a:gd name="connsiteX693" fmla="*/ 1910155 w 9497977"/>
              <a:gd name="connsiteY693" fmla="*/ 6111736 h 6857968"/>
              <a:gd name="connsiteX694" fmla="*/ 1981455 w 9497977"/>
              <a:gd name="connsiteY694" fmla="*/ 6111736 h 6857968"/>
              <a:gd name="connsiteX695" fmla="*/ 1981455 w 9497977"/>
              <a:gd name="connsiteY695" fmla="*/ 6040435 h 6857968"/>
              <a:gd name="connsiteX696" fmla="*/ 1767483 w 9497977"/>
              <a:gd name="connsiteY696" fmla="*/ 6040435 h 6857968"/>
              <a:gd name="connsiteX697" fmla="*/ 1767483 w 9497977"/>
              <a:gd name="connsiteY697" fmla="*/ 6111736 h 6857968"/>
              <a:gd name="connsiteX698" fmla="*/ 1838783 w 9497977"/>
              <a:gd name="connsiteY698" fmla="*/ 6111736 h 6857968"/>
              <a:gd name="connsiteX699" fmla="*/ 1838783 w 9497977"/>
              <a:gd name="connsiteY699" fmla="*/ 6040435 h 6857968"/>
              <a:gd name="connsiteX700" fmla="*/ 1624882 w 9497977"/>
              <a:gd name="connsiteY700" fmla="*/ 6040435 h 6857968"/>
              <a:gd name="connsiteX701" fmla="*/ 1624882 w 9497977"/>
              <a:gd name="connsiteY701" fmla="*/ 6111736 h 6857968"/>
              <a:gd name="connsiteX702" fmla="*/ 1696183 w 9497977"/>
              <a:gd name="connsiteY702" fmla="*/ 6111736 h 6857968"/>
              <a:gd name="connsiteX703" fmla="*/ 1696183 w 9497977"/>
              <a:gd name="connsiteY703" fmla="*/ 6040435 h 6857968"/>
              <a:gd name="connsiteX704" fmla="*/ 1482218 w 9497977"/>
              <a:gd name="connsiteY704" fmla="*/ 6040435 h 6857968"/>
              <a:gd name="connsiteX705" fmla="*/ 1482218 w 9497977"/>
              <a:gd name="connsiteY705" fmla="*/ 6111736 h 6857968"/>
              <a:gd name="connsiteX706" fmla="*/ 1553511 w 9497977"/>
              <a:gd name="connsiteY706" fmla="*/ 6111736 h 6857968"/>
              <a:gd name="connsiteX707" fmla="*/ 1553511 w 9497977"/>
              <a:gd name="connsiteY707" fmla="*/ 6040435 h 6857968"/>
              <a:gd name="connsiteX708" fmla="*/ 1339621 w 9497977"/>
              <a:gd name="connsiteY708" fmla="*/ 6040435 h 6857968"/>
              <a:gd name="connsiteX709" fmla="*/ 1339621 w 9497977"/>
              <a:gd name="connsiteY709" fmla="*/ 6111736 h 6857968"/>
              <a:gd name="connsiteX710" fmla="*/ 1410920 w 9497977"/>
              <a:gd name="connsiteY710" fmla="*/ 6111736 h 6857968"/>
              <a:gd name="connsiteX711" fmla="*/ 1410920 w 9497977"/>
              <a:gd name="connsiteY711" fmla="*/ 6040435 h 6857968"/>
              <a:gd name="connsiteX712" fmla="*/ 1196948 w 9497977"/>
              <a:gd name="connsiteY712" fmla="*/ 6040435 h 6857968"/>
              <a:gd name="connsiteX713" fmla="*/ 1196948 w 9497977"/>
              <a:gd name="connsiteY713" fmla="*/ 6111736 h 6857968"/>
              <a:gd name="connsiteX714" fmla="*/ 1268245 w 9497977"/>
              <a:gd name="connsiteY714" fmla="*/ 6111736 h 6857968"/>
              <a:gd name="connsiteX715" fmla="*/ 1268245 w 9497977"/>
              <a:gd name="connsiteY715" fmla="*/ 6040435 h 6857968"/>
              <a:gd name="connsiteX716" fmla="*/ 1054277 w 9497977"/>
              <a:gd name="connsiteY716" fmla="*/ 6040435 h 6857968"/>
              <a:gd name="connsiteX717" fmla="*/ 1054277 w 9497977"/>
              <a:gd name="connsiteY717" fmla="*/ 6111736 h 6857968"/>
              <a:gd name="connsiteX718" fmla="*/ 1125575 w 9497977"/>
              <a:gd name="connsiteY718" fmla="*/ 6111736 h 6857968"/>
              <a:gd name="connsiteX719" fmla="*/ 1125575 w 9497977"/>
              <a:gd name="connsiteY719" fmla="*/ 6040435 h 6857968"/>
              <a:gd name="connsiteX720" fmla="*/ 911663 w 9497977"/>
              <a:gd name="connsiteY720" fmla="*/ 6040435 h 6857968"/>
              <a:gd name="connsiteX721" fmla="*/ 911663 w 9497977"/>
              <a:gd name="connsiteY721" fmla="*/ 6111736 h 6857968"/>
              <a:gd name="connsiteX722" fmla="*/ 982964 w 9497977"/>
              <a:gd name="connsiteY722" fmla="*/ 6111736 h 6857968"/>
              <a:gd name="connsiteX723" fmla="*/ 982964 w 9497977"/>
              <a:gd name="connsiteY723" fmla="*/ 6040435 h 6857968"/>
              <a:gd name="connsiteX724" fmla="*/ 6857645 w 9497977"/>
              <a:gd name="connsiteY724" fmla="*/ 0 h 6857968"/>
              <a:gd name="connsiteX725" fmla="*/ 9497977 w 9497977"/>
              <a:gd name="connsiteY725" fmla="*/ 0 h 6857968"/>
              <a:gd name="connsiteX726" fmla="*/ 9497977 w 9497977"/>
              <a:gd name="connsiteY726" fmla="*/ 6857968 h 6857968"/>
              <a:gd name="connsiteX727" fmla="*/ 0 w 9497977"/>
              <a:gd name="connsiteY727" fmla="*/ 6857968 h 6857968"/>
              <a:gd name="connsiteX728" fmla="*/ 341118 w 9497977"/>
              <a:gd name="connsiteY728" fmla="*/ 6516838 h 6857968"/>
              <a:gd name="connsiteX729" fmla="*/ 341118 w 9497977"/>
              <a:gd name="connsiteY729" fmla="*/ 6545648 h 6857968"/>
              <a:gd name="connsiteX730" fmla="*/ 412416 w 9497977"/>
              <a:gd name="connsiteY730" fmla="*/ 6545648 h 6857968"/>
              <a:gd name="connsiteX731" fmla="*/ 412416 w 9497977"/>
              <a:gd name="connsiteY731" fmla="*/ 6474347 h 6857968"/>
              <a:gd name="connsiteX732" fmla="*/ 383607 w 9497977"/>
              <a:gd name="connsiteY732" fmla="*/ 6474347 h 6857968"/>
              <a:gd name="connsiteX733" fmla="*/ 483718 w 9497977"/>
              <a:gd name="connsiteY733" fmla="*/ 6374231 h 6857968"/>
              <a:gd name="connsiteX734" fmla="*/ 483718 w 9497977"/>
              <a:gd name="connsiteY734" fmla="*/ 6397010 h 6857968"/>
              <a:gd name="connsiteX735" fmla="*/ 555020 w 9497977"/>
              <a:gd name="connsiteY735" fmla="*/ 6397010 h 6857968"/>
              <a:gd name="connsiteX736" fmla="*/ 555020 w 9497977"/>
              <a:gd name="connsiteY736" fmla="*/ 6325709 h 6857968"/>
              <a:gd name="connsiteX737" fmla="*/ 532239 w 9497977"/>
              <a:gd name="connsiteY737" fmla="*/ 6325709 h 6857968"/>
              <a:gd name="connsiteX738" fmla="*/ 626392 w 9497977"/>
              <a:gd name="connsiteY738" fmla="*/ 6231552 h 6857968"/>
              <a:gd name="connsiteX739" fmla="*/ 626392 w 9497977"/>
              <a:gd name="connsiteY739" fmla="*/ 6254408 h 6857968"/>
              <a:gd name="connsiteX740" fmla="*/ 697691 w 9497977"/>
              <a:gd name="connsiteY740" fmla="*/ 6254408 h 6857968"/>
              <a:gd name="connsiteX741" fmla="*/ 697691 w 9497977"/>
              <a:gd name="connsiteY741" fmla="*/ 6183107 h 6857968"/>
              <a:gd name="connsiteX742" fmla="*/ 674833 w 9497977"/>
              <a:gd name="connsiteY742" fmla="*/ 6183107 h 6857968"/>
              <a:gd name="connsiteX743" fmla="*/ 769001 w 9497977"/>
              <a:gd name="connsiteY743" fmla="*/ 6088935 h 6857968"/>
              <a:gd name="connsiteX744" fmla="*/ 769001 w 9497977"/>
              <a:gd name="connsiteY744" fmla="*/ 6111736 h 6857968"/>
              <a:gd name="connsiteX745" fmla="*/ 840303 w 9497977"/>
              <a:gd name="connsiteY745" fmla="*/ 6111736 h 6857968"/>
              <a:gd name="connsiteX746" fmla="*/ 840303 w 9497977"/>
              <a:gd name="connsiteY746" fmla="*/ 6040435 h 6857968"/>
              <a:gd name="connsiteX747" fmla="*/ 817496 w 9497977"/>
              <a:gd name="connsiteY747" fmla="*/ 6040435 h 685796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  <a:cxn ang="0">
                <a:pos x="connsiteX229" y="connsiteY229"/>
              </a:cxn>
              <a:cxn ang="0">
                <a:pos x="connsiteX230" y="connsiteY230"/>
              </a:cxn>
              <a:cxn ang="0">
                <a:pos x="connsiteX231" y="connsiteY231"/>
              </a:cxn>
              <a:cxn ang="0">
                <a:pos x="connsiteX232" y="connsiteY232"/>
              </a:cxn>
              <a:cxn ang="0">
                <a:pos x="connsiteX233" y="connsiteY233"/>
              </a:cxn>
              <a:cxn ang="0">
                <a:pos x="connsiteX234" y="connsiteY234"/>
              </a:cxn>
              <a:cxn ang="0">
                <a:pos x="connsiteX235" y="connsiteY235"/>
              </a:cxn>
              <a:cxn ang="0">
                <a:pos x="connsiteX236" y="connsiteY236"/>
              </a:cxn>
              <a:cxn ang="0">
                <a:pos x="connsiteX237" y="connsiteY237"/>
              </a:cxn>
              <a:cxn ang="0">
                <a:pos x="connsiteX238" y="connsiteY238"/>
              </a:cxn>
              <a:cxn ang="0">
                <a:pos x="connsiteX239" y="connsiteY239"/>
              </a:cxn>
              <a:cxn ang="0">
                <a:pos x="connsiteX240" y="connsiteY240"/>
              </a:cxn>
              <a:cxn ang="0">
                <a:pos x="connsiteX241" y="connsiteY241"/>
              </a:cxn>
              <a:cxn ang="0">
                <a:pos x="connsiteX242" y="connsiteY242"/>
              </a:cxn>
              <a:cxn ang="0">
                <a:pos x="connsiteX243" y="connsiteY243"/>
              </a:cxn>
              <a:cxn ang="0">
                <a:pos x="connsiteX244" y="connsiteY244"/>
              </a:cxn>
              <a:cxn ang="0">
                <a:pos x="connsiteX245" y="connsiteY245"/>
              </a:cxn>
              <a:cxn ang="0">
                <a:pos x="connsiteX246" y="connsiteY246"/>
              </a:cxn>
              <a:cxn ang="0">
                <a:pos x="connsiteX247" y="connsiteY247"/>
              </a:cxn>
              <a:cxn ang="0">
                <a:pos x="connsiteX248" y="connsiteY248"/>
              </a:cxn>
              <a:cxn ang="0">
                <a:pos x="connsiteX249" y="connsiteY249"/>
              </a:cxn>
              <a:cxn ang="0">
                <a:pos x="connsiteX250" y="connsiteY250"/>
              </a:cxn>
              <a:cxn ang="0">
                <a:pos x="connsiteX251" y="connsiteY251"/>
              </a:cxn>
              <a:cxn ang="0">
                <a:pos x="connsiteX252" y="connsiteY252"/>
              </a:cxn>
              <a:cxn ang="0">
                <a:pos x="connsiteX253" y="connsiteY253"/>
              </a:cxn>
              <a:cxn ang="0">
                <a:pos x="connsiteX254" y="connsiteY254"/>
              </a:cxn>
              <a:cxn ang="0">
                <a:pos x="connsiteX255" y="connsiteY255"/>
              </a:cxn>
              <a:cxn ang="0">
                <a:pos x="connsiteX256" y="connsiteY256"/>
              </a:cxn>
              <a:cxn ang="0">
                <a:pos x="connsiteX257" y="connsiteY257"/>
              </a:cxn>
              <a:cxn ang="0">
                <a:pos x="connsiteX258" y="connsiteY258"/>
              </a:cxn>
              <a:cxn ang="0">
                <a:pos x="connsiteX259" y="connsiteY259"/>
              </a:cxn>
              <a:cxn ang="0">
                <a:pos x="connsiteX260" y="connsiteY260"/>
              </a:cxn>
              <a:cxn ang="0">
                <a:pos x="connsiteX261" y="connsiteY261"/>
              </a:cxn>
              <a:cxn ang="0">
                <a:pos x="connsiteX262" y="connsiteY262"/>
              </a:cxn>
              <a:cxn ang="0">
                <a:pos x="connsiteX263" y="connsiteY263"/>
              </a:cxn>
              <a:cxn ang="0">
                <a:pos x="connsiteX264" y="connsiteY264"/>
              </a:cxn>
              <a:cxn ang="0">
                <a:pos x="connsiteX265" y="connsiteY265"/>
              </a:cxn>
              <a:cxn ang="0">
                <a:pos x="connsiteX266" y="connsiteY266"/>
              </a:cxn>
              <a:cxn ang="0">
                <a:pos x="connsiteX267" y="connsiteY267"/>
              </a:cxn>
              <a:cxn ang="0">
                <a:pos x="connsiteX268" y="connsiteY268"/>
              </a:cxn>
              <a:cxn ang="0">
                <a:pos x="connsiteX269" y="connsiteY269"/>
              </a:cxn>
              <a:cxn ang="0">
                <a:pos x="connsiteX270" y="connsiteY270"/>
              </a:cxn>
              <a:cxn ang="0">
                <a:pos x="connsiteX271" y="connsiteY271"/>
              </a:cxn>
              <a:cxn ang="0">
                <a:pos x="connsiteX272" y="connsiteY272"/>
              </a:cxn>
              <a:cxn ang="0">
                <a:pos x="connsiteX273" y="connsiteY273"/>
              </a:cxn>
              <a:cxn ang="0">
                <a:pos x="connsiteX274" y="connsiteY274"/>
              </a:cxn>
              <a:cxn ang="0">
                <a:pos x="connsiteX275" y="connsiteY275"/>
              </a:cxn>
              <a:cxn ang="0">
                <a:pos x="connsiteX276" y="connsiteY276"/>
              </a:cxn>
              <a:cxn ang="0">
                <a:pos x="connsiteX277" y="connsiteY277"/>
              </a:cxn>
              <a:cxn ang="0">
                <a:pos x="connsiteX278" y="connsiteY278"/>
              </a:cxn>
              <a:cxn ang="0">
                <a:pos x="connsiteX279" y="connsiteY279"/>
              </a:cxn>
              <a:cxn ang="0">
                <a:pos x="connsiteX280" y="connsiteY280"/>
              </a:cxn>
              <a:cxn ang="0">
                <a:pos x="connsiteX281" y="connsiteY281"/>
              </a:cxn>
              <a:cxn ang="0">
                <a:pos x="connsiteX282" y="connsiteY282"/>
              </a:cxn>
              <a:cxn ang="0">
                <a:pos x="connsiteX283" y="connsiteY283"/>
              </a:cxn>
              <a:cxn ang="0">
                <a:pos x="connsiteX284" y="connsiteY284"/>
              </a:cxn>
              <a:cxn ang="0">
                <a:pos x="connsiteX285" y="connsiteY285"/>
              </a:cxn>
              <a:cxn ang="0">
                <a:pos x="connsiteX286" y="connsiteY286"/>
              </a:cxn>
              <a:cxn ang="0">
                <a:pos x="connsiteX287" y="connsiteY287"/>
              </a:cxn>
              <a:cxn ang="0">
                <a:pos x="connsiteX288" y="connsiteY288"/>
              </a:cxn>
              <a:cxn ang="0">
                <a:pos x="connsiteX289" y="connsiteY289"/>
              </a:cxn>
              <a:cxn ang="0">
                <a:pos x="connsiteX290" y="connsiteY290"/>
              </a:cxn>
              <a:cxn ang="0">
                <a:pos x="connsiteX291" y="connsiteY291"/>
              </a:cxn>
              <a:cxn ang="0">
                <a:pos x="connsiteX292" y="connsiteY292"/>
              </a:cxn>
              <a:cxn ang="0">
                <a:pos x="connsiteX293" y="connsiteY293"/>
              </a:cxn>
              <a:cxn ang="0">
                <a:pos x="connsiteX294" y="connsiteY294"/>
              </a:cxn>
              <a:cxn ang="0">
                <a:pos x="connsiteX295" y="connsiteY295"/>
              </a:cxn>
              <a:cxn ang="0">
                <a:pos x="connsiteX296" y="connsiteY296"/>
              </a:cxn>
              <a:cxn ang="0">
                <a:pos x="connsiteX297" y="connsiteY297"/>
              </a:cxn>
              <a:cxn ang="0">
                <a:pos x="connsiteX298" y="connsiteY298"/>
              </a:cxn>
              <a:cxn ang="0">
                <a:pos x="connsiteX299" y="connsiteY299"/>
              </a:cxn>
              <a:cxn ang="0">
                <a:pos x="connsiteX300" y="connsiteY300"/>
              </a:cxn>
              <a:cxn ang="0">
                <a:pos x="connsiteX301" y="connsiteY301"/>
              </a:cxn>
              <a:cxn ang="0">
                <a:pos x="connsiteX302" y="connsiteY302"/>
              </a:cxn>
              <a:cxn ang="0">
                <a:pos x="connsiteX303" y="connsiteY303"/>
              </a:cxn>
              <a:cxn ang="0">
                <a:pos x="connsiteX304" y="connsiteY304"/>
              </a:cxn>
              <a:cxn ang="0">
                <a:pos x="connsiteX305" y="connsiteY305"/>
              </a:cxn>
              <a:cxn ang="0">
                <a:pos x="connsiteX306" y="connsiteY306"/>
              </a:cxn>
              <a:cxn ang="0">
                <a:pos x="connsiteX307" y="connsiteY307"/>
              </a:cxn>
              <a:cxn ang="0">
                <a:pos x="connsiteX308" y="connsiteY308"/>
              </a:cxn>
              <a:cxn ang="0">
                <a:pos x="connsiteX309" y="connsiteY309"/>
              </a:cxn>
              <a:cxn ang="0">
                <a:pos x="connsiteX310" y="connsiteY310"/>
              </a:cxn>
              <a:cxn ang="0">
                <a:pos x="connsiteX311" y="connsiteY311"/>
              </a:cxn>
              <a:cxn ang="0">
                <a:pos x="connsiteX312" y="connsiteY312"/>
              </a:cxn>
              <a:cxn ang="0">
                <a:pos x="connsiteX313" y="connsiteY313"/>
              </a:cxn>
              <a:cxn ang="0">
                <a:pos x="connsiteX314" y="connsiteY314"/>
              </a:cxn>
              <a:cxn ang="0">
                <a:pos x="connsiteX315" y="connsiteY315"/>
              </a:cxn>
              <a:cxn ang="0">
                <a:pos x="connsiteX316" y="connsiteY316"/>
              </a:cxn>
              <a:cxn ang="0">
                <a:pos x="connsiteX317" y="connsiteY317"/>
              </a:cxn>
              <a:cxn ang="0">
                <a:pos x="connsiteX318" y="connsiteY318"/>
              </a:cxn>
              <a:cxn ang="0">
                <a:pos x="connsiteX319" y="connsiteY319"/>
              </a:cxn>
              <a:cxn ang="0">
                <a:pos x="connsiteX320" y="connsiteY320"/>
              </a:cxn>
              <a:cxn ang="0">
                <a:pos x="connsiteX321" y="connsiteY321"/>
              </a:cxn>
              <a:cxn ang="0">
                <a:pos x="connsiteX322" y="connsiteY322"/>
              </a:cxn>
              <a:cxn ang="0">
                <a:pos x="connsiteX323" y="connsiteY323"/>
              </a:cxn>
              <a:cxn ang="0">
                <a:pos x="connsiteX324" y="connsiteY324"/>
              </a:cxn>
              <a:cxn ang="0">
                <a:pos x="connsiteX325" y="connsiteY325"/>
              </a:cxn>
              <a:cxn ang="0">
                <a:pos x="connsiteX326" y="connsiteY326"/>
              </a:cxn>
              <a:cxn ang="0">
                <a:pos x="connsiteX327" y="connsiteY327"/>
              </a:cxn>
              <a:cxn ang="0">
                <a:pos x="connsiteX328" y="connsiteY328"/>
              </a:cxn>
              <a:cxn ang="0">
                <a:pos x="connsiteX329" y="connsiteY329"/>
              </a:cxn>
              <a:cxn ang="0">
                <a:pos x="connsiteX330" y="connsiteY330"/>
              </a:cxn>
              <a:cxn ang="0">
                <a:pos x="connsiteX331" y="connsiteY331"/>
              </a:cxn>
              <a:cxn ang="0">
                <a:pos x="connsiteX332" y="connsiteY332"/>
              </a:cxn>
              <a:cxn ang="0">
                <a:pos x="connsiteX333" y="connsiteY333"/>
              </a:cxn>
              <a:cxn ang="0">
                <a:pos x="connsiteX334" y="connsiteY334"/>
              </a:cxn>
              <a:cxn ang="0">
                <a:pos x="connsiteX335" y="connsiteY335"/>
              </a:cxn>
              <a:cxn ang="0">
                <a:pos x="connsiteX336" y="connsiteY336"/>
              </a:cxn>
              <a:cxn ang="0">
                <a:pos x="connsiteX337" y="connsiteY337"/>
              </a:cxn>
              <a:cxn ang="0">
                <a:pos x="connsiteX338" y="connsiteY338"/>
              </a:cxn>
              <a:cxn ang="0">
                <a:pos x="connsiteX339" y="connsiteY339"/>
              </a:cxn>
              <a:cxn ang="0">
                <a:pos x="connsiteX340" y="connsiteY340"/>
              </a:cxn>
              <a:cxn ang="0">
                <a:pos x="connsiteX341" y="connsiteY341"/>
              </a:cxn>
              <a:cxn ang="0">
                <a:pos x="connsiteX342" y="connsiteY342"/>
              </a:cxn>
              <a:cxn ang="0">
                <a:pos x="connsiteX343" y="connsiteY343"/>
              </a:cxn>
              <a:cxn ang="0">
                <a:pos x="connsiteX344" y="connsiteY344"/>
              </a:cxn>
              <a:cxn ang="0">
                <a:pos x="connsiteX345" y="connsiteY345"/>
              </a:cxn>
              <a:cxn ang="0">
                <a:pos x="connsiteX346" y="connsiteY346"/>
              </a:cxn>
              <a:cxn ang="0">
                <a:pos x="connsiteX347" y="connsiteY347"/>
              </a:cxn>
              <a:cxn ang="0">
                <a:pos x="connsiteX348" y="connsiteY348"/>
              </a:cxn>
              <a:cxn ang="0">
                <a:pos x="connsiteX349" y="connsiteY349"/>
              </a:cxn>
              <a:cxn ang="0">
                <a:pos x="connsiteX350" y="connsiteY350"/>
              </a:cxn>
              <a:cxn ang="0">
                <a:pos x="connsiteX351" y="connsiteY351"/>
              </a:cxn>
              <a:cxn ang="0">
                <a:pos x="connsiteX352" y="connsiteY352"/>
              </a:cxn>
              <a:cxn ang="0">
                <a:pos x="connsiteX353" y="connsiteY353"/>
              </a:cxn>
              <a:cxn ang="0">
                <a:pos x="connsiteX354" y="connsiteY354"/>
              </a:cxn>
              <a:cxn ang="0">
                <a:pos x="connsiteX355" y="connsiteY355"/>
              </a:cxn>
              <a:cxn ang="0">
                <a:pos x="connsiteX356" y="connsiteY356"/>
              </a:cxn>
              <a:cxn ang="0">
                <a:pos x="connsiteX357" y="connsiteY357"/>
              </a:cxn>
              <a:cxn ang="0">
                <a:pos x="connsiteX358" y="connsiteY358"/>
              </a:cxn>
              <a:cxn ang="0">
                <a:pos x="connsiteX359" y="connsiteY359"/>
              </a:cxn>
              <a:cxn ang="0">
                <a:pos x="connsiteX360" y="connsiteY360"/>
              </a:cxn>
              <a:cxn ang="0">
                <a:pos x="connsiteX361" y="connsiteY361"/>
              </a:cxn>
              <a:cxn ang="0">
                <a:pos x="connsiteX362" y="connsiteY362"/>
              </a:cxn>
              <a:cxn ang="0">
                <a:pos x="connsiteX363" y="connsiteY363"/>
              </a:cxn>
              <a:cxn ang="0">
                <a:pos x="connsiteX364" y="connsiteY364"/>
              </a:cxn>
              <a:cxn ang="0">
                <a:pos x="connsiteX365" y="connsiteY365"/>
              </a:cxn>
              <a:cxn ang="0">
                <a:pos x="connsiteX366" y="connsiteY366"/>
              </a:cxn>
              <a:cxn ang="0">
                <a:pos x="connsiteX367" y="connsiteY367"/>
              </a:cxn>
              <a:cxn ang="0">
                <a:pos x="connsiteX368" y="connsiteY368"/>
              </a:cxn>
              <a:cxn ang="0">
                <a:pos x="connsiteX369" y="connsiteY369"/>
              </a:cxn>
              <a:cxn ang="0">
                <a:pos x="connsiteX370" y="connsiteY370"/>
              </a:cxn>
              <a:cxn ang="0">
                <a:pos x="connsiteX371" y="connsiteY371"/>
              </a:cxn>
              <a:cxn ang="0">
                <a:pos x="connsiteX372" y="connsiteY372"/>
              </a:cxn>
              <a:cxn ang="0">
                <a:pos x="connsiteX373" y="connsiteY373"/>
              </a:cxn>
              <a:cxn ang="0">
                <a:pos x="connsiteX374" y="connsiteY374"/>
              </a:cxn>
              <a:cxn ang="0">
                <a:pos x="connsiteX375" y="connsiteY375"/>
              </a:cxn>
              <a:cxn ang="0">
                <a:pos x="connsiteX376" y="connsiteY376"/>
              </a:cxn>
              <a:cxn ang="0">
                <a:pos x="connsiteX377" y="connsiteY377"/>
              </a:cxn>
              <a:cxn ang="0">
                <a:pos x="connsiteX378" y="connsiteY378"/>
              </a:cxn>
              <a:cxn ang="0">
                <a:pos x="connsiteX379" y="connsiteY379"/>
              </a:cxn>
              <a:cxn ang="0">
                <a:pos x="connsiteX380" y="connsiteY380"/>
              </a:cxn>
              <a:cxn ang="0">
                <a:pos x="connsiteX381" y="connsiteY381"/>
              </a:cxn>
              <a:cxn ang="0">
                <a:pos x="connsiteX382" y="connsiteY382"/>
              </a:cxn>
              <a:cxn ang="0">
                <a:pos x="connsiteX383" y="connsiteY383"/>
              </a:cxn>
              <a:cxn ang="0">
                <a:pos x="connsiteX384" y="connsiteY384"/>
              </a:cxn>
              <a:cxn ang="0">
                <a:pos x="connsiteX385" y="connsiteY385"/>
              </a:cxn>
              <a:cxn ang="0">
                <a:pos x="connsiteX386" y="connsiteY386"/>
              </a:cxn>
              <a:cxn ang="0">
                <a:pos x="connsiteX387" y="connsiteY387"/>
              </a:cxn>
              <a:cxn ang="0">
                <a:pos x="connsiteX388" y="connsiteY388"/>
              </a:cxn>
              <a:cxn ang="0">
                <a:pos x="connsiteX389" y="connsiteY389"/>
              </a:cxn>
              <a:cxn ang="0">
                <a:pos x="connsiteX390" y="connsiteY390"/>
              </a:cxn>
              <a:cxn ang="0">
                <a:pos x="connsiteX391" y="connsiteY391"/>
              </a:cxn>
              <a:cxn ang="0">
                <a:pos x="connsiteX392" y="connsiteY392"/>
              </a:cxn>
              <a:cxn ang="0">
                <a:pos x="connsiteX393" y="connsiteY393"/>
              </a:cxn>
              <a:cxn ang="0">
                <a:pos x="connsiteX394" y="connsiteY394"/>
              </a:cxn>
              <a:cxn ang="0">
                <a:pos x="connsiteX395" y="connsiteY395"/>
              </a:cxn>
              <a:cxn ang="0">
                <a:pos x="connsiteX396" y="connsiteY396"/>
              </a:cxn>
              <a:cxn ang="0">
                <a:pos x="connsiteX397" y="connsiteY397"/>
              </a:cxn>
              <a:cxn ang="0">
                <a:pos x="connsiteX398" y="connsiteY398"/>
              </a:cxn>
              <a:cxn ang="0">
                <a:pos x="connsiteX399" y="connsiteY399"/>
              </a:cxn>
              <a:cxn ang="0">
                <a:pos x="connsiteX400" y="connsiteY400"/>
              </a:cxn>
              <a:cxn ang="0">
                <a:pos x="connsiteX401" y="connsiteY401"/>
              </a:cxn>
              <a:cxn ang="0">
                <a:pos x="connsiteX402" y="connsiteY402"/>
              </a:cxn>
              <a:cxn ang="0">
                <a:pos x="connsiteX403" y="connsiteY403"/>
              </a:cxn>
              <a:cxn ang="0">
                <a:pos x="connsiteX404" y="connsiteY404"/>
              </a:cxn>
              <a:cxn ang="0">
                <a:pos x="connsiteX405" y="connsiteY405"/>
              </a:cxn>
              <a:cxn ang="0">
                <a:pos x="connsiteX406" y="connsiteY406"/>
              </a:cxn>
              <a:cxn ang="0">
                <a:pos x="connsiteX407" y="connsiteY407"/>
              </a:cxn>
              <a:cxn ang="0">
                <a:pos x="connsiteX408" y="connsiteY408"/>
              </a:cxn>
              <a:cxn ang="0">
                <a:pos x="connsiteX409" y="connsiteY409"/>
              </a:cxn>
              <a:cxn ang="0">
                <a:pos x="connsiteX410" y="connsiteY410"/>
              </a:cxn>
              <a:cxn ang="0">
                <a:pos x="connsiteX411" y="connsiteY411"/>
              </a:cxn>
              <a:cxn ang="0">
                <a:pos x="connsiteX412" y="connsiteY412"/>
              </a:cxn>
              <a:cxn ang="0">
                <a:pos x="connsiteX413" y="connsiteY413"/>
              </a:cxn>
              <a:cxn ang="0">
                <a:pos x="connsiteX414" y="connsiteY414"/>
              </a:cxn>
              <a:cxn ang="0">
                <a:pos x="connsiteX415" y="connsiteY415"/>
              </a:cxn>
              <a:cxn ang="0">
                <a:pos x="connsiteX416" y="connsiteY416"/>
              </a:cxn>
              <a:cxn ang="0">
                <a:pos x="connsiteX417" y="connsiteY417"/>
              </a:cxn>
              <a:cxn ang="0">
                <a:pos x="connsiteX418" y="connsiteY418"/>
              </a:cxn>
              <a:cxn ang="0">
                <a:pos x="connsiteX419" y="connsiteY419"/>
              </a:cxn>
              <a:cxn ang="0">
                <a:pos x="connsiteX420" y="connsiteY420"/>
              </a:cxn>
              <a:cxn ang="0">
                <a:pos x="connsiteX421" y="connsiteY421"/>
              </a:cxn>
              <a:cxn ang="0">
                <a:pos x="connsiteX422" y="connsiteY422"/>
              </a:cxn>
              <a:cxn ang="0">
                <a:pos x="connsiteX423" y="connsiteY423"/>
              </a:cxn>
              <a:cxn ang="0">
                <a:pos x="connsiteX424" y="connsiteY424"/>
              </a:cxn>
              <a:cxn ang="0">
                <a:pos x="connsiteX425" y="connsiteY425"/>
              </a:cxn>
              <a:cxn ang="0">
                <a:pos x="connsiteX426" y="connsiteY426"/>
              </a:cxn>
              <a:cxn ang="0">
                <a:pos x="connsiteX427" y="connsiteY427"/>
              </a:cxn>
              <a:cxn ang="0">
                <a:pos x="connsiteX428" y="connsiteY428"/>
              </a:cxn>
              <a:cxn ang="0">
                <a:pos x="connsiteX429" y="connsiteY429"/>
              </a:cxn>
              <a:cxn ang="0">
                <a:pos x="connsiteX430" y="connsiteY430"/>
              </a:cxn>
              <a:cxn ang="0">
                <a:pos x="connsiteX431" y="connsiteY431"/>
              </a:cxn>
              <a:cxn ang="0">
                <a:pos x="connsiteX432" y="connsiteY432"/>
              </a:cxn>
              <a:cxn ang="0">
                <a:pos x="connsiteX433" y="connsiteY433"/>
              </a:cxn>
              <a:cxn ang="0">
                <a:pos x="connsiteX434" y="connsiteY434"/>
              </a:cxn>
              <a:cxn ang="0">
                <a:pos x="connsiteX435" y="connsiteY435"/>
              </a:cxn>
              <a:cxn ang="0">
                <a:pos x="connsiteX436" y="connsiteY436"/>
              </a:cxn>
              <a:cxn ang="0">
                <a:pos x="connsiteX437" y="connsiteY437"/>
              </a:cxn>
              <a:cxn ang="0">
                <a:pos x="connsiteX438" y="connsiteY438"/>
              </a:cxn>
              <a:cxn ang="0">
                <a:pos x="connsiteX439" y="connsiteY439"/>
              </a:cxn>
              <a:cxn ang="0">
                <a:pos x="connsiteX440" y="connsiteY440"/>
              </a:cxn>
              <a:cxn ang="0">
                <a:pos x="connsiteX441" y="connsiteY441"/>
              </a:cxn>
              <a:cxn ang="0">
                <a:pos x="connsiteX442" y="connsiteY442"/>
              </a:cxn>
              <a:cxn ang="0">
                <a:pos x="connsiteX443" y="connsiteY443"/>
              </a:cxn>
              <a:cxn ang="0">
                <a:pos x="connsiteX444" y="connsiteY444"/>
              </a:cxn>
              <a:cxn ang="0">
                <a:pos x="connsiteX445" y="connsiteY445"/>
              </a:cxn>
              <a:cxn ang="0">
                <a:pos x="connsiteX446" y="connsiteY446"/>
              </a:cxn>
              <a:cxn ang="0">
                <a:pos x="connsiteX447" y="connsiteY447"/>
              </a:cxn>
              <a:cxn ang="0">
                <a:pos x="connsiteX448" y="connsiteY448"/>
              </a:cxn>
              <a:cxn ang="0">
                <a:pos x="connsiteX449" y="connsiteY449"/>
              </a:cxn>
              <a:cxn ang="0">
                <a:pos x="connsiteX450" y="connsiteY450"/>
              </a:cxn>
              <a:cxn ang="0">
                <a:pos x="connsiteX451" y="connsiteY451"/>
              </a:cxn>
              <a:cxn ang="0">
                <a:pos x="connsiteX452" y="connsiteY452"/>
              </a:cxn>
              <a:cxn ang="0">
                <a:pos x="connsiteX453" y="connsiteY453"/>
              </a:cxn>
              <a:cxn ang="0">
                <a:pos x="connsiteX454" y="connsiteY454"/>
              </a:cxn>
              <a:cxn ang="0">
                <a:pos x="connsiteX455" y="connsiteY455"/>
              </a:cxn>
              <a:cxn ang="0">
                <a:pos x="connsiteX456" y="connsiteY456"/>
              </a:cxn>
              <a:cxn ang="0">
                <a:pos x="connsiteX457" y="connsiteY457"/>
              </a:cxn>
              <a:cxn ang="0">
                <a:pos x="connsiteX458" y="connsiteY458"/>
              </a:cxn>
              <a:cxn ang="0">
                <a:pos x="connsiteX459" y="connsiteY459"/>
              </a:cxn>
              <a:cxn ang="0">
                <a:pos x="connsiteX460" y="connsiteY460"/>
              </a:cxn>
              <a:cxn ang="0">
                <a:pos x="connsiteX461" y="connsiteY461"/>
              </a:cxn>
              <a:cxn ang="0">
                <a:pos x="connsiteX462" y="connsiteY462"/>
              </a:cxn>
              <a:cxn ang="0">
                <a:pos x="connsiteX463" y="connsiteY463"/>
              </a:cxn>
              <a:cxn ang="0">
                <a:pos x="connsiteX464" y="connsiteY464"/>
              </a:cxn>
              <a:cxn ang="0">
                <a:pos x="connsiteX465" y="connsiteY465"/>
              </a:cxn>
              <a:cxn ang="0">
                <a:pos x="connsiteX466" y="connsiteY466"/>
              </a:cxn>
              <a:cxn ang="0">
                <a:pos x="connsiteX467" y="connsiteY467"/>
              </a:cxn>
              <a:cxn ang="0">
                <a:pos x="connsiteX468" y="connsiteY468"/>
              </a:cxn>
              <a:cxn ang="0">
                <a:pos x="connsiteX469" y="connsiteY469"/>
              </a:cxn>
              <a:cxn ang="0">
                <a:pos x="connsiteX470" y="connsiteY470"/>
              </a:cxn>
              <a:cxn ang="0">
                <a:pos x="connsiteX471" y="connsiteY471"/>
              </a:cxn>
              <a:cxn ang="0">
                <a:pos x="connsiteX472" y="connsiteY472"/>
              </a:cxn>
              <a:cxn ang="0">
                <a:pos x="connsiteX473" y="connsiteY473"/>
              </a:cxn>
              <a:cxn ang="0">
                <a:pos x="connsiteX474" y="connsiteY474"/>
              </a:cxn>
              <a:cxn ang="0">
                <a:pos x="connsiteX475" y="connsiteY475"/>
              </a:cxn>
              <a:cxn ang="0">
                <a:pos x="connsiteX476" y="connsiteY476"/>
              </a:cxn>
              <a:cxn ang="0">
                <a:pos x="connsiteX477" y="connsiteY477"/>
              </a:cxn>
              <a:cxn ang="0">
                <a:pos x="connsiteX478" y="connsiteY478"/>
              </a:cxn>
              <a:cxn ang="0">
                <a:pos x="connsiteX479" y="connsiteY479"/>
              </a:cxn>
              <a:cxn ang="0">
                <a:pos x="connsiteX480" y="connsiteY480"/>
              </a:cxn>
              <a:cxn ang="0">
                <a:pos x="connsiteX481" y="connsiteY481"/>
              </a:cxn>
              <a:cxn ang="0">
                <a:pos x="connsiteX482" y="connsiteY482"/>
              </a:cxn>
              <a:cxn ang="0">
                <a:pos x="connsiteX483" y="connsiteY483"/>
              </a:cxn>
              <a:cxn ang="0">
                <a:pos x="connsiteX484" y="connsiteY484"/>
              </a:cxn>
              <a:cxn ang="0">
                <a:pos x="connsiteX485" y="connsiteY485"/>
              </a:cxn>
              <a:cxn ang="0">
                <a:pos x="connsiteX486" y="connsiteY486"/>
              </a:cxn>
              <a:cxn ang="0">
                <a:pos x="connsiteX487" y="connsiteY487"/>
              </a:cxn>
              <a:cxn ang="0">
                <a:pos x="connsiteX488" y="connsiteY488"/>
              </a:cxn>
              <a:cxn ang="0">
                <a:pos x="connsiteX489" y="connsiteY489"/>
              </a:cxn>
              <a:cxn ang="0">
                <a:pos x="connsiteX490" y="connsiteY490"/>
              </a:cxn>
              <a:cxn ang="0">
                <a:pos x="connsiteX491" y="connsiteY491"/>
              </a:cxn>
              <a:cxn ang="0">
                <a:pos x="connsiteX492" y="connsiteY492"/>
              </a:cxn>
              <a:cxn ang="0">
                <a:pos x="connsiteX493" y="connsiteY493"/>
              </a:cxn>
              <a:cxn ang="0">
                <a:pos x="connsiteX494" y="connsiteY494"/>
              </a:cxn>
              <a:cxn ang="0">
                <a:pos x="connsiteX495" y="connsiteY495"/>
              </a:cxn>
              <a:cxn ang="0">
                <a:pos x="connsiteX496" y="connsiteY496"/>
              </a:cxn>
              <a:cxn ang="0">
                <a:pos x="connsiteX497" y="connsiteY497"/>
              </a:cxn>
              <a:cxn ang="0">
                <a:pos x="connsiteX498" y="connsiteY498"/>
              </a:cxn>
              <a:cxn ang="0">
                <a:pos x="connsiteX499" y="connsiteY499"/>
              </a:cxn>
              <a:cxn ang="0">
                <a:pos x="connsiteX500" y="connsiteY500"/>
              </a:cxn>
              <a:cxn ang="0">
                <a:pos x="connsiteX501" y="connsiteY501"/>
              </a:cxn>
              <a:cxn ang="0">
                <a:pos x="connsiteX502" y="connsiteY502"/>
              </a:cxn>
              <a:cxn ang="0">
                <a:pos x="connsiteX503" y="connsiteY503"/>
              </a:cxn>
              <a:cxn ang="0">
                <a:pos x="connsiteX504" y="connsiteY504"/>
              </a:cxn>
              <a:cxn ang="0">
                <a:pos x="connsiteX505" y="connsiteY505"/>
              </a:cxn>
              <a:cxn ang="0">
                <a:pos x="connsiteX506" y="connsiteY506"/>
              </a:cxn>
              <a:cxn ang="0">
                <a:pos x="connsiteX507" y="connsiteY507"/>
              </a:cxn>
              <a:cxn ang="0">
                <a:pos x="connsiteX508" y="connsiteY508"/>
              </a:cxn>
              <a:cxn ang="0">
                <a:pos x="connsiteX509" y="connsiteY509"/>
              </a:cxn>
              <a:cxn ang="0">
                <a:pos x="connsiteX510" y="connsiteY510"/>
              </a:cxn>
              <a:cxn ang="0">
                <a:pos x="connsiteX511" y="connsiteY511"/>
              </a:cxn>
              <a:cxn ang="0">
                <a:pos x="connsiteX512" y="connsiteY512"/>
              </a:cxn>
              <a:cxn ang="0">
                <a:pos x="connsiteX513" y="connsiteY513"/>
              </a:cxn>
              <a:cxn ang="0">
                <a:pos x="connsiteX514" y="connsiteY514"/>
              </a:cxn>
              <a:cxn ang="0">
                <a:pos x="connsiteX515" y="connsiteY515"/>
              </a:cxn>
              <a:cxn ang="0">
                <a:pos x="connsiteX516" y="connsiteY516"/>
              </a:cxn>
              <a:cxn ang="0">
                <a:pos x="connsiteX517" y="connsiteY517"/>
              </a:cxn>
              <a:cxn ang="0">
                <a:pos x="connsiteX518" y="connsiteY518"/>
              </a:cxn>
              <a:cxn ang="0">
                <a:pos x="connsiteX519" y="connsiteY519"/>
              </a:cxn>
              <a:cxn ang="0">
                <a:pos x="connsiteX520" y="connsiteY520"/>
              </a:cxn>
              <a:cxn ang="0">
                <a:pos x="connsiteX521" y="connsiteY521"/>
              </a:cxn>
              <a:cxn ang="0">
                <a:pos x="connsiteX522" y="connsiteY522"/>
              </a:cxn>
              <a:cxn ang="0">
                <a:pos x="connsiteX523" y="connsiteY523"/>
              </a:cxn>
              <a:cxn ang="0">
                <a:pos x="connsiteX524" y="connsiteY524"/>
              </a:cxn>
              <a:cxn ang="0">
                <a:pos x="connsiteX525" y="connsiteY525"/>
              </a:cxn>
              <a:cxn ang="0">
                <a:pos x="connsiteX526" y="connsiteY526"/>
              </a:cxn>
              <a:cxn ang="0">
                <a:pos x="connsiteX527" y="connsiteY527"/>
              </a:cxn>
              <a:cxn ang="0">
                <a:pos x="connsiteX528" y="connsiteY528"/>
              </a:cxn>
              <a:cxn ang="0">
                <a:pos x="connsiteX529" y="connsiteY529"/>
              </a:cxn>
              <a:cxn ang="0">
                <a:pos x="connsiteX530" y="connsiteY530"/>
              </a:cxn>
              <a:cxn ang="0">
                <a:pos x="connsiteX531" y="connsiteY531"/>
              </a:cxn>
              <a:cxn ang="0">
                <a:pos x="connsiteX532" y="connsiteY532"/>
              </a:cxn>
              <a:cxn ang="0">
                <a:pos x="connsiteX533" y="connsiteY533"/>
              </a:cxn>
              <a:cxn ang="0">
                <a:pos x="connsiteX534" y="connsiteY534"/>
              </a:cxn>
              <a:cxn ang="0">
                <a:pos x="connsiteX535" y="connsiteY535"/>
              </a:cxn>
              <a:cxn ang="0">
                <a:pos x="connsiteX536" y="connsiteY536"/>
              </a:cxn>
              <a:cxn ang="0">
                <a:pos x="connsiteX537" y="connsiteY537"/>
              </a:cxn>
              <a:cxn ang="0">
                <a:pos x="connsiteX538" y="connsiteY538"/>
              </a:cxn>
              <a:cxn ang="0">
                <a:pos x="connsiteX539" y="connsiteY539"/>
              </a:cxn>
              <a:cxn ang="0">
                <a:pos x="connsiteX540" y="connsiteY540"/>
              </a:cxn>
              <a:cxn ang="0">
                <a:pos x="connsiteX541" y="connsiteY541"/>
              </a:cxn>
              <a:cxn ang="0">
                <a:pos x="connsiteX542" y="connsiteY542"/>
              </a:cxn>
              <a:cxn ang="0">
                <a:pos x="connsiteX543" y="connsiteY543"/>
              </a:cxn>
              <a:cxn ang="0">
                <a:pos x="connsiteX544" y="connsiteY544"/>
              </a:cxn>
              <a:cxn ang="0">
                <a:pos x="connsiteX545" y="connsiteY545"/>
              </a:cxn>
              <a:cxn ang="0">
                <a:pos x="connsiteX546" y="connsiteY546"/>
              </a:cxn>
              <a:cxn ang="0">
                <a:pos x="connsiteX547" y="connsiteY547"/>
              </a:cxn>
              <a:cxn ang="0">
                <a:pos x="connsiteX548" y="connsiteY548"/>
              </a:cxn>
              <a:cxn ang="0">
                <a:pos x="connsiteX549" y="connsiteY549"/>
              </a:cxn>
              <a:cxn ang="0">
                <a:pos x="connsiteX550" y="connsiteY550"/>
              </a:cxn>
              <a:cxn ang="0">
                <a:pos x="connsiteX551" y="connsiteY551"/>
              </a:cxn>
              <a:cxn ang="0">
                <a:pos x="connsiteX552" y="connsiteY552"/>
              </a:cxn>
              <a:cxn ang="0">
                <a:pos x="connsiteX553" y="connsiteY553"/>
              </a:cxn>
              <a:cxn ang="0">
                <a:pos x="connsiteX554" y="connsiteY554"/>
              </a:cxn>
              <a:cxn ang="0">
                <a:pos x="connsiteX555" y="connsiteY555"/>
              </a:cxn>
              <a:cxn ang="0">
                <a:pos x="connsiteX556" y="connsiteY556"/>
              </a:cxn>
              <a:cxn ang="0">
                <a:pos x="connsiteX557" y="connsiteY557"/>
              </a:cxn>
              <a:cxn ang="0">
                <a:pos x="connsiteX558" y="connsiteY558"/>
              </a:cxn>
              <a:cxn ang="0">
                <a:pos x="connsiteX559" y="connsiteY559"/>
              </a:cxn>
              <a:cxn ang="0">
                <a:pos x="connsiteX560" y="connsiteY560"/>
              </a:cxn>
              <a:cxn ang="0">
                <a:pos x="connsiteX561" y="connsiteY561"/>
              </a:cxn>
              <a:cxn ang="0">
                <a:pos x="connsiteX562" y="connsiteY562"/>
              </a:cxn>
              <a:cxn ang="0">
                <a:pos x="connsiteX563" y="connsiteY563"/>
              </a:cxn>
              <a:cxn ang="0">
                <a:pos x="connsiteX564" y="connsiteY564"/>
              </a:cxn>
              <a:cxn ang="0">
                <a:pos x="connsiteX565" y="connsiteY565"/>
              </a:cxn>
              <a:cxn ang="0">
                <a:pos x="connsiteX566" y="connsiteY566"/>
              </a:cxn>
              <a:cxn ang="0">
                <a:pos x="connsiteX567" y="connsiteY567"/>
              </a:cxn>
              <a:cxn ang="0">
                <a:pos x="connsiteX568" y="connsiteY568"/>
              </a:cxn>
              <a:cxn ang="0">
                <a:pos x="connsiteX569" y="connsiteY569"/>
              </a:cxn>
              <a:cxn ang="0">
                <a:pos x="connsiteX570" y="connsiteY570"/>
              </a:cxn>
              <a:cxn ang="0">
                <a:pos x="connsiteX571" y="connsiteY571"/>
              </a:cxn>
              <a:cxn ang="0">
                <a:pos x="connsiteX572" y="connsiteY572"/>
              </a:cxn>
              <a:cxn ang="0">
                <a:pos x="connsiteX573" y="connsiteY573"/>
              </a:cxn>
              <a:cxn ang="0">
                <a:pos x="connsiteX574" y="connsiteY574"/>
              </a:cxn>
              <a:cxn ang="0">
                <a:pos x="connsiteX575" y="connsiteY575"/>
              </a:cxn>
              <a:cxn ang="0">
                <a:pos x="connsiteX576" y="connsiteY576"/>
              </a:cxn>
              <a:cxn ang="0">
                <a:pos x="connsiteX577" y="connsiteY577"/>
              </a:cxn>
              <a:cxn ang="0">
                <a:pos x="connsiteX578" y="connsiteY578"/>
              </a:cxn>
              <a:cxn ang="0">
                <a:pos x="connsiteX579" y="connsiteY579"/>
              </a:cxn>
              <a:cxn ang="0">
                <a:pos x="connsiteX580" y="connsiteY580"/>
              </a:cxn>
              <a:cxn ang="0">
                <a:pos x="connsiteX581" y="connsiteY581"/>
              </a:cxn>
              <a:cxn ang="0">
                <a:pos x="connsiteX582" y="connsiteY582"/>
              </a:cxn>
              <a:cxn ang="0">
                <a:pos x="connsiteX583" y="connsiteY583"/>
              </a:cxn>
              <a:cxn ang="0">
                <a:pos x="connsiteX584" y="connsiteY584"/>
              </a:cxn>
              <a:cxn ang="0">
                <a:pos x="connsiteX585" y="connsiteY585"/>
              </a:cxn>
              <a:cxn ang="0">
                <a:pos x="connsiteX586" y="connsiteY586"/>
              </a:cxn>
              <a:cxn ang="0">
                <a:pos x="connsiteX587" y="connsiteY587"/>
              </a:cxn>
              <a:cxn ang="0">
                <a:pos x="connsiteX588" y="connsiteY588"/>
              </a:cxn>
              <a:cxn ang="0">
                <a:pos x="connsiteX589" y="connsiteY589"/>
              </a:cxn>
              <a:cxn ang="0">
                <a:pos x="connsiteX590" y="connsiteY590"/>
              </a:cxn>
              <a:cxn ang="0">
                <a:pos x="connsiteX591" y="connsiteY591"/>
              </a:cxn>
              <a:cxn ang="0">
                <a:pos x="connsiteX592" y="connsiteY592"/>
              </a:cxn>
              <a:cxn ang="0">
                <a:pos x="connsiteX593" y="connsiteY593"/>
              </a:cxn>
              <a:cxn ang="0">
                <a:pos x="connsiteX594" y="connsiteY594"/>
              </a:cxn>
              <a:cxn ang="0">
                <a:pos x="connsiteX595" y="connsiteY595"/>
              </a:cxn>
              <a:cxn ang="0">
                <a:pos x="connsiteX596" y="connsiteY596"/>
              </a:cxn>
              <a:cxn ang="0">
                <a:pos x="connsiteX597" y="connsiteY597"/>
              </a:cxn>
              <a:cxn ang="0">
                <a:pos x="connsiteX598" y="connsiteY598"/>
              </a:cxn>
              <a:cxn ang="0">
                <a:pos x="connsiteX599" y="connsiteY599"/>
              </a:cxn>
              <a:cxn ang="0">
                <a:pos x="connsiteX600" y="connsiteY600"/>
              </a:cxn>
              <a:cxn ang="0">
                <a:pos x="connsiteX601" y="connsiteY601"/>
              </a:cxn>
              <a:cxn ang="0">
                <a:pos x="connsiteX602" y="connsiteY602"/>
              </a:cxn>
              <a:cxn ang="0">
                <a:pos x="connsiteX603" y="connsiteY603"/>
              </a:cxn>
              <a:cxn ang="0">
                <a:pos x="connsiteX604" y="connsiteY604"/>
              </a:cxn>
              <a:cxn ang="0">
                <a:pos x="connsiteX605" y="connsiteY605"/>
              </a:cxn>
              <a:cxn ang="0">
                <a:pos x="connsiteX606" y="connsiteY606"/>
              </a:cxn>
              <a:cxn ang="0">
                <a:pos x="connsiteX607" y="connsiteY607"/>
              </a:cxn>
              <a:cxn ang="0">
                <a:pos x="connsiteX608" y="connsiteY608"/>
              </a:cxn>
              <a:cxn ang="0">
                <a:pos x="connsiteX609" y="connsiteY609"/>
              </a:cxn>
              <a:cxn ang="0">
                <a:pos x="connsiteX610" y="connsiteY610"/>
              </a:cxn>
              <a:cxn ang="0">
                <a:pos x="connsiteX611" y="connsiteY611"/>
              </a:cxn>
              <a:cxn ang="0">
                <a:pos x="connsiteX612" y="connsiteY612"/>
              </a:cxn>
              <a:cxn ang="0">
                <a:pos x="connsiteX613" y="connsiteY613"/>
              </a:cxn>
              <a:cxn ang="0">
                <a:pos x="connsiteX614" y="connsiteY614"/>
              </a:cxn>
              <a:cxn ang="0">
                <a:pos x="connsiteX615" y="connsiteY615"/>
              </a:cxn>
              <a:cxn ang="0">
                <a:pos x="connsiteX616" y="connsiteY616"/>
              </a:cxn>
              <a:cxn ang="0">
                <a:pos x="connsiteX617" y="connsiteY617"/>
              </a:cxn>
              <a:cxn ang="0">
                <a:pos x="connsiteX618" y="connsiteY618"/>
              </a:cxn>
              <a:cxn ang="0">
                <a:pos x="connsiteX619" y="connsiteY619"/>
              </a:cxn>
              <a:cxn ang="0">
                <a:pos x="connsiteX620" y="connsiteY620"/>
              </a:cxn>
              <a:cxn ang="0">
                <a:pos x="connsiteX621" y="connsiteY621"/>
              </a:cxn>
              <a:cxn ang="0">
                <a:pos x="connsiteX622" y="connsiteY622"/>
              </a:cxn>
              <a:cxn ang="0">
                <a:pos x="connsiteX623" y="connsiteY623"/>
              </a:cxn>
              <a:cxn ang="0">
                <a:pos x="connsiteX624" y="connsiteY624"/>
              </a:cxn>
              <a:cxn ang="0">
                <a:pos x="connsiteX625" y="connsiteY625"/>
              </a:cxn>
              <a:cxn ang="0">
                <a:pos x="connsiteX626" y="connsiteY626"/>
              </a:cxn>
              <a:cxn ang="0">
                <a:pos x="connsiteX627" y="connsiteY627"/>
              </a:cxn>
              <a:cxn ang="0">
                <a:pos x="connsiteX628" y="connsiteY628"/>
              </a:cxn>
              <a:cxn ang="0">
                <a:pos x="connsiteX629" y="connsiteY629"/>
              </a:cxn>
              <a:cxn ang="0">
                <a:pos x="connsiteX630" y="connsiteY630"/>
              </a:cxn>
              <a:cxn ang="0">
                <a:pos x="connsiteX631" y="connsiteY631"/>
              </a:cxn>
              <a:cxn ang="0">
                <a:pos x="connsiteX632" y="connsiteY632"/>
              </a:cxn>
              <a:cxn ang="0">
                <a:pos x="connsiteX633" y="connsiteY633"/>
              </a:cxn>
              <a:cxn ang="0">
                <a:pos x="connsiteX634" y="connsiteY634"/>
              </a:cxn>
              <a:cxn ang="0">
                <a:pos x="connsiteX635" y="connsiteY635"/>
              </a:cxn>
              <a:cxn ang="0">
                <a:pos x="connsiteX636" y="connsiteY636"/>
              </a:cxn>
              <a:cxn ang="0">
                <a:pos x="connsiteX637" y="connsiteY637"/>
              </a:cxn>
              <a:cxn ang="0">
                <a:pos x="connsiteX638" y="connsiteY638"/>
              </a:cxn>
              <a:cxn ang="0">
                <a:pos x="connsiteX639" y="connsiteY639"/>
              </a:cxn>
              <a:cxn ang="0">
                <a:pos x="connsiteX640" y="connsiteY640"/>
              </a:cxn>
              <a:cxn ang="0">
                <a:pos x="connsiteX641" y="connsiteY641"/>
              </a:cxn>
              <a:cxn ang="0">
                <a:pos x="connsiteX642" y="connsiteY642"/>
              </a:cxn>
              <a:cxn ang="0">
                <a:pos x="connsiteX643" y="connsiteY643"/>
              </a:cxn>
              <a:cxn ang="0">
                <a:pos x="connsiteX644" y="connsiteY644"/>
              </a:cxn>
              <a:cxn ang="0">
                <a:pos x="connsiteX645" y="connsiteY645"/>
              </a:cxn>
              <a:cxn ang="0">
                <a:pos x="connsiteX646" y="connsiteY646"/>
              </a:cxn>
              <a:cxn ang="0">
                <a:pos x="connsiteX647" y="connsiteY647"/>
              </a:cxn>
              <a:cxn ang="0">
                <a:pos x="connsiteX648" y="connsiteY648"/>
              </a:cxn>
              <a:cxn ang="0">
                <a:pos x="connsiteX649" y="connsiteY649"/>
              </a:cxn>
              <a:cxn ang="0">
                <a:pos x="connsiteX650" y="connsiteY650"/>
              </a:cxn>
              <a:cxn ang="0">
                <a:pos x="connsiteX651" y="connsiteY651"/>
              </a:cxn>
              <a:cxn ang="0">
                <a:pos x="connsiteX652" y="connsiteY652"/>
              </a:cxn>
              <a:cxn ang="0">
                <a:pos x="connsiteX653" y="connsiteY653"/>
              </a:cxn>
              <a:cxn ang="0">
                <a:pos x="connsiteX654" y="connsiteY654"/>
              </a:cxn>
              <a:cxn ang="0">
                <a:pos x="connsiteX655" y="connsiteY655"/>
              </a:cxn>
              <a:cxn ang="0">
                <a:pos x="connsiteX656" y="connsiteY656"/>
              </a:cxn>
              <a:cxn ang="0">
                <a:pos x="connsiteX657" y="connsiteY657"/>
              </a:cxn>
              <a:cxn ang="0">
                <a:pos x="connsiteX658" y="connsiteY658"/>
              </a:cxn>
              <a:cxn ang="0">
                <a:pos x="connsiteX659" y="connsiteY659"/>
              </a:cxn>
              <a:cxn ang="0">
                <a:pos x="connsiteX660" y="connsiteY660"/>
              </a:cxn>
              <a:cxn ang="0">
                <a:pos x="connsiteX661" y="connsiteY661"/>
              </a:cxn>
              <a:cxn ang="0">
                <a:pos x="connsiteX662" y="connsiteY662"/>
              </a:cxn>
              <a:cxn ang="0">
                <a:pos x="connsiteX663" y="connsiteY663"/>
              </a:cxn>
              <a:cxn ang="0">
                <a:pos x="connsiteX664" y="connsiteY664"/>
              </a:cxn>
              <a:cxn ang="0">
                <a:pos x="connsiteX665" y="connsiteY665"/>
              </a:cxn>
              <a:cxn ang="0">
                <a:pos x="connsiteX666" y="connsiteY666"/>
              </a:cxn>
              <a:cxn ang="0">
                <a:pos x="connsiteX667" y="connsiteY667"/>
              </a:cxn>
              <a:cxn ang="0">
                <a:pos x="connsiteX668" y="connsiteY668"/>
              </a:cxn>
              <a:cxn ang="0">
                <a:pos x="connsiteX669" y="connsiteY669"/>
              </a:cxn>
              <a:cxn ang="0">
                <a:pos x="connsiteX670" y="connsiteY670"/>
              </a:cxn>
              <a:cxn ang="0">
                <a:pos x="connsiteX671" y="connsiteY671"/>
              </a:cxn>
              <a:cxn ang="0">
                <a:pos x="connsiteX672" y="connsiteY672"/>
              </a:cxn>
              <a:cxn ang="0">
                <a:pos x="connsiteX673" y="connsiteY673"/>
              </a:cxn>
              <a:cxn ang="0">
                <a:pos x="connsiteX674" y="connsiteY674"/>
              </a:cxn>
              <a:cxn ang="0">
                <a:pos x="connsiteX675" y="connsiteY675"/>
              </a:cxn>
              <a:cxn ang="0">
                <a:pos x="connsiteX676" y="connsiteY676"/>
              </a:cxn>
              <a:cxn ang="0">
                <a:pos x="connsiteX677" y="connsiteY677"/>
              </a:cxn>
              <a:cxn ang="0">
                <a:pos x="connsiteX678" y="connsiteY678"/>
              </a:cxn>
              <a:cxn ang="0">
                <a:pos x="connsiteX679" y="connsiteY679"/>
              </a:cxn>
              <a:cxn ang="0">
                <a:pos x="connsiteX680" y="connsiteY680"/>
              </a:cxn>
              <a:cxn ang="0">
                <a:pos x="connsiteX681" y="connsiteY681"/>
              </a:cxn>
              <a:cxn ang="0">
                <a:pos x="connsiteX682" y="connsiteY682"/>
              </a:cxn>
              <a:cxn ang="0">
                <a:pos x="connsiteX683" y="connsiteY683"/>
              </a:cxn>
              <a:cxn ang="0">
                <a:pos x="connsiteX684" y="connsiteY684"/>
              </a:cxn>
              <a:cxn ang="0">
                <a:pos x="connsiteX685" y="connsiteY685"/>
              </a:cxn>
              <a:cxn ang="0">
                <a:pos x="connsiteX686" y="connsiteY686"/>
              </a:cxn>
              <a:cxn ang="0">
                <a:pos x="connsiteX687" y="connsiteY687"/>
              </a:cxn>
              <a:cxn ang="0">
                <a:pos x="connsiteX688" y="connsiteY688"/>
              </a:cxn>
              <a:cxn ang="0">
                <a:pos x="connsiteX689" y="connsiteY689"/>
              </a:cxn>
              <a:cxn ang="0">
                <a:pos x="connsiteX690" y="connsiteY690"/>
              </a:cxn>
              <a:cxn ang="0">
                <a:pos x="connsiteX691" y="connsiteY691"/>
              </a:cxn>
              <a:cxn ang="0">
                <a:pos x="connsiteX692" y="connsiteY692"/>
              </a:cxn>
              <a:cxn ang="0">
                <a:pos x="connsiteX693" y="connsiteY693"/>
              </a:cxn>
              <a:cxn ang="0">
                <a:pos x="connsiteX694" y="connsiteY694"/>
              </a:cxn>
              <a:cxn ang="0">
                <a:pos x="connsiteX695" y="connsiteY695"/>
              </a:cxn>
              <a:cxn ang="0">
                <a:pos x="connsiteX696" y="connsiteY696"/>
              </a:cxn>
              <a:cxn ang="0">
                <a:pos x="connsiteX697" y="connsiteY697"/>
              </a:cxn>
              <a:cxn ang="0">
                <a:pos x="connsiteX698" y="connsiteY698"/>
              </a:cxn>
              <a:cxn ang="0">
                <a:pos x="connsiteX699" y="connsiteY699"/>
              </a:cxn>
              <a:cxn ang="0">
                <a:pos x="connsiteX700" y="connsiteY700"/>
              </a:cxn>
              <a:cxn ang="0">
                <a:pos x="connsiteX701" y="connsiteY701"/>
              </a:cxn>
              <a:cxn ang="0">
                <a:pos x="connsiteX702" y="connsiteY702"/>
              </a:cxn>
              <a:cxn ang="0">
                <a:pos x="connsiteX703" y="connsiteY703"/>
              </a:cxn>
              <a:cxn ang="0">
                <a:pos x="connsiteX704" y="connsiteY704"/>
              </a:cxn>
              <a:cxn ang="0">
                <a:pos x="connsiteX705" y="connsiteY705"/>
              </a:cxn>
              <a:cxn ang="0">
                <a:pos x="connsiteX706" y="connsiteY706"/>
              </a:cxn>
              <a:cxn ang="0">
                <a:pos x="connsiteX707" y="connsiteY707"/>
              </a:cxn>
              <a:cxn ang="0">
                <a:pos x="connsiteX708" y="connsiteY708"/>
              </a:cxn>
              <a:cxn ang="0">
                <a:pos x="connsiteX709" y="connsiteY709"/>
              </a:cxn>
              <a:cxn ang="0">
                <a:pos x="connsiteX710" y="connsiteY710"/>
              </a:cxn>
              <a:cxn ang="0">
                <a:pos x="connsiteX711" y="connsiteY711"/>
              </a:cxn>
              <a:cxn ang="0">
                <a:pos x="connsiteX712" y="connsiteY712"/>
              </a:cxn>
              <a:cxn ang="0">
                <a:pos x="connsiteX713" y="connsiteY713"/>
              </a:cxn>
              <a:cxn ang="0">
                <a:pos x="connsiteX714" y="connsiteY714"/>
              </a:cxn>
              <a:cxn ang="0">
                <a:pos x="connsiteX715" y="connsiteY715"/>
              </a:cxn>
              <a:cxn ang="0">
                <a:pos x="connsiteX716" y="connsiteY716"/>
              </a:cxn>
              <a:cxn ang="0">
                <a:pos x="connsiteX717" y="connsiteY717"/>
              </a:cxn>
              <a:cxn ang="0">
                <a:pos x="connsiteX718" y="connsiteY718"/>
              </a:cxn>
              <a:cxn ang="0">
                <a:pos x="connsiteX719" y="connsiteY719"/>
              </a:cxn>
              <a:cxn ang="0">
                <a:pos x="connsiteX720" y="connsiteY720"/>
              </a:cxn>
              <a:cxn ang="0">
                <a:pos x="connsiteX721" y="connsiteY721"/>
              </a:cxn>
              <a:cxn ang="0">
                <a:pos x="connsiteX722" y="connsiteY722"/>
              </a:cxn>
              <a:cxn ang="0">
                <a:pos x="connsiteX723" y="connsiteY723"/>
              </a:cxn>
              <a:cxn ang="0">
                <a:pos x="connsiteX724" y="connsiteY724"/>
              </a:cxn>
              <a:cxn ang="0">
                <a:pos x="connsiteX725" y="connsiteY725"/>
              </a:cxn>
              <a:cxn ang="0">
                <a:pos x="connsiteX726" y="connsiteY726"/>
              </a:cxn>
              <a:cxn ang="0">
                <a:pos x="connsiteX727" y="connsiteY727"/>
              </a:cxn>
              <a:cxn ang="0">
                <a:pos x="connsiteX728" y="connsiteY728"/>
              </a:cxn>
              <a:cxn ang="0">
                <a:pos x="connsiteX729" y="connsiteY729"/>
              </a:cxn>
              <a:cxn ang="0">
                <a:pos x="connsiteX730" y="connsiteY730"/>
              </a:cxn>
              <a:cxn ang="0">
                <a:pos x="connsiteX731" y="connsiteY731"/>
              </a:cxn>
              <a:cxn ang="0">
                <a:pos x="connsiteX732" y="connsiteY732"/>
              </a:cxn>
              <a:cxn ang="0">
                <a:pos x="connsiteX733" y="connsiteY733"/>
              </a:cxn>
              <a:cxn ang="0">
                <a:pos x="connsiteX734" y="connsiteY734"/>
              </a:cxn>
              <a:cxn ang="0">
                <a:pos x="connsiteX735" y="connsiteY735"/>
              </a:cxn>
              <a:cxn ang="0">
                <a:pos x="connsiteX736" y="connsiteY736"/>
              </a:cxn>
              <a:cxn ang="0">
                <a:pos x="connsiteX737" y="connsiteY737"/>
              </a:cxn>
              <a:cxn ang="0">
                <a:pos x="connsiteX738" y="connsiteY738"/>
              </a:cxn>
              <a:cxn ang="0">
                <a:pos x="connsiteX739" y="connsiteY739"/>
              </a:cxn>
              <a:cxn ang="0">
                <a:pos x="connsiteX740" y="connsiteY740"/>
              </a:cxn>
              <a:cxn ang="0">
                <a:pos x="connsiteX741" y="connsiteY741"/>
              </a:cxn>
              <a:cxn ang="0">
                <a:pos x="connsiteX742" y="connsiteY742"/>
              </a:cxn>
              <a:cxn ang="0">
                <a:pos x="connsiteX743" y="connsiteY743"/>
              </a:cxn>
              <a:cxn ang="0">
                <a:pos x="connsiteX744" y="connsiteY744"/>
              </a:cxn>
              <a:cxn ang="0">
                <a:pos x="connsiteX745" y="connsiteY745"/>
              </a:cxn>
              <a:cxn ang="0">
                <a:pos x="connsiteX746" y="connsiteY746"/>
              </a:cxn>
              <a:cxn ang="0">
                <a:pos x="connsiteX747" y="connsiteY747"/>
              </a:cxn>
            </a:cxnLst>
            <a:rect l="l" t="t" r="r" b="b"/>
            <a:pathLst>
              <a:path w="9497977" h="6857968">
                <a:moveTo>
                  <a:pt x="6330995" y="6474347"/>
                </a:moveTo>
                <a:lnTo>
                  <a:pt x="6330995" y="6545648"/>
                </a:lnTo>
                <a:lnTo>
                  <a:pt x="6402296" y="6545648"/>
                </a:lnTo>
                <a:lnTo>
                  <a:pt x="6402296" y="6474347"/>
                </a:lnTo>
                <a:close/>
                <a:moveTo>
                  <a:pt x="6188393" y="6474347"/>
                </a:moveTo>
                <a:lnTo>
                  <a:pt x="6188393" y="6545648"/>
                </a:lnTo>
                <a:lnTo>
                  <a:pt x="6259694" y="6545648"/>
                </a:lnTo>
                <a:lnTo>
                  <a:pt x="6259694" y="6474347"/>
                </a:lnTo>
                <a:close/>
                <a:moveTo>
                  <a:pt x="6045721" y="6474347"/>
                </a:moveTo>
                <a:lnTo>
                  <a:pt x="6045721" y="6545648"/>
                </a:lnTo>
                <a:lnTo>
                  <a:pt x="6117021" y="6545648"/>
                </a:lnTo>
                <a:lnTo>
                  <a:pt x="6117021" y="6474347"/>
                </a:lnTo>
                <a:close/>
                <a:moveTo>
                  <a:pt x="5903048" y="6474347"/>
                </a:moveTo>
                <a:lnTo>
                  <a:pt x="5903048" y="6545648"/>
                </a:lnTo>
                <a:lnTo>
                  <a:pt x="5974349" y="6545648"/>
                </a:lnTo>
                <a:lnTo>
                  <a:pt x="5974349" y="6474347"/>
                </a:lnTo>
                <a:close/>
                <a:moveTo>
                  <a:pt x="5760447" y="6474347"/>
                </a:moveTo>
                <a:lnTo>
                  <a:pt x="5760447" y="6545648"/>
                </a:lnTo>
                <a:lnTo>
                  <a:pt x="5831748" y="6545648"/>
                </a:lnTo>
                <a:lnTo>
                  <a:pt x="5831748" y="6474347"/>
                </a:lnTo>
                <a:close/>
                <a:moveTo>
                  <a:pt x="5617774" y="6474347"/>
                </a:moveTo>
                <a:lnTo>
                  <a:pt x="5617774" y="6545648"/>
                </a:lnTo>
                <a:lnTo>
                  <a:pt x="5689075" y="6545648"/>
                </a:lnTo>
                <a:lnTo>
                  <a:pt x="5689075" y="6474347"/>
                </a:lnTo>
                <a:close/>
                <a:moveTo>
                  <a:pt x="5475173" y="6474347"/>
                </a:moveTo>
                <a:lnTo>
                  <a:pt x="5475173" y="6545648"/>
                </a:lnTo>
                <a:lnTo>
                  <a:pt x="5546474" y="6545648"/>
                </a:lnTo>
                <a:lnTo>
                  <a:pt x="5546474" y="6474347"/>
                </a:lnTo>
                <a:close/>
                <a:moveTo>
                  <a:pt x="5332500" y="6474347"/>
                </a:moveTo>
                <a:lnTo>
                  <a:pt x="5332500" y="6545648"/>
                </a:lnTo>
                <a:lnTo>
                  <a:pt x="5403801" y="6545648"/>
                </a:lnTo>
                <a:lnTo>
                  <a:pt x="5403801" y="6474347"/>
                </a:lnTo>
                <a:close/>
                <a:moveTo>
                  <a:pt x="5189828" y="6474347"/>
                </a:moveTo>
                <a:lnTo>
                  <a:pt x="5189828" y="6545648"/>
                </a:lnTo>
                <a:lnTo>
                  <a:pt x="5261129" y="6545648"/>
                </a:lnTo>
                <a:lnTo>
                  <a:pt x="5261129" y="6474347"/>
                </a:lnTo>
                <a:close/>
                <a:moveTo>
                  <a:pt x="5047226" y="6474347"/>
                </a:moveTo>
                <a:lnTo>
                  <a:pt x="5047226" y="6545648"/>
                </a:lnTo>
                <a:lnTo>
                  <a:pt x="5118527" y="6545648"/>
                </a:lnTo>
                <a:lnTo>
                  <a:pt x="5118527" y="6474347"/>
                </a:lnTo>
                <a:close/>
                <a:moveTo>
                  <a:pt x="4904553" y="6474347"/>
                </a:moveTo>
                <a:lnTo>
                  <a:pt x="4904553" y="6545648"/>
                </a:lnTo>
                <a:lnTo>
                  <a:pt x="4975854" y="6545648"/>
                </a:lnTo>
                <a:lnTo>
                  <a:pt x="4975854" y="6474347"/>
                </a:lnTo>
                <a:close/>
                <a:moveTo>
                  <a:pt x="4761952" y="6474347"/>
                </a:moveTo>
                <a:lnTo>
                  <a:pt x="4761952" y="6545648"/>
                </a:lnTo>
                <a:lnTo>
                  <a:pt x="4833253" y="6545648"/>
                </a:lnTo>
                <a:lnTo>
                  <a:pt x="4833253" y="6474347"/>
                </a:lnTo>
                <a:close/>
                <a:moveTo>
                  <a:pt x="4619279" y="6474347"/>
                </a:moveTo>
                <a:lnTo>
                  <a:pt x="4619279" y="6545648"/>
                </a:lnTo>
                <a:lnTo>
                  <a:pt x="4690580" y="6545648"/>
                </a:lnTo>
                <a:lnTo>
                  <a:pt x="4690580" y="6474347"/>
                </a:lnTo>
                <a:close/>
                <a:moveTo>
                  <a:pt x="4476678" y="6474347"/>
                </a:moveTo>
                <a:lnTo>
                  <a:pt x="4476678" y="6545648"/>
                </a:lnTo>
                <a:lnTo>
                  <a:pt x="4547979" y="6545648"/>
                </a:lnTo>
                <a:lnTo>
                  <a:pt x="4547979" y="6474347"/>
                </a:lnTo>
                <a:close/>
                <a:moveTo>
                  <a:pt x="4334005" y="6474347"/>
                </a:moveTo>
                <a:lnTo>
                  <a:pt x="4334005" y="6545648"/>
                </a:lnTo>
                <a:lnTo>
                  <a:pt x="4405306" y="6545648"/>
                </a:lnTo>
                <a:lnTo>
                  <a:pt x="4405306" y="6474347"/>
                </a:lnTo>
                <a:close/>
                <a:moveTo>
                  <a:pt x="4191404" y="6474347"/>
                </a:moveTo>
                <a:lnTo>
                  <a:pt x="4191404" y="6545648"/>
                </a:lnTo>
                <a:lnTo>
                  <a:pt x="4262705" y="6545648"/>
                </a:lnTo>
                <a:lnTo>
                  <a:pt x="4262705" y="6474347"/>
                </a:lnTo>
                <a:close/>
                <a:moveTo>
                  <a:pt x="4048731" y="6474347"/>
                </a:moveTo>
                <a:lnTo>
                  <a:pt x="4048731" y="6545648"/>
                </a:lnTo>
                <a:lnTo>
                  <a:pt x="4120032" y="6545648"/>
                </a:lnTo>
                <a:lnTo>
                  <a:pt x="4120032" y="6474347"/>
                </a:lnTo>
                <a:close/>
                <a:moveTo>
                  <a:pt x="3906059" y="6474347"/>
                </a:moveTo>
                <a:lnTo>
                  <a:pt x="3906059" y="6545648"/>
                </a:lnTo>
                <a:lnTo>
                  <a:pt x="3977360" y="6545648"/>
                </a:lnTo>
                <a:lnTo>
                  <a:pt x="3977360" y="6474347"/>
                </a:lnTo>
                <a:close/>
                <a:moveTo>
                  <a:pt x="3763457" y="6474347"/>
                </a:moveTo>
                <a:lnTo>
                  <a:pt x="3763457" y="6545648"/>
                </a:lnTo>
                <a:lnTo>
                  <a:pt x="3834758" y="6545648"/>
                </a:lnTo>
                <a:lnTo>
                  <a:pt x="3834758" y="6474347"/>
                </a:lnTo>
                <a:close/>
                <a:moveTo>
                  <a:pt x="3620784" y="6474347"/>
                </a:moveTo>
                <a:lnTo>
                  <a:pt x="3620784" y="6545648"/>
                </a:lnTo>
                <a:lnTo>
                  <a:pt x="3692085" y="6545648"/>
                </a:lnTo>
                <a:lnTo>
                  <a:pt x="3692085" y="6474347"/>
                </a:lnTo>
                <a:close/>
                <a:moveTo>
                  <a:pt x="3478184" y="6474347"/>
                </a:moveTo>
                <a:lnTo>
                  <a:pt x="3478184" y="6545648"/>
                </a:lnTo>
                <a:lnTo>
                  <a:pt x="3549484" y="6545648"/>
                </a:lnTo>
                <a:lnTo>
                  <a:pt x="3549484" y="6474347"/>
                </a:lnTo>
                <a:close/>
                <a:moveTo>
                  <a:pt x="3335511" y="6474347"/>
                </a:moveTo>
                <a:lnTo>
                  <a:pt x="3335511" y="6545648"/>
                </a:lnTo>
                <a:lnTo>
                  <a:pt x="3406811" y="6545648"/>
                </a:lnTo>
                <a:lnTo>
                  <a:pt x="3406811" y="6474347"/>
                </a:lnTo>
                <a:close/>
                <a:moveTo>
                  <a:pt x="3192839" y="6474347"/>
                </a:moveTo>
                <a:lnTo>
                  <a:pt x="3192839" y="6545648"/>
                </a:lnTo>
                <a:lnTo>
                  <a:pt x="3264139" y="6545648"/>
                </a:lnTo>
                <a:lnTo>
                  <a:pt x="3264139" y="6474347"/>
                </a:lnTo>
                <a:close/>
                <a:moveTo>
                  <a:pt x="3050237" y="6474347"/>
                </a:moveTo>
                <a:lnTo>
                  <a:pt x="3050237" y="6545648"/>
                </a:lnTo>
                <a:lnTo>
                  <a:pt x="3121537" y="6545648"/>
                </a:lnTo>
                <a:lnTo>
                  <a:pt x="3121537" y="6474347"/>
                </a:lnTo>
                <a:close/>
                <a:moveTo>
                  <a:pt x="2907564" y="6474347"/>
                </a:moveTo>
                <a:lnTo>
                  <a:pt x="2907564" y="6545648"/>
                </a:lnTo>
                <a:lnTo>
                  <a:pt x="2978865" y="6545648"/>
                </a:lnTo>
                <a:lnTo>
                  <a:pt x="2978865" y="6474347"/>
                </a:lnTo>
                <a:close/>
                <a:moveTo>
                  <a:pt x="2764962" y="6474347"/>
                </a:moveTo>
                <a:lnTo>
                  <a:pt x="2764962" y="6545648"/>
                </a:lnTo>
                <a:lnTo>
                  <a:pt x="2836263" y="6545648"/>
                </a:lnTo>
                <a:lnTo>
                  <a:pt x="2836263" y="6474347"/>
                </a:lnTo>
                <a:close/>
                <a:moveTo>
                  <a:pt x="2622291" y="6474347"/>
                </a:moveTo>
                <a:lnTo>
                  <a:pt x="2622291" y="6545648"/>
                </a:lnTo>
                <a:lnTo>
                  <a:pt x="2693591" y="6545648"/>
                </a:lnTo>
                <a:lnTo>
                  <a:pt x="2693591" y="6474347"/>
                </a:lnTo>
                <a:close/>
                <a:moveTo>
                  <a:pt x="2479688" y="6474347"/>
                </a:moveTo>
                <a:lnTo>
                  <a:pt x="2479688" y="6545648"/>
                </a:lnTo>
                <a:lnTo>
                  <a:pt x="2550990" y="6545648"/>
                </a:lnTo>
                <a:lnTo>
                  <a:pt x="2550990" y="6474347"/>
                </a:lnTo>
                <a:close/>
                <a:moveTo>
                  <a:pt x="2337016" y="6474347"/>
                </a:moveTo>
                <a:lnTo>
                  <a:pt x="2337016" y="6545648"/>
                </a:lnTo>
                <a:lnTo>
                  <a:pt x="2408317" y="6545648"/>
                </a:lnTo>
                <a:lnTo>
                  <a:pt x="2408317" y="6474347"/>
                </a:lnTo>
                <a:close/>
                <a:moveTo>
                  <a:pt x="2195429" y="6474347"/>
                </a:moveTo>
                <a:lnTo>
                  <a:pt x="2195429" y="6545648"/>
                </a:lnTo>
                <a:lnTo>
                  <a:pt x="2266731" y="6545648"/>
                </a:lnTo>
                <a:lnTo>
                  <a:pt x="2266731" y="6474347"/>
                </a:lnTo>
                <a:close/>
                <a:moveTo>
                  <a:pt x="2052828" y="6474347"/>
                </a:moveTo>
                <a:lnTo>
                  <a:pt x="2052828" y="6545648"/>
                </a:lnTo>
                <a:lnTo>
                  <a:pt x="2124128" y="6545648"/>
                </a:lnTo>
                <a:lnTo>
                  <a:pt x="2124128" y="6474347"/>
                </a:lnTo>
                <a:close/>
                <a:moveTo>
                  <a:pt x="1910155" y="6474347"/>
                </a:moveTo>
                <a:lnTo>
                  <a:pt x="1910155" y="6545648"/>
                </a:lnTo>
                <a:lnTo>
                  <a:pt x="1981455" y="6545648"/>
                </a:lnTo>
                <a:lnTo>
                  <a:pt x="1981455" y="6474347"/>
                </a:lnTo>
                <a:close/>
                <a:moveTo>
                  <a:pt x="1767483" y="6474347"/>
                </a:moveTo>
                <a:lnTo>
                  <a:pt x="1767483" y="6545648"/>
                </a:lnTo>
                <a:lnTo>
                  <a:pt x="1838783" y="6545648"/>
                </a:lnTo>
                <a:lnTo>
                  <a:pt x="1838783" y="6474347"/>
                </a:lnTo>
                <a:close/>
                <a:moveTo>
                  <a:pt x="1624882" y="6474347"/>
                </a:moveTo>
                <a:lnTo>
                  <a:pt x="1624882" y="6545648"/>
                </a:lnTo>
                <a:lnTo>
                  <a:pt x="1696183" y="6545648"/>
                </a:lnTo>
                <a:lnTo>
                  <a:pt x="1696183" y="6474347"/>
                </a:lnTo>
                <a:close/>
                <a:moveTo>
                  <a:pt x="1482215" y="6474347"/>
                </a:moveTo>
                <a:lnTo>
                  <a:pt x="1482215" y="6545648"/>
                </a:lnTo>
                <a:lnTo>
                  <a:pt x="1553511" y="6545648"/>
                </a:lnTo>
                <a:lnTo>
                  <a:pt x="1553511" y="6474347"/>
                </a:lnTo>
                <a:close/>
                <a:moveTo>
                  <a:pt x="1339617" y="6474347"/>
                </a:moveTo>
                <a:lnTo>
                  <a:pt x="1339617" y="6545648"/>
                </a:lnTo>
                <a:lnTo>
                  <a:pt x="1410920" y="6545648"/>
                </a:lnTo>
                <a:lnTo>
                  <a:pt x="1410920" y="6474347"/>
                </a:lnTo>
                <a:close/>
                <a:moveTo>
                  <a:pt x="1196941" y="6474347"/>
                </a:moveTo>
                <a:lnTo>
                  <a:pt x="1196941" y="6545648"/>
                </a:lnTo>
                <a:lnTo>
                  <a:pt x="1268245" y="6545648"/>
                </a:lnTo>
                <a:lnTo>
                  <a:pt x="1268245" y="6474347"/>
                </a:lnTo>
                <a:close/>
                <a:moveTo>
                  <a:pt x="1054277" y="6474347"/>
                </a:moveTo>
                <a:lnTo>
                  <a:pt x="1054277" y="6545648"/>
                </a:lnTo>
                <a:lnTo>
                  <a:pt x="1125575" y="6545648"/>
                </a:lnTo>
                <a:lnTo>
                  <a:pt x="1125575" y="6474347"/>
                </a:lnTo>
                <a:close/>
                <a:moveTo>
                  <a:pt x="911663" y="6474347"/>
                </a:moveTo>
                <a:lnTo>
                  <a:pt x="911663" y="6545648"/>
                </a:lnTo>
                <a:lnTo>
                  <a:pt x="982964" y="6545648"/>
                </a:lnTo>
                <a:lnTo>
                  <a:pt x="982964" y="6474347"/>
                </a:lnTo>
                <a:close/>
                <a:moveTo>
                  <a:pt x="769001" y="6474347"/>
                </a:moveTo>
                <a:lnTo>
                  <a:pt x="769001" y="6545648"/>
                </a:lnTo>
                <a:lnTo>
                  <a:pt x="840299" y="6545648"/>
                </a:lnTo>
                <a:lnTo>
                  <a:pt x="840299" y="6474347"/>
                </a:lnTo>
                <a:close/>
                <a:moveTo>
                  <a:pt x="626392" y="6474347"/>
                </a:moveTo>
                <a:lnTo>
                  <a:pt x="626392" y="6545648"/>
                </a:lnTo>
                <a:lnTo>
                  <a:pt x="697691" y="6545648"/>
                </a:lnTo>
                <a:lnTo>
                  <a:pt x="697691" y="6474347"/>
                </a:lnTo>
                <a:close/>
                <a:moveTo>
                  <a:pt x="483718" y="6474347"/>
                </a:moveTo>
                <a:lnTo>
                  <a:pt x="483718" y="6545648"/>
                </a:lnTo>
                <a:lnTo>
                  <a:pt x="555020" y="6545648"/>
                </a:lnTo>
                <a:lnTo>
                  <a:pt x="555020" y="6474347"/>
                </a:lnTo>
                <a:close/>
                <a:moveTo>
                  <a:pt x="7329490" y="6325709"/>
                </a:moveTo>
                <a:lnTo>
                  <a:pt x="7329490" y="6397010"/>
                </a:lnTo>
                <a:lnTo>
                  <a:pt x="7400791" y="6397010"/>
                </a:lnTo>
                <a:lnTo>
                  <a:pt x="7400791" y="6325709"/>
                </a:lnTo>
                <a:close/>
                <a:moveTo>
                  <a:pt x="7186888" y="6325709"/>
                </a:moveTo>
                <a:lnTo>
                  <a:pt x="7186888" y="6397010"/>
                </a:lnTo>
                <a:lnTo>
                  <a:pt x="7258188" y="6397010"/>
                </a:lnTo>
                <a:lnTo>
                  <a:pt x="7258188" y="6325709"/>
                </a:lnTo>
                <a:close/>
                <a:moveTo>
                  <a:pt x="7044216" y="6325709"/>
                </a:moveTo>
                <a:lnTo>
                  <a:pt x="7044216" y="6397010"/>
                </a:lnTo>
                <a:lnTo>
                  <a:pt x="7115517" y="6397010"/>
                </a:lnTo>
                <a:lnTo>
                  <a:pt x="7115517" y="6325709"/>
                </a:lnTo>
                <a:close/>
                <a:moveTo>
                  <a:pt x="6901543" y="6325709"/>
                </a:moveTo>
                <a:lnTo>
                  <a:pt x="6901543" y="6397010"/>
                </a:lnTo>
                <a:lnTo>
                  <a:pt x="6972844" y="6397010"/>
                </a:lnTo>
                <a:lnTo>
                  <a:pt x="6972844" y="6325709"/>
                </a:lnTo>
                <a:close/>
                <a:moveTo>
                  <a:pt x="6758942" y="6325709"/>
                </a:moveTo>
                <a:lnTo>
                  <a:pt x="6758942" y="6397010"/>
                </a:lnTo>
                <a:lnTo>
                  <a:pt x="6830242" y="6397010"/>
                </a:lnTo>
                <a:lnTo>
                  <a:pt x="6830242" y="6325709"/>
                </a:lnTo>
                <a:close/>
                <a:moveTo>
                  <a:pt x="6616269" y="6325709"/>
                </a:moveTo>
                <a:lnTo>
                  <a:pt x="6616269" y="6397010"/>
                </a:lnTo>
                <a:lnTo>
                  <a:pt x="6687570" y="6397010"/>
                </a:lnTo>
                <a:lnTo>
                  <a:pt x="6687570" y="6325709"/>
                </a:lnTo>
                <a:close/>
                <a:moveTo>
                  <a:pt x="6473667" y="6325709"/>
                </a:moveTo>
                <a:lnTo>
                  <a:pt x="6473667" y="6397010"/>
                </a:lnTo>
                <a:lnTo>
                  <a:pt x="6544968" y="6397010"/>
                </a:lnTo>
                <a:lnTo>
                  <a:pt x="6544968" y="6325709"/>
                </a:lnTo>
                <a:close/>
                <a:moveTo>
                  <a:pt x="6330995" y="6325709"/>
                </a:moveTo>
                <a:lnTo>
                  <a:pt x="6330995" y="6397010"/>
                </a:lnTo>
                <a:lnTo>
                  <a:pt x="6402296" y="6397010"/>
                </a:lnTo>
                <a:lnTo>
                  <a:pt x="6402296" y="6325709"/>
                </a:lnTo>
                <a:close/>
                <a:moveTo>
                  <a:pt x="6188393" y="6325709"/>
                </a:moveTo>
                <a:lnTo>
                  <a:pt x="6188393" y="6397010"/>
                </a:lnTo>
                <a:lnTo>
                  <a:pt x="6259694" y="6397010"/>
                </a:lnTo>
                <a:lnTo>
                  <a:pt x="6259694" y="6325709"/>
                </a:lnTo>
                <a:close/>
                <a:moveTo>
                  <a:pt x="6045721" y="6325709"/>
                </a:moveTo>
                <a:lnTo>
                  <a:pt x="6045721" y="6397010"/>
                </a:lnTo>
                <a:lnTo>
                  <a:pt x="6117021" y="6397010"/>
                </a:lnTo>
                <a:lnTo>
                  <a:pt x="6117021" y="6325709"/>
                </a:lnTo>
                <a:close/>
                <a:moveTo>
                  <a:pt x="5903048" y="6325709"/>
                </a:moveTo>
                <a:lnTo>
                  <a:pt x="5903048" y="6397010"/>
                </a:lnTo>
                <a:lnTo>
                  <a:pt x="5974349" y="6397010"/>
                </a:lnTo>
                <a:lnTo>
                  <a:pt x="5974349" y="6325709"/>
                </a:lnTo>
                <a:close/>
                <a:moveTo>
                  <a:pt x="5760447" y="6325709"/>
                </a:moveTo>
                <a:lnTo>
                  <a:pt x="5760447" y="6397010"/>
                </a:lnTo>
                <a:lnTo>
                  <a:pt x="5831748" y="6397010"/>
                </a:lnTo>
                <a:lnTo>
                  <a:pt x="5831748" y="6325709"/>
                </a:lnTo>
                <a:close/>
                <a:moveTo>
                  <a:pt x="5617774" y="6325709"/>
                </a:moveTo>
                <a:lnTo>
                  <a:pt x="5617774" y="6397010"/>
                </a:lnTo>
                <a:lnTo>
                  <a:pt x="5689075" y="6397010"/>
                </a:lnTo>
                <a:lnTo>
                  <a:pt x="5689075" y="6325709"/>
                </a:lnTo>
                <a:close/>
                <a:moveTo>
                  <a:pt x="5475173" y="6325709"/>
                </a:moveTo>
                <a:lnTo>
                  <a:pt x="5475173" y="6397010"/>
                </a:lnTo>
                <a:lnTo>
                  <a:pt x="5546474" y="6397010"/>
                </a:lnTo>
                <a:lnTo>
                  <a:pt x="5546474" y="6325709"/>
                </a:lnTo>
                <a:close/>
                <a:moveTo>
                  <a:pt x="5332500" y="6325709"/>
                </a:moveTo>
                <a:lnTo>
                  <a:pt x="5332500" y="6397010"/>
                </a:lnTo>
                <a:lnTo>
                  <a:pt x="5403801" y="6397010"/>
                </a:lnTo>
                <a:lnTo>
                  <a:pt x="5403801" y="6325709"/>
                </a:lnTo>
                <a:close/>
                <a:moveTo>
                  <a:pt x="5189828" y="6325709"/>
                </a:moveTo>
                <a:lnTo>
                  <a:pt x="5189828" y="6397010"/>
                </a:lnTo>
                <a:lnTo>
                  <a:pt x="5261129" y="6397010"/>
                </a:lnTo>
                <a:lnTo>
                  <a:pt x="5261129" y="6325709"/>
                </a:lnTo>
                <a:close/>
                <a:moveTo>
                  <a:pt x="5047226" y="6325709"/>
                </a:moveTo>
                <a:lnTo>
                  <a:pt x="5047226" y="6397010"/>
                </a:lnTo>
                <a:lnTo>
                  <a:pt x="5118527" y="6397010"/>
                </a:lnTo>
                <a:lnTo>
                  <a:pt x="5118527" y="6325709"/>
                </a:lnTo>
                <a:close/>
                <a:moveTo>
                  <a:pt x="4904553" y="6325709"/>
                </a:moveTo>
                <a:lnTo>
                  <a:pt x="4904553" y="6397010"/>
                </a:lnTo>
                <a:lnTo>
                  <a:pt x="4975854" y="6397010"/>
                </a:lnTo>
                <a:lnTo>
                  <a:pt x="4975854" y="6325709"/>
                </a:lnTo>
                <a:close/>
                <a:moveTo>
                  <a:pt x="4761952" y="6325709"/>
                </a:moveTo>
                <a:lnTo>
                  <a:pt x="4761952" y="6397010"/>
                </a:lnTo>
                <a:lnTo>
                  <a:pt x="4833253" y="6397010"/>
                </a:lnTo>
                <a:lnTo>
                  <a:pt x="4833253" y="6325709"/>
                </a:lnTo>
                <a:close/>
                <a:moveTo>
                  <a:pt x="4619279" y="6325709"/>
                </a:moveTo>
                <a:lnTo>
                  <a:pt x="4619279" y="6397010"/>
                </a:lnTo>
                <a:lnTo>
                  <a:pt x="4690580" y="6397010"/>
                </a:lnTo>
                <a:lnTo>
                  <a:pt x="4690580" y="6325709"/>
                </a:lnTo>
                <a:close/>
                <a:moveTo>
                  <a:pt x="4476678" y="6325709"/>
                </a:moveTo>
                <a:lnTo>
                  <a:pt x="4476678" y="6397010"/>
                </a:lnTo>
                <a:lnTo>
                  <a:pt x="4547979" y="6397010"/>
                </a:lnTo>
                <a:lnTo>
                  <a:pt x="4547979" y="6325709"/>
                </a:lnTo>
                <a:close/>
                <a:moveTo>
                  <a:pt x="4334005" y="6325709"/>
                </a:moveTo>
                <a:lnTo>
                  <a:pt x="4334005" y="6397010"/>
                </a:lnTo>
                <a:lnTo>
                  <a:pt x="4405306" y="6397010"/>
                </a:lnTo>
                <a:lnTo>
                  <a:pt x="4405306" y="6325709"/>
                </a:lnTo>
                <a:close/>
                <a:moveTo>
                  <a:pt x="4191404" y="6325709"/>
                </a:moveTo>
                <a:lnTo>
                  <a:pt x="4191404" y="6397010"/>
                </a:lnTo>
                <a:lnTo>
                  <a:pt x="4262705" y="6397010"/>
                </a:lnTo>
                <a:lnTo>
                  <a:pt x="4262705" y="6325709"/>
                </a:lnTo>
                <a:close/>
                <a:moveTo>
                  <a:pt x="4048731" y="6325709"/>
                </a:moveTo>
                <a:lnTo>
                  <a:pt x="4048731" y="6397010"/>
                </a:lnTo>
                <a:lnTo>
                  <a:pt x="4120032" y="6397010"/>
                </a:lnTo>
                <a:lnTo>
                  <a:pt x="4120032" y="6325709"/>
                </a:lnTo>
                <a:close/>
                <a:moveTo>
                  <a:pt x="3906059" y="6325709"/>
                </a:moveTo>
                <a:lnTo>
                  <a:pt x="3906059" y="6397010"/>
                </a:lnTo>
                <a:lnTo>
                  <a:pt x="3977360" y="6397010"/>
                </a:lnTo>
                <a:lnTo>
                  <a:pt x="3977360" y="6325709"/>
                </a:lnTo>
                <a:close/>
                <a:moveTo>
                  <a:pt x="3763457" y="6325709"/>
                </a:moveTo>
                <a:lnTo>
                  <a:pt x="3763457" y="6397010"/>
                </a:lnTo>
                <a:lnTo>
                  <a:pt x="3834758" y="6397010"/>
                </a:lnTo>
                <a:lnTo>
                  <a:pt x="3834758" y="6325709"/>
                </a:lnTo>
                <a:close/>
                <a:moveTo>
                  <a:pt x="3620784" y="6325709"/>
                </a:moveTo>
                <a:lnTo>
                  <a:pt x="3620784" y="6397010"/>
                </a:lnTo>
                <a:lnTo>
                  <a:pt x="3692085" y="6397010"/>
                </a:lnTo>
                <a:lnTo>
                  <a:pt x="3692085" y="6325709"/>
                </a:lnTo>
                <a:close/>
                <a:moveTo>
                  <a:pt x="3478184" y="6325709"/>
                </a:moveTo>
                <a:lnTo>
                  <a:pt x="3478184" y="6397010"/>
                </a:lnTo>
                <a:lnTo>
                  <a:pt x="3549484" y="6397010"/>
                </a:lnTo>
                <a:lnTo>
                  <a:pt x="3549484" y="6325709"/>
                </a:lnTo>
                <a:close/>
                <a:moveTo>
                  <a:pt x="3335511" y="6325709"/>
                </a:moveTo>
                <a:lnTo>
                  <a:pt x="3335511" y="6397010"/>
                </a:lnTo>
                <a:lnTo>
                  <a:pt x="3406811" y="6397010"/>
                </a:lnTo>
                <a:lnTo>
                  <a:pt x="3406811" y="6325709"/>
                </a:lnTo>
                <a:close/>
                <a:moveTo>
                  <a:pt x="3192839" y="6325709"/>
                </a:moveTo>
                <a:lnTo>
                  <a:pt x="3192839" y="6397010"/>
                </a:lnTo>
                <a:lnTo>
                  <a:pt x="3264139" y="6397010"/>
                </a:lnTo>
                <a:lnTo>
                  <a:pt x="3264139" y="6325709"/>
                </a:lnTo>
                <a:close/>
                <a:moveTo>
                  <a:pt x="3050237" y="6325709"/>
                </a:moveTo>
                <a:lnTo>
                  <a:pt x="3050237" y="6397010"/>
                </a:lnTo>
                <a:lnTo>
                  <a:pt x="3121537" y="6397010"/>
                </a:lnTo>
                <a:lnTo>
                  <a:pt x="3121537" y="6325709"/>
                </a:lnTo>
                <a:close/>
                <a:moveTo>
                  <a:pt x="2907564" y="6325709"/>
                </a:moveTo>
                <a:lnTo>
                  <a:pt x="2907564" y="6397010"/>
                </a:lnTo>
                <a:lnTo>
                  <a:pt x="2978865" y="6397010"/>
                </a:lnTo>
                <a:lnTo>
                  <a:pt x="2978865" y="6325709"/>
                </a:lnTo>
                <a:close/>
                <a:moveTo>
                  <a:pt x="2764962" y="6325709"/>
                </a:moveTo>
                <a:lnTo>
                  <a:pt x="2764962" y="6397010"/>
                </a:lnTo>
                <a:lnTo>
                  <a:pt x="2836263" y="6397010"/>
                </a:lnTo>
                <a:lnTo>
                  <a:pt x="2836263" y="6325709"/>
                </a:lnTo>
                <a:close/>
                <a:moveTo>
                  <a:pt x="2622291" y="6325709"/>
                </a:moveTo>
                <a:lnTo>
                  <a:pt x="2622291" y="6397010"/>
                </a:lnTo>
                <a:lnTo>
                  <a:pt x="2693591" y="6397010"/>
                </a:lnTo>
                <a:lnTo>
                  <a:pt x="2693591" y="6325709"/>
                </a:lnTo>
                <a:close/>
                <a:moveTo>
                  <a:pt x="2479688" y="6325709"/>
                </a:moveTo>
                <a:lnTo>
                  <a:pt x="2479688" y="6397010"/>
                </a:lnTo>
                <a:lnTo>
                  <a:pt x="2550990" y="6397010"/>
                </a:lnTo>
                <a:lnTo>
                  <a:pt x="2550990" y="6325709"/>
                </a:lnTo>
                <a:close/>
                <a:moveTo>
                  <a:pt x="2337016" y="6325709"/>
                </a:moveTo>
                <a:lnTo>
                  <a:pt x="2337016" y="6397010"/>
                </a:lnTo>
                <a:lnTo>
                  <a:pt x="2408317" y="6397010"/>
                </a:lnTo>
                <a:lnTo>
                  <a:pt x="2408317" y="6325709"/>
                </a:lnTo>
                <a:close/>
                <a:moveTo>
                  <a:pt x="2195429" y="6325709"/>
                </a:moveTo>
                <a:lnTo>
                  <a:pt x="2195429" y="6397010"/>
                </a:lnTo>
                <a:lnTo>
                  <a:pt x="2266731" y="6397010"/>
                </a:lnTo>
                <a:lnTo>
                  <a:pt x="2266731" y="6325709"/>
                </a:lnTo>
                <a:close/>
                <a:moveTo>
                  <a:pt x="2052828" y="6325709"/>
                </a:moveTo>
                <a:lnTo>
                  <a:pt x="2052828" y="6397010"/>
                </a:lnTo>
                <a:lnTo>
                  <a:pt x="2124128" y="6397010"/>
                </a:lnTo>
                <a:lnTo>
                  <a:pt x="2124128" y="6325709"/>
                </a:lnTo>
                <a:close/>
                <a:moveTo>
                  <a:pt x="1910155" y="6325709"/>
                </a:moveTo>
                <a:lnTo>
                  <a:pt x="1910155" y="6397010"/>
                </a:lnTo>
                <a:lnTo>
                  <a:pt x="1981455" y="6397010"/>
                </a:lnTo>
                <a:lnTo>
                  <a:pt x="1981455" y="6325709"/>
                </a:lnTo>
                <a:close/>
                <a:moveTo>
                  <a:pt x="1767483" y="6325709"/>
                </a:moveTo>
                <a:lnTo>
                  <a:pt x="1767483" y="6397010"/>
                </a:lnTo>
                <a:lnTo>
                  <a:pt x="1838783" y="6397010"/>
                </a:lnTo>
                <a:lnTo>
                  <a:pt x="1838783" y="6325709"/>
                </a:lnTo>
                <a:close/>
                <a:moveTo>
                  <a:pt x="1624882" y="6325709"/>
                </a:moveTo>
                <a:lnTo>
                  <a:pt x="1624882" y="6397010"/>
                </a:lnTo>
                <a:lnTo>
                  <a:pt x="1696183" y="6397010"/>
                </a:lnTo>
                <a:lnTo>
                  <a:pt x="1696183" y="6325709"/>
                </a:lnTo>
                <a:close/>
                <a:moveTo>
                  <a:pt x="1482215" y="6325709"/>
                </a:moveTo>
                <a:lnTo>
                  <a:pt x="1482215" y="6397010"/>
                </a:lnTo>
                <a:lnTo>
                  <a:pt x="1553511" y="6397010"/>
                </a:lnTo>
                <a:lnTo>
                  <a:pt x="1553511" y="6325709"/>
                </a:lnTo>
                <a:close/>
                <a:moveTo>
                  <a:pt x="1339621" y="6325709"/>
                </a:moveTo>
                <a:lnTo>
                  <a:pt x="1339621" y="6397010"/>
                </a:lnTo>
                <a:lnTo>
                  <a:pt x="1410920" y="6397010"/>
                </a:lnTo>
                <a:lnTo>
                  <a:pt x="1410920" y="6325709"/>
                </a:lnTo>
                <a:close/>
                <a:moveTo>
                  <a:pt x="1196941" y="6325709"/>
                </a:moveTo>
                <a:lnTo>
                  <a:pt x="1196941" y="6397010"/>
                </a:lnTo>
                <a:lnTo>
                  <a:pt x="1268245" y="6397010"/>
                </a:lnTo>
                <a:lnTo>
                  <a:pt x="1268245" y="6325709"/>
                </a:lnTo>
                <a:close/>
                <a:moveTo>
                  <a:pt x="1054277" y="6325709"/>
                </a:moveTo>
                <a:lnTo>
                  <a:pt x="1054277" y="6397010"/>
                </a:lnTo>
                <a:lnTo>
                  <a:pt x="1125575" y="6397010"/>
                </a:lnTo>
                <a:lnTo>
                  <a:pt x="1125575" y="6325709"/>
                </a:lnTo>
                <a:close/>
                <a:moveTo>
                  <a:pt x="911663" y="6325709"/>
                </a:moveTo>
                <a:lnTo>
                  <a:pt x="911663" y="6397010"/>
                </a:lnTo>
                <a:lnTo>
                  <a:pt x="982964" y="6397010"/>
                </a:lnTo>
                <a:lnTo>
                  <a:pt x="982964" y="6325709"/>
                </a:lnTo>
                <a:close/>
                <a:moveTo>
                  <a:pt x="769001" y="6325709"/>
                </a:moveTo>
                <a:lnTo>
                  <a:pt x="769001" y="6397010"/>
                </a:lnTo>
                <a:lnTo>
                  <a:pt x="840299" y="6397010"/>
                </a:lnTo>
                <a:lnTo>
                  <a:pt x="840299" y="6325709"/>
                </a:lnTo>
                <a:close/>
                <a:moveTo>
                  <a:pt x="626392" y="6325709"/>
                </a:moveTo>
                <a:lnTo>
                  <a:pt x="626392" y="6397010"/>
                </a:lnTo>
                <a:lnTo>
                  <a:pt x="697691" y="6397010"/>
                </a:lnTo>
                <a:lnTo>
                  <a:pt x="697691" y="6325709"/>
                </a:lnTo>
                <a:close/>
                <a:moveTo>
                  <a:pt x="7044216" y="6183107"/>
                </a:moveTo>
                <a:lnTo>
                  <a:pt x="7044216" y="6254408"/>
                </a:lnTo>
                <a:lnTo>
                  <a:pt x="7115517" y="6254408"/>
                </a:lnTo>
                <a:lnTo>
                  <a:pt x="7115517" y="6183107"/>
                </a:lnTo>
                <a:close/>
                <a:moveTo>
                  <a:pt x="6901543" y="6183107"/>
                </a:moveTo>
                <a:lnTo>
                  <a:pt x="6901543" y="6254408"/>
                </a:lnTo>
                <a:lnTo>
                  <a:pt x="6972844" y="6254408"/>
                </a:lnTo>
                <a:lnTo>
                  <a:pt x="6972844" y="6183107"/>
                </a:lnTo>
                <a:close/>
                <a:moveTo>
                  <a:pt x="6758942" y="6183107"/>
                </a:moveTo>
                <a:lnTo>
                  <a:pt x="6758942" y="6254408"/>
                </a:lnTo>
                <a:lnTo>
                  <a:pt x="6830242" y="6254408"/>
                </a:lnTo>
                <a:lnTo>
                  <a:pt x="6830242" y="6183107"/>
                </a:lnTo>
                <a:close/>
                <a:moveTo>
                  <a:pt x="6616269" y="6183107"/>
                </a:moveTo>
                <a:lnTo>
                  <a:pt x="6616269" y="6254408"/>
                </a:lnTo>
                <a:lnTo>
                  <a:pt x="6687570" y="6254408"/>
                </a:lnTo>
                <a:lnTo>
                  <a:pt x="6687570" y="6183107"/>
                </a:lnTo>
                <a:close/>
                <a:moveTo>
                  <a:pt x="6473667" y="6183107"/>
                </a:moveTo>
                <a:lnTo>
                  <a:pt x="6473667" y="6254408"/>
                </a:lnTo>
                <a:lnTo>
                  <a:pt x="6544968" y="6254408"/>
                </a:lnTo>
                <a:lnTo>
                  <a:pt x="6544968" y="6183107"/>
                </a:lnTo>
                <a:close/>
                <a:moveTo>
                  <a:pt x="6330995" y="6183107"/>
                </a:moveTo>
                <a:lnTo>
                  <a:pt x="6330995" y="6254408"/>
                </a:lnTo>
                <a:lnTo>
                  <a:pt x="6402296" y="6254408"/>
                </a:lnTo>
                <a:lnTo>
                  <a:pt x="6402296" y="6183107"/>
                </a:lnTo>
                <a:close/>
                <a:moveTo>
                  <a:pt x="6188393" y="6183107"/>
                </a:moveTo>
                <a:lnTo>
                  <a:pt x="6188393" y="6254408"/>
                </a:lnTo>
                <a:lnTo>
                  <a:pt x="6259694" y="6254408"/>
                </a:lnTo>
                <a:lnTo>
                  <a:pt x="6259694" y="6183107"/>
                </a:lnTo>
                <a:close/>
                <a:moveTo>
                  <a:pt x="6045721" y="6183107"/>
                </a:moveTo>
                <a:lnTo>
                  <a:pt x="6045721" y="6254408"/>
                </a:lnTo>
                <a:lnTo>
                  <a:pt x="6117021" y="6254408"/>
                </a:lnTo>
                <a:lnTo>
                  <a:pt x="6117021" y="6183107"/>
                </a:lnTo>
                <a:close/>
                <a:moveTo>
                  <a:pt x="5903048" y="6183107"/>
                </a:moveTo>
                <a:lnTo>
                  <a:pt x="5903048" y="6254408"/>
                </a:lnTo>
                <a:lnTo>
                  <a:pt x="5974349" y="6254408"/>
                </a:lnTo>
                <a:lnTo>
                  <a:pt x="5974349" y="6183107"/>
                </a:lnTo>
                <a:close/>
                <a:moveTo>
                  <a:pt x="5760447" y="6183107"/>
                </a:moveTo>
                <a:lnTo>
                  <a:pt x="5760447" y="6254408"/>
                </a:lnTo>
                <a:lnTo>
                  <a:pt x="5831748" y="6254408"/>
                </a:lnTo>
                <a:lnTo>
                  <a:pt x="5831748" y="6183107"/>
                </a:lnTo>
                <a:close/>
                <a:moveTo>
                  <a:pt x="5617774" y="6183107"/>
                </a:moveTo>
                <a:lnTo>
                  <a:pt x="5617774" y="6254408"/>
                </a:lnTo>
                <a:lnTo>
                  <a:pt x="5689075" y="6254408"/>
                </a:lnTo>
                <a:lnTo>
                  <a:pt x="5689075" y="6183107"/>
                </a:lnTo>
                <a:close/>
                <a:moveTo>
                  <a:pt x="5475173" y="6183107"/>
                </a:moveTo>
                <a:lnTo>
                  <a:pt x="5475173" y="6254408"/>
                </a:lnTo>
                <a:lnTo>
                  <a:pt x="5546474" y="6254408"/>
                </a:lnTo>
                <a:lnTo>
                  <a:pt x="5546474" y="6183107"/>
                </a:lnTo>
                <a:close/>
                <a:moveTo>
                  <a:pt x="5332500" y="6183107"/>
                </a:moveTo>
                <a:lnTo>
                  <a:pt x="5332500" y="6254408"/>
                </a:lnTo>
                <a:lnTo>
                  <a:pt x="5403801" y="6254408"/>
                </a:lnTo>
                <a:lnTo>
                  <a:pt x="5403801" y="6183107"/>
                </a:lnTo>
                <a:close/>
                <a:moveTo>
                  <a:pt x="5189828" y="6183107"/>
                </a:moveTo>
                <a:lnTo>
                  <a:pt x="5189828" y="6254408"/>
                </a:lnTo>
                <a:lnTo>
                  <a:pt x="5261129" y="6254408"/>
                </a:lnTo>
                <a:lnTo>
                  <a:pt x="5261129" y="6183107"/>
                </a:lnTo>
                <a:close/>
                <a:moveTo>
                  <a:pt x="5047226" y="6183107"/>
                </a:moveTo>
                <a:lnTo>
                  <a:pt x="5047226" y="6254408"/>
                </a:lnTo>
                <a:lnTo>
                  <a:pt x="5118527" y="6254408"/>
                </a:lnTo>
                <a:lnTo>
                  <a:pt x="5118527" y="6183107"/>
                </a:lnTo>
                <a:close/>
                <a:moveTo>
                  <a:pt x="4904553" y="6183107"/>
                </a:moveTo>
                <a:lnTo>
                  <a:pt x="4904553" y="6254408"/>
                </a:lnTo>
                <a:lnTo>
                  <a:pt x="4975854" y="6254408"/>
                </a:lnTo>
                <a:lnTo>
                  <a:pt x="4975854" y="6183107"/>
                </a:lnTo>
                <a:close/>
                <a:moveTo>
                  <a:pt x="4761952" y="6183107"/>
                </a:moveTo>
                <a:lnTo>
                  <a:pt x="4761952" y="6254408"/>
                </a:lnTo>
                <a:lnTo>
                  <a:pt x="4833253" y="6254408"/>
                </a:lnTo>
                <a:lnTo>
                  <a:pt x="4833253" y="6183107"/>
                </a:lnTo>
                <a:close/>
                <a:moveTo>
                  <a:pt x="4619279" y="6183107"/>
                </a:moveTo>
                <a:lnTo>
                  <a:pt x="4619279" y="6254408"/>
                </a:lnTo>
                <a:lnTo>
                  <a:pt x="4690580" y="6254408"/>
                </a:lnTo>
                <a:lnTo>
                  <a:pt x="4690580" y="6183107"/>
                </a:lnTo>
                <a:close/>
                <a:moveTo>
                  <a:pt x="4476678" y="6183107"/>
                </a:moveTo>
                <a:lnTo>
                  <a:pt x="4476678" y="6254408"/>
                </a:lnTo>
                <a:lnTo>
                  <a:pt x="4547979" y="6254408"/>
                </a:lnTo>
                <a:lnTo>
                  <a:pt x="4547979" y="6183107"/>
                </a:lnTo>
                <a:close/>
                <a:moveTo>
                  <a:pt x="4334005" y="6183107"/>
                </a:moveTo>
                <a:lnTo>
                  <a:pt x="4334005" y="6254408"/>
                </a:lnTo>
                <a:lnTo>
                  <a:pt x="4405306" y="6254408"/>
                </a:lnTo>
                <a:lnTo>
                  <a:pt x="4405306" y="6183107"/>
                </a:lnTo>
                <a:close/>
                <a:moveTo>
                  <a:pt x="4191404" y="6183107"/>
                </a:moveTo>
                <a:lnTo>
                  <a:pt x="4191404" y="6254408"/>
                </a:lnTo>
                <a:lnTo>
                  <a:pt x="4262705" y="6254408"/>
                </a:lnTo>
                <a:lnTo>
                  <a:pt x="4262705" y="6183107"/>
                </a:lnTo>
                <a:close/>
                <a:moveTo>
                  <a:pt x="4048731" y="6183107"/>
                </a:moveTo>
                <a:lnTo>
                  <a:pt x="4048731" y="6254408"/>
                </a:lnTo>
                <a:lnTo>
                  <a:pt x="4120032" y="6254408"/>
                </a:lnTo>
                <a:lnTo>
                  <a:pt x="4120032" y="6183107"/>
                </a:lnTo>
                <a:close/>
                <a:moveTo>
                  <a:pt x="3906059" y="6183107"/>
                </a:moveTo>
                <a:lnTo>
                  <a:pt x="3906059" y="6254408"/>
                </a:lnTo>
                <a:lnTo>
                  <a:pt x="3977360" y="6254408"/>
                </a:lnTo>
                <a:lnTo>
                  <a:pt x="3977360" y="6183107"/>
                </a:lnTo>
                <a:close/>
                <a:moveTo>
                  <a:pt x="3763457" y="6183107"/>
                </a:moveTo>
                <a:lnTo>
                  <a:pt x="3763457" y="6254408"/>
                </a:lnTo>
                <a:lnTo>
                  <a:pt x="3834758" y="6254408"/>
                </a:lnTo>
                <a:lnTo>
                  <a:pt x="3834758" y="6183107"/>
                </a:lnTo>
                <a:close/>
                <a:moveTo>
                  <a:pt x="3620784" y="6183107"/>
                </a:moveTo>
                <a:lnTo>
                  <a:pt x="3620784" y="6254408"/>
                </a:lnTo>
                <a:lnTo>
                  <a:pt x="3692085" y="6254408"/>
                </a:lnTo>
                <a:lnTo>
                  <a:pt x="3692085" y="6183107"/>
                </a:lnTo>
                <a:close/>
                <a:moveTo>
                  <a:pt x="3478184" y="6183107"/>
                </a:moveTo>
                <a:lnTo>
                  <a:pt x="3478184" y="6254408"/>
                </a:lnTo>
                <a:lnTo>
                  <a:pt x="3549484" y="6254408"/>
                </a:lnTo>
                <a:lnTo>
                  <a:pt x="3549484" y="6183107"/>
                </a:lnTo>
                <a:close/>
                <a:moveTo>
                  <a:pt x="3335511" y="6183107"/>
                </a:moveTo>
                <a:lnTo>
                  <a:pt x="3335511" y="6254408"/>
                </a:lnTo>
                <a:lnTo>
                  <a:pt x="3406811" y="6254408"/>
                </a:lnTo>
                <a:lnTo>
                  <a:pt x="3406811" y="6183107"/>
                </a:lnTo>
                <a:close/>
                <a:moveTo>
                  <a:pt x="3192839" y="6183107"/>
                </a:moveTo>
                <a:lnTo>
                  <a:pt x="3192839" y="6254408"/>
                </a:lnTo>
                <a:lnTo>
                  <a:pt x="3264139" y="6254408"/>
                </a:lnTo>
                <a:lnTo>
                  <a:pt x="3264139" y="6183107"/>
                </a:lnTo>
                <a:close/>
                <a:moveTo>
                  <a:pt x="3050237" y="6183107"/>
                </a:moveTo>
                <a:lnTo>
                  <a:pt x="3050237" y="6254408"/>
                </a:lnTo>
                <a:lnTo>
                  <a:pt x="3121537" y="6254408"/>
                </a:lnTo>
                <a:lnTo>
                  <a:pt x="3121537" y="6183107"/>
                </a:lnTo>
                <a:close/>
                <a:moveTo>
                  <a:pt x="2907564" y="6183107"/>
                </a:moveTo>
                <a:lnTo>
                  <a:pt x="2907564" y="6254408"/>
                </a:lnTo>
                <a:lnTo>
                  <a:pt x="2978865" y="6254408"/>
                </a:lnTo>
                <a:lnTo>
                  <a:pt x="2978865" y="6183107"/>
                </a:lnTo>
                <a:close/>
                <a:moveTo>
                  <a:pt x="2764962" y="6183107"/>
                </a:moveTo>
                <a:lnTo>
                  <a:pt x="2764962" y="6254408"/>
                </a:lnTo>
                <a:lnTo>
                  <a:pt x="2836263" y="6254408"/>
                </a:lnTo>
                <a:lnTo>
                  <a:pt x="2836263" y="6183107"/>
                </a:lnTo>
                <a:close/>
                <a:moveTo>
                  <a:pt x="2622291" y="6183107"/>
                </a:moveTo>
                <a:lnTo>
                  <a:pt x="2622291" y="6254408"/>
                </a:lnTo>
                <a:lnTo>
                  <a:pt x="2693591" y="6254408"/>
                </a:lnTo>
                <a:lnTo>
                  <a:pt x="2693591" y="6183107"/>
                </a:lnTo>
                <a:close/>
                <a:moveTo>
                  <a:pt x="2479688" y="6183107"/>
                </a:moveTo>
                <a:lnTo>
                  <a:pt x="2479688" y="6254408"/>
                </a:lnTo>
                <a:lnTo>
                  <a:pt x="2550990" y="6254408"/>
                </a:lnTo>
                <a:lnTo>
                  <a:pt x="2550990" y="6183107"/>
                </a:lnTo>
                <a:close/>
                <a:moveTo>
                  <a:pt x="2337016" y="6183107"/>
                </a:moveTo>
                <a:lnTo>
                  <a:pt x="2337016" y="6254408"/>
                </a:lnTo>
                <a:lnTo>
                  <a:pt x="2408317" y="6254408"/>
                </a:lnTo>
                <a:lnTo>
                  <a:pt x="2408317" y="6183107"/>
                </a:lnTo>
                <a:close/>
                <a:moveTo>
                  <a:pt x="2195429" y="6183107"/>
                </a:moveTo>
                <a:lnTo>
                  <a:pt x="2195429" y="6254408"/>
                </a:lnTo>
                <a:lnTo>
                  <a:pt x="2266731" y="6254408"/>
                </a:lnTo>
                <a:lnTo>
                  <a:pt x="2266731" y="6183107"/>
                </a:lnTo>
                <a:close/>
                <a:moveTo>
                  <a:pt x="2052828" y="6183107"/>
                </a:moveTo>
                <a:lnTo>
                  <a:pt x="2052828" y="6254408"/>
                </a:lnTo>
                <a:lnTo>
                  <a:pt x="2124128" y="6254408"/>
                </a:lnTo>
                <a:lnTo>
                  <a:pt x="2124128" y="6183107"/>
                </a:lnTo>
                <a:close/>
                <a:moveTo>
                  <a:pt x="1910155" y="6183107"/>
                </a:moveTo>
                <a:lnTo>
                  <a:pt x="1910155" y="6254408"/>
                </a:lnTo>
                <a:lnTo>
                  <a:pt x="1981455" y="6254408"/>
                </a:lnTo>
                <a:lnTo>
                  <a:pt x="1981455" y="6183107"/>
                </a:lnTo>
                <a:close/>
                <a:moveTo>
                  <a:pt x="1767483" y="6183107"/>
                </a:moveTo>
                <a:lnTo>
                  <a:pt x="1767483" y="6254408"/>
                </a:lnTo>
                <a:lnTo>
                  <a:pt x="1838783" y="6254408"/>
                </a:lnTo>
                <a:lnTo>
                  <a:pt x="1838783" y="6183107"/>
                </a:lnTo>
                <a:close/>
                <a:moveTo>
                  <a:pt x="1624882" y="6183107"/>
                </a:moveTo>
                <a:lnTo>
                  <a:pt x="1624882" y="6254408"/>
                </a:lnTo>
                <a:lnTo>
                  <a:pt x="1696183" y="6254408"/>
                </a:lnTo>
                <a:lnTo>
                  <a:pt x="1696183" y="6183107"/>
                </a:lnTo>
                <a:close/>
                <a:moveTo>
                  <a:pt x="1482215" y="6183107"/>
                </a:moveTo>
                <a:lnTo>
                  <a:pt x="1482215" y="6254408"/>
                </a:lnTo>
                <a:lnTo>
                  <a:pt x="1553511" y="6254408"/>
                </a:lnTo>
                <a:lnTo>
                  <a:pt x="1553511" y="6183107"/>
                </a:lnTo>
                <a:close/>
                <a:moveTo>
                  <a:pt x="1339621" y="6183107"/>
                </a:moveTo>
                <a:lnTo>
                  <a:pt x="1339621" y="6254408"/>
                </a:lnTo>
                <a:lnTo>
                  <a:pt x="1410920" y="6254408"/>
                </a:lnTo>
                <a:lnTo>
                  <a:pt x="1410920" y="6183107"/>
                </a:lnTo>
                <a:close/>
                <a:moveTo>
                  <a:pt x="1196948" y="6183107"/>
                </a:moveTo>
                <a:lnTo>
                  <a:pt x="1196948" y="6254408"/>
                </a:lnTo>
                <a:lnTo>
                  <a:pt x="1268245" y="6254408"/>
                </a:lnTo>
                <a:lnTo>
                  <a:pt x="1268245" y="6183107"/>
                </a:lnTo>
                <a:close/>
                <a:moveTo>
                  <a:pt x="1054277" y="6183107"/>
                </a:moveTo>
                <a:lnTo>
                  <a:pt x="1054277" y="6254408"/>
                </a:lnTo>
                <a:lnTo>
                  <a:pt x="1125575" y="6254408"/>
                </a:lnTo>
                <a:lnTo>
                  <a:pt x="1125575" y="6183107"/>
                </a:lnTo>
                <a:close/>
                <a:moveTo>
                  <a:pt x="911663" y="6183107"/>
                </a:moveTo>
                <a:lnTo>
                  <a:pt x="911663" y="6254408"/>
                </a:lnTo>
                <a:lnTo>
                  <a:pt x="982964" y="6254408"/>
                </a:lnTo>
                <a:lnTo>
                  <a:pt x="982964" y="6183107"/>
                </a:lnTo>
                <a:close/>
                <a:moveTo>
                  <a:pt x="769001" y="6183107"/>
                </a:moveTo>
                <a:lnTo>
                  <a:pt x="769001" y="6254408"/>
                </a:lnTo>
                <a:lnTo>
                  <a:pt x="840299" y="6254408"/>
                </a:lnTo>
                <a:lnTo>
                  <a:pt x="840299" y="6183107"/>
                </a:lnTo>
                <a:close/>
                <a:moveTo>
                  <a:pt x="7329490" y="6040435"/>
                </a:moveTo>
                <a:lnTo>
                  <a:pt x="7329490" y="6111736"/>
                </a:lnTo>
                <a:lnTo>
                  <a:pt x="7400791" y="6111736"/>
                </a:lnTo>
                <a:lnTo>
                  <a:pt x="7400791" y="6040435"/>
                </a:lnTo>
                <a:close/>
                <a:moveTo>
                  <a:pt x="7186888" y="6040435"/>
                </a:moveTo>
                <a:lnTo>
                  <a:pt x="7186888" y="6111736"/>
                </a:lnTo>
                <a:lnTo>
                  <a:pt x="7258188" y="6111736"/>
                </a:lnTo>
                <a:lnTo>
                  <a:pt x="7258188" y="6040435"/>
                </a:lnTo>
                <a:close/>
                <a:moveTo>
                  <a:pt x="7044216" y="6040435"/>
                </a:moveTo>
                <a:lnTo>
                  <a:pt x="7044216" y="6111736"/>
                </a:lnTo>
                <a:lnTo>
                  <a:pt x="7115517" y="6111736"/>
                </a:lnTo>
                <a:lnTo>
                  <a:pt x="7115517" y="6040435"/>
                </a:lnTo>
                <a:close/>
                <a:moveTo>
                  <a:pt x="6901543" y="6040435"/>
                </a:moveTo>
                <a:lnTo>
                  <a:pt x="6901543" y="6111736"/>
                </a:lnTo>
                <a:lnTo>
                  <a:pt x="6972844" y="6111736"/>
                </a:lnTo>
                <a:lnTo>
                  <a:pt x="6972844" y="6040435"/>
                </a:lnTo>
                <a:close/>
                <a:moveTo>
                  <a:pt x="6758942" y="6040435"/>
                </a:moveTo>
                <a:lnTo>
                  <a:pt x="6758942" y="6111736"/>
                </a:lnTo>
                <a:lnTo>
                  <a:pt x="6830242" y="6111736"/>
                </a:lnTo>
                <a:lnTo>
                  <a:pt x="6830242" y="6040435"/>
                </a:lnTo>
                <a:close/>
                <a:moveTo>
                  <a:pt x="6616269" y="6040435"/>
                </a:moveTo>
                <a:lnTo>
                  <a:pt x="6616269" y="6111736"/>
                </a:lnTo>
                <a:lnTo>
                  <a:pt x="6687570" y="6111736"/>
                </a:lnTo>
                <a:lnTo>
                  <a:pt x="6687570" y="6040435"/>
                </a:lnTo>
                <a:close/>
                <a:moveTo>
                  <a:pt x="6473667" y="6040435"/>
                </a:moveTo>
                <a:lnTo>
                  <a:pt x="6473667" y="6111736"/>
                </a:lnTo>
                <a:lnTo>
                  <a:pt x="6544968" y="6111736"/>
                </a:lnTo>
                <a:lnTo>
                  <a:pt x="6544968" y="6040435"/>
                </a:lnTo>
                <a:close/>
                <a:moveTo>
                  <a:pt x="6330995" y="6040435"/>
                </a:moveTo>
                <a:lnTo>
                  <a:pt x="6330995" y="6111736"/>
                </a:lnTo>
                <a:lnTo>
                  <a:pt x="6402296" y="6111736"/>
                </a:lnTo>
                <a:lnTo>
                  <a:pt x="6402296" y="6040435"/>
                </a:lnTo>
                <a:close/>
                <a:moveTo>
                  <a:pt x="6188393" y="6040435"/>
                </a:moveTo>
                <a:lnTo>
                  <a:pt x="6188393" y="6111736"/>
                </a:lnTo>
                <a:lnTo>
                  <a:pt x="6259694" y="6111736"/>
                </a:lnTo>
                <a:lnTo>
                  <a:pt x="6259694" y="6040435"/>
                </a:lnTo>
                <a:close/>
                <a:moveTo>
                  <a:pt x="6045721" y="6040435"/>
                </a:moveTo>
                <a:lnTo>
                  <a:pt x="6045721" y="6111736"/>
                </a:lnTo>
                <a:lnTo>
                  <a:pt x="6117021" y="6111736"/>
                </a:lnTo>
                <a:lnTo>
                  <a:pt x="6117021" y="6040435"/>
                </a:lnTo>
                <a:close/>
                <a:moveTo>
                  <a:pt x="5903048" y="6040435"/>
                </a:moveTo>
                <a:lnTo>
                  <a:pt x="5903048" y="6111736"/>
                </a:lnTo>
                <a:lnTo>
                  <a:pt x="5974349" y="6111736"/>
                </a:lnTo>
                <a:lnTo>
                  <a:pt x="5974349" y="6040435"/>
                </a:lnTo>
                <a:close/>
                <a:moveTo>
                  <a:pt x="5760447" y="6040435"/>
                </a:moveTo>
                <a:lnTo>
                  <a:pt x="5760447" y="6111736"/>
                </a:lnTo>
                <a:lnTo>
                  <a:pt x="5831748" y="6111736"/>
                </a:lnTo>
                <a:lnTo>
                  <a:pt x="5831748" y="6040435"/>
                </a:lnTo>
                <a:close/>
                <a:moveTo>
                  <a:pt x="5617774" y="6040435"/>
                </a:moveTo>
                <a:lnTo>
                  <a:pt x="5617774" y="6111736"/>
                </a:lnTo>
                <a:lnTo>
                  <a:pt x="5689075" y="6111736"/>
                </a:lnTo>
                <a:lnTo>
                  <a:pt x="5689075" y="6040435"/>
                </a:lnTo>
                <a:close/>
                <a:moveTo>
                  <a:pt x="5475173" y="6040435"/>
                </a:moveTo>
                <a:lnTo>
                  <a:pt x="5475173" y="6111736"/>
                </a:lnTo>
                <a:lnTo>
                  <a:pt x="5546474" y="6111736"/>
                </a:lnTo>
                <a:lnTo>
                  <a:pt x="5546474" y="6040435"/>
                </a:lnTo>
                <a:close/>
                <a:moveTo>
                  <a:pt x="5332500" y="6040435"/>
                </a:moveTo>
                <a:lnTo>
                  <a:pt x="5332500" y="6111736"/>
                </a:lnTo>
                <a:lnTo>
                  <a:pt x="5403801" y="6111736"/>
                </a:lnTo>
                <a:lnTo>
                  <a:pt x="5403801" y="6040435"/>
                </a:lnTo>
                <a:close/>
                <a:moveTo>
                  <a:pt x="5189828" y="6040435"/>
                </a:moveTo>
                <a:lnTo>
                  <a:pt x="5189828" y="6111736"/>
                </a:lnTo>
                <a:lnTo>
                  <a:pt x="5261129" y="6111736"/>
                </a:lnTo>
                <a:lnTo>
                  <a:pt x="5261129" y="6040435"/>
                </a:lnTo>
                <a:close/>
                <a:moveTo>
                  <a:pt x="5047226" y="6040435"/>
                </a:moveTo>
                <a:lnTo>
                  <a:pt x="5047226" y="6111736"/>
                </a:lnTo>
                <a:lnTo>
                  <a:pt x="5118527" y="6111736"/>
                </a:lnTo>
                <a:lnTo>
                  <a:pt x="5118527" y="6040435"/>
                </a:lnTo>
                <a:close/>
                <a:moveTo>
                  <a:pt x="4904553" y="6040435"/>
                </a:moveTo>
                <a:lnTo>
                  <a:pt x="4904553" y="6111736"/>
                </a:lnTo>
                <a:lnTo>
                  <a:pt x="4975854" y="6111736"/>
                </a:lnTo>
                <a:lnTo>
                  <a:pt x="4975854" y="6040435"/>
                </a:lnTo>
                <a:close/>
                <a:moveTo>
                  <a:pt x="4761952" y="6040435"/>
                </a:moveTo>
                <a:lnTo>
                  <a:pt x="4761952" y="6111736"/>
                </a:lnTo>
                <a:lnTo>
                  <a:pt x="4833253" y="6111736"/>
                </a:lnTo>
                <a:lnTo>
                  <a:pt x="4833253" y="6040435"/>
                </a:lnTo>
                <a:close/>
                <a:moveTo>
                  <a:pt x="4619279" y="6040435"/>
                </a:moveTo>
                <a:lnTo>
                  <a:pt x="4619279" y="6111736"/>
                </a:lnTo>
                <a:lnTo>
                  <a:pt x="4690580" y="6111736"/>
                </a:lnTo>
                <a:lnTo>
                  <a:pt x="4690580" y="6040435"/>
                </a:lnTo>
                <a:close/>
                <a:moveTo>
                  <a:pt x="4476678" y="6040435"/>
                </a:moveTo>
                <a:lnTo>
                  <a:pt x="4476678" y="6111736"/>
                </a:lnTo>
                <a:lnTo>
                  <a:pt x="4547979" y="6111736"/>
                </a:lnTo>
                <a:lnTo>
                  <a:pt x="4547979" y="6040435"/>
                </a:lnTo>
                <a:close/>
                <a:moveTo>
                  <a:pt x="4334005" y="6040435"/>
                </a:moveTo>
                <a:lnTo>
                  <a:pt x="4334005" y="6111736"/>
                </a:lnTo>
                <a:lnTo>
                  <a:pt x="4405306" y="6111736"/>
                </a:lnTo>
                <a:lnTo>
                  <a:pt x="4405306" y="6040435"/>
                </a:lnTo>
                <a:close/>
                <a:moveTo>
                  <a:pt x="4191404" y="6040435"/>
                </a:moveTo>
                <a:lnTo>
                  <a:pt x="4191404" y="6111736"/>
                </a:lnTo>
                <a:lnTo>
                  <a:pt x="4262705" y="6111736"/>
                </a:lnTo>
                <a:lnTo>
                  <a:pt x="4262705" y="6040435"/>
                </a:lnTo>
                <a:close/>
                <a:moveTo>
                  <a:pt x="4048731" y="6040435"/>
                </a:moveTo>
                <a:lnTo>
                  <a:pt x="4048731" y="6111736"/>
                </a:lnTo>
                <a:lnTo>
                  <a:pt x="4120032" y="6111736"/>
                </a:lnTo>
                <a:lnTo>
                  <a:pt x="4120032" y="6040435"/>
                </a:lnTo>
                <a:close/>
                <a:moveTo>
                  <a:pt x="3906059" y="6040435"/>
                </a:moveTo>
                <a:lnTo>
                  <a:pt x="3906059" y="6111736"/>
                </a:lnTo>
                <a:lnTo>
                  <a:pt x="3977360" y="6111736"/>
                </a:lnTo>
                <a:lnTo>
                  <a:pt x="3977360" y="6040435"/>
                </a:lnTo>
                <a:close/>
                <a:moveTo>
                  <a:pt x="3763457" y="6040435"/>
                </a:moveTo>
                <a:lnTo>
                  <a:pt x="3763457" y="6111736"/>
                </a:lnTo>
                <a:lnTo>
                  <a:pt x="3834758" y="6111736"/>
                </a:lnTo>
                <a:lnTo>
                  <a:pt x="3834758" y="6040435"/>
                </a:lnTo>
                <a:close/>
                <a:moveTo>
                  <a:pt x="3620784" y="6040435"/>
                </a:moveTo>
                <a:lnTo>
                  <a:pt x="3620784" y="6111736"/>
                </a:lnTo>
                <a:lnTo>
                  <a:pt x="3692085" y="6111736"/>
                </a:lnTo>
                <a:lnTo>
                  <a:pt x="3692085" y="6040435"/>
                </a:lnTo>
                <a:close/>
                <a:moveTo>
                  <a:pt x="3478184" y="6040435"/>
                </a:moveTo>
                <a:lnTo>
                  <a:pt x="3478184" y="6111736"/>
                </a:lnTo>
                <a:lnTo>
                  <a:pt x="3549484" y="6111736"/>
                </a:lnTo>
                <a:lnTo>
                  <a:pt x="3549484" y="6040435"/>
                </a:lnTo>
                <a:close/>
                <a:moveTo>
                  <a:pt x="3335511" y="6040435"/>
                </a:moveTo>
                <a:lnTo>
                  <a:pt x="3335511" y="6111736"/>
                </a:lnTo>
                <a:lnTo>
                  <a:pt x="3406811" y="6111736"/>
                </a:lnTo>
                <a:lnTo>
                  <a:pt x="3406811" y="6040435"/>
                </a:lnTo>
                <a:close/>
                <a:moveTo>
                  <a:pt x="3192839" y="6040435"/>
                </a:moveTo>
                <a:lnTo>
                  <a:pt x="3192839" y="6111736"/>
                </a:lnTo>
                <a:lnTo>
                  <a:pt x="3264139" y="6111736"/>
                </a:lnTo>
                <a:lnTo>
                  <a:pt x="3264139" y="6040435"/>
                </a:lnTo>
                <a:close/>
                <a:moveTo>
                  <a:pt x="3050237" y="6040435"/>
                </a:moveTo>
                <a:lnTo>
                  <a:pt x="3050237" y="6111736"/>
                </a:lnTo>
                <a:lnTo>
                  <a:pt x="3121537" y="6111736"/>
                </a:lnTo>
                <a:lnTo>
                  <a:pt x="3121537" y="6040435"/>
                </a:lnTo>
                <a:close/>
                <a:moveTo>
                  <a:pt x="2907564" y="6040435"/>
                </a:moveTo>
                <a:lnTo>
                  <a:pt x="2907564" y="6111736"/>
                </a:lnTo>
                <a:lnTo>
                  <a:pt x="2978865" y="6111736"/>
                </a:lnTo>
                <a:lnTo>
                  <a:pt x="2978865" y="6040435"/>
                </a:lnTo>
                <a:close/>
                <a:moveTo>
                  <a:pt x="2764962" y="6040435"/>
                </a:moveTo>
                <a:lnTo>
                  <a:pt x="2764962" y="6111736"/>
                </a:lnTo>
                <a:lnTo>
                  <a:pt x="2836263" y="6111736"/>
                </a:lnTo>
                <a:lnTo>
                  <a:pt x="2836263" y="6040435"/>
                </a:lnTo>
                <a:close/>
                <a:moveTo>
                  <a:pt x="2622291" y="6040435"/>
                </a:moveTo>
                <a:lnTo>
                  <a:pt x="2622291" y="6111736"/>
                </a:lnTo>
                <a:lnTo>
                  <a:pt x="2693591" y="6111736"/>
                </a:lnTo>
                <a:lnTo>
                  <a:pt x="2693591" y="6040435"/>
                </a:lnTo>
                <a:close/>
                <a:moveTo>
                  <a:pt x="2479688" y="6040435"/>
                </a:moveTo>
                <a:lnTo>
                  <a:pt x="2479688" y="6111736"/>
                </a:lnTo>
                <a:lnTo>
                  <a:pt x="2550990" y="6111736"/>
                </a:lnTo>
                <a:lnTo>
                  <a:pt x="2550990" y="6040435"/>
                </a:lnTo>
                <a:close/>
                <a:moveTo>
                  <a:pt x="2337016" y="6040435"/>
                </a:moveTo>
                <a:lnTo>
                  <a:pt x="2337016" y="6111736"/>
                </a:lnTo>
                <a:lnTo>
                  <a:pt x="2408317" y="6111736"/>
                </a:lnTo>
                <a:lnTo>
                  <a:pt x="2408317" y="6040435"/>
                </a:lnTo>
                <a:close/>
                <a:moveTo>
                  <a:pt x="2195429" y="6040435"/>
                </a:moveTo>
                <a:lnTo>
                  <a:pt x="2195429" y="6111736"/>
                </a:lnTo>
                <a:lnTo>
                  <a:pt x="2266731" y="6111736"/>
                </a:lnTo>
                <a:lnTo>
                  <a:pt x="2266731" y="6040435"/>
                </a:lnTo>
                <a:close/>
                <a:moveTo>
                  <a:pt x="2052828" y="6040435"/>
                </a:moveTo>
                <a:lnTo>
                  <a:pt x="2052828" y="6111736"/>
                </a:lnTo>
                <a:lnTo>
                  <a:pt x="2124128" y="6111736"/>
                </a:lnTo>
                <a:lnTo>
                  <a:pt x="2124128" y="6040435"/>
                </a:lnTo>
                <a:close/>
                <a:moveTo>
                  <a:pt x="1910155" y="6040435"/>
                </a:moveTo>
                <a:lnTo>
                  <a:pt x="1910155" y="6111736"/>
                </a:lnTo>
                <a:lnTo>
                  <a:pt x="1981455" y="6111736"/>
                </a:lnTo>
                <a:lnTo>
                  <a:pt x="1981455" y="6040435"/>
                </a:lnTo>
                <a:close/>
                <a:moveTo>
                  <a:pt x="1767483" y="6040435"/>
                </a:moveTo>
                <a:lnTo>
                  <a:pt x="1767483" y="6111736"/>
                </a:lnTo>
                <a:lnTo>
                  <a:pt x="1838783" y="6111736"/>
                </a:lnTo>
                <a:lnTo>
                  <a:pt x="1838783" y="6040435"/>
                </a:lnTo>
                <a:close/>
                <a:moveTo>
                  <a:pt x="1624882" y="6040435"/>
                </a:moveTo>
                <a:lnTo>
                  <a:pt x="1624882" y="6111736"/>
                </a:lnTo>
                <a:lnTo>
                  <a:pt x="1696183" y="6111736"/>
                </a:lnTo>
                <a:lnTo>
                  <a:pt x="1696183" y="6040435"/>
                </a:lnTo>
                <a:close/>
                <a:moveTo>
                  <a:pt x="1482218" y="6040435"/>
                </a:moveTo>
                <a:lnTo>
                  <a:pt x="1482218" y="6111736"/>
                </a:lnTo>
                <a:lnTo>
                  <a:pt x="1553511" y="6111736"/>
                </a:lnTo>
                <a:lnTo>
                  <a:pt x="1553511" y="6040435"/>
                </a:lnTo>
                <a:close/>
                <a:moveTo>
                  <a:pt x="1339621" y="6040435"/>
                </a:moveTo>
                <a:lnTo>
                  <a:pt x="1339621" y="6111736"/>
                </a:lnTo>
                <a:lnTo>
                  <a:pt x="1410920" y="6111736"/>
                </a:lnTo>
                <a:lnTo>
                  <a:pt x="1410920" y="6040435"/>
                </a:lnTo>
                <a:close/>
                <a:moveTo>
                  <a:pt x="1196948" y="6040435"/>
                </a:moveTo>
                <a:lnTo>
                  <a:pt x="1196948" y="6111736"/>
                </a:lnTo>
                <a:lnTo>
                  <a:pt x="1268245" y="6111736"/>
                </a:lnTo>
                <a:lnTo>
                  <a:pt x="1268245" y="6040435"/>
                </a:lnTo>
                <a:close/>
                <a:moveTo>
                  <a:pt x="1054277" y="6040435"/>
                </a:moveTo>
                <a:lnTo>
                  <a:pt x="1054277" y="6111736"/>
                </a:lnTo>
                <a:lnTo>
                  <a:pt x="1125575" y="6111736"/>
                </a:lnTo>
                <a:lnTo>
                  <a:pt x="1125575" y="6040435"/>
                </a:lnTo>
                <a:close/>
                <a:moveTo>
                  <a:pt x="911663" y="6040435"/>
                </a:moveTo>
                <a:lnTo>
                  <a:pt x="911663" y="6111736"/>
                </a:lnTo>
                <a:lnTo>
                  <a:pt x="982964" y="6111736"/>
                </a:lnTo>
                <a:lnTo>
                  <a:pt x="982964" y="6040435"/>
                </a:lnTo>
                <a:close/>
                <a:moveTo>
                  <a:pt x="6857645" y="0"/>
                </a:moveTo>
                <a:lnTo>
                  <a:pt x="9497977" y="0"/>
                </a:lnTo>
                <a:lnTo>
                  <a:pt x="9497977" y="6857968"/>
                </a:lnTo>
                <a:lnTo>
                  <a:pt x="0" y="6857968"/>
                </a:lnTo>
                <a:lnTo>
                  <a:pt x="341118" y="6516838"/>
                </a:lnTo>
                <a:lnTo>
                  <a:pt x="341118" y="6545648"/>
                </a:lnTo>
                <a:lnTo>
                  <a:pt x="412416" y="6545648"/>
                </a:lnTo>
                <a:lnTo>
                  <a:pt x="412416" y="6474347"/>
                </a:lnTo>
                <a:lnTo>
                  <a:pt x="383607" y="6474347"/>
                </a:lnTo>
                <a:lnTo>
                  <a:pt x="483718" y="6374231"/>
                </a:lnTo>
                <a:lnTo>
                  <a:pt x="483718" y="6397010"/>
                </a:lnTo>
                <a:lnTo>
                  <a:pt x="555020" y="6397010"/>
                </a:lnTo>
                <a:lnTo>
                  <a:pt x="555020" y="6325709"/>
                </a:lnTo>
                <a:lnTo>
                  <a:pt x="532239" y="6325709"/>
                </a:lnTo>
                <a:lnTo>
                  <a:pt x="626392" y="6231552"/>
                </a:lnTo>
                <a:lnTo>
                  <a:pt x="626392" y="6254408"/>
                </a:lnTo>
                <a:lnTo>
                  <a:pt x="697691" y="6254408"/>
                </a:lnTo>
                <a:lnTo>
                  <a:pt x="697691" y="6183107"/>
                </a:lnTo>
                <a:lnTo>
                  <a:pt x="674833" y="6183107"/>
                </a:lnTo>
                <a:lnTo>
                  <a:pt x="769001" y="6088935"/>
                </a:lnTo>
                <a:lnTo>
                  <a:pt x="769001" y="6111736"/>
                </a:lnTo>
                <a:lnTo>
                  <a:pt x="840303" y="6111736"/>
                </a:lnTo>
                <a:lnTo>
                  <a:pt x="840303" y="6040435"/>
                </a:lnTo>
                <a:lnTo>
                  <a:pt x="817496" y="6040435"/>
                </a:lnTo>
                <a:close/>
              </a:path>
            </a:pathLst>
          </a:custGeom>
          <a:solidFill>
            <a:srgbClr val="0C2074">
              <a:alpha val="12941"/>
            </a:srgbClr>
          </a:solidFill>
          <a:ln>
            <a:noFill/>
          </a:ln>
        </p:spPr>
        <p:txBody>
          <a:bodyPr wrap="square">
            <a:no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en-US"/>
              <a:t> </a:t>
            </a:r>
          </a:p>
        </p:txBody>
      </p:sp>
      <p:sp>
        <p:nvSpPr>
          <p:cNvPr id="2" name="Titel 1">
            <a:extLst>
              <a:ext uri="{FF2B5EF4-FFF2-40B4-BE49-F238E27FC236}">
                <a16:creationId xmlns:a16="http://schemas.microsoft.com/office/drawing/2014/main" id="{4E5C8C94-6483-5F44-A214-6BBE58E30B33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513358" y="313067"/>
            <a:ext cx="7744488" cy="2387600"/>
          </a:xfrm>
        </p:spPr>
        <p:txBody>
          <a:bodyPr anchor="b">
            <a:noAutofit/>
          </a:bodyPr>
          <a:lstStyle>
            <a:lvl1pPr algn="l">
              <a:defRPr sz="4875">
                <a:solidFill>
                  <a:schemeClr val="accent1"/>
                </a:solidFill>
              </a:defRPr>
            </a:lvl1pPr>
          </a:lstStyle>
          <a:p>
            <a:r>
              <a:rPr lang="nl-NL"/>
              <a:t>Voeg titel toe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D28D2045-79CC-614D-BA13-696E7AAAEE4A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513358" y="2876824"/>
            <a:ext cx="7744488" cy="1655762"/>
          </a:xfrm>
        </p:spPr>
        <p:txBody>
          <a:bodyPr/>
          <a:lstStyle>
            <a:lvl1pPr marL="0" indent="0" algn="l">
              <a:buNone/>
              <a:defRPr sz="195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75" indent="0" algn="ctr">
              <a:buNone/>
              <a:defRPr sz="1625"/>
            </a:lvl2pPr>
            <a:lvl3pPr marL="742950" indent="0" algn="ctr">
              <a:buNone/>
              <a:defRPr sz="1463"/>
            </a:lvl3pPr>
            <a:lvl4pPr marL="1114425" indent="0" algn="ctr">
              <a:buNone/>
              <a:defRPr sz="1300"/>
            </a:lvl4pPr>
            <a:lvl5pPr marL="1485900" indent="0" algn="ctr">
              <a:buNone/>
              <a:defRPr sz="1300"/>
            </a:lvl5pPr>
            <a:lvl6pPr marL="1857375" indent="0" algn="ctr">
              <a:buNone/>
              <a:defRPr sz="1300"/>
            </a:lvl6pPr>
            <a:lvl7pPr marL="2228850" indent="0" algn="ctr">
              <a:buNone/>
              <a:defRPr sz="1300"/>
            </a:lvl7pPr>
            <a:lvl8pPr marL="2600325" indent="0" algn="ctr">
              <a:buNone/>
              <a:defRPr sz="1300"/>
            </a:lvl8pPr>
            <a:lvl9pPr marL="2971800" indent="0" algn="ctr">
              <a:buNone/>
              <a:defRPr sz="1300"/>
            </a:lvl9pPr>
          </a:lstStyle>
          <a:p>
            <a:r>
              <a:rPr lang="nl-NL"/>
              <a:t>Voeg ondertitel toe</a:t>
            </a:r>
          </a:p>
        </p:txBody>
      </p:sp>
      <p:sp>
        <p:nvSpPr>
          <p:cNvPr id="29" name="Freeform: Shape 28">
            <a:extLst>
              <a:ext uri="{FF2B5EF4-FFF2-40B4-BE49-F238E27FC236}">
                <a16:creationId xmlns:a16="http://schemas.microsoft.com/office/drawing/2014/main" id="{7CFB27A8-9C4A-461D-9970-77857B17D290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0" name="Freeform: Shape 29">
            <a:extLst>
              <a:ext uri="{FF2B5EF4-FFF2-40B4-BE49-F238E27FC236}">
                <a16:creationId xmlns:a16="http://schemas.microsoft.com/office/drawing/2014/main" id="{DB080469-7312-4D9A-97F8-76CC0D697DCA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1" name="Freeform: Shape 30">
            <a:extLst>
              <a:ext uri="{FF2B5EF4-FFF2-40B4-BE49-F238E27FC236}">
                <a16:creationId xmlns:a16="http://schemas.microsoft.com/office/drawing/2014/main" id="{1917E6CC-D4C4-4A9E-961D-0B948335C1D5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2" name="Freeform: Shape 31">
            <a:extLst>
              <a:ext uri="{FF2B5EF4-FFF2-40B4-BE49-F238E27FC236}">
                <a16:creationId xmlns:a16="http://schemas.microsoft.com/office/drawing/2014/main" id="{E0CC0964-109E-4724-9CBD-9C5E8E1259E3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3" name="Freeform: Shape 32">
            <a:extLst>
              <a:ext uri="{FF2B5EF4-FFF2-40B4-BE49-F238E27FC236}">
                <a16:creationId xmlns:a16="http://schemas.microsoft.com/office/drawing/2014/main" id="{BAA75C3C-7293-4F05-A284-5A879C55898D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4" name="Freeform: Shape 33">
            <a:extLst>
              <a:ext uri="{FF2B5EF4-FFF2-40B4-BE49-F238E27FC236}">
                <a16:creationId xmlns:a16="http://schemas.microsoft.com/office/drawing/2014/main" id="{32BC5C39-F12F-4182-BF69-2195D6B83D83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5" name="Freeform: Shape 34">
            <a:extLst>
              <a:ext uri="{FF2B5EF4-FFF2-40B4-BE49-F238E27FC236}">
                <a16:creationId xmlns:a16="http://schemas.microsoft.com/office/drawing/2014/main" id="{E586304D-0D32-4355-AFB8-EE1B95429126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6" name="Freeform: Shape 35">
            <a:extLst>
              <a:ext uri="{FF2B5EF4-FFF2-40B4-BE49-F238E27FC236}">
                <a16:creationId xmlns:a16="http://schemas.microsoft.com/office/drawing/2014/main" id="{E46081E0-F5F3-471B-BD58-FAE737F9B87D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7" name="Freeform: Shape 36">
            <a:extLst>
              <a:ext uri="{FF2B5EF4-FFF2-40B4-BE49-F238E27FC236}">
                <a16:creationId xmlns:a16="http://schemas.microsoft.com/office/drawing/2014/main" id="{4977F8C8-F8D3-467D-ADC4-D72F1CD86B0D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8" name="Freeform: Shape 37">
            <a:extLst>
              <a:ext uri="{FF2B5EF4-FFF2-40B4-BE49-F238E27FC236}">
                <a16:creationId xmlns:a16="http://schemas.microsoft.com/office/drawing/2014/main" id="{ADF03386-67A2-4DA1-933B-68ACD7DB7263}"/>
              </a:ext>
            </a:extLst>
          </p:cNvPr>
          <p:cNvSpPr/>
          <p:nvPr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19" name="Date Placeholder 3">
            <a:extLst>
              <a:ext uri="{FF2B5EF4-FFF2-40B4-BE49-F238E27FC236}">
                <a16:creationId xmlns:a16="http://schemas.microsoft.com/office/drawing/2014/main" id="{29DD2B6B-C0F3-41B0-A2D9-6E3EF76A5C8A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513358" y="7165953"/>
            <a:ext cx="676085" cy="179921"/>
          </a:xfrm>
        </p:spPr>
        <p:txBody>
          <a:bodyPr/>
          <a:lstStyle/>
          <a:p>
            <a:fld id="{4FC09DFC-B8F8-4958-9D34-83C08EAA181D}" type="datetime1">
              <a:rPr lang="en-GB" smtClean="0"/>
              <a:t>26/01/2023</a:t>
            </a:fld>
            <a:endParaRPr lang="en-GB"/>
          </a:p>
        </p:txBody>
      </p:sp>
      <p:sp>
        <p:nvSpPr>
          <p:cNvPr id="20" name="Footer Placeholder 4">
            <a:extLst>
              <a:ext uri="{FF2B5EF4-FFF2-40B4-BE49-F238E27FC236}">
                <a16:creationId xmlns:a16="http://schemas.microsoft.com/office/drawing/2014/main" id="{F758635A-2F43-40A4-AC11-905BFDC31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1269414" y="7165952"/>
            <a:ext cx="7064081" cy="179921"/>
          </a:xfrm>
        </p:spPr>
        <p:txBody>
          <a:bodyPr/>
          <a:lstStyle/>
          <a:p>
            <a:endParaRPr lang="en-GB"/>
          </a:p>
        </p:txBody>
      </p:sp>
      <p:sp>
        <p:nvSpPr>
          <p:cNvPr id="21" name="Slide Number Placeholder 5">
            <a:extLst>
              <a:ext uri="{FF2B5EF4-FFF2-40B4-BE49-F238E27FC236}">
                <a16:creationId xmlns:a16="http://schemas.microsoft.com/office/drawing/2014/main" id="{E68BCCDE-037F-4221-9C3C-8648B1A6C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413467" y="7165954"/>
            <a:ext cx="394875" cy="179921"/>
          </a:xfrm>
        </p:spPr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446" name="Text Placeholder 2059">
            <a:extLst>
              <a:ext uri="{FF2B5EF4-FFF2-40B4-BE49-F238E27FC236}">
                <a16:creationId xmlns:a16="http://schemas.microsoft.com/office/drawing/2014/main" id="{B4005224-3F47-4576-9D58-87DDA0FD3DB5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8384164" y="6026150"/>
            <a:ext cx="1272897" cy="617539"/>
          </a:xfrm>
          <a:blipFill dpi="0"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r>
              <a:rPr lang="en-US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936893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dia met afbeelding (alternatief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Picture Placeholder 647">
            <a:extLst>
              <a:ext uri="{FF2B5EF4-FFF2-40B4-BE49-F238E27FC236}">
                <a16:creationId xmlns:a16="http://schemas.microsoft.com/office/drawing/2014/main" id="{34E9255F-4BD2-4449-A3CE-FB90ADC96F74}"/>
              </a:ext>
            </a:extLst>
          </p:cNvPr>
          <p:cNvSpPr>
            <a:spLocks noGrp="1"/>
          </p:cNvSpPr>
          <p:nvPr>
            <p:ph type="pic" sz="quarter" idx="16" hasCustomPrompt="1"/>
          </p:nvPr>
        </p:nvSpPr>
        <p:spPr bwMode="auto">
          <a:xfrm>
            <a:off x="4373557" y="51490"/>
            <a:ext cx="5532445" cy="6806511"/>
          </a:xfrm>
          <a:custGeom>
            <a:avLst/>
            <a:gdLst>
              <a:gd name="connsiteX0" fmla="*/ 3659391 w 6809163"/>
              <a:gd name="connsiteY0" fmla="*/ 6443281 h 6826901"/>
              <a:gd name="connsiteX1" fmla="*/ 3659391 w 6809163"/>
              <a:gd name="connsiteY1" fmla="*/ 6514582 h 6826901"/>
              <a:gd name="connsiteX2" fmla="*/ 3730692 w 6809163"/>
              <a:gd name="connsiteY2" fmla="*/ 6514582 h 6826901"/>
              <a:gd name="connsiteX3" fmla="*/ 3730692 w 6809163"/>
              <a:gd name="connsiteY3" fmla="*/ 6443281 h 6826901"/>
              <a:gd name="connsiteX4" fmla="*/ 3516789 w 6809163"/>
              <a:gd name="connsiteY4" fmla="*/ 6443281 h 6826901"/>
              <a:gd name="connsiteX5" fmla="*/ 3516789 w 6809163"/>
              <a:gd name="connsiteY5" fmla="*/ 6514582 h 6826901"/>
              <a:gd name="connsiteX6" fmla="*/ 3588090 w 6809163"/>
              <a:gd name="connsiteY6" fmla="*/ 6514582 h 6826901"/>
              <a:gd name="connsiteX7" fmla="*/ 3588090 w 6809163"/>
              <a:gd name="connsiteY7" fmla="*/ 6443281 h 6826901"/>
              <a:gd name="connsiteX8" fmla="*/ 3374117 w 6809163"/>
              <a:gd name="connsiteY8" fmla="*/ 6443281 h 6826901"/>
              <a:gd name="connsiteX9" fmla="*/ 3374117 w 6809163"/>
              <a:gd name="connsiteY9" fmla="*/ 6514582 h 6826901"/>
              <a:gd name="connsiteX10" fmla="*/ 3445417 w 6809163"/>
              <a:gd name="connsiteY10" fmla="*/ 6514582 h 6826901"/>
              <a:gd name="connsiteX11" fmla="*/ 3445417 w 6809163"/>
              <a:gd name="connsiteY11" fmla="*/ 6443281 h 6826901"/>
              <a:gd name="connsiteX12" fmla="*/ 3231444 w 6809163"/>
              <a:gd name="connsiteY12" fmla="*/ 6443281 h 6826901"/>
              <a:gd name="connsiteX13" fmla="*/ 3231444 w 6809163"/>
              <a:gd name="connsiteY13" fmla="*/ 6514582 h 6826901"/>
              <a:gd name="connsiteX14" fmla="*/ 3302745 w 6809163"/>
              <a:gd name="connsiteY14" fmla="*/ 6514582 h 6826901"/>
              <a:gd name="connsiteX15" fmla="*/ 3302745 w 6809163"/>
              <a:gd name="connsiteY15" fmla="*/ 6443281 h 6826901"/>
              <a:gd name="connsiteX16" fmla="*/ 3088843 w 6809163"/>
              <a:gd name="connsiteY16" fmla="*/ 6443281 h 6826901"/>
              <a:gd name="connsiteX17" fmla="*/ 3088843 w 6809163"/>
              <a:gd name="connsiteY17" fmla="*/ 6514582 h 6826901"/>
              <a:gd name="connsiteX18" fmla="*/ 3160144 w 6809163"/>
              <a:gd name="connsiteY18" fmla="*/ 6514582 h 6826901"/>
              <a:gd name="connsiteX19" fmla="*/ 3160144 w 6809163"/>
              <a:gd name="connsiteY19" fmla="*/ 6443281 h 6826901"/>
              <a:gd name="connsiteX20" fmla="*/ 2946170 w 6809163"/>
              <a:gd name="connsiteY20" fmla="*/ 6443281 h 6826901"/>
              <a:gd name="connsiteX21" fmla="*/ 2946170 w 6809163"/>
              <a:gd name="connsiteY21" fmla="*/ 6514582 h 6826901"/>
              <a:gd name="connsiteX22" fmla="*/ 3017471 w 6809163"/>
              <a:gd name="connsiteY22" fmla="*/ 6514582 h 6826901"/>
              <a:gd name="connsiteX23" fmla="*/ 3017471 w 6809163"/>
              <a:gd name="connsiteY23" fmla="*/ 6443281 h 6826901"/>
              <a:gd name="connsiteX24" fmla="*/ 2803569 w 6809163"/>
              <a:gd name="connsiteY24" fmla="*/ 6443281 h 6826901"/>
              <a:gd name="connsiteX25" fmla="*/ 2803569 w 6809163"/>
              <a:gd name="connsiteY25" fmla="*/ 6514582 h 6826901"/>
              <a:gd name="connsiteX26" fmla="*/ 2874870 w 6809163"/>
              <a:gd name="connsiteY26" fmla="*/ 6514582 h 6826901"/>
              <a:gd name="connsiteX27" fmla="*/ 2874870 w 6809163"/>
              <a:gd name="connsiteY27" fmla="*/ 6443281 h 6826901"/>
              <a:gd name="connsiteX28" fmla="*/ 2660896 w 6809163"/>
              <a:gd name="connsiteY28" fmla="*/ 6443281 h 6826901"/>
              <a:gd name="connsiteX29" fmla="*/ 2660896 w 6809163"/>
              <a:gd name="connsiteY29" fmla="*/ 6514582 h 6826901"/>
              <a:gd name="connsiteX30" fmla="*/ 2732197 w 6809163"/>
              <a:gd name="connsiteY30" fmla="*/ 6514582 h 6826901"/>
              <a:gd name="connsiteX31" fmla="*/ 2732197 w 6809163"/>
              <a:gd name="connsiteY31" fmla="*/ 6443281 h 6826901"/>
              <a:gd name="connsiteX32" fmla="*/ 2518224 w 6809163"/>
              <a:gd name="connsiteY32" fmla="*/ 6443281 h 6826901"/>
              <a:gd name="connsiteX33" fmla="*/ 2518224 w 6809163"/>
              <a:gd name="connsiteY33" fmla="*/ 6514582 h 6826901"/>
              <a:gd name="connsiteX34" fmla="*/ 2589525 w 6809163"/>
              <a:gd name="connsiteY34" fmla="*/ 6514582 h 6826901"/>
              <a:gd name="connsiteX35" fmla="*/ 2589525 w 6809163"/>
              <a:gd name="connsiteY35" fmla="*/ 6443281 h 6826901"/>
              <a:gd name="connsiteX36" fmla="*/ 2375622 w 6809163"/>
              <a:gd name="connsiteY36" fmla="*/ 6443281 h 6826901"/>
              <a:gd name="connsiteX37" fmla="*/ 2375622 w 6809163"/>
              <a:gd name="connsiteY37" fmla="*/ 6514582 h 6826901"/>
              <a:gd name="connsiteX38" fmla="*/ 2446923 w 6809163"/>
              <a:gd name="connsiteY38" fmla="*/ 6514582 h 6826901"/>
              <a:gd name="connsiteX39" fmla="*/ 2446923 w 6809163"/>
              <a:gd name="connsiteY39" fmla="*/ 6443281 h 6826901"/>
              <a:gd name="connsiteX40" fmla="*/ 2232949 w 6809163"/>
              <a:gd name="connsiteY40" fmla="*/ 6443281 h 6826901"/>
              <a:gd name="connsiteX41" fmla="*/ 2232949 w 6809163"/>
              <a:gd name="connsiteY41" fmla="*/ 6514582 h 6826901"/>
              <a:gd name="connsiteX42" fmla="*/ 2304250 w 6809163"/>
              <a:gd name="connsiteY42" fmla="*/ 6514582 h 6826901"/>
              <a:gd name="connsiteX43" fmla="*/ 2304250 w 6809163"/>
              <a:gd name="connsiteY43" fmla="*/ 6443281 h 6826901"/>
              <a:gd name="connsiteX44" fmla="*/ 2090348 w 6809163"/>
              <a:gd name="connsiteY44" fmla="*/ 6443281 h 6826901"/>
              <a:gd name="connsiteX45" fmla="*/ 2090348 w 6809163"/>
              <a:gd name="connsiteY45" fmla="*/ 6514582 h 6826901"/>
              <a:gd name="connsiteX46" fmla="*/ 2161649 w 6809163"/>
              <a:gd name="connsiteY46" fmla="*/ 6514582 h 6826901"/>
              <a:gd name="connsiteX47" fmla="*/ 2161649 w 6809163"/>
              <a:gd name="connsiteY47" fmla="*/ 6443281 h 6826901"/>
              <a:gd name="connsiteX48" fmla="*/ 1947675 w 6809163"/>
              <a:gd name="connsiteY48" fmla="*/ 6443281 h 6826901"/>
              <a:gd name="connsiteX49" fmla="*/ 1947675 w 6809163"/>
              <a:gd name="connsiteY49" fmla="*/ 6514582 h 6826901"/>
              <a:gd name="connsiteX50" fmla="*/ 2018976 w 6809163"/>
              <a:gd name="connsiteY50" fmla="*/ 6514582 h 6826901"/>
              <a:gd name="connsiteX51" fmla="*/ 2018976 w 6809163"/>
              <a:gd name="connsiteY51" fmla="*/ 6443281 h 6826901"/>
              <a:gd name="connsiteX52" fmla="*/ 1805074 w 6809163"/>
              <a:gd name="connsiteY52" fmla="*/ 6443281 h 6826901"/>
              <a:gd name="connsiteX53" fmla="*/ 1805074 w 6809163"/>
              <a:gd name="connsiteY53" fmla="*/ 6514582 h 6826901"/>
              <a:gd name="connsiteX54" fmla="*/ 1876375 w 6809163"/>
              <a:gd name="connsiteY54" fmla="*/ 6514582 h 6826901"/>
              <a:gd name="connsiteX55" fmla="*/ 1876375 w 6809163"/>
              <a:gd name="connsiteY55" fmla="*/ 6443281 h 6826901"/>
              <a:gd name="connsiteX56" fmla="*/ 1662401 w 6809163"/>
              <a:gd name="connsiteY56" fmla="*/ 6443281 h 6826901"/>
              <a:gd name="connsiteX57" fmla="*/ 1662401 w 6809163"/>
              <a:gd name="connsiteY57" fmla="*/ 6514582 h 6826901"/>
              <a:gd name="connsiteX58" fmla="*/ 1733702 w 6809163"/>
              <a:gd name="connsiteY58" fmla="*/ 6514582 h 6826901"/>
              <a:gd name="connsiteX59" fmla="*/ 1733702 w 6809163"/>
              <a:gd name="connsiteY59" fmla="*/ 6443281 h 6826901"/>
              <a:gd name="connsiteX60" fmla="*/ 1519800 w 6809163"/>
              <a:gd name="connsiteY60" fmla="*/ 6443281 h 6826901"/>
              <a:gd name="connsiteX61" fmla="*/ 1519800 w 6809163"/>
              <a:gd name="connsiteY61" fmla="*/ 6514582 h 6826901"/>
              <a:gd name="connsiteX62" fmla="*/ 1591101 w 6809163"/>
              <a:gd name="connsiteY62" fmla="*/ 6514582 h 6826901"/>
              <a:gd name="connsiteX63" fmla="*/ 1591101 w 6809163"/>
              <a:gd name="connsiteY63" fmla="*/ 6443281 h 6826901"/>
              <a:gd name="connsiteX64" fmla="*/ 1377127 w 6809163"/>
              <a:gd name="connsiteY64" fmla="*/ 6443281 h 6826901"/>
              <a:gd name="connsiteX65" fmla="*/ 1377127 w 6809163"/>
              <a:gd name="connsiteY65" fmla="*/ 6514582 h 6826901"/>
              <a:gd name="connsiteX66" fmla="*/ 1448428 w 6809163"/>
              <a:gd name="connsiteY66" fmla="*/ 6514582 h 6826901"/>
              <a:gd name="connsiteX67" fmla="*/ 1448428 w 6809163"/>
              <a:gd name="connsiteY67" fmla="*/ 6443281 h 6826901"/>
              <a:gd name="connsiteX68" fmla="*/ 1234455 w 6809163"/>
              <a:gd name="connsiteY68" fmla="*/ 6443281 h 6826901"/>
              <a:gd name="connsiteX69" fmla="*/ 1234455 w 6809163"/>
              <a:gd name="connsiteY69" fmla="*/ 6514582 h 6826901"/>
              <a:gd name="connsiteX70" fmla="*/ 1305756 w 6809163"/>
              <a:gd name="connsiteY70" fmla="*/ 6514582 h 6826901"/>
              <a:gd name="connsiteX71" fmla="*/ 1305756 w 6809163"/>
              <a:gd name="connsiteY71" fmla="*/ 6443281 h 6826901"/>
              <a:gd name="connsiteX72" fmla="*/ 1091853 w 6809163"/>
              <a:gd name="connsiteY72" fmla="*/ 6443281 h 6826901"/>
              <a:gd name="connsiteX73" fmla="*/ 1091853 w 6809163"/>
              <a:gd name="connsiteY73" fmla="*/ 6514582 h 6826901"/>
              <a:gd name="connsiteX74" fmla="*/ 1163154 w 6809163"/>
              <a:gd name="connsiteY74" fmla="*/ 6514582 h 6826901"/>
              <a:gd name="connsiteX75" fmla="*/ 1163154 w 6809163"/>
              <a:gd name="connsiteY75" fmla="*/ 6443281 h 6826901"/>
              <a:gd name="connsiteX76" fmla="*/ 949180 w 6809163"/>
              <a:gd name="connsiteY76" fmla="*/ 6443281 h 6826901"/>
              <a:gd name="connsiteX77" fmla="*/ 949180 w 6809163"/>
              <a:gd name="connsiteY77" fmla="*/ 6514582 h 6826901"/>
              <a:gd name="connsiteX78" fmla="*/ 1020481 w 6809163"/>
              <a:gd name="connsiteY78" fmla="*/ 6514582 h 6826901"/>
              <a:gd name="connsiteX79" fmla="*/ 1020481 w 6809163"/>
              <a:gd name="connsiteY79" fmla="*/ 6443281 h 6826901"/>
              <a:gd name="connsiteX80" fmla="*/ 806579 w 6809163"/>
              <a:gd name="connsiteY80" fmla="*/ 6443281 h 6826901"/>
              <a:gd name="connsiteX81" fmla="*/ 806579 w 6809163"/>
              <a:gd name="connsiteY81" fmla="*/ 6514582 h 6826901"/>
              <a:gd name="connsiteX82" fmla="*/ 877880 w 6809163"/>
              <a:gd name="connsiteY82" fmla="*/ 6514582 h 6826901"/>
              <a:gd name="connsiteX83" fmla="*/ 877880 w 6809163"/>
              <a:gd name="connsiteY83" fmla="*/ 6443281 h 6826901"/>
              <a:gd name="connsiteX84" fmla="*/ 663906 w 6809163"/>
              <a:gd name="connsiteY84" fmla="*/ 6443281 h 6826901"/>
              <a:gd name="connsiteX85" fmla="*/ 663906 w 6809163"/>
              <a:gd name="connsiteY85" fmla="*/ 6514582 h 6826901"/>
              <a:gd name="connsiteX86" fmla="*/ 735207 w 6809163"/>
              <a:gd name="connsiteY86" fmla="*/ 6514582 h 6826901"/>
              <a:gd name="connsiteX87" fmla="*/ 735207 w 6809163"/>
              <a:gd name="connsiteY87" fmla="*/ 6443281 h 6826901"/>
              <a:gd name="connsiteX88" fmla="*/ 521234 w 6809163"/>
              <a:gd name="connsiteY88" fmla="*/ 6443281 h 6826901"/>
              <a:gd name="connsiteX89" fmla="*/ 521234 w 6809163"/>
              <a:gd name="connsiteY89" fmla="*/ 6514582 h 6826901"/>
              <a:gd name="connsiteX90" fmla="*/ 592536 w 6809163"/>
              <a:gd name="connsiteY90" fmla="*/ 6514582 h 6826901"/>
              <a:gd name="connsiteX91" fmla="*/ 592536 w 6809163"/>
              <a:gd name="connsiteY91" fmla="*/ 6443281 h 6826901"/>
              <a:gd name="connsiteX92" fmla="*/ 4657886 w 6809163"/>
              <a:gd name="connsiteY92" fmla="*/ 6294643 h 6826901"/>
              <a:gd name="connsiteX93" fmla="*/ 4657886 w 6809163"/>
              <a:gd name="connsiteY93" fmla="*/ 6365944 h 6826901"/>
              <a:gd name="connsiteX94" fmla="*/ 4729187 w 6809163"/>
              <a:gd name="connsiteY94" fmla="*/ 6365944 h 6826901"/>
              <a:gd name="connsiteX95" fmla="*/ 4729187 w 6809163"/>
              <a:gd name="connsiteY95" fmla="*/ 6294643 h 6826901"/>
              <a:gd name="connsiteX96" fmla="*/ 4515284 w 6809163"/>
              <a:gd name="connsiteY96" fmla="*/ 6294643 h 6826901"/>
              <a:gd name="connsiteX97" fmla="*/ 4515284 w 6809163"/>
              <a:gd name="connsiteY97" fmla="*/ 6365944 h 6826901"/>
              <a:gd name="connsiteX98" fmla="*/ 4586584 w 6809163"/>
              <a:gd name="connsiteY98" fmla="*/ 6365944 h 6826901"/>
              <a:gd name="connsiteX99" fmla="*/ 4586584 w 6809163"/>
              <a:gd name="connsiteY99" fmla="*/ 6294643 h 6826901"/>
              <a:gd name="connsiteX100" fmla="*/ 4372612 w 6809163"/>
              <a:gd name="connsiteY100" fmla="*/ 6294643 h 6826901"/>
              <a:gd name="connsiteX101" fmla="*/ 4372612 w 6809163"/>
              <a:gd name="connsiteY101" fmla="*/ 6365944 h 6826901"/>
              <a:gd name="connsiteX102" fmla="*/ 4443913 w 6809163"/>
              <a:gd name="connsiteY102" fmla="*/ 6365944 h 6826901"/>
              <a:gd name="connsiteX103" fmla="*/ 4443913 w 6809163"/>
              <a:gd name="connsiteY103" fmla="*/ 6294643 h 6826901"/>
              <a:gd name="connsiteX104" fmla="*/ 4229939 w 6809163"/>
              <a:gd name="connsiteY104" fmla="*/ 6294643 h 6826901"/>
              <a:gd name="connsiteX105" fmla="*/ 4229939 w 6809163"/>
              <a:gd name="connsiteY105" fmla="*/ 6365944 h 6826901"/>
              <a:gd name="connsiteX106" fmla="*/ 4301240 w 6809163"/>
              <a:gd name="connsiteY106" fmla="*/ 6365944 h 6826901"/>
              <a:gd name="connsiteX107" fmla="*/ 4301240 w 6809163"/>
              <a:gd name="connsiteY107" fmla="*/ 6294643 h 6826901"/>
              <a:gd name="connsiteX108" fmla="*/ 4087338 w 6809163"/>
              <a:gd name="connsiteY108" fmla="*/ 6294643 h 6826901"/>
              <a:gd name="connsiteX109" fmla="*/ 4087338 w 6809163"/>
              <a:gd name="connsiteY109" fmla="*/ 6365944 h 6826901"/>
              <a:gd name="connsiteX110" fmla="*/ 4158638 w 6809163"/>
              <a:gd name="connsiteY110" fmla="*/ 6365944 h 6826901"/>
              <a:gd name="connsiteX111" fmla="*/ 4158638 w 6809163"/>
              <a:gd name="connsiteY111" fmla="*/ 6294643 h 6826901"/>
              <a:gd name="connsiteX112" fmla="*/ 3944665 w 6809163"/>
              <a:gd name="connsiteY112" fmla="*/ 6294643 h 6826901"/>
              <a:gd name="connsiteX113" fmla="*/ 3944665 w 6809163"/>
              <a:gd name="connsiteY113" fmla="*/ 6365944 h 6826901"/>
              <a:gd name="connsiteX114" fmla="*/ 4015966 w 6809163"/>
              <a:gd name="connsiteY114" fmla="*/ 6365944 h 6826901"/>
              <a:gd name="connsiteX115" fmla="*/ 4015966 w 6809163"/>
              <a:gd name="connsiteY115" fmla="*/ 6294643 h 6826901"/>
              <a:gd name="connsiteX116" fmla="*/ 3802063 w 6809163"/>
              <a:gd name="connsiteY116" fmla="*/ 6294643 h 6826901"/>
              <a:gd name="connsiteX117" fmla="*/ 3802063 w 6809163"/>
              <a:gd name="connsiteY117" fmla="*/ 6365944 h 6826901"/>
              <a:gd name="connsiteX118" fmla="*/ 3873364 w 6809163"/>
              <a:gd name="connsiteY118" fmla="*/ 6365944 h 6826901"/>
              <a:gd name="connsiteX119" fmla="*/ 3873364 w 6809163"/>
              <a:gd name="connsiteY119" fmla="*/ 6294643 h 6826901"/>
              <a:gd name="connsiteX120" fmla="*/ 3659391 w 6809163"/>
              <a:gd name="connsiteY120" fmla="*/ 6294643 h 6826901"/>
              <a:gd name="connsiteX121" fmla="*/ 3659391 w 6809163"/>
              <a:gd name="connsiteY121" fmla="*/ 6365944 h 6826901"/>
              <a:gd name="connsiteX122" fmla="*/ 3730692 w 6809163"/>
              <a:gd name="connsiteY122" fmla="*/ 6365944 h 6826901"/>
              <a:gd name="connsiteX123" fmla="*/ 3730692 w 6809163"/>
              <a:gd name="connsiteY123" fmla="*/ 6294643 h 6826901"/>
              <a:gd name="connsiteX124" fmla="*/ 3516789 w 6809163"/>
              <a:gd name="connsiteY124" fmla="*/ 6294643 h 6826901"/>
              <a:gd name="connsiteX125" fmla="*/ 3516789 w 6809163"/>
              <a:gd name="connsiteY125" fmla="*/ 6365944 h 6826901"/>
              <a:gd name="connsiteX126" fmla="*/ 3588090 w 6809163"/>
              <a:gd name="connsiteY126" fmla="*/ 6365944 h 6826901"/>
              <a:gd name="connsiteX127" fmla="*/ 3588090 w 6809163"/>
              <a:gd name="connsiteY127" fmla="*/ 6294643 h 6826901"/>
              <a:gd name="connsiteX128" fmla="*/ 3374117 w 6809163"/>
              <a:gd name="connsiteY128" fmla="*/ 6294643 h 6826901"/>
              <a:gd name="connsiteX129" fmla="*/ 3374117 w 6809163"/>
              <a:gd name="connsiteY129" fmla="*/ 6365944 h 6826901"/>
              <a:gd name="connsiteX130" fmla="*/ 3445417 w 6809163"/>
              <a:gd name="connsiteY130" fmla="*/ 6365944 h 6826901"/>
              <a:gd name="connsiteX131" fmla="*/ 3445417 w 6809163"/>
              <a:gd name="connsiteY131" fmla="*/ 6294643 h 6826901"/>
              <a:gd name="connsiteX132" fmla="*/ 3231444 w 6809163"/>
              <a:gd name="connsiteY132" fmla="*/ 6294643 h 6826901"/>
              <a:gd name="connsiteX133" fmla="*/ 3231444 w 6809163"/>
              <a:gd name="connsiteY133" fmla="*/ 6365944 h 6826901"/>
              <a:gd name="connsiteX134" fmla="*/ 3302745 w 6809163"/>
              <a:gd name="connsiteY134" fmla="*/ 6365944 h 6826901"/>
              <a:gd name="connsiteX135" fmla="*/ 3302745 w 6809163"/>
              <a:gd name="connsiteY135" fmla="*/ 6294643 h 6826901"/>
              <a:gd name="connsiteX136" fmla="*/ 3088843 w 6809163"/>
              <a:gd name="connsiteY136" fmla="*/ 6294643 h 6826901"/>
              <a:gd name="connsiteX137" fmla="*/ 3088843 w 6809163"/>
              <a:gd name="connsiteY137" fmla="*/ 6365944 h 6826901"/>
              <a:gd name="connsiteX138" fmla="*/ 3160144 w 6809163"/>
              <a:gd name="connsiteY138" fmla="*/ 6365944 h 6826901"/>
              <a:gd name="connsiteX139" fmla="*/ 3160144 w 6809163"/>
              <a:gd name="connsiteY139" fmla="*/ 6294643 h 6826901"/>
              <a:gd name="connsiteX140" fmla="*/ 2946170 w 6809163"/>
              <a:gd name="connsiteY140" fmla="*/ 6294643 h 6826901"/>
              <a:gd name="connsiteX141" fmla="*/ 2946170 w 6809163"/>
              <a:gd name="connsiteY141" fmla="*/ 6365944 h 6826901"/>
              <a:gd name="connsiteX142" fmla="*/ 3017471 w 6809163"/>
              <a:gd name="connsiteY142" fmla="*/ 6365944 h 6826901"/>
              <a:gd name="connsiteX143" fmla="*/ 3017471 w 6809163"/>
              <a:gd name="connsiteY143" fmla="*/ 6294643 h 6826901"/>
              <a:gd name="connsiteX144" fmla="*/ 2803569 w 6809163"/>
              <a:gd name="connsiteY144" fmla="*/ 6294643 h 6826901"/>
              <a:gd name="connsiteX145" fmla="*/ 2803569 w 6809163"/>
              <a:gd name="connsiteY145" fmla="*/ 6365944 h 6826901"/>
              <a:gd name="connsiteX146" fmla="*/ 2874870 w 6809163"/>
              <a:gd name="connsiteY146" fmla="*/ 6365944 h 6826901"/>
              <a:gd name="connsiteX147" fmla="*/ 2874870 w 6809163"/>
              <a:gd name="connsiteY147" fmla="*/ 6294643 h 6826901"/>
              <a:gd name="connsiteX148" fmla="*/ 2660896 w 6809163"/>
              <a:gd name="connsiteY148" fmla="*/ 6294643 h 6826901"/>
              <a:gd name="connsiteX149" fmla="*/ 2660896 w 6809163"/>
              <a:gd name="connsiteY149" fmla="*/ 6365944 h 6826901"/>
              <a:gd name="connsiteX150" fmla="*/ 2732197 w 6809163"/>
              <a:gd name="connsiteY150" fmla="*/ 6365944 h 6826901"/>
              <a:gd name="connsiteX151" fmla="*/ 2732197 w 6809163"/>
              <a:gd name="connsiteY151" fmla="*/ 6294643 h 6826901"/>
              <a:gd name="connsiteX152" fmla="*/ 2518224 w 6809163"/>
              <a:gd name="connsiteY152" fmla="*/ 6294643 h 6826901"/>
              <a:gd name="connsiteX153" fmla="*/ 2518224 w 6809163"/>
              <a:gd name="connsiteY153" fmla="*/ 6365944 h 6826901"/>
              <a:gd name="connsiteX154" fmla="*/ 2589525 w 6809163"/>
              <a:gd name="connsiteY154" fmla="*/ 6365944 h 6826901"/>
              <a:gd name="connsiteX155" fmla="*/ 2589525 w 6809163"/>
              <a:gd name="connsiteY155" fmla="*/ 6294643 h 6826901"/>
              <a:gd name="connsiteX156" fmla="*/ 2375622 w 6809163"/>
              <a:gd name="connsiteY156" fmla="*/ 6294643 h 6826901"/>
              <a:gd name="connsiteX157" fmla="*/ 2375622 w 6809163"/>
              <a:gd name="connsiteY157" fmla="*/ 6365944 h 6826901"/>
              <a:gd name="connsiteX158" fmla="*/ 2446923 w 6809163"/>
              <a:gd name="connsiteY158" fmla="*/ 6365944 h 6826901"/>
              <a:gd name="connsiteX159" fmla="*/ 2446923 w 6809163"/>
              <a:gd name="connsiteY159" fmla="*/ 6294643 h 6826901"/>
              <a:gd name="connsiteX160" fmla="*/ 2232949 w 6809163"/>
              <a:gd name="connsiteY160" fmla="*/ 6294643 h 6826901"/>
              <a:gd name="connsiteX161" fmla="*/ 2232949 w 6809163"/>
              <a:gd name="connsiteY161" fmla="*/ 6365944 h 6826901"/>
              <a:gd name="connsiteX162" fmla="*/ 2304250 w 6809163"/>
              <a:gd name="connsiteY162" fmla="*/ 6365944 h 6826901"/>
              <a:gd name="connsiteX163" fmla="*/ 2304250 w 6809163"/>
              <a:gd name="connsiteY163" fmla="*/ 6294643 h 6826901"/>
              <a:gd name="connsiteX164" fmla="*/ 2090348 w 6809163"/>
              <a:gd name="connsiteY164" fmla="*/ 6294643 h 6826901"/>
              <a:gd name="connsiteX165" fmla="*/ 2090348 w 6809163"/>
              <a:gd name="connsiteY165" fmla="*/ 6365944 h 6826901"/>
              <a:gd name="connsiteX166" fmla="*/ 2161649 w 6809163"/>
              <a:gd name="connsiteY166" fmla="*/ 6365944 h 6826901"/>
              <a:gd name="connsiteX167" fmla="*/ 2161649 w 6809163"/>
              <a:gd name="connsiteY167" fmla="*/ 6294643 h 6826901"/>
              <a:gd name="connsiteX168" fmla="*/ 1947675 w 6809163"/>
              <a:gd name="connsiteY168" fmla="*/ 6294643 h 6826901"/>
              <a:gd name="connsiteX169" fmla="*/ 1947675 w 6809163"/>
              <a:gd name="connsiteY169" fmla="*/ 6365944 h 6826901"/>
              <a:gd name="connsiteX170" fmla="*/ 2018976 w 6809163"/>
              <a:gd name="connsiteY170" fmla="*/ 6365944 h 6826901"/>
              <a:gd name="connsiteX171" fmla="*/ 2018976 w 6809163"/>
              <a:gd name="connsiteY171" fmla="*/ 6294643 h 6826901"/>
              <a:gd name="connsiteX172" fmla="*/ 1805074 w 6809163"/>
              <a:gd name="connsiteY172" fmla="*/ 6294643 h 6826901"/>
              <a:gd name="connsiteX173" fmla="*/ 1805074 w 6809163"/>
              <a:gd name="connsiteY173" fmla="*/ 6365944 h 6826901"/>
              <a:gd name="connsiteX174" fmla="*/ 1876375 w 6809163"/>
              <a:gd name="connsiteY174" fmla="*/ 6365944 h 6826901"/>
              <a:gd name="connsiteX175" fmla="*/ 1876375 w 6809163"/>
              <a:gd name="connsiteY175" fmla="*/ 6294643 h 6826901"/>
              <a:gd name="connsiteX176" fmla="*/ 1662401 w 6809163"/>
              <a:gd name="connsiteY176" fmla="*/ 6294643 h 6826901"/>
              <a:gd name="connsiteX177" fmla="*/ 1662401 w 6809163"/>
              <a:gd name="connsiteY177" fmla="*/ 6365944 h 6826901"/>
              <a:gd name="connsiteX178" fmla="*/ 1733702 w 6809163"/>
              <a:gd name="connsiteY178" fmla="*/ 6365944 h 6826901"/>
              <a:gd name="connsiteX179" fmla="*/ 1733702 w 6809163"/>
              <a:gd name="connsiteY179" fmla="*/ 6294643 h 6826901"/>
              <a:gd name="connsiteX180" fmla="*/ 1519800 w 6809163"/>
              <a:gd name="connsiteY180" fmla="*/ 6294643 h 6826901"/>
              <a:gd name="connsiteX181" fmla="*/ 1519800 w 6809163"/>
              <a:gd name="connsiteY181" fmla="*/ 6365944 h 6826901"/>
              <a:gd name="connsiteX182" fmla="*/ 1591101 w 6809163"/>
              <a:gd name="connsiteY182" fmla="*/ 6365944 h 6826901"/>
              <a:gd name="connsiteX183" fmla="*/ 1591101 w 6809163"/>
              <a:gd name="connsiteY183" fmla="*/ 6294643 h 6826901"/>
              <a:gd name="connsiteX184" fmla="*/ 1377127 w 6809163"/>
              <a:gd name="connsiteY184" fmla="*/ 6294643 h 6826901"/>
              <a:gd name="connsiteX185" fmla="*/ 1377127 w 6809163"/>
              <a:gd name="connsiteY185" fmla="*/ 6365944 h 6826901"/>
              <a:gd name="connsiteX186" fmla="*/ 1448428 w 6809163"/>
              <a:gd name="connsiteY186" fmla="*/ 6365944 h 6826901"/>
              <a:gd name="connsiteX187" fmla="*/ 1448428 w 6809163"/>
              <a:gd name="connsiteY187" fmla="*/ 6294643 h 6826901"/>
              <a:gd name="connsiteX188" fmla="*/ 1234455 w 6809163"/>
              <a:gd name="connsiteY188" fmla="*/ 6294643 h 6826901"/>
              <a:gd name="connsiteX189" fmla="*/ 1234455 w 6809163"/>
              <a:gd name="connsiteY189" fmla="*/ 6365944 h 6826901"/>
              <a:gd name="connsiteX190" fmla="*/ 1305756 w 6809163"/>
              <a:gd name="connsiteY190" fmla="*/ 6365944 h 6826901"/>
              <a:gd name="connsiteX191" fmla="*/ 1305756 w 6809163"/>
              <a:gd name="connsiteY191" fmla="*/ 6294643 h 6826901"/>
              <a:gd name="connsiteX192" fmla="*/ 1091853 w 6809163"/>
              <a:gd name="connsiteY192" fmla="*/ 6294643 h 6826901"/>
              <a:gd name="connsiteX193" fmla="*/ 1091853 w 6809163"/>
              <a:gd name="connsiteY193" fmla="*/ 6365944 h 6826901"/>
              <a:gd name="connsiteX194" fmla="*/ 1163154 w 6809163"/>
              <a:gd name="connsiteY194" fmla="*/ 6365944 h 6826901"/>
              <a:gd name="connsiteX195" fmla="*/ 1163154 w 6809163"/>
              <a:gd name="connsiteY195" fmla="*/ 6294643 h 6826901"/>
              <a:gd name="connsiteX196" fmla="*/ 949180 w 6809163"/>
              <a:gd name="connsiteY196" fmla="*/ 6294643 h 6826901"/>
              <a:gd name="connsiteX197" fmla="*/ 949180 w 6809163"/>
              <a:gd name="connsiteY197" fmla="*/ 6365944 h 6826901"/>
              <a:gd name="connsiteX198" fmla="*/ 1020481 w 6809163"/>
              <a:gd name="connsiteY198" fmla="*/ 6365944 h 6826901"/>
              <a:gd name="connsiteX199" fmla="*/ 1020481 w 6809163"/>
              <a:gd name="connsiteY199" fmla="*/ 6294643 h 6826901"/>
              <a:gd name="connsiteX200" fmla="*/ 806579 w 6809163"/>
              <a:gd name="connsiteY200" fmla="*/ 6294643 h 6826901"/>
              <a:gd name="connsiteX201" fmla="*/ 806579 w 6809163"/>
              <a:gd name="connsiteY201" fmla="*/ 6365944 h 6826901"/>
              <a:gd name="connsiteX202" fmla="*/ 877880 w 6809163"/>
              <a:gd name="connsiteY202" fmla="*/ 6365944 h 6826901"/>
              <a:gd name="connsiteX203" fmla="*/ 877880 w 6809163"/>
              <a:gd name="connsiteY203" fmla="*/ 6294643 h 6826901"/>
              <a:gd name="connsiteX204" fmla="*/ 663906 w 6809163"/>
              <a:gd name="connsiteY204" fmla="*/ 6294643 h 6826901"/>
              <a:gd name="connsiteX205" fmla="*/ 663906 w 6809163"/>
              <a:gd name="connsiteY205" fmla="*/ 6365944 h 6826901"/>
              <a:gd name="connsiteX206" fmla="*/ 735207 w 6809163"/>
              <a:gd name="connsiteY206" fmla="*/ 6365944 h 6826901"/>
              <a:gd name="connsiteX207" fmla="*/ 735207 w 6809163"/>
              <a:gd name="connsiteY207" fmla="*/ 6294643 h 6826901"/>
              <a:gd name="connsiteX208" fmla="*/ 4372612 w 6809163"/>
              <a:gd name="connsiteY208" fmla="*/ 6152041 h 6826901"/>
              <a:gd name="connsiteX209" fmla="*/ 4372612 w 6809163"/>
              <a:gd name="connsiteY209" fmla="*/ 6223342 h 6826901"/>
              <a:gd name="connsiteX210" fmla="*/ 4443913 w 6809163"/>
              <a:gd name="connsiteY210" fmla="*/ 6223342 h 6826901"/>
              <a:gd name="connsiteX211" fmla="*/ 4443913 w 6809163"/>
              <a:gd name="connsiteY211" fmla="*/ 6152041 h 6826901"/>
              <a:gd name="connsiteX212" fmla="*/ 4229939 w 6809163"/>
              <a:gd name="connsiteY212" fmla="*/ 6152041 h 6826901"/>
              <a:gd name="connsiteX213" fmla="*/ 4229939 w 6809163"/>
              <a:gd name="connsiteY213" fmla="*/ 6223342 h 6826901"/>
              <a:gd name="connsiteX214" fmla="*/ 4301240 w 6809163"/>
              <a:gd name="connsiteY214" fmla="*/ 6223342 h 6826901"/>
              <a:gd name="connsiteX215" fmla="*/ 4301240 w 6809163"/>
              <a:gd name="connsiteY215" fmla="*/ 6152041 h 6826901"/>
              <a:gd name="connsiteX216" fmla="*/ 4087338 w 6809163"/>
              <a:gd name="connsiteY216" fmla="*/ 6152041 h 6826901"/>
              <a:gd name="connsiteX217" fmla="*/ 4087338 w 6809163"/>
              <a:gd name="connsiteY217" fmla="*/ 6223342 h 6826901"/>
              <a:gd name="connsiteX218" fmla="*/ 4158638 w 6809163"/>
              <a:gd name="connsiteY218" fmla="*/ 6223342 h 6826901"/>
              <a:gd name="connsiteX219" fmla="*/ 4158638 w 6809163"/>
              <a:gd name="connsiteY219" fmla="*/ 6152041 h 6826901"/>
              <a:gd name="connsiteX220" fmla="*/ 3944665 w 6809163"/>
              <a:gd name="connsiteY220" fmla="*/ 6152041 h 6826901"/>
              <a:gd name="connsiteX221" fmla="*/ 3944665 w 6809163"/>
              <a:gd name="connsiteY221" fmla="*/ 6223342 h 6826901"/>
              <a:gd name="connsiteX222" fmla="*/ 4015966 w 6809163"/>
              <a:gd name="connsiteY222" fmla="*/ 6223342 h 6826901"/>
              <a:gd name="connsiteX223" fmla="*/ 4015966 w 6809163"/>
              <a:gd name="connsiteY223" fmla="*/ 6152041 h 6826901"/>
              <a:gd name="connsiteX224" fmla="*/ 3802063 w 6809163"/>
              <a:gd name="connsiteY224" fmla="*/ 6152041 h 6826901"/>
              <a:gd name="connsiteX225" fmla="*/ 3802063 w 6809163"/>
              <a:gd name="connsiteY225" fmla="*/ 6223342 h 6826901"/>
              <a:gd name="connsiteX226" fmla="*/ 3873364 w 6809163"/>
              <a:gd name="connsiteY226" fmla="*/ 6223342 h 6826901"/>
              <a:gd name="connsiteX227" fmla="*/ 3873364 w 6809163"/>
              <a:gd name="connsiteY227" fmla="*/ 6152041 h 6826901"/>
              <a:gd name="connsiteX228" fmla="*/ 3659391 w 6809163"/>
              <a:gd name="connsiteY228" fmla="*/ 6152041 h 6826901"/>
              <a:gd name="connsiteX229" fmla="*/ 3659391 w 6809163"/>
              <a:gd name="connsiteY229" fmla="*/ 6223342 h 6826901"/>
              <a:gd name="connsiteX230" fmla="*/ 3730692 w 6809163"/>
              <a:gd name="connsiteY230" fmla="*/ 6223342 h 6826901"/>
              <a:gd name="connsiteX231" fmla="*/ 3730692 w 6809163"/>
              <a:gd name="connsiteY231" fmla="*/ 6152041 h 6826901"/>
              <a:gd name="connsiteX232" fmla="*/ 3516789 w 6809163"/>
              <a:gd name="connsiteY232" fmla="*/ 6152041 h 6826901"/>
              <a:gd name="connsiteX233" fmla="*/ 3516789 w 6809163"/>
              <a:gd name="connsiteY233" fmla="*/ 6223342 h 6826901"/>
              <a:gd name="connsiteX234" fmla="*/ 3588090 w 6809163"/>
              <a:gd name="connsiteY234" fmla="*/ 6223342 h 6826901"/>
              <a:gd name="connsiteX235" fmla="*/ 3588090 w 6809163"/>
              <a:gd name="connsiteY235" fmla="*/ 6152041 h 6826901"/>
              <a:gd name="connsiteX236" fmla="*/ 3374117 w 6809163"/>
              <a:gd name="connsiteY236" fmla="*/ 6152041 h 6826901"/>
              <a:gd name="connsiteX237" fmla="*/ 3374117 w 6809163"/>
              <a:gd name="connsiteY237" fmla="*/ 6223342 h 6826901"/>
              <a:gd name="connsiteX238" fmla="*/ 3445417 w 6809163"/>
              <a:gd name="connsiteY238" fmla="*/ 6223342 h 6826901"/>
              <a:gd name="connsiteX239" fmla="*/ 3445417 w 6809163"/>
              <a:gd name="connsiteY239" fmla="*/ 6152041 h 6826901"/>
              <a:gd name="connsiteX240" fmla="*/ 3231444 w 6809163"/>
              <a:gd name="connsiteY240" fmla="*/ 6152041 h 6826901"/>
              <a:gd name="connsiteX241" fmla="*/ 3231444 w 6809163"/>
              <a:gd name="connsiteY241" fmla="*/ 6223342 h 6826901"/>
              <a:gd name="connsiteX242" fmla="*/ 3302745 w 6809163"/>
              <a:gd name="connsiteY242" fmla="*/ 6223342 h 6826901"/>
              <a:gd name="connsiteX243" fmla="*/ 3302745 w 6809163"/>
              <a:gd name="connsiteY243" fmla="*/ 6152041 h 6826901"/>
              <a:gd name="connsiteX244" fmla="*/ 3088843 w 6809163"/>
              <a:gd name="connsiteY244" fmla="*/ 6152041 h 6826901"/>
              <a:gd name="connsiteX245" fmla="*/ 3088843 w 6809163"/>
              <a:gd name="connsiteY245" fmla="*/ 6223342 h 6826901"/>
              <a:gd name="connsiteX246" fmla="*/ 3160144 w 6809163"/>
              <a:gd name="connsiteY246" fmla="*/ 6223342 h 6826901"/>
              <a:gd name="connsiteX247" fmla="*/ 3160144 w 6809163"/>
              <a:gd name="connsiteY247" fmla="*/ 6152041 h 6826901"/>
              <a:gd name="connsiteX248" fmla="*/ 2946170 w 6809163"/>
              <a:gd name="connsiteY248" fmla="*/ 6152041 h 6826901"/>
              <a:gd name="connsiteX249" fmla="*/ 2946170 w 6809163"/>
              <a:gd name="connsiteY249" fmla="*/ 6223342 h 6826901"/>
              <a:gd name="connsiteX250" fmla="*/ 3017471 w 6809163"/>
              <a:gd name="connsiteY250" fmla="*/ 6223342 h 6826901"/>
              <a:gd name="connsiteX251" fmla="*/ 3017471 w 6809163"/>
              <a:gd name="connsiteY251" fmla="*/ 6152041 h 6826901"/>
              <a:gd name="connsiteX252" fmla="*/ 2803569 w 6809163"/>
              <a:gd name="connsiteY252" fmla="*/ 6152041 h 6826901"/>
              <a:gd name="connsiteX253" fmla="*/ 2803569 w 6809163"/>
              <a:gd name="connsiteY253" fmla="*/ 6223342 h 6826901"/>
              <a:gd name="connsiteX254" fmla="*/ 2874870 w 6809163"/>
              <a:gd name="connsiteY254" fmla="*/ 6223342 h 6826901"/>
              <a:gd name="connsiteX255" fmla="*/ 2874870 w 6809163"/>
              <a:gd name="connsiteY255" fmla="*/ 6152041 h 6826901"/>
              <a:gd name="connsiteX256" fmla="*/ 2660896 w 6809163"/>
              <a:gd name="connsiteY256" fmla="*/ 6152041 h 6826901"/>
              <a:gd name="connsiteX257" fmla="*/ 2660896 w 6809163"/>
              <a:gd name="connsiteY257" fmla="*/ 6223342 h 6826901"/>
              <a:gd name="connsiteX258" fmla="*/ 2732197 w 6809163"/>
              <a:gd name="connsiteY258" fmla="*/ 6223342 h 6826901"/>
              <a:gd name="connsiteX259" fmla="*/ 2732197 w 6809163"/>
              <a:gd name="connsiteY259" fmla="*/ 6152041 h 6826901"/>
              <a:gd name="connsiteX260" fmla="*/ 2518224 w 6809163"/>
              <a:gd name="connsiteY260" fmla="*/ 6152041 h 6826901"/>
              <a:gd name="connsiteX261" fmla="*/ 2518224 w 6809163"/>
              <a:gd name="connsiteY261" fmla="*/ 6223342 h 6826901"/>
              <a:gd name="connsiteX262" fmla="*/ 2589525 w 6809163"/>
              <a:gd name="connsiteY262" fmla="*/ 6223342 h 6826901"/>
              <a:gd name="connsiteX263" fmla="*/ 2589525 w 6809163"/>
              <a:gd name="connsiteY263" fmla="*/ 6152041 h 6826901"/>
              <a:gd name="connsiteX264" fmla="*/ 2375622 w 6809163"/>
              <a:gd name="connsiteY264" fmla="*/ 6152041 h 6826901"/>
              <a:gd name="connsiteX265" fmla="*/ 2375622 w 6809163"/>
              <a:gd name="connsiteY265" fmla="*/ 6223342 h 6826901"/>
              <a:gd name="connsiteX266" fmla="*/ 2446923 w 6809163"/>
              <a:gd name="connsiteY266" fmla="*/ 6223342 h 6826901"/>
              <a:gd name="connsiteX267" fmla="*/ 2446923 w 6809163"/>
              <a:gd name="connsiteY267" fmla="*/ 6152041 h 6826901"/>
              <a:gd name="connsiteX268" fmla="*/ 2232949 w 6809163"/>
              <a:gd name="connsiteY268" fmla="*/ 6152041 h 6826901"/>
              <a:gd name="connsiteX269" fmla="*/ 2232949 w 6809163"/>
              <a:gd name="connsiteY269" fmla="*/ 6223342 h 6826901"/>
              <a:gd name="connsiteX270" fmla="*/ 2304250 w 6809163"/>
              <a:gd name="connsiteY270" fmla="*/ 6223342 h 6826901"/>
              <a:gd name="connsiteX271" fmla="*/ 2304250 w 6809163"/>
              <a:gd name="connsiteY271" fmla="*/ 6152041 h 6826901"/>
              <a:gd name="connsiteX272" fmla="*/ 2090348 w 6809163"/>
              <a:gd name="connsiteY272" fmla="*/ 6152041 h 6826901"/>
              <a:gd name="connsiteX273" fmla="*/ 2090348 w 6809163"/>
              <a:gd name="connsiteY273" fmla="*/ 6223342 h 6826901"/>
              <a:gd name="connsiteX274" fmla="*/ 2161649 w 6809163"/>
              <a:gd name="connsiteY274" fmla="*/ 6223342 h 6826901"/>
              <a:gd name="connsiteX275" fmla="*/ 2161649 w 6809163"/>
              <a:gd name="connsiteY275" fmla="*/ 6152041 h 6826901"/>
              <a:gd name="connsiteX276" fmla="*/ 1947675 w 6809163"/>
              <a:gd name="connsiteY276" fmla="*/ 6152041 h 6826901"/>
              <a:gd name="connsiteX277" fmla="*/ 1947675 w 6809163"/>
              <a:gd name="connsiteY277" fmla="*/ 6223342 h 6826901"/>
              <a:gd name="connsiteX278" fmla="*/ 2018976 w 6809163"/>
              <a:gd name="connsiteY278" fmla="*/ 6223342 h 6826901"/>
              <a:gd name="connsiteX279" fmla="*/ 2018976 w 6809163"/>
              <a:gd name="connsiteY279" fmla="*/ 6152041 h 6826901"/>
              <a:gd name="connsiteX280" fmla="*/ 1805074 w 6809163"/>
              <a:gd name="connsiteY280" fmla="*/ 6152041 h 6826901"/>
              <a:gd name="connsiteX281" fmla="*/ 1805074 w 6809163"/>
              <a:gd name="connsiteY281" fmla="*/ 6223342 h 6826901"/>
              <a:gd name="connsiteX282" fmla="*/ 1876375 w 6809163"/>
              <a:gd name="connsiteY282" fmla="*/ 6223342 h 6826901"/>
              <a:gd name="connsiteX283" fmla="*/ 1876375 w 6809163"/>
              <a:gd name="connsiteY283" fmla="*/ 6152041 h 6826901"/>
              <a:gd name="connsiteX284" fmla="*/ 1662401 w 6809163"/>
              <a:gd name="connsiteY284" fmla="*/ 6152041 h 6826901"/>
              <a:gd name="connsiteX285" fmla="*/ 1662401 w 6809163"/>
              <a:gd name="connsiteY285" fmla="*/ 6223342 h 6826901"/>
              <a:gd name="connsiteX286" fmla="*/ 1733702 w 6809163"/>
              <a:gd name="connsiteY286" fmla="*/ 6223342 h 6826901"/>
              <a:gd name="connsiteX287" fmla="*/ 1733702 w 6809163"/>
              <a:gd name="connsiteY287" fmla="*/ 6152041 h 6826901"/>
              <a:gd name="connsiteX288" fmla="*/ 1519800 w 6809163"/>
              <a:gd name="connsiteY288" fmla="*/ 6152041 h 6826901"/>
              <a:gd name="connsiteX289" fmla="*/ 1519800 w 6809163"/>
              <a:gd name="connsiteY289" fmla="*/ 6223342 h 6826901"/>
              <a:gd name="connsiteX290" fmla="*/ 1591101 w 6809163"/>
              <a:gd name="connsiteY290" fmla="*/ 6223342 h 6826901"/>
              <a:gd name="connsiteX291" fmla="*/ 1591101 w 6809163"/>
              <a:gd name="connsiteY291" fmla="*/ 6152041 h 6826901"/>
              <a:gd name="connsiteX292" fmla="*/ 1377127 w 6809163"/>
              <a:gd name="connsiteY292" fmla="*/ 6152041 h 6826901"/>
              <a:gd name="connsiteX293" fmla="*/ 1377127 w 6809163"/>
              <a:gd name="connsiteY293" fmla="*/ 6223342 h 6826901"/>
              <a:gd name="connsiteX294" fmla="*/ 1448428 w 6809163"/>
              <a:gd name="connsiteY294" fmla="*/ 6223342 h 6826901"/>
              <a:gd name="connsiteX295" fmla="*/ 1448428 w 6809163"/>
              <a:gd name="connsiteY295" fmla="*/ 6152041 h 6826901"/>
              <a:gd name="connsiteX296" fmla="*/ 1234455 w 6809163"/>
              <a:gd name="connsiteY296" fmla="*/ 6152041 h 6826901"/>
              <a:gd name="connsiteX297" fmla="*/ 1234455 w 6809163"/>
              <a:gd name="connsiteY297" fmla="*/ 6223342 h 6826901"/>
              <a:gd name="connsiteX298" fmla="*/ 1305756 w 6809163"/>
              <a:gd name="connsiteY298" fmla="*/ 6223342 h 6826901"/>
              <a:gd name="connsiteX299" fmla="*/ 1305756 w 6809163"/>
              <a:gd name="connsiteY299" fmla="*/ 6152041 h 6826901"/>
              <a:gd name="connsiteX300" fmla="*/ 1091853 w 6809163"/>
              <a:gd name="connsiteY300" fmla="*/ 6152041 h 6826901"/>
              <a:gd name="connsiteX301" fmla="*/ 1091853 w 6809163"/>
              <a:gd name="connsiteY301" fmla="*/ 6223342 h 6826901"/>
              <a:gd name="connsiteX302" fmla="*/ 1163154 w 6809163"/>
              <a:gd name="connsiteY302" fmla="*/ 6223342 h 6826901"/>
              <a:gd name="connsiteX303" fmla="*/ 1163154 w 6809163"/>
              <a:gd name="connsiteY303" fmla="*/ 6152041 h 6826901"/>
              <a:gd name="connsiteX304" fmla="*/ 949180 w 6809163"/>
              <a:gd name="connsiteY304" fmla="*/ 6152041 h 6826901"/>
              <a:gd name="connsiteX305" fmla="*/ 949180 w 6809163"/>
              <a:gd name="connsiteY305" fmla="*/ 6223342 h 6826901"/>
              <a:gd name="connsiteX306" fmla="*/ 1020481 w 6809163"/>
              <a:gd name="connsiteY306" fmla="*/ 6223342 h 6826901"/>
              <a:gd name="connsiteX307" fmla="*/ 1020481 w 6809163"/>
              <a:gd name="connsiteY307" fmla="*/ 6152041 h 6826901"/>
              <a:gd name="connsiteX308" fmla="*/ 806579 w 6809163"/>
              <a:gd name="connsiteY308" fmla="*/ 6152041 h 6826901"/>
              <a:gd name="connsiteX309" fmla="*/ 806579 w 6809163"/>
              <a:gd name="connsiteY309" fmla="*/ 6223342 h 6826901"/>
              <a:gd name="connsiteX310" fmla="*/ 877880 w 6809163"/>
              <a:gd name="connsiteY310" fmla="*/ 6223342 h 6826901"/>
              <a:gd name="connsiteX311" fmla="*/ 877880 w 6809163"/>
              <a:gd name="connsiteY311" fmla="*/ 6152041 h 6826901"/>
              <a:gd name="connsiteX312" fmla="*/ 4657886 w 6809163"/>
              <a:gd name="connsiteY312" fmla="*/ 6009369 h 6826901"/>
              <a:gd name="connsiteX313" fmla="*/ 4657886 w 6809163"/>
              <a:gd name="connsiteY313" fmla="*/ 6080670 h 6826901"/>
              <a:gd name="connsiteX314" fmla="*/ 4729187 w 6809163"/>
              <a:gd name="connsiteY314" fmla="*/ 6080670 h 6826901"/>
              <a:gd name="connsiteX315" fmla="*/ 4729187 w 6809163"/>
              <a:gd name="connsiteY315" fmla="*/ 6009369 h 6826901"/>
              <a:gd name="connsiteX316" fmla="*/ 4515284 w 6809163"/>
              <a:gd name="connsiteY316" fmla="*/ 6009369 h 6826901"/>
              <a:gd name="connsiteX317" fmla="*/ 4515284 w 6809163"/>
              <a:gd name="connsiteY317" fmla="*/ 6080670 h 6826901"/>
              <a:gd name="connsiteX318" fmla="*/ 4586584 w 6809163"/>
              <a:gd name="connsiteY318" fmla="*/ 6080670 h 6826901"/>
              <a:gd name="connsiteX319" fmla="*/ 4586584 w 6809163"/>
              <a:gd name="connsiteY319" fmla="*/ 6009369 h 6826901"/>
              <a:gd name="connsiteX320" fmla="*/ 4372612 w 6809163"/>
              <a:gd name="connsiteY320" fmla="*/ 6009369 h 6826901"/>
              <a:gd name="connsiteX321" fmla="*/ 4372612 w 6809163"/>
              <a:gd name="connsiteY321" fmla="*/ 6080670 h 6826901"/>
              <a:gd name="connsiteX322" fmla="*/ 4443913 w 6809163"/>
              <a:gd name="connsiteY322" fmla="*/ 6080670 h 6826901"/>
              <a:gd name="connsiteX323" fmla="*/ 4443913 w 6809163"/>
              <a:gd name="connsiteY323" fmla="*/ 6009369 h 6826901"/>
              <a:gd name="connsiteX324" fmla="*/ 4229939 w 6809163"/>
              <a:gd name="connsiteY324" fmla="*/ 6009369 h 6826901"/>
              <a:gd name="connsiteX325" fmla="*/ 4229939 w 6809163"/>
              <a:gd name="connsiteY325" fmla="*/ 6080670 h 6826901"/>
              <a:gd name="connsiteX326" fmla="*/ 4301240 w 6809163"/>
              <a:gd name="connsiteY326" fmla="*/ 6080670 h 6826901"/>
              <a:gd name="connsiteX327" fmla="*/ 4301240 w 6809163"/>
              <a:gd name="connsiteY327" fmla="*/ 6009369 h 6826901"/>
              <a:gd name="connsiteX328" fmla="*/ 4087338 w 6809163"/>
              <a:gd name="connsiteY328" fmla="*/ 6009369 h 6826901"/>
              <a:gd name="connsiteX329" fmla="*/ 4087338 w 6809163"/>
              <a:gd name="connsiteY329" fmla="*/ 6080670 h 6826901"/>
              <a:gd name="connsiteX330" fmla="*/ 4158638 w 6809163"/>
              <a:gd name="connsiteY330" fmla="*/ 6080670 h 6826901"/>
              <a:gd name="connsiteX331" fmla="*/ 4158638 w 6809163"/>
              <a:gd name="connsiteY331" fmla="*/ 6009369 h 6826901"/>
              <a:gd name="connsiteX332" fmla="*/ 3944665 w 6809163"/>
              <a:gd name="connsiteY332" fmla="*/ 6009369 h 6826901"/>
              <a:gd name="connsiteX333" fmla="*/ 3944665 w 6809163"/>
              <a:gd name="connsiteY333" fmla="*/ 6080670 h 6826901"/>
              <a:gd name="connsiteX334" fmla="*/ 4015966 w 6809163"/>
              <a:gd name="connsiteY334" fmla="*/ 6080670 h 6826901"/>
              <a:gd name="connsiteX335" fmla="*/ 4015966 w 6809163"/>
              <a:gd name="connsiteY335" fmla="*/ 6009369 h 6826901"/>
              <a:gd name="connsiteX336" fmla="*/ 3802063 w 6809163"/>
              <a:gd name="connsiteY336" fmla="*/ 6009369 h 6826901"/>
              <a:gd name="connsiteX337" fmla="*/ 3802063 w 6809163"/>
              <a:gd name="connsiteY337" fmla="*/ 6080670 h 6826901"/>
              <a:gd name="connsiteX338" fmla="*/ 3873364 w 6809163"/>
              <a:gd name="connsiteY338" fmla="*/ 6080670 h 6826901"/>
              <a:gd name="connsiteX339" fmla="*/ 3873364 w 6809163"/>
              <a:gd name="connsiteY339" fmla="*/ 6009369 h 6826901"/>
              <a:gd name="connsiteX340" fmla="*/ 3659391 w 6809163"/>
              <a:gd name="connsiteY340" fmla="*/ 6009369 h 6826901"/>
              <a:gd name="connsiteX341" fmla="*/ 3659391 w 6809163"/>
              <a:gd name="connsiteY341" fmla="*/ 6080670 h 6826901"/>
              <a:gd name="connsiteX342" fmla="*/ 3730692 w 6809163"/>
              <a:gd name="connsiteY342" fmla="*/ 6080670 h 6826901"/>
              <a:gd name="connsiteX343" fmla="*/ 3730692 w 6809163"/>
              <a:gd name="connsiteY343" fmla="*/ 6009369 h 6826901"/>
              <a:gd name="connsiteX344" fmla="*/ 3516789 w 6809163"/>
              <a:gd name="connsiteY344" fmla="*/ 6009369 h 6826901"/>
              <a:gd name="connsiteX345" fmla="*/ 3516789 w 6809163"/>
              <a:gd name="connsiteY345" fmla="*/ 6080670 h 6826901"/>
              <a:gd name="connsiteX346" fmla="*/ 3588090 w 6809163"/>
              <a:gd name="connsiteY346" fmla="*/ 6080670 h 6826901"/>
              <a:gd name="connsiteX347" fmla="*/ 3588090 w 6809163"/>
              <a:gd name="connsiteY347" fmla="*/ 6009369 h 6826901"/>
              <a:gd name="connsiteX348" fmla="*/ 3374117 w 6809163"/>
              <a:gd name="connsiteY348" fmla="*/ 6009369 h 6826901"/>
              <a:gd name="connsiteX349" fmla="*/ 3374117 w 6809163"/>
              <a:gd name="connsiteY349" fmla="*/ 6080670 h 6826901"/>
              <a:gd name="connsiteX350" fmla="*/ 3445417 w 6809163"/>
              <a:gd name="connsiteY350" fmla="*/ 6080670 h 6826901"/>
              <a:gd name="connsiteX351" fmla="*/ 3445417 w 6809163"/>
              <a:gd name="connsiteY351" fmla="*/ 6009369 h 6826901"/>
              <a:gd name="connsiteX352" fmla="*/ 3231444 w 6809163"/>
              <a:gd name="connsiteY352" fmla="*/ 6009369 h 6826901"/>
              <a:gd name="connsiteX353" fmla="*/ 3231444 w 6809163"/>
              <a:gd name="connsiteY353" fmla="*/ 6080670 h 6826901"/>
              <a:gd name="connsiteX354" fmla="*/ 3302745 w 6809163"/>
              <a:gd name="connsiteY354" fmla="*/ 6080670 h 6826901"/>
              <a:gd name="connsiteX355" fmla="*/ 3302745 w 6809163"/>
              <a:gd name="connsiteY355" fmla="*/ 6009369 h 6826901"/>
              <a:gd name="connsiteX356" fmla="*/ 3088843 w 6809163"/>
              <a:gd name="connsiteY356" fmla="*/ 6009369 h 6826901"/>
              <a:gd name="connsiteX357" fmla="*/ 3088843 w 6809163"/>
              <a:gd name="connsiteY357" fmla="*/ 6080670 h 6826901"/>
              <a:gd name="connsiteX358" fmla="*/ 3160144 w 6809163"/>
              <a:gd name="connsiteY358" fmla="*/ 6080670 h 6826901"/>
              <a:gd name="connsiteX359" fmla="*/ 3160144 w 6809163"/>
              <a:gd name="connsiteY359" fmla="*/ 6009369 h 6826901"/>
              <a:gd name="connsiteX360" fmla="*/ 2946170 w 6809163"/>
              <a:gd name="connsiteY360" fmla="*/ 6009369 h 6826901"/>
              <a:gd name="connsiteX361" fmla="*/ 2946170 w 6809163"/>
              <a:gd name="connsiteY361" fmla="*/ 6080670 h 6826901"/>
              <a:gd name="connsiteX362" fmla="*/ 3017471 w 6809163"/>
              <a:gd name="connsiteY362" fmla="*/ 6080670 h 6826901"/>
              <a:gd name="connsiteX363" fmla="*/ 3017471 w 6809163"/>
              <a:gd name="connsiteY363" fmla="*/ 6009369 h 6826901"/>
              <a:gd name="connsiteX364" fmla="*/ 2803569 w 6809163"/>
              <a:gd name="connsiteY364" fmla="*/ 6009369 h 6826901"/>
              <a:gd name="connsiteX365" fmla="*/ 2803569 w 6809163"/>
              <a:gd name="connsiteY365" fmla="*/ 6080670 h 6826901"/>
              <a:gd name="connsiteX366" fmla="*/ 2874870 w 6809163"/>
              <a:gd name="connsiteY366" fmla="*/ 6080670 h 6826901"/>
              <a:gd name="connsiteX367" fmla="*/ 2874870 w 6809163"/>
              <a:gd name="connsiteY367" fmla="*/ 6009369 h 6826901"/>
              <a:gd name="connsiteX368" fmla="*/ 2660896 w 6809163"/>
              <a:gd name="connsiteY368" fmla="*/ 6009369 h 6826901"/>
              <a:gd name="connsiteX369" fmla="*/ 2660896 w 6809163"/>
              <a:gd name="connsiteY369" fmla="*/ 6080670 h 6826901"/>
              <a:gd name="connsiteX370" fmla="*/ 2732197 w 6809163"/>
              <a:gd name="connsiteY370" fmla="*/ 6080670 h 6826901"/>
              <a:gd name="connsiteX371" fmla="*/ 2732197 w 6809163"/>
              <a:gd name="connsiteY371" fmla="*/ 6009369 h 6826901"/>
              <a:gd name="connsiteX372" fmla="*/ 2518224 w 6809163"/>
              <a:gd name="connsiteY372" fmla="*/ 6009369 h 6826901"/>
              <a:gd name="connsiteX373" fmla="*/ 2518224 w 6809163"/>
              <a:gd name="connsiteY373" fmla="*/ 6080670 h 6826901"/>
              <a:gd name="connsiteX374" fmla="*/ 2589525 w 6809163"/>
              <a:gd name="connsiteY374" fmla="*/ 6080670 h 6826901"/>
              <a:gd name="connsiteX375" fmla="*/ 2589525 w 6809163"/>
              <a:gd name="connsiteY375" fmla="*/ 6009369 h 6826901"/>
              <a:gd name="connsiteX376" fmla="*/ 2375622 w 6809163"/>
              <a:gd name="connsiteY376" fmla="*/ 6009369 h 6826901"/>
              <a:gd name="connsiteX377" fmla="*/ 2375622 w 6809163"/>
              <a:gd name="connsiteY377" fmla="*/ 6080670 h 6826901"/>
              <a:gd name="connsiteX378" fmla="*/ 2446923 w 6809163"/>
              <a:gd name="connsiteY378" fmla="*/ 6080670 h 6826901"/>
              <a:gd name="connsiteX379" fmla="*/ 2446923 w 6809163"/>
              <a:gd name="connsiteY379" fmla="*/ 6009369 h 6826901"/>
              <a:gd name="connsiteX380" fmla="*/ 2232949 w 6809163"/>
              <a:gd name="connsiteY380" fmla="*/ 6009369 h 6826901"/>
              <a:gd name="connsiteX381" fmla="*/ 2232949 w 6809163"/>
              <a:gd name="connsiteY381" fmla="*/ 6080670 h 6826901"/>
              <a:gd name="connsiteX382" fmla="*/ 2304250 w 6809163"/>
              <a:gd name="connsiteY382" fmla="*/ 6080670 h 6826901"/>
              <a:gd name="connsiteX383" fmla="*/ 2304250 w 6809163"/>
              <a:gd name="connsiteY383" fmla="*/ 6009369 h 6826901"/>
              <a:gd name="connsiteX384" fmla="*/ 2090348 w 6809163"/>
              <a:gd name="connsiteY384" fmla="*/ 6009369 h 6826901"/>
              <a:gd name="connsiteX385" fmla="*/ 2090348 w 6809163"/>
              <a:gd name="connsiteY385" fmla="*/ 6080670 h 6826901"/>
              <a:gd name="connsiteX386" fmla="*/ 2161649 w 6809163"/>
              <a:gd name="connsiteY386" fmla="*/ 6080670 h 6826901"/>
              <a:gd name="connsiteX387" fmla="*/ 2161649 w 6809163"/>
              <a:gd name="connsiteY387" fmla="*/ 6009369 h 6826901"/>
              <a:gd name="connsiteX388" fmla="*/ 1947675 w 6809163"/>
              <a:gd name="connsiteY388" fmla="*/ 6009369 h 6826901"/>
              <a:gd name="connsiteX389" fmla="*/ 1947675 w 6809163"/>
              <a:gd name="connsiteY389" fmla="*/ 6080670 h 6826901"/>
              <a:gd name="connsiteX390" fmla="*/ 2018976 w 6809163"/>
              <a:gd name="connsiteY390" fmla="*/ 6080670 h 6826901"/>
              <a:gd name="connsiteX391" fmla="*/ 2018976 w 6809163"/>
              <a:gd name="connsiteY391" fmla="*/ 6009369 h 6826901"/>
              <a:gd name="connsiteX392" fmla="*/ 1805074 w 6809163"/>
              <a:gd name="connsiteY392" fmla="*/ 6009369 h 6826901"/>
              <a:gd name="connsiteX393" fmla="*/ 1805074 w 6809163"/>
              <a:gd name="connsiteY393" fmla="*/ 6080670 h 6826901"/>
              <a:gd name="connsiteX394" fmla="*/ 1876375 w 6809163"/>
              <a:gd name="connsiteY394" fmla="*/ 6080670 h 6826901"/>
              <a:gd name="connsiteX395" fmla="*/ 1876375 w 6809163"/>
              <a:gd name="connsiteY395" fmla="*/ 6009369 h 6826901"/>
              <a:gd name="connsiteX396" fmla="*/ 1662401 w 6809163"/>
              <a:gd name="connsiteY396" fmla="*/ 6009369 h 6826901"/>
              <a:gd name="connsiteX397" fmla="*/ 1662401 w 6809163"/>
              <a:gd name="connsiteY397" fmla="*/ 6080670 h 6826901"/>
              <a:gd name="connsiteX398" fmla="*/ 1733702 w 6809163"/>
              <a:gd name="connsiteY398" fmla="*/ 6080670 h 6826901"/>
              <a:gd name="connsiteX399" fmla="*/ 1733702 w 6809163"/>
              <a:gd name="connsiteY399" fmla="*/ 6009369 h 6826901"/>
              <a:gd name="connsiteX400" fmla="*/ 1519800 w 6809163"/>
              <a:gd name="connsiteY400" fmla="*/ 6009369 h 6826901"/>
              <a:gd name="connsiteX401" fmla="*/ 1519800 w 6809163"/>
              <a:gd name="connsiteY401" fmla="*/ 6080670 h 6826901"/>
              <a:gd name="connsiteX402" fmla="*/ 1591101 w 6809163"/>
              <a:gd name="connsiteY402" fmla="*/ 6080670 h 6826901"/>
              <a:gd name="connsiteX403" fmla="*/ 1591101 w 6809163"/>
              <a:gd name="connsiteY403" fmla="*/ 6009369 h 6826901"/>
              <a:gd name="connsiteX404" fmla="*/ 1377127 w 6809163"/>
              <a:gd name="connsiteY404" fmla="*/ 6009369 h 6826901"/>
              <a:gd name="connsiteX405" fmla="*/ 1377127 w 6809163"/>
              <a:gd name="connsiteY405" fmla="*/ 6080670 h 6826901"/>
              <a:gd name="connsiteX406" fmla="*/ 1448428 w 6809163"/>
              <a:gd name="connsiteY406" fmla="*/ 6080670 h 6826901"/>
              <a:gd name="connsiteX407" fmla="*/ 1448428 w 6809163"/>
              <a:gd name="connsiteY407" fmla="*/ 6009369 h 6826901"/>
              <a:gd name="connsiteX408" fmla="*/ 1234455 w 6809163"/>
              <a:gd name="connsiteY408" fmla="*/ 6009369 h 6826901"/>
              <a:gd name="connsiteX409" fmla="*/ 1234455 w 6809163"/>
              <a:gd name="connsiteY409" fmla="*/ 6080670 h 6826901"/>
              <a:gd name="connsiteX410" fmla="*/ 1305756 w 6809163"/>
              <a:gd name="connsiteY410" fmla="*/ 6080670 h 6826901"/>
              <a:gd name="connsiteX411" fmla="*/ 1305756 w 6809163"/>
              <a:gd name="connsiteY411" fmla="*/ 6009369 h 6826901"/>
              <a:gd name="connsiteX412" fmla="*/ 1091853 w 6809163"/>
              <a:gd name="connsiteY412" fmla="*/ 6009369 h 6826901"/>
              <a:gd name="connsiteX413" fmla="*/ 1091853 w 6809163"/>
              <a:gd name="connsiteY413" fmla="*/ 6080670 h 6826901"/>
              <a:gd name="connsiteX414" fmla="*/ 1163154 w 6809163"/>
              <a:gd name="connsiteY414" fmla="*/ 6080670 h 6826901"/>
              <a:gd name="connsiteX415" fmla="*/ 1163154 w 6809163"/>
              <a:gd name="connsiteY415" fmla="*/ 6009369 h 6826901"/>
              <a:gd name="connsiteX416" fmla="*/ 949180 w 6809163"/>
              <a:gd name="connsiteY416" fmla="*/ 6009369 h 6826901"/>
              <a:gd name="connsiteX417" fmla="*/ 949180 w 6809163"/>
              <a:gd name="connsiteY417" fmla="*/ 6080670 h 6826901"/>
              <a:gd name="connsiteX418" fmla="*/ 1020481 w 6809163"/>
              <a:gd name="connsiteY418" fmla="*/ 6080670 h 6826901"/>
              <a:gd name="connsiteX419" fmla="*/ 1020481 w 6809163"/>
              <a:gd name="connsiteY419" fmla="*/ 6009369 h 6826901"/>
              <a:gd name="connsiteX420" fmla="*/ 6807516 w 6809163"/>
              <a:gd name="connsiteY420" fmla="*/ 0 h 6826901"/>
              <a:gd name="connsiteX421" fmla="*/ 6809163 w 6809163"/>
              <a:gd name="connsiteY421" fmla="*/ 6826901 h 6826901"/>
              <a:gd name="connsiteX422" fmla="*/ 0 w 6809163"/>
              <a:gd name="connsiteY422" fmla="*/ 6826901 h 6826901"/>
              <a:gd name="connsiteX423" fmla="*/ 378632 w 6809163"/>
              <a:gd name="connsiteY423" fmla="*/ 6447189 h 6826901"/>
              <a:gd name="connsiteX424" fmla="*/ 378632 w 6809163"/>
              <a:gd name="connsiteY424" fmla="*/ 6514582 h 6826901"/>
              <a:gd name="connsiteX425" fmla="*/ 449934 w 6809163"/>
              <a:gd name="connsiteY425" fmla="*/ 6514582 h 6826901"/>
              <a:gd name="connsiteX426" fmla="*/ 449934 w 6809163"/>
              <a:gd name="connsiteY426" fmla="*/ 6443281 h 6826901"/>
              <a:gd name="connsiteX427" fmla="*/ 382530 w 6809163"/>
              <a:gd name="connsiteY427" fmla="*/ 6443281 h 6826901"/>
              <a:gd name="connsiteX428" fmla="*/ 521234 w 6809163"/>
              <a:gd name="connsiteY428" fmla="*/ 6304180 h 6826901"/>
              <a:gd name="connsiteX429" fmla="*/ 521234 w 6809163"/>
              <a:gd name="connsiteY429" fmla="*/ 6365944 h 6826901"/>
              <a:gd name="connsiteX430" fmla="*/ 592536 w 6809163"/>
              <a:gd name="connsiteY430" fmla="*/ 6365944 h 6826901"/>
              <a:gd name="connsiteX431" fmla="*/ 592536 w 6809163"/>
              <a:gd name="connsiteY431" fmla="*/ 6294643 h 6826901"/>
              <a:gd name="connsiteX432" fmla="*/ 530745 w 6809163"/>
              <a:gd name="connsiteY432" fmla="*/ 6294643 h 6826901"/>
              <a:gd name="connsiteX433" fmla="*/ 663906 w 6809163"/>
              <a:gd name="connsiteY433" fmla="*/ 6161102 h 6826901"/>
              <a:gd name="connsiteX434" fmla="*/ 663906 w 6809163"/>
              <a:gd name="connsiteY434" fmla="*/ 6223342 h 6826901"/>
              <a:gd name="connsiteX435" fmla="*/ 735207 w 6809163"/>
              <a:gd name="connsiteY435" fmla="*/ 6223342 h 6826901"/>
              <a:gd name="connsiteX436" fmla="*/ 735207 w 6809163"/>
              <a:gd name="connsiteY436" fmla="*/ 6152041 h 6826901"/>
              <a:gd name="connsiteX437" fmla="*/ 672942 w 6809163"/>
              <a:gd name="connsiteY437" fmla="*/ 6152041 h 6826901"/>
              <a:gd name="connsiteX438" fmla="*/ 806579 w 6809163"/>
              <a:gd name="connsiteY438" fmla="*/ 6018022 h 6826901"/>
              <a:gd name="connsiteX439" fmla="*/ 806579 w 6809163"/>
              <a:gd name="connsiteY439" fmla="*/ 6080670 h 6826901"/>
              <a:gd name="connsiteX440" fmla="*/ 877880 w 6809163"/>
              <a:gd name="connsiteY440" fmla="*/ 6080670 h 6826901"/>
              <a:gd name="connsiteX441" fmla="*/ 877880 w 6809163"/>
              <a:gd name="connsiteY441" fmla="*/ 6009369 h 6826901"/>
              <a:gd name="connsiteX442" fmla="*/ 815208 w 6809163"/>
              <a:gd name="connsiteY442" fmla="*/ 6009369 h 682690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  <a:cxn ang="0">
                <a:pos x="connsiteX229" y="connsiteY229"/>
              </a:cxn>
              <a:cxn ang="0">
                <a:pos x="connsiteX230" y="connsiteY230"/>
              </a:cxn>
              <a:cxn ang="0">
                <a:pos x="connsiteX231" y="connsiteY231"/>
              </a:cxn>
              <a:cxn ang="0">
                <a:pos x="connsiteX232" y="connsiteY232"/>
              </a:cxn>
              <a:cxn ang="0">
                <a:pos x="connsiteX233" y="connsiteY233"/>
              </a:cxn>
              <a:cxn ang="0">
                <a:pos x="connsiteX234" y="connsiteY234"/>
              </a:cxn>
              <a:cxn ang="0">
                <a:pos x="connsiteX235" y="connsiteY235"/>
              </a:cxn>
              <a:cxn ang="0">
                <a:pos x="connsiteX236" y="connsiteY236"/>
              </a:cxn>
              <a:cxn ang="0">
                <a:pos x="connsiteX237" y="connsiteY237"/>
              </a:cxn>
              <a:cxn ang="0">
                <a:pos x="connsiteX238" y="connsiteY238"/>
              </a:cxn>
              <a:cxn ang="0">
                <a:pos x="connsiteX239" y="connsiteY239"/>
              </a:cxn>
              <a:cxn ang="0">
                <a:pos x="connsiteX240" y="connsiteY240"/>
              </a:cxn>
              <a:cxn ang="0">
                <a:pos x="connsiteX241" y="connsiteY241"/>
              </a:cxn>
              <a:cxn ang="0">
                <a:pos x="connsiteX242" y="connsiteY242"/>
              </a:cxn>
              <a:cxn ang="0">
                <a:pos x="connsiteX243" y="connsiteY243"/>
              </a:cxn>
              <a:cxn ang="0">
                <a:pos x="connsiteX244" y="connsiteY244"/>
              </a:cxn>
              <a:cxn ang="0">
                <a:pos x="connsiteX245" y="connsiteY245"/>
              </a:cxn>
              <a:cxn ang="0">
                <a:pos x="connsiteX246" y="connsiteY246"/>
              </a:cxn>
              <a:cxn ang="0">
                <a:pos x="connsiteX247" y="connsiteY247"/>
              </a:cxn>
              <a:cxn ang="0">
                <a:pos x="connsiteX248" y="connsiteY248"/>
              </a:cxn>
              <a:cxn ang="0">
                <a:pos x="connsiteX249" y="connsiteY249"/>
              </a:cxn>
              <a:cxn ang="0">
                <a:pos x="connsiteX250" y="connsiteY250"/>
              </a:cxn>
              <a:cxn ang="0">
                <a:pos x="connsiteX251" y="connsiteY251"/>
              </a:cxn>
              <a:cxn ang="0">
                <a:pos x="connsiteX252" y="connsiteY252"/>
              </a:cxn>
              <a:cxn ang="0">
                <a:pos x="connsiteX253" y="connsiteY253"/>
              </a:cxn>
              <a:cxn ang="0">
                <a:pos x="connsiteX254" y="connsiteY254"/>
              </a:cxn>
              <a:cxn ang="0">
                <a:pos x="connsiteX255" y="connsiteY255"/>
              </a:cxn>
              <a:cxn ang="0">
                <a:pos x="connsiteX256" y="connsiteY256"/>
              </a:cxn>
              <a:cxn ang="0">
                <a:pos x="connsiteX257" y="connsiteY257"/>
              </a:cxn>
              <a:cxn ang="0">
                <a:pos x="connsiteX258" y="connsiteY258"/>
              </a:cxn>
              <a:cxn ang="0">
                <a:pos x="connsiteX259" y="connsiteY259"/>
              </a:cxn>
              <a:cxn ang="0">
                <a:pos x="connsiteX260" y="connsiteY260"/>
              </a:cxn>
              <a:cxn ang="0">
                <a:pos x="connsiteX261" y="connsiteY261"/>
              </a:cxn>
              <a:cxn ang="0">
                <a:pos x="connsiteX262" y="connsiteY262"/>
              </a:cxn>
              <a:cxn ang="0">
                <a:pos x="connsiteX263" y="connsiteY263"/>
              </a:cxn>
              <a:cxn ang="0">
                <a:pos x="connsiteX264" y="connsiteY264"/>
              </a:cxn>
              <a:cxn ang="0">
                <a:pos x="connsiteX265" y="connsiteY265"/>
              </a:cxn>
              <a:cxn ang="0">
                <a:pos x="connsiteX266" y="connsiteY266"/>
              </a:cxn>
              <a:cxn ang="0">
                <a:pos x="connsiteX267" y="connsiteY267"/>
              </a:cxn>
              <a:cxn ang="0">
                <a:pos x="connsiteX268" y="connsiteY268"/>
              </a:cxn>
              <a:cxn ang="0">
                <a:pos x="connsiteX269" y="connsiteY269"/>
              </a:cxn>
              <a:cxn ang="0">
                <a:pos x="connsiteX270" y="connsiteY270"/>
              </a:cxn>
              <a:cxn ang="0">
                <a:pos x="connsiteX271" y="connsiteY271"/>
              </a:cxn>
              <a:cxn ang="0">
                <a:pos x="connsiteX272" y="connsiteY272"/>
              </a:cxn>
              <a:cxn ang="0">
                <a:pos x="connsiteX273" y="connsiteY273"/>
              </a:cxn>
              <a:cxn ang="0">
                <a:pos x="connsiteX274" y="connsiteY274"/>
              </a:cxn>
              <a:cxn ang="0">
                <a:pos x="connsiteX275" y="connsiteY275"/>
              </a:cxn>
              <a:cxn ang="0">
                <a:pos x="connsiteX276" y="connsiteY276"/>
              </a:cxn>
              <a:cxn ang="0">
                <a:pos x="connsiteX277" y="connsiteY277"/>
              </a:cxn>
              <a:cxn ang="0">
                <a:pos x="connsiteX278" y="connsiteY278"/>
              </a:cxn>
              <a:cxn ang="0">
                <a:pos x="connsiteX279" y="connsiteY279"/>
              </a:cxn>
              <a:cxn ang="0">
                <a:pos x="connsiteX280" y="connsiteY280"/>
              </a:cxn>
              <a:cxn ang="0">
                <a:pos x="connsiteX281" y="connsiteY281"/>
              </a:cxn>
              <a:cxn ang="0">
                <a:pos x="connsiteX282" y="connsiteY282"/>
              </a:cxn>
              <a:cxn ang="0">
                <a:pos x="connsiteX283" y="connsiteY283"/>
              </a:cxn>
              <a:cxn ang="0">
                <a:pos x="connsiteX284" y="connsiteY284"/>
              </a:cxn>
              <a:cxn ang="0">
                <a:pos x="connsiteX285" y="connsiteY285"/>
              </a:cxn>
              <a:cxn ang="0">
                <a:pos x="connsiteX286" y="connsiteY286"/>
              </a:cxn>
              <a:cxn ang="0">
                <a:pos x="connsiteX287" y="connsiteY287"/>
              </a:cxn>
              <a:cxn ang="0">
                <a:pos x="connsiteX288" y="connsiteY288"/>
              </a:cxn>
              <a:cxn ang="0">
                <a:pos x="connsiteX289" y="connsiteY289"/>
              </a:cxn>
              <a:cxn ang="0">
                <a:pos x="connsiteX290" y="connsiteY290"/>
              </a:cxn>
              <a:cxn ang="0">
                <a:pos x="connsiteX291" y="connsiteY291"/>
              </a:cxn>
              <a:cxn ang="0">
                <a:pos x="connsiteX292" y="connsiteY292"/>
              </a:cxn>
              <a:cxn ang="0">
                <a:pos x="connsiteX293" y="connsiteY293"/>
              </a:cxn>
              <a:cxn ang="0">
                <a:pos x="connsiteX294" y="connsiteY294"/>
              </a:cxn>
              <a:cxn ang="0">
                <a:pos x="connsiteX295" y="connsiteY295"/>
              </a:cxn>
              <a:cxn ang="0">
                <a:pos x="connsiteX296" y="connsiteY296"/>
              </a:cxn>
              <a:cxn ang="0">
                <a:pos x="connsiteX297" y="connsiteY297"/>
              </a:cxn>
              <a:cxn ang="0">
                <a:pos x="connsiteX298" y="connsiteY298"/>
              </a:cxn>
              <a:cxn ang="0">
                <a:pos x="connsiteX299" y="connsiteY299"/>
              </a:cxn>
              <a:cxn ang="0">
                <a:pos x="connsiteX300" y="connsiteY300"/>
              </a:cxn>
              <a:cxn ang="0">
                <a:pos x="connsiteX301" y="connsiteY301"/>
              </a:cxn>
              <a:cxn ang="0">
                <a:pos x="connsiteX302" y="connsiteY302"/>
              </a:cxn>
              <a:cxn ang="0">
                <a:pos x="connsiteX303" y="connsiteY303"/>
              </a:cxn>
              <a:cxn ang="0">
                <a:pos x="connsiteX304" y="connsiteY304"/>
              </a:cxn>
              <a:cxn ang="0">
                <a:pos x="connsiteX305" y="connsiteY305"/>
              </a:cxn>
              <a:cxn ang="0">
                <a:pos x="connsiteX306" y="connsiteY306"/>
              </a:cxn>
              <a:cxn ang="0">
                <a:pos x="connsiteX307" y="connsiteY307"/>
              </a:cxn>
              <a:cxn ang="0">
                <a:pos x="connsiteX308" y="connsiteY308"/>
              </a:cxn>
              <a:cxn ang="0">
                <a:pos x="connsiteX309" y="connsiteY309"/>
              </a:cxn>
              <a:cxn ang="0">
                <a:pos x="connsiteX310" y="connsiteY310"/>
              </a:cxn>
              <a:cxn ang="0">
                <a:pos x="connsiteX311" y="connsiteY311"/>
              </a:cxn>
              <a:cxn ang="0">
                <a:pos x="connsiteX312" y="connsiteY312"/>
              </a:cxn>
              <a:cxn ang="0">
                <a:pos x="connsiteX313" y="connsiteY313"/>
              </a:cxn>
              <a:cxn ang="0">
                <a:pos x="connsiteX314" y="connsiteY314"/>
              </a:cxn>
              <a:cxn ang="0">
                <a:pos x="connsiteX315" y="connsiteY315"/>
              </a:cxn>
              <a:cxn ang="0">
                <a:pos x="connsiteX316" y="connsiteY316"/>
              </a:cxn>
              <a:cxn ang="0">
                <a:pos x="connsiteX317" y="connsiteY317"/>
              </a:cxn>
              <a:cxn ang="0">
                <a:pos x="connsiteX318" y="connsiteY318"/>
              </a:cxn>
              <a:cxn ang="0">
                <a:pos x="connsiteX319" y="connsiteY319"/>
              </a:cxn>
              <a:cxn ang="0">
                <a:pos x="connsiteX320" y="connsiteY320"/>
              </a:cxn>
              <a:cxn ang="0">
                <a:pos x="connsiteX321" y="connsiteY321"/>
              </a:cxn>
              <a:cxn ang="0">
                <a:pos x="connsiteX322" y="connsiteY322"/>
              </a:cxn>
              <a:cxn ang="0">
                <a:pos x="connsiteX323" y="connsiteY323"/>
              </a:cxn>
              <a:cxn ang="0">
                <a:pos x="connsiteX324" y="connsiteY324"/>
              </a:cxn>
              <a:cxn ang="0">
                <a:pos x="connsiteX325" y="connsiteY325"/>
              </a:cxn>
              <a:cxn ang="0">
                <a:pos x="connsiteX326" y="connsiteY326"/>
              </a:cxn>
              <a:cxn ang="0">
                <a:pos x="connsiteX327" y="connsiteY327"/>
              </a:cxn>
              <a:cxn ang="0">
                <a:pos x="connsiteX328" y="connsiteY328"/>
              </a:cxn>
              <a:cxn ang="0">
                <a:pos x="connsiteX329" y="connsiteY329"/>
              </a:cxn>
              <a:cxn ang="0">
                <a:pos x="connsiteX330" y="connsiteY330"/>
              </a:cxn>
              <a:cxn ang="0">
                <a:pos x="connsiteX331" y="connsiteY331"/>
              </a:cxn>
              <a:cxn ang="0">
                <a:pos x="connsiteX332" y="connsiteY332"/>
              </a:cxn>
              <a:cxn ang="0">
                <a:pos x="connsiteX333" y="connsiteY333"/>
              </a:cxn>
              <a:cxn ang="0">
                <a:pos x="connsiteX334" y="connsiteY334"/>
              </a:cxn>
              <a:cxn ang="0">
                <a:pos x="connsiteX335" y="connsiteY335"/>
              </a:cxn>
              <a:cxn ang="0">
                <a:pos x="connsiteX336" y="connsiteY336"/>
              </a:cxn>
              <a:cxn ang="0">
                <a:pos x="connsiteX337" y="connsiteY337"/>
              </a:cxn>
              <a:cxn ang="0">
                <a:pos x="connsiteX338" y="connsiteY338"/>
              </a:cxn>
              <a:cxn ang="0">
                <a:pos x="connsiteX339" y="connsiteY339"/>
              </a:cxn>
              <a:cxn ang="0">
                <a:pos x="connsiteX340" y="connsiteY340"/>
              </a:cxn>
              <a:cxn ang="0">
                <a:pos x="connsiteX341" y="connsiteY341"/>
              </a:cxn>
              <a:cxn ang="0">
                <a:pos x="connsiteX342" y="connsiteY342"/>
              </a:cxn>
              <a:cxn ang="0">
                <a:pos x="connsiteX343" y="connsiteY343"/>
              </a:cxn>
              <a:cxn ang="0">
                <a:pos x="connsiteX344" y="connsiteY344"/>
              </a:cxn>
              <a:cxn ang="0">
                <a:pos x="connsiteX345" y="connsiteY345"/>
              </a:cxn>
              <a:cxn ang="0">
                <a:pos x="connsiteX346" y="connsiteY346"/>
              </a:cxn>
              <a:cxn ang="0">
                <a:pos x="connsiteX347" y="connsiteY347"/>
              </a:cxn>
              <a:cxn ang="0">
                <a:pos x="connsiteX348" y="connsiteY348"/>
              </a:cxn>
              <a:cxn ang="0">
                <a:pos x="connsiteX349" y="connsiteY349"/>
              </a:cxn>
              <a:cxn ang="0">
                <a:pos x="connsiteX350" y="connsiteY350"/>
              </a:cxn>
              <a:cxn ang="0">
                <a:pos x="connsiteX351" y="connsiteY351"/>
              </a:cxn>
              <a:cxn ang="0">
                <a:pos x="connsiteX352" y="connsiteY352"/>
              </a:cxn>
              <a:cxn ang="0">
                <a:pos x="connsiteX353" y="connsiteY353"/>
              </a:cxn>
              <a:cxn ang="0">
                <a:pos x="connsiteX354" y="connsiteY354"/>
              </a:cxn>
              <a:cxn ang="0">
                <a:pos x="connsiteX355" y="connsiteY355"/>
              </a:cxn>
              <a:cxn ang="0">
                <a:pos x="connsiteX356" y="connsiteY356"/>
              </a:cxn>
              <a:cxn ang="0">
                <a:pos x="connsiteX357" y="connsiteY357"/>
              </a:cxn>
              <a:cxn ang="0">
                <a:pos x="connsiteX358" y="connsiteY358"/>
              </a:cxn>
              <a:cxn ang="0">
                <a:pos x="connsiteX359" y="connsiteY359"/>
              </a:cxn>
              <a:cxn ang="0">
                <a:pos x="connsiteX360" y="connsiteY360"/>
              </a:cxn>
              <a:cxn ang="0">
                <a:pos x="connsiteX361" y="connsiteY361"/>
              </a:cxn>
              <a:cxn ang="0">
                <a:pos x="connsiteX362" y="connsiteY362"/>
              </a:cxn>
              <a:cxn ang="0">
                <a:pos x="connsiteX363" y="connsiteY363"/>
              </a:cxn>
              <a:cxn ang="0">
                <a:pos x="connsiteX364" y="connsiteY364"/>
              </a:cxn>
              <a:cxn ang="0">
                <a:pos x="connsiteX365" y="connsiteY365"/>
              </a:cxn>
              <a:cxn ang="0">
                <a:pos x="connsiteX366" y="connsiteY366"/>
              </a:cxn>
              <a:cxn ang="0">
                <a:pos x="connsiteX367" y="connsiteY367"/>
              </a:cxn>
              <a:cxn ang="0">
                <a:pos x="connsiteX368" y="connsiteY368"/>
              </a:cxn>
              <a:cxn ang="0">
                <a:pos x="connsiteX369" y="connsiteY369"/>
              </a:cxn>
              <a:cxn ang="0">
                <a:pos x="connsiteX370" y="connsiteY370"/>
              </a:cxn>
              <a:cxn ang="0">
                <a:pos x="connsiteX371" y="connsiteY371"/>
              </a:cxn>
              <a:cxn ang="0">
                <a:pos x="connsiteX372" y="connsiteY372"/>
              </a:cxn>
              <a:cxn ang="0">
                <a:pos x="connsiteX373" y="connsiteY373"/>
              </a:cxn>
              <a:cxn ang="0">
                <a:pos x="connsiteX374" y="connsiteY374"/>
              </a:cxn>
              <a:cxn ang="0">
                <a:pos x="connsiteX375" y="connsiteY375"/>
              </a:cxn>
              <a:cxn ang="0">
                <a:pos x="connsiteX376" y="connsiteY376"/>
              </a:cxn>
              <a:cxn ang="0">
                <a:pos x="connsiteX377" y="connsiteY377"/>
              </a:cxn>
              <a:cxn ang="0">
                <a:pos x="connsiteX378" y="connsiteY378"/>
              </a:cxn>
              <a:cxn ang="0">
                <a:pos x="connsiteX379" y="connsiteY379"/>
              </a:cxn>
              <a:cxn ang="0">
                <a:pos x="connsiteX380" y="connsiteY380"/>
              </a:cxn>
              <a:cxn ang="0">
                <a:pos x="connsiteX381" y="connsiteY381"/>
              </a:cxn>
              <a:cxn ang="0">
                <a:pos x="connsiteX382" y="connsiteY382"/>
              </a:cxn>
              <a:cxn ang="0">
                <a:pos x="connsiteX383" y="connsiteY383"/>
              </a:cxn>
              <a:cxn ang="0">
                <a:pos x="connsiteX384" y="connsiteY384"/>
              </a:cxn>
              <a:cxn ang="0">
                <a:pos x="connsiteX385" y="connsiteY385"/>
              </a:cxn>
              <a:cxn ang="0">
                <a:pos x="connsiteX386" y="connsiteY386"/>
              </a:cxn>
              <a:cxn ang="0">
                <a:pos x="connsiteX387" y="connsiteY387"/>
              </a:cxn>
              <a:cxn ang="0">
                <a:pos x="connsiteX388" y="connsiteY388"/>
              </a:cxn>
              <a:cxn ang="0">
                <a:pos x="connsiteX389" y="connsiteY389"/>
              </a:cxn>
              <a:cxn ang="0">
                <a:pos x="connsiteX390" y="connsiteY390"/>
              </a:cxn>
              <a:cxn ang="0">
                <a:pos x="connsiteX391" y="connsiteY391"/>
              </a:cxn>
              <a:cxn ang="0">
                <a:pos x="connsiteX392" y="connsiteY392"/>
              </a:cxn>
              <a:cxn ang="0">
                <a:pos x="connsiteX393" y="connsiteY393"/>
              </a:cxn>
              <a:cxn ang="0">
                <a:pos x="connsiteX394" y="connsiteY394"/>
              </a:cxn>
              <a:cxn ang="0">
                <a:pos x="connsiteX395" y="connsiteY395"/>
              </a:cxn>
              <a:cxn ang="0">
                <a:pos x="connsiteX396" y="connsiteY396"/>
              </a:cxn>
              <a:cxn ang="0">
                <a:pos x="connsiteX397" y="connsiteY397"/>
              </a:cxn>
              <a:cxn ang="0">
                <a:pos x="connsiteX398" y="connsiteY398"/>
              </a:cxn>
              <a:cxn ang="0">
                <a:pos x="connsiteX399" y="connsiteY399"/>
              </a:cxn>
              <a:cxn ang="0">
                <a:pos x="connsiteX400" y="connsiteY400"/>
              </a:cxn>
              <a:cxn ang="0">
                <a:pos x="connsiteX401" y="connsiteY401"/>
              </a:cxn>
              <a:cxn ang="0">
                <a:pos x="connsiteX402" y="connsiteY402"/>
              </a:cxn>
              <a:cxn ang="0">
                <a:pos x="connsiteX403" y="connsiteY403"/>
              </a:cxn>
              <a:cxn ang="0">
                <a:pos x="connsiteX404" y="connsiteY404"/>
              </a:cxn>
              <a:cxn ang="0">
                <a:pos x="connsiteX405" y="connsiteY405"/>
              </a:cxn>
              <a:cxn ang="0">
                <a:pos x="connsiteX406" y="connsiteY406"/>
              </a:cxn>
              <a:cxn ang="0">
                <a:pos x="connsiteX407" y="connsiteY407"/>
              </a:cxn>
              <a:cxn ang="0">
                <a:pos x="connsiteX408" y="connsiteY408"/>
              </a:cxn>
              <a:cxn ang="0">
                <a:pos x="connsiteX409" y="connsiteY409"/>
              </a:cxn>
              <a:cxn ang="0">
                <a:pos x="connsiteX410" y="connsiteY410"/>
              </a:cxn>
              <a:cxn ang="0">
                <a:pos x="connsiteX411" y="connsiteY411"/>
              </a:cxn>
              <a:cxn ang="0">
                <a:pos x="connsiteX412" y="connsiteY412"/>
              </a:cxn>
              <a:cxn ang="0">
                <a:pos x="connsiteX413" y="connsiteY413"/>
              </a:cxn>
              <a:cxn ang="0">
                <a:pos x="connsiteX414" y="connsiteY414"/>
              </a:cxn>
              <a:cxn ang="0">
                <a:pos x="connsiteX415" y="connsiteY415"/>
              </a:cxn>
              <a:cxn ang="0">
                <a:pos x="connsiteX416" y="connsiteY416"/>
              </a:cxn>
              <a:cxn ang="0">
                <a:pos x="connsiteX417" y="connsiteY417"/>
              </a:cxn>
              <a:cxn ang="0">
                <a:pos x="connsiteX418" y="connsiteY418"/>
              </a:cxn>
              <a:cxn ang="0">
                <a:pos x="connsiteX419" y="connsiteY419"/>
              </a:cxn>
              <a:cxn ang="0">
                <a:pos x="connsiteX420" y="connsiteY420"/>
              </a:cxn>
              <a:cxn ang="0">
                <a:pos x="connsiteX421" y="connsiteY421"/>
              </a:cxn>
              <a:cxn ang="0">
                <a:pos x="connsiteX422" y="connsiteY422"/>
              </a:cxn>
              <a:cxn ang="0">
                <a:pos x="connsiteX423" y="connsiteY423"/>
              </a:cxn>
              <a:cxn ang="0">
                <a:pos x="connsiteX424" y="connsiteY424"/>
              </a:cxn>
              <a:cxn ang="0">
                <a:pos x="connsiteX425" y="connsiteY425"/>
              </a:cxn>
              <a:cxn ang="0">
                <a:pos x="connsiteX426" y="connsiteY426"/>
              </a:cxn>
              <a:cxn ang="0">
                <a:pos x="connsiteX427" y="connsiteY427"/>
              </a:cxn>
              <a:cxn ang="0">
                <a:pos x="connsiteX428" y="connsiteY428"/>
              </a:cxn>
              <a:cxn ang="0">
                <a:pos x="connsiteX429" y="connsiteY429"/>
              </a:cxn>
              <a:cxn ang="0">
                <a:pos x="connsiteX430" y="connsiteY430"/>
              </a:cxn>
              <a:cxn ang="0">
                <a:pos x="connsiteX431" y="connsiteY431"/>
              </a:cxn>
              <a:cxn ang="0">
                <a:pos x="connsiteX432" y="connsiteY432"/>
              </a:cxn>
              <a:cxn ang="0">
                <a:pos x="connsiteX433" y="connsiteY433"/>
              </a:cxn>
              <a:cxn ang="0">
                <a:pos x="connsiteX434" y="connsiteY434"/>
              </a:cxn>
              <a:cxn ang="0">
                <a:pos x="connsiteX435" y="connsiteY435"/>
              </a:cxn>
              <a:cxn ang="0">
                <a:pos x="connsiteX436" y="connsiteY436"/>
              </a:cxn>
              <a:cxn ang="0">
                <a:pos x="connsiteX437" y="connsiteY437"/>
              </a:cxn>
              <a:cxn ang="0">
                <a:pos x="connsiteX438" y="connsiteY438"/>
              </a:cxn>
              <a:cxn ang="0">
                <a:pos x="connsiteX439" y="connsiteY439"/>
              </a:cxn>
              <a:cxn ang="0">
                <a:pos x="connsiteX440" y="connsiteY440"/>
              </a:cxn>
              <a:cxn ang="0">
                <a:pos x="connsiteX441" y="connsiteY441"/>
              </a:cxn>
              <a:cxn ang="0">
                <a:pos x="connsiteX442" y="connsiteY442"/>
              </a:cxn>
            </a:cxnLst>
            <a:rect l="l" t="t" r="r" b="b"/>
            <a:pathLst>
              <a:path w="6809163" h="6826901">
                <a:moveTo>
                  <a:pt x="3659391" y="6443281"/>
                </a:moveTo>
                <a:lnTo>
                  <a:pt x="3659391" y="6514582"/>
                </a:lnTo>
                <a:lnTo>
                  <a:pt x="3730692" y="6514582"/>
                </a:lnTo>
                <a:lnTo>
                  <a:pt x="3730692" y="6443281"/>
                </a:lnTo>
                <a:close/>
                <a:moveTo>
                  <a:pt x="3516789" y="6443281"/>
                </a:moveTo>
                <a:lnTo>
                  <a:pt x="3516789" y="6514582"/>
                </a:lnTo>
                <a:lnTo>
                  <a:pt x="3588090" y="6514582"/>
                </a:lnTo>
                <a:lnTo>
                  <a:pt x="3588090" y="6443281"/>
                </a:lnTo>
                <a:close/>
                <a:moveTo>
                  <a:pt x="3374117" y="6443281"/>
                </a:moveTo>
                <a:lnTo>
                  <a:pt x="3374117" y="6514582"/>
                </a:lnTo>
                <a:lnTo>
                  <a:pt x="3445417" y="6514582"/>
                </a:lnTo>
                <a:lnTo>
                  <a:pt x="3445417" y="6443281"/>
                </a:lnTo>
                <a:close/>
                <a:moveTo>
                  <a:pt x="3231444" y="6443281"/>
                </a:moveTo>
                <a:lnTo>
                  <a:pt x="3231444" y="6514582"/>
                </a:lnTo>
                <a:lnTo>
                  <a:pt x="3302745" y="6514582"/>
                </a:lnTo>
                <a:lnTo>
                  <a:pt x="3302745" y="6443281"/>
                </a:lnTo>
                <a:close/>
                <a:moveTo>
                  <a:pt x="3088843" y="6443281"/>
                </a:moveTo>
                <a:lnTo>
                  <a:pt x="3088843" y="6514582"/>
                </a:lnTo>
                <a:lnTo>
                  <a:pt x="3160144" y="6514582"/>
                </a:lnTo>
                <a:lnTo>
                  <a:pt x="3160144" y="6443281"/>
                </a:lnTo>
                <a:close/>
                <a:moveTo>
                  <a:pt x="2946170" y="6443281"/>
                </a:moveTo>
                <a:lnTo>
                  <a:pt x="2946170" y="6514582"/>
                </a:lnTo>
                <a:lnTo>
                  <a:pt x="3017471" y="6514582"/>
                </a:lnTo>
                <a:lnTo>
                  <a:pt x="3017471" y="6443281"/>
                </a:lnTo>
                <a:close/>
                <a:moveTo>
                  <a:pt x="2803569" y="6443281"/>
                </a:moveTo>
                <a:lnTo>
                  <a:pt x="2803569" y="6514582"/>
                </a:lnTo>
                <a:lnTo>
                  <a:pt x="2874870" y="6514582"/>
                </a:lnTo>
                <a:lnTo>
                  <a:pt x="2874870" y="6443281"/>
                </a:lnTo>
                <a:close/>
                <a:moveTo>
                  <a:pt x="2660896" y="6443281"/>
                </a:moveTo>
                <a:lnTo>
                  <a:pt x="2660896" y="6514582"/>
                </a:lnTo>
                <a:lnTo>
                  <a:pt x="2732197" y="6514582"/>
                </a:lnTo>
                <a:lnTo>
                  <a:pt x="2732197" y="6443281"/>
                </a:lnTo>
                <a:close/>
                <a:moveTo>
                  <a:pt x="2518224" y="6443281"/>
                </a:moveTo>
                <a:lnTo>
                  <a:pt x="2518224" y="6514582"/>
                </a:lnTo>
                <a:lnTo>
                  <a:pt x="2589525" y="6514582"/>
                </a:lnTo>
                <a:lnTo>
                  <a:pt x="2589525" y="6443281"/>
                </a:lnTo>
                <a:close/>
                <a:moveTo>
                  <a:pt x="2375622" y="6443281"/>
                </a:moveTo>
                <a:lnTo>
                  <a:pt x="2375622" y="6514582"/>
                </a:lnTo>
                <a:lnTo>
                  <a:pt x="2446923" y="6514582"/>
                </a:lnTo>
                <a:lnTo>
                  <a:pt x="2446923" y="6443281"/>
                </a:lnTo>
                <a:close/>
                <a:moveTo>
                  <a:pt x="2232949" y="6443281"/>
                </a:moveTo>
                <a:lnTo>
                  <a:pt x="2232949" y="6514582"/>
                </a:lnTo>
                <a:lnTo>
                  <a:pt x="2304250" y="6514582"/>
                </a:lnTo>
                <a:lnTo>
                  <a:pt x="2304250" y="6443281"/>
                </a:lnTo>
                <a:close/>
                <a:moveTo>
                  <a:pt x="2090348" y="6443281"/>
                </a:moveTo>
                <a:lnTo>
                  <a:pt x="2090348" y="6514582"/>
                </a:lnTo>
                <a:lnTo>
                  <a:pt x="2161649" y="6514582"/>
                </a:lnTo>
                <a:lnTo>
                  <a:pt x="2161649" y="6443281"/>
                </a:lnTo>
                <a:close/>
                <a:moveTo>
                  <a:pt x="1947675" y="6443281"/>
                </a:moveTo>
                <a:lnTo>
                  <a:pt x="1947675" y="6514582"/>
                </a:lnTo>
                <a:lnTo>
                  <a:pt x="2018976" y="6514582"/>
                </a:lnTo>
                <a:lnTo>
                  <a:pt x="2018976" y="6443281"/>
                </a:lnTo>
                <a:close/>
                <a:moveTo>
                  <a:pt x="1805074" y="6443281"/>
                </a:moveTo>
                <a:lnTo>
                  <a:pt x="1805074" y="6514582"/>
                </a:lnTo>
                <a:lnTo>
                  <a:pt x="1876375" y="6514582"/>
                </a:lnTo>
                <a:lnTo>
                  <a:pt x="1876375" y="6443281"/>
                </a:lnTo>
                <a:close/>
                <a:moveTo>
                  <a:pt x="1662401" y="6443281"/>
                </a:moveTo>
                <a:lnTo>
                  <a:pt x="1662401" y="6514582"/>
                </a:lnTo>
                <a:lnTo>
                  <a:pt x="1733702" y="6514582"/>
                </a:lnTo>
                <a:lnTo>
                  <a:pt x="1733702" y="6443281"/>
                </a:lnTo>
                <a:close/>
                <a:moveTo>
                  <a:pt x="1519800" y="6443281"/>
                </a:moveTo>
                <a:lnTo>
                  <a:pt x="1519800" y="6514582"/>
                </a:lnTo>
                <a:lnTo>
                  <a:pt x="1591101" y="6514582"/>
                </a:lnTo>
                <a:lnTo>
                  <a:pt x="1591101" y="6443281"/>
                </a:lnTo>
                <a:close/>
                <a:moveTo>
                  <a:pt x="1377127" y="6443281"/>
                </a:moveTo>
                <a:lnTo>
                  <a:pt x="1377127" y="6514582"/>
                </a:lnTo>
                <a:lnTo>
                  <a:pt x="1448428" y="6514582"/>
                </a:lnTo>
                <a:lnTo>
                  <a:pt x="1448428" y="6443281"/>
                </a:lnTo>
                <a:close/>
                <a:moveTo>
                  <a:pt x="1234455" y="6443281"/>
                </a:moveTo>
                <a:lnTo>
                  <a:pt x="1234455" y="6514582"/>
                </a:lnTo>
                <a:lnTo>
                  <a:pt x="1305756" y="6514582"/>
                </a:lnTo>
                <a:lnTo>
                  <a:pt x="1305756" y="6443281"/>
                </a:lnTo>
                <a:close/>
                <a:moveTo>
                  <a:pt x="1091853" y="6443281"/>
                </a:moveTo>
                <a:lnTo>
                  <a:pt x="1091853" y="6514582"/>
                </a:lnTo>
                <a:lnTo>
                  <a:pt x="1163154" y="6514582"/>
                </a:lnTo>
                <a:lnTo>
                  <a:pt x="1163154" y="6443281"/>
                </a:lnTo>
                <a:close/>
                <a:moveTo>
                  <a:pt x="949180" y="6443281"/>
                </a:moveTo>
                <a:lnTo>
                  <a:pt x="949180" y="6514582"/>
                </a:lnTo>
                <a:lnTo>
                  <a:pt x="1020481" y="6514582"/>
                </a:lnTo>
                <a:lnTo>
                  <a:pt x="1020481" y="6443281"/>
                </a:lnTo>
                <a:close/>
                <a:moveTo>
                  <a:pt x="806579" y="6443281"/>
                </a:moveTo>
                <a:lnTo>
                  <a:pt x="806579" y="6514582"/>
                </a:lnTo>
                <a:lnTo>
                  <a:pt x="877880" y="6514582"/>
                </a:lnTo>
                <a:lnTo>
                  <a:pt x="877880" y="6443281"/>
                </a:lnTo>
                <a:close/>
                <a:moveTo>
                  <a:pt x="663906" y="6443281"/>
                </a:moveTo>
                <a:lnTo>
                  <a:pt x="663906" y="6514582"/>
                </a:lnTo>
                <a:lnTo>
                  <a:pt x="735207" y="6514582"/>
                </a:lnTo>
                <a:lnTo>
                  <a:pt x="735207" y="6443281"/>
                </a:lnTo>
                <a:close/>
                <a:moveTo>
                  <a:pt x="521234" y="6443281"/>
                </a:moveTo>
                <a:lnTo>
                  <a:pt x="521234" y="6514582"/>
                </a:lnTo>
                <a:lnTo>
                  <a:pt x="592536" y="6514582"/>
                </a:lnTo>
                <a:lnTo>
                  <a:pt x="592536" y="6443281"/>
                </a:lnTo>
                <a:close/>
                <a:moveTo>
                  <a:pt x="4657886" y="6294643"/>
                </a:moveTo>
                <a:lnTo>
                  <a:pt x="4657886" y="6365944"/>
                </a:lnTo>
                <a:lnTo>
                  <a:pt x="4729187" y="6365944"/>
                </a:lnTo>
                <a:lnTo>
                  <a:pt x="4729187" y="6294643"/>
                </a:lnTo>
                <a:close/>
                <a:moveTo>
                  <a:pt x="4515284" y="6294643"/>
                </a:moveTo>
                <a:lnTo>
                  <a:pt x="4515284" y="6365944"/>
                </a:lnTo>
                <a:lnTo>
                  <a:pt x="4586584" y="6365944"/>
                </a:lnTo>
                <a:lnTo>
                  <a:pt x="4586584" y="6294643"/>
                </a:lnTo>
                <a:close/>
                <a:moveTo>
                  <a:pt x="4372612" y="6294643"/>
                </a:moveTo>
                <a:lnTo>
                  <a:pt x="4372612" y="6365944"/>
                </a:lnTo>
                <a:lnTo>
                  <a:pt x="4443913" y="6365944"/>
                </a:lnTo>
                <a:lnTo>
                  <a:pt x="4443913" y="6294643"/>
                </a:lnTo>
                <a:close/>
                <a:moveTo>
                  <a:pt x="4229939" y="6294643"/>
                </a:moveTo>
                <a:lnTo>
                  <a:pt x="4229939" y="6365944"/>
                </a:lnTo>
                <a:lnTo>
                  <a:pt x="4301240" y="6365944"/>
                </a:lnTo>
                <a:lnTo>
                  <a:pt x="4301240" y="6294643"/>
                </a:lnTo>
                <a:close/>
                <a:moveTo>
                  <a:pt x="4087338" y="6294643"/>
                </a:moveTo>
                <a:lnTo>
                  <a:pt x="4087338" y="6365944"/>
                </a:lnTo>
                <a:lnTo>
                  <a:pt x="4158638" y="6365944"/>
                </a:lnTo>
                <a:lnTo>
                  <a:pt x="4158638" y="6294643"/>
                </a:lnTo>
                <a:close/>
                <a:moveTo>
                  <a:pt x="3944665" y="6294643"/>
                </a:moveTo>
                <a:lnTo>
                  <a:pt x="3944665" y="6365944"/>
                </a:lnTo>
                <a:lnTo>
                  <a:pt x="4015966" y="6365944"/>
                </a:lnTo>
                <a:lnTo>
                  <a:pt x="4015966" y="6294643"/>
                </a:lnTo>
                <a:close/>
                <a:moveTo>
                  <a:pt x="3802063" y="6294643"/>
                </a:moveTo>
                <a:lnTo>
                  <a:pt x="3802063" y="6365944"/>
                </a:lnTo>
                <a:lnTo>
                  <a:pt x="3873364" y="6365944"/>
                </a:lnTo>
                <a:lnTo>
                  <a:pt x="3873364" y="6294643"/>
                </a:lnTo>
                <a:close/>
                <a:moveTo>
                  <a:pt x="3659391" y="6294643"/>
                </a:moveTo>
                <a:lnTo>
                  <a:pt x="3659391" y="6365944"/>
                </a:lnTo>
                <a:lnTo>
                  <a:pt x="3730692" y="6365944"/>
                </a:lnTo>
                <a:lnTo>
                  <a:pt x="3730692" y="6294643"/>
                </a:lnTo>
                <a:close/>
                <a:moveTo>
                  <a:pt x="3516789" y="6294643"/>
                </a:moveTo>
                <a:lnTo>
                  <a:pt x="3516789" y="6365944"/>
                </a:lnTo>
                <a:lnTo>
                  <a:pt x="3588090" y="6365944"/>
                </a:lnTo>
                <a:lnTo>
                  <a:pt x="3588090" y="6294643"/>
                </a:lnTo>
                <a:close/>
                <a:moveTo>
                  <a:pt x="3374117" y="6294643"/>
                </a:moveTo>
                <a:lnTo>
                  <a:pt x="3374117" y="6365944"/>
                </a:lnTo>
                <a:lnTo>
                  <a:pt x="3445417" y="6365944"/>
                </a:lnTo>
                <a:lnTo>
                  <a:pt x="3445417" y="6294643"/>
                </a:lnTo>
                <a:close/>
                <a:moveTo>
                  <a:pt x="3231444" y="6294643"/>
                </a:moveTo>
                <a:lnTo>
                  <a:pt x="3231444" y="6365944"/>
                </a:lnTo>
                <a:lnTo>
                  <a:pt x="3302745" y="6365944"/>
                </a:lnTo>
                <a:lnTo>
                  <a:pt x="3302745" y="6294643"/>
                </a:lnTo>
                <a:close/>
                <a:moveTo>
                  <a:pt x="3088843" y="6294643"/>
                </a:moveTo>
                <a:lnTo>
                  <a:pt x="3088843" y="6365944"/>
                </a:lnTo>
                <a:lnTo>
                  <a:pt x="3160144" y="6365944"/>
                </a:lnTo>
                <a:lnTo>
                  <a:pt x="3160144" y="6294643"/>
                </a:lnTo>
                <a:close/>
                <a:moveTo>
                  <a:pt x="2946170" y="6294643"/>
                </a:moveTo>
                <a:lnTo>
                  <a:pt x="2946170" y="6365944"/>
                </a:lnTo>
                <a:lnTo>
                  <a:pt x="3017471" y="6365944"/>
                </a:lnTo>
                <a:lnTo>
                  <a:pt x="3017471" y="6294643"/>
                </a:lnTo>
                <a:close/>
                <a:moveTo>
                  <a:pt x="2803569" y="6294643"/>
                </a:moveTo>
                <a:lnTo>
                  <a:pt x="2803569" y="6365944"/>
                </a:lnTo>
                <a:lnTo>
                  <a:pt x="2874870" y="6365944"/>
                </a:lnTo>
                <a:lnTo>
                  <a:pt x="2874870" y="6294643"/>
                </a:lnTo>
                <a:close/>
                <a:moveTo>
                  <a:pt x="2660896" y="6294643"/>
                </a:moveTo>
                <a:lnTo>
                  <a:pt x="2660896" y="6365944"/>
                </a:lnTo>
                <a:lnTo>
                  <a:pt x="2732197" y="6365944"/>
                </a:lnTo>
                <a:lnTo>
                  <a:pt x="2732197" y="6294643"/>
                </a:lnTo>
                <a:close/>
                <a:moveTo>
                  <a:pt x="2518224" y="6294643"/>
                </a:moveTo>
                <a:lnTo>
                  <a:pt x="2518224" y="6365944"/>
                </a:lnTo>
                <a:lnTo>
                  <a:pt x="2589525" y="6365944"/>
                </a:lnTo>
                <a:lnTo>
                  <a:pt x="2589525" y="6294643"/>
                </a:lnTo>
                <a:close/>
                <a:moveTo>
                  <a:pt x="2375622" y="6294643"/>
                </a:moveTo>
                <a:lnTo>
                  <a:pt x="2375622" y="6365944"/>
                </a:lnTo>
                <a:lnTo>
                  <a:pt x="2446923" y="6365944"/>
                </a:lnTo>
                <a:lnTo>
                  <a:pt x="2446923" y="6294643"/>
                </a:lnTo>
                <a:close/>
                <a:moveTo>
                  <a:pt x="2232949" y="6294643"/>
                </a:moveTo>
                <a:lnTo>
                  <a:pt x="2232949" y="6365944"/>
                </a:lnTo>
                <a:lnTo>
                  <a:pt x="2304250" y="6365944"/>
                </a:lnTo>
                <a:lnTo>
                  <a:pt x="2304250" y="6294643"/>
                </a:lnTo>
                <a:close/>
                <a:moveTo>
                  <a:pt x="2090348" y="6294643"/>
                </a:moveTo>
                <a:lnTo>
                  <a:pt x="2090348" y="6365944"/>
                </a:lnTo>
                <a:lnTo>
                  <a:pt x="2161649" y="6365944"/>
                </a:lnTo>
                <a:lnTo>
                  <a:pt x="2161649" y="6294643"/>
                </a:lnTo>
                <a:close/>
                <a:moveTo>
                  <a:pt x="1947675" y="6294643"/>
                </a:moveTo>
                <a:lnTo>
                  <a:pt x="1947675" y="6365944"/>
                </a:lnTo>
                <a:lnTo>
                  <a:pt x="2018976" y="6365944"/>
                </a:lnTo>
                <a:lnTo>
                  <a:pt x="2018976" y="6294643"/>
                </a:lnTo>
                <a:close/>
                <a:moveTo>
                  <a:pt x="1805074" y="6294643"/>
                </a:moveTo>
                <a:lnTo>
                  <a:pt x="1805074" y="6365944"/>
                </a:lnTo>
                <a:lnTo>
                  <a:pt x="1876375" y="6365944"/>
                </a:lnTo>
                <a:lnTo>
                  <a:pt x="1876375" y="6294643"/>
                </a:lnTo>
                <a:close/>
                <a:moveTo>
                  <a:pt x="1662401" y="6294643"/>
                </a:moveTo>
                <a:lnTo>
                  <a:pt x="1662401" y="6365944"/>
                </a:lnTo>
                <a:lnTo>
                  <a:pt x="1733702" y="6365944"/>
                </a:lnTo>
                <a:lnTo>
                  <a:pt x="1733702" y="6294643"/>
                </a:lnTo>
                <a:close/>
                <a:moveTo>
                  <a:pt x="1519800" y="6294643"/>
                </a:moveTo>
                <a:lnTo>
                  <a:pt x="1519800" y="6365944"/>
                </a:lnTo>
                <a:lnTo>
                  <a:pt x="1591101" y="6365944"/>
                </a:lnTo>
                <a:lnTo>
                  <a:pt x="1591101" y="6294643"/>
                </a:lnTo>
                <a:close/>
                <a:moveTo>
                  <a:pt x="1377127" y="6294643"/>
                </a:moveTo>
                <a:lnTo>
                  <a:pt x="1377127" y="6365944"/>
                </a:lnTo>
                <a:lnTo>
                  <a:pt x="1448428" y="6365944"/>
                </a:lnTo>
                <a:lnTo>
                  <a:pt x="1448428" y="6294643"/>
                </a:lnTo>
                <a:close/>
                <a:moveTo>
                  <a:pt x="1234455" y="6294643"/>
                </a:moveTo>
                <a:lnTo>
                  <a:pt x="1234455" y="6365944"/>
                </a:lnTo>
                <a:lnTo>
                  <a:pt x="1305756" y="6365944"/>
                </a:lnTo>
                <a:lnTo>
                  <a:pt x="1305756" y="6294643"/>
                </a:lnTo>
                <a:close/>
                <a:moveTo>
                  <a:pt x="1091853" y="6294643"/>
                </a:moveTo>
                <a:lnTo>
                  <a:pt x="1091853" y="6365944"/>
                </a:lnTo>
                <a:lnTo>
                  <a:pt x="1163154" y="6365944"/>
                </a:lnTo>
                <a:lnTo>
                  <a:pt x="1163154" y="6294643"/>
                </a:lnTo>
                <a:close/>
                <a:moveTo>
                  <a:pt x="949180" y="6294643"/>
                </a:moveTo>
                <a:lnTo>
                  <a:pt x="949180" y="6365944"/>
                </a:lnTo>
                <a:lnTo>
                  <a:pt x="1020481" y="6365944"/>
                </a:lnTo>
                <a:lnTo>
                  <a:pt x="1020481" y="6294643"/>
                </a:lnTo>
                <a:close/>
                <a:moveTo>
                  <a:pt x="806579" y="6294643"/>
                </a:moveTo>
                <a:lnTo>
                  <a:pt x="806579" y="6365944"/>
                </a:lnTo>
                <a:lnTo>
                  <a:pt x="877880" y="6365944"/>
                </a:lnTo>
                <a:lnTo>
                  <a:pt x="877880" y="6294643"/>
                </a:lnTo>
                <a:close/>
                <a:moveTo>
                  <a:pt x="663906" y="6294643"/>
                </a:moveTo>
                <a:lnTo>
                  <a:pt x="663906" y="6365944"/>
                </a:lnTo>
                <a:lnTo>
                  <a:pt x="735207" y="6365944"/>
                </a:lnTo>
                <a:lnTo>
                  <a:pt x="735207" y="6294643"/>
                </a:lnTo>
                <a:close/>
                <a:moveTo>
                  <a:pt x="4372612" y="6152041"/>
                </a:moveTo>
                <a:lnTo>
                  <a:pt x="4372612" y="6223342"/>
                </a:lnTo>
                <a:lnTo>
                  <a:pt x="4443913" y="6223342"/>
                </a:lnTo>
                <a:lnTo>
                  <a:pt x="4443913" y="6152041"/>
                </a:lnTo>
                <a:close/>
                <a:moveTo>
                  <a:pt x="4229939" y="6152041"/>
                </a:moveTo>
                <a:lnTo>
                  <a:pt x="4229939" y="6223342"/>
                </a:lnTo>
                <a:lnTo>
                  <a:pt x="4301240" y="6223342"/>
                </a:lnTo>
                <a:lnTo>
                  <a:pt x="4301240" y="6152041"/>
                </a:lnTo>
                <a:close/>
                <a:moveTo>
                  <a:pt x="4087338" y="6152041"/>
                </a:moveTo>
                <a:lnTo>
                  <a:pt x="4087338" y="6223342"/>
                </a:lnTo>
                <a:lnTo>
                  <a:pt x="4158638" y="6223342"/>
                </a:lnTo>
                <a:lnTo>
                  <a:pt x="4158638" y="6152041"/>
                </a:lnTo>
                <a:close/>
                <a:moveTo>
                  <a:pt x="3944665" y="6152041"/>
                </a:moveTo>
                <a:lnTo>
                  <a:pt x="3944665" y="6223342"/>
                </a:lnTo>
                <a:lnTo>
                  <a:pt x="4015966" y="6223342"/>
                </a:lnTo>
                <a:lnTo>
                  <a:pt x="4015966" y="6152041"/>
                </a:lnTo>
                <a:close/>
                <a:moveTo>
                  <a:pt x="3802063" y="6152041"/>
                </a:moveTo>
                <a:lnTo>
                  <a:pt x="3802063" y="6223342"/>
                </a:lnTo>
                <a:lnTo>
                  <a:pt x="3873364" y="6223342"/>
                </a:lnTo>
                <a:lnTo>
                  <a:pt x="3873364" y="6152041"/>
                </a:lnTo>
                <a:close/>
                <a:moveTo>
                  <a:pt x="3659391" y="6152041"/>
                </a:moveTo>
                <a:lnTo>
                  <a:pt x="3659391" y="6223342"/>
                </a:lnTo>
                <a:lnTo>
                  <a:pt x="3730692" y="6223342"/>
                </a:lnTo>
                <a:lnTo>
                  <a:pt x="3730692" y="6152041"/>
                </a:lnTo>
                <a:close/>
                <a:moveTo>
                  <a:pt x="3516789" y="6152041"/>
                </a:moveTo>
                <a:lnTo>
                  <a:pt x="3516789" y="6223342"/>
                </a:lnTo>
                <a:lnTo>
                  <a:pt x="3588090" y="6223342"/>
                </a:lnTo>
                <a:lnTo>
                  <a:pt x="3588090" y="6152041"/>
                </a:lnTo>
                <a:close/>
                <a:moveTo>
                  <a:pt x="3374117" y="6152041"/>
                </a:moveTo>
                <a:lnTo>
                  <a:pt x="3374117" y="6223342"/>
                </a:lnTo>
                <a:lnTo>
                  <a:pt x="3445417" y="6223342"/>
                </a:lnTo>
                <a:lnTo>
                  <a:pt x="3445417" y="6152041"/>
                </a:lnTo>
                <a:close/>
                <a:moveTo>
                  <a:pt x="3231444" y="6152041"/>
                </a:moveTo>
                <a:lnTo>
                  <a:pt x="3231444" y="6223342"/>
                </a:lnTo>
                <a:lnTo>
                  <a:pt x="3302745" y="6223342"/>
                </a:lnTo>
                <a:lnTo>
                  <a:pt x="3302745" y="6152041"/>
                </a:lnTo>
                <a:close/>
                <a:moveTo>
                  <a:pt x="3088843" y="6152041"/>
                </a:moveTo>
                <a:lnTo>
                  <a:pt x="3088843" y="6223342"/>
                </a:lnTo>
                <a:lnTo>
                  <a:pt x="3160144" y="6223342"/>
                </a:lnTo>
                <a:lnTo>
                  <a:pt x="3160144" y="6152041"/>
                </a:lnTo>
                <a:close/>
                <a:moveTo>
                  <a:pt x="2946170" y="6152041"/>
                </a:moveTo>
                <a:lnTo>
                  <a:pt x="2946170" y="6223342"/>
                </a:lnTo>
                <a:lnTo>
                  <a:pt x="3017471" y="6223342"/>
                </a:lnTo>
                <a:lnTo>
                  <a:pt x="3017471" y="6152041"/>
                </a:lnTo>
                <a:close/>
                <a:moveTo>
                  <a:pt x="2803569" y="6152041"/>
                </a:moveTo>
                <a:lnTo>
                  <a:pt x="2803569" y="6223342"/>
                </a:lnTo>
                <a:lnTo>
                  <a:pt x="2874870" y="6223342"/>
                </a:lnTo>
                <a:lnTo>
                  <a:pt x="2874870" y="6152041"/>
                </a:lnTo>
                <a:close/>
                <a:moveTo>
                  <a:pt x="2660896" y="6152041"/>
                </a:moveTo>
                <a:lnTo>
                  <a:pt x="2660896" y="6223342"/>
                </a:lnTo>
                <a:lnTo>
                  <a:pt x="2732197" y="6223342"/>
                </a:lnTo>
                <a:lnTo>
                  <a:pt x="2732197" y="6152041"/>
                </a:lnTo>
                <a:close/>
                <a:moveTo>
                  <a:pt x="2518224" y="6152041"/>
                </a:moveTo>
                <a:lnTo>
                  <a:pt x="2518224" y="6223342"/>
                </a:lnTo>
                <a:lnTo>
                  <a:pt x="2589525" y="6223342"/>
                </a:lnTo>
                <a:lnTo>
                  <a:pt x="2589525" y="6152041"/>
                </a:lnTo>
                <a:close/>
                <a:moveTo>
                  <a:pt x="2375622" y="6152041"/>
                </a:moveTo>
                <a:lnTo>
                  <a:pt x="2375622" y="6223342"/>
                </a:lnTo>
                <a:lnTo>
                  <a:pt x="2446923" y="6223342"/>
                </a:lnTo>
                <a:lnTo>
                  <a:pt x="2446923" y="6152041"/>
                </a:lnTo>
                <a:close/>
                <a:moveTo>
                  <a:pt x="2232949" y="6152041"/>
                </a:moveTo>
                <a:lnTo>
                  <a:pt x="2232949" y="6223342"/>
                </a:lnTo>
                <a:lnTo>
                  <a:pt x="2304250" y="6223342"/>
                </a:lnTo>
                <a:lnTo>
                  <a:pt x="2304250" y="6152041"/>
                </a:lnTo>
                <a:close/>
                <a:moveTo>
                  <a:pt x="2090348" y="6152041"/>
                </a:moveTo>
                <a:lnTo>
                  <a:pt x="2090348" y="6223342"/>
                </a:lnTo>
                <a:lnTo>
                  <a:pt x="2161649" y="6223342"/>
                </a:lnTo>
                <a:lnTo>
                  <a:pt x="2161649" y="6152041"/>
                </a:lnTo>
                <a:close/>
                <a:moveTo>
                  <a:pt x="1947675" y="6152041"/>
                </a:moveTo>
                <a:lnTo>
                  <a:pt x="1947675" y="6223342"/>
                </a:lnTo>
                <a:lnTo>
                  <a:pt x="2018976" y="6223342"/>
                </a:lnTo>
                <a:lnTo>
                  <a:pt x="2018976" y="6152041"/>
                </a:lnTo>
                <a:close/>
                <a:moveTo>
                  <a:pt x="1805074" y="6152041"/>
                </a:moveTo>
                <a:lnTo>
                  <a:pt x="1805074" y="6223342"/>
                </a:lnTo>
                <a:lnTo>
                  <a:pt x="1876375" y="6223342"/>
                </a:lnTo>
                <a:lnTo>
                  <a:pt x="1876375" y="6152041"/>
                </a:lnTo>
                <a:close/>
                <a:moveTo>
                  <a:pt x="1662401" y="6152041"/>
                </a:moveTo>
                <a:lnTo>
                  <a:pt x="1662401" y="6223342"/>
                </a:lnTo>
                <a:lnTo>
                  <a:pt x="1733702" y="6223342"/>
                </a:lnTo>
                <a:lnTo>
                  <a:pt x="1733702" y="6152041"/>
                </a:lnTo>
                <a:close/>
                <a:moveTo>
                  <a:pt x="1519800" y="6152041"/>
                </a:moveTo>
                <a:lnTo>
                  <a:pt x="1519800" y="6223342"/>
                </a:lnTo>
                <a:lnTo>
                  <a:pt x="1591101" y="6223342"/>
                </a:lnTo>
                <a:lnTo>
                  <a:pt x="1591101" y="6152041"/>
                </a:lnTo>
                <a:close/>
                <a:moveTo>
                  <a:pt x="1377127" y="6152041"/>
                </a:moveTo>
                <a:lnTo>
                  <a:pt x="1377127" y="6223342"/>
                </a:lnTo>
                <a:lnTo>
                  <a:pt x="1448428" y="6223342"/>
                </a:lnTo>
                <a:lnTo>
                  <a:pt x="1448428" y="6152041"/>
                </a:lnTo>
                <a:close/>
                <a:moveTo>
                  <a:pt x="1234455" y="6152041"/>
                </a:moveTo>
                <a:lnTo>
                  <a:pt x="1234455" y="6223342"/>
                </a:lnTo>
                <a:lnTo>
                  <a:pt x="1305756" y="6223342"/>
                </a:lnTo>
                <a:lnTo>
                  <a:pt x="1305756" y="6152041"/>
                </a:lnTo>
                <a:close/>
                <a:moveTo>
                  <a:pt x="1091853" y="6152041"/>
                </a:moveTo>
                <a:lnTo>
                  <a:pt x="1091853" y="6223342"/>
                </a:lnTo>
                <a:lnTo>
                  <a:pt x="1163154" y="6223342"/>
                </a:lnTo>
                <a:lnTo>
                  <a:pt x="1163154" y="6152041"/>
                </a:lnTo>
                <a:close/>
                <a:moveTo>
                  <a:pt x="949180" y="6152041"/>
                </a:moveTo>
                <a:lnTo>
                  <a:pt x="949180" y="6223342"/>
                </a:lnTo>
                <a:lnTo>
                  <a:pt x="1020481" y="6223342"/>
                </a:lnTo>
                <a:lnTo>
                  <a:pt x="1020481" y="6152041"/>
                </a:lnTo>
                <a:close/>
                <a:moveTo>
                  <a:pt x="806579" y="6152041"/>
                </a:moveTo>
                <a:lnTo>
                  <a:pt x="806579" y="6223342"/>
                </a:lnTo>
                <a:lnTo>
                  <a:pt x="877880" y="6223342"/>
                </a:lnTo>
                <a:lnTo>
                  <a:pt x="877880" y="6152041"/>
                </a:lnTo>
                <a:close/>
                <a:moveTo>
                  <a:pt x="4657886" y="6009369"/>
                </a:moveTo>
                <a:lnTo>
                  <a:pt x="4657886" y="6080670"/>
                </a:lnTo>
                <a:lnTo>
                  <a:pt x="4729187" y="6080670"/>
                </a:lnTo>
                <a:lnTo>
                  <a:pt x="4729187" y="6009369"/>
                </a:lnTo>
                <a:close/>
                <a:moveTo>
                  <a:pt x="4515284" y="6009369"/>
                </a:moveTo>
                <a:lnTo>
                  <a:pt x="4515284" y="6080670"/>
                </a:lnTo>
                <a:lnTo>
                  <a:pt x="4586584" y="6080670"/>
                </a:lnTo>
                <a:lnTo>
                  <a:pt x="4586584" y="6009369"/>
                </a:lnTo>
                <a:close/>
                <a:moveTo>
                  <a:pt x="4372612" y="6009369"/>
                </a:moveTo>
                <a:lnTo>
                  <a:pt x="4372612" y="6080670"/>
                </a:lnTo>
                <a:lnTo>
                  <a:pt x="4443913" y="6080670"/>
                </a:lnTo>
                <a:lnTo>
                  <a:pt x="4443913" y="6009369"/>
                </a:lnTo>
                <a:close/>
                <a:moveTo>
                  <a:pt x="4229939" y="6009369"/>
                </a:moveTo>
                <a:lnTo>
                  <a:pt x="4229939" y="6080670"/>
                </a:lnTo>
                <a:lnTo>
                  <a:pt x="4301240" y="6080670"/>
                </a:lnTo>
                <a:lnTo>
                  <a:pt x="4301240" y="6009369"/>
                </a:lnTo>
                <a:close/>
                <a:moveTo>
                  <a:pt x="4087338" y="6009369"/>
                </a:moveTo>
                <a:lnTo>
                  <a:pt x="4087338" y="6080670"/>
                </a:lnTo>
                <a:lnTo>
                  <a:pt x="4158638" y="6080670"/>
                </a:lnTo>
                <a:lnTo>
                  <a:pt x="4158638" y="6009369"/>
                </a:lnTo>
                <a:close/>
                <a:moveTo>
                  <a:pt x="3944665" y="6009369"/>
                </a:moveTo>
                <a:lnTo>
                  <a:pt x="3944665" y="6080670"/>
                </a:lnTo>
                <a:lnTo>
                  <a:pt x="4015966" y="6080670"/>
                </a:lnTo>
                <a:lnTo>
                  <a:pt x="4015966" y="6009369"/>
                </a:lnTo>
                <a:close/>
                <a:moveTo>
                  <a:pt x="3802063" y="6009369"/>
                </a:moveTo>
                <a:lnTo>
                  <a:pt x="3802063" y="6080670"/>
                </a:lnTo>
                <a:lnTo>
                  <a:pt x="3873364" y="6080670"/>
                </a:lnTo>
                <a:lnTo>
                  <a:pt x="3873364" y="6009369"/>
                </a:lnTo>
                <a:close/>
                <a:moveTo>
                  <a:pt x="3659391" y="6009369"/>
                </a:moveTo>
                <a:lnTo>
                  <a:pt x="3659391" y="6080670"/>
                </a:lnTo>
                <a:lnTo>
                  <a:pt x="3730692" y="6080670"/>
                </a:lnTo>
                <a:lnTo>
                  <a:pt x="3730692" y="6009369"/>
                </a:lnTo>
                <a:close/>
                <a:moveTo>
                  <a:pt x="3516789" y="6009369"/>
                </a:moveTo>
                <a:lnTo>
                  <a:pt x="3516789" y="6080670"/>
                </a:lnTo>
                <a:lnTo>
                  <a:pt x="3588090" y="6080670"/>
                </a:lnTo>
                <a:lnTo>
                  <a:pt x="3588090" y="6009369"/>
                </a:lnTo>
                <a:close/>
                <a:moveTo>
                  <a:pt x="3374117" y="6009369"/>
                </a:moveTo>
                <a:lnTo>
                  <a:pt x="3374117" y="6080670"/>
                </a:lnTo>
                <a:lnTo>
                  <a:pt x="3445417" y="6080670"/>
                </a:lnTo>
                <a:lnTo>
                  <a:pt x="3445417" y="6009369"/>
                </a:lnTo>
                <a:close/>
                <a:moveTo>
                  <a:pt x="3231444" y="6009369"/>
                </a:moveTo>
                <a:lnTo>
                  <a:pt x="3231444" y="6080670"/>
                </a:lnTo>
                <a:lnTo>
                  <a:pt x="3302745" y="6080670"/>
                </a:lnTo>
                <a:lnTo>
                  <a:pt x="3302745" y="6009369"/>
                </a:lnTo>
                <a:close/>
                <a:moveTo>
                  <a:pt x="3088843" y="6009369"/>
                </a:moveTo>
                <a:lnTo>
                  <a:pt x="3088843" y="6080670"/>
                </a:lnTo>
                <a:lnTo>
                  <a:pt x="3160144" y="6080670"/>
                </a:lnTo>
                <a:lnTo>
                  <a:pt x="3160144" y="6009369"/>
                </a:lnTo>
                <a:close/>
                <a:moveTo>
                  <a:pt x="2946170" y="6009369"/>
                </a:moveTo>
                <a:lnTo>
                  <a:pt x="2946170" y="6080670"/>
                </a:lnTo>
                <a:lnTo>
                  <a:pt x="3017471" y="6080670"/>
                </a:lnTo>
                <a:lnTo>
                  <a:pt x="3017471" y="6009369"/>
                </a:lnTo>
                <a:close/>
                <a:moveTo>
                  <a:pt x="2803569" y="6009369"/>
                </a:moveTo>
                <a:lnTo>
                  <a:pt x="2803569" y="6080670"/>
                </a:lnTo>
                <a:lnTo>
                  <a:pt x="2874870" y="6080670"/>
                </a:lnTo>
                <a:lnTo>
                  <a:pt x="2874870" y="6009369"/>
                </a:lnTo>
                <a:close/>
                <a:moveTo>
                  <a:pt x="2660896" y="6009369"/>
                </a:moveTo>
                <a:lnTo>
                  <a:pt x="2660896" y="6080670"/>
                </a:lnTo>
                <a:lnTo>
                  <a:pt x="2732197" y="6080670"/>
                </a:lnTo>
                <a:lnTo>
                  <a:pt x="2732197" y="6009369"/>
                </a:lnTo>
                <a:close/>
                <a:moveTo>
                  <a:pt x="2518224" y="6009369"/>
                </a:moveTo>
                <a:lnTo>
                  <a:pt x="2518224" y="6080670"/>
                </a:lnTo>
                <a:lnTo>
                  <a:pt x="2589525" y="6080670"/>
                </a:lnTo>
                <a:lnTo>
                  <a:pt x="2589525" y="6009369"/>
                </a:lnTo>
                <a:close/>
                <a:moveTo>
                  <a:pt x="2375622" y="6009369"/>
                </a:moveTo>
                <a:lnTo>
                  <a:pt x="2375622" y="6080670"/>
                </a:lnTo>
                <a:lnTo>
                  <a:pt x="2446923" y="6080670"/>
                </a:lnTo>
                <a:lnTo>
                  <a:pt x="2446923" y="6009369"/>
                </a:lnTo>
                <a:close/>
                <a:moveTo>
                  <a:pt x="2232949" y="6009369"/>
                </a:moveTo>
                <a:lnTo>
                  <a:pt x="2232949" y="6080670"/>
                </a:lnTo>
                <a:lnTo>
                  <a:pt x="2304250" y="6080670"/>
                </a:lnTo>
                <a:lnTo>
                  <a:pt x="2304250" y="6009369"/>
                </a:lnTo>
                <a:close/>
                <a:moveTo>
                  <a:pt x="2090348" y="6009369"/>
                </a:moveTo>
                <a:lnTo>
                  <a:pt x="2090348" y="6080670"/>
                </a:lnTo>
                <a:lnTo>
                  <a:pt x="2161649" y="6080670"/>
                </a:lnTo>
                <a:lnTo>
                  <a:pt x="2161649" y="6009369"/>
                </a:lnTo>
                <a:close/>
                <a:moveTo>
                  <a:pt x="1947675" y="6009369"/>
                </a:moveTo>
                <a:lnTo>
                  <a:pt x="1947675" y="6080670"/>
                </a:lnTo>
                <a:lnTo>
                  <a:pt x="2018976" y="6080670"/>
                </a:lnTo>
                <a:lnTo>
                  <a:pt x="2018976" y="6009369"/>
                </a:lnTo>
                <a:close/>
                <a:moveTo>
                  <a:pt x="1805074" y="6009369"/>
                </a:moveTo>
                <a:lnTo>
                  <a:pt x="1805074" y="6080670"/>
                </a:lnTo>
                <a:lnTo>
                  <a:pt x="1876375" y="6080670"/>
                </a:lnTo>
                <a:lnTo>
                  <a:pt x="1876375" y="6009369"/>
                </a:lnTo>
                <a:close/>
                <a:moveTo>
                  <a:pt x="1662401" y="6009369"/>
                </a:moveTo>
                <a:lnTo>
                  <a:pt x="1662401" y="6080670"/>
                </a:lnTo>
                <a:lnTo>
                  <a:pt x="1733702" y="6080670"/>
                </a:lnTo>
                <a:lnTo>
                  <a:pt x="1733702" y="6009369"/>
                </a:lnTo>
                <a:close/>
                <a:moveTo>
                  <a:pt x="1519800" y="6009369"/>
                </a:moveTo>
                <a:lnTo>
                  <a:pt x="1519800" y="6080670"/>
                </a:lnTo>
                <a:lnTo>
                  <a:pt x="1591101" y="6080670"/>
                </a:lnTo>
                <a:lnTo>
                  <a:pt x="1591101" y="6009369"/>
                </a:lnTo>
                <a:close/>
                <a:moveTo>
                  <a:pt x="1377127" y="6009369"/>
                </a:moveTo>
                <a:lnTo>
                  <a:pt x="1377127" y="6080670"/>
                </a:lnTo>
                <a:lnTo>
                  <a:pt x="1448428" y="6080670"/>
                </a:lnTo>
                <a:lnTo>
                  <a:pt x="1448428" y="6009369"/>
                </a:lnTo>
                <a:close/>
                <a:moveTo>
                  <a:pt x="1234455" y="6009369"/>
                </a:moveTo>
                <a:lnTo>
                  <a:pt x="1234455" y="6080670"/>
                </a:lnTo>
                <a:lnTo>
                  <a:pt x="1305756" y="6080670"/>
                </a:lnTo>
                <a:lnTo>
                  <a:pt x="1305756" y="6009369"/>
                </a:lnTo>
                <a:close/>
                <a:moveTo>
                  <a:pt x="1091853" y="6009369"/>
                </a:moveTo>
                <a:lnTo>
                  <a:pt x="1091853" y="6080670"/>
                </a:lnTo>
                <a:lnTo>
                  <a:pt x="1163154" y="6080670"/>
                </a:lnTo>
                <a:lnTo>
                  <a:pt x="1163154" y="6009369"/>
                </a:lnTo>
                <a:close/>
                <a:moveTo>
                  <a:pt x="949180" y="6009369"/>
                </a:moveTo>
                <a:lnTo>
                  <a:pt x="949180" y="6080670"/>
                </a:lnTo>
                <a:lnTo>
                  <a:pt x="1020481" y="6080670"/>
                </a:lnTo>
                <a:lnTo>
                  <a:pt x="1020481" y="6009369"/>
                </a:lnTo>
                <a:close/>
                <a:moveTo>
                  <a:pt x="6807516" y="0"/>
                </a:moveTo>
                <a:lnTo>
                  <a:pt x="6809163" y="6826901"/>
                </a:lnTo>
                <a:lnTo>
                  <a:pt x="0" y="6826901"/>
                </a:lnTo>
                <a:lnTo>
                  <a:pt x="378632" y="6447189"/>
                </a:lnTo>
                <a:lnTo>
                  <a:pt x="378632" y="6514582"/>
                </a:lnTo>
                <a:lnTo>
                  <a:pt x="449934" y="6514582"/>
                </a:lnTo>
                <a:lnTo>
                  <a:pt x="449934" y="6443281"/>
                </a:lnTo>
                <a:lnTo>
                  <a:pt x="382530" y="6443281"/>
                </a:lnTo>
                <a:lnTo>
                  <a:pt x="521234" y="6304180"/>
                </a:lnTo>
                <a:lnTo>
                  <a:pt x="521234" y="6365944"/>
                </a:lnTo>
                <a:lnTo>
                  <a:pt x="592536" y="6365944"/>
                </a:lnTo>
                <a:lnTo>
                  <a:pt x="592536" y="6294643"/>
                </a:lnTo>
                <a:lnTo>
                  <a:pt x="530745" y="6294643"/>
                </a:lnTo>
                <a:lnTo>
                  <a:pt x="663906" y="6161102"/>
                </a:lnTo>
                <a:lnTo>
                  <a:pt x="663906" y="6223342"/>
                </a:lnTo>
                <a:lnTo>
                  <a:pt x="735207" y="6223342"/>
                </a:lnTo>
                <a:lnTo>
                  <a:pt x="735207" y="6152041"/>
                </a:lnTo>
                <a:lnTo>
                  <a:pt x="672942" y="6152041"/>
                </a:lnTo>
                <a:lnTo>
                  <a:pt x="806579" y="6018022"/>
                </a:lnTo>
                <a:lnTo>
                  <a:pt x="806579" y="6080670"/>
                </a:lnTo>
                <a:lnTo>
                  <a:pt x="877880" y="6080670"/>
                </a:lnTo>
                <a:lnTo>
                  <a:pt x="877880" y="6009369"/>
                </a:lnTo>
                <a:lnTo>
                  <a:pt x="815208" y="6009369"/>
                </a:lnTo>
                <a:close/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noAutofit/>
          </a:bodyPr>
          <a:lstStyle>
            <a:lvl1pPr marL="0" indent="0" algn="r">
              <a:buNone/>
              <a:defRPr/>
            </a:lvl1pPr>
          </a:lstStyle>
          <a:p>
            <a:r>
              <a:rPr lang="nl-NL" sz="1463" i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Klik op deze vorm en kies een afbeelding uit de Templafy bibliotheek</a:t>
            </a:r>
            <a:endParaRPr lang="en-US"/>
          </a:p>
        </p:txBody>
      </p:sp>
      <p:sp>
        <p:nvSpPr>
          <p:cNvPr id="80" name="Text Placeholder 2059">
            <a:extLst>
              <a:ext uri="{FF2B5EF4-FFF2-40B4-BE49-F238E27FC236}">
                <a16:creationId xmlns:a16="http://schemas.microsoft.com/office/drawing/2014/main" id="{09052932-03B9-4400-AE30-DE65E4F075D0}"/>
              </a:ext>
            </a:extLst>
          </p:cNvPr>
          <p:cNvSpPr>
            <a:spLocks noGrp="1"/>
          </p:cNvSpPr>
          <p:nvPr userDrawn="1">
            <p:ph type="body" sz="quarter" idx="15" hasCustomPrompt="1"/>
          </p:nvPr>
        </p:nvSpPr>
        <p:spPr>
          <a:xfrm>
            <a:off x="8384164" y="6026150"/>
            <a:ext cx="1272897" cy="617539"/>
          </a:xfrm>
          <a:blipFill dpi="0"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r>
              <a:rPr lang="en-US"/>
              <a:t> </a:t>
            </a:r>
          </a:p>
        </p:txBody>
      </p:sp>
      <p:sp>
        <p:nvSpPr>
          <p:cNvPr id="84" name="Titel 1">
            <a:extLst>
              <a:ext uri="{FF2B5EF4-FFF2-40B4-BE49-F238E27FC236}">
                <a16:creationId xmlns:a16="http://schemas.microsoft.com/office/drawing/2014/main" id="{47AE4C24-5AF6-4E4A-9315-DADF6661528D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513358" y="1776549"/>
            <a:ext cx="6022176" cy="894117"/>
          </a:xfrm>
        </p:spPr>
        <p:txBody>
          <a:bodyPr anchor="t">
            <a:noAutofit/>
          </a:bodyPr>
          <a:lstStyle>
            <a:lvl1pPr algn="l">
              <a:defRPr sz="4875">
                <a:solidFill>
                  <a:schemeClr val="accent1"/>
                </a:solidFill>
              </a:defRPr>
            </a:lvl1pPr>
          </a:lstStyle>
          <a:p>
            <a:r>
              <a:rPr lang="nl-NL"/>
              <a:t>Voeg titel toe</a:t>
            </a:r>
          </a:p>
        </p:txBody>
      </p:sp>
      <p:sp>
        <p:nvSpPr>
          <p:cNvPr id="86" name="Freeform: Shape 85">
            <a:extLst>
              <a:ext uri="{FF2B5EF4-FFF2-40B4-BE49-F238E27FC236}">
                <a16:creationId xmlns:a16="http://schemas.microsoft.com/office/drawing/2014/main" id="{D3477D4A-1B0D-4855-AED5-020E217FE9FF}"/>
              </a:ext>
            </a:extLst>
          </p:cNvPr>
          <p:cNvSpPr/>
          <p:nvPr userDrawn="1"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87" name="Freeform: Shape 86">
            <a:extLst>
              <a:ext uri="{FF2B5EF4-FFF2-40B4-BE49-F238E27FC236}">
                <a16:creationId xmlns:a16="http://schemas.microsoft.com/office/drawing/2014/main" id="{5BD62A7A-5FD3-4FEB-9530-EE0F5C360BF2}"/>
              </a:ext>
            </a:extLst>
          </p:cNvPr>
          <p:cNvSpPr/>
          <p:nvPr userDrawn="1"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88" name="Freeform: Shape 87">
            <a:extLst>
              <a:ext uri="{FF2B5EF4-FFF2-40B4-BE49-F238E27FC236}">
                <a16:creationId xmlns:a16="http://schemas.microsoft.com/office/drawing/2014/main" id="{BF4E971B-879B-492E-8AAF-364F70D9EBD3}"/>
              </a:ext>
            </a:extLst>
          </p:cNvPr>
          <p:cNvSpPr/>
          <p:nvPr userDrawn="1"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89" name="Freeform: Shape 88">
            <a:extLst>
              <a:ext uri="{FF2B5EF4-FFF2-40B4-BE49-F238E27FC236}">
                <a16:creationId xmlns:a16="http://schemas.microsoft.com/office/drawing/2014/main" id="{0CA55659-6962-4045-9083-644EB9C284B3}"/>
              </a:ext>
            </a:extLst>
          </p:cNvPr>
          <p:cNvSpPr/>
          <p:nvPr userDrawn="1"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0" name="Freeform: Shape 89">
            <a:extLst>
              <a:ext uri="{FF2B5EF4-FFF2-40B4-BE49-F238E27FC236}">
                <a16:creationId xmlns:a16="http://schemas.microsoft.com/office/drawing/2014/main" id="{EA8B184D-B4CC-4BCE-92F0-0D4497CF0DAC}"/>
              </a:ext>
            </a:extLst>
          </p:cNvPr>
          <p:cNvSpPr/>
          <p:nvPr userDrawn="1"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1" name="Freeform: Shape 90">
            <a:extLst>
              <a:ext uri="{FF2B5EF4-FFF2-40B4-BE49-F238E27FC236}">
                <a16:creationId xmlns:a16="http://schemas.microsoft.com/office/drawing/2014/main" id="{BA4EDA8B-7AE3-4FA2-9C3A-AECE66D040AE}"/>
              </a:ext>
            </a:extLst>
          </p:cNvPr>
          <p:cNvSpPr/>
          <p:nvPr userDrawn="1"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2" name="Freeform: Shape 91">
            <a:extLst>
              <a:ext uri="{FF2B5EF4-FFF2-40B4-BE49-F238E27FC236}">
                <a16:creationId xmlns:a16="http://schemas.microsoft.com/office/drawing/2014/main" id="{CDBAE73D-B3FA-4C9F-93B2-EDE39CFAD2E1}"/>
              </a:ext>
            </a:extLst>
          </p:cNvPr>
          <p:cNvSpPr/>
          <p:nvPr userDrawn="1"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3" name="Freeform: Shape 92">
            <a:extLst>
              <a:ext uri="{FF2B5EF4-FFF2-40B4-BE49-F238E27FC236}">
                <a16:creationId xmlns:a16="http://schemas.microsoft.com/office/drawing/2014/main" id="{93776FFC-3176-4623-8D60-367E08FCE2B7}"/>
              </a:ext>
            </a:extLst>
          </p:cNvPr>
          <p:cNvSpPr/>
          <p:nvPr userDrawn="1"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4" name="Freeform: Shape 93">
            <a:extLst>
              <a:ext uri="{FF2B5EF4-FFF2-40B4-BE49-F238E27FC236}">
                <a16:creationId xmlns:a16="http://schemas.microsoft.com/office/drawing/2014/main" id="{40993F3E-2EF6-47BC-AA1A-D377BD805AE2}"/>
              </a:ext>
            </a:extLst>
          </p:cNvPr>
          <p:cNvSpPr/>
          <p:nvPr userDrawn="1"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5" name="Freeform: Shape 94">
            <a:extLst>
              <a:ext uri="{FF2B5EF4-FFF2-40B4-BE49-F238E27FC236}">
                <a16:creationId xmlns:a16="http://schemas.microsoft.com/office/drawing/2014/main" id="{5403741D-A913-4F97-85DE-B43A88A382C9}"/>
              </a:ext>
            </a:extLst>
          </p:cNvPr>
          <p:cNvSpPr/>
          <p:nvPr userDrawn="1"/>
        </p:nvSpPr>
        <p:spPr>
          <a:xfrm>
            <a:off x="5825234" y="-345714"/>
            <a:ext cx="5770" cy="7101"/>
          </a:xfrm>
          <a:custGeom>
            <a:avLst/>
            <a:gdLst/>
            <a:ahLst/>
            <a:cxnLst/>
            <a:rect l="l" t="t" r="r" b="b"/>
            <a:pathLst>
              <a:path w="7101" h="7101"/>
            </a:pathLst>
          </a:custGeom>
          <a:noFill/>
          <a:ln w="24686" cap="flat">
            <a:solidFill>
              <a:srgbClr val="85D1EC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grpSp>
        <p:nvGrpSpPr>
          <p:cNvPr id="649" name="Group 648">
            <a:extLst>
              <a:ext uri="{FF2B5EF4-FFF2-40B4-BE49-F238E27FC236}">
                <a16:creationId xmlns:a16="http://schemas.microsoft.com/office/drawing/2014/main" id="{952A5519-D437-4A8B-A663-A8A33FA7FC5C}"/>
              </a:ext>
            </a:extLst>
          </p:cNvPr>
          <p:cNvGrpSpPr/>
          <p:nvPr userDrawn="1"/>
        </p:nvGrpSpPr>
        <p:grpSpPr>
          <a:xfrm>
            <a:off x="47096" y="6040468"/>
            <a:ext cx="8168924" cy="505212"/>
            <a:chOff x="57964" y="6040468"/>
            <a:chExt cx="10054060" cy="505212"/>
          </a:xfrm>
          <a:solidFill>
            <a:schemeClr val="bg1"/>
          </a:solidFill>
        </p:grpSpPr>
        <p:sp>
          <p:nvSpPr>
            <p:cNvPr id="650" name="Freeform: Shape 649">
              <a:extLst>
                <a:ext uri="{FF2B5EF4-FFF2-40B4-BE49-F238E27FC236}">
                  <a16:creationId xmlns:a16="http://schemas.microsoft.com/office/drawing/2014/main" id="{4A7579D9-3E86-43B0-9A0A-ED11D977BEDA}"/>
                </a:ext>
              </a:extLst>
            </p:cNvPr>
            <p:cNvSpPr/>
            <p:nvPr/>
          </p:nvSpPr>
          <p:spPr>
            <a:xfrm>
              <a:off x="918490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1" name="Freeform: Shape 650">
              <a:extLst>
                <a:ext uri="{FF2B5EF4-FFF2-40B4-BE49-F238E27FC236}">
                  <a16:creationId xmlns:a16="http://schemas.microsoft.com/office/drawing/2014/main" id="{84CA168E-8F9F-4A32-BA8F-DADFEA16E4B7}"/>
                </a:ext>
              </a:extLst>
            </p:cNvPr>
            <p:cNvSpPr/>
            <p:nvPr/>
          </p:nvSpPr>
          <p:spPr>
            <a:xfrm>
              <a:off x="918490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2" name="Freeform: Shape 651">
              <a:extLst>
                <a:ext uri="{FF2B5EF4-FFF2-40B4-BE49-F238E27FC236}">
                  <a16:creationId xmlns:a16="http://schemas.microsoft.com/office/drawing/2014/main" id="{AD730FAD-CDC3-49E6-BA15-7B907AAD4D23}"/>
                </a:ext>
              </a:extLst>
            </p:cNvPr>
            <p:cNvSpPr/>
            <p:nvPr/>
          </p:nvSpPr>
          <p:spPr>
            <a:xfrm>
              <a:off x="918490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3" name="Freeform: Shape 652">
              <a:extLst>
                <a:ext uri="{FF2B5EF4-FFF2-40B4-BE49-F238E27FC236}">
                  <a16:creationId xmlns:a16="http://schemas.microsoft.com/office/drawing/2014/main" id="{CD62EDF1-3DF8-440D-B5ED-45AAAFF5671D}"/>
                </a:ext>
              </a:extLst>
            </p:cNvPr>
            <p:cNvSpPr/>
            <p:nvPr/>
          </p:nvSpPr>
          <p:spPr>
            <a:xfrm>
              <a:off x="932750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4" name="Freeform: Shape 653">
              <a:extLst>
                <a:ext uri="{FF2B5EF4-FFF2-40B4-BE49-F238E27FC236}">
                  <a16:creationId xmlns:a16="http://schemas.microsoft.com/office/drawing/2014/main" id="{887E48FE-D4AD-4ECB-B036-AA78FEDC71DE}"/>
                </a:ext>
              </a:extLst>
            </p:cNvPr>
            <p:cNvSpPr/>
            <p:nvPr/>
          </p:nvSpPr>
          <p:spPr>
            <a:xfrm>
              <a:off x="932750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5" name="Freeform: Shape 654">
              <a:extLst>
                <a:ext uri="{FF2B5EF4-FFF2-40B4-BE49-F238E27FC236}">
                  <a16:creationId xmlns:a16="http://schemas.microsoft.com/office/drawing/2014/main" id="{DD0AB86F-549C-4197-814B-C0BEE456379B}"/>
                </a:ext>
              </a:extLst>
            </p:cNvPr>
            <p:cNvSpPr/>
            <p:nvPr/>
          </p:nvSpPr>
          <p:spPr>
            <a:xfrm>
              <a:off x="932750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6" name="Freeform: Shape 655">
              <a:extLst>
                <a:ext uri="{FF2B5EF4-FFF2-40B4-BE49-F238E27FC236}">
                  <a16:creationId xmlns:a16="http://schemas.microsoft.com/office/drawing/2014/main" id="{B3A9E766-475E-45D7-81CA-DE49036C11D8}"/>
                </a:ext>
              </a:extLst>
            </p:cNvPr>
            <p:cNvSpPr/>
            <p:nvPr/>
          </p:nvSpPr>
          <p:spPr>
            <a:xfrm>
              <a:off x="947017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7" name="Freeform: Shape 656">
              <a:extLst>
                <a:ext uri="{FF2B5EF4-FFF2-40B4-BE49-F238E27FC236}">
                  <a16:creationId xmlns:a16="http://schemas.microsoft.com/office/drawing/2014/main" id="{ED0D4E3C-55B4-4BED-91C4-F6EA2137F3DD}"/>
                </a:ext>
              </a:extLst>
            </p:cNvPr>
            <p:cNvSpPr/>
            <p:nvPr/>
          </p:nvSpPr>
          <p:spPr>
            <a:xfrm>
              <a:off x="947017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8" name="Freeform: Shape 657">
              <a:extLst>
                <a:ext uri="{FF2B5EF4-FFF2-40B4-BE49-F238E27FC236}">
                  <a16:creationId xmlns:a16="http://schemas.microsoft.com/office/drawing/2014/main" id="{360C6004-1BF8-41EB-8CAF-F15FB0802B3E}"/>
                </a:ext>
              </a:extLst>
            </p:cNvPr>
            <p:cNvSpPr/>
            <p:nvPr/>
          </p:nvSpPr>
          <p:spPr>
            <a:xfrm>
              <a:off x="947017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9" name="Freeform: Shape 658">
              <a:extLst>
                <a:ext uri="{FF2B5EF4-FFF2-40B4-BE49-F238E27FC236}">
                  <a16:creationId xmlns:a16="http://schemas.microsoft.com/office/drawing/2014/main" id="{3A66472D-1D37-4FFB-8731-BB2F9C61273E}"/>
                </a:ext>
              </a:extLst>
            </p:cNvPr>
            <p:cNvSpPr/>
            <p:nvPr/>
          </p:nvSpPr>
          <p:spPr>
            <a:xfrm>
              <a:off x="961277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0" name="Freeform: Shape 659">
              <a:extLst>
                <a:ext uri="{FF2B5EF4-FFF2-40B4-BE49-F238E27FC236}">
                  <a16:creationId xmlns:a16="http://schemas.microsoft.com/office/drawing/2014/main" id="{F7448FFD-193B-428F-A58A-20C90547954B}"/>
                </a:ext>
              </a:extLst>
            </p:cNvPr>
            <p:cNvSpPr/>
            <p:nvPr/>
          </p:nvSpPr>
          <p:spPr>
            <a:xfrm>
              <a:off x="961277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1" name="Freeform: Shape 660">
              <a:extLst>
                <a:ext uri="{FF2B5EF4-FFF2-40B4-BE49-F238E27FC236}">
                  <a16:creationId xmlns:a16="http://schemas.microsoft.com/office/drawing/2014/main" id="{81D0E35F-8D82-4808-A418-B0819A834ADF}"/>
                </a:ext>
              </a:extLst>
            </p:cNvPr>
            <p:cNvSpPr/>
            <p:nvPr/>
          </p:nvSpPr>
          <p:spPr>
            <a:xfrm>
              <a:off x="961277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2" name="Freeform: Shape 661">
              <a:extLst>
                <a:ext uri="{FF2B5EF4-FFF2-40B4-BE49-F238E27FC236}">
                  <a16:creationId xmlns:a16="http://schemas.microsoft.com/office/drawing/2014/main" id="{635A3189-5725-4751-9F9A-10150E752D75}"/>
                </a:ext>
              </a:extLst>
            </p:cNvPr>
            <p:cNvSpPr/>
            <p:nvPr/>
          </p:nvSpPr>
          <p:spPr>
            <a:xfrm>
              <a:off x="975545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3" name="Freeform: Shape 662">
              <a:extLst>
                <a:ext uri="{FF2B5EF4-FFF2-40B4-BE49-F238E27FC236}">
                  <a16:creationId xmlns:a16="http://schemas.microsoft.com/office/drawing/2014/main" id="{3673D3F1-1669-495D-9EA0-BF2AFFF76D98}"/>
                </a:ext>
              </a:extLst>
            </p:cNvPr>
            <p:cNvSpPr/>
            <p:nvPr/>
          </p:nvSpPr>
          <p:spPr>
            <a:xfrm>
              <a:off x="975545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4" name="Freeform: Shape 663">
              <a:extLst>
                <a:ext uri="{FF2B5EF4-FFF2-40B4-BE49-F238E27FC236}">
                  <a16:creationId xmlns:a16="http://schemas.microsoft.com/office/drawing/2014/main" id="{66830FA0-3E46-4524-BBC1-225DED9B19C0}"/>
                </a:ext>
              </a:extLst>
            </p:cNvPr>
            <p:cNvSpPr/>
            <p:nvPr/>
          </p:nvSpPr>
          <p:spPr>
            <a:xfrm>
              <a:off x="975545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5" name="Freeform: Shape 664">
              <a:extLst>
                <a:ext uri="{FF2B5EF4-FFF2-40B4-BE49-F238E27FC236}">
                  <a16:creationId xmlns:a16="http://schemas.microsoft.com/office/drawing/2014/main" id="{88CEE22A-D448-437C-A76A-6E57C851BFFB}"/>
                </a:ext>
              </a:extLst>
            </p:cNvPr>
            <p:cNvSpPr/>
            <p:nvPr/>
          </p:nvSpPr>
          <p:spPr>
            <a:xfrm>
              <a:off x="989812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6" name="Freeform: Shape 665">
              <a:extLst>
                <a:ext uri="{FF2B5EF4-FFF2-40B4-BE49-F238E27FC236}">
                  <a16:creationId xmlns:a16="http://schemas.microsoft.com/office/drawing/2014/main" id="{996CBA5F-6BAE-451A-B3E7-2F02EBAD4DA9}"/>
                </a:ext>
              </a:extLst>
            </p:cNvPr>
            <p:cNvSpPr/>
            <p:nvPr/>
          </p:nvSpPr>
          <p:spPr>
            <a:xfrm>
              <a:off x="989812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7" name="Freeform: Shape 666">
              <a:extLst>
                <a:ext uri="{FF2B5EF4-FFF2-40B4-BE49-F238E27FC236}">
                  <a16:creationId xmlns:a16="http://schemas.microsoft.com/office/drawing/2014/main" id="{3E0F6371-CAC6-451D-850D-45E04BAE8764}"/>
                </a:ext>
              </a:extLst>
            </p:cNvPr>
            <p:cNvSpPr/>
            <p:nvPr/>
          </p:nvSpPr>
          <p:spPr>
            <a:xfrm>
              <a:off x="1004072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8" name="Freeform: Shape 667">
              <a:extLst>
                <a:ext uri="{FF2B5EF4-FFF2-40B4-BE49-F238E27FC236}">
                  <a16:creationId xmlns:a16="http://schemas.microsoft.com/office/drawing/2014/main" id="{03B625C9-3894-4CBE-BE41-A31D5C0B957C}"/>
                </a:ext>
              </a:extLst>
            </p:cNvPr>
            <p:cNvSpPr/>
            <p:nvPr/>
          </p:nvSpPr>
          <p:spPr>
            <a:xfrm>
              <a:off x="1004072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69" name="Freeform: Shape 668">
              <a:extLst>
                <a:ext uri="{FF2B5EF4-FFF2-40B4-BE49-F238E27FC236}">
                  <a16:creationId xmlns:a16="http://schemas.microsoft.com/office/drawing/2014/main" id="{542C7D84-BEF8-40ED-873A-732694A81B71}"/>
                </a:ext>
              </a:extLst>
            </p:cNvPr>
            <p:cNvSpPr/>
            <p:nvPr/>
          </p:nvSpPr>
          <p:spPr>
            <a:xfrm>
              <a:off x="504825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0" name="Freeform: Shape 669">
              <a:extLst>
                <a:ext uri="{FF2B5EF4-FFF2-40B4-BE49-F238E27FC236}">
                  <a16:creationId xmlns:a16="http://schemas.microsoft.com/office/drawing/2014/main" id="{6587352D-FBF4-47B6-B5C3-541A3F884123}"/>
                </a:ext>
              </a:extLst>
            </p:cNvPr>
            <p:cNvSpPr/>
            <p:nvPr/>
          </p:nvSpPr>
          <p:spPr>
            <a:xfrm>
              <a:off x="761578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1" name="Freeform: Shape 670">
              <a:extLst>
                <a:ext uri="{FF2B5EF4-FFF2-40B4-BE49-F238E27FC236}">
                  <a16:creationId xmlns:a16="http://schemas.microsoft.com/office/drawing/2014/main" id="{46BB5D62-C8A5-4D69-8BAE-AF8BD25FAE0A}"/>
                </a:ext>
              </a:extLst>
            </p:cNvPr>
            <p:cNvSpPr/>
            <p:nvPr/>
          </p:nvSpPr>
          <p:spPr>
            <a:xfrm>
              <a:off x="504825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2" name="Freeform: Shape 671">
              <a:extLst>
                <a:ext uri="{FF2B5EF4-FFF2-40B4-BE49-F238E27FC236}">
                  <a16:creationId xmlns:a16="http://schemas.microsoft.com/office/drawing/2014/main" id="{FC9749F5-738D-46E6-83F2-2931A503E6DE}"/>
                </a:ext>
              </a:extLst>
            </p:cNvPr>
            <p:cNvSpPr/>
            <p:nvPr/>
          </p:nvSpPr>
          <p:spPr>
            <a:xfrm>
              <a:off x="504825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3" name="Freeform: Shape 672">
              <a:extLst>
                <a:ext uri="{FF2B5EF4-FFF2-40B4-BE49-F238E27FC236}">
                  <a16:creationId xmlns:a16="http://schemas.microsoft.com/office/drawing/2014/main" id="{74CBB2AF-84B3-4003-A722-567D361D1E3D}"/>
                </a:ext>
              </a:extLst>
            </p:cNvPr>
            <p:cNvSpPr/>
            <p:nvPr/>
          </p:nvSpPr>
          <p:spPr>
            <a:xfrm>
              <a:off x="504825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4" name="Freeform: Shape 673">
              <a:extLst>
                <a:ext uri="{FF2B5EF4-FFF2-40B4-BE49-F238E27FC236}">
                  <a16:creationId xmlns:a16="http://schemas.microsoft.com/office/drawing/2014/main" id="{51E65849-3AEC-402F-AE7E-177B6B34325A}"/>
                </a:ext>
              </a:extLst>
            </p:cNvPr>
            <p:cNvSpPr/>
            <p:nvPr/>
          </p:nvSpPr>
          <p:spPr>
            <a:xfrm>
              <a:off x="761578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5" name="Freeform: Shape 674">
              <a:extLst>
                <a:ext uri="{FF2B5EF4-FFF2-40B4-BE49-F238E27FC236}">
                  <a16:creationId xmlns:a16="http://schemas.microsoft.com/office/drawing/2014/main" id="{C75632EE-14C7-4C1A-8632-96090159F28C}"/>
                </a:ext>
              </a:extLst>
            </p:cNvPr>
            <p:cNvSpPr/>
            <p:nvPr/>
          </p:nvSpPr>
          <p:spPr>
            <a:xfrm>
              <a:off x="761578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6" name="Freeform: Shape 675">
              <a:extLst>
                <a:ext uri="{FF2B5EF4-FFF2-40B4-BE49-F238E27FC236}">
                  <a16:creationId xmlns:a16="http://schemas.microsoft.com/office/drawing/2014/main" id="{F4A90CF0-66B4-43AB-AC71-AA0D566E8918}"/>
                </a:ext>
              </a:extLst>
            </p:cNvPr>
            <p:cNvSpPr/>
            <p:nvPr/>
          </p:nvSpPr>
          <p:spPr>
            <a:xfrm>
              <a:off x="761578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7" name="Freeform: Shape 676">
              <a:extLst>
                <a:ext uri="{FF2B5EF4-FFF2-40B4-BE49-F238E27FC236}">
                  <a16:creationId xmlns:a16="http://schemas.microsoft.com/office/drawing/2014/main" id="{C1E7A849-D9BA-4A74-A5C2-9F07A17D68A9}"/>
                </a:ext>
              </a:extLst>
            </p:cNvPr>
            <p:cNvSpPr/>
            <p:nvPr/>
          </p:nvSpPr>
          <p:spPr>
            <a:xfrm>
              <a:off x="533352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8" name="Freeform: Shape 677">
              <a:extLst>
                <a:ext uri="{FF2B5EF4-FFF2-40B4-BE49-F238E27FC236}">
                  <a16:creationId xmlns:a16="http://schemas.microsoft.com/office/drawing/2014/main" id="{CADD2EA7-F904-4F09-8F28-48DE098F3129}"/>
                </a:ext>
              </a:extLst>
            </p:cNvPr>
            <p:cNvSpPr/>
            <p:nvPr/>
          </p:nvSpPr>
          <p:spPr>
            <a:xfrm>
              <a:off x="790106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9" name="Freeform: Shape 678">
              <a:extLst>
                <a:ext uri="{FF2B5EF4-FFF2-40B4-BE49-F238E27FC236}">
                  <a16:creationId xmlns:a16="http://schemas.microsoft.com/office/drawing/2014/main" id="{2A533467-DE69-4C76-A1BC-E3635299B712}"/>
                </a:ext>
              </a:extLst>
            </p:cNvPr>
            <p:cNvSpPr/>
            <p:nvPr/>
          </p:nvSpPr>
          <p:spPr>
            <a:xfrm>
              <a:off x="533352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0" name="Freeform: Shape 679">
              <a:extLst>
                <a:ext uri="{FF2B5EF4-FFF2-40B4-BE49-F238E27FC236}">
                  <a16:creationId xmlns:a16="http://schemas.microsoft.com/office/drawing/2014/main" id="{A580345E-E074-4EB4-9D11-926117D83506}"/>
                </a:ext>
              </a:extLst>
            </p:cNvPr>
            <p:cNvSpPr/>
            <p:nvPr/>
          </p:nvSpPr>
          <p:spPr>
            <a:xfrm>
              <a:off x="533352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1" name="Freeform: Shape 680">
              <a:extLst>
                <a:ext uri="{FF2B5EF4-FFF2-40B4-BE49-F238E27FC236}">
                  <a16:creationId xmlns:a16="http://schemas.microsoft.com/office/drawing/2014/main" id="{C53BCC5A-B21A-4E36-A7DC-C1C5B9F15026}"/>
                </a:ext>
              </a:extLst>
            </p:cNvPr>
            <p:cNvSpPr/>
            <p:nvPr/>
          </p:nvSpPr>
          <p:spPr>
            <a:xfrm>
              <a:off x="533352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2" name="Freeform: Shape 681">
              <a:extLst>
                <a:ext uri="{FF2B5EF4-FFF2-40B4-BE49-F238E27FC236}">
                  <a16:creationId xmlns:a16="http://schemas.microsoft.com/office/drawing/2014/main" id="{AE903234-3D0A-4DF1-BCF0-BF078E8860BF}"/>
                </a:ext>
              </a:extLst>
            </p:cNvPr>
            <p:cNvSpPr/>
            <p:nvPr/>
          </p:nvSpPr>
          <p:spPr>
            <a:xfrm>
              <a:off x="790106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3" name="Freeform: Shape 682">
              <a:extLst>
                <a:ext uri="{FF2B5EF4-FFF2-40B4-BE49-F238E27FC236}">
                  <a16:creationId xmlns:a16="http://schemas.microsoft.com/office/drawing/2014/main" id="{1DBBE67A-4AE5-4D31-9ED3-F0DFBE773BAF}"/>
                </a:ext>
              </a:extLst>
            </p:cNvPr>
            <p:cNvSpPr/>
            <p:nvPr/>
          </p:nvSpPr>
          <p:spPr>
            <a:xfrm>
              <a:off x="790106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4" name="Freeform: Shape 683">
              <a:extLst>
                <a:ext uri="{FF2B5EF4-FFF2-40B4-BE49-F238E27FC236}">
                  <a16:creationId xmlns:a16="http://schemas.microsoft.com/office/drawing/2014/main" id="{B2AD4B2B-0DEF-4E8E-9D03-6980E67D9013}"/>
                </a:ext>
              </a:extLst>
            </p:cNvPr>
            <p:cNvSpPr/>
            <p:nvPr/>
          </p:nvSpPr>
          <p:spPr>
            <a:xfrm>
              <a:off x="790106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5" name="Freeform: Shape 684">
              <a:extLst>
                <a:ext uri="{FF2B5EF4-FFF2-40B4-BE49-F238E27FC236}">
                  <a16:creationId xmlns:a16="http://schemas.microsoft.com/office/drawing/2014/main" id="{FE57C8BC-2F27-4F10-99AF-8541147FB6B4}"/>
                </a:ext>
              </a:extLst>
            </p:cNvPr>
            <p:cNvSpPr/>
            <p:nvPr/>
          </p:nvSpPr>
          <p:spPr>
            <a:xfrm>
              <a:off x="547619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6" name="Freeform: Shape 685">
              <a:extLst>
                <a:ext uri="{FF2B5EF4-FFF2-40B4-BE49-F238E27FC236}">
                  <a16:creationId xmlns:a16="http://schemas.microsoft.com/office/drawing/2014/main" id="{5D43F4D9-81F3-47A8-84A1-77C7A03E6334}"/>
                </a:ext>
              </a:extLst>
            </p:cNvPr>
            <p:cNvSpPr/>
            <p:nvPr/>
          </p:nvSpPr>
          <p:spPr>
            <a:xfrm>
              <a:off x="804373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7" name="Freeform: Shape 686">
              <a:extLst>
                <a:ext uri="{FF2B5EF4-FFF2-40B4-BE49-F238E27FC236}">
                  <a16:creationId xmlns:a16="http://schemas.microsoft.com/office/drawing/2014/main" id="{A4F7B9A9-0A53-4676-AC53-E6D4067843E6}"/>
                </a:ext>
              </a:extLst>
            </p:cNvPr>
            <p:cNvSpPr/>
            <p:nvPr/>
          </p:nvSpPr>
          <p:spPr>
            <a:xfrm>
              <a:off x="547619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8" name="Freeform: Shape 687">
              <a:extLst>
                <a:ext uri="{FF2B5EF4-FFF2-40B4-BE49-F238E27FC236}">
                  <a16:creationId xmlns:a16="http://schemas.microsoft.com/office/drawing/2014/main" id="{B8B43929-4B9F-476C-BF2B-71DC2D35F47F}"/>
                </a:ext>
              </a:extLst>
            </p:cNvPr>
            <p:cNvSpPr/>
            <p:nvPr/>
          </p:nvSpPr>
          <p:spPr>
            <a:xfrm>
              <a:off x="547619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9" name="Freeform: Shape 688">
              <a:extLst>
                <a:ext uri="{FF2B5EF4-FFF2-40B4-BE49-F238E27FC236}">
                  <a16:creationId xmlns:a16="http://schemas.microsoft.com/office/drawing/2014/main" id="{6D1B900B-E747-470B-81C3-44F168D0A1EC}"/>
                </a:ext>
              </a:extLst>
            </p:cNvPr>
            <p:cNvSpPr/>
            <p:nvPr/>
          </p:nvSpPr>
          <p:spPr>
            <a:xfrm>
              <a:off x="547619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0" name="Freeform: Shape 689">
              <a:extLst>
                <a:ext uri="{FF2B5EF4-FFF2-40B4-BE49-F238E27FC236}">
                  <a16:creationId xmlns:a16="http://schemas.microsoft.com/office/drawing/2014/main" id="{DF13123C-E761-4ABE-9A5D-62DBCB36EDF8}"/>
                </a:ext>
              </a:extLst>
            </p:cNvPr>
            <p:cNvSpPr/>
            <p:nvPr/>
          </p:nvSpPr>
          <p:spPr>
            <a:xfrm>
              <a:off x="804373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1" name="Freeform: Shape 690">
              <a:extLst>
                <a:ext uri="{FF2B5EF4-FFF2-40B4-BE49-F238E27FC236}">
                  <a16:creationId xmlns:a16="http://schemas.microsoft.com/office/drawing/2014/main" id="{D421FCD1-F7FF-4AED-9617-DD8466B6E42A}"/>
                </a:ext>
              </a:extLst>
            </p:cNvPr>
            <p:cNvSpPr/>
            <p:nvPr/>
          </p:nvSpPr>
          <p:spPr>
            <a:xfrm>
              <a:off x="804373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2" name="Freeform: Shape 691">
              <a:extLst>
                <a:ext uri="{FF2B5EF4-FFF2-40B4-BE49-F238E27FC236}">
                  <a16:creationId xmlns:a16="http://schemas.microsoft.com/office/drawing/2014/main" id="{8FD0302A-AD9D-41F8-88BC-AAA97CC330AC}"/>
                </a:ext>
              </a:extLst>
            </p:cNvPr>
            <p:cNvSpPr/>
            <p:nvPr/>
          </p:nvSpPr>
          <p:spPr>
            <a:xfrm>
              <a:off x="804373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3" name="Freeform: Shape 692">
              <a:extLst>
                <a:ext uri="{FF2B5EF4-FFF2-40B4-BE49-F238E27FC236}">
                  <a16:creationId xmlns:a16="http://schemas.microsoft.com/office/drawing/2014/main" id="{A40C4C62-93B4-4137-9B1A-528E4B665470}"/>
                </a:ext>
              </a:extLst>
            </p:cNvPr>
            <p:cNvSpPr/>
            <p:nvPr/>
          </p:nvSpPr>
          <p:spPr>
            <a:xfrm>
              <a:off x="561879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4" name="Freeform: Shape 693">
              <a:extLst>
                <a:ext uri="{FF2B5EF4-FFF2-40B4-BE49-F238E27FC236}">
                  <a16:creationId xmlns:a16="http://schemas.microsoft.com/office/drawing/2014/main" id="{9C5A257E-EB2E-48DF-9893-6AC3D4CA8314}"/>
                </a:ext>
              </a:extLst>
            </p:cNvPr>
            <p:cNvSpPr/>
            <p:nvPr/>
          </p:nvSpPr>
          <p:spPr>
            <a:xfrm>
              <a:off x="818640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5" name="Freeform: Shape 694">
              <a:extLst>
                <a:ext uri="{FF2B5EF4-FFF2-40B4-BE49-F238E27FC236}">
                  <a16:creationId xmlns:a16="http://schemas.microsoft.com/office/drawing/2014/main" id="{798183EE-0DAF-4E35-AB2F-86BE53AA9CBC}"/>
                </a:ext>
              </a:extLst>
            </p:cNvPr>
            <p:cNvSpPr/>
            <p:nvPr/>
          </p:nvSpPr>
          <p:spPr>
            <a:xfrm>
              <a:off x="561879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6" name="Freeform: Shape 695">
              <a:extLst>
                <a:ext uri="{FF2B5EF4-FFF2-40B4-BE49-F238E27FC236}">
                  <a16:creationId xmlns:a16="http://schemas.microsoft.com/office/drawing/2014/main" id="{6526D83E-5332-4053-B5F1-4AA945266259}"/>
                </a:ext>
              </a:extLst>
            </p:cNvPr>
            <p:cNvSpPr/>
            <p:nvPr/>
          </p:nvSpPr>
          <p:spPr>
            <a:xfrm>
              <a:off x="561879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7" name="Freeform: Shape 696">
              <a:extLst>
                <a:ext uri="{FF2B5EF4-FFF2-40B4-BE49-F238E27FC236}">
                  <a16:creationId xmlns:a16="http://schemas.microsoft.com/office/drawing/2014/main" id="{88AE5474-765D-45F3-969E-63ECB427C43D}"/>
                </a:ext>
              </a:extLst>
            </p:cNvPr>
            <p:cNvSpPr/>
            <p:nvPr/>
          </p:nvSpPr>
          <p:spPr>
            <a:xfrm>
              <a:off x="561879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8" name="Freeform: Shape 697">
              <a:extLst>
                <a:ext uri="{FF2B5EF4-FFF2-40B4-BE49-F238E27FC236}">
                  <a16:creationId xmlns:a16="http://schemas.microsoft.com/office/drawing/2014/main" id="{699CAAD7-8A59-44AF-ADBE-9874E11B1F9D}"/>
                </a:ext>
              </a:extLst>
            </p:cNvPr>
            <p:cNvSpPr/>
            <p:nvPr/>
          </p:nvSpPr>
          <p:spPr>
            <a:xfrm>
              <a:off x="818640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9" name="Freeform: Shape 698">
              <a:extLst>
                <a:ext uri="{FF2B5EF4-FFF2-40B4-BE49-F238E27FC236}">
                  <a16:creationId xmlns:a16="http://schemas.microsoft.com/office/drawing/2014/main" id="{FAA64E09-DED1-4B89-9BB3-FA2FA820149D}"/>
                </a:ext>
              </a:extLst>
            </p:cNvPr>
            <p:cNvSpPr/>
            <p:nvPr/>
          </p:nvSpPr>
          <p:spPr>
            <a:xfrm>
              <a:off x="818640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0" name="Freeform: Shape 699">
              <a:extLst>
                <a:ext uri="{FF2B5EF4-FFF2-40B4-BE49-F238E27FC236}">
                  <a16:creationId xmlns:a16="http://schemas.microsoft.com/office/drawing/2014/main" id="{4E710145-52AB-4F21-B635-E5EBEB0DD759}"/>
                </a:ext>
              </a:extLst>
            </p:cNvPr>
            <p:cNvSpPr/>
            <p:nvPr/>
          </p:nvSpPr>
          <p:spPr>
            <a:xfrm>
              <a:off x="818640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1" name="Freeform: Shape 700">
              <a:extLst>
                <a:ext uri="{FF2B5EF4-FFF2-40B4-BE49-F238E27FC236}">
                  <a16:creationId xmlns:a16="http://schemas.microsoft.com/office/drawing/2014/main" id="{FAF2EB0D-253D-4A69-937D-E231DCD6E497}"/>
                </a:ext>
              </a:extLst>
            </p:cNvPr>
            <p:cNvSpPr/>
            <p:nvPr/>
          </p:nvSpPr>
          <p:spPr>
            <a:xfrm>
              <a:off x="576147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2" name="Freeform: Shape 701">
              <a:extLst>
                <a:ext uri="{FF2B5EF4-FFF2-40B4-BE49-F238E27FC236}">
                  <a16:creationId xmlns:a16="http://schemas.microsoft.com/office/drawing/2014/main" id="{A4DCBF22-ED0A-4253-B8AF-95B64D412A69}"/>
                </a:ext>
              </a:extLst>
            </p:cNvPr>
            <p:cNvSpPr/>
            <p:nvPr/>
          </p:nvSpPr>
          <p:spPr>
            <a:xfrm>
              <a:off x="832900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3" name="Freeform: Shape 702">
              <a:extLst>
                <a:ext uri="{FF2B5EF4-FFF2-40B4-BE49-F238E27FC236}">
                  <a16:creationId xmlns:a16="http://schemas.microsoft.com/office/drawing/2014/main" id="{760B4A82-BFCA-49FE-A3CC-882A1490178B}"/>
                </a:ext>
              </a:extLst>
            </p:cNvPr>
            <p:cNvSpPr/>
            <p:nvPr/>
          </p:nvSpPr>
          <p:spPr>
            <a:xfrm>
              <a:off x="576147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4" name="Freeform: Shape 703">
              <a:extLst>
                <a:ext uri="{FF2B5EF4-FFF2-40B4-BE49-F238E27FC236}">
                  <a16:creationId xmlns:a16="http://schemas.microsoft.com/office/drawing/2014/main" id="{5946D81F-EA5A-4457-8487-8FD25D453405}"/>
                </a:ext>
              </a:extLst>
            </p:cNvPr>
            <p:cNvSpPr/>
            <p:nvPr/>
          </p:nvSpPr>
          <p:spPr>
            <a:xfrm>
              <a:off x="576147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5" name="Freeform: Shape 704">
              <a:extLst>
                <a:ext uri="{FF2B5EF4-FFF2-40B4-BE49-F238E27FC236}">
                  <a16:creationId xmlns:a16="http://schemas.microsoft.com/office/drawing/2014/main" id="{0E0BDD3C-7B49-495B-83D2-E56C3BFB6DA5}"/>
                </a:ext>
              </a:extLst>
            </p:cNvPr>
            <p:cNvSpPr/>
            <p:nvPr/>
          </p:nvSpPr>
          <p:spPr>
            <a:xfrm>
              <a:off x="576147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6" name="Freeform: Shape 705">
              <a:extLst>
                <a:ext uri="{FF2B5EF4-FFF2-40B4-BE49-F238E27FC236}">
                  <a16:creationId xmlns:a16="http://schemas.microsoft.com/office/drawing/2014/main" id="{1608B2A7-65D0-4DC5-ADD2-2BCFD61320ED}"/>
                </a:ext>
              </a:extLst>
            </p:cNvPr>
            <p:cNvSpPr/>
            <p:nvPr/>
          </p:nvSpPr>
          <p:spPr>
            <a:xfrm>
              <a:off x="832900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7" name="Freeform: Shape 706">
              <a:extLst>
                <a:ext uri="{FF2B5EF4-FFF2-40B4-BE49-F238E27FC236}">
                  <a16:creationId xmlns:a16="http://schemas.microsoft.com/office/drawing/2014/main" id="{7E6468A5-0DFC-4ABB-B565-F051C143F979}"/>
                </a:ext>
              </a:extLst>
            </p:cNvPr>
            <p:cNvSpPr/>
            <p:nvPr/>
          </p:nvSpPr>
          <p:spPr>
            <a:xfrm>
              <a:off x="832900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8" name="Freeform: Shape 707">
              <a:extLst>
                <a:ext uri="{FF2B5EF4-FFF2-40B4-BE49-F238E27FC236}">
                  <a16:creationId xmlns:a16="http://schemas.microsoft.com/office/drawing/2014/main" id="{51D624B8-BE8F-4E7B-B00D-D94D8D606E26}"/>
                </a:ext>
              </a:extLst>
            </p:cNvPr>
            <p:cNvSpPr/>
            <p:nvPr/>
          </p:nvSpPr>
          <p:spPr>
            <a:xfrm>
              <a:off x="832900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09" name="Freeform: Shape 708">
              <a:extLst>
                <a:ext uri="{FF2B5EF4-FFF2-40B4-BE49-F238E27FC236}">
                  <a16:creationId xmlns:a16="http://schemas.microsoft.com/office/drawing/2014/main" id="{08E77EA8-FD9C-4C2E-9F18-27DA1B24E5A5}"/>
                </a:ext>
              </a:extLst>
            </p:cNvPr>
            <p:cNvSpPr/>
            <p:nvPr/>
          </p:nvSpPr>
          <p:spPr>
            <a:xfrm>
              <a:off x="590407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0" name="Freeform: Shape 709">
              <a:extLst>
                <a:ext uri="{FF2B5EF4-FFF2-40B4-BE49-F238E27FC236}">
                  <a16:creationId xmlns:a16="http://schemas.microsoft.com/office/drawing/2014/main" id="{942E3EDE-22AA-4A0C-893D-F2B9A27DC5FD}"/>
                </a:ext>
              </a:extLst>
            </p:cNvPr>
            <p:cNvSpPr/>
            <p:nvPr/>
          </p:nvSpPr>
          <p:spPr>
            <a:xfrm>
              <a:off x="847168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1" name="Freeform: Shape 710">
              <a:extLst>
                <a:ext uri="{FF2B5EF4-FFF2-40B4-BE49-F238E27FC236}">
                  <a16:creationId xmlns:a16="http://schemas.microsoft.com/office/drawing/2014/main" id="{7B285FE8-BCF8-4E46-87D8-77564B329D67}"/>
                </a:ext>
              </a:extLst>
            </p:cNvPr>
            <p:cNvSpPr/>
            <p:nvPr/>
          </p:nvSpPr>
          <p:spPr>
            <a:xfrm>
              <a:off x="590407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2" name="Freeform: Shape 711">
              <a:extLst>
                <a:ext uri="{FF2B5EF4-FFF2-40B4-BE49-F238E27FC236}">
                  <a16:creationId xmlns:a16="http://schemas.microsoft.com/office/drawing/2014/main" id="{AF04BA79-8050-4E26-8625-31B4979D77BF}"/>
                </a:ext>
              </a:extLst>
            </p:cNvPr>
            <p:cNvSpPr/>
            <p:nvPr/>
          </p:nvSpPr>
          <p:spPr>
            <a:xfrm>
              <a:off x="590407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3" name="Freeform: Shape 712">
              <a:extLst>
                <a:ext uri="{FF2B5EF4-FFF2-40B4-BE49-F238E27FC236}">
                  <a16:creationId xmlns:a16="http://schemas.microsoft.com/office/drawing/2014/main" id="{8CD4FF7D-8309-403A-983E-24BEDA62B48D}"/>
                </a:ext>
              </a:extLst>
            </p:cNvPr>
            <p:cNvSpPr/>
            <p:nvPr/>
          </p:nvSpPr>
          <p:spPr>
            <a:xfrm>
              <a:off x="590407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4" name="Freeform: Shape 713">
              <a:extLst>
                <a:ext uri="{FF2B5EF4-FFF2-40B4-BE49-F238E27FC236}">
                  <a16:creationId xmlns:a16="http://schemas.microsoft.com/office/drawing/2014/main" id="{654AA8FA-601C-4626-9CCF-A92FAD9D27F8}"/>
                </a:ext>
              </a:extLst>
            </p:cNvPr>
            <p:cNvSpPr/>
            <p:nvPr/>
          </p:nvSpPr>
          <p:spPr>
            <a:xfrm>
              <a:off x="847168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5" name="Freeform: Shape 714">
              <a:extLst>
                <a:ext uri="{FF2B5EF4-FFF2-40B4-BE49-F238E27FC236}">
                  <a16:creationId xmlns:a16="http://schemas.microsoft.com/office/drawing/2014/main" id="{5BA63ECD-F64E-4C30-922E-0B6EFAB44058}"/>
                </a:ext>
              </a:extLst>
            </p:cNvPr>
            <p:cNvSpPr/>
            <p:nvPr/>
          </p:nvSpPr>
          <p:spPr>
            <a:xfrm>
              <a:off x="847168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6" name="Freeform: Shape 715">
              <a:extLst>
                <a:ext uri="{FF2B5EF4-FFF2-40B4-BE49-F238E27FC236}">
                  <a16:creationId xmlns:a16="http://schemas.microsoft.com/office/drawing/2014/main" id="{876C2CA0-A07B-4E4A-8137-537AB38E4CC8}"/>
                </a:ext>
              </a:extLst>
            </p:cNvPr>
            <p:cNvSpPr/>
            <p:nvPr/>
          </p:nvSpPr>
          <p:spPr>
            <a:xfrm>
              <a:off x="604674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7" name="Freeform: Shape 716">
              <a:extLst>
                <a:ext uri="{FF2B5EF4-FFF2-40B4-BE49-F238E27FC236}">
                  <a16:creationId xmlns:a16="http://schemas.microsoft.com/office/drawing/2014/main" id="{582AC73C-DB3C-4292-B53D-EC215E83805F}"/>
                </a:ext>
              </a:extLst>
            </p:cNvPr>
            <p:cNvSpPr/>
            <p:nvPr/>
          </p:nvSpPr>
          <p:spPr>
            <a:xfrm>
              <a:off x="861428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8" name="Freeform: Shape 717">
              <a:extLst>
                <a:ext uri="{FF2B5EF4-FFF2-40B4-BE49-F238E27FC236}">
                  <a16:creationId xmlns:a16="http://schemas.microsoft.com/office/drawing/2014/main" id="{EAEC7E28-AF00-4FC3-AF82-3542C5FD443E}"/>
                </a:ext>
              </a:extLst>
            </p:cNvPr>
            <p:cNvSpPr/>
            <p:nvPr/>
          </p:nvSpPr>
          <p:spPr>
            <a:xfrm>
              <a:off x="604674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9" name="Freeform: Shape 718">
              <a:extLst>
                <a:ext uri="{FF2B5EF4-FFF2-40B4-BE49-F238E27FC236}">
                  <a16:creationId xmlns:a16="http://schemas.microsoft.com/office/drawing/2014/main" id="{1F8BE279-2F84-46E3-AEBF-A2AA79A500C9}"/>
                </a:ext>
              </a:extLst>
            </p:cNvPr>
            <p:cNvSpPr/>
            <p:nvPr/>
          </p:nvSpPr>
          <p:spPr>
            <a:xfrm>
              <a:off x="604674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0" name="Freeform: Shape 719">
              <a:extLst>
                <a:ext uri="{FF2B5EF4-FFF2-40B4-BE49-F238E27FC236}">
                  <a16:creationId xmlns:a16="http://schemas.microsoft.com/office/drawing/2014/main" id="{ED6E6790-13F8-4F9C-AC07-1F0A962D7229}"/>
                </a:ext>
              </a:extLst>
            </p:cNvPr>
            <p:cNvSpPr/>
            <p:nvPr/>
          </p:nvSpPr>
          <p:spPr>
            <a:xfrm>
              <a:off x="604674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1" name="Freeform: Shape 720">
              <a:extLst>
                <a:ext uri="{FF2B5EF4-FFF2-40B4-BE49-F238E27FC236}">
                  <a16:creationId xmlns:a16="http://schemas.microsoft.com/office/drawing/2014/main" id="{44DF12F7-DFBE-481A-B242-0FAD5AEBC4EC}"/>
                </a:ext>
              </a:extLst>
            </p:cNvPr>
            <p:cNvSpPr/>
            <p:nvPr/>
          </p:nvSpPr>
          <p:spPr>
            <a:xfrm>
              <a:off x="861428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2" name="Freeform: Shape 721">
              <a:extLst>
                <a:ext uri="{FF2B5EF4-FFF2-40B4-BE49-F238E27FC236}">
                  <a16:creationId xmlns:a16="http://schemas.microsoft.com/office/drawing/2014/main" id="{3F333445-0517-4A8A-8A73-CC8ED17A925F}"/>
                </a:ext>
              </a:extLst>
            </p:cNvPr>
            <p:cNvSpPr/>
            <p:nvPr/>
          </p:nvSpPr>
          <p:spPr>
            <a:xfrm>
              <a:off x="861428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3" name="Freeform: Shape 722">
              <a:extLst>
                <a:ext uri="{FF2B5EF4-FFF2-40B4-BE49-F238E27FC236}">
                  <a16:creationId xmlns:a16="http://schemas.microsoft.com/office/drawing/2014/main" id="{7BCEB8A7-A712-4C7A-B36C-FEE4175DDCE3}"/>
                </a:ext>
              </a:extLst>
            </p:cNvPr>
            <p:cNvSpPr/>
            <p:nvPr/>
          </p:nvSpPr>
          <p:spPr>
            <a:xfrm>
              <a:off x="861428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4" name="Freeform: Shape 723">
              <a:extLst>
                <a:ext uri="{FF2B5EF4-FFF2-40B4-BE49-F238E27FC236}">
                  <a16:creationId xmlns:a16="http://schemas.microsoft.com/office/drawing/2014/main" id="{F37F8A20-9B3D-41D2-BB9E-B7802CD47B74}"/>
                </a:ext>
              </a:extLst>
            </p:cNvPr>
            <p:cNvSpPr/>
            <p:nvPr/>
          </p:nvSpPr>
          <p:spPr>
            <a:xfrm>
              <a:off x="618941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5" name="Freeform: Shape 724">
              <a:extLst>
                <a:ext uri="{FF2B5EF4-FFF2-40B4-BE49-F238E27FC236}">
                  <a16:creationId xmlns:a16="http://schemas.microsoft.com/office/drawing/2014/main" id="{EB29A806-E45A-43A1-B519-186985BAC241}"/>
                </a:ext>
              </a:extLst>
            </p:cNvPr>
            <p:cNvSpPr/>
            <p:nvPr/>
          </p:nvSpPr>
          <p:spPr>
            <a:xfrm>
              <a:off x="875695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6" name="Freeform: Shape 725">
              <a:extLst>
                <a:ext uri="{FF2B5EF4-FFF2-40B4-BE49-F238E27FC236}">
                  <a16:creationId xmlns:a16="http://schemas.microsoft.com/office/drawing/2014/main" id="{8E6EA8D1-A87F-49B2-AB4A-3F5945D73C0E}"/>
                </a:ext>
              </a:extLst>
            </p:cNvPr>
            <p:cNvSpPr/>
            <p:nvPr/>
          </p:nvSpPr>
          <p:spPr>
            <a:xfrm>
              <a:off x="618941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7" name="Freeform: Shape 726">
              <a:extLst>
                <a:ext uri="{FF2B5EF4-FFF2-40B4-BE49-F238E27FC236}">
                  <a16:creationId xmlns:a16="http://schemas.microsoft.com/office/drawing/2014/main" id="{28EEB3FF-6435-4F25-ACCD-92F9599B3BDF}"/>
                </a:ext>
              </a:extLst>
            </p:cNvPr>
            <p:cNvSpPr/>
            <p:nvPr/>
          </p:nvSpPr>
          <p:spPr>
            <a:xfrm>
              <a:off x="618941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8" name="Freeform: Shape 727">
              <a:extLst>
                <a:ext uri="{FF2B5EF4-FFF2-40B4-BE49-F238E27FC236}">
                  <a16:creationId xmlns:a16="http://schemas.microsoft.com/office/drawing/2014/main" id="{8F32D05F-D013-4157-A461-FE8F97C82347}"/>
                </a:ext>
              </a:extLst>
            </p:cNvPr>
            <p:cNvSpPr/>
            <p:nvPr/>
          </p:nvSpPr>
          <p:spPr>
            <a:xfrm>
              <a:off x="618941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9" name="Freeform: Shape 728">
              <a:extLst>
                <a:ext uri="{FF2B5EF4-FFF2-40B4-BE49-F238E27FC236}">
                  <a16:creationId xmlns:a16="http://schemas.microsoft.com/office/drawing/2014/main" id="{28146E73-06A7-4ECA-8552-BC0614A772DB}"/>
                </a:ext>
              </a:extLst>
            </p:cNvPr>
            <p:cNvSpPr/>
            <p:nvPr/>
          </p:nvSpPr>
          <p:spPr>
            <a:xfrm>
              <a:off x="875695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0" name="Freeform: Shape 729">
              <a:extLst>
                <a:ext uri="{FF2B5EF4-FFF2-40B4-BE49-F238E27FC236}">
                  <a16:creationId xmlns:a16="http://schemas.microsoft.com/office/drawing/2014/main" id="{BC596489-15C7-4C8B-91BF-73690A651489}"/>
                </a:ext>
              </a:extLst>
            </p:cNvPr>
            <p:cNvSpPr/>
            <p:nvPr/>
          </p:nvSpPr>
          <p:spPr>
            <a:xfrm>
              <a:off x="875695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1" name="Freeform: Shape 730">
              <a:extLst>
                <a:ext uri="{FF2B5EF4-FFF2-40B4-BE49-F238E27FC236}">
                  <a16:creationId xmlns:a16="http://schemas.microsoft.com/office/drawing/2014/main" id="{15E66663-B03C-46FB-84DF-7310895151D5}"/>
                </a:ext>
              </a:extLst>
            </p:cNvPr>
            <p:cNvSpPr/>
            <p:nvPr/>
          </p:nvSpPr>
          <p:spPr>
            <a:xfrm>
              <a:off x="875695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2" name="Freeform: Shape 731">
              <a:extLst>
                <a:ext uri="{FF2B5EF4-FFF2-40B4-BE49-F238E27FC236}">
                  <a16:creationId xmlns:a16="http://schemas.microsoft.com/office/drawing/2014/main" id="{416E210C-C737-4CAA-9BDF-80D79EE046AD}"/>
                </a:ext>
              </a:extLst>
            </p:cNvPr>
            <p:cNvSpPr/>
            <p:nvPr/>
          </p:nvSpPr>
          <p:spPr>
            <a:xfrm>
              <a:off x="633201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3" name="Freeform: Shape 732">
              <a:extLst>
                <a:ext uri="{FF2B5EF4-FFF2-40B4-BE49-F238E27FC236}">
                  <a16:creationId xmlns:a16="http://schemas.microsoft.com/office/drawing/2014/main" id="{5A926DA7-4D6C-4ACF-BE87-253984D1EFFB}"/>
                </a:ext>
              </a:extLst>
            </p:cNvPr>
            <p:cNvSpPr/>
            <p:nvPr/>
          </p:nvSpPr>
          <p:spPr>
            <a:xfrm>
              <a:off x="889962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4" name="Freeform: Shape 733">
              <a:extLst>
                <a:ext uri="{FF2B5EF4-FFF2-40B4-BE49-F238E27FC236}">
                  <a16:creationId xmlns:a16="http://schemas.microsoft.com/office/drawing/2014/main" id="{3EBB7D74-7CEF-447B-9ECE-6F507F4F6361}"/>
                </a:ext>
              </a:extLst>
            </p:cNvPr>
            <p:cNvSpPr/>
            <p:nvPr/>
          </p:nvSpPr>
          <p:spPr>
            <a:xfrm>
              <a:off x="633201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5" name="Freeform: Shape 734">
              <a:extLst>
                <a:ext uri="{FF2B5EF4-FFF2-40B4-BE49-F238E27FC236}">
                  <a16:creationId xmlns:a16="http://schemas.microsoft.com/office/drawing/2014/main" id="{BDCC8E1F-F47C-4D18-98EF-595F3FA9E41F}"/>
                </a:ext>
              </a:extLst>
            </p:cNvPr>
            <p:cNvSpPr/>
            <p:nvPr/>
          </p:nvSpPr>
          <p:spPr>
            <a:xfrm>
              <a:off x="633201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6" name="Freeform: Shape 735">
              <a:extLst>
                <a:ext uri="{FF2B5EF4-FFF2-40B4-BE49-F238E27FC236}">
                  <a16:creationId xmlns:a16="http://schemas.microsoft.com/office/drawing/2014/main" id="{C00F1D74-74C8-4846-BD3A-D5934D42037B}"/>
                </a:ext>
              </a:extLst>
            </p:cNvPr>
            <p:cNvSpPr/>
            <p:nvPr/>
          </p:nvSpPr>
          <p:spPr>
            <a:xfrm>
              <a:off x="633201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7" name="Freeform: Shape 736">
              <a:extLst>
                <a:ext uri="{FF2B5EF4-FFF2-40B4-BE49-F238E27FC236}">
                  <a16:creationId xmlns:a16="http://schemas.microsoft.com/office/drawing/2014/main" id="{233AFB4B-C22A-4592-B950-F5D01D3A3A1A}"/>
                </a:ext>
              </a:extLst>
            </p:cNvPr>
            <p:cNvSpPr/>
            <p:nvPr/>
          </p:nvSpPr>
          <p:spPr>
            <a:xfrm>
              <a:off x="889962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8" name="Freeform: Shape 737">
              <a:extLst>
                <a:ext uri="{FF2B5EF4-FFF2-40B4-BE49-F238E27FC236}">
                  <a16:creationId xmlns:a16="http://schemas.microsoft.com/office/drawing/2014/main" id="{CE5CF42B-D7C0-42DD-ACF0-6F1CDC80D54D}"/>
                </a:ext>
              </a:extLst>
            </p:cNvPr>
            <p:cNvSpPr/>
            <p:nvPr/>
          </p:nvSpPr>
          <p:spPr>
            <a:xfrm>
              <a:off x="889962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9" name="Freeform: Shape 738">
              <a:extLst>
                <a:ext uri="{FF2B5EF4-FFF2-40B4-BE49-F238E27FC236}">
                  <a16:creationId xmlns:a16="http://schemas.microsoft.com/office/drawing/2014/main" id="{7562BFE5-2E47-4C9E-9661-F5BAFBB81480}"/>
                </a:ext>
              </a:extLst>
            </p:cNvPr>
            <p:cNvSpPr/>
            <p:nvPr/>
          </p:nvSpPr>
          <p:spPr>
            <a:xfrm>
              <a:off x="889962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0" name="Freeform: Shape 739">
              <a:extLst>
                <a:ext uri="{FF2B5EF4-FFF2-40B4-BE49-F238E27FC236}">
                  <a16:creationId xmlns:a16="http://schemas.microsoft.com/office/drawing/2014/main" id="{6A50FCE7-D4C2-4980-A883-97BB21D4E38E}"/>
                </a:ext>
              </a:extLst>
            </p:cNvPr>
            <p:cNvSpPr/>
            <p:nvPr/>
          </p:nvSpPr>
          <p:spPr>
            <a:xfrm>
              <a:off x="647469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1" name="Freeform: Shape 740">
              <a:extLst>
                <a:ext uri="{FF2B5EF4-FFF2-40B4-BE49-F238E27FC236}">
                  <a16:creationId xmlns:a16="http://schemas.microsoft.com/office/drawing/2014/main" id="{FB065692-9B06-498F-A0F1-A13FE51573F2}"/>
                </a:ext>
              </a:extLst>
            </p:cNvPr>
            <p:cNvSpPr/>
            <p:nvPr/>
          </p:nvSpPr>
          <p:spPr>
            <a:xfrm>
              <a:off x="904222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2" name="Freeform: Shape 741">
              <a:extLst>
                <a:ext uri="{FF2B5EF4-FFF2-40B4-BE49-F238E27FC236}">
                  <a16:creationId xmlns:a16="http://schemas.microsoft.com/office/drawing/2014/main" id="{CC779C5D-493C-4F61-9745-B55C294C3AA0}"/>
                </a:ext>
              </a:extLst>
            </p:cNvPr>
            <p:cNvSpPr/>
            <p:nvPr/>
          </p:nvSpPr>
          <p:spPr>
            <a:xfrm>
              <a:off x="647469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3" name="Freeform: Shape 742">
              <a:extLst>
                <a:ext uri="{FF2B5EF4-FFF2-40B4-BE49-F238E27FC236}">
                  <a16:creationId xmlns:a16="http://schemas.microsoft.com/office/drawing/2014/main" id="{43F0F6AB-B870-418F-81E5-015DDB8E30FF}"/>
                </a:ext>
              </a:extLst>
            </p:cNvPr>
            <p:cNvSpPr/>
            <p:nvPr/>
          </p:nvSpPr>
          <p:spPr>
            <a:xfrm>
              <a:off x="647469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4" name="Freeform: Shape 743">
              <a:extLst>
                <a:ext uri="{FF2B5EF4-FFF2-40B4-BE49-F238E27FC236}">
                  <a16:creationId xmlns:a16="http://schemas.microsoft.com/office/drawing/2014/main" id="{2D6CFF1B-50B1-4AFF-910F-6A766B0B9447}"/>
                </a:ext>
              </a:extLst>
            </p:cNvPr>
            <p:cNvSpPr/>
            <p:nvPr/>
          </p:nvSpPr>
          <p:spPr>
            <a:xfrm>
              <a:off x="647469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5" name="Freeform: Shape 744">
              <a:extLst>
                <a:ext uri="{FF2B5EF4-FFF2-40B4-BE49-F238E27FC236}">
                  <a16:creationId xmlns:a16="http://schemas.microsoft.com/office/drawing/2014/main" id="{170374D7-98C8-48A8-BBB4-B6BA13E3B8E7}"/>
                </a:ext>
              </a:extLst>
            </p:cNvPr>
            <p:cNvSpPr/>
            <p:nvPr/>
          </p:nvSpPr>
          <p:spPr>
            <a:xfrm>
              <a:off x="904222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6" name="Freeform: Shape 745">
              <a:extLst>
                <a:ext uri="{FF2B5EF4-FFF2-40B4-BE49-F238E27FC236}">
                  <a16:creationId xmlns:a16="http://schemas.microsoft.com/office/drawing/2014/main" id="{E0C86869-C682-459D-AFEB-94E99BE81B3D}"/>
                </a:ext>
              </a:extLst>
            </p:cNvPr>
            <p:cNvSpPr/>
            <p:nvPr/>
          </p:nvSpPr>
          <p:spPr>
            <a:xfrm>
              <a:off x="904222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7" name="Freeform: Shape 746">
              <a:extLst>
                <a:ext uri="{FF2B5EF4-FFF2-40B4-BE49-F238E27FC236}">
                  <a16:creationId xmlns:a16="http://schemas.microsoft.com/office/drawing/2014/main" id="{3D0D995C-8818-4194-972D-720AE45AD9EF}"/>
                </a:ext>
              </a:extLst>
            </p:cNvPr>
            <p:cNvSpPr/>
            <p:nvPr/>
          </p:nvSpPr>
          <p:spPr>
            <a:xfrm>
              <a:off x="904222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8" name="Freeform: Shape 747">
              <a:extLst>
                <a:ext uri="{FF2B5EF4-FFF2-40B4-BE49-F238E27FC236}">
                  <a16:creationId xmlns:a16="http://schemas.microsoft.com/office/drawing/2014/main" id="{D88A5C16-BFF6-473A-B19F-403DA9B0967D}"/>
                </a:ext>
              </a:extLst>
            </p:cNvPr>
            <p:cNvSpPr/>
            <p:nvPr/>
          </p:nvSpPr>
          <p:spPr>
            <a:xfrm>
              <a:off x="661729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9" name="Freeform: Shape 748">
              <a:extLst>
                <a:ext uri="{FF2B5EF4-FFF2-40B4-BE49-F238E27FC236}">
                  <a16:creationId xmlns:a16="http://schemas.microsoft.com/office/drawing/2014/main" id="{491299CA-3E95-4B3E-BD3C-586F2FE529B6}"/>
                </a:ext>
              </a:extLst>
            </p:cNvPr>
            <p:cNvSpPr/>
            <p:nvPr/>
          </p:nvSpPr>
          <p:spPr>
            <a:xfrm>
              <a:off x="661729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0" name="Freeform: Shape 749">
              <a:extLst>
                <a:ext uri="{FF2B5EF4-FFF2-40B4-BE49-F238E27FC236}">
                  <a16:creationId xmlns:a16="http://schemas.microsoft.com/office/drawing/2014/main" id="{34BBEB72-A90C-421B-A829-D8AA6047CE4C}"/>
                </a:ext>
              </a:extLst>
            </p:cNvPr>
            <p:cNvSpPr/>
            <p:nvPr/>
          </p:nvSpPr>
          <p:spPr>
            <a:xfrm>
              <a:off x="661729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1" name="Freeform: Shape 750">
              <a:extLst>
                <a:ext uri="{FF2B5EF4-FFF2-40B4-BE49-F238E27FC236}">
                  <a16:creationId xmlns:a16="http://schemas.microsoft.com/office/drawing/2014/main" id="{BE2394FA-0B80-4215-8EAC-DB8DF83FEACA}"/>
                </a:ext>
              </a:extLst>
            </p:cNvPr>
            <p:cNvSpPr/>
            <p:nvPr/>
          </p:nvSpPr>
          <p:spPr>
            <a:xfrm>
              <a:off x="661729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2" name="Freeform: Shape 751">
              <a:extLst>
                <a:ext uri="{FF2B5EF4-FFF2-40B4-BE49-F238E27FC236}">
                  <a16:creationId xmlns:a16="http://schemas.microsoft.com/office/drawing/2014/main" id="{234D2EDB-7797-488E-A26D-0626A88FFE5A}"/>
                </a:ext>
              </a:extLst>
            </p:cNvPr>
            <p:cNvSpPr/>
            <p:nvPr/>
          </p:nvSpPr>
          <p:spPr>
            <a:xfrm>
              <a:off x="675996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3" name="Freeform: Shape 752">
              <a:extLst>
                <a:ext uri="{FF2B5EF4-FFF2-40B4-BE49-F238E27FC236}">
                  <a16:creationId xmlns:a16="http://schemas.microsoft.com/office/drawing/2014/main" id="{61A71AB4-1E30-4214-98A7-7648F7DA2D16}"/>
                </a:ext>
              </a:extLst>
            </p:cNvPr>
            <p:cNvSpPr/>
            <p:nvPr/>
          </p:nvSpPr>
          <p:spPr>
            <a:xfrm>
              <a:off x="675996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4" name="Freeform: Shape 753">
              <a:extLst>
                <a:ext uri="{FF2B5EF4-FFF2-40B4-BE49-F238E27FC236}">
                  <a16:creationId xmlns:a16="http://schemas.microsoft.com/office/drawing/2014/main" id="{BFC1FA53-16D2-4B7F-95BB-D2A1DFD3A056}"/>
                </a:ext>
              </a:extLst>
            </p:cNvPr>
            <p:cNvSpPr/>
            <p:nvPr/>
          </p:nvSpPr>
          <p:spPr>
            <a:xfrm>
              <a:off x="675996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5" name="Freeform: Shape 754">
              <a:extLst>
                <a:ext uri="{FF2B5EF4-FFF2-40B4-BE49-F238E27FC236}">
                  <a16:creationId xmlns:a16="http://schemas.microsoft.com/office/drawing/2014/main" id="{40C7DACF-F634-44E1-9137-C54D1445D89C}"/>
                </a:ext>
              </a:extLst>
            </p:cNvPr>
            <p:cNvSpPr/>
            <p:nvPr/>
          </p:nvSpPr>
          <p:spPr>
            <a:xfrm>
              <a:off x="675996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6" name="Freeform: Shape 755">
              <a:extLst>
                <a:ext uri="{FF2B5EF4-FFF2-40B4-BE49-F238E27FC236}">
                  <a16:creationId xmlns:a16="http://schemas.microsoft.com/office/drawing/2014/main" id="{AD71793E-1A0E-4EED-ABAA-425D9CA64596}"/>
                </a:ext>
              </a:extLst>
            </p:cNvPr>
            <p:cNvSpPr/>
            <p:nvPr/>
          </p:nvSpPr>
          <p:spPr>
            <a:xfrm>
              <a:off x="690263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7" name="Freeform: Shape 756">
              <a:extLst>
                <a:ext uri="{FF2B5EF4-FFF2-40B4-BE49-F238E27FC236}">
                  <a16:creationId xmlns:a16="http://schemas.microsoft.com/office/drawing/2014/main" id="{5420089D-ADDA-44A8-A77B-03BD14F0CECF}"/>
                </a:ext>
              </a:extLst>
            </p:cNvPr>
            <p:cNvSpPr/>
            <p:nvPr/>
          </p:nvSpPr>
          <p:spPr>
            <a:xfrm>
              <a:off x="690263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8" name="Freeform: Shape 757">
              <a:extLst>
                <a:ext uri="{FF2B5EF4-FFF2-40B4-BE49-F238E27FC236}">
                  <a16:creationId xmlns:a16="http://schemas.microsoft.com/office/drawing/2014/main" id="{75C28F3D-06C5-4C68-8BFA-24A0929736B2}"/>
                </a:ext>
              </a:extLst>
            </p:cNvPr>
            <p:cNvSpPr/>
            <p:nvPr/>
          </p:nvSpPr>
          <p:spPr>
            <a:xfrm>
              <a:off x="690263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9" name="Freeform: Shape 758">
              <a:extLst>
                <a:ext uri="{FF2B5EF4-FFF2-40B4-BE49-F238E27FC236}">
                  <a16:creationId xmlns:a16="http://schemas.microsoft.com/office/drawing/2014/main" id="{CAF48FDE-9561-4452-9E28-FD6242C7BEF2}"/>
                </a:ext>
              </a:extLst>
            </p:cNvPr>
            <p:cNvSpPr/>
            <p:nvPr/>
          </p:nvSpPr>
          <p:spPr>
            <a:xfrm>
              <a:off x="690263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0" name="Freeform: Shape 759">
              <a:extLst>
                <a:ext uri="{FF2B5EF4-FFF2-40B4-BE49-F238E27FC236}">
                  <a16:creationId xmlns:a16="http://schemas.microsoft.com/office/drawing/2014/main" id="{144EAA7A-F778-4049-8892-A0B456C5DDC7}"/>
                </a:ext>
              </a:extLst>
            </p:cNvPr>
            <p:cNvSpPr/>
            <p:nvPr/>
          </p:nvSpPr>
          <p:spPr>
            <a:xfrm>
              <a:off x="704523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1" name="Freeform: Shape 760">
              <a:extLst>
                <a:ext uri="{FF2B5EF4-FFF2-40B4-BE49-F238E27FC236}">
                  <a16:creationId xmlns:a16="http://schemas.microsoft.com/office/drawing/2014/main" id="{1C4F4FDE-4202-4A56-AD67-E9B733D38644}"/>
                </a:ext>
              </a:extLst>
            </p:cNvPr>
            <p:cNvSpPr/>
            <p:nvPr/>
          </p:nvSpPr>
          <p:spPr>
            <a:xfrm>
              <a:off x="704523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2" name="Freeform: Shape 761">
              <a:extLst>
                <a:ext uri="{FF2B5EF4-FFF2-40B4-BE49-F238E27FC236}">
                  <a16:creationId xmlns:a16="http://schemas.microsoft.com/office/drawing/2014/main" id="{264B8E20-B744-40F8-9BCB-A1D7830E3CAE}"/>
                </a:ext>
              </a:extLst>
            </p:cNvPr>
            <p:cNvSpPr/>
            <p:nvPr/>
          </p:nvSpPr>
          <p:spPr>
            <a:xfrm>
              <a:off x="704523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3" name="Freeform: Shape 762">
              <a:extLst>
                <a:ext uri="{FF2B5EF4-FFF2-40B4-BE49-F238E27FC236}">
                  <a16:creationId xmlns:a16="http://schemas.microsoft.com/office/drawing/2014/main" id="{DF12528A-D1B6-4418-971A-3CD95F408132}"/>
                </a:ext>
              </a:extLst>
            </p:cNvPr>
            <p:cNvSpPr/>
            <p:nvPr/>
          </p:nvSpPr>
          <p:spPr>
            <a:xfrm>
              <a:off x="704523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4" name="Freeform: Shape 763">
              <a:extLst>
                <a:ext uri="{FF2B5EF4-FFF2-40B4-BE49-F238E27FC236}">
                  <a16:creationId xmlns:a16="http://schemas.microsoft.com/office/drawing/2014/main" id="{2FC10C21-BB61-479C-AFA6-99E0E45E4A89}"/>
                </a:ext>
              </a:extLst>
            </p:cNvPr>
            <p:cNvSpPr/>
            <p:nvPr/>
          </p:nvSpPr>
          <p:spPr>
            <a:xfrm>
              <a:off x="718791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5" name="Freeform: Shape 764">
              <a:extLst>
                <a:ext uri="{FF2B5EF4-FFF2-40B4-BE49-F238E27FC236}">
                  <a16:creationId xmlns:a16="http://schemas.microsoft.com/office/drawing/2014/main" id="{6013E88D-5B96-40FD-84FD-8DAA8D924BA2}"/>
                </a:ext>
              </a:extLst>
            </p:cNvPr>
            <p:cNvSpPr/>
            <p:nvPr/>
          </p:nvSpPr>
          <p:spPr>
            <a:xfrm>
              <a:off x="718791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6" name="Freeform: Shape 765">
              <a:extLst>
                <a:ext uri="{FF2B5EF4-FFF2-40B4-BE49-F238E27FC236}">
                  <a16:creationId xmlns:a16="http://schemas.microsoft.com/office/drawing/2014/main" id="{286BC8AC-9EFE-4842-8D55-53072FEB784B}"/>
                </a:ext>
              </a:extLst>
            </p:cNvPr>
            <p:cNvSpPr/>
            <p:nvPr/>
          </p:nvSpPr>
          <p:spPr>
            <a:xfrm>
              <a:off x="718791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7" name="Freeform: Shape 766">
              <a:extLst>
                <a:ext uri="{FF2B5EF4-FFF2-40B4-BE49-F238E27FC236}">
                  <a16:creationId xmlns:a16="http://schemas.microsoft.com/office/drawing/2014/main" id="{93131264-BD18-4E51-BB89-28B65CE821EA}"/>
                </a:ext>
              </a:extLst>
            </p:cNvPr>
            <p:cNvSpPr/>
            <p:nvPr/>
          </p:nvSpPr>
          <p:spPr>
            <a:xfrm>
              <a:off x="718791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8" name="Freeform: Shape 767">
              <a:extLst>
                <a:ext uri="{FF2B5EF4-FFF2-40B4-BE49-F238E27FC236}">
                  <a16:creationId xmlns:a16="http://schemas.microsoft.com/office/drawing/2014/main" id="{7C77ACF6-1C5B-499A-9D5C-512062A08B33}"/>
                </a:ext>
              </a:extLst>
            </p:cNvPr>
            <p:cNvSpPr/>
            <p:nvPr/>
          </p:nvSpPr>
          <p:spPr>
            <a:xfrm>
              <a:off x="733051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69" name="Freeform: Shape 768">
              <a:extLst>
                <a:ext uri="{FF2B5EF4-FFF2-40B4-BE49-F238E27FC236}">
                  <a16:creationId xmlns:a16="http://schemas.microsoft.com/office/drawing/2014/main" id="{9700DF5D-47C3-4740-9EF5-D89993A7E665}"/>
                </a:ext>
              </a:extLst>
            </p:cNvPr>
            <p:cNvSpPr/>
            <p:nvPr/>
          </p:nvSpPr>
          <p:spPr>
            <a:xfrm>
              <a:off x="733051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0" name="Freeform: Shape 769">
              <a:extLst>
                <a:ext uri="{FF2B5EF4-FFF2-40B4-BE49-F238E27FC236}">
                  <a16:creationId xmlns:a16="http://schemas.microsoft.com/office/drawing/2014/main" id="{E1EFA55B-D4AD-4C47-8181-999229AB2300}"/>
                </a:ext>
              </a:extLst>
            </p:cNvPr>
            <p:cNvSpPr/>
            <p:nvPr/>
          </p:nvSpPr>
          <p:spPr>
            <a:xfrm>
              <a:off x="733051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1" name="Freeform: Shape 770">
              <a:extLst>
                <a:ext uri="{FF2B5EF4-FFF2-40B4-BE49-F238E27FC236}">
                  <a16:creationId xmlns:a16="http://schemas.microsoft.com/office/drawing/2014/main" id="{8299D5F7-5C82-4D1D-BD05-BAF6E96F3676}"/>
                </a:ext>
              </a:extLst>
            </p:cNvPr>
            <p:cNvSpPr/>
            <p:nvPr/>
          </p:nvSpPr>
          <p:spPr>
            <a:xfrm>
              <a:off x="733051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2" name="Freeform: Shape 771">
              <a:extLst>
                <a:ext uri="{FF2B5EF4-FFF2-40B4-BE49-F238E27FC236}">
                  <a16:creationId xmlns:a16="http://schemas.microsoft.com/office/drawing/2014/main" id="{B24C4787-7984-4B43-8259-E464004D3512}"/>
                </a:ext>
              </a:extLst>
            </p:cNvPr>
            <p:cNvSpPr/>
            <p:nvPr/>
          </p:nvSpPr>
          <p:spPr>
            <a:xfrm>
              <a:off x="747318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3" name="Freeform: Shape 772">
              <a:extLst>
                <a:ext uri="{FF2B5EF4-FFF2-40B4-BE49-F238E27FC236}">
                  <a16:creationId xmlns:a16="http://schemas.microsoft.com/office/drawing/2014/main" id="{0A1DE1FE-367E-4F45-83E9-D6484F2D771B}"/>
                </a:ext>
              </a:extLst>
            </p:cNvPr>
            <p:cNvSpPr/>
            <p:nvPr/>
          </p:nvSpPr>
          <p:spPr>
            <a:xfrm>
              <a:off x="747318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4" name="Freeform: Shape 773">
              <a:extLst>
                <a:ext uri="{FF2B5EF4-FFF2-40B4-BE49-F238E27FC236}">
                  <a16:creationId xmlns:a16="http://schemas.microsoft.com/office/drawing/2014/main" id="{85029611-7D07-464B-BA84-834B6D0A00F2}"/>
                </a:ext>
              </a:extLst>
            </p:cNvPr>
            <p:cNvSpPr/>
            <p:nvPr/>
          </p:nvSpPr>
          <p:spPr>
            <a:xfrm>
              <a:off x="747318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5" name="Freeform: Shape 774">
              <a:extLst>
                <a:ext uri="{FF2B5EF4-FFF2-40B4-BE49-F238E27FC236}">
                  <a16:creationId xmlns:a16="http://schemas.microsoft.com/office/drawing/2014/main" id="{038483BE-5CDE-42F4-8B6B-994F8F5C0620}"/>
                </a:ext>
              </a:extLst>
            </p:cNvPr>
            <p:cNvSpPr/>
            <p:nvPr/>
          </p:nvSpPr>
          <p:spPr>
            <a:xfrm>
              <a:off x="747318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6" name="Freeform: Shape 775">
              <a:extLst>
                <a:ext uri="{FF2B5EF4-FFF2-40B4-BE49-F238E27FC236}">
                  <a16:creationId xmlns:a16="http://schemas.microsoft.com/office/drawing/2014/main" id="{35BDCB75-8BA3-4C79-8078-3F5164979B25}"/>
                </a:ext>
              </a:extLst>
            </p:cNvPr>
            <p:cNvSpPr/>
            <p:nvPr/>
          </p:nvSpPr>
          <p:spPr>
            <a:xfrm>
              <a:off x="519092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7" name="Freeform: Shape 776">
              <a:extLst>
                <a:ext uri="{FF2B5EF4-FFF2-40B4-BE49-F238E27FC236}">
                  <a16:creationId xmlns:a16="http://schemas.microsoft.com/office/drawing/2014/main" id="{A9DFAEAC-50E6-43C4-A07A-F465393B9286}"/>
                </a:ext>
              </a:extLst>
            </p:cNvPr>
            <p:cNvSpPr/>
            <p:nvPr/>
          </p:nvSpPr>
          <p:spPr>
            <a:xfrm>
              <a:off x="775846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8" name="Freeform: Shape 777">
              <a:extLst>
                <a:ext uri="{FF2B5EF4-FFF2-40B4-BE49-F238E27FC236}">
                  <a16:creationId xmlns:a16="http://schemas.microsoft.com/office/drawing/2014/main" id="{10152B5C-F5AB-4ED1-AE59-A4CCF81395F3}"/>
                </a:ext>
              </a:extLst>
            </p:cNvPr>
            <p:cNvSpPr/>
            <p:nvPr/>
          </p:nvSpPr>
          <p:spPr>
            <a:xfrm>
              <a:off x="519092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9" name="Freeform: Shape 778">
              <a:extLst>
                <a:ext uri="{FF2B5EF4-FFF2-40B4-BE49-F238E27FC236}">
                  <a16:creationId xmlns:a16="http://schemas.microsoft.com/office/drawing/2014/main" id="{7A2B36FA-EDEF-479D-9157-EC21540EDA14}"/>
                </a:ext>
              </a:extLst>
            </p:cNvPr>
            <p:cNvSpPr/>
            <p:nvPr/>
          </p:nvSpPr>
          <p:spPr>
            <a:xfrm>
              <a:off x="519092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0" name="Freeform: Shape 779">
              <a:extLst>
                <a:ext uri="{FF2B5EF4-FFF2-40B4-BE49-F238E27FC236}">
                  <a16:creationId xmlns:a16="http://schemas.microsoft.com/office/drawing/2014/main" id="{03188861-F4C9-42A4-80F4-B74B088F4A65}"/>
                </a:ext>
              </a:extLst>
            </p:cNvPr>
            <p:cNvSpPr/>
            <p:nvPr/>
          </p:nvSpPr>
          <p:spPr>
            <a:xfrm>
              <a:off x="519092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1" name="Freeform: Shape 780">
              <a:extLst>
                <a:ext uri="{FF2B5EF4-FFF2-40B4-BE49-F238E27FC236}">
                  <a16:creationId xmlns:a16="http://schemas.microsoft.com/office/drawing/2014/main" id="{8781C1D6-CB91-48D0-B5B5-E818BE0168CB}"/>
                </a:ext>
              </a:extLst>
            </p:cNvPr>
            <p:cNvSpPr/>
            <p:nvPr/>
          </p:nvSpPr>
          <p:spPr>
            <a:xfrm>
              <a:off x="775846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2" name="Freeform: Shape 781">
              <a:extLst>
                <a:ext uri="{FF2B5EF4-FFF2-40B4-BE49-F238E27FC236}">
                  <a16:creationId xmlns:a16="http://schemas.microsoft.com/office/drawing/2014/main" id="{F7EE5A5D-0DBF-4D56-A550-66EEA22EA8D6}"/>
                </a:ext>
              </a:extLst>
            </p:cNvPr>
            <p:cNvSpPr/>
            <p:nvPr/>
          </p:nvSpPr>
          <p:spPr>
            <a:xfrm>
              <a:off x="775846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3" name="Freeform: Shape 782">
              <a:extLst>
                <a:ext uri="{FF2B5EF4-FFF2-40B4-BE49-F238E27FC236}">
                  <a16:creationId xmlns:a16="http://schemas.microsoft.com/office/drawing/2014/main" id="{55577C07-37D4-4289-81E5-2A98FCD310A4}"/>
                </a:ext>
              </a:extLst>
            </p:cNvPr>
            <p:cNvSpPr/>
            <p:nvPr/>
          </p:nvSpPr>
          <p:spPr>
            <a:xfrm>
              <a:off x="775846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4" name="Freeform: Shape 783">
              <a:extLst>
                <a:ext uri="{FF2B5EF4-FFF2-40B4-BE49-F238E27FC236}">
                  <a16:creationId xmlns:a16="http://schemas.microsoft.com/office/drawing/2014/main" id="{8D5D30B0-4A11-4E71-9962-4E6350D4AACF}"/>
                </a:ext>
              </a:extLst>
            </p:cNvPr>
            <p:cNvSpPr/>
            <p:nvPr/>
          </p:nvSpPr>
          <p:spPr>
            <a:xfrm>
              <a:off x="847168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5" name="Freeform: Shape 784">
              <a:extLst>
                <a:ext uri="{FF2B5EF4-FFF2-40B4-BE49-F238E27FC236}">
                  <a16:creationId xmlns:a16="http://schemas.microsoft.com/office/drawing/2014/main" id="{F47A231B-2517-4177-8C19-D6F77967F09B}"/>
                </a:ext>
              </a:extLst>
            </p:cNvPr>
            <p:cNvSpPr/>
            <p:nvPr/>
          </p:nvSpPr>
          <p:spPr>
            <a:xfrm>
              <a:off x="91268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6" name="Freeform: Shape 785">
              <a:extLst>
                <a:ext uri="{FF2B5EF4-FFF2-40B4-BE49-F238E27FC236}">
                  <a16:creationId xmlns:a16="http://schemas.microsoft.com/office/drawing/2014/main" id="{870424B5-CCDD-471A-9983-E80807376283}"/>
                </a:ext>
              </a:extLst>
            </p:cNvPr>
            <p:cNvSpPr/>
            <p:nvPr/>
          </p:nvSpPr>
          <p:spPr>
            <a:xfrm>
              <a:off x="348022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7" name="Freeform: Shape 786">
              <a:extLst>
                <a:ext uri="{FF2B5EF4-FFF2-40B4-BE49-F238E27FC236}">
                  <a16:creationId xmlns:a16="http://schemas.microsoft.com/office/drawing/2014/main" id="{655671E0-FD2C-4BFC-90FE-7FFA1EB596FD}"/>
                </a:ext>
              </a:extLst>
            </p:cNvPr>
            <p:cNvSpPr/>
            <p:nvPr/>
          </p:nvSpPr>
          <p:spPr>
            <a:xfrm>
              <a:off x="91268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8" name="Freeform: Shape 787">
              <a:extLst>
                <a:ext uri="{FF2B5EF4-FFF2-40B4-BE49-F238E27FC236}">
                  <a16:creationId xmlns:a16="http://schemas.microsoft.com/office/drawing/2014/main" id="{438ECF4E-5178-4791-9CEB-7139A90C8C4C}"/>
                </a:ext>
              </a:extLst>
            </p:cNvPr>
            <p:cNvSpPr/>
            <p:nvPr/>
          </p:nvSpPr>
          <p:spPr>
            <a:xfrm>
              <a:off x="91268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89" name="Freeform: Shape 788">
              <a:extLst>
                <a:ext uri="{FF2B5EF4-FFF2-40B4-BE49-F238E27FC236}">
                  <a16:creationId xmlns:a16="http://schemas.microsoft.com/office/drawing/2014/main" id="{85B094F1-6E9F-4E0D-B1AE-96469B150BE2}"/>
                </a:ext>
              </a:extLst>
            </p:cNvPr>
            <p:cNvSpPr/>
            <p:nvPr/>
          </p:nvSpPr>
          <p:spPr>
            <a:xfrm>
              <a:off x="91268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0" name="Freeform: Shape 789">
              <a:extLst>
                <a:ext uri="{FF2B5EF4-FFF2-40B4-BE49-F238E27FC236}">
                  <a16:creationId xmlns:a16="http://schemas.microsoft.com/office/drawing/2014/main" id="{8282C98B-9297-45F1-963C-C8D1E21C364F}"/>
                </a:ext>
              </a:extLst>
            </p:cNvPr>
            <p:cNvSpPr/>
            <p:nvPr/>
          </p:nvSpPr>
          <p:spPr>
            <a:xfrm>
              <a:off x="348022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1" name="Freeform: Shape 790">
              <a:extLst>
                <a:ext uri="{FF2B5EF4-FFF2-40B4-BE49-F238E27FC236}">
                  <a16:creationId xmlns:a16="http://schemas.microsoft.com/office/drawing/2014/main" id="{D6C98C91-6AC4-43AD-BD5E-E6024263CA7D}"/>
                </a:ext>
              </a:extLst>
            </p:cNvPr>
            <p:cNvSpPr/>
            <p:nvPr/>
          </p:nvSpPr>
          <p:spPr>
            <a:xfrm>
              <a:off x="348022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2" name="Freeform: Shape 791">
              <a:extLst>
                <a:ext uri="{FF2B5EF4-FFF2-40B4-BE49-F238E27FC236}">
                  <a16:creationId xmlns:a16="http://schemas.microsoft.com/office/drawing/2014/main" id="{0DA4C7FD-7518-410E-9A36-0A929138B4AC}"/>
                </a:ext>
              </a:extLst>
            </p:cNvPr>
            <p:cNvSpPr/>
            <p:nvPr/>
          </p:nvSpPr>
          <p:spPr>
            <a:xfrm>
              <a:off x="348022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3" name="Freeform: Shape 792">
              <a:extLst>
                <a:ext uri="{FF2B5EF4-FFF2-40B4-BE49-F238E27FC236}">
                  <a16:creationId xmlns:a16="http://schemas.microsoft.com/office/drawing/2014/main" id="{35FF550F-3E3C-406F-B830-75E4D128EE91}"/>
                </a:ext>
              </a:extLst>
            </p:cNvPr>
            <p:cNvSpPr/>
            <p:nvPr/>
          </p:nvSpPr>
          <p:spPr>
            <a:xfrm>
              <a:off x="119795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4" name="Freeform: Shape 793">
              <a:extLst>
                <a:ext uri="{FF2B5EF4-FFF2-40B4-BE49-F238E27FC236}">
                  <a16:creationId xmlns:a16="http://schemas.microsoft.com/office/drawing/2014/main" id="{96B73F27-77A0-4A12-941E-FFFDDEC877EA}"/>
                </a:ext>
              </a:extLst>
            </p:cNvPr>
            <p:cNvSpPr/>
            <p:nvPr/>
          </p:nvSpPr>
          <p:spPr>
            <a:xfrm>
              <a:off x="376549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5" name="Freeform: Shape 794">
              <a:extLst>
                <a:ext uri="{FF2B5EF4-FFF2-40B4-BE49-F238E27FC236}">
                  <a16:creationId xmlns:a16="http://schemas.microsoft.com/office/drawing/2014/main" id="{9F497CEA-6395-426F-B91D-C4B2B90BCBD4}"/>
                </a:ext>
              </a:extLst>
            </p:cNvPr>
            <p:cNvSpPr/>
            <p:nvPr/>
          </p:nvSpPr>
          <p:spPr>
            <a:xfrm>
              <a:off x="119795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6" name="Freeform: Shape 795">
              <a:extLst>
                <a:ext uri="{FF2B5EF4-FFF2-40B4-BE49-F238E27FC236}">
                  <a16:creationId xmlns:a16="http://schemas.microsoft.com/office/drawing/2014/main" id="{CC7078A9-29CF-49D2-8DF8-CC393ED245A6}"/>
                </a:ext>
              </a:extLst>
            </p:cNvPr>
            <p:cNvSpPr/>
            <p:nvPr/>
          </p:nvSpPr>
          <p:spPr>
            <a:xfrm>
              <a:off x="119795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7" name="Freeform: Shape 796">
              <a:extLst>
                <a:ext uri="{FF2B5EF4-FFF2-40B4-BE49-F238E27FC236}">
                  <a16:creationId xmlns:a16="http://schemas.microsoft.com/office/drawing/2014/main" id="{2B472E4D-FA1A-4B0B-B00C-BEE4CDE6E90D}"/>
                </a:ext>
              </a:extLst>
            </p:cNvPr>
            <p:cNvSpPr/>
            <p:nvPr/>
          </p:nvSpPr>
          <p:spPr>
            <a:xfrm>
              <a:off x="119795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8" name="Freeform: Shape 797">
              <a:extLst>
                <a:ext uri="{FF2B5EF4-FFF2-40B4-BE49-F238E27FC236}">
                  <a16:creationId xmlns:a16="http://schemas.microsoft.com/office/drawing/2014/main" id="{C5F8D134-291E-41DF-81A0-E418279654CC}"/>
                </a:ext>
              </a:extLst>
            </p:cNvPr>
            <p:cNvSpPr/>
            <p:nvPr/>
          </p:nvSpPr>
          <p:spPr>
            <a:xfrm>
              <a:off x="376549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9" name="Freeform: Shape 798">
              <a:extLst>
                <a:ext uri="{FF2B5EF4-FFF2-40B4-BE49-F238E27FC236}">
                  <a16:creationId xmlns:a16="http://schemas.microsoft.com/office/drawing/2014/main" id="{BFB157B8-EF78-4C08-B103-0C15708F3243}"/>
                </a:ext>
              </a:extLst>
            </p:cNvPr>
            <p:cNvSpPr/>
            <p:nvPr/>
          </p:nvSpPr>
          <p:spPr>
            <a:xfrm>
              <a:off x="376549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0" name="Freeform: Shape 799">
              <a:extLst>
                <a:ext uri="{FF2B5EF4-FFF2-40B4-BE49-F238E27FC236}">
                  <a16:creationId xmlns:a16="http://schemas.microsoft.com/office/drawing/2014/main" id="{6ADCA2A7-58FD-4EA2-9353-7DD3324424BD}"/>
                </a:ext>
              </a:extLst>
            </p:cNvPr>
            <p:cNvSpPr/>
            <p:nvPr/>
          </p:nvSpPr>
          <p:spPr>
            <a:xfrm>
              <a:off x="376549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1" name="Freeform: Shape 800">
              <a:extLst>
                <a:ext uri="{FF2B5EF4-FFF2-40B4-BE49-F238E27FC236}">
                  <a16:creationId xmlns:a16="http://schemas.microsoft.com/office/drawing/2014/main" id="{B9C69053-368E-4C20-B01D-E0AE0E36A625}"/>
                </a:ext>
              </a:extLst>
            </p:cNvPr>
            <p:cNvSpPr/>
            <p:nvPr/>
          </p:nvSpPr>
          <p:spPr>
            <a:xfrm>
              <a:off x="134063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2" name="Freeform: Shape 801">
              <a:extLst>
                <a:ext uri="{FF2B5EF4-FFF2-40B4-BE49-F238E27FC236}">
                  <a16:creationId xmlns:a16="http://schemas.microsoft.com/office/drawing/2014/main" id="{7C2BD604-C625-4FEB-B714-F5546678A5A3}"/>
                </a:ext>
              </a:extLst>
            </p:cNvPr>
            <p:cNvSpPr/>
            <p:nvPr/>
          </p:nvSpPr>
          <p:spPr>
            <a:xfrm>
              <a:off x="390816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3" name="Freeform: Shape 802">
              <a:extLst>
                <a:ext uri="{FF2B5EF4-FFF2-40B4-BE49-F238E27FC236}">
                  <a16:creationId xmlns:a16="http://schemas.microsoft.com/office/drawing/2014/main" id="{581FCA81-E2B7-4C31-A1FE-15555DEF1C1F}"/>
                </a:ext>
              </a:extLst>
            </p:cNvPr>
            <p:cNvSpPr/>
            <p:nvPr/>
          </p:nvSpPr>
          <p:spPr>
            <a:xfrm>
              <a:off x="134063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4" name="Freeform: Shape 803">
              <a:extLst>
                <a:ext uri="{FF2B5EF4-FFF2-40B4-BE49-F238E27FC236}">
                  <a16:creationId xmlns:a16="http://schemas.microsoft.com/office/drawing/2014/main" id="{CD94D3FD-3154-400F-BA5E-F621BEE47516}"/>
                </a:ext>
              </a:extLst>
            </p:cNvPr>
            <p:cNvSpPr/>
            <p:nvPr/>
          </p:nvSpPr>
          <p:spPr>
            <a:xfrm>
              <a:off x="134063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5" name="Freeform: Shape 804">
              <a:extLst>
                <a:ext uri="{FF2B5EF4-FFF2-40B4-BE49-F238E27FC236}">
                  <a16:creationId xmlns:a16="http://schemas.microsoft.com/office/drawing/2014/main" id="{EE068BB9-B456-414F-AE60-4F6760C916CF}"/>
                </a:ext>
              </a:extLst>
            </p:cNvPr>
            <p:cNvSpPr/>
            <p:nvPr/>
          </p:nvSpPr>
          <p:spPr>
            <a:xfrm>
              <a:off x="134063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6" name="Freeform: Shape 805">
              <a:extLst>
                <a:ext uri="{FF2B5EF4-FFF2-40B4-BE49-F238E27FC236}">
                  <a16:creationId xmlns:a16="http://schemas.microsoft.com/office/drawing/2014/main" id="{EC99B537-6138-424A-8A14-6E64ABA5DBCF}"/>
                </a:ext>
              </a:extLst>
            </p:cNvPr>
            <p:cNvSpPr/>
            <p:nvPr/>
          </p:nvSpPr>
          <p:spPr>
            <a:xfrm>
              <a:off x="390816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7" name="Freeform: Shape 806">
              <a:extLst>
                <a:ext uri="{FF2B5EF4-FFF2-40B4-BE49-F238E27FC236}">
                  <a16:creationId xmlns:a16="http://schemas.microsoft.com/office/drawing/2014/main" id="{2944CC3B-C045-4210-8687-0B20C24DCADB}"/>
                </a:ext>
              </a:extLst>
            </p:cNvPr>
            <p:cNvSpPr/>
            <p:nvPr/>
          </p:nvSpPr>
          <p:spPr>
            <a:xfrm>
              <a:off x="390816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8" name="Freeform: Shape 807">
              <a:extLst>
                <a:ext uri="{FF2B5EF4-FFF2-40B4-BE49-F238E27FC236}">
                  <a16:creationId xmlns:a16="http://schemas.microsoft.com/office/drawing/2014/main" id="{48267B91-C580-477E-BA75-62B03945C356}"/>
                </a:ext>
              </a:extLst>
            </p:cNvPr>
            <p:cNvSpPr/>
            <p:nvPr/>
          </p:nvSpPr>
          <p:spPr>
            <a:xfrm>
              <a:off x="390816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9" name="Freeform: Shape 808">
              <a:extLst>
                <a:ext uri="{FF2B5EF4-FFF2-40B4-BE49-F238E27FC236}">
                  <a16:creationId xmlns:a16="http://schemas.microsoft.com/office/drawing/2014/main" id="{D3DA6994-A25C-4C02-8360-53E38CEAD802}"/>
                </a:ext>
              </a:extLst>
            </p:cNvPr>
            <p:cNvSpPr/>
            <p:nvPr/>
          </p:nvSpPr>
          <p:spPr>
            <a:xfrm>
              <a:off x="148323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0" name="Freeform: Shape 809">
              <a:extLst>
                <a:ext uri="{FF2B5EF4-FFF2-40B4-BE49-F238E27FC236}">
                  <a16:creationId xmlns:a16="http://schemas.microsoft.com/office/drawing/2014/main" id="{72842F15-80BC-4CF2-8460-2BB9A91438ED}"/>
                </a:ext>
              </a:extLst>
            </p:cNvPr>
            <p:cNvSpPr/>
            <p:nvPr/>
          </p:nvSpPr>
          <p:spPr>
            <a:xfrm>
              <a:off x="405084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1" name="Freeform: Shape 810">
              <a:extLst>
                <a:ext uri="{FF2B5EF4-FFF2-40B4-BE49-F238E27FC236}">
                  <a16:creationId xmlns:a16="http://schemas.microsoft.com/office/drawing/2014/main" id="{3D2E5DB7-41F1-444D-AF37-3C231AAEA815}"/>
                </a:ext>
              </a:extLst>
            </p:cNvPr>
            <p:cNvSpPr/>
            <p:nvPr/>
          </p:nvSpPr>
          <p:spPr>
            <a:xfrm>
              <a:off x="148323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2" name="Freeform: Shape 811">
              <a:extLst>
                <a:ext uri="{FF2B5EF4-FFF2-40B4-BE49-F238E27FC236}">
                  <a16:creationId xmlns:a16="http://schemas.microsoft.com/office/drawing/2014/main" id="{6477AFCB-97FB-4456-8599-50133BCE8F18}"/>
                </a:ext>
              </a:extLst>
            </p:cNvPr>
            <p:cNvSpPr/>
            <p:nvPr/>
          </p:nvSpPr>
          <p:spPr>
            <a:xfrm>
              <a:off x="148323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3" name="Freeform: Shape 812">
              <a:extLst>
                <a:ext uri="{FF2B5EF4-FFF2-40B4-BE49-F238E27FC236}">
                  <a16:creationId xmlns:a16="http://schemas.microsoft.com/office/drawing/2014/main" id="{9C6D4235-A4D3-4766-9EC2-0536BF0484E8}"/>
                </a:ext>
              </a:extLst>
            </p:cNvPr>
            <p:cNvSpPr/>
            <p:nvPr/>
          </p:nvSpPr>
          <p:spPr>
            <a:xfrm>
              <a:off x="148323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4" name="Freeform: Shape 813">
              <a:extLst>
                <a:ext uri="{FF2B5EF4-FFF2-40B4-BE49-F238E27FC236}">
                  <a16:creationId xmlns:a16="http://schemas.microsoft.com/office/drawing/2014/main" id="{467E0EEB-AFE9-44AD-ACE2-31B2740AF5AA}"/>
                </a:ext>
              </a:extLst>
            </p:cNvPr>
            <p:cNvSpPr/>
            <p:nvPr/>
          </p:nvSpPr>
          <p:spPr>
            <a:xfrm>
              <a:off x="405084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5" name="Freeform: Shape 814">
              <a:extLst>
                <a:ext uri="{FF2B5EF4-FFF2-40B4-BE49-F238E27FC236}">
                  <a16:creationId xmlns:a16="http://schemas.microsoft.com/office/drawing/2014/main" id="{D83B6074-882E-4441-9A2D-72FB7FE84978}"/>
                </a:ext>
              </a:extLst>
            </p:cNvPr>
            <p:cNvSpPr/>
            <p:nvPr/>
          </p:nvSpPr>
          <p:spPr>
            <a:xfrm>
              <a:off x="405084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6" name="Freeform: Shape 815">
              <a:extLst>
                <a:ext uri="{FF2B5EF4-FFF2-40B4-BE49-F238E27FC236}">
                  <a16:creationId xmlns:a16="http://schemas.microsoft.com/office/drawing/2014/main" id="{EA4094DD-0652-4FFA-A7B4-CC5243A75302}"/>
                </a:ext>
              </a:extLst>
            </p:cNvPr>
            <p:cNvSpPr/>
            <p:nvPr/>
          </p:nvSpPr>
          <p:spPr>
            <a:xfrm>
              <a:off x="405084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7" name="Freeform: Shape 816">
              <a:extLst>
                <a:ext uri="{FF2B5EF4-FFF2-40B4-BE49-F238E27FC236}">
                  <a16:creationId xmlns:a16="http://schemas.microsoft.com/office/drawing/2014/main" id="{A57084D3-55AA-416A-B029-75C79A9C4F61}"/>
                </a:ext>
              </a:extLst>
            </p:cNvPr>
            <p:cNvSpPr/>
            <p:nvPr/>
          </p:nvSpPr>
          <p:spPr>
            <a:xfrm>
              <a:off x="162590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8" name="Freeform: Shape 817">
              <a:extLst>
                <a:ext uri="{FF2B5EF4-FFF2-40B4-BE49-F238E27FC236}">
                  <a16:creationId xmlns:a16="http://schemas.microsoft.com/office/drawing/2014/main" id="{A777310D-66CC-4F86-9A1D-0E13091BD99D}"/>
                </a:ext>
              </a:extLst>
            </p:cNvPr>
            <p:cNvSpPr/>
            <p:nvPr/>
          </p:nvSpPr>
          <p:spPr>
            <a:xfrm>
              <a:off x="419344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9" name="Freeform: Shape 818">
              <a:extLst>
                <a:ext uri="{FF2B5EF4-FFF2-40B4-BE49-F238E27FC236}">
                  <a16:creationId xmlns:a16="http://schemas.microsoft.com/office/drawing/2014/main" id="{B8818183-34E3-4675-B6FD-A0DF341F1928}"/>
                </a:ext>
              </a:extLst>
            </p:cNvPr>
            <p:cNvSpPr/>
            <p:nvPr/>
          </p:nvSpPr>
          <p:spPr>
            <a:xfrm>
              <a:off x="162590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0" name="Freeform: Shape 819">
              <a:extLst>
                <a:ext uri="{FF2B5EF4-FFF2-40B4-BE49-F238E27FC236}">
                  <a16:creationId xmlns:a16="http://schemas.microsoft.com/office/drawing/2014/main" id="{2B7D3F2B-8DD3-4851-8A6D-D5C3A7806FC4}"/>
                </a:ext>
              </a:extLst>
            </p:cNvPr>
            <p:cNvSpPr/>
            <p:nvPr/>
          </p:nvSpPr>
          <p:spPr>
            <a:xfrm>
              <a:off x="162590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1" name="Freeform: Shape 820">
              <a:extLst>
                <a:ext uri="{FF2B5EF4-FFF2-40B4-BE49-F238E27FC236}">
                  <a16:creationId xmlns:a16="http://schemas.microsoft.com/office/drawing/2014/main" id="{99282C7A-52F6-4056-975C-4BC44270CB1C}"/>
                </a:ext>
              </a:extLst>
            </p:cNvPr>
            <p:cNvSpPr/>
            <p:nvPr/>
          </p:nvSpPr>
          <p:spPr>
            <a:xfrm>
              <a:off x="162590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2" name="Freeform: Shape 821">
              <a:extLst>
                <a:ext uri="{FF2B5EF4-FFF2-40B4-BE49-F238E27FC236}">
                  <a16:creationId xmlns:a16="http://schemas.microsoft.com/office/drawing/2014/main" id="{93731349-8F6E-4183-9491-EFCA7BCCEE4D}"/>
                </a:ext>
              </a:extLst>
            </p:cNvPr>
            <p:cNvSpPr/>
            <p:nvPr/>
          </p:nvSpPr>
          <p:spPr>
            <a:xfrm>
              <a:off x="419344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3" name="Freeform: Shape 822">
              <a:extLst>
                <a:ext uri="{FF2B5EF4-FFF2-40B4-BE49-F238E27FC236}">
                  <a16:creationId xmlns:a16="http://schemas.microsoft.com/office/drawing/2014/main" id="{ED3A3402-115D-490F-A965-94D91AB0445B}"/>
                </a:ext>
              </a:extLst>
            </p:cNvPr>
            <p:cNvSpPr/>
            <p:nvPr/>
          </p:nvSpPr>
          <p:spPr>
            <a:xfrm>
              <a:off x="419344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4" name="Freeform: Shape 823">
              <a:extLst>
                <a:ext uri="{FF2B5EF4-FFF2-40B4-BE49-F238E27FC236}">
                  <a16:creationId xmlns:a16="http://schemas.microsoft.com/office/drawing/2014/main" id="{1EC020F8-DB15-455D-BA36-5B13FDFDC8C2}"/>
                </a:ext>
              </a:extLst>
            </p:cNvPr>
            <p:cNvSpPr/>
            <p:nvPr/>
          </p:nvSpPr>
          <p:spPr>
            <a:xfrm>
              <a:off x="419344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5" name="Freeform: Shape 824">
              <a:extLst>
                <a:ext uri="{FF2B5EF4-FFF2-40B4-BE49-F238E27FC236}">
                  <a16:creationId xmlns:a16="http://schemas.microsoft.com/office/drawing/2014/main" id="{C634C474-1AB1-4062-9E1E-C9153A8AA83C}"/>
                </a:ext>
              </a:extLst>
            </p:cNvPr>
            <p:cNvSpPr/>
            <p:nvPr/>
          </p:nvSpPr>
          <p:spPr>
            <a:xfrm>
              <a:off x="176850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6" name="Freeform: Shape 825">
              <a:extLst>
                <a:ext uri="{FF2B5EF4-FFF2-40B4-BE49-F238E27FC236}">
                  <a16:creationId xmlns:a16="http://schemas.microsoft.com/office/drawing/2014/main" id="{68F27E07-1EEF-42D3-9565-AE255CD0F758}"/>
                </a:ext>
              </a:extLst>
            </p:cNvPr>
            <p:cNvSpPr/>
            <p:nvPr/>
          </p:nvSpPr>
          <p:spPr>
            <a:xfrm>
              <a:off x="433611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7" name="Freeform: Shape 826">
              <a:extLst>
                <a:ext uri="{FF2B5EF4-FFF2-40B4-BE49-F238E27FC236}">
                  <a16:creationId xmlns:a16="http://schemas.microsoft.com/office/drawing/2014/main" id="{D3F39D49-4A83-4018-A649-90B933A55C1E}"/>
                </a:ext>
              </a:extLst>
            </p:cNvPr>
            <p:cNvSpPr/>
            <p:nvPr/>
          </p:nvSpPr>
          <p:spPr>
            <a:xfrm>
              <a:off x="176850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8" name="Freeform: Shape 827">
              <a:extLst>
                <a:ext uri="{FF2B5EF4-FFF2-40B4-BE49-F238E27FC236}">
                  <a16:creationId xmlns:a16="http://schemas.microsoft.com/office/drawing/2014/main" id="{02B43AD9-F2A2-435B-8F16-EBA577A785D9}"/>
                </a:ext>
              </a:extLst>
            </p:cNvPr>
            <p:cNvSpPr/>
            <p:nvPr/>
          </p:nvSpPr>
          <p:spPr>
            <a:xfrm>
              <a:off x="176850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9" name="Freeform: Shape 828">
              <a:extLst>
                <a:ext uri="{FF2B5EF4-FFF2-40B4-BE49-F238E27FC236}">
                  <a16:creationId xmlns:a16="http://schemas.microsoft.com/office/drawing/2014/main" id="{387F62BA-DCF8-4473-BFA6-1295069D5224}"/>
                </a:ext>
              </a:extLst>
            </p:cNvPr>
            <p:cNvSpPr/>
            <p:nvPr/>
          </p:nvSpPr>
          <p:spPr>
            <a:xfrm>
              <a:off x="176850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0" name="Freeform: Shape 829">
              <a:extLst>
                <a:ext uri="{FF2B5EF4-FFF2-40B4-BE49-F238E27FC236}">
                  <a16:creationId xmlns:a16="http://schemas.microsoft.com/office/drawing/2014/main" id="{69AFB2E0-3AFA-478F-9FB2-040C81CC81FE}"/>
                </a:ext>
              </a:extLst>
            </p:cNvPr>
            <p:cNvSpPr/>
            <p:nvPr/>
          </p:nvSpPr>
          <p:spPr>
            <a:xfrm>
              <a:off x="433611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1" name="Freeform: Shape 830">
              <a:extLst>
                <a:ext uri="{FF2B5EF4-FFF2-40B4-BE49-F238E27FC236}">
                  <a16:creationId xmlns:a16="http://schemas.microsoft.com/office/drawing/2014/main" id="{8CA30420-CBBD-4865-B4B3-AF0C55BFCF6A}"/>
                </a:ext>
              </a:extLst>
            </p:cNvPr>
            <p:cNvSpPr/>
            <p:nvPr/>
          </p:nvSpPr>
          <p:spPr>
            <a:xfrm>
              <a:off x="433611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2" name="Freeform: Shape 831">
              <a:extLst>
                <a:ext uri="{FF2B5EF4-FFF2-40B4-BE49-F238E27FC236}">
                  <a16:creationId xmlns:a16="http://schemas.microsoft.com/office/drawing/2014/main" id="{D9992ACB-88F7-4E9F-8568-D6C769A0263F}"/>
                </a:ext>
              </a:extLst>
            </p:cNvPr>
            <p:cNvSpPr/>
            <p:nvPr/>
          </p:nvSpPr>
          <p:spPr>
            <a:xfrm>
              <a:off x="191117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3" name="Freeform: Shape 832">
              <a:extLst>
                <a:ext uri="{FF2B5EF4-FFF2-40B4-BE49-F238E27FC236}">
                  <a16:creationId xmlns:a16="http://schemas.microsoft.com/office/drawing/2014/main" id="{42586B4E-656E-45E8-8A78-17A766AF425D}"/>
                </a:ext>
              </a:extLst>
            </p:cNvPr>
            <p:cNvSpPr/>
            <p:nvPr/>
          </p:nvSpPr>
          <p:spPr>
            <a:xfrm>
              <a:off x="447871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4" name="Freeform: Shape 833">
              <a:extLst>
                <a:ext uri="{FF2B5EF4-FFF2-40B4-BE49-F238E27FC236}">
                  <a16:creationId xmlns:a16="http://schemas.microsoft.com/office/drawing/2014/main" id="{BF0C647F-C508-476C-91C5-BB45ACD195A4}"/>
                </a:ext>
              </a:extLst>
            </p:cNvPr>
            <p:cNvSpPr/>
            <p:nvPr/>
          </p:nvSpPr>
          <p:spPr>
            <a:xfrm>
              <a:off x="191117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5" name="Freeform: Shape 834">
              <a:extLst>
                <a:ext uri="{FF2B5EF4-FFF2-40B4-BE49-F238E27FC236}">
                  <a16:creationId xmlns:a16="http://schemas.microsoft.com/office/drawing/2014/main" id="{10534114-45C5-442E-AB31-8946CD224CD8}"/>
                </a:ext>
              </a:extLst>
            </p:cNvPr>
            <p:cNvSpPr/>
            <p:nvPr/>
          </p:nvSpPr>
          <p:spPr>
            <a:xfrm>
              <a:off x="191117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6" name="Freeform: Shape 835">
              <a:extLst>
                <a:ext uri="{FF2B5EF4-FFF2-40B4-BE49-F238E27FC236}">
                  <a16:creationId xmlns:a16="http://schemas.microsoft.com/office/drawing/2014/main" id="{AC08E020-0D11-4653-9C36-B24D7ED47008}"/>
                </a:ext>
              </a:extLst>
            </p:cNvPr>
            <p:cNvSpPr/>
            <p:nvPr/>
          </p:nvSpPr>
          <p:spPr>
            <a:xfrm>
              <a:off x="191117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7" name="Freeform: Shape 836">
              <a:extLst>
                <a:ext uri="{FF2B5EF4-FFF2-40B4-BE49-F238E27FC236}">
                  <a16:creationId xmlns:a16="http://schemas.microsoft.com/office/drawing/2014/main" id="{6994EAA5-5D82-4173-B836-6D97B67500DE}"/>
                </a:ext>
              </a:extLst>
            </p:cNvPr>
            <p:cNvSpPr/>
            <p:nvPr/>
          </p:nvSpPr>
          <p:spPr>
            <a:xfrm>
              <a:off x="447871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8" name="Freeform: Shape 837">
              <a:extLst>
                <a:ext uri="{FF2B5EF4-FFF2-40B4-BE49-F238E27FC236}">
                  <a16:creationId xmlns:a16="http://schemas.microsoft.com/office/drawing/2014/main" id="{B6DA8E28-B186-49F3-9552-F7A9DBF99A1C}"/>
                </a:ext>
              </a:extLst>
            </p:cNvPr>
            <p:cNvSpPr/>
            <p:nvPr/>
          </p:nvSpPr>
          <p:spPr>
            <a:xfrm>
              <a:off x="447871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9" name="Freeform: Shape 838">
              <a:extLst>
                <a:ext uri="{FF2B5EF4-FFF2-40B4-BE49-F238E27FC236}">
                  <a16:creationId xmlns:a16="http://schemas.microsoft.com/office/drawing/2014/main" id="{0E29FCC2-8386-4F3A-AFCB-2A47601B3AB4}"/>
                </a:ext>
              </a:extLst>
            </p:cNvPr>
            <p:cNvSpPr/>
            <p:nvPr/>
          </p:nvSpPr>
          <p:spPr>
            <a:xfrm>
              <a:off x="447871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0" name="Freeform: Shape 839">
              <a:extLst>
                <a:ext uri="{FF2B5EF4-FFF2-40B4-BE49-F238E27FC236}">
                  <a16:creationId xmlns:a16="http://schemas.microsoft.com/office/drawing/2014/main" id="{288AE7B4-3EFA-4469-8099-081E059976CD}"/>
                </a:ext>
              </a:extLst>
            </p:cNvPr>
            <p:cNvSpPr/>
            <p:nvPr/>
          </p:nvSpPr>
          <p:spPr>
            <a:xfrm>
              <a:off x="205385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1" name="Freeform: Shape 840">
              <a:extLst>
                <a:ext uri="{FF2B5EF4-FFF2-40B4-BE49-F238E27FC236}">
                  <a16:creationId xmlns:a16="http://schemas.microsoft.com/office/drawing/2014/main" id="{F92B6456-D075-4093-A3D6-221E1409EB35}"/>
                </a:ext>
              </a:extLst>
            </p:cNvPr>
            <p:cNvSpPr/>
            <p:nvPr/>
          </p:nvSpPr>
          <p:spPr>
            <a:xfrm>
              <a:off x="462138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2" name="Freeform: Shape 841">
              <a:extLst>
                <a:ext uri="{FF2B5EF4-FFF2-40B4-BE49-F238E27FC236}">
                  <a16:creationId xmlns:a16="http://schemas.microsoft.com/office/drawing/2014/main" id="{AB8FF9CB-00FE-4F0A-9B73-DE442C04E414}"/>
                </a:ext>
              </a:extLst>
            </p:cNvPr>
            <p:cNvSpPr/>
            <p:nvPr/>
          </p:nvSpPr>
          <p:spPr>
            <a:xfrm>
              <a:off x="205385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3" name="Freeform: Shape 842">
              <a:extLst>
                <a:ext uri="{FF2B5EF4-FFF2-40B4-BE49-F238E27FC236}">
                  <a16:creationId xmlns:a16="http://schemas.microsoft.com/office/drawing/2014/main" id="{C1250568-FE9F-463A-A60D-45AAD18B9817}"/>
                </a:ext>
              </a:extLst>
            </p:cNvPr>
            <p:cNvSpPr/>
            <p:nvPr/>
          </p:nvSpPr>
          <p:spPr>
            <a:xfrm>
              <a:off x="205385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4" name="Freeform: Shape 843">
              <a:extLst>
                <a:ext uri="{FF2B5EF4-FFF2-40B4-BE49-F238E27FC236}">
                  <a16:creationId xmlns:a16="http://schemas.microsoft.com/office/drawing/2014/main" id="{6660480E-A92A-4749-BB8C-EFFD5AB49BBE}"/>
                </a:ext>
              </a:extLst>
            </p:cNvPr>
            <p:cNvSpPr/>
            <p:nvPr/>
          </p:nvSpPr>
          <p:spPr>
            <a:xfrm>
              <a:off x="205385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5" name="Freeform: Shape 844">
              <a:extLst>
                <a:ext uri="{FF2B5EF4-FFF2-40B4-BE49-F238E27FC236}">
                  <a16:creationId xmlns:a16="http://schemas.microsoft.com/office/drawing/2014/main" id="{7128BED6-4374-4590-89CE-B4675CD9F433}"/>
                </a:ext>
              </a:extLst>
            </p:cNvPr>
            <p:cNvSpPr/>
            <p:nvPr/>
          </p:nvSpPr>
          <p:spPr>
            <a:xfrm>
              <a:off x="462138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6" name="Freeform: Shape 845">
              <a:extLst>
                <a:ext uri="{FF2B5EF4-FFF2-40B4-BE49-F238E27FC236}">
                  <a16:creationId xmlns:a16="http://schemas.microsoft.com/office/drawing/2014/main" id="{E3FDEB37-20C6-4E97-BF6A-72269357DB32}"/>
                </a:ext>
              </a:extLst>
            </p:cNvPr>
            <p:cNvSpPr/>
            <p:nvPr/>
          </p:nvSpPr>
          <p:spPr>
            <a:xfrm>
              <a:off x="462138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7" name="Freeform: Shape 846">
              <a:extLst>
                <a:ext uri="{FF2B5EF4-FFF2-40B4-BE49-F238E27FC236}">
                  <a16:creationId xmlns:a16="http://schemas.microsoft.com/office/drawing/2014/main" id="{AF6F21E1-82AA-4EE4-80FD-623AFACA3CB4}"/>
                </a:ext>
              </a:extLst>
            </p:cNvPr>
            <p:cNvSpPr/>
            <p:nvPr/>
          </p:nvSpPr>
          <p:spPr>
            <a:xfrm>
              <a:off x="462138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8" name="Freeform: Shape 847">
              <a:extLst>
                <a:ext uri="{FF2B5EF4-FFF2-40B4-BE49-F238E27FC236}">
                  <a16:creationId xmlns:a16="http://schemas.microsoft.com/office/drawing/2014/main" id="{B7711CEE-2DC1-4C01-A3B7-B4483EFE5BF1}"/>
                </a:ext>
              </a:extLst>
            </p:cNvPr>
            <p:cNvSpPr/>
            <p:nvPr/>
          </p:nvSpPr>
          <p:spPr>
            <a:xfrm>
              <a:off x="219645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49" name="Freeform: Shape 848">
              <a:extLst>
                <a:ext uri="{FF2B5EF4-FFF2-40B4-BE49-F238E27FC236}">
                  <a16:creationId xmlns:a16="http://schemas.microsoft.com/office/drawing/2014/main" id="{0297294F-4D05-48FE-9837-43A5800561FA}"/>
                </a:ext>
              </a:extLst>
            </p:cNvPr>
            <p:cNvSpPr/>
            <p:nvPr/>
          </p:nvSpPr>
          <p:spPr>
            <a:xfrm>
              <a:off x="476406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0" name="Freeform: Shape 849">
              <a:extLst>
                <a:ext uri="{FF2B5EF4-FFF2-40B4-BE49-F238E27FC236}">
                  <a16:creationId xmlns:a16="http://schemas.microsoft.com/office/drawing/2014/main" id="{42D4C426-27C5-4CE4-AFAA-63F839FE54B9}"/>
                </a:ext>
              </a:extLst>
            </p:cNvPr>
            <p:cNvSpPr/>
            <p:nvPr/>
          </p:nvSpPr>
          <p:spPr>
            <a:xfrm>
              <a:off x="219645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1" name="Freeform: Shape 850">
              <a:extLst>
                <a:ext uri="{FF2B5EF4-FFF2-40B4-BE49-F238E27FC236}">
                  <a16:creationId xmlns:a16="http://schemas.microsoft.com/office/drawing/2014/main" id="{3F2CB39A-FD42-44F6-A346-1E852A0C87A0}"/>
                </a:ext>
              </a:extLst>
            </p:cNvPr>
            <p:cNvSpPr/>
            <p:nvPr/>
          </p:nvSpPr>
          <p:spPr>
            <a:xfrm>
              <a:off x="219645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2" name="Freeform: Shape 851">
              <a:extLst>
                <a:ext uri="{FF2B5EF4-FFF2-40B4-BE49-F238E27FC236}">
                  <a16:creationId xmlns:a16="http://schemas.microsoft.com/office/drawing/2014/main" id="{5990B966-48ED-4B84-9273-244F174D60B5}"/>
                </a:ext>
              </a:extLst>
            </p:cNvPr>
            <p:cNvSpPr/>
            <p:nvPr/>
          </p:nvSpPr>
          <p:spPr>
            <a:xfrm>
              <a:off x="219645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3" name="Freeform: Shape 852">
              <a:extLst>
                <a:ext uri="{FF2B5EF4-FFF2-40B4-BE49-F238E27FC236}">
                  <a16:creationId xmlns:a16="http://schemas.microsoft.com/office/drawing/2014/main" id="{9F689D6B-B144-4A45-AC2E-486376DD0696}"/>
                </a:ext>
              </a:extLst>
            </p:cNvPr>
            <p:cNvSpPr/>
            <p:nvPr/>
          </p:nvSpPr>
          <p:spPr>
            <a:xfrm>
              <a:off x="476406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4" name="Freeform: Shape 853">
              <a:extLst>
                <a:ext uri="{FF2B5EF4-FFF2-40B4-BE49-F238E27FC236}">
                  <a16:creationId xmlns:a16="http://schemas.microsoft.com/office/drawing/2014/main" id="{BAEE4ABA-15B5-4E6E-934F-6C6FA100AB09}"/>
                </a:ext>
              </a:extLst>
            </p:cNvPr>
            <p:cNvSpPr/>
            <p:nvPr/>
          </p:nvSpPr>
          <p:spPr>
            <a:xfrm>
              <a:off x="476406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5" name="Freeform: Shape 854">
              <a:extLst>
                <a:ext uri="{FF2B5EF4-FFF2-40B4-BE49-F238E27FC236}">
                  <a16:creationId xmlns:a16="http://schemas.microsoft.com/office/drawing/2014/main" id="{F628676A-17C1-4284-8E43-5D301C945A67}"/>
                </a:ext>
              </a:extLst>
            </p:cNvPr>
            <p:cNvSpPr/>
            <p:nvPr/>
          </p:nvSpPr>
          <p:spPr>
            <a:xfrm>
              <a:off x="476406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6" name="Freeform: Shape 855">
              <a:extLst>
                <a:ext uri="{FF2B5EF4-FFF2-40B4-BE49-F238E27FC236}">
                  <a16:creationId xmlns:a16="http://schemas.microsoft.com/office/drawing/2014/main" id="{F4EE78F8-E63C-4E5F-BA5B-34B5E611D323}"/>
                </a:ext>
              </a:extLst>
            </p:cNvPr>
            <p:cNvSpPr/>
            <p:nvPr/>
          </p:nvSpPr>
          <p:spPr>
            <a:xfrm>
              <a:off x="233912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7" name="Freeform: Shape 856">
              <a:extLst>
                <a:ext uri="{FF2B5EF4-FFF2-40B4-BE49-F238E27FC236}">
                  <a16:creationId xmlns:a16="http://schemas.microsoft.com/office/drawing/2014/main" id="{D6F86757-2EC5-435F-86BB-A7D7D2FF4F4D}"/>
                </a:ext>
              </a:extLst>
            </p:cNvPr>
            <p:cNvSpPr/>
            <p:nvPr/>
          </p:nvSpPr>
          <p:spPr>
            <a:xfrm>
              <a:off x="490666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8" name="Freeform: Shape 857">
              <a:extLst>
                <a:ext uri="{FF2B5EF4-FFF2-40B4-BE49-F238E27FC236}">
                  <a16:creationId xmlns:a16="http://schemas.microsoft.com/office/drawing/2014/main" id="{D84902E9-57D8-4D83-9F49-720C52D40634}"/>
                </a:ext>
              </a:extLst>
            </p:cNvPr>
            <p:cNvSpPr/>
            <p:nvPr/>
          </p:nvSpPr>
          <p:spPr>
            <a:xfrm>
              <a:off x="233912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9" name="Freeform: Shape 858">
              <a:extLst>
                <a:ext uri="{FF2B5EF4-FFF2-40B4-BE49-F238E27FC236}">
                  <a16:creationId xmlns:a16="http://schemas.microsoft.com/office/drawing/2014/main" id="{963D2EC3-F79A-4185-AEC0-211131F160E5}"/>
                </a:ext>
              </a:extLst>
            </p:cNvPr>
            <p:cNvSpPr/>
            <p:nvPr/>
          </p:nvSpPr>
          <p:spPr>
            <a:xfrm>
              <a:off x="233912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0" name="Freeform: Shape 859">
              <a:extLst>
                <a:ext uri="{FF2B5EF4-FFF2-40B4-BE49-F238E27FC236}">
                  <a16:creationId xmlns:a16="http://schemas.microsoft.com/office/drawing/2014/main" id="{C1686580-00FA-41C7-B15B-3F77EBDCE6EA}"/>
                </a:ext>
              </a:extLst>
            </p:cNvPr>
            <p:cNvSpPr/>
            <p:nvPr/>
          </p:nvSpPr>
          <p:spPr>
            <a:xfrm>
              <a:off x="233912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1" name="Freeform: Shape 860">
              <a:extLst>
                <a:ext uri="{FF2B5EF4-FFF2-40B4-BE49-F238E27FC236}">
                  <a16:creationId xmlns:a16="http://schemas.microsoft.com/office/drawing/2014/main" id="{810AF588-7FC0-4F64-AB9C-6BD51CDF3360}"/>
                </a:ext>
              </a:extLst>
            </p:cNvPr>
            <p:cNvSpPr/>
            <p:nvPr/>
          </p:nvSpPr>
          <p:spPr>
            <a:xfrm>
              <a:off x="490666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2" name="Freeform: Shape 861">
              <a:extLst>
                <a:ext uri="{FF2B5EF4-FFF2-40B4-BE49-F238E27FC236}">
                  <a16:creationId xmlns:a16="http://schemas.microsoft.com/office/drawing/2014/main" id="{37E176EE-EABE-4929-AD74-7BF17B573631}"/>
                </a:ext>
              </a:extLst>
            </p:cNvPr>
            <p:cNvSpPr/>
            <p:nvPr/>
          </p:nvSpPr>
          <p:spPr>
            <a:xfrm>
              <a:off x="490666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3" name="Freeform: Shape 862">
              <a:extLst>
                <a:ext uri="{FF2B5EF4-FFF2-40B4-BE49-F238E27FC236}">
                  <a16:creationId xmlns:a16="http://schemas.microsoft.com/office/drawing/2014/main" id="{98940014-7788-4596-9C57-C81C8A32F556}"/>
                </a:ext>
              </a:extLst>
            </p:cNvPr>
            <p:cNvSpPr/>
            <p:nvPr/>
          </p:nvSpPr>
          <p:spPr>
            <a:xfrm>
              <a:off x="490666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4" name="Freeform: Shape 863">
              <a:extLst>
                <a:ext uri="{FF2B5EF4-FFF2-40B4-BE49-F238E27FC236}">
                  <a16:creationId xmlns:a16="http://schemas.microsoft.com/office/drawing/2014/main" id="{181A2E34-3513-4384-98B7-6B1D123A46B9}"/>
                </a:ext>
              </a:extLst>
            </p:cNvPr>
            <p:cNvSpPr/>
            <p:nvPr/>
          </p:nvSpPr>
          <p:spPr>
            <a:xfrm>
              <a:off x="248172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5" name="Freeform: Shape 864">
              <a:extLst>
                <a:ext uri="{FF2B5EF4-FFF2-40B4-BE49-F238E27FC236}">
                  <a16:creationId xmlns:a16="http://schemas.microsoft.com/office/drawing/2014/main" id="{50BD3A1F-7B9E-442B-A08F-17EF0A1CA416}"/>
                </a:ext>
              </a:extLst>
            </p:cNvPr>
            <p:cNvSpPr/>
            <p:nvPr/>
          </p:nvSpPr>
          <p:spPr>
            <a:xfrm>
              <a:off x="248172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6" name="Freeform: Shape 865">
              <a:extLst>
                <a:ext uri="{FF2B5EF4-FFF2-40B4-BE49-F238E27FC236}">
                  <a16:creationId xmlns:a16="http://schemas.microsoft.com/office/drawing/2014/main" id="{5BDBB410-F33C-4268-87F1-B2F87DB9A27D}"/>
                </a:ext>
              </a:extLst>
            </p:cNvPr>
            <p:cNvSpPr/>
            <p:nvPr/>
          </p:nvSpPr>
          <p:spPr>
            <a:xfrm>
              <a:off x="248172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7" name="Freeform: Shape 866">
              <a:extLst>
                <a:ext uri="{FF2B5EF4-FFF2-40B4-BE49-F238E27FC236}">
                  <a16:creationId xmlns:a16="http://schemas.microsoft.com/office/drawing/2014/main" id="{BD19F2CB-5E46-4887-8A9E-478666765288}"/>
                </a:ext>
              </a:extLst>
            </p:cNvPr>
            <p:cNvSpPr/>
            <p:nvPr/>
          </p:nvSpPr>
          <p:spPr>
            <a:xfrm>
              <a:off x="248172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8" name="Freeform: Shape 867">
              <a:extLst>
                <a:ext uri="{FF2B5EF4-FFF2-40B4-BE49-F238E27FC236}">
                  <a16:creationId xmlns:a16="http://schemas.microsoft.com/office/drawing/2014/main" id="{980C9EB8-3771-4576-8A61-C962569C37F2}"/>
                </a:ext>
              </a:extLst>
            </p:cNvPr>
            <p:cNvSpPr/>
            <p:nvPr/>
          </p:nvSpPr>
          <p:spPr>
            <a:xfrm>
              <a:off x="2624399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9" name="Freeform: Shape 868">
              <a:extLst>
                <a:ext uri="{FF2B5EF4-FFF2-40B4-BE49-F238E27FC236}">
                  <a16:creationId xmlns:a16="http://schemas.microsoft.com/office/drawing/2014/main" id="{688CE1B3-BC70-452E-A6D2-F2C0AE6B43F2}"/>
                </a:ext>
              </a:extLst>
            </p:cNvPr>
            <p:cNvSpPr/>
            <p:nvPr/>
          </p:nvSpPr>
          <p:spPr>
            <a:xfrm>
              <a:off x="2624399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0" name="Freeform: Shape 869">
              <a:extLst>
                <a:ext uri="{FF2B5EF4-FFF2-40B4-BE49-F238E27FC236}">
                  <a16:creationId xmlns:a16="http://schemas.microsoft.com/office/drawing/2014/main" id="{552C5AE6-C329-4D73-A84D-9B16B41773F0}"/>
                </a:ext>
              </a:extLst>
            </p:cNvPr>
            <p:cNvSpPr/>
            <p:nvPr/>
          </p:nvSpPr>
          <p:spPr>
            <a:xfrm>
              <a:off x="2624399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1" name="Freeform: Shape 870">
              <a:extLst>
                <a:ext uri="{FF2B5EF4-FFF2-40B4-BE49-F238E27FC236}">
                  <a16:creationId xmlns:a16="http://schemas.microsoft.com/office/drawing/2014/main" id="{7D15C064-9B9E-41DA-906D-AA1A6F6E3ADC}"/>
                </a:ext>
              </a:extLst>
            </p:cNvPr>
            <p:cNvSpPr/>
            <p:nvPr/>
          </p:nvSpPr>
          <p:spPr>
            <a:xfrm>
              <a:off x="2624399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2" name="Freeform: Shape 871">
              <a:extLst>
                <a:ext uri="{FF2B5EF4-FFF2-40B4-BE49-F238E27FC236}">
                  <a16:creationId xmlns:a16="http://schemas.microsoft.com/office/drawing/2014/main" id="{B544968A-A9B0-48B5-BE84-5C5E4497696C}"/>
                </a:ext>
              </a:extLst>
            </p:cNvPr>
            <p:cNvSpPr/>
            <p:nvPr/>
          </p:nvSpPr>
          <p:spPr>
            <a:xfrm>
              <a:off x="2767072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3" name="Freeform: Shape 872">
              <a:extLst>
                <a:ext uri="{FF2B5EF4-FFF2-40B4-BE49-F238E27FC236}">
                  <a16:creationId xmlns:a16="http://schemas.microsoft.com/office/drawing/2014/main" id="{E385463A-41E9-4348-9685-9B76AD4D353D}"/>
                </a:ext>
              </a:extLst>
            </p:cNvPr>
            <p:cNvSpPr/>
            <p:nvPr/>
          </p:nvSpPr>
          <p:spPr>
            <a:xfrm>
              <a:off x="2767072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4" name="Freeform: Shape 873">
              <a:extLst>
                <a:ext uri="{FF2B5EF4-FFF2-40B4-BE49-F238E27FC236}">
                  <a16:creationId xmlns:a16="http://schemas.microsoft.com/office/drawing/2014/main" id="{15D43192-8471-4C5C-A6DB-60BDE951F3B6}"/>
                </a:ext>
              </a:extLst>
            </p:cNvPr>
            <p:cNvSpPr/>
            <p:nvPr/>
          </p:nvSpPr>
          <p:spPr>
            <a:xfrm>
              <a:off x="2767072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5" name="Freeform: Shape 874">
              <a:extLst>
                <a:ext uri="{FF2B5EF4-FFF2-40B4-BE49-F238E27FC236}">
                  <a16:creationId xmlns:a16="http://schemas.microsoft.com/office/drawing/2014/main" id="{7D052CE3-8D1D-40A6-899C-9DFF31D90C5D}"/>
                </a:ext>
              </a:extLst>
            </p:cNvPr>
            <p:cNvSpPr/>
            <p:nvPr/>
          </p:nvSpPr>
          <p:spPr>
            <a:xfrm>
              <a:off x="2767072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6" name="Freeform: Shape 875">
              <a:extLst>
                <a:ext uri="{FF2B5EF4-FFF2-40B4-BE49-F238E27FC236}">
                  <a16:creationId xmlns:a16="http://schemas.microsoft.com/office/drawing/2014/main" id="{25F1DBFC-5D6D-40D4-8B1F-CEAD14768DE6}"/>
                </a:ext>
              </a:extLst>
            </p:cNvPr>
            <p:cNvSpPr/>
            <p:nvPr/>
          </p:nvSpPr>
          <p:spPr>
            <a:xfrm>
              <a:off x="290967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7" name="Freeform: Shape 876">
              <a:extLst>
                <a:ext uri="{FF2B5EF4-FFF2-40B4-BE49-F238E27FC236}">
                  <a16:creationId xmlns:a16="http://schemas.microsoft.com/office/drawing/2014/main" id="{55E3AE1B-1B63-4BEF-A327-5C9BFDB5B310}"/>
                </a:ext>
              </a:extLst>
            </p:cNvPr>
            <p:cNvSpPr/>
            <p:nvPr/>
          </p:nvSpPr>
          <p:spPr>
            <a:xfrm>
              <a:off x="290967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8" name="Freeform: Shape 877">
              <a:extLst>
                <a:ext uri="{FF2B5EF4-FFF2-40B4-BE49-F238E27FC236}">
                  <a16:creationId xmlns:a16="http://schemas.microsoft.com/office/drawing/2014/main" id="{D5C02D53-BD48-4772-AAE3-6ADF01D9F4AF}"/>
                </a:ext>
              </a:extLst>
            </p:cNvPr>
            <p:cNvSpPr/>
            <p:nvPr/>
          </p:nvSpPr>
          <p:spPr>
            <a:xfrm>
              <a:off x="290967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9" name="Freeform: Shape 878">
              <a:extLst>
                <a:ext uri="{FF2B5EF4-FFF2-40B4-BE49-F238E27FC236}">
                  <a16:creationId xmlns:a16="http://schemas.microsoft.com/office/drawing/2014/main" id="{101686CC-4B91-4D77-85DC-D29209B2F89F}"/>
                </a:ext>
              </a:extLst>
            </p:cNvPr>
            <p:cNvSpPr/>
            <p:nvPr/>
          </p:nvSpPr>
          <p:spPr>
            <a:xfrm>
              <a:off x="290967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0" name="Freeform: Shape 879">
              <a:extLst>
                <a:ext uri="{FF2B5EF4-FFF2-40B4-BE49-F238E27FC236}">
                  <a16:creationId xmlns:a16="http://schemas.microsoft.com/office/drawing/2014/main" id="{5BA27A01-562C-4A2A-9F23-6A59F803FAE7}"/>
                </a:ext>
              </a:extLst>
            </p:cNvPr>
            <p:cNvSpPr/>
            <p:nvPr/>
          </p:nvSpPr>
          <p:spPr>
            <a:xfrm>
              <a:off x="305234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1" name="Freeform: Shape 880">
              <a:extLst>
                <a:ext uri="{FF2B5EF4-FFF2-40B4-BE49-F238E27FC236}">
                  <a16:creationId xmlns:a16="http://schemas.microsoft.com/office/drawing/2014/main" id="{756FCA17-118A-4A43-9122-DEFB4E2F86B2}"/>
                </a:ext>
              </a:extLst>
            </p:cNvPr>
            <p:cNvSpPr/>
            <p:nvPr/>
          </p:nvSpPr>
          <p:spPr>
            <a:xfrm>
              <a:off x="305234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2" name="Freeform: Shape 881">
              <a:extLst>
                <a:ext uri="{FF2B5EF4-FFF2-40B4-BE49-F238E27FC236}">
                  <a16:creationId xmlns:a16="http://schemas.microsoft.com/office/drawing/2014/main" id="{7324A662-54D5-4782-9149-30E908480F76}"/>
                </a:ext>
              </a:extLst>
            </p:cNvPr>
            <p:cNvSpPr/>
            <p:nvPr/>
          </p:nvSpPr>
          <p:spPr>
            <a:xfrm>
              <a:off x="305234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3" name="Freeform: Shape 882">
              <a:extLst>
                <a:ext uri="{FF2B5EF4-FFF2-40B4-BE49-F238E27FC236}">
                  <a16:creationId xmlns:a16="http://schemas.microsoft.com/office/drawing/2014/main" id="{95CDD55D-4360-4B69-ADA7-8698222B5025}"/>
                </a:ext>
              </a:extLst>
            </p:cNvPr>
            <p:cNvSpPr/>
            <p:nvPr/>
          </p:nvSpPr>
          <p:spPr>
            <a:xfrm>
              <a:off x="305234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4" name="Freeform: Shape 883">
              <a:extLst>
                <a:ext uri="{FF2B5EF4-FFF2-40B4-BE49-F238E27FC236}">
                  <a16:creationId xmlns:a16="http://schemas.microsoft.com/office/drawing/2014/main" id="{AC798404-ECCA-418B-971E-DDCC381B2631}"/>
                </a:ext>
              </a:extLst>
            </p:cNvPr>
            <p:cNvSpPr/>
            <p:nvPr/>
          </p:nvSpPr>
          <p:spPr>
            <a:xfrm>
              <a:off x="319494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5" name="Freeform: Shape 884">
              <a:extLst>
                <a:ext uri="{FF2B5EF4-FFF2-40B4-BE49-F238E27FC236}">
                  <a16:creationId xmlns:a16="http://schemas.microsoft.com/office/drawing/2014/main" id="{99E7AACC-D298-400B-B329-BC7C4F1AEB03}"/>
                </a:ext>
              </a:extLst>
            </p:cNvPr>
            <p:cNvSpPr/>
            <p:nvPr/>
          </p:nvSpPr>
          <p:spPr>
            <a:xfrm>
              <a:off x="319494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6" name="Freeform: Shape 885">
              <a:extLst>
                <a:ext uri="{FF2B5EF4-FFF2-40B4-BE49-F238E27FC236}">
                  <a16:creationId xmlns:a16="http://schemas.microsoft.com/office/drawing/2014/main" id="{8409EB2A-DC83-4734-ACCF-10599AE2A5FD}"/>
                </a:ext>
              </a:extLst>
            </p:cNvPr>
            <p:cNvSpPr/>
            <p:nvPr/>
          </p:nvSpPr>
          <p:spPr>
            <a:xfrm>
              <a:off x="319494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7" name="Freeform: Shape 886">
              <a:extLst>
                <a:ext uri="{FF2B5EF4-FFF2-40B4-BE49-F238E27FC236}">
                  <a16:creationId xmlns:a16="http://schemas.microsoft.com/office/drawing/2014/main" id="{FB245EE9-F005-4F49-9DD7-4EFBD53B9D20}"/>
                </a:ext>
              </a:extLst>
            </p:cNvPr>
            <p:cNvSpPr/>
            <p:nvPr/>
          </p:nvSpPr>
          <p:spPr>
            <a:xfrm>
              <a:off x="319494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8" name="Freeform: Shape 887">
              <a:extLst>
                <a:ext uri="{FF2B5EF4-FFF2-40B4-BE49-F238E27FC236}">
                  <a16:creationId xmlns:a16="http://schemas.microsoft.com/office/drawing/2014/main" id="{C6FBE0C9-23EC-4E5F-853F-732D5E61FA1F}"/>
                </a:ext>
              </a:extLst>
            </p:cNvPr>
            <p:cNvSpPr/>
            <p:nvPr/>
          </p:nvSpPr>
          <p:spPr>
            <a:xfrm>
              <a:off x="3337620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9" name="Freeform: Shape 888">
              <a:extLst>
                <a:ext uri="{FF2B5EF4-FFF2-40B4-BE49-F238E27FC236}">
                  <a16:creationId xmlns:a16="http://schemas.microsoft.com/office/drawing/2014/main" id="{0EB53203-49F2-45F5-BB5E-B9D3A7BA723D}"/>
                </a:ext>
              </a:extLst>
            </p:cNvPr>
            <p:cNvSpPr/>
            <p:nvPr/>
          </p:nvSpPr>
          <p:spPr>
            <a:xfrm>
              <a:off x="3337620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0" name="Freeform: Shape 889">
              <a:extLst>
                <a:ext uri="{FF2B5EF4-FFF2-40B4-BE49-F238E27FC236}">
                  <a16:creationId xmlns:a16="http://schemas.microsoft.com/office/drawing/2014/main" id="{8CBBB3F5-5033-4513-A6D9-1175A005C8DA}"/>
                </a:ext>
              </a:extLst>
            </p:cNvPr>
            <p:cNvSpPr/>
            <p:nvPr/>
          </p:nvSpPr>
          <p:spPr>
            <a:xfrm>
              <a:off x="3337620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1" name="Freeform: Shape 890">
              <a:extLst>
                <a:ext uri="{FF2B5EF4-FFF2-40B4-BE49-F238E27FC236}">
                  <a16:creationId xmlns:a16="http://schemas.microsoft.com/office/drawing/2014/main" id="{DBE2E459-8FFC-4E01-8840-A55554A07315}"/>
                </a:ext>
              </a:extLst>
            </p:cNvPr>
            <p:cNvSpPr/>
            <p:nvPr/>
          </p:nvSpPr>
          <p:spPr>
            <a:xfrm>
              <a:off x="3337620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2" name="Freeform: Shape 891">
              <a:extLst>
                <a:ext uri="{FF2B5EF4-FFF2-40B4-BE49-F238E27FC236}">
                  <a16:creationId xmlns:a16="http://schemas.microsoft.com/office/drawing/2014/main" id="{4C44B840-6C74-463D-BB7E-57AF8C047CA5}"/>
                </a:ext>
              </a:extLst>
            </p:cNvPr>
            <p:cNvSpPr/>
            <p:nvPr/>
          </p:nvSpPr>
          <p:spPr>
            <a:xfrm>
              <a:off x="1055356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3" name="Freeform: Shape 892">
              <a:extLst>
                <a:ext uri="{FF2B5EF4-FFF2-40B4-BE49-F238E27FC236}">
                  <a16:creationId xmlns:a16="http://schemas.microsoft.com/office/drawing/2014/main" id="{43C9EC05-7F21-4FEA-87A7-ABE907C8B56F}"/>
                </a:ext>
              </a:extLst>
            </p:cNvPr>
            <p:cNvSpPr/>
            <p:nvPr/>
          </p:nvSpPr>
          <p:spPr>
            <a:xfrm>
              <a:off x="362289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4" name="Freeform: Shape 893">
              <a:extLst>
                <a:ext uri="{FF2B5EF4-FFF2-40B4-BE49-F238E27FC236}">
                  <a16:creationId xmlns:a16="http://schemas.microsoft.com/office/drawing/2014/main" id="{587CE760-4F1A-4F03-BDB6-117B87A1993B}"/>
                </a:ext>
              </a:extLst>
            </p:cNvPr>
            <p:cNvSpPr/>
            <p:nvPr/>
          </p:nvSpPr>
          <p:spPr>
            <a:xfrm>
              <a:off x="1055356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5" name="Freeform: Shape 894">
              <a:extLst>
                <a:ext uri="{FF2B5EF4-FFF2-40B4-BE49-F238E27FC236}">
                  <a16:creationId xmlns:a16="http://schemas.microsoft.com/office/drawing/2014/main" id="{4C58FCE0-B2E9-42B3-B471-C7C314D908E3}"/>
                </a:ext>
              </a:extLst>
            </p:cNvPr>
            <p:cNvSpPr/>
            <p:nvPr/>
          </p:nvSpPr>
          <p:spPr>
            <a:xfrm>
              <a:off x="1055356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6" name="Freeform: Shape 895">
              <a:extLst>
                <a:ext uri="{FF2B5EF4-FFF2-40B4-BE49-F238E27FC236}">
                  <a16:creationId xmlns:a16="http://schemas.microsoft.com/office/drawing/2014/main" id="{71CFEA5C-0BC9-4C62-BB26-A071B2446252}"/>
                </a:ext>
              </a:extLst>
            </p:cNvPr>
            <p:cNvSpPr/>
            <p:nvPr/>
          </p:nvSpPr>
          <p:spPr>
            <a:xfrm>
              <a:off x="1055356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7" name="Freeform: Shape 896">
              <a:extLst>
                <a:ext uri="{FF2B5EF4-FFF2-40B4-BE49-F238E27FC236}">
                  <a16:creationId xmlns:a16="http://schemas.microsoft.com/office/drawing/2014/main" id="{C6E2CDC1-E1E2-4F13-89EB-70BC5F5EBF03}"/>
                </a:ext>
              </a:extLst>
            </p:cNvPr>
            <p:cNvSpPr/>
            <p:nvPr/>
          </p:nvSpPr>
          <p:spPr>
            <a:xfrm>
              <a:off x="362289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8" name="Freeform: Shape 897">
              <a:extLst>
                <a:ext uri="{FF2B5EF4-FFF2-40B4-BE49-F238E27FC236}">
                  <a16:creationId xmlns:a16="http://schemas.microsoft.com/office/drawing/2014/main" id="{C28CFF3C-7D40-4585-BF88-E080E8385840}"/>
                </a:ext>
              </a:extLst>
            </p:cNvPr>
            <p:cNvSpPr/>
            <p:nvPr/>
          </p:nvSpPr>
          <p:spPr>
            <a:xfrm>
              <a:off x="362289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9" name="Freeform: Shape 898">
              <a:extLst>
                <a:ext uri="{FF2B5EF4-FFF2-40B4-BE49-F238E27FC236}">
                  <a16:creationId xmlns:a16="http://schemas.microsoft.com/office/drawing/2014/main" id="{2D61B68B-DA86-45F8-813F-A389C968EF77}"/>
                </a:ext>
              </a:extLst>
            </p:cNvPr>
            <p:cNvSpPr/>
            <p:nvPr/>
          </p:nvSpPr>
          <p:spPr>
            <a:xfrm>
              <a:off x="362289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0" name="Freeform: Shape 899">
              <a:extLst>
                <a:ext uri="{FF2B5EF4-FFF2-40B4-BE49-F238E27FC236}">
                  <a16:creationId xmlns:a16="http://schemas.microsoft.com/office/drawing/2014/main" id="{7C0B32C7-B08E-4DC8-A2EF-90173D1664BC}"/>
                </a:ext>
              </a:extLst>
            </p:cNvPr>
            <p:cNvSpPr/>
            <p:nvPr/>
          </p:nvSpPr>
          <p:spPr>
            <a:xfrm>
              <a:off x="433611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1" name="Freeform: Shape 900">
              <a:extLst>
                <a:ext uri="{FF2B5EF4-FFF2-40B4-BE49-F238E27FC236}">
                  <a16:creationId xmlns:a16="http://schemas.microsoft.com/office/drawing/2014/main" id="{375AF5F3-5A05-4437-8E4F-FF23A6C04821}"/>
                </a:ext>
              </a:extLst>
            </p:cNvPr>
            <p:cNvSpPr/>
            <p:nvPr/>
          </p:nvSpPr>
          <p:spPr>
            <a:xfrm>
              <a:off x="57964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2" name="Freeform: Shape 901">
              <a:extLst>
                <a:ext uri="{FF2B5EF4-FFF2-40B4-BE49-F238E27FC236}">
                  <a16:creationId xmlns:a16="http://schemas.microsoft.com/office/drawing/2014/main" id="{A8B23A5C-026F-402B-8F7F-5E9F8A583E63}"/>
                </a:ext>
              </a:extLst>
            </p:cNvPr>
            <p:cNvSpPr/>
            <p:nvPr/>
          </p:nvSpPr>
          <p:spPr>
            <a:xfrm>
              <a:off x="57964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3" name="Freeform: Shape 902">
              <a:extLst>
                <a:ext uri="{FF2B5EF4-FFF2-40B4-BE49-F238E27FC236}">
                  <a16:creationId xmlns:a16="http://schemas.microsoft.com/office/drawing/2014/main" id="{7F6CA2C8-7B51-4BE3-BD01-CCF8DF7F116A}"/>
                </a:ext>
              </a:extLst>
            </p:cNvPr>
            <p:cNvSpPr/>
            <p:nvPr/>
          </p:nvSpPr>
          <p:spPr>
            <a:xfrm>
              <a:off x="57964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4" name="Freeform: Shape 903">
              <a:extLst>
                <a:ext uri="{FF2B5EF4-FFF2-40B4-BE49-F238E27FC236}">
                  <a16:creationId xmlns:a16="http://schemas.microsoft.com/office/drawing/2014/main" id="{29F96600-B88D-4993-A53B-3C4D2D8752DE}"/>
                </a:ext>
              </a:extLst>
            </p:cNvPr>
            <p:cNvSpPr/>
            <p:nvPr/>
          </p:nvSpPr>
          <p:spPr>
            <a:xfrm>
              <a:off x="57964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5" name="Freeform: Shape 904">
              <a:extLst>
                <a:ext uri="{FF2B5EF4-FFF2-40B4-BE49-F238E27FC236}">
                  <a16:creationId xmlns:a16="http://schemas.microsoft.com/office/drawing/2014/main" id="{ED8117D8-1CF2-4F73-AE84-4FC83191C945}"/>
                </a:ext>
              </a:extLst>
            </p:cNvPr>
            <p:cNvSpPr/>
            <p:nvPr/>
          </p:nvSpPr>
          <p:spPr>
            <a:xfrm>
              <a:off x="200637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6" name="Freeform: Shape 905">
              <a:extLst>
                <a:ext uri="{FF2B5EF4-FFF2-40B4-BE49-F238E27FC236}">
                  <a16:creationId xmlns:a16="http://schemas.microsoft.com/office/drawing/2014/main" id="{C99E34F5-B917-4D14-B8E1-1A02F5364878}"/>
                </a:ext>
              </a:extLst>
            </p:cNvPr>
            <p:cNvSpPr/>
            <p:nvPr/>
          </p:nvSpPr>
          <p:spPr>
            <a:xfrm>
              <a:off x="200637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7" name="Freeform: Shape 906">
              <a:extLst>
                <a:ext uri="{FF2B5EF4-FFF2-40B4-BE49-F238E27FC236}">
                  <a16:creationId xmlns:a16="http://schemas.microsoft.com/office/drawing/2014/main" id="{D390F972-38CA-4EBE-BAFD-7D0F813F4EAA}"/>
                </a:ext>
              </a:extLst>
            </p:cNvPr>
            <p:cNvSpPr/>
            <p:nvPr/>
          </p:nvSpPr>
          <p:spPr>
            <a:xfrm>
              <a:off x="200637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8" name="Freeform: Shape 907">
              <a:extLst>
                <a:ext uri="{FF2B5EF4-FFF2-40B4-BE49-F238E27FC236}">
                  <a16:creationId xmlns:a16="http://schemas.microsoft.com/office/drawing/2014/main" id="{6EAE91E7-5A44-491E-8702-CE331227F2D9}"/>
                </a:ext>
              </a:extLst>
            </p:cNvPr>
            <p:cNvSpPr/>
            <p:nvPr/>
          </p:nvSpPr>
          <p:spPr>
            <a:xfrm>
              <a:off x="343238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09" name="Freeform: Shape 908">
              <a:extLst>
                <a:ext uri="{FF2B5EF4-FFF2-40B4-BE49-F238E27FC236}">
                  <a16:creationId xmlns:a16="http://schemas.microsoft.com/office/drawing/2014/main" id="{700FA56A-C9BE-4294-9B85-2A9E535382B5}"/>
                </a:ext>
              </a:extLst>
            </p:cNvPr>
            <p:cNvSpPr/>
            <p:nvPr/>
          </p:nvSpPr>
          <p:spPr>
            <a:xfrm>
              <a:off x="343238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0" name="Freeform: Shape 909">
              <a:extLst>
                <a:ext uri="{FF2B5EF4-FFF2-40B4-BE49-F238E27FC236}">
                  <a16:creationId xmlns:a16="http://schemas.microsoft.com/office/drawing/2014/main" id="{6A42420D-4DBC-44C9-B6EF-F8C968C5571E}"/>
                </a:ext>
              </a:extLst>
            </p:cNvPr>
            <p:cNvSpPr/>
            <p:nvPr/>
          </p:nvSpPr>
          <p:spPr>
            <a:xfrm>
              <a:off x="343238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1" name="Freeform: Shape 910">
              <a:extLst>
                <a:ext uri="{FF2B5EF4-FFF2-40B4-BE49-F238E27FC236}">
                  <a16:creationId xmlns:a16="http://schemas.microsoft.com/office/drawing/2014/main" id="{3B894FE5-7282-440F-B3BD-DE4F9A562555}"/>
                </a:ext>
              </a:extLst>
            </p:cNvPr>
            <p:cNvSpPr/>
            <p:nvPr/>
          </p:nvSpPr>
          <p:spPr>
            <a:xfrm>
              <a:off x="343238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2" name="Freeform: Shape 911">
              <a:extLst>
                <a:ext uri="{FF2B5EF4-FFF2-40B4-BE49-F238E27FC236}">
                  <a16:creationId xmlns:a16="http://schemas.microsoft.com/office/drawing/2014/main" id="{50569F85-9ED1-4663-A8B4-CB10E649F5CA}"/>
                </a:ext>
              </a:extLst>
            </p:cNvPr>
            <p:cNvSpPr/>
            <p:nvPr/>
          </p:nvSpPr>
          <p:spPr>
            <a:xfrm>
              <a:off x="485911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3" name="Freeform: Shape 912">
              <a:extLst>
                <a:ext uri="{FF2B5EF4-FFF2-40B4-BE49-F238E27FC236}">
                  <a16:creationId xmlns:a16="http://schemas.microsoft.com/office/drawing/2014/main" id="{EEB3632A-8A46-4197-843E-85495BB838E8}"/>
                </a:ext>
              </a:extLst>
            </p:cNvPr>
            <p:cNvSpPr/>
            <p:nvPr/>
          </p:nvSpPr>
          <p:spPr>
            <a:xfrm>
              <a:off x="485911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4" name="Freeform: Shape 913">
              <a:extLst>
                <a:ext uri="{FF2B5EF4-FFF2-40B4-BE49-F238E27FC236}">
                  <a16:creationId xmlns:a16="http://schemas.microsoft.com/office/drawing/2014/main" id="{1D1FCCE9-9666-4814-B17F-96392D98AAA0}"/>
                </a:ext>
              </a:extLst>
            </p:cNvPr>
            <p:cNvSpPr/>
            <p:nvPr/>
          </p:nvSpPr>
          <p:spPr>
            <a:xfrm>
              <a:off x="485911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5" name="Freeform: Shape 914">
              <a:extLst>
                <a:ext uri="{FF2B5EF4-FFF2-40B4-BE49-F238E27FC236}">
                  <a16:creationId xmlns:a16="http://schemas.microsoft.com/office/drawing/2014/main" id="{7F5443F5-17E5-403C-96DB-4C85E4F08444}"/>
                </a:ext>
              </a:extLst>
            </p:cNvPr>
            <p:cNvSpPr/>
            <p:nvPr/>
          </p:nvSpPr>
          <p:spPr>
            <a:xfrm>
              <a:off x="485911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0 w 71300"/>
                <a:gd name="connsiteY1" fmla="*/ 0 h 71300"/>
                <a:gd name="connsiteX2" fmla="*/ 71300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0" y="0"/>
                  </a:lnTo>
                  <a:lnTo>
                    <a:pt x="71300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6" name="Freeform: Shape 915">
              <a:extLst>
                <a:ext uri="{FF2B5EF4-FFF2-40B4-BE49-F238E27FC236}">
                  <a16:creationId xmlns:a16="http://schemas.microsoft.com/office/drawing/2014/main" id="{C7B243CB-71BD-4465-8BD7-D915993F661D}"/>
                </a:ext>
              </a:extLst>
            </p:cNvPr>
            <p:cNvSpPr/>
            <p:nvPr/>
          </p:nvSpPr>
          <p:spPr>
            <a:xfrm>
              <a:off x="628583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7" name="Freeform: Shape 916">
              <a:extLst>
                <a:ext uri="{FF2B5EF4-FFF2-40B4-BE49-F238E27FC236}">
                  <a16:creationId xmlns:a16="http://schemas.microsoft.com/office/drawing/2014/main" id="{86D8B143-01B8-492D-9B8D-821DF707335C}"/>
                </a:ext>
              </a:extLst>
            </p:cNvPr>
            <p:cNvSpPr/>
            <p:nvPr/>
          </p:nvSpPr>
          <p:spPr>
            <a:xfrm>
              <a:off x="628583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8" name="Freeform: Shape 917">
              <a:extLst>
                <a:ext uri="{FF2B5EF4-FFF2-40B4-BE49-F238E27FC236}">
                  <a16:creationId xmlns:a16="http://schemas.microsoft.com/office/drawing/2014/main" id="{F2D9D993-F9EE-4AA3-ACC8-16067E88E17E}"/>
                </a:ext>
              </a:extLst>
            </p:cNvPr>
            <p:cNvSpPr/>
            <p:nvPr/>
          </p:nvSpPr>
          <p:spPr>
            <a:xfrm>
              <a:off x="628583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9" name="Freeform: Shape 918">
              <a:extLst>
                <a:ext uri="{FF2B5EF4-FFF2-40B4-BE49-F238E27FC236}">
                  <a16:creationId xmlns:a16="http://schemas.microsoft.com/office/drawing/2014/main" id="{832F6A35-320D-4BB2-9850-E9A1D7A075D5}"/>
                </a:ext>
              </a:extLst>
            </p:cNvPr>
            <p:cNvSpPr/>
            <p:nvPr/>
          </p:nvSpPr>
          <p:spPr>
            <a:xfrm>
              <a:off x="628583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20" name="Freeform: Shape 919">
              <a:extLst>
                <a:ext uri="{FF2B5EF4-FFF2-40B4-BE49-F238E27FC236}">
                  <a16:creationId xmlns:a16="http://schemas.microsoft.com/office/drawing/2014/main" id="{9AC30445-FD61-47A0-A5B1-A730C1CB5FE8}"/>
                </a:ext>
              </a:extLst>
            </p:cNvPr>
            <p:cNvSpPr/>
            <p:nvPr/>
          </p:nvSpPr>
          <p:spPr>
            <a:xfrm>
              <a:off x="771185" y="6040468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21" name="Freeform: Shape 920">
              <a:extLst>
                <a:ext uri="{FF2B5EF4-FFF2-40B4-BE49-F238E27FC236}">
                  <a16:creationId xmlns:a16="http://schemas.microsoft.com/office/drawing/2014/main" id="{333ACE67-8B9B-415E-9FDF-E8108ABCA446}"/>
                </a:ext>
              </a:extLst>
            </p:cNvPr>
            <p:cNvSpPr/>
            <p:nvPr/>
          </p:nvSpPr>
          <p:spPr>
            <a:xfrm>
              <a:off x="771185" y="618314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22" name="Freeform: Shape 921">
              <a:extLst>
                <a:ext uri="{FF2B5EF4-FFF2-40B4-BE49-F238E27FC236}">
                  <a16:creationId xmlns:a16="http://schemas.microsoft.com/office/drawing/2014/main" id="{5A8E9127-E04C-46FB-A9FD-36CD4F6AA842}"/>
                </a:ext>
              </a:extLst>
            </p:cNvPr>
            <p:cNvSpPr/>
            <p:nvPr/>
          </p:nvSpPr>
          <p:spPr>
            <a:xfrm>
              <a:off x="771185" y="6325742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23" name="Freeform: Shape 922">
              <a:extLst>
                <a:ext uri="{FF2B5EF4-FFF2-40B4-BE49-F238E27FC236}">
                  <a16:creationId xmlns:a16="http://schemas.microsoft.com/office/drawing/2014/main" id="{3A62D3EE-B041-46AC-91E5-B0ECEE0FC2D8}"/>
                </a:ext>
              </a:extLst>
            </p:cNvPr>
            <p:cNvSpPr/>
            <p:nvPr/>
          </p:nvSpPr>
          <p:spPr>
            <a:xfrm>
              <a:off x="771185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24" name="Freeform: Shape 923">
              <a:extLst>
                <a:ext uri="{FF2B5EF4-FFF2-40B4-BE49-F238E27FC236}">
                  <a16:creationId xmlns:a16="http://schemas.microsoft.com/office/drawing/2014/main" id="{1B46FE9D-B8D4-4D8E-8E59-74A1A2BC546B}"/>
                </a:ext>
              </a:extLst>
            </p:cNvPr>
            <p:cNvSpPr/>
            <p:nvPr/>
          </p:nvSpPr>
          <p:spPr>
            <a:xfrm>
              <a:off x="200637" y="6474380"/>
              <a:ext cx="71300" cy="71300"/>
            </a:xfrm>
            <a:custGeom>
              <a:avLst/>
              <a:gdLst>
                <a:gd name="connsiteX0" fmla="*/ 0 w 71300"/>
                <a:gd name="connsiteY0" fmla="*/ 0 h 71300"/>
                <a:gd name="connsiteX1" fmla="*/ 71301 w 71300"/>
                <a:gd name="connsiteY1" fmla="*/ 0 h 71300"/>
                <a:gd name="connsiteX2" fmla="*/ 71301 w 71300"/>
                <a:gd name="connsiteY2" fmla="*/ 71301 h 71300"/>
                <a:gd name="connsiteX3" fmla="*/ 0 w 71300"/>
                <a:gd name="connsiteY3" fmla="*/ 71301 h 71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300" h="71300">
                  <a:moveTo>
                    <a:pt x="0" y="0"/>
                  </a:moveTo>
                  <a:lnTo>
                    <a:pt x="71301" y="0"/>
                  </a:lnTo>
                  <a:lnTo>
                    <a:pt x="71301" y="71301"/>
                  </a:lnTo>
                  <a:lnTo>
                    <a:pt x="0" y="71301"/>
                  </a:lnTo>
                  <a:close/>
                </a:path>
              </a:pathLst>
            </a:custGeom>
            <a:grpFill/>
            <a:ln w="7094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</p:grpSp>
      <p:sp>
        <p:nvSpPr>
          <p:cNvPr id="294" name="Ondertitel 2">
            <a:extLst>
              <a:ext uri="{FF2B5EF4-FFF2-40B4-BE49-F238E27FC236}">
                <a16:creationId xmlns:a16="http://schemas.microsoft.com/office/drawing/2014/main" id="{52C2D506-C20C-4144-970E-1F30626721A2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513358" y="2758136"/>
            <a:ext cx="6022176" cy="1207146"/>
          </a:xfrm>
        </p:spPr>
        <p:txBody>
          <a:bodyPr anchor="b"/>
          <a:lstStyle>
            <a:lvl1pPr marL="0" indent="0" algn="l">
              <a:buNone/>
              <a:defRPr sz="1950" b="1" i="0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75" indent="0" algn="ctr">
              <a:buNone/>
              <a:defRPr sz="1625"/>
            </a:lvl2pPr>
            <a:lvl3pPr marL="742950" indent="0" algn="ctr">
              <a:buNone/>
              <a:defRPr sz="1463"/>
            </a:lvl3pPr>
            <a:lvl4pPr marL="1114425" indent="0" algn="ctr">
              <a:buNone/>
              <a:defRPr sz="1300"/>
            </a:lvl4pPr>
            <a:lvl5pPr marL="1485900" indent="0" algn="ctr">
              <a:buNone/>
              <a:defRPr sz="1300"/>
            </a:lvl5pPr>
            <a:lvl6pPr marL="1857375" indent="0" algn="ctr">
              <a:buNone/>
              <a:defRPr sz="1300"/>
            </a:lvl6pPr>
            <a:lvl7pPr marL="2228850" indent="0" algn="ctr">
              <a:buNone/>
              <a:defRPr sz="1300"/>
            </a:lvl7pPr>
            <a:lvl8pPr marL="2600325" indent="0" algn="ctr">
              <a:buNone/>
              <a:defRPr sz="1300"/>
            </a:lvl8pPr>
            <a:lvl9pPr marL="2971800" indent="0" algn="ctr">
              <a:buNone/>
              <a:defRPr sz="1300"/>
            </a:lvl9pPr>
          </a:lstStyle>
          <a:p>
            <a:r>
              <a:rPr lang="nl-NL"/>
              <a:t>Subtitel (optioneel)</a:t>
            </a:r>
          </a:p>
        </p:txBody>
      </p:sp>
      <p:sp>
        <p:nvSpPr>
          <p:cNvPr id="7" name="Tijdelijke aanduiding voor tekst 6">
            <a:extLst>
              <a:ext uri="{FF2B5EF4-FFF2-40B4-BE49-F238E27FC236}">
                <a16:creationId xmlns:a16="http://schemas.microsoft.com/office/drawing/2014/main" id="{0436758D-A761-416C-BE19-E67431685E52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514800" y="4024800"/>
            <a:ext cx="3504150" cy="460800"/>
          </a:xfrm>
        </p:spPr>
        <p:txBody>
          <a:bodyPr/>
          <a:lstStyle>
            <a:lvl1pPr marL="0" indent="0">
              <a:buNone/>
              <a:defRPr sz="1950" b="1">
                <a:solidFill>
                  <a:schemeClr val="accent4"/>
                </a:solidFill>
              </a:defRPr>
            </a:lvl1pPr>
            <a:lvl2pPr marL="371475" indent="0">
              <a:buNone/>
              <a:defRPr/>
            </a:lvl2pPr>
            <a:lvl3pPr marL="742950" indent="0">
              <a:buNone/>
              <a:defRPr/>
            </a:lvl3pPr>
            <a:lvl4pPr marL="1114425" indent="0">
              <a:buNone/>
              <a:defRPr/>
            </a:lvl4pPr>
            <a:lvl5pPr marL="1485900" indent="0">
              <a:buNone/>
              <a:defRPr/>
            </a:lvl5pPr>
          </a:lstStyle>
          <a:p>
            <a:pPr lvl="0"/>
            <a:r>
              <a:rPr lang="nl-NL" err="1"/>
              <a:t>Subregel</a:t>
            </a:r>
            <a:r>
              <a:rPr lang="nl-NL"/>
              <a:t> (optioneel)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7029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C1A2CBD-7AFA-5E47-9EDF-AA246AB44DF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13358" y="1709739"/>
            <a:ext cx="8294984" cy="2852737"/>
          </a:xfrm>
        </p:spPr>
        <p:txBody>
          <a:bodyPr anchor="b"/>
          <a:lstStyle>
            <a:lvl1pPr>
              <a:defRPr sz="4875"/>
            </a:lvl1pPr>
          </a:lstStyle>
          <a:p>
            <a:r>
              <a:rPr lang="nl-NL"/>
              <a:t>Voeg titel toe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834C0A41-57D5-6940-8FC6-D43359DFEC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13358" y="4589464"/>
            <a:ext cx="8294984" cy="1500187"/>
          </a:xfrm>
        </p:spPr>
        <p:txBody>
          <a:bodyPr/>
          <a:lstStyle>
            <a:lvl1pPr marL="0" indent="0">
              <a:buNone/>
              <a:defRPr sz="1950">
                <a:solidFill>
                  <a:schemeClr val="accent2"/>
                </a:solidFill>
              </a:defRPr>
            </a:lvl1pPr>
            <a:lvl2pPr marL="371475" indent="0">
              <a:buNone/>
              <a:defRPr sz="1625">
                <a:solidFill>
                  <a:schemeClr val="tx1">
                    <a:tint val="75000"/>
                  </a:schemeClr>
                </a:solidFill>
              </a:defRPr>
            </a:lvl2pPr>
            <a:lvl3pPr marL="742950" indent="0">
              <a:buNone/>
              <a:defRPr sz="1463">
                <a:solidFill>
                  <a:schemeClr val="tx1">
                    <a:tint val="75000"/>
                  </a:schemeClr>
                </a:solidFill>
              </a:defRPr>
            </a:lvl3pPr>
            <a:lvl4pPr marL="111442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48590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185737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22885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60032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297180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566AAF-D3EE-4FC4-8219-B967A1F3D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DDF44A-BF68-4CCF-A6CF-AFCBEE804673}" type="datetime1">
              <a:rPr lang="en-GB" smtClean="0"/>
              <a:t>26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626742-66D7-4243-B025-81683DB45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6F83D2-7DE5-4FBD-AACE-9622CBC3E6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7694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Ondertitel 2">
            <a:extLst>
              <a:ext uri="{FF2B5EF4-FFF2-40B4-BE49-F238E27FC236}">
                <a16:creationId xmlns:a16="http://schemas.microsoft.com/office/drawing/2014/main" id="{B8455A8C-1151-45FD-BC04-D6EFE9E66F6A}"/>
              </a:ext>
            </a:extLst>
          </p:cNvPr>
          <p:cNvSpPr>
            <a:spLocks noGrp="1"/>
          </p:cNvSpPr>
          <p:nvPr>
            <p:ph type="subTitle" idx="13" hasCustomPrompt="1"/>
          </p:nvPr>
        </p:nvSpPr>
        <p:spPr>
          <a:xfrm>
            <a:off x="513359" y="926508"/>
            <a:ext cx="8294985" cy="571042"/>
          </a:xfrm>
        </p:spPr>
        <p:txBody>
          <a:bodyPr/>
          <a:lstStyle>
            <a:lvl1pPr marL="0" indent="0" algn="l">
              <a:buNone/>
              <a:defRPr sz="195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75" indent="0" algn="ctr">
              <a:buNone/>
              <a:defRPr sz="1625"/>
            </a:lvl2pPr>
            <a:lvl3pPr marL="742950" indent="0" algn="ctr">
              <a:buNone/>
              <a:defRPr sz="1463"/>
            </a:lvl3pPr>
            <a:lvl4pPr marL="1114425" indent="0" algn="ctr">
              <a:buNone/>
              <a:defRPr sz="1300"/>
            </a:lvl4pPr>
            <a:lvl5pPr marL="1485900" indent="0" algn="ctr">
              <a:buNone/>
              <a:defRPr sz="1300"/>
            </a:lvl5pPr>
            <a:lvl6pPr marL="1857375" indent="0" algn="ctr">
              <a:buNone/>
              <a:defRPr sz="1300"/>
            </a:lvl6pPr>
            <a:lvl7pPr marL="2228850" indent="0" algn="ctr">
              <a:buNone/>
              <a:defRPr sz="1300"/>
            </a:lvl7pPr>
            <a:lvl8pPr marL="2600325" indent="0" algn="ctr">
              <a:buNone/>
              <a:defRPr sz="1300"/>
            </a:lvl8pPr>
            <a:lvl9pPr marL="2971800" indent="0" algn="ctr">
              <a:buNone/>
              <a:defRPr sz="1300"/>
            </a:lvl9pPr>
          </a:lstStyle>
          <a:p>
            <a:r>
              <a:rPr lang="nl-NL"/>
              <a:t>Voeg ondertitel toe</a:t>
            </a:r>
          </a:p>
        </p:txBody>
      </p:sp>
      <p:sp>
        <p:nvSpPr>
          <p:cNvPr id="22" name="Tijdelijke aanduiding voor inhoud 2">
            <a:extLst>
              <a:ext uri="{FF2B5EF4-FFF2-40B4-BE49-F238E27FC236}">
                <a16:creationId xmlns:a16="http://schemas.microsoft.com/office/drawing/2014/main" id="{8B00E604-4B97-4510-A3F5-5F4967D4D2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3358" y="1825626"/>
            <a:ext cx="8294985" cy="4032250"/>
          </a:xfrm>
        </p:spPr>
        <p:txBody>
          <a:bodyPr/>
          <a:lstStyle>
            <a:lvl1pPr>
              <a:defRPr sz="1138"/>
            </a:lvl1pPr>
          </a:lstStyle>
          <a:p>
            <a:pPr lvl="0"/>
            <a:endParaRPr lang="nl-NL"/>
          </a:p>
        </p:txBody>
      </p:sp>
      <p:sp>
        <p:nvSpPr>
          <p:cNvPr id="23" name="Title 22">
            <a:extLst>
              <a:ext uri="{FF2B5EF4-FFF2-40B4-BE49-F238E27FC236}">
                <a16:creationId xmlns:a16="http://schemas.microsoft.com/office/drawing/2014/main" id="{680762F9-45DE-418E-9F0E-4E555F12BFE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err="1"/>
              <a:t>Voeg</a:t>
            </a:r>
            <a:r>
              <a:rPr lang="en-US"/>
              <a:t> title toe</a:t>
            </a:r>
          </a:p>
        </p:txBody>
      </p:sp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F9CAEF-4AC1-482E-A28C-4BD4EF23823E}"/>
              </a:ext>
            </a:extLst>
          </p:cNvPr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fld id="{E02C8C58-7455-42B9-A9FD-EE48EC293C11}" type="datetime1">
              <a:rPr lang="en-GB" smtClean="0"/>
              <a:t>26/0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93A717A-0D90-431C-BCD3-A6ECA053C009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2E7448-FA38-460E-A530-78699A84B1D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699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C9813C8-B51D-6841-B87E-E5EC608D49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513358" y="1825626"/>
            <a:ext cx="4085608" cy="4032249"/>
          </a:xfrm>
        </p:spPr>
        <p:txBody>
          <a:bodyPr/>
          <a:lstStyle>
            <a:lvl1pPr>
              <a:defRPr sz="1138"/>
            </a:lvl1pPr>
          </a:lstStyle>
          <a:p>
            <a:pPr lvl="0"/>
            <a:endParaRPr lang="nl-NL"/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94CED3C7-DD9C-C945-8B8C-FF0FF66059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2734" y="1825626"/>
            <a:ext cx="4085608" cy="4032249"/>
          </a:xfrm>
        </p:spPr>
        <p:txBody>
          <a:bodyPr/>
          <a:lstStyle>
            <a:lvl1pPr>
              <a:defRPr sz="1138"/>
            </a:lvl1pPr>
          </a:lstStyle>
          <a:p>
            <a:pPr lvl="0"/>
            <a:endParaRPr lang="nl-NL"/>
          </a:p>
        </p:txBody>
      </p:sp>
      <p:sp>
        <p:nvSpPr>
          <p:cNvPr id="17" name="Ondertitel 2">
            <a:extLst>
              <a:ext uri="{FF2B5EF4-FFF2-40B4-BE49-F238E27FC236}">
                <a16:creationId xmlns:a16="http://schemas.microsoft.com/office/drawing/2014/main" id="{71108092-E756-4BC4-9CC5-DA455C29F3D8}"/>
              </a:ext>
            </a:extLst>
          </p:cNvPr>
          <p:cNvSpPr>
            <a:spLocks noGrp="1"/>
          </p:cNvSpPr>
          <p:nvPr>
            <p:ph type="subTitle" idx="13" hasCustomPrompt="1"/>
          </p:nvPr>
        </p:nvSpPr>
        <p:spPr>
          <a:xfrm>
            <a:off x="513359" y="926508"/>
            <a:ext cx="8294985" cy="571042"/>
          </a:xfrm>
        </p:spPr>
        <p:txBody>
          <a:bodyPr/>
          <a:lstStyle>
            <a:lvl1pPr marL="0" indent="0" algn="l">
              <a:buNone/>
              <a:defRPr sz="195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71475" indent="0" algn="ctr">
              <a:buNone/>
              <a:defRPr sz="1625"/>
            </a:lvl2pPr>
            <a:lvl3pPr marL="742950" indent="0" algn="ctr">
              <a:buNone/>
              <a:defRPr sz="1463"/>
            </a:lvl3pPr>
            <a:lvl4pPr marL="1114425" indent="0" algn="ctr">
              <a:buNone/>
              <a:defRPr sz="1300"/>
            </a:lvl4pPr>
            <a:lvl5pPr marL="1485900" indent="0" algn="ctr">
              <a:buNone/>
              <a:defRPr sz="1300"/>
            </a:lvl5pPr>
            <a:lvl6pPr marL="1857375" indent="0" algn="ctr">
              <a:buNone/>
              <a:defRPr sz="1300"/>
            </a:lvl6pPr>
            <a:lvl7pPr marL="2228850" indent="0" algn="ctr">
              <a:buNone/>
              <a:defRPr sz="1300"/>
            </a:lvl7pPr>
            <a:lvl8pPr marL="2600325" indent="0" algn="ctr">
              <a:buNone/>
              <a:defRPr sz="1300"/>
            </a:lvl8pPr>
            <a:lvl9pPr marL="2971800" indent="0" algn="ctr">
              <a:buNone/>
              <a:defRPr sz="1300"/>
            </a:lvl9pPr>
          </a:lstStyle>
          <a:p>
            <a:r>
              <a:rPr lang="nl-NL"/>
              <a:t>Voeg ondertitel toe</a:t>
            </a:r>
          </a:p>
        </p:txBody>
      </p:sp>
      <p:sp>
        <p:nvSpPr>
          <p:cNvPr id="21" name="Title 20">
            <a:extLst>
              <a:ext uri="{FF2B5EF4-FFF2-40B4-BE49-F238E27FC236}">
                <a16:creationId xmlns:a16="http://schemas.microsoft.com/office/drawing/2014/main" id="{B3D560FF-5751-4CD7-9FBE-4F699E3F600A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err="1"/>
              <a:t>Voeg</a:t>
            </a:r>
            <a:r>
              <a:rPr lang="en-US"/>
              <a:t> title toe</a:t>
            </a:r>
          </a:p>
        </p:txBody>
      </p:sp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0909B7A-1D5F-494A-9AF4-DA96E477342A}"/>
              </a:ext>
            </a:extLst>
          </p:cNvPr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fld id="{419E983A-F637-4B28-93FD-EAEA0BE524AF}" type="datetime1">
              <a:rPr lang="en-GB" smtClean="0"/>
              <a:t>26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8B29D4-7C46-4976-BE03-791E20F96459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14B727-1874-4DDC-BEDE-7D2DFAF07B9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6688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DA1C1E5-AE8F-DC45-9C52-75D68F11C68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13358" y="457200"/>
            <a:ext cx="3363913" cy="1600200"/>
          </a:xfrm>
        </p:spPr>
        <p:txBody>
          <a:bodyPr anchor="b">
            <a:normAutofit/>
          </a:bodyPr>
          <a:lstStyle>
            <a:lvl1pPr>
              <a:defRPr sz="3250"/>
            </a:lvl1pPr>
          </a:lstStyle>
          <a:p>
            <a:r>
              <a:rPr lang="nl-NL"/>
              <a:t>Voeg titel toe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6734FE2C-A4A1-E141-9EF8-52CAE1D6E8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11340" y="457201"/>
            <a:ext cx="4597002" cy="5403850"/>
          </a:xfrm>
        </p:spPr>
        <p:txBody>
          <a:bodyPr/>
          <a:lstStyle>
            <a:lvl1pPr>
              <a:defRPr sz="1950"/>
            </a:lvl1pPr>
            <a:lvl2pPr>
              <a:defRPr sz="2275"/>
            </a:lvl2pPr>
            <a:lvl3pPr>
              <a:defRPr sz="1950"/>
            </a:lvl3pPr>
            <a:lvl4pPr>
              <a:defRPr sz="1625"/>
            </a:lvl4pPr>
            <a:lvl5pPr>
              <a:defRPr sz="1625"/>
            </a:lvl5pPr>
            <a:lvl6pPr>
              <a:defRPr sz="1625"/>
            </a:lvl6pPr>
            <a:lvl7pPr>
              <a:defRPr sz="1625"/>
            </a:lvl7pPr>
            <a:lvl8pPr>
              <a:defRPr sz="1625"/>
            </a:lvl8pPr>
            <a:lvl9pPr>
              <a:defRPr sz="1625"/>
            </a:lvl9pPr>
          </a:lstStyle>
          <a:p>
            <a:pPr lvl="0"/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0B76EFB3-341C-CF4E-B80E-C7D1899988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13359" y="2057400"/>
            <a:ext cx="3363912" cy="3811588"/>
          </a:xfrm>
        </p:spPr>
        <p:txBody>
          <a:bodyPr/>
          <a:lstStyle>
            <a:lvl1pPr marL="0" indent="0">
              <a:buNone/>
              <a:defRPr sz="1138"/>
            </a:lvl1pPr>
            <a:lvl2pPr marL="371475" indent="0">
              <a:buNone/>
              <a:defRPr sz="1138"/>
            </a:lvl2pPr>
            <a:lvl3pPr marL="742950" indent="0">
              <a:buNone/>
              <a:defRPr sz="975"/>
            </a:lvl3pPr>
            <a:lvl4pPr marL="1114425" indent="0">
              <a:buNone/>
              <a:defRPr sz="813"/>
            </a:lvl4pPr>
            <a:lvl5pPr marL="1485900" indent="0">
              <a:buNone/>
              <a:defRPr sz="813"/>
            </a:lvl5pPr>
            <a:lvl6pPr marL="1857375" indent="0">
              <a:buNone/>
              <a:defRPr sz="813"/>
            </a:lvl6pPr>
            <a:lvl7pPr marL="2228850" indent="0">
              <a:buNone/>
              <a:defRPr sz="813"/>
            </a:lvl7pPr>
            <a:lvl8pPr marL="2600325" indent="0">
              <a:buNone/>
              <a:defRPr sz="813"/>
            </a:lvl8pPr>
            <a:lvl9pPr marL="2971800" indent="0">
              <a:buNone/>
              <a:defRPr sz="813"/>
            </a:lvl9pPr>
          </a:lstStyle>
          <a:p>
            <a:pPr lvl="0"/>
            <a:endParaRPr lang="nl-N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C65F25-4CB7-4E4B-A45E-8A3D75577F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F8827-6856-4A09-A018-24359788D71A}" type="datetime1">
              <a:rPr lang="en-GB" smtClean="0"/>
              <a:t>26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9A3D27-F97D-4584-A9E9-50DBA9BB9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8E0355-D002-4FB1-8315-EB2FFE036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928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D6022EB0-2AEA-8742-BA74-F7C05DA91A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211340" y="457201"/>
            <a:ext cx="4597002" cy="5403850"/>
          </a:xfrm>
        </p:spPr>
        <p:txBody>
          <a:bodyPr rtlCol="0">
            <a:normAutofit/>
          </a:bodyPr>
          <a:lstStyle>
            <a:lvl1pPr marL="0" indent="0">
              <a:buNone/>
              <a:defRPr sz="1950"/>
            </a:lvl1pPr>
            <a:lvl2pPr marL="371475" indent="0">
              <a:buNone/>
              <a:defRPr sz="2275"/>
            </a:lvl2pPr>
            <a:lvl3pPr marL="742950" indent="0">
              <a:buNone/>
              <a:defRPr sz="1950"/>
            </a:lvl3pPr>
            <a:lvl4pPr marL="1114425" indent="0">
              <a:buNone/>
              <a:defRPr sz="1625"/>
            </a:lvl4pPr>
            <a:lvl5pPr marL="1485900" indent="0">
              <a:buNone/>
              <a:defRPr sz="1625"/>
            </a:lvl5pPr>
            <a:lvl6pPr marL="1857375" indent="0">
              <a:buNone/>
              <a:defRPr sz="1625"/>
            </a:lvl6pPr>
            <a:lvl7pPr marL="2228850" indent="0">
              <a:buNone/>
              <a:defRPr sz="1625"/>
            </a:lvl7pPr>
            <a:lvl8pPr marL="2600325" indent="0">
              <a:buNone/>
              <a:defRPr sz="1625"/>
            </a:lvl8pPr>
            <a:lvl9pPr marL="2971800" indent="0">
              <a:buNone/>
              <a:defRPr sz="1625"/>
            </a:lvl9pPr>
          </a:lstStyle>
          <a:p>
            <a:pPr lvl="0"/>
            <a:endParaRPr lang="nl-NL" noProof="0"/>
          </a:p>
        </p:txBody>
      </p:sp>
      <p:sp>
        <p:nvSpPr>
          <p:cNvPr id="13" name="Titel 1">
            <a:extLst>
              <a:ext uri="{FF2B5EF4-FFF2-40B4-BE49-F238E27FC236}">
                <a16:creationId xmlns:a16="http://schemas.microsoft.com/office/drawing/2014/main" id="{DE2EBB02-DACF-47B5-8F5E-12EDE3F830F8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13358" y="457200"/>
            <a:ext cx="3363913" cy="1600200"/>
          </a:xfrm>
        </p:spPr>
        <p:txBody>
          <a:bodyPr anchor="b">
            <a:normAutofit/>
          </a:bodyPr>
          <a:lstStyle>
            <a:lvl1pPr>
              <a:defRPr sz="3250"/>
            </a:lvl1pPr>
          </a:lstStyle>
          <a:p>
            <a:r>
              <a:rPr lang="nl-NL"/>
              <a:t>Voeg titel toe</a:t>
            </a:r>
          </a:p>
        </p:txBody>
      </p:sp>
      <p:sp>
        <p:nvSpPr>
          <p:cNvPr id="14" name="Tijdelijke aanduiding voor tekst 3">
            <a:extLst>
              <a:ext uri="{FF2B5EF4-FFF2-40B4-BE49-F238E27FC236}">
                <a16:creationId xmlns:a16="http://schemas.microsoft.com/office/drawing/2014/main" id="{1440C125-C510-4962-806C-38C93CA438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13359" y="2057400"/>
            <a:ext cx="3363912" cy="3811588"/>
          </a:xfrm>
        </p:spPr>
        <p:txBody>
          <a:bodyPr/>
          <a:lstStyle>
            <a:lvl1pPr marL="232172" indent="-232172">
              <a:buFont typeface="Arial" panose="020B0604020202020204" pitchFamily="34" charset="0"/>
              <a:buChar char="•"/>
              <a:defRPr sz="1138"/>
            </a:lvl1pPr>
            <a:lvl2pPr marL="603647" indent="-232172">
              <a:buFont typeface="Arial" panose="020B0604020202020204" pitchFamily="34" charset="0"/>
              <a:buChar char="•"/>
              <a:defRPr sz="1138"/>
            </a:lvl2pPr>
            <a:lvl3pPr marL="882253" indent="-139303">
              <a:buFont typeface="Arial" panose="020B0604020202020204" pitchFamily="34" charset="0"/>
              <a:buChar char="•"/>
              <a:defRPr sz="975"/>
            </a:lvl3pPr>
            <a:lvl4pPr marL="1253728" indent="-139303">
              <a:buFont typeface="Arial" panose="020B0604020202020204" pitchFamily="34" charset="0"/>
              <a:buChar char="•"/>
              <a:defRPr sz="813"/>
            </a:lvl4pPr>
            <a:lvl5pPr marL="1625203" indent="-139303">
              <a:buFont typeface="Arial" panose="020B0604020202020204" pitchFamily="34" charset="0"/>
              <a:buChar char="•"/>
              <a:defRPr sz="813"/>
            </a:lvl5pPr>
            <a:lvl6pPr marL="1857375" indent="0">
              <a:buNone/>
              <a:defRPr sz="813"/>
            </a:lvl6pPr>
            <a:lvl7pPr marL="2228850" indent="0">
              <a:buNone/>
              <a:defRPr sz="813"/>
            </a:lvl7pPr>
            <a:lvl8pPr marL="2600325" indent="0">
              <a:buNone/>
              <a:defRPr sz="813"/>
            </a:lvl8pPr>
            <a:lvl9pPr marL="2971800" indent="0">
              <a:buNone/>
              <a:defRPr sz="813"/>
            </a:lvl9pPr>
          </a:lstStyle>
          <a:p>
            <a:pPr lvl="0"/>
            <a:endParaRPr lang="nl-NL"/>
          </a:p>
        </p:txBody>
      </p:sp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788018A-7690-4347-A6B0-BE896BA4F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B81A2-5B81-4A11-B009-4CA1936816F2}" type="datetime1">
              <a:rPr lang="en-GB" smtClean="0"/>
              <a:t>26/0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DFFF564-B1E9-4D03-93E7-8C506DB60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E40684-790F-46B4-BC70-725A912348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3203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1.pn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hthoekige driehoek 5">
            <a:extLst>
              <a:ext uri="{FF2B5EF4-FFF2-40B4-BE49-F238E27FC236}">
                <a16:creationId xmlns:a16="http://schemas.microsoft.com/office/drawing/2014/main" id="{83C50CDB-643D-41D1-A546-6004593C90CC}"/>
              </a:ext>
            </a:extLst>
          </p:cNvPr>
          <p:cNvSpPr/>
          <p:nvPr userDrawn="1"/>
        </p:nvSpPr>
        <p:spPr>
          <a:xfrm rot="5400000">
            <a:off x="-163513" y="146050"/>
            <a:ext cx="1565276" cy="1238250"/>
          </a:xfrm>
          <a:prstGeom prst="rtTriangle">
            <a:avLst/>
          </a:prstGeom>
          <a:solidFill>
            <a:srgbClr val="86D2ED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nl-NL"/>
          </a:p>
        </p:txBody>
      </p:sp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EE718F30-BFE0-0049-A724-06A1A3A580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13358" y="365126"/>
            <a:ext cx="8294984" cy="648000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nl-NL"/>
              <a:t>Voeg Titel toe</a:t>
            </a:r>
          </a:p>
        </p:txBody>
      </p:sp>
      <p:sp>
        <p:nvSpPr>
          <p:cNvPr id="1027" name="Tijdelijke aanduiding voor tekst 2">
            <a:extLst>
              <a:ext uri="{FF2B5EF4-FFF2-40B4-BE49-F238E27FC236}">
                <a16:creationId xmlns:a16="http://schemas.microsoft.com/office/drawing/2014/main" id="{49A86127-AF9F-2C41-9CC5-60997F3C5702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513358" y="1825625"/>
            <a:ext cx="8294984" cy="403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endParaRPr lang="nl-NL" altLang="nl-NL"/>
          </a:p>
          <a:p>
            <a:pPr lvl="1"/>
            <a:endParaRPr lang="nl-NL" altLang="nl-NL"/>
          </a:p>
          <a:p>
            <a:pPr lvl="2"/>
            <a:endParaRPr lang="nl-NL" altLang="nl-NL"/>
          </a:p>
          <a:p>
            <a:pPr lvl="3"/>
            <a:endParaRPr lang="nl-NL" altLang="nl-NL"/>
          </a:p>
          <a:p>
            <a:pPr lvl="4"/>
            <a:endParaRPr lang="nl-NL" altLang="nl-NL"/>
          </a:p>
          <a:p>
            <a:pPr lvl="4"/>
            <a:endParaRPr lang="nl-NL" altLang="nl-NL"/>
          </a:p>
        </p:txBody>
      </p:sp>
      <p:pic>
        <p:nvPicPr>
          <p:cNvPr id="4" name="Picture 9">
            <a:extLst>
              <a:ext uri="{FF2B5EF4-FFF2-40B4-BE49-F238E27FC236}">
                <a16:creationId xmlns:a16="http://schemas.microsoft.com/office/drawing/2014/main" id="{A2A64451-1F2C-476E-937F-8E907E5AE306}"/>
              </a:ext>
            </a:extLst>
          </p:cNvPr>
          <p:cNvPicPr>
            <a:picLocks noChangeAspect="1"/>
          </p:cNvPicPr>
          <p:nvPr userDrawn="1"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88314" y="6199189"/>
            <a:ext cx="937716" cy="598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ijdelijke aanduiding voor datum 3">
            <a:extLst>
              <a:ext uri="{FF2B5EF4-FFF2-40B4-BE49-F238E27FC236}">
                <a16:creationId xmlns:a16="http://schemas.microsoft.com/office/drawing/2014/main" id="{7AF74F37-9555-4F71-8CD7-EE564557B5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513358" y="6483047"/>
            <a:ext cx="676085" cy="1799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lang="nl-NL" sz="569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7678AA31-385E-486D-A654-59401A2A3B5E}" type="datetime1">
              <a:rPr lang="en-GB" smtClean="0"/>
              <a:pPr/>
              <a:t>26/01/2023</a:t>
            </a:fld>
            <a:endParaRPr lang="en-GB"/>
          </a:p>
        </p:txBody>
      </p:sp>
      <p:sp>
        <p:nvSpPr>
          <p:cNvPr id="6" name="Tijdelijke aanduiding voor voettekst 4">
            <a:extLst>
              <a:ext uri="{FF2B5EF4-FFF2-40B4-BE49-F238E27FC236}">
                <a16:creationId xmlns:a16="http://schemas.microsoft.com/office/drawing/2014/main" id="{E3A98EC9-551D-456A-AEEF-AFA8AEBD64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1269414" y="6483046"/>
            <a:ext cx="7064081" cy="1799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lang="nl-NL" sz="569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GB"/>
          </a:p>
        </p:txBody>
      </p:sp>
      <p:sp>
        <p:nvSpPr>
          <p:cNvPr id="7" name="Tijdelijke aanduiding voor dianummer 5">
            <a:extLst>
              <a:ext uri="{FF2B5EF4-FFF2-40B4-BE49-F238E27FC236}">
                <a16:creationId xmlns:a16="http://schemas.microsoft.com/office/drawing/2014/main" id="{67542B40-4943-4574-A4B5-BDC7E2560C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413467" y="6483048"/>
            <a:ext cx="394875" cy="1799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algn="r">
              <a:defRPr lang="nl-NL" altLang="nl-NL" sz="569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83D1311D-0AF4-BF42-8BF9-EAD1FE65203C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65" r:id="rId1"/>
    <p:sldLayoutId id="2147483981" r:id="rId2"/>
    <p:sldLayoutId id="2147483982" r:id="rId3"/>
    <p:sldLayoutId id="2147483983" r:id="rId4"/>
    <p:sldLayoutId id="2147483967" r:id="rId5"/>
    <p:sldLayoutId id="2147483966" r:id="rId6"/>
    <p:sldLayoutId id="2147483968" r:id="rId7"/>
    <p:sldLayoutId id="2147483972" r:id="rId8"/>
    <p:sldLayoutId id="2147483973" r:id="rId9"/>
    <p:sldLayoutId id="2147483969" r:id="rId10"/>
    <p:sldLayoutId id="2147483984" r:id="rId11"/>
    <p:sldLayoutId id="2147483970" r:id="rId12"/>
    <p:sldLayoutId id="2147483985" r:id="rId13"/>
  </p:sldLayoutIdLst>
  <p:hf hdr="0"/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250" b="0" kern="1200" cap="all" spc="-122" baseline="0">
          <a:solidFill>
            <a:schemeClr val="tx2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575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575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575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575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5pPr>
      <a:lvl6pPr marL="371475"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3575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6pPr>
      <a:lvl7pPr marL="742950"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3575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7pPr>
      <a:lvl8pPr marL="1114425"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3575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8pPr>
      <a:lvl9pPr marL="1485900" algn="l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3575" b="1">
          <a:solidFill>
            <a:srgbClr val="0C2074"/>
          </a:solidFill>
          <a:latin typeface="Arial Black" panose="020B0604020202020204" pitchFamily="34" charset="0"/>
          <a:ea typeface="Arial Black" panose="020B0604020202020204" pitchFamily="34" charset="0"/>
          <a:cs typeface="Arial Black" panose="020B0604020202020204" pitchFamily="34" charset="0"/>
        </a:defRPr>
      </a:lvl9pPr>
    </p:titleStyle>
    <p:bodyStyle>
      <a:lvl1pPr marL="185738" indent="-185738" algn="l" rtl="0" eaLnBrk="0" fontAlgn="base" hangingPunct="0">
        <a:lnSpc>
          <a:spcPct val="90000"/>
        </a:lnSpc>
        <a:spcBef>
          <a:spcPts val="813"/>
        </a:spcBef>
        <a:spcAft>
          <a:spcPct val="0"/>
        </a:spcAft>
        <a:buFont typeface="Arial" panose="020B0604020202020204" pitchFamily="34" charset="0"/>
        <a:buChar char="•"/>
        <a:defRPr sz="2275"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557213" indent="-185738" algn="l" rtl="0" eaLnBrk="0" fontAlgn="base" hangingPunct="0">
        <a:lnSpc>
          <a:spcPct val="90000"/>
        </a:lnSpc>
        <a:spcBef>
          <a:spcPts val="406"/>
        </a:spcBef>
        <a:spcAft>
          <a:spcPct val="0"/>
        </a:spcAft>
        <a:buFont typeface="Arial" panose="020B0604020202020204" pitchFamily="34" charset="0"/>
        <a:buChar char="•"/>
        <a:defRPr sz="1950"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928688" indent="-185738" algn="l" rtl="0" eaLnBrk="0" fontAlgn="base" hangingPunct="0">
        <a:lnSpc>
          <a:spcPct val="90000"/>
        </a:lnSpc>
        <a:spcBef>
          <a:spcPts val="406"/>
        </a:spcBef>
        <a:spcAft>
          <a:spcPct val="0"/>
        </a:spcAft>
        <a:buFont typeface="Arial" panose="020B0604020202020204" pitchFamily="34" charset="0"/>
        <a:buChar char="•"/>
        <a:defRPr sz="1625"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1300163" indent="-185738" algn="l" rtl="0" eaLnBrk="0" fontAlgn="base" hangingPunct="0">
        <a:lnSpc>
          <a:spcPct val="90000"/>
        </a:lnSpc>
        <a:spcBef>
          <a:spcPts val="406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1671638" indent="-185738" algn="l" rtl="0" eaLnBrk="0" fontAlgn="base" hangingPunct="0">
        <a:lnSpc>
          <a:spcPct val="90000"/>
        </a:lnSpc>
        <a:spcBef>
          <a:spcPts val="406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2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204311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6pPr>
      <a:lvl7pPr marL="241458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7pPr>
      <a:lvl8pPr marL="278606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8pPr>
      <a:lvl9pPr marL="315753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1pPr>
      <a:lvl2pPr marL="37147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2pPr>
      <a:lvl3pPr marL="74295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3pPr>
      <a:lvl4pPr marL="111442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4pPr>
      <a:lvl5pPr marL="148590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5pPr>
      <a:lvl6pPr marL="185737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7pPr>
      <a:lvl8pPr marL="260032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8pPr>
      <a:lvl9pPr marL="297180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2" Type="http://schemas.openxmlformats.org/officeDocument/2006/relationships/customXml" Target="../../customXml/item7.xml"/><Relationship Id="rId1" Type="http://schemas.openxmlformats.org/officeDocument/2006/relationships/customXml" Target="../../customXml/item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58398" y="603857"/>
            <a:ext cx="6508653" cy="5108396"/>
            <a:chOff x="797439" y="412656"/>
            <a:chExt cx="8010650" cy="6287256"/>
          </a:xfrm>
        </p:grpSpPr>
        <p:sp>
          <p:nvSpPr>
            <p:cNvPr id="10" name="Rectangle 9"/>
            <p:cNvSpPr/>
            <p:nvPr/>
          </p:nvSpPr>
          <p:spPr>
            <a:xfrm>
              <a:off x="904539" y="412656"/>
              <a:ext cx="2016239" cy="606829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742950"/>
              <a:endParaRPr lang="nl-NL" sz="1463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908205" y="3110958"/>
              <a:ext cx="1992978" cy="606829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742950"/>
              <a:endParaRPr lang="nl-NL" sz="1463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914729" y="462347"/>
              <a:ext cx="2006049" cy="5446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742950"/>
              <a:r>
                <a:rPr lang="nl-NL" sz="1138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149 </a:t>
              </a:r>
              <a:r>
                <a:rPr lang="nl-NL" sz="1138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evaluable</a:t>
              </a:r>
              <a:r>
                <a:rPr lang="nl-NL" sz="1138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1138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patients</a:t>
              </a:r>
              <a:r>
                <a:rPr lang="nl-NL" sz="1138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on 20 mg tamoxifen</a:t>
              </a:r>
              <a:endParaRPr lang="nl-NL" sz="1138" b="1" dirty="0">
                <a:solidFill>
                  <a:srgbClr val="000000"/>
                </a:solidFill>
                <a:ea typeface="Arial" charset="0"/>
                <a:cs typeface="Arial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97439" y="3124198"/>
              <a:ext cx="2212945" cy="5446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742950"/>
              <a:r>
                <a:rPr lang="nl-NL" sz="1138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37 </a:t>
              </a:r>
              <a:r>
                <a:rPr lang="nl-NL" sz="1138" b="1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patients</a:t>
              </a:r>
              <a:r>
                <a:rPr lang="nl-NL" sz="1138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eligible for dose-reduction at baseline</a:t>
              </a:r>
              <a:endParaRPr lang="nl-NL" sz="1138" b="1" dirty="0">
                <a:solidFill>
                  <a:srgbClr val="000000"/>
                </a:solidFill>
                <a:ea typeface="Arial" charset="0"/>
                <a:cs typeface="Arial" charset="0"/>
              </a:endParaRPr>
            </a:p>
          </p:txBody>
        </p:sp>
        <p:cxnSp>
          <p:nvCxnSpPr>
            <p:cNvPr id="25" name="Straight Arrow Connector 24"/>
            <p:cNvCxnSpPr/>
            <p:nvPr/>
          </p:nvCxnSpPr>
          <p:spPr>
            <a:xfrm>
              <a:off x="1896034" y="1023828"/>
              <a:ext cx="4436" cy="780588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Straight Arrow Connector 26"/>
            <p:cNvCxnSpPr/>
            <p:nvPr/>
          </p:nvCxnSpPr>
          <p:spPr>
            <a:xfrm>
              <a:off x="1922187" y="1273682"/>
              <a:ext cx="139653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Rectangle 27"/>
            <p:cNvSpPr/>
            <p:nvPr/>
          </p:nvSpPr>
          <p:spPr>
            <a:xfrm>
              <a:off x="3339677" y="1034319"/>
              <a:ext cx="2334175" cy="489231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742950"/>
              <a:endParaRPr lang="nl-NL" sz="1463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276941" y="1020960"/>
              <a:ext cx="2437168" cy="482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742950"/>
              <a:r>
                <a:rPr lang="nl-NL" sz="975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24 </a:t>
              </a:r>
              <a:r>
                <a:rPr lang="nl-NL" sz="975" b="1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patients</a:t>
              </a:r>
              <a:r>
                <a:rPr lang="nl-NL" sz="975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: 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no side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effects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and/or FACT-ES score was too high</a:t>
              </a: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3339676" y="2451699"/>
              <a:ext cx="2334176" cy="44261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742950"/>
              <a:endParaRPr lang="nl-NL" sz="1463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42"/>
            <p:cNvSpPr/>
            <p:nvPr/>
          </p:nvSpPr>
          <p:spPr>
            <a:xfrm>
              <a:off x="874263" y="1804834"/>
              <a:ext cx="2026920" cy="519703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742950"/>
              <a:endParaRPr lang="nl-NL" sz="1463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880843" y="1797862"/>
              <a:ext cx="2030382" cy="5446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742950"/>
              <a:r>
                <a:rPr lang="nl-NL" sz="1138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125 </a:t>
              </a:r>
              <a:r>
                <a:rPr lang="nl-NL" sz="1138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patients</a:t>
              </a:r>
              <a:r>
                <a:rPr lang="nl-NL" sz="1138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1138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with</a:t>
              </a:r>
              <a:r>
                <a:rPr lang="nl-NL" sz="1138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tamoxifen side </a:t>
              </a:r>
              <a:r>
                <a:rPr lang="nl-NL" sz="1138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effects</a:t>
              </a:r>
              <a:endParaRPr lang="nl-NL" sz="1138" b="1" dirty="0">
                <a:solidFill>
                  <a:srgbClr val="000000"/>
                </a:solidFill>
                <a:ea typeface="Arial" charset="0"/>
                <a:cs typeface="Arial" charset="0"/>
              </a:endParaRPr>
            </a:p>
          </p:txBody>
        </p:sp>
        <p:sp>
          <p:nvSpPr>
            <p:cNvPr id="45" name="Rectangle 44"/>
            <p:cNvSpPr/>
            <p:nvPr/>
          </p:nvSpPr>
          <p:spPr>
            <a:xfrm>
              <a:off x="894002" y="4617440"/>
              <a:ext cx="2017222" cy="606829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742950"/>
              <a:endParaRPr lang="nl-NL" sz="1463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833337" y="4642935"/>
              <a:ext cx="2136122" cy="5446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742950"/>
              <a:r>
                <a:rPr lang="nl-NL" sz="1138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20 </a:t>
              </a:r>
              <a:r>
                <a:rPr lang="nl-NL" sz="1138" b="1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patients</a:t>
              </a:r>
              <a:r>
                <a:rPr lang="nl-NL" sz="1138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1138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underwent</a:t>
              </a:r>
              <a:r>
                <a:rPr lang="nl-NL" sz="1138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tamoxifen </a:t>
              </a:r>
              <a:r>
                <a:rPr lang="nl-NL" sz="1138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dose</a:t>
              </a:r>
              <a:r>
                <a:rPr lang="nl-NL" sz="1138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1138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reduction</a:t>
              </a:r>
              <a:endParaRPr lang="nl-NL" sz="1138" b="1" dirty="0">
                <a:solidFill>
                  <a:srgbClr val="000000"/>
                </a:solidFill>
                <a:ea typeface="Arial" charset="0"/>
                <a:cs typeface="Arial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346603" y="2451699"/>
              <a:ext cx="2327249" cy="482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742950"/>
              <a:r>
                <a:rPr lang="nl-NL" sz="975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88 </a:t>
              </a:r>
              <a:r>
                <a:rPr lang="nl-NL" sz="975" b="1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patients</a:t>
              </a:r>
              <a:r>
                <a:rPr lang="nl-NL" sz="975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had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endoxifen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levels </a:t>
              </a:r>
            </a:p>
            <a:p>
              <a:pPr algn="ctr" defTabSz="742950"/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&lt;32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nM</a:t>
              </a:r>
              <a:endParaRPr lang="nl-NL" sz="975" dirty="0">
                <a:solidFill>
                  <a:srgbClr val="000000"/>
                </a:solidFill>
                <a:ea typeface="Arial" charset="0"/>
                <a:cs typeface="Arial" charset="0"/>
              </a:endParaRPr>
            </a:p>
          </p:txBody>
        </p:sp>
        <p:sp>
          <p:nvSpPr>
            <p:cNvPr id="53" name="Rectangle 52"/>
            <p:cNvSpPr/>
            <p:nvPr/>
          </p:nvSpPr>
          <p:spPr>
            <a:xfrm>
              <a:off x="894002" y="6093083"/>
              <a:ext cx="2017222" cy="606829"/>
            </a:xfrm>
            <a:prstGeom prst="rect">
              <a:avLst/>
            </a:prstGeom>
            <a:solidFill>
              <a:srgbClr val="79831E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742950"/>
              <a:endParaRPr lang="nl-NL" sz="1463" dirty="0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4" name="Straight Arrow Connector 53"/>
            <p:cNvCxnSpPr>
              <a:stCxn id="45" idx="2"/>
              <a:endCxn id="53" idx="0"/>
            </p:cNvCxnSpPr>
            <p:nvPr/>
          </p:nvCxnSpPr>
          <p:spPr>
            <a:xfrm>
              <a:off x="1902613" y="5224269"/>
              <a:ext cx="0" cy="868814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882047" y="6132796"/>
              <a:ext cx="2019136" cy="5446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742950"/>
              <a:r>
                <a:rPr lang="nl-NL" sz="1138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Evaluable patients with </a:t>
              </a:r>
              <a:r>
                <a:rPr lang="nl-NL" sz="1138" b="1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dose-reduction</a:t>
              </a:r>
              <a:r>
                <a:rPr lang="nl-NL" sz="1138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1138" b="1" dirty="0" smtClean="0">
                  <a:solidFill>
                    <a:srgbClr val="000000"/>
                  </a:solidFill>
                  <a:ea typeface="Arial" charset="0"/>
                  <a:cs typeface="Arial" charset="0"/>
                </a:rPr>
                <a:t>n </a:t>
              </a:r>
              <a:r>
                <a:rPr lang="nl-NL" sz="1138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= 17</a:t>
              </a: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3311106" y="5150852"/>
              <a:ext cx="2355240" cy="1002827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742950"/>
              <a:endParaRPr lang="nl-NL" sz="1463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268461" y="5138016"/>
              <a:ext cx="2317527" cy="10369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742950"/>
              <a:r>
                <a:rPr lang="nl-NL" sz="975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3 patients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were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non-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evaluable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for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side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effects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endParaRPr lang="nl-NL" sz="975" b="1" dirty="0">
                <a:solidFill>
                  <a:srgbClr val="000000"/>
                </a:solidFill>
                <a:ea typeface="Arial" charset="0"/>
                <a:cs typeface="Arial" charset="0"/>
              </a:endParaRPr>
            </a:p>
            <a:p>
              <a:pPr marL="139303" indent="-139303" defTabSz="742950">
                <a:buFont typeface="Arial" panose="020B0604020202020204" pitchFamily="34" charset="0"/>
                <a:buChar char="•"/>
              </a:pP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Endoxifen</a:t>
              </a:r>
              <a:r>
                <a:rPr lang="nl-NL" sz="975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smtClean="0">
                  <a:solidFill>
                    <a:srgbClr val="000000"/>
                  </a:solidFill>
                  <a:ea typeface="Arial" charset="0"/>
                  <a:cs typeface="Arial" charset="0"/>
                </a:rPr>
                <a:t>&lt;16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nM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at TDM2</a:t>
              </a:r>
            </a:p>
            <a:p>
              <a:pPr marL="139303" indent="-139303" defTabSz="742950">
                <a:buFont typeface="Arial" panose="020B0604020202020204" pitchFamily="34" charset="0"/>
                <a:buChar char="•"/>
              </a:pP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Tamoxifen was stopped early</a:t>
              </a:r>
            </a:p>
            <a:p>
              <a:pPr marL="139303" indent="-139303" defTabSz="742950">
                <a:buFont typeface="Arial" panose="020B0604020202020204" pitchFamily="34" charset="0"/>
                <a:buChar char="•"/>
              </a:pP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Lost to follow-up</a:t>
              </a:r>
            </a:p>
          </p:txBody>
        </p:sp>
        <p:cxnSp>
          <p:nvCxnSpPr>
            <p:cNvPr id="58" name="Straight Arrow Connector 57"/>
            <p:cNvCxnSpPr/>
            <p:nvPr/>
          </p:nvCxnSpPr>
          <p:spPr>
            <a:xfrm>
              <a:off x="1904694" y="5651179"/>
              <a:ext cx="139653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/>
            <p:nvPr/>
          </p:nvCxnSpPr>
          <p:spPr>
            <a:xfrm>
              <a:off x="1923084" y="2676695"/>
              <a:ext cx="139653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" name="Straight Arrow Connector 58"/>
            <p:cNvCxnSpPr>
              <a:stCxn id="11" idx="2"/>
              <a:endCxn id="45" idx="0"/>
            </p:cNvCxnSpPr>
            <p:nvPr/>
          </p:nvCxnSpPr>
          <p:spPr>
            <a:xfrm flipH="1">
              <a:off x="1902613" y="3717787"/>
              <a:ext cx="2081" cy="899653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Straight Arrow Connector 59"/>
            <p:cNvCxnSpPr/>
            <p:nvPr/>
          </p:nvCxnSpPr>
          <p:spPr>
            <a:xfrm>
              <a:off x="1895470" y="2333481"/>
              <a:ext cx="4436" cy="780588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3297036" y="3484888"/>
              <a:ext cx="2416745" cy="6676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39303" indent="-139303" defTabSz="742950">
                <a:buFont typeface="Arial" panose="020B0604020202020204" pitchFamily="34" charset="0"/>
                <a:buChar char="•"/>
              </a:pPr>
              <a:r>
                <a:rPr lang="nl-NL" sz="975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18 </a:t>
              </a:r>
              <a:r>
                <a:rPr lang="nl-NL" sz="975" b="1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patients</a:t>
              </a:r>
              <a:r>
                <a:rPr lang="nl-NL" sz="975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did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not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find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their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side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effects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bothersome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 smtClean="0">
                  <a:solidFill>
                    <a:srgbClr val="000000"/>
                  </a:solidFill>
                  <a:ea typeface="Arial" charset="0"/>
                  <a:cs typeface="Arial" charset="0"/>
                </a:rPr>
                <a:t>enough</a:t>
              </a:r>
              <a:endParaRPr lang="nl-NL" sz="975" dirty="0">
                <a:solidFill>
                  <a:srgbClr val="000000"/>
                </a:solidFill>
                <a:ea typeface="Arial" charset="0"/>
                <a:cs typeface="Arial" charset="0"/>
              </a:endParaRPr>
            </a:p>
            <a:p>
              <a:pPr marL="139303" indent="-139303" defTabSz="742950">
                <a:buFont typeface="Arial" panose="020B0604020202020204" pitchFamily="34" charset="0"/>
                <a:buChar char="•"/>
              </a:pPr>
              <a:r>
                <a:rPr lang="nl-NL" sz="975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1 </a:t>
              </a:r>
              <a:r>
                <a:rPr lang="nl-NL" sz="975" b="1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patient</a:t>
              </a:r>
              <a:r>
                <a:rPr lang="nl-NL" sz="975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quit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tamoxifen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early</a:t>
              </a:r>
              <a:endParaRPr lang="nl-NL" sz="975" dirty="0">
                <a:solidFill>
                  <a:srgbClr val="000000"/>
                </a:solidFill>
                <a:ea typeface="Arial" charset="0"/>
                <a:cs typeface="Arial" charset="0"/>
              </a:endParaRPr>
            </a:p>
          </p:txBody>
        </p:sp>
        <p:cxnSp>
          <p:nvCxnSpPr>
            <p:cNvPr id="63" name="Straight Arrow Connector 62"/>
            <p:cNvCxnSpPr/>
            <p:nvPr/>
          </p:nvCxnSpPr>
          <p:spPr>
            <a:xfrm>
              <a:off x="1917753" y="3810174"/>
              <a:ext cx="1364500" cy="61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Rectangle 63"/>
            <p:cNvSpPr/>
            <p:nvPr/>
          </p:nvSpPr>
          <p:spPr>
            <a:xfrm>
              <a:off x="3332171" y="3498190"/>
              <a:ext cx="2334175" cy="623969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742950"/>
              <a:endParaRPr lang="nl-NL" sz="1463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5" name="Straight Arrow Connector 64"/>
            <p:cNvCxnSpPr/>
            <p:nvPr/>
          </p:nvCxnSpPr>
          <p:spPr>
            <a:xfrm flipH="1" flipV="1">
              <a:off x="1924103" y="4446059"/>
              <a:ext cx="1345450" cy="344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3332171" y="3896544"/>
              <a:ext cx="23341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Rectangle 46"/>
            <p:cNvSpPr/>
            <p:nvPr/>
          </p:nvSpPr>
          <p:spPr>
            <a:xfrm>
              <a:off x="6217399" y="2802432"/>
              <a:ext cx="2478106" cy="864705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742950"/>
              <a:endParaRPr lang="nl-NL" sz="1463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176473" y="2797660"/>
              <a:ext cx="2631616" cy="8523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39303" indent="-139303" defTabSz="742950">
                <a:buFont typeface="Arial" panose="020B0604020202020204" pitchFamily="34" charset="0"/>
                <a:buChar char="•"/>
              </a:pPr>
              <a:r>
                <a:rPr lang="nl-NL" sz="975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34 </a:t>
              </a:r>
              <a:r>
                <a:rPr lang="nl-NL" sz="975" b="1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patients</a:t>
              </a:r>
              <a:r>
                <a:rPr lang="nl-NL" sz="975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increased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tamoxifen </a:t>
              </a:r>
            </a:p>
            <a:p>
              <a:pPr defTabSz="742950"/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dose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due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to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endoxifen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levels </a:t>
              </a:r>
              <a:r>
                <a:rPr lang="nl-NL" sz="975" dirty="0" smtClean="0">
                  <a:solidFill>
                    <a:srgbClr val="000000"/>
                  </a:solidFill>
                  <a:ea typeface="Arial" charset="0"/>
                  <a:cs typeface="Arial" charset="0"/>
                </a:rPr>
                <a:t>&lt;16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nM</a:t>
              </a:r>
              <a:endParaRPr lang="nl-NL" sz="975" dirty="0">
                <a:solidFill>
                  <a:srgbClr val="000000"/>
                </a:solidFill>
                <a:ea typeface="Arial" charset="0"/>
                <a:cs typeface="Arial" charset="0"/>
              </a:endParaRPr>
            </a:p>
            <a:p>
              <a:pPr marL="139303" indent="-139303" defTabSz="742950">
                <a:buFont typeface="Arial" panose="020B0604020202020204" pitchFamily="34" charset="0"/>
                <a:buChar char="•"/>
              </a:pPr>
              <a:r>
                <a:rPr lang="nl-NL" sz="975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12 </a:t>
              </a:r>
              <a:r>
                <a:rPr lang="nl-NL" sz="975" b="1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patients</a:t>
              </a:r>
              <a:r>
                <a:rPr lang="nl-NL" sz="975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did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not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complete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all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questionnaires /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quit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the</a:t>
              </a:r>
              <a:r>
                <a:rPr lang="nl-NL" sz="975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75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study</a:t>
              </a:r>
              <a:endParaRPr lang="nl-NL" sz="975" dirty="0">
                <a:solidFill>
                  <a:srgbClr val="000000"/>
                </a:solidFill>
                <a:ea typeface="Arial" charset="0"/>
                <a:cs typeface="Arial" charset="0"/>
              </a:endParaRPr>
            </a:p>
          </p:txBody>
        </p:sp>
        <p:cxnSp>
          <p:nvCxnSpPr>
            <p:cNvPr id="30" name="Straight Connector 29"/>
            <p:cNvCxnSpPr/>
            <p:nvPr/>
          </p:nvCxnSpPr>
          <p:spPr>
            <a:xfrm>
              <a:off x="5668727" y="3696713"/>
              <a:ext cx="1272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5673491" y="2675385"/>
              <a:ext cx="1272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 flipH="1">
              <a:off x="5795962" y="2673005"/>
              <a:ext cx="4764" cy="101533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/>
            <p:cNvCxnSpPr/>
            <p:nvPr/>
          </p:nvCxnSpPr>
          <p:spPr>
            <a:xfrm>
              <a:off x="5800726" y="3184353"/>
              <a:ext cx="3619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Rectangle 60"/>
            <p:cNvSpPr/>
            <p:nvPr/>
          </p:nvSpPr>
          <p:spPr>
            <a:xfrm>
              <a:off x="6217398" y="4281199"/>
              <a:ext cx="2478107" cy="733013"/>
            </a:xfrm>
            <a:prstGeom prst="rect">
              <a:avLst/>
            </a:prstGeom>
            <a:solidFill>
              <a:srgbClr val="79831E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742950"/>
              <a:endParaRPr lang="nl-NL" sz="1463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6217399" y="4279529"/>
              <a:ext cx="2478106" cy="760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742950"/>
              <a:r>
                <a:rPr lang="nl-NL" sz="1138" b="1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Evaluable</a:t>
              </a:r>
              <a:r>
                <a:rPr lang="nl-NL" sz="1138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1138" b="1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patients</a:t>
              </a:r>
              <a:r>
                <a:rPr lang="nl-NL" sz="1138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1138" b="1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with</a:t>
              </a:r>
              <a:r>
                <a:rPr lang="nl-NL" sz="1138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side </a:t>
              </a:r>
              <a:r>
                <a:rPr lang="nl-NL" sz="1138" b="1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effects</a:t>
              </a:r>
              <a:r>
                <a:rPr lang="nl-NL" sz="1138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remaining on 20 mg </a:t>
              </a:r>
            </a:p>
            <a:p>
              <a:pPr algn="ctr" defTabSz="742950"/>
              <a:r>
                <a:rPr lang="nl-NL" sz="1138" b="1" dirty="0" smtClean="0">
                  <a:solidFill>
                    <a:srgbClr val="000000"/>
                  </a:solidFill>
                  <a:ea typeface="Arial" charset="0"/>
                  <a:cs typeface="Arial" charset="0"/>
                </a:rPr>
                <a:t>n </a:t>
              </a:r>
              <a:r>
                <a:rPr lang="nl-NL" sz="1138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= 60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3259318" y="4127192"/>
              <a:ext cx="2426725" cy="4545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742950"/>
              <a:r>
                <a:rPr lang="nl-NL" sz="900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2 </a:t>
              </a:r>
              <a:r>
                <a:rPr lang="nl-NL" sz="900" b="1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patients</a:t>
              </a:r>
              <a:r>
                <a:rPr lang="nl-NL" sz="900" b="1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00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with</a:t>
              </a:r>
              <a:r>
                <a:rPr lang="nl-NL" sz="900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00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endoxifen</a:t>
              </a:r>
              <a:r>
                <a:rPr lang="nl-NL" sz="900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levels </a:t>
              </a:r>
              <a:r>
                <a:rPr lang="nl-NL" sz="900" u="sng" dirty="0" smtClean="0">
                  <a:solidFill>
                    <a:srgbClr val="000000"/>
                  </a:solidFill>
                  <a:ea typeface="Arial" charset="0"/>
                  <a:cs typeface="Arial" charset="0"/>
                </a:rPr>
                <a:t>&gt;</a:t>
              </a:r>
              <a:r>
                <a:rPr lang="nl-NL" sz="900" dirty="0" smtClean="0">
                  <a:solidFill>
                    <a:srgbClr val="000000"/>
                  </a:solidFill>
                  <a:ea typeface="Arial" charset="0"/>
                  <a:cs typeface="Arial" charset="0"/>
                </a:rPr>
                <a:t>32 </a:t>
              </a:r>
              <a:r>
                <a:rPr lang="nl-NL" sz="900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nM</a:t>
              </a:r>
              <a:r>
                <a:rPr lang="nl-NL" sz="900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later </a:t>
              </a:r>
              <a:r>
                <a:rPr lang="nl-NL" sz="900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than</a:t>
              </a:r>
              <a:r>
                <a:rPr lang="nl-NL" sz="900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baseline </a:t>
              </a:r>
              <a:r>
                <a:rPr lang="nl-NL" sz="900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were</a:t>
              </a:r>
              <a:r>
                <a:rPr lang="nl-NL" sz="900" dirty="0">
                  <a:solidFill>
                    <a:srgbClr val="000000"/>
                  </a:solidFill>
                  <a:ea typeface="Arial" charset="0"/>
                  <a:cs typeface="Arial" charset="0"/>
                </a:rPr>
                <a:t> </a:t>
              </a:r>
              <a:r>
                <a:rPr lang="nl-NL" sz="900" dirty="0" err="1">
                  <a:solidFill>
                    <a:srgbClr val="000000"/>
                  </a:solidFill>
                  <a:ea typeface="Arial" charset="0"/>
                  <a:cs typeface="Arial" charset="0"/>
                </a:rPr>
                <a:t>added</a:t>
              </a:r>
              <a:endParaRPr lang="nl-NL" sz="900" dirty="0">
                <a:solidFill>
                  <a:srgbClr val="000000"/>
                </a:solidFill>
                <a:ea typeface="Arial" charset="0"/>
                <a:cs typeface="Arial" charset="0"/>
              </a:endParaRPr>
            </a:p>
          </p:txBody>
        </p:sp>
        <p:sp>
          <p:nvSpPr>
            <p:cNvPr id="71" name="Rectangle 70"/>
            <p:cNvSpPr/>
            <p:nvPr/>
          </p:nvSpPr>
          <p:spPr>
            <a:xfrm>
              <a:off x="3333101" y="4125943"/>
              <a:ext cx="2334175" cy="489231"/>
            </a:xfrm>
            <a:prstGeom prst="rect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 defTabSz="742950"/>
              <a:endParaRPr lang="nl-NL" sz="1463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90" name="Elbow Connector 89"/>
            <p:cNvCxnSpPr/>
            <p:nvPr/>
          </p:nvCxnSpPr>
          <p:spPr>
            <a:xfrm rot="16200000" flipH="1">
              <a:off x="5361662" y="3811007"/>
              <a:ext cx="1436494" cy="240797"/>
            </a:xfrm>
            <a:prstGeom prst="bentConnector2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Box 2"/>
          <p:cNvSpPr txBox="1"/>
          <p:nvPr/>
        </p:nvSpPr>
        <p:spPr>
          <a:xfrm>
            <a:off x="647918" y="224878"/>
            <a:ext cx="4936418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nl-NL" sz="1300" b="1" dirty="0">
                <a:ea typeface="Arial" charset="0"/>
                <a:cs typeface="Arial" charset="0"/>
              </a:rPr>
              <a:t>Flowchart </a:t>
            </a:r>
            <a:r>
              <a:rPr lang="nl-NL" sz="1300" b="1" dirty="0" err="1">
                <a:ea typeface="Arial" charset="0"/>
                <a:cs typeface="Arial" charset="0"/>
              </a:rPr>
              <a:t>patient</a:t>
            </a:r>
            <a:r>
              <a:rPr lang="nl-NL" sz="1300" b="1" dirty="0">
                <a:ea typeface="Arial" charset="0"/>
                <a:cs typeface="Arial" charset="0"/>
              </a:rPr>
              <a:t> </a:t>
            </a:r>
            <a:r>
              <a:rPr lang="nl-NL" sz="1300" b="1" dirty="0" err="1">
                <a:ea typeface="Arial" charset="0"/>
                <a:cs typeface="Arial" charset="0"/>
              </a:rPr>
              <a:t>selection</a:t>
            </a:r>
            <a:r>
              <a:rPr lang="nl-NL" sz="1300" b="1" dirty="0">
                <a:ea typeface="Arial" charset="0"/>
                <a:cs typeface="Arial" charset="0"/>
              </a:rPr>
              <a:t> </a:t>
            </a:r>
            <a:r>
              <a:rPr lang="nl-NL" sz="1300" b="1" dirty="0" err="1">
                <a:ea typeface="Arial" charset="0"/>
                <a:cs typeface="Arial" charset="0"/>
              </a:rPr>
              <a:t>for</a:t>
            </a:r>
            <a:r>
              <a:rPr lang="nl-NL" sz="1300" b="1" dirty="0">
                <a:ea typeface="Arial" charset="0"/>
                <a:cs typeface="Arial" charset="0"/>
              </a:rPr>
              <a:t> </a:t>
            </a:r>
            <a:r>
              <a:rPr lang="nl-NL" sz="1300" b="1" dirty="0" err="1">
                <a:ea typeface="Arial" charset="0"/>
                <a:cs typeface="Arial" charset="0"/>
              </a:rPr>
              <a:t>dose-reduction</a:t>
            </a:r>
            <a:endParaRPr lang="en-GB" sz="1300" b="1" dirty="0" err="1">
              <a:ea typeface="Arial" charset="0"/>
              <a:cs typeface="Arial" charset="0"/>
            </a:endParaRPr>
          </a:p>
        </p:txBody>
      </p:sp>
      <p:sp>
        <p:nvSpPr>
          <p:cNvPr id="51" name="Text Box 2"/>
          <p:cNvSpPr txBox="1">
            <a:spLocks noChangeArrowheads="1"/>
          </p:cNvSpPr>
          <p:nvPr/>
        </p:nvSpPr>
        <p:spPr bwMode="auto">
          <a:xfrm>
            <a:off x="658398" y="5761841"/>
            <a:ext cx="9000992" cy="913906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74295" tIns="37148" rIns="74295" bIns="37148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650"/>
              </a:spcAft>
            </a:pPr>
            <a:r>
              <a:rPr lang="en-GB" sz="650" b="1" kern="100" dirty="0">
                <a:ea typeface="Calibri" panose="020F0502020204030204" pitchFamily="34" charset="0"/>
                <a:cs typeface="Calibri" panose="020F0502020204030204" pitchFamily="34" charset="0"/>
              </a:rPr>
              <a:t>Legend.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From all patients undergoing therapeutic drug monitoring according to the TOTAM-study 125 patients experienced tamoxifen-related side effects. From this group 37 patients had </a:t>
            </a:r>
            <a:r>
              <a:rPr lang="en-GB" sz="650" i="1" kern="100" dirty="0" err="1">
                <a:ea typeface="Calibri" panose="020F0502020204030204" pitchFamily="34" charset="0"/>
                <a:cs typeface="Calibri" panose="020F0502020204030204" pitchFamily="34" charset="0"/>
              </a:rPr>
              <a:t>endoxifen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levels </a:t>
            </a:r>
            <a:r>
              <a:rPr lang="en-GB" sz="650" i="1" u="sng" kern="100" dirty="0">
                <a:ea typeface="Calibri" panose="020F0502020204030204" pitchFamily="34" charset="0"/>
                <a:cs typeface="Calibri" panose="020F0502020204030204" pitchFamily="34" charset="0"/>
              </a:rPr>
              <a:t>&gt;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32 </a:t>
            </a:r>
            <a:r>
              <a:rPr lang="en-GB" sz="650" i="1" kern="100" dirty="0" err="1">
                <a:ea typeface="Calibri" panose="020F0502020204030204" pitchFamily="34" charset="0"/>
                <a:cs typeface="Calibri" panose="020F0502020204030204" pitchFamily="34" charset="0"/>
              </a:rPr>
              <a:t>nM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and were eligible for dose-reduction at baseline. Eighteen patients did not find their side effects bothersome enough for dose-reduction </a:t>
            </a:r>
            <a:r>
              <a:rPr lang="en-GB" sz="650" i="1" kern="100" dirty="0" smtClean="0">
                <a:ea typeface="Calibri" panose="020F0502020204030204" pitchFamily="34" charset="0"/>
                <a:cs typeface="Calibri" panose="020F0502020204030204" pitchFamily="34" charset="0"/>
              </a:rPr>
              <a:t>and 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remained on </a:t>
            </a:r>
            <a:r>
              <a:rPr lang="en-GB" sz="650" i="1" kern="100" dirty="0" smtClean="0">
                <a:ea typeface="Calibri" panose="020F0502020204030204" pitchFamily="34" charset="0"/>
                <a:cs typeface="Calibri" panose="020F0502020204030204" pitchFamily="34" charset="0"/>
              </a:rPr>
              <a:t>tamoxifen 20 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mg, 1 patient quit tamoxifen shortly after start of study and two patients who at the first </a:t>
            </a:r>
            <a:r>
              <a:rPr lang="en-GB" sz="650" i="1" kern="100" dirty="0" err="1">
                <a:ea typeface="Calibri" panose="020F0502020204030204" pitchFamily="34" charset="0"/>
                <a:cs typeface="Calibri" panose="020F0502020204030204" pitchFamily="34" charset="0"/>
              </a:rPr>
              <a:t>endoxifen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measurement at baseline did not have </a:t>
            </a:r>
            <a:r>
              <a:rPr lang="en-GB" sz="650" i="1" kern="100" dirty="0" err="1">
                <a:ea typeface="Calibri" panose="020F0502020204030204" pitchFamily="34" charset="0"/>
                <a:cs typeface="Calibri" panose="020F0502020204030204" pitchFamily="34" charset="0"/>
              </a:rPr>
              <a:t>endoxifen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levels </a:t>
            </a:r>
            <a:r>
              <a:rPr lang="en-GB" sz="650" i="1" u="sng" kern="100" dirty="0">
                <a:ea typeface="Calibri" panose="020F0502020204030204" pitchFamily="34" charset="0"/>
                <a:cs typeface="Calibri" panose="020F0502020204030204" pitchFamily="34" charset="0"/>
              </a:rPr>
              <a:t>&gt;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32 </a:t>
            </a:r>
            <a:r>
              <a:rPr lang="en-GB" sz="650" i="1" kern="100" dirty="0" err="1">
                <a:ea typeface="Calibri" panose="020F0502020204030204" pitchFamily="34" charset="0"/>
                <a:cs typeface="Calibri" panose="020F0502020204030204" pitchFamily="34" charset="0"/>
              </a:rPr>
              <a:t>nM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were </a:t>
            </a:r>
            <a:r>
              <a:rPr lang="en-GB" sz="650" i="1" kern="100" dirty="0" smtClean="0">
                <a:ea typeface="Calibri" panose="020F0502020204030204" pitchFamily="34" charset="0"/>
                <a:cs typeface="Calibri" panose="020F0502020204030204" pitchFamily="34" charset="0"/>
              </a:rPr>
              <a:t>reduced in dose 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later in the study when </a:t>
            </a:r>
            <a:r>
              <a:rPr lang="en-GB" sz="650" i="1" kern="100" dirty="0" err="1">
                <a:ea typeface="Calibri" panose="020F0502020204030204" pitchFamily="34" charset="0"/>
                <a:cs typeface="Calibri" panose="020F0502020204030204" pitchFamily="34" charset="0"/>
              </a:rPr>
              <a:t>endoxifen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levels became </a:t>
            </a:r>
            <a:r>
              <a:rPr lang="en-GB" sz="650" i="1" u="sng" kern="100" dirty="0">
                <a:ea typeface="Calibri" panose="020F0502020204030204" pitchFamily="34" charset="0"/>
                <a:cs typeface="Calibri" panose="020F0502020204030204" pitchFamily="34" charset="0"/>
              </a:rPr>
              <a:t>&gt;</a:t>
            </a:r>
            <a:r>
              <a:rPr lang="en-GB" sz="650" kern="100" dirty="0">
                <a:ea typeface="Calibri" panose="020F0502020204030204" pitchFamily="34" charset="0"/>
                <a:cs typeface="Calibri" panose="020F0502020204030204" pitchFamily="34" charset="0"/>
              </a:rPr>
              <a:t>32 </a:t>
            </a:r>
            <a:r>
              <a:rPr lang="en-GB" sz="650" kern="100" dirty="0" err="1">
                <a:ea typeface="Calibri" panose="020F0502020204030204" pitchFamily="34" charset="0"/>
                <a:cs typeface="Calibri" panose="020F0502020204030204" pitchFamily="34" charset="0"/>
              </a:rPr>
              <a:t>nM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. Eventually, 20 out 150 patients (13%) were reduced in tamoxifen dose. From these patients 1 was lost to follow-up for side effect assessment, 1 quit tamoxifen 2 months after tamoxifen dose was reduced and in 1 patient the </a:t>
            </a:r>
            <a:r>
              <a:rPr lang="en-GB" sz="650" i="1" kern="100" dirty="0" err="1">
                <a:ea typeface="Calibri" panose="020F0502020204030204" pitchFamily="34" charset="0"/>
                <a:cs typeface="Calibri" panose="020F0502020204030204" pitchFamily="34" charset="0"/>
              </a:rPr>
              <a:t>endoxifen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level was already below 16 </a:t>
            </a:r>
            <a:r>
              <a:rPr lang="en-GB" sz="650" i="1" kern="100" dirty="0" err="1">
                <a:ea typeface="Calibri" panose="020F0502020204030204" pitchFamily="34" charset="0"/>
                <a:cs typeface="Calibri" panose="020F0502020204030204" pitchFamily="34" charset="0"/>
              </a:rPr>
              <a:t>nM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26 days after the dose-reduction and thus tamoxifen </a:t>
            </a:r>
            <a:r>
              <a:rPr lang="en-GB" sz="650" i="1" kern="100" dirty="0" smtClean="0">
                <a:ea typeface="Calibri" panose="020F0502020204030204" pitchFamily="34" charset="0"/>
                <a:cs typeface="Calibri" panose="020F0502020204030204" pitchFamily="34" charset="0"/>
              </a:rPr>
              <a:t>dose was increased 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to 15 mg.</a:t>
            </a:r>
            <a:endParaRPr lang="en-GB" sz="894" kern="1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650"/>
              </a:spcAft>
            </a:pP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The 88 patients with side effects but </a:t>
            </a:r>
            <a:r>
              <a:rPr lang="en-GB" sz="650" i="1" kern="100" dirty="0" err="1">
                <a:ea typeface="Calibri" panose="020F0502020204030204" pitchFamily="34" charset="0"/>
                <a:cs typeface="Calibri" panose="020F0502020204030204" pitchFamily="34" charset="0"/>
              </a:rPr>
              <a:t>endoxifen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levels &lt;32 </a:t>
            </a:r>
            <a:r>
              <a:rPr lang="en-GB" sz="650" i="1" kern="100" dirty="0" err="1">
                <a:ea typeface="Calibri" panose="020F0502020204030204" pitchFamily="34" charset="0"/>
                <a:cs typeface="Calibri" panose="020F0502020204030204" pitchFamily="34" charset="0"/>
              </a:rPr>
              <a:t>nM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and the 18 patients with </a:t>
            </a:r>
            <a:r>
              <a:rPr lang="en-GB" sz="650" i="1" kern="100" dirty="0" err="1">
                <a:ea typeface="Calibri" panose="020F0502020204030204" pitchFamily="34" charset="0"/>
                <a:cs typeface="Calibri" panose="020F0502020204030204" pitchFamily="34" charset="0"/>
              </a:rPr>
              <a:t>endoxifen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levels </a:t>
            </a:r>
            <a:r>
              <a:rPr lang="en-GB" sz="650" i="1" u="sng" kern="100" dirty="0" smtClean="0">
                <a:ea typeface="Calibri" panose="020F0502020204030204" pitchFamily="34" charset="0"/>
                <a:cs typeface="Calibri" panose="020F0502020204030204" pitchFamily="34" charset="0"/>
              </a:rPr>
              <a:t>&gt;</a:t>
            </a:r>
            <a:r>
              <a:rPr lang="en-GB" sz="650" i="1" kern="100" dirty="0" smtClean="0">
                <a:ea typeface="Calibri" panose="020F0502020204030204" pitchFamily="34" charset="0"/>
                <a:cs typeface="Calibri" panose="020F0502020204030204" pitchFamily="34" charset="0"/>
              </a:rPr>
              <a:t>32 </a:t>
            </a:r>
            <a:r>
              <a:rPr lang="en-GB" sz="650" i="1" kern="100" dirty="0" err="1">
                <a:ea typeface="Calibri" panose="020F0502020204030204" pitchFamily="34" charset="0"/>
                <a:cs typeface="Calibri" panose="020F0502020204030204" pitchFamily="34" charset="0"/>
              </a:rPr>
              <a:t>nM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but who refused dose-reduction were used as a control group if they remained on a tamoxifen dose of 20 mg from 3 to 6 months of tamoxifen use. From these 106 patients, 34 patients were increased in tamoxifen dose due to </a:t>
            </a:r>
            <a:r>
              <a:rPr lang="en-GB" sz="650" i="1" kern="100" dirty="0" err="1">
                <a:ea typeface="Calibri" panose="020F0502020204030204" pitchFamily="34" charset="0"/>
                <a:cs typeface="Calibri" panose="020F0502020204030204" pitchFamily="34" charset="0"/>
              </a:rPr>
              <a:t>endoxifen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levels &lt;16 </a:t>
            </a:r>
            <a:r>
              <a:rPr lang="en-GB" sz="650" i="1" kern="100" dirty="0" err="1">
                <a:ea typeface="Calibri" panose="020F0502020204030204" pitchFamily="34" charset="0"/>
                <a:cs typeface="Calibri" panose="020F0502020204030204" pitchFamily="34" charset="0"/>
              </a:rPr>
              <a:t>nM</a:t>
            </a:r>
            <a:r>
              <a:rPr lang="en-GB" sz="650" i="1" kern="100" dirty="0">
                <a:ea typeface="Calibri" panose="020F0502020204030204" pitchFamily="34" charset="0"/>
                <a:cs typeface="Calibri" panose="020F0502020204030204" pitchFamily="34" charset="0"/>
              </a:rPr>
              <a:t> and 12 patients did not complete all questionnaires or quit the study early. Therefore, 60 patients with side effects who remained on 20 mg tamoxifen for at least 3 months after inclusion could be used as a group to check for a potential time-effect. </a:t>
            </a:r>
            <a:endParaRPr lang="en-GB" sz="894" kern="1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custDataLst>
      <p:custData r:id="rId1"/>
      <p:custData r:id="rId2"/>
    </p:custDataLst>
    <p:extLst>
      <p:ext uri="{BB962C8B-B14F-4D97-AF65-F5344CB8AC3E}">
        <p14:creationId xmlns:p14="http://schemas.microsoft.com/office/powerpoint/2010/main" val="15351766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Erasmus MC">
  <a:themeElements>
    <a:clrScheme name="Erasmus MC">
      <a:dk1>
        <a:srgbClr val="000000"/>
      </a:dk1>
      <a:lt1>
        <a:srgbClr val="FFFFFF"/>
      </a:lt1>
      <a:dk2>
        <a:srgbClr val="0C2074"/>
      </a:dk2>
      <a:lt2>
        <a:srgbClr val="E7E6E6"/>
      </a:lt2>
      <a:accent1>
        <a:srgbClr val="0C2074"/>
      </a:accent1>
      <a:accent2>
        <a:srgbClr val="6D79AC"/>
      </a:accent2>
      <a:accent3>
        <a:srgbClr val="CED2E3"/>
      </a:accent3>
      <a:accent4>
        <a:srgbClr val="86D2ED"/>
      </a:accent4>
      <a:accent5>
        <a:srgbClr val="B6E4F4"/>
      </a:accent5>
      <a:accent6>
        <a:srgbClr val="E7F6FB"/>
      </a:accent6>
      <a:hlink>
        <a:srgbClr val="86D2EE"/>
      </a:hlink>
      <a:folHlink>
        <a:srgbClr val="B6E4F4"/>
      </a:folHlink>
    </a:clrScheme>
    <a:fontScheme name="Erasmus MC">
      <a:majorFont>
        <a:latin typeface="Arial Black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2400" b="1" i="0" dirty="0" err="1" smtClean="0">
            <a:solidFill>
              <a:schemeClr val="accent4"/>
            </a:solidFill>
            <a:ea typeface="Arial" charset="0"/>
            <a:cs typeface="Arial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ERA190317_Erasmus MC Bedrijfspresentatie 15nov" id="{2DD2DD8F-3AE1-074E-836C-1DE8AE280910}" vid="{94CA0FB4-C30D-A947-829B-7D66DD7D08D9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_rels/item5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5.xml"/></Relationships>
</file>

<file path=customXml/_rels/item6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6.xml"/></Relationships>
</file>

<file path=customXml/_rels/item7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7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Taal xmlns="aacb7df8-672f-46f2-977f-893ce5cef86b" xsi:nil="true"/>
    <_ip_UnifiedCompliancePolicyProperties xmlns="http://schemas.microsoft.com/sharepoint/v3" xsi:nil="true"/>
    <Bedrijf xmlns="aacb7df8-672f-46f2-977f-893ce5cef86b" xsi:nil="true"/>
  </documentManagement>
</p:properties>
</file>

<file path=customXml/item2.xml><?xml version="1.0" encoding="utf-8"?>
<TemplafyTemplateConfiguration><![CDATA[{"elementsMetadata":[],"transformationConfigurations":[],"templateName":"blank","templateDescription":"","enableDocumentContentUpdater":false,"version":"2.0"}]]></TemplafyTemplateConfiguration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C3CCF29AC71D4428C978BA42A6A441C" ma:contentTypeVersion="31" ma:contentTypeDescription="Een nieuw document maken." ma:contentTypeScope="" ma:versionID="08fcdbeb2871c85628b191b60714f011">
  <xsd:schema xmlns:xsd="http://www.w3.org/2001/XMLSchema" xmlns:xs="http://www.w3.org/2001/XMLSchema" xmlns:p="http://schemas.microsoft.com/office/2006/metadata/properties" xmlns:ns1="http://schemas.microsoft.com/sharepoint/v3" xmlns:ns2="aacb7df8-672f-46f2-977f-893ce5cef86b" xmlns:ns3="22a3f1e7-1ad8-4567-967d-700183da1d1b" targetNamespace="http://schemas.microsoft.com/office/2006/metadata/properties" ma:root="true" ma:fieldsID="24d34939b9d8ca4ebc6c79201e24bdec" ns1:_="" ns2:_="" ns3:_="">
    <xsd:import namespace="http://schemas.microsoft.com/sharepoint/v3"/>
    <xsd:import namespace="aacb7df8-672f-46f2-977f-893ce5cef86b"/>
    <xsd:import namespace="22a3f1e7-1ad8-4567-967d-700183da1d1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DateTaken" minOccurs="0"/>
                <xsd:element ref="ns2:MediaServiceLocation" minOccurs="0"/>
                <xsd:element ref="ns2:MediaServiceOCR" minOccurs="0"/>
                <xsd:element ref="ns3:SharedWithUsers" minOccurs="0"/>
                <xsd:element ref="ns3:SharedWithDetails" minOccurs="0"/>
                <xsd:element ref="ns2:MediaServiceGenerationTime" minOccurs="0"/>
                <xsd:element ref="ns2:MediaServiceEventHashCode" minOccurs="0"/>
                <xsd:element ref="ns1:_ip_UnifiedCompliancePolicyProperties" minOccurs="0"/>
                <xsd:element ref="ns1:_ip_UnifiedCompliancePolicyUIAction" minOccurs="0"/>
                <xsd:element ref="ns2:Bedrijf" minOccurs="0"/>
                <xsd:element ref="ns2:Taal" minOccurs="0"/>
                <xsd:element ref="ns2:MediaServiceAutoKeyPoints" minOccurs="0"/>
                <xsd:element ref="ns2:MediaServiceKeyPoints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8" nillable="true" ma:displayName="Eigenschappen van het geïntegreerd beleid voor naleving" ma:hidden="true" ma:internalName="_ip_UnifiedCompliancePolicyProperties">
      <xsd:simpleType>
        <xsd:restriction base="dms:Note"/>
      </xsd:simpleType>
    </xsd:element>
    <xsd:element name="_ip_UnifiedCompliancePolicyUIAction" ma:index="19" nillable="true" ma:displayName="Actie van de gebruikersinterface van het geïntegreerd beleid voor naleving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acb7df8-672f-46f2-977f-893ce5cef86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DateTaken" ma:index="11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2" nillable="true" ma:displayName="MediaServiceLocation" ma:internalName="MediaServiceLocation" ma:readOnly="true">
      <xsd:simpleType>
        <xsd:restriction base="dms:Text"/>
      </xsd:simpleType>
    </xsd:element>
    <xsd:element name="MediaServiceOCR" ma:index="13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Bedrijf" ma:index="20" nillable="true" ma:displayName="Bedrijf" ma:internalName="Bedrijf">
      <xsd:simpleType>
        <xsd:restriction base="dms:Text">
          <xsd:maxLength value="255"/>
        </xsd:restriction>
      </xsd:simpleType>
    </xsd:element>
    <xsd:element name="Taal" ma:index="21" nillable="true" ma:displayName="Taal" ma:format="Dropdown" ma:internalName="Taal">
      <xsd:simpleType>
        <xsd:restriction base="dms:Text">
          <xsd:maxLength value="255"/>
        </xsd:restriction>
      </xsd:simpleType>
    </xsd:element>
    <xsd:element name="MediaServiceAutoKeyPoints" ma:index="2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4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a3f1e7-1ad8-4567-967d-700183da1d1b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Gedeeld met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Gedeeld met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oudstype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4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5.xml><?xml version="1.0" encoding="utf-8"?>
<TemplafySlideFormConfiguration><![CDATA[{"formFields":[],"formDataEntries":[]}]]></TemplafySlideFormConfiguration>
</file>

<file path=customXml/item6.xml><?xml version="1.0" encoding="utf-8"?>
<TemplafyFormConfiguration><![CDATA[{"formFields":[],"formDataEntries":[]}]]></TemplafyFormConfiguration>
</file>

<file path=customXml/item7.xml><?xml version="1.0" encoding="utf-8"?>
<TemplafySlideTemplateConfiguration><![CDATA[{"slideVersion":1,"isValidatorEnabled":false,"isLocked":false,"elementsMetadata":[],"slideId":"637727432499508828","enableDocumentContentUpdater":false,"version":"2.0"}]]></TemplafySlideTemplateConfiguration>
</file>

<file path=customXml/itemProps1.xml><?xml version="1.0" encoding="utf-8"?>
<ds:datastoreItem xmlns:ds="http://schemas.openxmlformats.org/officeDocument/2006/customXml" ds:itemID="{CE7FB006-060E-420C-B955-CC58F092D3A8}">
  <ds:schemaRefs>
    <ds:schemaRef ds:uri="http://schemas.microsoft.com/sharepoint/v3"/>
    <ds:schemaRef ds:uri="http://schemas.microsoft.com/office/2006/documentManagement/types"/>
    <ds:schemaRef ds:uri="http://purl.org/dc/terms/"/>
    <ds:schemaRef ds:uri="http://schemas.openxmlformats.org/package/2006/metadata/core-properties"/>
    <ds:schemaRef ds:uri="22a3f1e7-1ad8-4567-967d-700183da1d1b"/>
    <ds:schemaRef ds:uri="http://purl.org/dc/dcmitype/"/>
    <ds:schemaRef ds:uri="http://schemas.microsoft.com/office/infopath/2007/PartnerControls"/>
    <ds:schemaRef ds:uri="http://purl.org/dc/elements/1.1/"/>
    <ds:schemaRef ds:uri="http://schemas.microsoft.com/office/2006/metadata/properties"/>
    <ds:schemaRef ds:uri="aacb7df8-672f-46f2-977f-893ce5cef86b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A70A3159-FD05-4484-841B-C1C38C19BF11}">
  <ds:schemaRefs/>
</ds:datastoreItem>
</file>

<file path=customXml/itemProps3.xml><?xml version="1.0" encoding="utf-8"?>
<ds:datastoreItem xmlns:ds="http://schemas.openxmlformats.org/officeDocument/2006/customXml" ds:itemID="{CE26E5A5-5C6D-489B-856E-2C451FE083B6}">
  <ds:schemaRefs>
    <ds:schemaRef ds:uri="22a3f1e7-1ad8-4567-967d-700183da1d1b"/>
    <ds:schemaRef ds:uri="aacb7df8-672f-46f2-977f-893ce5cef86b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microsoft.com/sharepoint/v3"/>
    <ds:schemaRef ds:uri="http://schemas.openxmlformats.org/package/2006/metadata/core-properties"/>
    <ds:schemaRef ds:uri="http://www.w3.org/2001/XMLSchema"/>
  </ds:schemaRefs>
</ds:datastoreItem>
</file>

<file path=customXml/itemProps4.xml><?xml version="1.0" encoding="utf-8"?>
<ds:datastoreItem xmlns:ds="http://schemas.openxmlformats.org/officeDocument/2006/customXml" ds:itemID="{B3DD47DF-D318-48F0-9F72-2CC7BB8FCB4E}">
  <ds:schemaRefs>
    <ds:schemaRef ds:uri="http://schemas.microsoft.com/sharepoint/v3/contenttype/forms"/>
  </ds:schemaRefs>
</ds:datastoreItem>
</file>

<file path=customXml/itemProps5.xml><?xml version="1.0" encoding="utf-8"?>
<ds:datastoreItem xmlns:ds="http://schemas.openxmlformats.org/officeDocument/2006/customXml" ds:itemID="{D2DD6E0E-3219-4932-B5EB-655F9E9BB3C5}">
  <ds:schemaRefs/>
</ds:datastoreItem>
</file>

<file path=customXml/itemProps6.xml><?xml version="1.0" encoding="utf-8"?>
<ds:datastoreItem xmlns:ds="http://schemas.openxmlformats.org/officeDocument/2006/customXml" ds:itemID="{BCB0DF27-E6BE-4EFC-B725-FE1A07D51F8F}">
  <ds:schemaRefs/>
</ds:datastoreItem>
</file>

<file path=customXml/itemProps7.xml><?xml version="1.0" encoding="utf-8"?>
<ds:datastoreItem xmlns:ds="http://schemas.openxmlformats.org/officeDocument/2006/customXml" ds:itemID="{060119ED-EB0C-4BBF-8B03-0CDEA68320CC}">
  <ds:schemaRefs/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ERA190317_Erasmus MC Bedrijfspresentatie 14nov</Template>
  <TotalTime>21</TotalTime>
  <Words>425</Words>
  <Application>Microsoft Office PowerPoint</Application>
  <PresentationFormat>A4 Paper (210x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Black</vt:lpstr>
      <vt:lpstr>Calibri</vt:lpstr>
      <vt:lpstr>Times New Roman</vt:lpstr>
      <vt:lpstr>Erasmus MC</vt:lpstr>
      <vt:lpstr>PowerPoint Presentation</vt:lpstr>
    </vt:vector>
  </TitlesOfParts>
  <Company>Erasmus 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P. van Rikxoort</dc:creator>
  <cp:lastModifiedBy>Sanne Buijs</cp:lastModifiedBy>
  <cp:revision>8</cp:revision>
  <dcterms:created xsi:type="dcterms:W3CDTF">2022-10-25T13:02:38Z</dcterms:created>
  <dcterms:modified xsi:type="dcterms:W3CDTF">2023-01-26T16:40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TemplafyTimeStamp">
    <vt:lpwstr>2021-11-17T10:54:09</vt:lpwstr>
  </property>
  <property fmtid="{D5CDD505-2E9C-101B-9397-08002B2CF9AE}" pid="3" name="ContentTypeId">
    <vt:lpwstr>0x0101009C3CCF29AC71D4428C978BA42A6A441C</vt:lpwstr>
  </property>
  <property fmtid="{D5CDD505-2E9C-101B-9397-08002B2CF9AE}" pid="4" name="TemplafyTenantId">
    <vt:lpwstr>erasmusmc</vt:lpwstr>
  </property>
  <property fmtid="{D5CDD505-2E9C-101B-9397-08002B2CF9AE}" pid="5" name="TemplafyTemplateId">
    <vt:lpwstr>637727432487719242</vt:lpwstr>
  </property>
  <property fmtid="{D5CDD505-2E9C-101B-9397-08002B2CF9AE}" pid="6" name="TemplafyUserProfileId">
    <vt:lpwstr>637728415402150835</vt:lpwstr>
  </property>
  <property fmtid="{D5CDD505-2E9C-101B-9397-08002B2CF9AE}" pid="7" name="TemplafyFromBlank">
    <vt:bool>true</vt:bool>
  </property>
</Properties>
</file>